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72" r:id="rId5"/>
    <p:sldId id="273" r:id="rId6"/>
    <p:sldId id="274" r:id="rId7"/>
    <p:sldId id="275" r:id="rId8"/>
    <p:sldId id="361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4A797"/>
    <a:srgbClr val="94A992"/>
    <a:srgbClr val="C4B569"/>
    <a:srgbClr val="F57778"/>
    <a:srgbClr val="E59400"/>
    <a:srgbClr val="FFEBAF"/>
    <a:srgbClr val="9C9C9C"/>
    <a:srgbClr val="F4B184"/>
    <a:srgbClr val="FFFFFF"/>
    <a:srgbClr val="4E4E4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C067122-D664-49C9-B6F7-F0DCEA5F6488}" v="1" dt="2024-12-28T08:41:24.6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08" autoAdjust="0"/>
    <p:restoredTop sz="94660"/>
  </p:normalViewPr>
  <p:slideViewPr>
    <p:cSldViewPr snapToGrid="0">
      <p:cViewPr varScale="1">
        <p:scale>
          <a:sx n="88" d="100"/>
          <a:sy n="88" d="100"/>
        </p:scale>
        <p:origin x="1202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5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u Baidya" userId="594f5481-a248-420f-87e4-07d6a00588cb" providerId="ADAL" clId="{3C067122-D664-49C9-B6F7-F0DCEA5F6488}"/>
    <pc:docChg chg="modSld">
      <pc:chgData name="Abu Baidya" userId="594f5481-a248-420f-87e4-07d6a00588cb" providerId="ADAL" clId="{3C067122-D664-49C9-B6F7-F0DCEA5F6488}" dt="2024-12-28T08:41:24.674" v="0" actId="164"/>
      <pc:docMkLst>
        <pc:docMk/>
      </pc:docMkLst>
      <pc:sldChg chg="addSp modSp">
        <pc:chgData name="Abu Baidya" userId="594f5481-a248-420f-87e4-07d6a00588cb" providerId="ADAL" clId="{3C067122-D664-49C9-B6F7-F0DCEA5F6488}" dt="2024-12-28T08:41:24.674" v="0" actId="164"/>
        <pc:sldMkLst>
          <pc:docMk/>
          <pc:sldMk cId="3079365767" sldId="272"/>
        </pc:sldMkLst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4" creationId="{4B666EB9-34A4-DCC0-8500-D8932C215C93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5" creationId="{AF0F30B0-231B-6EC9-B06F-2F8013569DB6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7" creationId="{862F13E7-581B-1DE5-9F91-C476DD618656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9" creationId="{5DFCA5F0-0FC0-4250-15EF-FAB255E72657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0" creationId="{D48F1201-EDAE-7707-CA6E-40BE02E37298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1" creationId="{EFB7EF78-A45A-9D5C-73DE-AA2CA97767BD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2" creationId="{AE011154-0459-C065-3DA1-93D3460B8958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3" creationId="{267F0B51-6823-C5D2-3A45-9BCE60D64E47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4" creationId="{E178FF26-9B8D-EDE2-F117-C5FE4CBB917C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7" creationId="{91B2A3F0-3D2F-EF1E-9566-7DFC6C4A5E71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9" creationId="{E3CCA852-59CA-032F-7D00-53BDEC44A50E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3" creationId="{E0D646ED-EA4A-2CDC-C444-DEAD9D193F17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4" creationId="{8613D75A-3CC0-B1D5-060B-1B9995612D34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5" creationId="{92501B7B-A030-A320-7E42-58F1879ECCC3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6" creationId="{999E26B2-F893-CCB7-45CF-DEA2EA3E2C30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8" creationId="{6FC5A816-FC9C-916F-EA42-1D845BD8C038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29" creationId="{961E87B5-D13E-19EF-AAC4-5FC4CBD499F6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30" creationId="{6D596BD0-E296-EB37-2DFE-28DAD091294C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46" creationId="{79D2B9DA-4485-8CCA-7895-8BC601358B4C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50" creationId="{1B9350C2-2300-9715-BD82-C42D94034388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74" creationId="{B251024D-8098-4644-191C-47A024F83A22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75" creationId="{CC07E9DD-0A91-B164-2226-6ABC0CDC5B18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04" creationId="{F5239034-5E11-032E-AE2E-C1FECFA821C5}"/>
          </ac:spMkLst>
        </pc:spChg>
        <pc:spChg chg="mod">
          <ac:chgData name="Abu Baidya" userId="594f5481-a248-420f-87e4-07d6a00588cb" providerId="ADAL" clId="{3C067122-D664-49C9-B6F7-F0DCEA5F6488}" dt="2024-12-28T08:41:24.674" v="0" actId="164"/>
          <ac:spMkLst>
            <pc:docMk/>
            <pc:sldMk cId="3079365767" sldId="272"/>
            <ac:spMk id="105" creationId="{FA03E8E5-6AB7-039C-848A-B0B4E836CBB2}"/>
          </ac:spMkLst>
        </pc:spChg>
        <pc:grpChg chg="add 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6" creationId="{22E74C90-A6A4-5F91-D4A4-AB14ACDBEFBF}"/>
          </ac:grpSpMkLst>
        </pc:grpChg>
        <pc:grpChg chg="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16" creationId="{950EC24F-1D25-DBD5-DCBC-6DD42019D93C}"/>
          </ac:grpSpMkLst>
        </pc:grpChg>
        <pc:grpChg chg="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18" creationId="{C0680758-EA8C-9F71-C391-A6AB1738F837}"/>
          </ac:grpSpMkLst>
        </pc:grpChg>
        <pc:grpChg chg="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20" creationId="{C9B12F8B-F17D-2E5D-37C3-7D8C605E26DF}"/>
          </ac:grpSpMkLst>
        </pc:grpChg>
        <pc:grpChg chg="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51" creationId="{CBFD6563-D00F-25A9-C84D-D30CF7009827}"/>
          </ac:grpSpMkLst>
        </pc:grpChg>
        <pc:grpChg chg="mod">
          <ac:chgData name="Abu Baidya" userId="594f5481-a248-420f-87e4-07d6a00588cb" providerId="ADAL" clId="{3C067122-D664-49C9-B6F7-F0DCEA5F6488}" dt="2024-12-28T08:41:24.674" v="0" actId="164"/>
          <ac:grpSpMkLst>
            <pc:docMk/>
            <pc:sldMk cId="3079365767" sldId="272"/>
            <ac:grpSpMk id="391" creationId="{C100EA9B-C17A-3A8D-4294-BAD5B6FCE5E2}"/>
          </ac:grpSpMkLst>
        </pc:grpChg>
        <pc:picChg chg="mod">
          <ac:chgData name="Abu Baidya" userId="594f5481-a248-420f-87e4-07d6a00588cb" providerId="ADAL" clId="{3C067122-D664-49C9-B6F7-F0DCEA5F6488}" dt="2024-12-28T08:41:24.674" v="0" actId="164"/>
          <ac:picMkLst>
            <pc:docMk/>
            <pc:sldMk cId="3079365767" sldId="272"/>
            <ac:picMk id="15" creationId="{39238EB7-A1B8-3358-D923-9B4713F264CF}"/>
          </ac:picMkLst>
        </pc:picChg>
        <pc:cxnChg chg="mod">
          <ac:chgData name="Abu Baidya" userId="594f5481-a248-420f-87e4-07d6a00588cb" providerId="ADAL" clId="{3C067122-D664-49C9-B6F7-F0DCEA5F6488}" dt="2024-12-28T08:41:24.674" v="0" actId="164"/>
          <ac:cxnSpMkLst>
            <pc:docMk/>
            <pc:sldMk cId="3079365767" sldId="272"/>
            <ac:cxnSpMk id="8" creationId="{6973F690-F943-1002-A738-78F230C82F27}"/>
          </ac:cxnSpMkLst>
        </pc:cxnChg>
        <pc:cxnChg chg="mod">
          <ac:chgData name="Abu Baidya" userId="594f5481-a248-420f-87e4-07d6a00588cb" providerId="ADAL" clId="{3C067122-D664-49C9-B6F7-F0DCEA5F6488}" dt="2024-12-28T08:41:24.674" v="0" actId="164"/>
          <ac:cxnSpMkLst>
            <pc:docMk/>
            <pc:sldMk cId="3079365767" sldId="272"/>
            <ac:cxnSpMk id="415" creationId="{6ADD1E9F-AC71-3007-71B9-576CEADD2902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7116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7703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5179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6124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2078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6595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1422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8710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322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8545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3936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6C083-72F0-4177-AE7E-0E0F0F599541}" type="datetimeFigureOut">
              <a:rPr lang="de-DE" smtClean="0"/>
              <a:t>28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AEBDB-3EC0-42FB-A157-41FE1AB7A78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850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TextBox 449">
            <a:extLst>
              <a:ext uri="{FF2B5EF4-FFF2-40B4-BE49-F238E27FC236}">
                <a16:creationId xmlns:a16="http://schemas.microsoft.com/office/drawing/2014/main" id="{E99488E6-A13B-DAB4-CC31-352E9DD1E981}"/>
              </a:ext>
            </a:extLst>
          </p:cNvPr>
          <p:cNvSpPr txBox="1"/>
          <p:nvPr/>
        </p:nvSpPr>
        <p:spPr>
          <a:xfrm>
            <a:off x="304979" y="6640258"/>
            <a:ext cx="791527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1" dirty="0"/>
              <a:t>Fig. 1. </a:t>
            </a:r>
            <a:r>
              <a:rPr lang="en-US" sz="1200" i="1" dirty="0"/>
              <a:t>Geological map of the Barberton Greenstone Belt, South Africa, modified from </a:t>
            </a:r>
            <a:r>
              <a:rPr lang="en-US" sz="1200" i="1" dirty="0" err="1"/>
              <a:t>Homann</a:t>
            </a:r>
            <a:r>
              <a:rPr lang="en-US" sz="1200" i="1" dirty="0"/>
              <a:t> et al. (2015). The Eureka Syncline is a large refolded structure in the north-central BGB. Stratigraphic column to the right shows generalized lithology of the </a:t>
            </a:r>
            <a:r>
              <a:rPr lang="en-US" sz="1200" i="1" dirty="0" err="1"/>
              <a:t>Moodies</a:t>
            </a:r>
            <a:r>
              <a:rPr lang="en-US" sz="1200" i="1" dirty="0"/>
              <a:t> Group in the Saddleback and Eureka Synclines which preserve the greatest stratigraphic thickness of this unit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2E74C90-A6A4-5F91-D4A4-AB14ACDBEFBF}"/>
              </a:ext>
            </a:extLst>
          </p:cNvPr>
          <p:cNvGrpSpPr/>
          <p:nvPr/>
        </p:nvGrpSpPr>
        <p:grpSpPr>
          <a:xfrm>
            <a:off x="-391492" y="140933"/>
            <a:ext cx="8785432" cy="6368898"/>
            <a:chOff x="-391492" y="140933"/>
            <a:chExt cx="8785432" cy="6368898"/>
          </a:xfrm>
        </p:grpSpPr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39238EB7-A1B8-3358-D923-9B4713F264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94"/>
            <a:stretch/>
          </p:blipFill>
          <p:spPr bwMode="auto">
            <a:xfrm>
              <a:off x="323968" y="222191"/>
              <a:ext cx="6662092" cy="62240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23" name="AutoShape 3">
              <a:extLst>
                <a:ext uri="{FF2B5EF4-FFF2-40B4-BE49-F238E27FC236}">
                  <a16:creationId xmlns:a16="http://schemas.microsoft.com/office/drawing/2014/main" id="{E0D646ED-EA4A-2CDC-C444-DEAD9D193F1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04980" y="142258"/>
              <a:ext cx="8088960" cy="633196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Freeform 8">
              <a:extLst>
                <a:ext uri="{FF2B5EF4-FFF2-40B4-BE49-F238E27FC236}">
                  <a16:creationId xmlns:a16="http://schemas.microsoft.com/office/drawing/2014/main" id="{8613D75A-3CC0-B1D5-060B-1B9995612D3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391492" y="151497"/>
              <a:ext cx="6575267" cy="1738519"/>
            </a:xfrm>
            <a:custGeom>
              <a:avLst/>
              <a:gdLst>
                <a:gd name="T0" fmla="*/ 716 w 1502"/>
                <a:gd name="T1" fmla="*/ 349 h 397"/>
                <a:gd name="T2" fmla="*/ 580 w 1502"/>
                <a:gd name="T3" fmla="*/ 390 h 397"/>
                <a:gd name="T4" fmla="*/ 371 w 1502"/>
                <a:gd name="T5" fmla="*/ 324 h 397"/>
                <a:gd name="T6" fmla="*/ 231 w 1502"/>
                <a:gd name="T7" fmla="*/ 294 h 397"/>
                <a:gd name="T8" fmla="*/ 185 w 1502"/>
                <a:gd name="T9" fmla="*/ 279 h 397"/>
                <a:gd name="T10" fmla="*/ 121 w 1502"/>
                <a:gd name="T11" fmla="*/ 285 h 397"/>
                <a:gd name="T12" fmla="*/ 109 w 1502"/>
                <a:gd name="T13" fmla="*/ 269 h 397"/>
                <a:gd name="T14" fmla="*/ 71 w 1502"/>
                <a:gd name="T15" fmla="*/ 245 h 397"/>
                <a:gd name="T16" fmla="*/ 37 w 1502"/>
                <a:gd name="T17" fmla="*/ 295 h 397"/>
                <a:gd name="T18" fmla="*/ 32 w 1502"/>
                <a:gd name="T19" fmla="*/ 212 h 397"/>
                <a:gd name="T20" fmla="*/ 15 w 1502"/>
                <a:gd name="T21" fmla="*/ 182 h 397"/>
                <a:gd name="T22" fmla="*/ 48 w 1502"/>
                <a:gd name="T23" fmla="*/ 160 h 397"/>
                <a:gd name="T24" fmla="*/ 114 w 1502"/>
                <a:gd name="T25" fmla="*/ 172 h 397"/>
                <a:gd name="T26" fmla="*/ 159 w 1502"/>
                <a:gd name="T27" fmla="*/ 146 h 397"/>
                <a:gd name="T28" fmla="*/ 116 w 1502"/>
                <a:gd name="T29" fmla="*/ 65 h 397"/>
                <a:gd name="T30" fmla="*/ 75 w 1502"/>
                <a:gd name="T31" fmla="*/ 8 h 397"/>
                <a:gd name="T32" fmla="*/ 1497 w 1502"/>
                <a:gd name="T33" fmla="*/ 14 h 397"/>
                <a:gd name="T34" fmla="*/ 1502 w 1502"/>
                <a:gd name="T35" fmla="*/ 45 h 397"/>
                <a:gd name="T36" fmla="*/ 1445 w 1502"/>
                <a:gd name="T37" fmla="*/ 76 h 397"/>
                <a:gd name="T38" fmla="*/ 1400 w 1502"/>
                <a:gd name="T39" fmla="*/ 190 h 397"/>
                <a:gd name="T40" fmla="*/ 1399 w 1502"/>
                <a:gd name="T41" fmla="*/ 177 h 397"/>
                <a:gd name="T42" fmla="*/ 1335 w 1502"/>
                <a:gd name="T43" fmla="*/ 147 h 397"/>
                <a:gd name="T44" fmla="*/ 1356 w 1502"/>
                <a:gd name="T45" fmla="*/ 139 h 397"/>
                <a:gd name="T46" fmla="*/ 1397 w 1502"/>
                <a:gd name="T47" fmla="*/ 132 h 397"/>
                <a:gd name="T48" fmla="*/ 1380 w 1502"/>
                <a:gd name="T49" fmla="*/ 120 h 397"/>
                <a:gd name="T50" fmla="*/ 1337 w 1502"/>
                <a:gd name="T51" fmla="*/ 139 h 397"/>
                <a:gd name="T52" fmla="*/ 1301 w 1502"/>
                <a:gd name="T53" fmla="*/ 138 h 397"/>
                <a:gd name="T54" fmla="*/ 1268 w 1502"/>
                <a:gd name="T55" fmla="*/ 136 h 397"/>
                <a:gd name="T56" fmla="*/ 1241 w 1502"/>
                <a:gd name="T57" fmla="*/ 132 h 397"/>
                <a:gd name="T58" fmla="*/ 1221 w 1502"/>
                <a:gd name="T59" fmla="*/ 102 h 397"/>
                <a:gd name="T60" fmla="*/ 1211 w 1502"/>
                <a:gd name="T61" fmla="*/ 110 h 397"/>
                <a:gd name="T62" fmla="*/ 1189 w 1502"/>
                <a:gd name="T63" fmla="*/ 145 h 397"/>
                <a:gd name="T64" fmla="*/ 1153 w 1502"/>
                <a:gd name="T65" fmla="*/ 153 h 397"/>
                <a:gd name="T66" fmla="*/ 1130 w 1502"/>
                <a:gd name="T67" fmla="*/ 151 h 397"/>
                <a:gd name="T68" fmla="*/ 1093 w 1502"/>
                <a:gd name="T69" fmla="*/ 185 h 397"/>
                <a:gd name="T70" fmla="*/ 1029 w 1502"/>
                <a:gd name="T71" fmla="*/ 214 h 397"/>
                <a:gd name="T72" fmla="*/ 937 w 1502"/>
                <a:gd name="T73" fmla="*/ 244 h 397"/>
                <a:gd name="T74" fmla="*/ 847 w 1502"/>
                <a:gd name="T75" fmla="*/ 279 h 397"/>
                <a:gd name="T76" fmla="*/ 816 w 1502"/>
                <a:gd name="T77" fmla="*/ 308 h 397"/>
                <a:gd name="T78" fmla="*/ 658 w 1502"/>
                <a:gd name="T79" fmla="*/ 322 h 397"/>
                <a:gd name="T80" fmla="*/ 638 w 1502"/>
                <a:gd name="T81" fmla="*/ 336 h 397"/>
                <a:gd name="T82" fmla="*/ 634 w 1502"/>
                <a:gd name="T83" fmla="*/ 344 h 397"/>
                <a:gd name="T84" fmla="*/ 581 w 1502"/>
                <a:gd name="T85" fmla="*/ 383 h 397"/>
                <a:gd name="T86" fmla="*/ 619 w 1502"/>
                <a:gd name="T87" fmla="*/ 368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502" h="397">
                  <a:moveTo>
                    <a:pt x="812" y="310"/>
                  </a:moveTo>
                  <a:cubicBezTo>
                    <a:pt x="811" y="311"/>
                    <a:pt x="794" y="317"/>
                    <a:pt x="772" y="329"/>
                  </a:cubicBezTo>
                  <a:cubicBezTo>
                    <a:pt x="749" y="341"/>
                    <a:pt x="722" y="348"/>
                    <a:pt x="716" y="349"/>
                  </a:cubicBezTo>
                  <a:cubicBezTo>
                    <a:pt x="709" y="350"/>
                    <a:pt x="656" y="363"/>
                    <a:pt x="637" y="374"/>
                  </a:cubicBezTo>
                  <a:cubicBezTo>
                    <a:pt x="623" y="382"/>
                    <a:pt x="623" y="383"/>
                    <a:pt x="606" y="386"/>
                  </a:cubicBezTo>
                  <a:cubicBezTo>
                    <a:pt x="600" y="387"/>
                    <a:pt x="592" y="388"/>
                    <a:pt x="580" y="390"/>
                  </a:cubicBezTo>
                  <a:cubicBezTo>
                    <a:pt x="536" y="397"/>
                    <a:pt x="529" y="383"/>
                    <a:pt x="516" y="377"/>
                  </a:cubicBezTo>
                  <a:cubicBezTo>
                    <a:pt x="503" y="372"/>
                    <a:pt x="478" y="355"/>
                    <a:pt x="460" y="348"/>
                  </a:cubicBezTo>
                  <a:cubicBezTo>
                    <a:pt x="442" y="341"/>
                    <a:pt x="388" y="327"/>
                    <a:pt x="371" y="324"/>
                  </a:cubicBezTo>
                  <a:cubicBezTo>
                    <a:pt x="354" y="321"/>
                    <a:pt x="353" y="316"/>
                    <a:pt x="316" y="302"/>
                  </a:cubicBezTo>
                  <a:cubicBezTo>
                    <a:pt x="278" y="289"/>
                    <a:pt x="242" y="298"/>
                    <a:pt x="242" y="298"/>
                  </a:cubicBezTo>
                  <a:cubicBezTo>
                    <a:pt x="231" y="294"/>
                    <a:pt x="231" y="294"/>
                    <a:pt x="231" y="294"/>
                  </a:cubicBezTo>
                  <a:cubicBezTo>
                    <a:pt x="214" y="287"/>
                    <a:pt x="214" y="287"/>
                    <a:pt x="214" y="287"/>
                  </a:cubicBezTo>
                  <a:cubicBezTo>
                    <a:pt x="198" y="281"/>
                    <a:pt x="198" y="281"/>
                    <a:pt x="198" y="281"/>
                  </a:cubicBezTo>
                  <a:cubicBezTo>
                    <a:pt x="185" y="279"/>
                    <a:pt x="185" y="279"/>
                    <a:pt x="185" y="279"/>
                  </a:cubicBezTo>
                  <a:cubicBezTo>
                    <a:pt x="172" y="279"/>
                    <a:pt x="172" y="279"/>
                    <a:pt x="172" y="279"/>
                  </a:cubicBezTo>
                  <a:cubicBezTo>
                    <a:pt x="162" y="281"/>
                    <a:pt x="162" y="281"/>
                    <a:pt x="162" y="281"/>
                  </a:cubicBezTo>
                  <a:cubicBezTo>
                    <a:pt x="162" y="281"/>
                    <a:pt x="141" y="286"/>
                    <a:pt x="121" y="285"/>
                  </a:cubicBezTo>
                  <a:cubicBezTo>
                    <a:pt x="119" y="285"/>
                    <a:pt x="117" y="285"/>
                    <a:pt x="115" y="285"/>
                  </a:cubicBezTo>
                  <a:cubicBezTo>
                    <a:pt x="115" y="285"/>
                    <a:pt x="115" y="285"/>
                    <a:pt x="115" y="285"/>
                  </a:cubicBezTo>
                  <a:cubicBezTo>
                    <a:pt x="113" y="285"/>
                    <a:pt x="110" y="284"/>
                    <a:pt x="109" y="269"/>
                  </a:cubicBezTo>
                  <a:cubicBezTo>
                    <a:pt x="109" y="251"/>
                    <a:pt x="100" y="254"/>
                    <a:pt x="95" y="254"/>
                  </a:cubicBezTo>
                  <a:cubicBezTo>
                    <a:pt x="90" y="254"/>
                    <a:pt x="91" y="252"/>
                    <a:pt x="88" y="248"/>
                  </a:cubicBezTo>
                  <a:cubicBezTo>
                    <a:pt x="85" y="244"/>
                    <a:pt x="87" y="236"/>
                    <a:pt x="71" y="245"/>
                  </a:cubicBezTo>
                  <a:cubicBezTo>
                    <a:pt x="54" y="254"/>
                    <a:pt x="63" y="258"/>
                    <a:pt x="69" y="270"/>
                  </a:cubicBezTo>
                  <a:cubicBezTo>
                    <a:pt x="74" y="280"/>
                    <a:pt x="62" y="282"/>
                    <a:pt x="68" y="295"/>
                  </a:cubicBezTo>
                  <a:cubicBezTo>
                    <a:pt x="68" y="295"/>
                    <a:pt x="49" y="296"/>
                    <a:pt x="37" y="295"/>
                  </a:cubicBezTo>
                  <a:cubicBezTo>
                    <a:pt x="26" y="294"/>
                    <a:pt x="29" y="276"/>
                    <a:pt x="29" y="276"/>
                  </a:cubicBezTo>
                  <a:cubicBezTo>
                    <a:pt x="29" y="276"/>
                    <a:pt x="35" y="242"/>
                    <a:pt x="37" y="234"/>
                  </a:cubicBezTo>
                  <a:cubicBezTo>
                    <a:pt x="39" y="226"/>
                    <a:pt x="35" y="216"/>
                    <a:pt x="32" y="212"/>
                  </a:cubicBezTo>
                  <a:cubicBezTo>
                    <a:pt x="29" y="210"/>
                    <a:pt x="29" y="199"/>
                    <a:pt x="29" y="199"/>
                  </a:cubicBezTo>
                  <a:cubicBezTo>
                    <a:pt x="30" y="198"/>
                    <a:pt x="32" y="196"/>
                    <a:pt x="34" y="194"/>
                  </a:cubicBezTo>
                  <a:cubicBezTo>
                    <a:pt x="50" y="178"/>
                    <a:pt x="31" y="184"/>
                    <a:pt x="15" y="182"/>
                  </a:cubicBezTo>
                  <a:cubicBezTo>
                    <a:pt x="0" y="181"/>
                    <a:pt x="25" y="178"/>
                    <a:pt x="14" y="173"/>
                  </a:cubicBezTo>
                  <a:cubicBezTo>
                    <a:pt x="3" y="168"/>
                    <a:pt x="16" y="164"/>
                    <a:pt x="16" y="164"/>
                  </a:cubicBezTo>
                  <a:cubicBezTo>
                    <a:pt x="16" y="164"/>
                    <a:pt x="36" y="161"/>
                    <a:pt x="48" y="160"/>
                  </a:cubicBezTo>
                  <a:cubicBezTo>
                    <a:pt x="52" y="160"/>
                    <a:pt x="55" y="160"/>
                    <a:pt x="57" y="160"/>
                  </a:cubicBezTo>
                  <a:cubicBezTo>
                    <a:pt x="62" y="161"/>
                    <a:pt x="72" y="164"/>
                    <a:pt x="81" y="169"/>
                  </a:cubicBezTo>
                  <a:cubicBezTo>
                    <a:pt x="90" y="174"/>
                    <a:pt x="106" y="172"/>
                    <a:pt x="114" y="172"/>
                  </a:cubicBezTo>
                  <a:cubicBezTo>
                    <a:pt x="123" y="172"/>
                    <a:pt x="134" y="166"/>
                    <a:pt x="141" y="165"/>
                  </a:cubicBezTo>
                  <a:cubicBezTo>
                    <a:pt x="148" y="164"/>
                    <a:pt x="132" y="164"/>
                    <a:pt x="157" y="160"/>
                  </a:cubicBezTo>
                  <a:cubicBezTo>
                    <a:pt x="181" y="158"/>
                    <a:pt x="181" y="148"/>
                    <a:pt x="159" y="146"/>
                  </a:cubicBezTo>
                  <a:cubicBezTo>
                    <a:pt x="138" y="144"/>
                    <a:pt x="135" y="126"/>
                    <a:pt x="135" y="126"/>
                  </a:cubicBezTo>
                  <a:cubicBezTo>
                    <a:pt x="135" y="126"/>
                    <a:pt x="135" y="116"/>
                    <a:pt x="131" y="112"/>
                  </a:cubicBezTo>
                  <a:cubicBezTo>
                    <a:pt x="127" y="108"/>
                    <a:pt x="118" y="74"/>
                    <a:pt x="116" y="65"/>
                  </a:cubicBezTo>
                  <a:cubicBezTo>
                    <a:pt x="114" y="57"/>
                    <a:pt x="114" y="48"/>
                    <a:pt x="100" y="35"/>
                  </a:cubicBezTo>
                  <a:cubicBezTo>
                    <a:pt x="98" y="34"/>
                    <a:pt x="95" y="32"/>
                    <a:pt x="92" y="30"/>
                  </a:cubicBezTo>
                  <a:cubicBezTo>
                    <a:pt x="71" y="14"/>
                    <a:pt x="75" y="8"/>
                    <a:pt x="75" y="8"/>
                  </a:cubicBezTo>
                  <a:cubicBezTo>
                    <a:pt x="79" y="0"/>
                    <a:pt x="79" y="0"/>
                    <a:pt x="79" y="0"/>
                  </a:cubicBezTo>
                  <a:cubicBezTo>
                    <a:pt x="1498" y="0"/>
                    <a:pt x="1498" y="0"/>
                    <a:pt x="1498" y="0"/>
                  </a:cubicBezTo>
                  <a:cubicBezTo>
                    <a:pt x="1497" y="14"/>
                    <a:pt x="1497" y="14"/>
                    <a:pt x="1497" y="14"/>
                  </a:cubicBezTo>
                  <a:cubicBezTo>
                    <a:pt x="1498" y="23"/>
                    <a:pt x="1498" y="23"/>
                    <a:pt x="1498" y="23"/>
                  </a:cubicBezTo>
                  <a:cubicBezTo>
                    <a:pt x="1501" y="33"/>
                    <a:pt x="1501" y="33"/>
                    <a:pt x="1501" y="33"/>
                  </a:cubicBezTo>
                  <a:cubicBezTo>
                    <a:pt x="1502" y="45"/>
                    <a:pt x="1502" y="45"/>
                    <a:pt x="1502" y="45"/>
                  </a:cubicBezTo>
                  <a:cubicBezTo>
                    <a:pt x="1483" y="54"/>
                    <a:pt x="1483" y="54"/>
                    <a:pt x="1483" y="54"/>
                  </a:cubicBezTo>
                  <a:cubicBezTo>
                    <a:pt x="1465" y="62"/>
                    <a:pt x="1465" y="62"/>
                    <a:pt x="1465" y="62"/>
                  </a:cubicBezTo>
                  <a:cubicBezTo>
                    <a:pt x="1465" y="62"/>
                    <a:pt x="1455" y="66"/>
                    <a:pt x="1445" y="76"/>
                  </a:cubicBezTo>
                  <a:cubicBezTo>
                    <a:pt x="1434" y="86"/>
                    <a:pt x="1421" y="90"/>
                    <a:pt x="1438" y="108"/>
                  </a:cubicBezTo>
                  <a:cubicBezTo>
                    <a:pt x="1455" y="126"/>
                    <a:pt x="1431" y="158"/>
                    <a:pt x="1429" y="159"/>
                  </a:cubicBezTo>
                  <a:cubicBezTo>
                    <a:pt x="1428" y="160"/>
                    <a:pt x="1401" y="189"/>
                    <a:pt x="1400" y="190"/>
                  </a:cubicBezTo>
                  <a:cubicBezTo>
                    <a:pt x="1400" y="191"/>
                    <a:pt x="1397" y="193"/>
                    <a:pt x="1394" y="197"/>
                  </a:cubicBezTo>
                  <a:cubicBezTo>
                    <a:pt x="1394" y="197"/>
                    <a:pt x="1395" y="194"/>
                    <a:pt x="1395" y="191"/>
                  </a:cubicBezTo>
                  <a:cubicBezTo>
                    <a:pt x="1396" y="188"/>
                    <a:pt x="1397" y="188"/>
                    <a:pt x="1399" y="177"/>
                  </a:cubicBezTo>
                  <a:cubicBezTo>
                    <a:pt x="1400" y="166"/>
                    <a:pt x="1392" y="163"/>
                    <a:pt x="1385" y="158"/>
                  </a:cubicBezTo>
                  <a:cubicBezTo>
                    <a:pt x="1379" y="152"/>
                    <a:pt x="1371" y="152"/>
                    <a:pt x="1353" y="152"/>
                  </a:cubicBezTo>
                  <a:cubicBezTo>
                    <a:pt x="1335" y="153"/>
                    <a:pt x="1335" y="147"/>
                    <a:pt x="1335" y="147"/>
                  </a:cubicBezTo>
                  <a:cubicBezTo>
                    <a:pt x="1342" y="145"/>
                    <a:pt x="1342" y="145"/>
                    <a:pt x="1342" y="145"/>
                  </a:cubicBezTo>
                  <a:cubicBezTo>
                    <a:pt x="1349" y="143"/>
                    <a:pt x="1349" y="143"/>
                    <a:pt x="1349" y="143"/>
                  </a:cubicBezTo>
                  <a:cubicBezTo>
                    <a:pt x="1356" y="139"/>
                    <a:pt x="1356" y="139"/>
                    <a:pt x="1356" y="139"/>
                  </a:cubicBezTo>
                  <a:cubicBezTo>
                    <a:pt x="1365" y="135"/>
                    <a:pt x="1365" y="135"/>
                    <a:pt x="1365" y="135"/>
                  </a:cubicBezTo>
                  <a:cubicBezTo>
                    <a:pt x="1376" y="132"/>
                    <a:pt x="1376" y="132"/>
                    <a:pt x="1376" y="132"/>
                  </a:cubicBezTo>
                  <a:cubicBezTo>
                    <a:pt x="1376" y="132"/>
                    <a:pt x="1382" y="131"/>
                    <a:pt x="1397" y="132"/>
                  </a:cubicBezTo>
                  <a:cubicBezTo>
                    <a:pt x="1412" y="134"/>
                    <a:pt x="1402" y="128"/>
                    <a:pt x="1402" y="128"/>
                  </a:cubicBezTo>
                  <a:cubicBezTo>
                    <a:pt x="1402" y="128"/>
                    <a:pt x="1402" y="128"/>
                    <a:pt x="1394" y="122"/>
                  </a:cubicBezTo>
                  <a:cubicBezTo>
                    <a:pt x="1386" y="116"/>
                    <a:pt x="1380" y="120"/>
                    <a:pt x="1380" y="120"/>
                  </a:cubicBezTo>
                  <a:cubicBezTo>
                    <a:pt x="1372" y="124"/>
                    <a:pt x="1372" y="124"/>
                    <a:pt x="1372" y="124"/>
                  </a:cubicBezTo>
                  <a:cubicBezTo>
                    <a:pt x="1354" y="132"/>
                    <a:pt x="1354" y="132"/>
                    <a:pt x="1354" y="132"/>
                  </a:cubicBezTo>
                  <a:cubicBezTo>
                    <a:pt x="1337" y="139"/>
                    <a:pt x="1337" y="139"/>
                    <a:pt x="1337" y="139"/>
                  </a:cubicBezTo>
                  <a:cubicBezTo>
                    <a:pt x="1323" y="140"/>
                    <a:pt x="1323" y="140"/>
                    <a:pt x="1323" y="140"/>
                  </a:cubicBezTo>
                  <a:cubicBezTo>
                    <a:pt x="1311" y="140"/>
                    <a:pt x="1311" y="140"/>
                    <a:pt x="1311" y="140"/>
                  </a:cubicBezTo>
                  <a:cubicBezTo>
                    <a:pt x="1301" y="138"/>
                    <a:pt x="1301" y="138"/>
                    <a:pt x="1301" y="138"/>
                  </a:cubicBezTo>
                  <a:cubicBezTo>
                    <a:pt x="1287" y="133"/>
                    <a:pt x="1287" y="133"/>
                    <a:pt x="1287" y="133"/>
                  </a:cubicBezTo>
                  <a:cubicBezTo>
                    <a:pt x="1276" y="132"/>
                    <a:pt x="1276" y="132"/>
                    <a:pt x="1276" y="132"/>
                  </a:cubicBezTo>
                  <a:cubicBezTo>
                    <a:pt x="1268" y="136"/>
                    <a:pt x="1268" y="136"/>
                    <a:pt x="1268" y="136"/>
                  </a:cubicBezTo>
                  <a:cubicBezTo>
                    <a:pt x="1258" y="138"/>
                    <a:pt x="1258" y="138"/>
                    <a:pt x="1258" y="138"/>
                  </a:cubicBezTo>
                  <a:cubicBezTo>
                    <a:pt x="1248" y="136"/>
                    <a:pt x="1248" y="136"/>
                    <a:pt x="1248" y="136"/>
                  </a:cubicBezTo>
                  <a:cubicBezTo>
                    <a:pt x="1241" y="132"/>
                    <a:pt x="1241" y="132"/>
                    <a:pt x="1241" y="132"/>
                  </a:cubicBezTo>
                  <a:cubicBezTo>
                    <a:pt x="1236" y="128"/>
                    <a:pt x="1236" y="128"/>
                    <a:pt x="1236" y="128"/>
                  </a:cubicBezTo>
                  <a:cubicBezTo>
                    <a:pt x="1231" y="121"/>
                    <a:pt x="1231" y="121"/>
                    <a:pt x="1231" y="121"/>
                  </a:cubicBezTo>
                  <a:cubicBezTo>
                    <a:pt x="1231" y="121"/>
                    <a:pt x="1227" y="117"/>
                    <a:pt x="1221" y="102"/>
                  </a:cubicBezTo>
                  <a:cubicBezTo>
                    <a:pt x="1216" y="88"/>
                    <a:pt x="1215" y="98"/>
                    <a:pt x="1215" y="98"/>
                  </a:cubicBezTo>
                  <a:cubicBezTo>
                    <a:pt x="1213" y="104"/>
                    <a:pt x="1213" y="104"/>
                    <a:pt x="1213" y="104"/>
                  </a:cubicBezTo>
                  <a:cubicBezTo>
                    <a:pt x="1211" y="110"/>
                    <a:pt x="1211" y="110"/>
                    <a:pt x="1211" y="110"/>
                  </a:cubicBezTo>
                  <a:cubicBezTo>
                    <a:pt x="1205" y="128"/>
                    <a:pt x="1205" y="128"/>
                    <a:pt x="1205" y="128"/>
                  </a:cubicBezTo>
                  <a:cubicBezTo>
                    <a:pt x="1201" y="136"/>
                    <a:pt x="1201" y="136"/>
                    <a:pt x="1201" y="136"/>
                  </a:cubicBezTo>
                  <a:cubicBezTo>
                    <a:pt x="1189" y="145"/>
                    <a:pt x="1189" y="145"/>
                    <a:pt x="1189" y="145"/>
                  </a:cubicBezTo>
                  <a:cubicBezTo>
                    <a:pt x="1183" y="149"/>
                    <a:pt x="1183" y="149"/>
                    <a:pt x="1183" y="149"/>
                  </a:cubicBezTo>
                  <a:cubicBezTo>
                    <a:pt x="1171" y="152"/>
                    <a:pt x="1171" y="152"/>
                    <a:pt x="1171" y="152"/>
                  </a:cubicBezTo>
                  <a:cubicBezTo>
                    <a:pt x="1171" y="152"/>
                    <a:pt x="1156" y="153"/>
                    <a:pt x="1153" y="153"/>
                  </a:cubicBezTo>
                  <a:cubicBezTo>
                    <a:pt x="1150" y="154"/>
                    <a:pt x="1143" y="156"/>
                    <a:pt x="1143" y="146"/>
                  </a:cubicBezTo>
                  <a:cubicBezTo>
                    <a:pt x="1142" y="136"/>
                    <a:pt x="1136" y="144"/>
                    <a:pt x="1136" y="144"/>
                  </a:cubicBezTo>
                  <a:cubicBezTo>
                    <a:pt x="1130" y="151"/>
                    <a:pt x="1130" y="151"/>
                    <a:pt x="1130" y="151"/>
                  </a:cubicBezTo>
                  <a:cubicBezTo>
                    <a:pt x="1120" y="165"/>
                    <a:pt x="1120" y="165"/>
                    <a:pt x="1120" y="165"/>
                  </a:cubicBezTo>
                  <a:cubicBezTo>
                    <a:pt x="1108" y="177"/>
                    <a:pt x="1108" y="177"/>
                    <a:pt x="1108" y="177"/>
                  </a:cubicBezTo>
                  <a:cubicBezTo>
                    <a:pt x="1108" y="177"/>
                    <a:pt x="1101" y="182"/>
                    <a:pt x="1093" y="185"/>
                  </a:cubicBezTo>
                  <a:cubicBezTo>
                    <a:pt x="1086" y="188"/>
                    <a:pt x="1080" y="189"/>
                    <a:pt x="1080" y="189"/>
                  </a:cubicBezTo>
                  <a:cubicBezTo>
                    <a:pt x="1060" y="201"/>
                    <a:pt x="1060" y="201"/>
                    <a:pt x="1060" y="201"/>
                  </a:cubicBezTo>
                  <a:cubicBezTo>
                    <a:pt x="1029" y="214"/>
                    <a:pt x="1029" y="214"/>
                    <a:pt x="1029" y="214"/>
                  </a:cubicBezTo>
                  <a:cubicBezTo>
                    <a:pt x="1029" y="214"/>
                    <a:pt x="1005" y="220"/>
                    <a:pt x="997" y="225"/>
                  </a:cubicBezTo>
                  <a:cubicBezTo>
                    <a:pt x="988" y="230"/>
                    <a:pt x="966" y="234"/>
                    <a:pt x="966" y="234"/>
                  </a:cubicBezTo>
                  <a:cubicBezTo>
                    <a:pt x="937" y="244"/>
                    <a:pt x="937" y="244"/>
                    <a:pt x="937" y="244"/>
                  </a:cubicBezTo>
                  <a:cubicBezTo>
                    <a:pt x="937" y="244"/>
                    <a:pt x="909" y="252"/>
                    <a:pt x="898" y="265"/>
                  </a:cubicBezTo>
                  <a:cubicBezTo>
                    <a:pt x="886" y="279"/>
                    <a:pt x="874" y="268"/>
                    <a:pt x="871" y="275"/>
                  </a:cubicBezTo>
                  <a:cubicBezTo>
                    <a:pt x="868" y="282"/>
                    <a:pt x="856" y="280"/>
                    <a:pt x="847" y="279"/>
                  </a:cubicBezTo>
                  <a:cubicBezTo>
                    <a:pt x="838" y="278"/>
                    <a:pt x="834" y="278"/>
                    <a:pt x="826" y="285"/>
                  </a:cubicBezTo>
                  <a:cubicBezTo>
                    <a:pt x="817" y="291"/>
                    <a:pt x="804" y="298"/>
                    <a:pt x="823" y="298"/>
                  </a:cubicBezTo>
                  <a:cubicBezTo>
                    <a:pt x="843" y="298"/>
                    <a:pt x="831" y="301"/>
                    <a:pt x="816" y="308"/>
                  </a:cubicBezTo>
                  <a:cubicBezTo>
                    <a:pt x="814" y="309"/>
                    <a:pt x="813" y="310"/>
                    <a:pt x="812" y="310"/>
                  </a:cubicBezTo>
                  <a:close/>
                  <a:moveTo>
                    <a:pt x="652" y="329"/>
                  </a:moveTo>
                  <a:cubicBezTo>
                    <a:pt x="652" y="329"/>
                    <a:pt x="665" y="322"/>
                    <a:pt x="658" y="322"/>
                  </a:cubicBezTo>
                  <a:cubicBezTo>
                    <a:pt x="652" y="322"/>
                    <a:pt x="652" y="322"/>
                    <a:pt x="652" y="322"/>
                  </a:cubicBezTo>
                  <a:cubicBezTo>
                    <a:pt x="646" y="324"/>
                    <a:pt x="635" y="331"/>
                    <a:pt x="635" y="331"/>
                  </a:cubicBezTo>
                  <a:cubicBezTo>
                    <a:pt x="635" y="331"/>
                    <a:pt x="629" y="338"/>
                    <a:pt x="638" y="336"/>
                  </a:cubicBezTo>
                  <a:cubicBezTo>
                    <a:pt x="647" y="334"/>
                    <a:pt x="652" y="329"/>
                    <a:pt x="652" y="329"/>
                  </a:cubicBezTo>
                  <a:close/>
                  <a:moveTo>
                    <a:pt x="640" y="348"/>
                  </a:moveTo>
                  <a:cubicBezTo>
                    <a:pt x="640" y="348"/>
                    <a:pt x="654" y="337"/>
                    <a:pt x="634" y="344"/>
                  </a:cubicBezTo>
                  <a:cubicBezTo>
                    <a:pt x="613" y="351"/>
                    <a:pt x="604" y="358"/>
                    <a:pt x="604" y="358"/>
                  </a:cubicBezTo>
                  <a:cubicBezTo>
                    <a:pt x="589" y="368"/>
                    <a:pt x="589" y="368"/>
                    <a:pt x="589" y="368"/>
                  </a:cubicBezTo>
                  <a:cubicBezTo>
                    <a:pt x="589" y="368"/>
                    <a:pt x="564" y="383"/>
                    <a:pt x="581" y="383"/>
                  </a:cubicBezTo>
                  <a:cubicBezTo>
                    <a:pt x="599" y="382"/>
                    <a:pt x="606" y="380"/>
                    <a:pt x="606" y="380"/>
                  </a:cubicBezTo>
                  <a:cubicBezTo>
                    <a:pt x="612" y="380"/>
                    <a:pt x="612" y="380"/>
                    <a:pt x="612" y="380"/>
                  </a:cubicBezTo>
                  <a:cubicBezTo>
                    <a:pt x="612" y="380"/>
                    <a:pt x="618" y="369"/>
                    <a:pt x="619" y="368"/>
                  </a:cubicBezTo>
                  <a:cubicBezTo>
                    <a:pt x="620" y="367"/>
                    <a:pt x="624" y="362"/>
                    <a:pt x="628" y="359"/>
                  </a:cubicBezTo>
                  <a:cubicBezTo>
                    <a:pt x="631" y="356"/>
                    <a:pt x="640" y="348"/>
                    <a:pt x="640" y="348"/>
                  </a:cubicBezTo>
                  <a:close/>
                </a:path>
              </a:pathLst>
            </a:cu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" name="Freeform 33">
              <a:extLst>
                <a:ext uri="{FF2B5EF4-FFF2-40B4-BE49-F238E27FC236}">
                  <a16:creationId xmlns:a16="http://schemas.microsoft.com/office/drawing/2014/main" id="{92501B7B-A030-A320-7E42-58F1879ECCC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9150" y="1508128"/>
              <a:ext cx="1489060" cy="674465"/>
            </a:xfrm>
            <a:custGeom>
              <a:avLst/>
              <a:gdLst>
                <a:gd name="T0" fmla="*/ 326 w 340"/>
                <a:gd name="T1" fmla="*/ 29 h 154"/>
                <a:gd name="T2" fmla="*/ 336 w 340"/>
                <a:gd name="T3" fmla="*/ 44 h 154"/>
                <a:gd name="T4" fmla="*/ 318 w 340"/>
                <a:gd name="T5" fmla="*/ 72 h 154"/>
                <a:gd name="T6" fmla="*/ 248 w 340"/>
                <a:gd name="T7" fmla="*/ 110 h 154"/>
                <a:gd name="T8" fmla="*/ 214 w 340"/>
                <a:gd name="T9" fmla="*/ 118 h 154"/>
                <a:gd name="T10" fmla="*/ 183 w 340"/>
                <a:gd name="T11" fmla="*/ 128 h 154"/>
                <a:gd name="T12" fmla="*/ 120 w 340"/>
                <a:gd name="T13" fmla="*/ 148 h 154"/>
                <a:gd name="T14" fmla="*/ 74 w 340"/>
                <a:gd name="T15" fmla="*/ 152 h 154"/>
                <a:gd name="T16" fmla="*/ 74 w 340"/>
                <a:gd name="T17" fmla="*/ 152 h 154"/>
                <a:gd name="T18" fmla="*/ 63 w 340"/>
                <a:gd name="T19" fmla="*/ 149 h 154"/>
                <a:gd name="T20" fmla="*/ 63 w 340"/>
                <a:gd name="T21" fmla="*/ 149 h 154"/>
                <a:gd name="T22" fmla="*/ 61 w 340"/>
                <a:gd name="T23" fmla="*/ 148 h 154"/>
                <a:gd name="T24" fmla="*/ 11 w 340"/>
                <a:gd name="T25" fmla="*/ 117 h 154"/>
                <a:gd name="T26" fmla="*/ 14 w 340"/>
                <a:gd name="T27" fmla="*/ 105 h 154"/>
                <a:gd name="T28" fmla="*/ 40 w 340"/>
                <a:gd name="T29" fmla="*/ 100 h 154"/>
                <a:gd name="T30" fmla="*/ 81 w 340"/>
                <a:gd name="T31" fmla="*/ 80 h 154"/>
                <a:gd name="T32" fmla="*/ 69 w 340"/>
                <a:gd name="T33" fmla="*/ 80 h 154"/>
                <a:gd name="T34" fmla="*/ 51 w 340"/>
                <a:gd name="T35" fmla="*/ 86 h 154"/>
                <a:gd name="T36" fmla="*/ 49 w 340"/>
                <a:gd name="T37" fmla="*/ 87 h 154"/>
                <a:gd name="T38" fmla="*/ 48 w 340"/>
                <a:gd name="T39" fmla="*/ 76 h 154"/>
                <a:gd name="T40" fmla="*/ 79 w 340"/>
                <a:gd name="T41" fmla="*/ 64 h 154"/>
                <a:gd name="T42" fmla="*/ 158 w 340"/>
                <a:gd name="T43" fmla="*/ 39 h 154"/>
                <a:gd name="T44" fmla="*/ 214 w 340"/>
                <a:gd name="T45" fmla="*/ 19 h 154"/>
                <a:gd name="T46" fmla="*/ 254 w 340"/>
                <a:gd name="T47" fmla="*/ 0 h 154"/>
                <a:gd name="T48" fmla="*/ 266 w 340"/>
                <a:gd name="T49" fmla="*/ 4 h 154"/>
                <a:gd name="T50" fmla="*/ 279 w 340"/>
                <a:gd name="T51" fmla="*/ 6 h 154"/>
                <a:gd name="T52" fmla="*/ 314 w 340"/>
                <a:gd name="T53" fmla="*/ 16 h 154"/>
                <a:gd name="T54" fmla="*/ 326 w 340"/>
                <a:gd name="T55" fmla="*/ 29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40" h="154">
                  <a:moveTo>
                    <a:pt x="326" y="29"/>
                  </a:moveTo>
                  <a:cubicBezTo>
                    <a:pt x="340" y="28"/>
                    <a:pt x="336" y="34"/>
                    <a:pt x="336" y="44"/>
                  </a:cubicBezTo>
                  <a:cubicBezTo>
                    <a:pt x="336" y="53"/>
                    <a:pt x="328" y="60"/>
                    <a:pt x="318" y="72"/>
                  </a:cubicBezTo>
                  <a:cubicBezTo>
                    <a:pt x="308" y="84"/>
                    <a:pt x="248" y="110"/>
                    <a:pt x="248" y="110"/>
                  </a:cubicBezTo>
                  <a:cubicBezTo>
                    <a:pt x="214" y="118"/>
                    <a:pt x="214" y="118"/>
                    <a:pt x="214" y="118"/>
                  </a:cubicBezTo>
                  <a:cubicBezTo>
                    <a:pt x="183" y="128"/>
                    <a:pt x="183" y="128"/>
                    <a:pt x="183" y="128"/>
                  </a:cubicBezTo>
                  <a:cubicBezTo>
                    <a:pt x="183" y="128"/>
                    <a:pt x="151" y="138"/>
                    <a:pt x="120" y="148"/>
                  </a:cubicBezTo>
                  <a:cubicBezTo>
                    <a:pt x="98" y="154"/>
                    <a:pt x="85" y="154"/>
                    <a:pt x="74" y="152"/>
                  </a:cubicBezTo>
                  <a:cubicBezTo>
                    <a:pt x="74" y="152"/>
                    <a:pt x="74" y="152"/>
                    <a:pt x="74" y="152"/>
                  </a:cubicBezTo>
                  <a:cubicBezTo>
                    <a:pt x="70" y="151"/>
                    <a:pt x="66" y="150"/>
                    <a:pt x="63" y="149"/>
                  </a:cubicBezTo>
                  <a:cubicBezTo>
                    <a:pt x="63" y="149"/>
                    <a:pt x="63" y="149"/>
                    <a:pt x="63" y="149"/>
                  </a:cubicBezTo>
                  <a:cubicBezTo>
                    <a:pt x="63" y="149"/>
                    <a:pt x="62" y="148"/>
                    <a:pt x="61" y="148"/>
                  </a:cubicBezTo>
                  <a:cubicBezTo>
                    <a:pt x="50" y="144"/>
                    <a:pt x="22" y="130"/>
                    <a:pt x="11" y="117"/>
                  </a:cubicBezTo>
                  <a:cubicBezTo>
                    <a:pt x="0" y="104"/>
                    <a:pt x="14" y="105"/>
                    <a:pt x="14" y="105"/>
                  </a:cubicBezTo>
                  <a:cubicBezTo>
                    <a:pt x="14" y="105"/>
                    <a:pt x="20" y="104"/>
                    <a:pt x="40" y="100"/>
                  </a:cubicBezTo>
                  <a:cubicBezTo>
                    <a:pt x="60" y="96"/>
                    <a:pt x="63" y="94"/>
                    <a:pt x="81" y="80"/>
                  </a:cubicBezTo>
                  <a:cubicBezTo>
                    <a:pt x="99" y="64"/>
                    <a:pt x="76" y="75"/>
                    <a:pt x="69" y="80"/>
                  </a:cubicBezTo>
                  <a:cubicBezTo>
                    <a:pt x="63" y="84"/>
                    <a:pt x="51" y="86"/>
                    <a:pt x="51" y="86"/>
                  </a:cubicBezTo>
                  <a:cubicBezTo>
                    <a:pt x="51" y="86"/>
                    <a:pt x="51" y="86"/>
                    <a:pt x="49" y="87"/>
                  </a:cubicBezTo>
                  <a:cubicBezTo>
                    <a:pt x="48" y="76"/>
                    <a:pt x="48" y="76"/>
                    <a:pt x="48" y="76"/>
                  </a:cubicBezTo>
                  <a:cubicBezTo>
                    <a:pt x="65" y="73"/>
                    <a:pt x="65" y="72"/>
                    <a:pt x="79" y="64"/>
                  </a:cubicBezTo>
                  <a:cubicBezTo>
                    <a:pt x="98" y="53"/>
                    <a:pt x="151" y="40"/>
                    <a:pt x="158" y="39"/>
                  </a:cubicBezTo>
                  <a:cubicBezTo>
                    <a:pt x="164" y="38"/>
                    <a:pt x="191" y="31"/>
                    <a:pt x="214" y="19"/>
                  </a:cubicBezTo>
                  <a:cubicBezTo>
                    <a:pt x="236" y="7"/>
                    <a:pt x="253" y="1"/>
                    <a:pt x="254" y="0"/>
                  </a:cubicBezTo>
                  <a:cubicBezTo>
                    <a:pt x="250" y="4"/>
                    <a:pt x="265" y="1"/>
                    <a:pt x="266" y="4"/>
                  </a:cubicBezTo>
                  <a:cubicBezTo>
                    <a:pt x="267" y="6"/>
                    <a:pt x="268" y="6"/>
                    <a:pt x="279" y="6"/>
                  </a:cubicBezTo>
                  <a:cubicBezTo>
                    <a:pt x="289" y="6"/>
                    <a:pt x="304" y="10"/>
                    <a:pt x="314" y="16"/>
                  </a:cubicBezTo>
                  <a:cubicBezTo>
                    <a:pt x="324" y="22"/>
                    <a:pt x="312" y="30"/>
                    <a:pt x="326" y="29"/>
                  </a:cubicBezTo>
                  <a:close/>
                </a:path>
              </a:pathLst>
            </a:cu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Freeform 52">
              <a:extLst>
                <a:ext uri="{FF2B5EF4-FFF2-40B4-BE49-F238E27FC236}">
                  <a16:creationId xmlns:a16="http://schemas.microsoft.com/office/drawing/2014/main" id="{999E26B2-F893-CCB7-45CF-DEA2EA3E2C3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6342" y="1417275"/>
              <a:ext cx="1598390" cy="591312"/>
            </a:xfrm>
            <a:custGeom>
              <a:avLst/>
              <a:gdLst>
                <a:gd name="T0" fmla="*/ 364 w 365"/>
                <a:gd name="T1" fmla="*/ 97 h 135"/>
                <a:gd name="T2" fmla="*/ 365 w 365"/>
                <a:gd name="T3" fmla="*/ 108 h 135"/>
                <a:gd name="T4" fmla="*/ 296 w 365"/>
                <a:gd name="T5" fmla="*/ 123 h 135"/>
                <a:gd name="T6" fmla="*/ 229 w 365"/>
                <a:gd name="T7" fmla="*/ 118 h 135"/>
                <a:gd name="T8" fmla="*/ 190 w 365"/>
                <a:gd name="T9" fmla="*/ 91 h 135"/>
                <a:gd name="T10" fmla="*/ 181 w 365"/>
                <a:gd name="T11" fmla="*/ 87 h 135"/>
                <a:gd name="T12" fmla="*/ 165 w 365"/>
                <a:gd name="T13" fmla="*/ 82 h 135"/>
                <a:gd name="T14" fmla="*/ 150 w 365"/>
                <a:gd name="T15" fmla="*/ 78 h 135"/>
                <a:gd name="T16" fmla="*/ 127 w 365"/>
                <a:gd name="T17" fmla="*/ 74 h 135"/>
                <a:gd name="T18" fmla="*/ 116 w 365"/>
                <a:gd name="T19" fmla="*/ 69 h 135"/>
                <a:gd name="T20" fmla="*/ 107 w 365"/>
                <a:gd name="T21" fmla="*/ 65 h 135"/>
                <a:gd name="T22" fmla="*/ 99 w 365"/>
                <a:gd name="T23" fmla="*/ 59 h 135"/>
                <a:gd name="T24" fmla="*/ 89 w 365"/>
                <a:gd name="T25" fmla="*/ 50 h 135"/>
                <a:gd name="T26" fmla="*/ 71 w 365"/>
                <a:gd name="T27" fmla="*/ 40 h 135"/>
                <a:gd name="T28" fmla="*/ 57 w 365"/>
                <a:gd name="T29" fmla="*/ 34 h 135"/>
                <a:gd name="T30" fmla="*/ 45 w 365"/>
                <a:gd name="T31" fmla="*/ 31 h 135"/>
                <a:gd name="T32" fmla="*/ 39 w 365"/>
                <a:gd name="T33" fmla="*/ 27 h 135"/>
                <a:gd name="T34" fmla="*/ 23 w 365"/>
                <a:gd name="T35" fmla="*/ 19 h 135"/>
                <a:gd name="T36" fmla="*/ 0 w 365"/>
                <a:gd name="T37" fmla="*/ 9 h 135"/>
                <a:gd name="T38" fmla="*/ 74 w 365"/>
                <a:gd name="T39" fmla="*/ 13 h 135"/>
                <a:gd name="T40" fmla="*/ 129 w 365"/>
                <a:gd name="T41" fmla="*/ 35 h 135"/>
                <a:gd name="T42" fmla="*/ 218 w 365"/>
                <a:gd name="T43" fmla="*/ 59 h 135"/>
                <a:gd name="T44" fmla="*/ 274 w 365"/>
                <a:gd name="T45" fmla="*/ 88 h 135"/>
                <a:gd name="T46" fmla="*/ 338 w 365"/>
                <a:gd name="T47" fmla="*/ 101 h 135"/>
                <a:gd name="T48" fmla="*/ 364 w 365"/>
                <a:gd name="T49" fmla="*/ 97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365" h="135">
                  <a:moveTo>
                    <a:pt x="364" y="97"/>
                  </a:moveTo>
                  <a:cubicBezTo>
                    <a:pt x="365" y="108"/>
                    <a:pt x="365" y="108"/>
                    <a:pt x="365" y="108"/>
                  </a:cubicBezTo>
                  <a:cubicBezTo>
                    <a:pt x="360" y="109"/>
                    <a:pt x="342" y="113"/>
                    <a:pt x="296" y="123"/>
                  </a:cubicBezTo>
                  <a:cubicBezTo>
                    <a:pt x="239" y="135"/>
                    <a:pt x="229" y="118"/>
                    <a:pt x="229" y="118"/>
                  </a:cubicBezTo>
                  <a:cubicBezTo>
                    <a:pt x="190" y="91"/>
                    <a:pt x="190" y="91"/>
                    <a:pt x="190" y="91"/>
                  </a:cubicBezTo>
                  <a:cubicBezTo>
                    <a:pt x="181" y="87"/>
                    <a:pt x="181" y="87"/>
                    <a:pt x="181" y="87"/>
                  </a:cubicBezTo>
                  <a:cubicBezTo>
                    <a:pt x="165" y="82"/>
                    <a:pt x="165" y="82"/>
                    <a:pt x="165" y="82"/>
                  </a:cubicBezTo>
                  <a:cubicBezTo>
                    <a:pt x="150" y="78"/>
                    <a:pt x="150" y="78"/>
                    <a:pt x="150" y="78"/>
                  </a:cubicBezTo>
                  <a:cubicBezTo>
                    <a:pt x="127" y="74"/>
                    <a:pt x="127" y="74"/>
                    <a:pt x="127" y="74"/>
                  </a:cubicBezTo>
                  <a:cubicBezTo>
                    <a:pt x="116" y="69"/>
                    <a:pt x="116" y="69"/>
                    <a:pt x="116" y="69"/>
                  </a:cubicBezTo>
                  <a:cubicBezTo>
                    <a:pt x="107" y="65"/>
                    <a:pt x="107" y="65"/>
                    <a:pt x="107" y="65"/>
                  </a:cubicBezTo>
                  <a:cubicBezTo>
                    <a:pt x="99" y="59"/>
                    <a:pt x="99" y="59"/>
                    <a:pt x="99" y="59"/>
                  </a:cubicBezTo>
                  <a:cubicBezTo>
                    <a:pt x="89" y="50"/>
                    <a:pt x="89" y="50"/>
                    <a:pt x="89" y="50"/>
                  </a:cubicBezTo>
                  <a:cubicBezTo>
                    <a:pt x="71" y="40"/>
                    <a:pt x="71" y="40"/>
                    <a:pt x="71" y="40"/>
                  </a:cubicBezTo>
                  <a:cubicBezTo>
                    <a:pt x="57" y="34"/>
                    <a:pt x="57" y="34"/>
                    <a:pt x="57" y="34"/>
                  </a:cubicBezTo>
                  <a:cubicBezTo>
                    <a:pt x="45" y="31"/>
                    <a:pt x="45" y="31"/>
                    <a:pt x="45" y="31"/>
                  </a:cubicBezTo>
                  <a:cubicBezTo>
                    <a:pt x="39" y="27"/>
                    <a:pt x="39" y="27"/>
                    <a:pt x="39" y="27"/>
                  </a:cubicBezTo>
                  <a:cubicBezTo>
                    <a:pt x="23" y="19"/>
                    <a:pt x="23" y="19"/>
                    <a:pt x="23" y="19"/>
                  </a:cubicBezTo>
                  <a:cubicBezTo>
                    <a:pt x="0" y="9"/>
                    <a:pt x="0" y="9"/>
                    <a:pt x="0" y="9"/>
                  </a:cubicBezTo>
                  <a:cubicBezTo>
                    <a:pt x="0" y="9"/>
                    <a:pt x="36" y="0"/>
                    <a:pt x="74" y="13"/>
                  </a:cubicBezTo>
                  <a:cubicBezTo>
                    <a:pt x="111" y="27"/>
                    <a:pt x="112" y="32"/>
                    <a:pt x="129" y="35"/>
                  </a:cubicBezTo>
                  <a:cubicBezTo>
                    <a:pt x="146" y="38"/>
                    <a:pt x="200" y="52"/>
                    <a:pt x="218" y="59"/>
                  </a:cubicBezTo>
                  <a:cubicBezTo>
                    <a:pt x="236" y="66"/>
                    <a:pt x="261" y="83"/>
                    <a:pt x="274" y="88"/>
                  </a:cubicBezTo>
                  <a:cubicBezTo>
                    <a:pt x="287" y="94"/>
                    <a:pt x="294" y="108"/>
                    <a:pt x="338" y="101"/>
                  </a:cubicBezTo>
                  <a:cubicBezTo>
                    <a:pt x="350" y="99"/>
                    <a:pt x="358" y="98"/>
                    <a:pt x="364" y="97"/>
                  </a:cubicBezTo>
                  <a:close/>
                </a:path>
              </a:pathLst>
            </a:cu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Freeform 82">
              <a:extLst>
                <a:ext uri="{FF2B5EF4-FFF2-40B4-BE49-F238E27FC236}">
                  <a16:creationId xmlns:a16="http://schemas.microsoft.com/office/drawing/2014/main" id="{6FC5A816-FC9C-916F-EA42-1D845BD8C03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9753" y="3469928"/>
              <a:ext cx="47737" cy="4620"/>
            </a:xfrm>
            <a:custGeom>
              <a:avLst/>
              <a:gdLst>
                <a:gd name="T0" fmla="*/ 11 w 11"/>
                <a:gd name="T1" fmla="*/ 0 h 1"/>
                <a:gd name="T2" fmla="*/ 0 w 11"/>
                <a:gd name="T3" fmla="*/ 1 h 1"/>
                <a:gd name="T4" fmla="*/ 11 w 11"/>
                <a:gd name="T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">
                  <a:moveTo>
                    <a:pt x="11" y="0"/>
                  </a:moveTo>
                  <a:cubicBezTo>
                    <a:pt x="0" y="1"/>
                    <a:pt x="0" y="1"/>
                    <a:pt x="0" y="1"/>
                  </a:cubicBezTo>
                  <a:cubicBezTo>
                    <a:pt x="5" y="1"/>
                    <a:pt x="9" y="0"/>
                    <a:pt x="11" y="0"/>
                  </a:cubicBezTo>
                  <a:close/>
                </a:path>
              </a:pathLst>
            </a:custGeom>
            <a:solidFill>
              <a:srgbClr val="00693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" name="Freeform 83">
              <a:extLst>
                <a:ext uri="{FF2B5EF4-FFF2-40B4-BE49-F238E27FC236}">
                  <a16:creationId xmlns:a16="http://schemas.microsoft.com/office/drawing/2014/main" id="{961E87B5-D13E-19EF-AAC4-5FC4CBD499F6}"/>
                </a:ext>
              </a:extLst>
            </p:cNvPr>
            <p:cNvSpPr>
              <a:spLocks/>
            </p:cNvSpPr>
            <p:nvPr/>
          </p:nvSpPr>
          <p:spPr bwMode="auto">
            <a:xfrm>
              <a:off x="965839" y="3474548"/>
              <a:ext cx="73914" cy="9239"/>
            </a:xfrm>
            <a:custGeom>
              <a:avLst/>
              <a:gdLst>
                <a:gd name="T0" fmla="*/ 17 w 17"/>
                <a:gd name="T1" fmla="*/ 0 h 2"/>
                <a:gd name="T2" fmla="*/ 15 w 17"/>
                <a:gd name="T3" fmla="*/ 0 h 2"/>
                <a:gd name="T4" fmla="*/ 6 w 17"/>
                <a:gd name="T5" fmla="*/ 2 h 2"/>
                <a:gd name="T6" fmla="*/ 5 w 17"/>
                <a:gd name="T7" fmla="*/ 2 h 2"/>
                <a:gd name="T8" fmla="*/ 0 w 17"/>
                <a:gd name="T9" fmla="*/ 2 h 2"/>
                <a:gd name="T10" fmla="*/ 17 w 17"/>
                <a:gd name="T11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7" h="2">
                  <a:moveTo>
                    <a:pt x="17" y="0"/>
                  </a:moveTo>
                  <a:cubicBezTo>
                    <a:pt x="15" y="0"/>
                    <a:pt x="15" y="0"/>
                    <a:pt x="15" y="0"/>
                  </a:cubicBezTo>
                  <a:cubicBezTo>
                    <a:pt x="6" y="2"/>
                    <a:pt x="6" y="2"/>
                    <a:pt x="6" y="2"/>
                  </a:cubicBezTo>
                  <a:cubicBezTo>
                    <a:pt x="5" y="2"/>
                    <a:pt x="5" y="2"/>
                    <a:pt x="5" y="2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5" y="2"/>
                    <a:pt x="11" y="1"/>
                    <a:pt x="17" y="0"/>
                  </a:cubicBezTo>
                  <a:close/>
                </a:path>
              </a:pathLst>
            </a:custGeom>
            <a:solidFill>
              <a:srgbClr val="00693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Freeform 84">
              <a:extLst>
                <a:ext uri="{FF2B5EF4-FFF2-40B4-BE49-F238E27FC236}">
                  <a16:creationId xmlns:a16="http://schemas.microsoft.com/office/drawing/2014/main" id="{6D596BD0-E296-EB37-2DFE-28DAD091294C}"/>
                </a:ext>
              </a:extLst>
            </p:cNvPr>
            <p:cNvSpPr>
              <a:spLocks/>
            </p:cNvSpPr>
            <p:nvPr/>
          </p:nvSpPr>
          <p:spPr bwMode="auto">
            <a:xfrm>
              <a:off x="947360" y="3483787"/>
              <a:ext cx="18479" cy="0"/>
            </a:xfrm>
            <a:custGeom>
              <a:avLst/>
              <a:gdLst>
                <a:gd name="T0" fmla="*/ 4 w 4"/>
                <a:gd name="T1" fmla="*/ 0 w 4"/>
                <a:gd name="T2" fmla="*/ 4 w 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">
                  <a:moveTo>
                    <a:pt x="4" y="0"/>
                  </a:moveTo>
                  <a:cubicBezTo>
                    <a:pt x="3" y="0"/>
                    <a:pt x="1" y="0"/>
                    <a:pt x="0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EE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grpSp>
          <p:nvGrpSpPr>
            <p:cNvPr id="16" name="Gruppieren 15">
              <a:extLst>
                <a:ext uri="{FF2B5EF4-FFF2-40B4-BE49-F238E27FC236}">
                  <a16:creationId xmlns:a16="http://schemas.microsoft.com/office/drawing/2014/main" id="{950EC24F-1D25-DBD5-DCBC-6DD42019D93C}"/>
                </a:ext>
              </a:extLst>
            </p:cNvPr>
            <p:cNvGrpSpPr/>
            <p:nvPr/>
          </p:nvGrpSpPr>
          <p:grpSpPr>
            <a:xfrm>
              <a:off x="2663048" y="300639"/>
              <a:ext cx="2122710" cy="621858"/>
              <a:chOff x="2328753" y="246015"/>
              <a:chExt cx="2122710" cy="621858"/>
            </a:xfrm>
          </p:grpSpPr>
          <p:grpSp>
            <p:nvGrpSpPr>
              <p:cNvPr id="38" name="Gruppieren 37">
                <a:extLst>
                  <a:ext uri="{FF2B5EF4-FFF2-40B4-BE49-F238E27FC236}">
                    <a16:creationId xmlns:a16="http://schemas.microsoft.com/office/drawing/2014/main" id="{81215270-724D-AA4E-0312-7AB9E22A6A39}"/>
                  </a:ext>
                </a:extLst>
              </p:cNvPr>
              <p:cNvGrpSpPr/>
              <p:nvPr/>
            </p:nvGrpSpPr>
            <p:grpSpPr>
              <a:xfrm>
                <a:off x="2328753" y="480355"/>
                <a:ext cx="2122710" cy="387518"/>
                <a:chOff x="3127853" y="7172859"/>
                <a:chExt cx="2019093" cy="399503"/>
              </a:xfrm>
            </p:grpSpPr>
            <p:sp>
              <p:nvSpPr>
                <p:cNvPr id="39" name="Line 292">
                  <a:extLst>
                    <a:ext uri="{FF2B5EF4-FFF2-40B4-BE49-F238E27FC236}">
                      <a16:creationId xmlns:a16="http://schemas.microsoft.com/office/drawing/2014/main" id="{8B42D5DF-5AD6-BFD0-9A87-3D123CD9075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2901" y="7176601"/>
                  <a:ext cx="1781998" cy="0"/>
                </a:xfrm>
                <a:prstGeom prst="line">
                  <a:avLst/>
                </a:prstGeom>
                <a:noFill/>
                <a:ln w="12700" cap="flat">
                  <a:solidFill>
                    <a:srgbClr val="23202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40" name="Line 293">
                  <a:extLst>
                    <a:ext uri="{FF2B5EF4-FFF2-40B4-BE49-F238E27FC236}">
                      <a16:creationId xmlns:a16="http://schemas.microsoft.com/office/drawing/2014/main" id="{AA82E5CB-15DF-57AC-3451-4DBD36DA9D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7663" y="7175240"/>
                  <a:ext cx="0" cy="169387"/>
                </a:xfrm>
                <a:prstGeom prst="line">
                  <a:avLst/>
                </a:prstGeom>
                <a:noFill/>
                <a:ln w="12700" cap="flat">
                  <a:solidFill>
                    <a:srgbClr val="23202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41" name="Line 294">
                  <a:extLst>
                    <a:ext uri="{FF2B5EF4-FFF2-40B4-BE49-F238E27FC236}">
                      <a16:creationId xmlns:a16="http://schemas.microsoft.com/office/drawing/2014/main" id="{9DE34341-71E3-AFBE-A293-0A1366E9E1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42518" y="7172859"/>
                  <a:ext cx="0" cy="169387"/>
                </a:xfrm>
                <a:prstGeom prst="line">
                  <a:avLst/>
                </a:prstGeom>
                <a:noFill/>
                <a:ln w="12700" cap="flat">
                  <a:solidFill>
                    <a:srgbClr val="23202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42" name="Rectangle 295">
                  <a:extLst>
                    <a:ext uri="{FF2B5EF4-FFF2-40B4-BE49-F238E27FC236}">
                      <a16:creationId xmlns:a16="http://schemas.microsoft.com/office/drawing/2014/main" id="{EFD61BC3-797F-D4D8-BE42-0F9F5DD76D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0165" y="7369931"/>
                  <a:ext cx="416781" cy="2000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300" i="0" u="none" strike="noStrike" cap="none" normalizeH="0" baseline="0" dirty="0">
                      <a:ln>
                        <a:noFill/>
                      </a:ln>
                      <a:solidFill>
                        <a:srgbClr val="232021"/>
                      </a:solidFill>
                      <a:effectLst/>
                      <a:latin typeface="+mn-lt"/>
                    </a:rPr>
                    <a:t>30 km</a:t>
                  </a:r>
                  <a:endParaRPr kumimoji="0" lang="de-DE" altLang="de-DE" sz="1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</a:endParaRPr>
                </a:p>
              </p:txBody>
            </p:sp>
            <p:sp>
              <p:nvSpPr>
                <p:cNvPr id="43" name="Rectangle 295">
                  <a:extLst>
                    <a:ext uri="{FF2B5EF4-FFF2-40B4-BE49-F238E27FC236}">
                      <a16:creationId xmlns:a16="http://schemas.microsoft.com/office/drawing/2014/main" id="{58B0AC8C-F5AC-95DE-1749-F62A135D83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27853" y="7372307"/>
                  <a:ext cx="84960" cy="2000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300" i="0" u="none" strike="noStrike" cap="none" normalizeH="0" baseline="0" dirty="0">
                      <a:ln>
                        <a:noFill/>
                      </a:ln>
                      <a:solidFill>
                        <a:srgbClr val="232021"/>
                      </a:solidFill>
                      <a:effectLst/>
                      <a:latin typeface="+mn-lt"/>
                    </a:rPr>
                    <a:t>0</a:t>
                  </a:r>
                  <a:endParaRPr kumimoji="0" lang="de-DE" altLang="de-DE" sz="1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</a:endParaRPr>
                </a:p>
              </p:txBody>
            </p:sp>
          </p:grpSp>
          <p:cxnSp>
            <p:nvCxnSpPr>
              <p:cNvPr id="44" name="Gerade Verbindung mit Pfeil 43">
                <a:extLst>
                  <a:ext uri="{FF2B5EF4-FFF2-40B4-BE49-F238E27FC236}">
                    <a16:creationId xmlns:a16="http://schemas.microsoft.com/office/drawing/2014/main" id="{17A79E9D-FA0A-A4FC-F296-BCEBC0669E99}"/>
                  </a:ext>
                </a:extLst>
              </p:cNvPr>
              <p:cNvCxnSpPr/>
              <p:nvPr/>
            </p:nvCxnSpPr>
            <p:spPr>
              <a:xfrm rot="5340000" flipH="1" flipV="1">
                <a:off x="3048032" y="480015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feld 40">
              <a:extLst>
                <a:ext uri="{FF2B5EF4-FFF2-40B4-BE49-F238E27FC236}">
                  <a16:creationId xmlns:a16="http://schemas.microsoft.com/office/drawing/2014/main" id="{79D2B9DA-4485-8CCA-7895-8BC601358B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1540000">
              <a:off x="1738946" y="2689598"/>
              <a:ext cx="830287" cy="2550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de-DE" sz="1400" i="1" dirty="0" err="1">
                  <a:latin typeface="Calibri" pitchFamily="34" charset="0"/>
                </a:rPr>
                <a:t>Barberton</a:t>
              </a:r>
              <a:endParaRPr lang="de-DE" sz="1400" i="1" dirty="0">
                <a:latin typeface="Calibri" pitchFamily="34" charset="0"/>
              </a:endParaRPr>
            </a:p>
          </p:txBody>
        </p:sp>
        <p:sp>
          <p:nvSpPr>
            <p:cNvPr id="50" name="Ellipse 49">
              <a:extLst>
                <a:ext uri="{FF2B5EF4-FFF2-40B4-BE49-F238E27FC236}">
                  <a16:creationId xmlns:a16="http://schemas.microsoft.com/office/drawing/2014/main" id="{1B9350C2-2300-9715-BD82-C42D94034388}"/>
                </a:ext>
              </a:extLst>
            </p:cNvPr>
            <p:cNvSpPr/>
            <p:nvPr/>
          </p:nvSpPr>
          <p:spPr>
            <a:xfrm rot="21540000">
              <a:off x="2606982" y="2854945"/>
              <a:ext cx="147791" cy="134084"/>
            </a:xfrm>
            <a:prstGeom prst="ellipse">
              <a:avLst/>
            </a:prstGeom>
            <a:solidFill>
              <a:schemeClr val="tx1">
                <a:lumMod val="65000"/>
                <a:lumOff val="3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/>
            </a:p>
          </p:txBody>
        </p:sp>
        <p:grpSp>
          <p:nvGrpSpPr>
            <p:cNvPr id="51" name="Gruppieren 50">
              <a:extLst>
                <a:ext uri="{FF2B5EF4-FFF2-40B4-BE49-F238E27FC236}">
                  <a16:creationId xmlns:a16="http://schemas.microsoft.com/office/drawing/2014/main" id="{CBFD6563-D00F-25A9-C84D-D30CF7009827}"/>
                </a:ext>
              </a:extLst>
            </p:cNvPr>
            <p:cNvGrpSpPr/>
            <p:nvPr/>
          </p:nvGrpSpPr>
          <p:grpSpPr>
            <a:xfrm>
              <a:off x="308451" y="140933"/>
              <a:ext cx="1969501" cy="1559894"/>
              <a:chOff x="7883527" y="2439988"/>
              <a:chExt cx="2030413" cy="1608138"/>
            </a:xfrm>
          </p:grpSpPr>
          <p:sp>
            <p:nvSpPr>
              <p:cNvPr id="52" name="Freeform 267">
                <a:extLst>
                  <a:ext uri="{FF2B5EF4-FFF2-40B4-BE49-F238E27FC236}">
                    <a16:creationId xmlns:a16="http://schemas.microsoft.com/office/drawing/2014/main" id="{5FAE9350-6B7F-CBEF-35BA-6567C7522C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83527" y="2439988"/>
                <a:ext cx="2030413" cy="1603375"/>
              </a:xfrm>
              <a:custGeom>
                <a:avLst/>
                <a:gdLst>
                  <a:gd name="T0" fmla="*/ 1279 w 1279"/>
                  <a:gd name="T1" fmla="*/ 57 h 1010"/>
                  <a:gd name="T2" fmla="*/ 1279 w 1279"/>
                  <a:gd name="T3" fmla="*/ 1010 h 1010"/>
                  <a:gd name="T4" fmla="*/ 366 w 1279"/>
                  <a:gd name="T5" fmla="*/ 1010 h 1010"/>
                  <a:gd name="T6" fmla="*/ 347 w 1279"/>
                  <a:gd name="T7" fmla="*/ 1010 h 1010"/>
                  <a:gd name="T8" fmla="*/ 0 w 1279"/>
                  <a:gd name="T9" fmla="*/ 1010 h 1010"/>
                  <a:gd name="T10" fmla="*/ 0 w 1279"/>
                  <a:gd name="T11" fmla="*/ 137 h 1010"/>
                  <a:gd name="T12" fmla="*/ 0 w 1279"/>
                  <a:gd name="T13" fmla="*/ 80 h 1010"/>
                  <a:gd name="T14" fmla="*/ 0 w 1279"/>
                  <a:gd name="T15" fmla="*/ 0 h 1010"/>
                  <a:gd name="T16" fmla="*/ 474 w 1279"/>
                  <a:gd name="T17" fmla="*/ 0 h 1010"/>
                  <a:gd name="T18" fmla="*/ 810 w 1279"/>
                  <a:gd name="T19" fmla="*/ 0 h 1010"/>
                  <a:gd name="T20" fmla="*/ 858 w 1279"/>
                  <a:gd name="T21" fmla="*/ 0 h 1010"/>
                  <a:gd name="T22" fmla="*/ 1279 w 1279"/>
                  <a:gd name="T23" fmla="*/ 0 h 1010"/>
                  <a:gd name="T24" fmla="*/ 1279 w 1279"/>
                  <a:gd name="T25" fmla="*/ 57 h 10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1279" h="1010">
                    <a:moveTo>
                      <a:pt x="1279" y="57"/>
                    </a:moveTo>
                    <a:lnTo>
                      <a:pt x="1279" y="1010"/>
                    </a:lnTo>
                    <a:lnTo>
                      <a:pt x="366" y="1010"/>
                    </a:lnTo>
                    <a:lnTo>
                      <a:pt x="347" y="1010"/>
                    </a:lnTo>
                    <a:lnTo>
                      <a:pt x="0" y="1010"/>
                    </a:lnTo>
                    <a:lnTo>
                      <a:pt x="0" y="137"/>
                    </a:lnTo>
                    <a:lnTo>
                      <a:pt x="0" y="80"/>
                    </a:lnTo>
                    <a:lnTo>
                      <a:pt x="0" y="0"/>
                    </a:lnTo>
                    <a:lnTo>
                      <a:pt x="474" y="0"/>
                    </a:lnTo>
                    <a:lnTo>
                      <a:pt x="810" y="0"/>
                    </a:lnTo>
                    <a:lnTo>
                      <a:pt x="858" y="0"/>
                    </a:lnTo>
                    <a:lnTo>
                      <a:pt x="1279" y="0"/>
                    </a:lnTo>
                    <a:lnTo>
                      <a:pt x="1279" y="57"/>
                    </a:lnTo>
                    <a:close/>
                  </a:path>
                </a:pathLst>
              </a:custGeom>
              <a:solidFill>
                <a:schemeClr val="bg1">
                  <a:lumMod val="85000"/>
                </a:schemeClr>
              </a:solidFill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" name="Freeform 261">
                <a:extLst>
                  <a:ext uri="{FF2B5EF4-FFF2-40B4-BE49-F238E27FC236}">
                    <a16:creationId xmlns:a16="http://schemas.microsoft.com/office/drawing/2014/main" id="{A9283ECF-05B6-407A-2039-04EF39A517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59790" y="2525714"/>
                <a:ext cx="1449388" cy="1512888"/>
              </a:xfrm>
              <a:custGeom>
                <a:avLst/>
                <a:gdLst>
                  <a:gd name="T0" fmla="*/ 321 w 321"/>
                  <a:gd name="T1" fmla="*/ 0 h 335"/>
                  <a:gd name="T2" fmla="*/ 321 w 321"/>
                  <a:gd name="T3" fmla="*/ 335 h 335"/>
                  <a:gd name="T4" fmla="*/ 0 w 321"/>
                  <a:gd name="T5" fmla="*/ 335 h 335"/>
                  <a:gd name="T6" fmla="*/ 3 w 321"/>
                  <a:gd name="T7" fmla="*/ 330 h 335"/>
                  <a:gd name="T8" fmla="*/ 14 w 321"/>
                  <a:gd name="T9" fmla="*/ 327 h 335"/>
                  <a:gd name="T10" fmla="*/ 26 w 321"/>
                  <a:gd name="T11" fmla="*/ 327 h 335"/>
                  <a:gd name="T12" fmla="*/ 29 w 321"/>
                  <a:gd name="T13" fmla="*/ 324 h 335"/>
                  <a:gd name="T14" fmla="*/ 38 w 321"/>
                  <a:gd name="T15" fmla="*/ 320 h 335"/>
                  <a:gd name="T16" fmla="*/ 56 w 321"/>
                  <a:gd name="T17" fmla="*/ 320 h 335"/>
                  <a:gd name="T18" fmla="*/ 71 w 321"/>
                  <a:gd name="T19" fmla="*/ 322 h 335"/>
                  <a:gd name="T20" fmla="*/ 82 w 321"/>
                  <a:gd name="T21" fmla="*/ 320 h 335"/>
                  <a:gd name="T22" fmla="*/ 96 w 321"/>
                  <a:gd name="T23" fmla="*/ 315 h 335"/>
                  <a:gd name="T24" fmla="*/ 116 w 321"/>
                  <a:gd name="T25" fmla="*/ 305 h 335"/>
                  <a:gd name="T26" fmla="*/ 146 w 321"/>
                  <a:gd name="T27" fmla="*/ 280 h 335"/>
                  <a:gd name="T28" fmla="*/ 172 w 321"/>
                  <a:gd name="T29" fmla="*/ 247 h 335"/>
                  <a:gd name="T30" fmla="*/ 183 w 321"/>
                  <a:gd name="T31" fmla="*/ 229 h 335"/>
                  <a:gd name="T32" fmla="*/ 193 w 321"/>
                  <a:gd name="T33" fmla="*/ 223 h 335"/>
                  <a:gd name="T34" fmla="*/ 200 w 321"/>
                  <a:gd name="T35" fmla="*/ 207 h 335"/>
                  <a:gd name="T36" fmla="*/ 206 w 321"/>
                  <a:gd name="T37" fmla="*/ 191 h 335"/>
                  <a:gd name="T38" fmla="*/ 207 w 321"/>
                  <a:gd name="T39" fmla="*/ 190 h 335"/>
                  <a:gd name="T40" fmla="*/ 206 w 321"/>
                  <a:gd name="T41" fmla="*/ 177 h 335"/>
                  <a:gd name="T42" fmla="*/ 208 w 321"/>
                  <a:gd name="T43" fmla="*/ 165 h 335"/>
                  <a:gd name="T44" fmla="*/ 228 w 321"/>
                  <a:gd name="T45" fmla="*/ 152 h 335"/>
                  <a:gd name="T46" fmla="*/ 250 w 321"/>
                  <a:gd name="T47" fmla="*/ 135 h 335"/>
                  <a:gd name="T48" fmla="*/ 250 w 321"/>
                  <a:gd name="T49" fmla="*/ 120 h 335"/>
                  <a:gd name="T50" fmla="*/ 250 w 321"/>
                  <a:gd name="T51" fmla="*/ 102 h 335"/>
                  <a:gd name="T52" fmla="*/ 245 w 321"/>
                  <a:gd name="T53" fmla="*/ 80 h 335"/>
                  <a:gd name="T54" fmla="*/ 241 w 321"/>
                  <a:gd name="T55" fmla="*/ 70 h 335"/>
                  <a:gd name="T56" fmla="*/ 248 w 321"/>
                  <a:gd name="T57" fmla="*/ 54 h 335"/>
                  <a:gd name="T58" fmla="*/ 268 w 321"/>
                  <a:gd name="T59" fmla="*/ 37 h 335"/>
                  <a:gd name="T60" fmla="*/ 290 w 321"/>
                  <a:gd name="T61" fmla="*/ 15 h 335"/>
                  <a:gd name="T62" fmla="*/ 303 w 321"/>
                  <a:gd name="T63" fmla="*/ 7 h 335"/>
                  <a:gd name="T64" fmla="*/ 321 w 321"/>
                  <a:gd name="T65" fmla="*/ 0 h 3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321" h="335">
                    <a:moveTo>
                      <a:pt x="321" y="0"/>
                    </a:moveTo>
                    <a:cubicBezTo>
                      <a:pt x="321" y="335"/>
                      <a:pt x="321" y="335"/>
                      <a:pt x="321" y="335"/>
                    </a:cubicBezTo>
                    <a:cubicBezTo>
                      <a:pt x="0" y="335"/>
                      <a:pt x="0" y="335"/>
                      <a:pt x="0" y="335"/>
                    </a:cubicBezTo>
                    <a:cubicBezTo>
                      <a:pt x="0" y="335"/>
                      <a:pt x="1" y="331"/>
                      <a:pt x="3" y="330"/>
                    </a:cubicBezTo>
                    <a:cubicBezTo>
                      <a:pt x="6" y="328"/>
                      <a:pt x="10" y="327"/>
                      <a:pt x="14" y="327"/>
                    </a:cubicBezTo>
                    <a:cubicBezTo>
                      <a:pt x="18" y="327"/>
                      <a:pt x="26" y="327"/>
                      <a:pt x="26" y="327"/>
                    </a:cubicBezTo>
                    <a:cubicBezTo>
                      <a:pt x="26" y="327"/>
                      <a:pt x="29" y="325"/>
                      <a:pt x="29" y="324"/>
                    </a:cubicBezTo>
                    <a:cubicBezTo>
                      <a:pt x="29" y="322"/>
                      <a:pt x="33" y="321"/>
                      <a:pt x="38" y="320"/>
                    </a:cubicBezTo>
                    <a:cubicBezTo>
                      <a:pt x="42" y="319"/>
                      <a:pt x="53" y="321"/>
                      <a:pt x="56" y="320"/>
                    </a:cubicBezTo>
                    <a:cubicBezTo>
                      <a:pt x="59" y="319"/>
                      <a:pt x="69" y="322"/>
                      <a:pt x="71" y="322"/>
                    </a:cubicBezTo>
                    <a:cubicBezTo>
                      <a:pt x="72" y="323"/>
                      <a:pt x="80" y="322"/>
                      <a:pt x="82" y="320"/>
                    </a:cubicBezTo>
                    <a:cubicBezTo>
                      <a:pt x="85" y="318"/>
                      <a:pt x="93" y="315"/>
                      <a:pt x="96" y="315"/>
                    </a:cubicBezTo>
                    <a:cubicBezTo>
                      <a:pt x="99" y="315"/>
                      <a:pt x="105" y="316"/>
                      <a:pt x="116" y="305"/>
                    </a:cubicBezTo>
                    <a:cubicBezTo>
                      <a:pt x="128" y="295"/>
                      <a:pt x="146" y="280"/>
                      <a:pt x="146" y="280"/>
                    </a:cubicBezTo>
                    <a:cubicBezTo>
                      <a:pt x="172" y="247"/>
                      <a:pt x="172" y="247"/>
                      <a:pt x="172" y="247"/>
                    </a:cubicBezTo>
                    <a:cubicBezTo>
                      <a:pt x="183" y="229"/>
                      <a:pt x="183" y="229"/>
                      <a:pt x="183" y="229"/>
                    </a:cubicBezTo>
                    <a:cubicBezTo>
                      <a:pt x="183" y="229"/>
                      <a:pt x="192" y="223"/>
                      <a:pt x="193" y="223"/>
                    </a:cubicBezTo>
                    <a:cubicBezTo>
                      <a:pt x="195" y="223"/>
                      <a:pt x="198" y="219"/>
                      <a:pt x="200" y="207"/>
                    </a:cubicBezTo>
                    <a:cubicBezTo>
                      <a:pt x="202" y="195"/>
                      <a:pt x="203" y="194"/>
                      <a:pt x="206" y="191"/>
                    </a:cubicBezTo>
                    <a:cubicBezTo>
                      <a:pt x="207" y="191"/>
                      <a:pt x="207" y="190"/>
                      <a:pt x="207" y="190"/>
                    </a:cubicBezTo>
                    <a:cubicBezTo>
                      <a:pt x="208" y="186"/>
                      <a:pt x="206" y="179"/>
                      <a:pt x="206" y="177"/>
                    </a:cubicBezTo>
                    <a:cubicBezTo>
                      <a:pt x="206" y="176"/>
                      <a:pt x="197" y="175"/>
                      <a:pt x="208" y="165"/>
                    </a:cubicBezTo>
                    <a:cubicBezTo>
                      <a:pt x="218" y="155"/>
                      <a:pt x="224" y="152"/>
                      <a:pt x="228" y="152"/>
                    </a:cubicBezTo>
                    <a:cubicBezTo>
                      <a:pt x="232" y="151"/>
                      <a:pt x="249" y="145"/>
                      <a:pt x="250" y="135"/>
                    </a:cubicBezTo>
                    <a:cubicBezTo>
                      <a:pt x="250" y="125"/>
                      <a:pt x="246" y="124"/>
                      <a:pt x="250" y="120"/>
                    </a:cubicBezTo>
                    <a:cubicBezTo>
                      <a:pt x="253" y="115"/>
                      <a:pt x="251" y="109"/>
                      <a:pt x="250" y="102"/>
                    </a:cubicBezTo>
                    <a:cubicBezTo>
                      <a:pt x="248" y="95"/>
                      <a:pt x="245" y="80"/>
                      <a:pt x="245" y="80"/>
                    </a:cubicBezTo>
                    <a:cubicBezTo>
                      <a:pt x="245" y="80"/>
                      <a:pt x="246" y="75"/>
                      <a:pt x="241" y="70"/>
                    </a:cubicBezTo>
                    <a:cubicBezTo>
                      <a:pt x="235" y="65"/>
                      <a:pt x="245" y="59"/>
                      <a:pt x="248" y="54"/>
                    </a:cubicBezTo>
                    <a:cubicBezTo>
                      <a:pt x="252" y="50"/>
                      <a:pt x="268" y="37"/>
                      <a:pt x="268" y="37"/>
                    </a:cubicBezTo>
                    <a:cubicBezTo>
                      <a:pt x="290" y="15"/>
                      <a:pt x="290" y="15"/>
                      <a:pt x="290" y="15"/>
                    </a:cubicBezTo>
                    <a:cubicBezTo>
                      <a:pt x="290" y="15"/>
                      <a:pt x="298" y="8"/>
                      <a:pt x="303" y="7"/>
                    </a:cubicBezTo>
                    <a:cubicBezTo>
                      <a:pt x="308" y="5"/>
                      <a:pt x="321" y="0"/>
                      <a:pt x="321" y="0"/>
                    </a:cubicBezTo>
                    <a:close/>
                  </a:path>
                </a:pathLst>
              </a:custGeom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4" name="Freeform 262">
                <a:extLst>
                  <a:ext uri="{FF2B5EF4-FFF2-40B4-BE49-F238E27FC236}">
                    <a16:creationId xmlns:a16="http://schemas.microsoft.com/office/drawing/2014/main" id="{6F6AC47B-2257-2698-F39D-0572F5CEA92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207377" y="2987676"/>
                <a:ext cx="1192213" cy="1055688"/>
              </a:xfrm>
              <a:custGeom>
                <a:avLst/>
                <a:gdLst>
                  <a:gd name="T0" fmla="*/ 263 w 264"/>
                  <a:gd name="T1" fmla="*/ 90 h 234"/>
                  <a:gd name="T2" fmla="*/ 250 w 264"/>
                  <a:gd name="T3" fmla="*/ 122 h 234"/>
                  <a:gd name="T4" fmla="*/ 229 w 264"/>
                  <a:gd name="T5" fmla="*/ 146 h 234"/>
                  <a:gd name="T6" fmla="*/ 173 w 264"/>
                  <a:gd name="T7" fmla="*/ 204 h 234"/>
                  <a:gd name="T8" fmla="*/ 139 w 264"/>
                  <a:gd name="T9" fmla="*/ 219 h 234"/>
                  <a:gd name="T10" fmla="*/ 113 w 264"/>
                  <a:gd name="T11" fmla="*/ 219 h 234"/>
                  <a:gd name="T12" fmla="*/ 86 w 264"/>
                  <a:gd name="T13" fmla="*/ 223 h 234"/>
                  <a:gd name="T14" fmla="*/ 71 w 264"/>
                  <a:gd name="T15" fmla="*/ 226 h 234"/>
                  <a:gd name="T16" fmla="*/ 57 w 264"/>
                  <a:gd name="T17" fmla="*/ 234 h 234"/>
                  <a:gd name="T18" fmla="*/ 48 w 264"/>
                  <a:gd name="T19" fmla="*/ 231 h 234"/>
                  <a:gd name="T20" fmla="*/ 36 w 264"/>
                  <a:gd name="T21" fmla="*/ 222 h 234"/>
                  <a:gd name="T22" fmla="*/ 31 w 264"/>
                  <a:gd name="T23" fmla="*/ 217 h 234"/>
                  <a:gd name="T24" fmla="*/ 23 w 264"/>
                  <a:gd name="T25" fmla="*/ 199 h 234"/>
                  <a:gd name="T26" fmla="*/ 29 w 264"/>
                  <a:gd name="T27" fmla="*/ 194 h 234"/>
                  <a:gd name="T28" fmla="*/ 20 w 264"/>
                  <a:gd name="T29" fmla="*/ 162 h 234"/>
                  <a:gd name="T30" fmla="*/ 0 w 264"/>
                  <a:gd name="T31" fmla="*/ 118 h 234"/>
                  <a:gd name="T32" fmla="*/ 19 w 264"/>
                  <a:gd name="T33" fmla="*/ 119 h 234"/>
                  <a:gd name="T34" fmla="*/ 47 w 264"/>
                  <a:gd name="T35" fmla="*/ 121 h 234"/>
                  <a:gd name="T36" fmla="*/ 57 w 264"/>
                  <a:gd name="T37" fmla="*/ 110 h 234"/>
                  <a:gd name="T38" fmla="*/ 68 w 264"/>
                  <a:gd name="T39" fmla="*/ 56 h 234"/>
                  <a:gd name="T40" fmla="*/ 70 w 264"/>
                  <a:gd name="T41" fmla="*/ 79 h 234"/>
                  <a:gd name="T42" fmla="*/ 79 w 264"/>
                  <a:gd name="T43" fmla="*/ 86 h 234"/>
                  <a:gd name="T44" fmla="*/ 106 w 264"/>
                  <a:gd name="T45" fmla="*/ 60 h 234"/>
                  <a:gd name="T46" fmla="*/ 122 w 264"/>
                  <a:gd name="T47" fmla="*/ 62 h 234"/>
                  <a:gd name="T48" fmla="*/ 153 w 264"/>
                  <a:gd name="T49" fmla="*/ 56 h 234"/>
                  <a:gd name="T50" fmla="*/ 171 w 264"/>
                  <a:gd name="T51" fmla="*/ 31 h 234"/>
                  <a:gd name="T52" fmla="*/ 186 w 264"/>
                  <a:gd name="T53" fmla="*/ 15 h 234"/>
                  <a:gd name="T54" fmla="*/ 208 w 264"/>
                  <a:gd name="T55" fmla="*/ 0 h 234"/>
                  <a:gd name="T56" fmla="*/ 242 w 264"/>
                  <a:gd name="T57" fmla="*/ 2 h 234"/>
                  <a:gd name="T58" fmla="*/ 244 w 264"/>
                  <a:gd name="T59" fmla="*/ 14 h 234"/>
                  <a:gd name="T60" fmla="*/ 246 w 264"/>
                  <a:gd name="T61" fmla="*/ 28 h 234"/>
                  <a:gd name="T62" fmla="*/ 248 w 264"/>
                  <a:gd name="T63" fmla="*/ 34 h 234"/>
                  <a:gd name="T64" fmla="*/ 250 w 264"/>
                  <a:gd name="T65" fmla="*/ 63 h 234"/>
                  <a:gd name="T66" fmla="*/ 246 w 264"/>
                  <a:gd name="T67" fmla="*/ 68 h 234"/>
                  <a:gd name="T68" fmla="*/ 239 w 264"/>
                  <a:gd name="T69" fmla="*/ 70 h 234"/>
                  <a:gd name="T70" fmla="*/ 238 w 264"/>
                  <a:gd name="T71" fmla="*/ 74 h 234"/>
                  <a:gd name="T72" fmla="*/ 233 w 264"/>
                  <a:gd name="T73" fmla="*/ 79 h 234"/>
                  <a:gd name="T74" fmla="*/ 232 w 264"/>
                  <a:gd name="T75" fmla="*/ 87 h 234"/>
                  <a:gd name="T76" fmla="*/ 238 w 264"/>
                  <a:gd name="T77" fmla="*/ 92 h 234"/>
                  <a:gd name="T78" fmla="*/ 243 w 264"/>
                  <a:gd name="T79" fmla="*/ 94 h 234"/>
                  <a:gd name="T80" fmla="*/ 248 w 264"/>
                  <a:gd name="T81" fmla="*/ 92 h 234"/>
                  <a:gd name="T82" fmla="*/ 250 w 264"/>
                  <a:gd name="T83" fmla="*/ 89 h 234"/>
                  <a:gd name="T84" fmla="*/ 255 w 264"/>
                  <a:gd name="T85" fmla="*/ 89 h 234"/>
                  <a:gd name="T86" fmla="*/ 206 w 264"/>
                  <a:gd name="T87" fmla="*/ 133 h 234"/>
                  <a:gd name="T88" fmla="*/ 204 w 264"/>
                  <a:gd name="T89" fmla="*/ 126 h 234"/>
                  <a:gd name="T90" fmla="*/ 197 w 264"/>
                  <a:gd name="T91" fmla="*/ 119 h 234"/>
                  <a:gd name="T92" fmla="*/ 190 w 264"/>
                  <a:gd name="T93" fmla="*/ 119 h 234"/>
                  <a:gd name="T94" fmla="*/ 184 w 264"/>
                  <a:gd name="T95" fmla="*/ 124 h 234"/>
                  <a:gd name="T96" fmla="*/ 178 w 264"/>
                  <a:gd name="T97" fmla="*/ 129 h 234"/>
                  <a:gd name="T98" fmla="*/ 174 w 264"/>
                  <a:gd name="T99" fmla="*/ 133 h 234"/>
                  <a:gd name="T100" fmla="*/ 169 w 264"/>
                  <a:gd name="T101" fmla="*/ 139 h 234"/>
                  <a:gd name="T102" fmla="*/ 172 w 264"/>
                  <a:gd name="T103" fmla="*/ 148 h 234"/>
                  <a:gd name="T104" fmla="*/ 179 w 264"/>
                  <a:gd name="T105" fmla="*/ 156 h 234"/>
                  <a:gd name="T106" fmla="*/ 184 w 264"/>
                  <a:gd name="T107" fmla="*/ 156 h 234"/>
                  <a:gd name="T108" fmla="*/ 186 w 264"/>
                  <a:gd name="T109" fmla="*/ 149 h 234"/>
                  <a:gd name="T110" fmla="*/ 191 w 264"/>
                  <a:gd name="T111" fmla="*/ 146 h 234"/>
                  <a:gd name="T112" fmla="*/ 197 w 264"/>
                  <a:gd name="T113" fmla="*/ 146 h 234"/>
                  <a:gd name="T114" fmla="*/ 202 w 264"/>
                  <a:gd name="T115" fmla="*/ 141 h 234"/>
                  <a:gd name="T116" fmla="*/ 206 w 264"/>
                  <a:gd name="T117" fmla="*/ 133 h 2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264" h="234">
                    <a:moveTo>
                      <a:pt x="264" y="89"/>
                    </a:moveTo>
                    <a:cubicBezTo>
                      <a:pt x="264" y="89"/>
                      <a:pt x="264" y="90"/>
                      <a:pt x="263" y="90"/>
                    </a:cubicBezTo>
                    <a:cubicBezTo>
                      <a:pt x="260" y="93"/>
                      <a:pt x="259" y="94"/>
                      <a:pt x="257" y="106"/>
                    </a:cubicBezTo>
                    <a:cubicBezTo>
                      <a:pt x="255" y="118"/>
                      <a:pt x="252" y="122"/>
                      <a:pt x="250" y="122"/>
                    </a:cubicBezTo>
                    <a:cubicBezTo>
                      <a:pt x="249" y="122"/>
                      <a:pt x="240" y="128"/>
                      <a:pt x="240" y="128"/>
                    </a:cubicBezTo>
                    <a:cubicBezTo>
                      <a:pt x="229" y="146"/>
                      <a:pt x="229" y="146"/>
                      <a:pt x="229" y="146"/>
                    </a:cubicBezTo>
                    <a:cubicBezTo>
                      <a:pt x="203" y="179"/>
                      <a:pt x="203" y="179"/>
                      <a:pt x="203" y="179"/>
                    </a:cubicBezTo>
                    <a:cubicBezTo>
                      <a:pt x="203" y="179"/>
                      <a:pt x="185" y="194"/>
                      <a:pt x="173" y="204"/>
                    </a:cubicBezTo>
                    <a:cubicBezTo>
                      <a:pt x="162" y="215"/>
                      <a:pt x="156" y="214"/>
                      <a:pt x="153" y="214"/>
                    </a:cubicBezTo>
                    <a:cubicBezTo>
                      <a:pt x="150" y="214"/>
                      <a:pt x="142" y="217"/>
                      <a:pt x="139" y="219"/>
                    </a:cubicBezTo>
                    <a:cubicBezTo>
                      <a:pt x="137" y="221"/>
                      <a:pt x="129" y="222"/>
                      <a:pt x="128" y="221"/>
                    </a:cubicBezTo>
                    <a:cubicBezTo>
                      <a:pt x="126" y="221"/>
                      <a:pt x="116" y="218"/>
                      <a:pt x="113" y="219"/>
                    </a:cubicBezTo>
                    <a:cubicBezTo>
                      <a:pt x="110" y="220"/>
                      <a:pt x="99" y="218"/>
                      <a:pt x="95" y="219"/>
                    </a:cubicBezTo>
                    <a:cubicBezTo>
                      <a:pt x="90" y="220"/>
                      <a:pt x="86" y="221"/>
                      <a:pt x="86" y="223"/>
                    </a:cubicBezTo>
                    <a:cubicBezTo>
                      <a:pt x="86" y="224"/>
                      <a:pt x="83" y="226"/>
                      <a:pt x="83" y="226"/>
                    </a:cubicBezTo>
                    <a:cubicBezTo>
                      <a:pt x="83" y="226"/>
                      <a:pt x="75" y="226"/>
                      <a:pt x="71" y="226"/>
                    </a:cubicBezTo>
                    <a:cubicBezTo>
                      <a:pt x="67" y="226"/>
                      <a:pt x="63" y="227"/>
                      <a:pt x="60" y="229"/>
                    </a:cubicBezTo>
                    <a:cubicBezTo>
                      <a:pt x="58" y="230"/>
                      <a:pt x="57" y="234"/>
                      <a:pt x="57" y="234"/>
                    </a:cubicBezTo>
                    <a:cubicBezTo>
                      <a:pt x="50" y="234"/>
                      <a:pt x="50" y="234"/>
                      <a:pt x="50" y="234"/>
                    </a:cubicBezTo>
                    <a:cubicBezTo>
                      <a:pt x="48" y="231"/>
                      <a:pt x="48" y="231"/>
                      <a:pt x="48" y="231"/>
                    </a:cubicBezTo>
                    <a:cubicBezTo>
                      <a:pt x="42" y="226"/>
                      <a:pt x="42" y="226"/>
                      <a:pt x="42" y="226"/>
                    </a:cubicBezTo>
                    <a:cubicBezTo>
                      <a:pt x="42" y="226"/>
                      <a:pt x="39" y="223"/>
                      <a:pt x="36" y="222"/>
                    </a:cubicBezTo>
                    <a:cubicBezTo>
                      <a:pt x="34" y="222"/>
                      <a:pt x="31" y="222"/>
                      <a:pt x="31" y="222"/>
                    </a:cubicBezTo>
                    <a:cubicBezTo>
                      <a:pt x="31" y="217"/>
                      <a:pt x="31" y="217"/>
                      <a:pt x="31" y="217"/>
                    </a:cubicBezTo>
                    <a:cubicBezTo>
                      <a:pt x="29" y="206"/>
                      <a:pt x="29" y="206"/>
                      <a:pt x="29" y="206"/>
                    </a:cubicBezTo>
                    <a:cubicBezTo>
                      <a:pt x="29" y="206"/>
                      <a:pt x="24" y="203"/>
                      <a:pt x="23" y="199"/>
                    </a:cubicBezTo>
                    <a:cubicBezTo>
                      <a:pt x="21" y="194"/>
                      <a:pt x="24" y="195"/>
                      <a:pt x="26" y="194"/>
                    </a:cubicBezTo>
                    <a:cubicBezTo>
                      <a:pt x="28" y="194"/>
                      <a:pt x="29" y="194"/>
                      <a:pt x="29" y="194"/>
                    </a:cubicBezTo>
                    <a:cubicBezTo>
                      <a:pt x="29" y="194"/>
                      <a:pt x="29" y="189"/>
                      <a:pt x="29" y="184"/>
                    </a:cubicBezTo>
                    <a:cubicBezTo>
                      <a:pt x="28" y="178"/>
                      <a:pt x="23" y="166"/>
                      <a:pt x="20" y="162"/>
                    </a:cubicBezTo>
                    <a:cubicBezTo>
                      <a:pt x="18" y="157"/>
                      <a:pt x="14" y="152"/>
                      <a:pt x="12" y="145"/>
                    </a:cubicBezTo>
                    <a:cubicBezTo>
                      <a:pt x="11" y="138"/>
                      <a:pt x="2" y="121"/>
                      <a:pt x="0" y="118"/>
                    </a:cubicBezTo>
                    <a:cubicBezTo>
                      <a:pt x="1" y="119"/>
                      <a:pt x="4" y="123"/>
                      <a:pt x="8" y="113"/>
                    </a:cubicBezTo>
                    <a:cubicBezTo>
                      <a:pt x="12" y="103"/>
                      <a:pt x="16" y="115"/>
                      <a:pt x="19" y="119"/>
                    </a:cubicBezTo>
                    <a:cubicBezTo>
                      <a:pt x="21" y="123"/>
                      <a:pt x="35" y="124"/>
                      <a:pt x="35" y="124"/>
                    </a:cubicBezTo>
                    <a:cubicBezTo>
                      <a:pt x="35" y="124"/>
                      <a:pt x="46" y="125"/>
                      <a:pt x="47" y="121"/>
                    </a:cubicBezTo>
                    <a:cubicBezTo>
                      <a:pt x="48" y="118"/>
                      <a:pt x="57" y="115"/>
                      <a:pt x="57" y="115"/>
                    </a:cubicBezTo>
                    <a:cubicBezTo>
                      <a:pt x="57" y="110"/>
                      <a:pt x="57" y="110"/>
                      <a:pt x="57" y="110"/>
                    </a:cubicBezTo>
                    <a:cubicBezTo>
                      <a:pt x="60" y="49"/>
                      <a:pt x="60" y="49"/>
                      <a:pt x="60" y="49"/>
                    </a:cubicBezTo>
                    <a:cubicBezTo>
                      <a:pt x="60" y="49"/>
                      <a:pt x="66" y="53"/>
                      <a:pt x="68" y="56"/>
                    </a:cubicBezTo>
                    <a:cubicBezTo>
                      <a:pt x="70" y="60"/>
                      <a:pt x="73" y="66"/>
                      <a:pt x="72" y="70"/>
                    </a:cubicBezTo>
                    <a:cubicBezTo>
                      <a:pt x="72" y="74"/>
                      <a:pt x="71" y="74"/>
                      <a:pt x="70" y="79"/>
                    </a:cubicBezTo>
                    <a:cubicBezTo>
                      <a:pt x="69" y="83"/>
                      <a:pt x="68" y="86"/>
                      <a:pt x="70" y="86"/>
                    </a:cubicBezTo>
                    <a:cubicBezTo>
                      <a:pt x="72" y="87"/>
                      <a:pt x="76" y="86"/>
                      <a:pt x="79" y="86"/>
                    </a:cubicBezTo>
                    <a:cubicBezTo>
                      <a:pt x="82" y="86"/>
                      <a:pt x="89" y="87"/>
                      <a:pt x="97" y="77"/>
                    </a:cubicBezTo>
                    <a:cubicBezTo>
                      <a:pt x="105" y="67"/>
                      <a:pt x="106" y="61"/>
                      <a:pt x="106" y="60"/>
                    </a:cubicBezTo>
                    <a:cubicBezTo>
                      <a:pt x="105" y="58"/>
                      <a:pt x="108" y="57"/>
                      <a:pt x="111" y="56"/>
                    </a:cubicBezTo>
                    <a:cubicBezTo>
                      <a:pt x="114" y="56"/>
                      <a:pt x="120" y="61"/>
                      <a:pt x="122" y="62"/>
                    </a:cubicBezTo>
                    <a:cubicBezTo>
                      <a:pt x="124" y="64"/>
                      <a:pt x="132" y="68"/>
                      <a:pt x="139" y="66"/>
                    </a:cubicBezTo>
                    <a:cubicBezTo>
                      <a:pt x="146" y="65"/>
                      <a:pt x="153" y="61"/>
                      <a:pt x="153" y="56"/>
                    </a:cubicBezTo>
                    <a:cubicBezTo>
                      <a:pt x="153" y="52"/>
                      <a:pt x="167" y="40"/>
                      <a:pt x="168" y="41"/>
                    </a:cubicBezTo>
                    <a:cubicBezTo>
                      <a:pt x="169" y="42"/>
                      <a:pt x="170" y="35"/>
                      <a:pt x="171" y="31"/>
                    </a:cubicBezTo>
                    <a:cubicBezTo>
                      <a:pt x="172" y="28"/>
                      <a:pt x="173" y="26"/>
                      <a:pt x="175" y="24"/>
                    </a:cubicBezTo>
                    <a:cubicBezTo>
                      <a:pt x="178" y="22"/>
                      <a:pt x="183" y="20"/>
                      <a:pt x="186" y="15"/>
                    </a:cubicBezTo>
                    <a:cubicBezTo>
                      <a:pt x="190" y="11"/>
                      <a:pt x="192" y="8"/>
                      <a:pt x="194" y="8"/>
                    </a:cubicBezTo>
                    <a:cubicBezTo>
                      <a:pt x="196" y="8"/>
                      <a:pt x="208" y="1"/>
                      <a:pt x="208" y="0"/>
                    </a:cubicBezTo>
                    <a:cubicBezTo>
                      <a:pt x="217" y="2"/>
                      <a:pt x="217" y="2"/>
                      <a:pt x="217" y="2"/>
                    </a:cubicBezTo>
                    <a:cubicBezTo>
                      <a:pt x="242" y="2"/>
                      <a:pt x="242" y="2"/>
                      <a:pt x="242" y="2"/>
                    </a:cubicBezTo>
                    <a:cubicBezTo>
                      <a:pt x="242" y="2"/>
                      <a:pt x="240" y="6"/>
                      <a:pt x="242" y="8"/>
                    </a:cubicBezTo>
                    <a:cubicBezTo>
                      <a:pt x="243" y="9"/>
                      <a:pt x="244" y="14"/>
                      <a:pt x="244" y="14"/>
                    </a:cubicBezTo>
                    <a:cubicBezTo>
                      <a:pt x="244" y="14"/>
                      <a:pt x="244" y="16"/>
                      <a:pt x="245" y="19"/>
                    </a:cubicBezTo>
                    <a:cubicBezTo>
                      <a:pt x="245" y="22"/>
                      <a:pt x="245" y="27"/>
                      <a:pt x="246" y="28"/>
                    </a:cubicBezTo>
                    <a:cubicBezTo>
                      <a:pt x="247" y="29"/>
                      <a:pt x="248" y="32"/>
                      <a:pt x="248" y="32"/>
                    </a:cubicBezTo>
                    <a:cubicBezTo>
                      <a:pt x="248" y="34"/>
                      <a:pt x="248" y="34"/>
                      <a:pt x="248" y="34"/>
                    </a:cubicBezTo>
                    <a:cubicBezTo>
                      <a:pt x="248" y="51"/>
                      <a:pt x="248" y="51"/>
                      <a:pt x="248" y="51"/>
                    </a:cubicBezTo>
                    <a:cubicBezTo>
                      <a:pt x="250" y="63"/>
                      <a:pt x="250" y="63"/>
                      <a:pt x="250" y="63"/>
                    </a:cubicBezTo>
                    <a:cubicBezTo>
                      <a:pt x="250" y="70"/>
                      <a:pt x="250" y="70"/>
                      <a:pt x="250" y="70"/>
                    </a:cubicBezTo>
                    <a:cubicBezTo>
                      <a:pt x="246" y="68"/>
                      <a:pt x="246" y="68"/>
                      <a:pt x="246" y="68"/>
                    </a:cubicBezTo>
                    <a:cubicBezTo>
                      <a:pt x="241" y="68"/>
                      <a:pt x="241" y="68"/>
                      <a:pt x="241" y="68"/>
                    </a:cubicBezTo>
                    <a:cubicBezTo>
                      <a:pt x="239" y="70"/>
                      <a:pt x="239" y="70"/>
                      <a:pt x="239" y="70"/>
                    </a:cubicBezTo>
                    <a:cubicBezTo>
                      <a:pt x="239" y="70"/>
                      <a:pt x="238" y="71"/>
                      <a:pt x="238" y="72"/>
                    </a:cubicBezTo>
                    <a:cubicBezTo>
                      <a:pt x="237" y="73"/>
                      <a:pt x="239" y="73"/>
                      <a:pt x="238" y="74"/>
                    </a:cubicBezTo>
                    <a:cubicBezTo>
                      <a:pt x="236" y="75"/>
                      <a:pt x="234" y="77"/>
                      <a:pt x="234" y="77"/>
                    </a:cubicBezTo>
                    <a:cubicBezTo>
                      <a:pt x="233" y="79"/>
                      <a:pt x="233" y="79"/>
                      <a:pt x="233" y="79"/>
                    </a:cubicBezTo>
                    <a:cubicBezTo>
                      <a:pt x="233" y="79"/>
                      <a:pt x="234" y="81"/>
                      <a:pt x="233" y="82"/>
                    </a:cubicBezTo>
                    <a:cubicBezTo>
                      <a:pt x="232" y="83"/>
                      <a:pt x="232" y="87"/>
                      <a:pt x="232" y="87"/>
                    </a:cubicBezTo>
                    <a:cubicBezTo>
                      <a:pt x="232" y="87"/>
                      <a:pt x="234" y="90"/>
                      <a:pt x="235" y="90"/>
                    </a:cubicBezTo>
                    <a:cubicBezTo>
                      <a:pt x="236" y="91"/>
                      <a:pt x="238" y="92"/>
                      <a:pt x="238" y="92"/>
                    </a:cubicBezTo>
                    <a:cubicBezTo>
                      <a:pt x="241" y="94"/>
                      <a:pt x="241" y="94"/>
                      <a:pt x="241" y="94"/>
                    </a:cubicBezTo>
                    <a:cubicBezTo>
                      <a:pt x="243" y="94"/>
                      <a:pt x="243" y="94"/>
                      <a:pt x="243" y="94"/>
                    </a:cubicBezTo>
                    <a:cubicBezTo>
                      <a:pt x="245" y="94"/>
                      <a:pt x="245" y="94"/>
                      <a:pt x="245" y="94"/>
                    </a:cubicBezTo>
                    <a:cubicBezTo>
                      <a:pt x="248" y="92"/>
                      <a:pt x="248" y="92"/>
                      <a:pt x="248" y="92"/>
                    </a:cubicBezTo>
                    <a:cubicBezTo>
                      <a:pt x="249" y="91"/>
                      <a:pt x="249" y="91"/>
                      <a:pt x="249" y="91"/>
                    </a:cubicBezTo>
                    <a:cubicBezTo>
                      <a:pt x="250" y="89"/>
                      <a:pt x="250" y="89"/>
                      <a:pt x="250" y="89"/>
                    </a:cubicBezTo>
                    <a:cubicBezTo>
                      <a:pt x="253" y="87"/>
                      <a:pt x="253" y="87"/>
                      <a:pt x="253" y="87"/>
                    </a:cubicBezTo>
                    <a:cubicBezTo>
                      <a:pt x="253" y="87"/>
                      <a:pt x="254" y="88"/>
                      <a:pt x="255" y="89"/>
                    </a:cubicBezTo>
                    <a:cubicBezTo>
                      <a:pt x="257" y="89"/>
                      <a:pt x="264" y="89"/>
                      <a:pt x="264" y="89"/>
                    </a:cubicBezTo>
                    <a:close/>
                    <a:moveTo>
                      <a:pt x="206" y="133"/>
                    </a:moveTo>
                    <a:cubicBezTo>
                      <a:pt x="206" y="130"/>
                      <a:pt x="206" y="130"/>
                      <a:pt x="206" y="130"/>
                    </a:cubicBezTo>
                    <a:cubicBezTo>
                      <a:pt x="204" y="126"/>
                      <a:pt x="204" y="126"/>
                      <a:pt x="204" y="126"/>
                    </a:cubicBezTo>
                    <a:cubicBezTo>
                      <a:pt x="200" y="123"/>
                      <a:pt x="200" y="123"/>
                      <a:pt x="200" y="123"/>
                    </a:cubicBezTo>
                    <a:cubicBezTo>
                      <a:pt x="197" y="119"/>
                      <a:pt x="197" y="119"/>
                      <a:pt x="197" y="119"/>
                    </a:cubicBezTo>
                    <a:cubicBezTo>
                      <a:pt x="195" y="119"/>
                      <a:pt x="195" y="119"/>
                      <a:pt x="195" y="119"/>
                    </a:cubicBezTo>
                    <a:cubicBezTo>
                      <a:pt x="190" y="119"/>
                      <a:pt x="190" y="119"/>
                      <a:pt x="190" y="119"/>
                    </a:cubicBezTo>
                    <a:cubicBezTo>
                      <a:pt x="188" y="122"/>
                      <a:pt x="188" y="122"/>
                      <a:pt x="188" y="122"/>
                    </a:cubicBezTo>
                    <a:cubicBezTo>
                      <a:pt x="188" y="122"/>
                      <a:pt x="185" y="123"/>
                      <a:pt x="184" y="124"/>
                    </a:cubicBezTo>
                    <a:cubicBezTo>
                      <a:pt x="184" y="126"/>
                      <a:pt x="181" y="127"/>
                      <a:pt x="181" y="127"/>
                    </a:cubicBezTo>
                    <a:cubicBezTo>
                      <a:pt x="178" y="129"/>
                      <a:pt x="178" y="129"/>
                      <a:pt x="178" y="129"/>
                    </a:cubicBezTo>
                    <a:cubicBezTo>
                      <a:pt x="176" y="131"/>
                      <a:pt x="176" y="131"/>
                      <a:pt x="176" y="131"/>
                    </a:cubicBezTo>
                    <a:cubicBezTo>
                      <a:pt x="174" y="133"/>
                      <a:pt x="174" y="133"/>
                      <a:pt x="174" y="133"/>
                    </a:cubicBezTo>
                    <a:cubicBezTo>
                      <a:pt x="169" y="136"/>
                      <a:pt x="169" y="136"/>
                      <a:pt x="169" y="136"/>
                    </a:cubicBezTo>
                    <a:cubicBezTo>
                      <a:pt x="169" y="139"/>
                      <a:pt x="169" y="139"/>
                      <a:pt x="169" y="139"/>
                    </a:cubicBezTo>
                    <a:cubicBezTo>
                      <a:pt x="169" y="144"/>
                      <a:pt x="169" y="144"/>
                      <a:pt x="169" y="144"/>
                    </a:cubicBezTo>
                    <a:cubicBezTo>
                      <a:pt x="172" y="148"/>
                      <a:pt x="172" y="148"/>
                      <a:pt x="172" y="148"/>
                    </a:cubicBezTo>
                    <a:cubicBezTo>
                      <a:pt x="176" y="152"/>
                      <a:pt x="176" y="152"/>
                      <a:pt x="176" y="152"/>
                    </a:cubicBezTo>
                    <a:cubicBezTo>
                      <a:pt x="179" y="156"/>
                      <a:pt x="179" y="156"/>
                      <a:pt x="179" y="156"/>
                    </a:cubicBezTo>
                    <a:cubicBezTo>
                      <a:pt x="182" y="158"/>
                      <a:pt x="182" y="158"/>
                      <a:pt x="182" y="158"/>
                    </a:cubicBezTo>
                    <a:cubicBezTo>
                      <a:pt x="184" y="156"/>
                      <a:pt x="184" y="156"/>
                      <a:pt x="184" y="156"/>
                    </a:cubicBezTo>
                    <a:cubicBezTo>
                      <a:pt x="184" y="156"/>
                      <a:pt x="186" y="155"/>
                      <a:pt x="186" y="154"/>
                    </a:cubicBezTo>
                    <a:cubicBezTo>
                      <a:pt x="187" y="153"/>
                      <a:pt x="186" y="149"/>
                      <a:pt x="186" y="149"/>
                    </a:cubicBezTo>
                    <a:cubicBezTo>
                      <a:pt x="189" y="148"/>
                      <a:pt x="189" y="148"/>
                      <a:pt x="189" y="148"/>
                    </a:cubicBezTo>
                    <a:cubicBezTo>
                      <a:pt x="191" y="146"/>
                      <a:pt x="191" y="146"/>
                      <a:pt x="191" y="146"/>
                    </a:cubicBezTo>
                    <a:cubicBezTo>
                      <a:pt x="194" y="146"/>
                      <a:pt x="194" y="146"/>
                      <a:pt x="194" y="146"/>
                    </a:cubicBezTo>
                    <a:cubicBezTo>
                      <a:pt x="197" y="146"/>
                      <a:pt x="197" y="146"/>
                      <a:pt x="197" y="146"/>
                    </a:cubicBezTo>
                    <a:cubicBezTo>
                      <a:pt x="200" y="144"/>
                      <a:pt x="200" y="144"/>
                      <a:pt x="200" y="144"/>
                    </a:cubicBezTo>
                    <a:cubicBezTo>
                      <a:pt x="202" y="141"/>
                      <a:pt x="202" y="141"/>
                      <a:pt x="202" y="141"/>
                    </a:cubicBezTo>
                    <a:cubicBezTo>
                      <a:pt x="204" y="137"/>
                      <a:pt x="204" y="137"/>
                      <a:pt x="204" y="137"/>
                    </a:cubicBezTo>
                    <a:lnTo>
                      <a:pt x="206" y="133"/>
                    </a:lnTo>
                    <a:close/>
                  </a:path>
                </a:pathLst>
              </a:custGeom>
              <a:solidFill>
                <a:schemeClr val="accent4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5" name="Freeform 263">
                <a:extLst>
                  <a:ext uri="{FF2B5EF4-FFF2-40B4-BE49-F238E27FC236}">
                    <a16:creationId xmlns:a16="http://schemas.microsoft.com/office/drawing/2014/main" id="{021FF8AD-A066-EE54-2752-752873F77D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83527" y="2439988"/>
                <a:ext cx="842963" cy="195263"/>
              </a:xfrm>
              <a:custGeom>
                <a:avLst/>
                <a:gdLst>
                  <a:gd name="T0" fmla="*/ 176 w 187"/>
                  <a:gd name="T1" fmla="*/ 24 h 43"/>
                  <a:gd name="T2" fmla="*/ 187 w 187"/>
                  <a:gd name="T3" fmla="*/ 37 h 43"/>
                  <a:gd name="T4" fmla="*/ 169 w 187"/>
                  <a:gd name="T5" fmla="*/ 41 h 43"/>
                  <a:gd name="T6" fmla="*/ 122 w 187"/>
                  <a:gd name="T7" fmla="*/ 41 h 43"/>
                  <a:gd name="T8" fmla="*/ 110 w 187"/>
                  <a:gd name="T9" fmla="*/ 34 h 43"/>
                  <a:gd name="T10" fmla="*/ 97 w 187"/>
                  <a:gd name="T11" fmla="*/ 32 h 43"/>
                  <a:gd name="T12" fmla="*/ 82 w 187"/>
                  <a:gd name="T13" fmla="*/ 32 h 43"/>
                  <a:gd name="T14" fmla="*/ 42 w 187"/>
                  <a:gd name="T15" fmla="*/ 34 h 43"/>
                  <a:gd name="T16" fmla="*/ 28 w 187"/>
                  <a:gd name="T17" fmla="*/ 25 h 43"/>
                  <a:gd name="T18" fmla="*/ 20 w 187"/>
                  <a:gd name="T19" fmla="*/ 25 h 43"/>
                  <a:gd name="T20" fmla="*/ 12 w 187"/>
                  <a:gd name="T21" fmla="*/ 28 h 43"/>
                  <a:gd name="T22" fmla="*/ 0 w 187"/>
                  <a:gd name="T23" fmla="*/ 28 h 43"/>
                  <a:gd name="T24" fmla="*/ 0 w 187"/>
                  <a:gd name="T25" fmla="*/ 0 h 43"/>
                  <a:gd name="T26" fmla="*/ 167 w 187"/>
                  <a:gd name="T27" fmla="*/ 0 h 43"/>
                  <a:gd name="T28" fmla="*/ 167 w 187"/>
                  <a:gd name="T29" fmla="*/ 13 h 43"/>
                  <a:gd name="T30" fmla="*/ 176 w 187"/>
                  <a:gd name="T31" fmla="*/ 24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187" h="43">
                    <a:moveTo>
                      <a:pt x="176" y="24"/>
                    </a:moveTo>
                    <a:cubicBezTo>
                      <a:pt x="187" y="37"/>
                      <a:pt x="187" y="37"/>
                      <a:pt x="187" y="37"/>
                    </a:cubicBezTo>
                    <a:cubicBezTo>
                      <a:pt x="169" y="41"/>
                      <a:pt x="169" y="41"/>
                      <a:pt x="169" y="41"/>
                    </a:cubicBezTo>
                    <a:cubicBezTo>
                      <a:pt x="169" y="41"/>
                      <a:pt x="136" y="43"/>
                      <a:pt x="122" y="41"/>
                    </a:cubicBezTo>
                    <a:cubicBezTo>
                      <a:pt x="109" y="39"/>
                      <a:pt x="113" y="36"/>
                      <a:pt x="110" y="34"/>
                    </a:cubicBezTo>
                    <a:cubicBezTo>
                      <a:pt x="106" y="32"/>
                      <a:pt x="97" y="32"/>
                      <a:pt x="97" y="32"/>
                    </a:cubicBezTo>
                    <a:cubicBezTo>
                      <a:pt x="82" y="32"/>
                      <a:pt x="82" y="32"/>
                      <a:pt x="82" y="32"/>
                    </a:cubicBezTo>
                    <a:cubicBezTo>
                      <a:pt x="82" y="32"/>
                      <a:pt x="45" y="32"/>
                      <a:pt x="42" y="34"/>
                    </a:cubicBezTo>
                    <a:cubicBezTo>
                      <a:pt x="38" y="35"/>
                      <a:pt x="31" y="26"/>
                      <a:pt x="28" y="25"/>
                    </a:cubicBezTo>
                    <a:cubicBezTo>
                      <a:pt x="25" y="24"/>
                      <a:pt x="21" y="22"/>
                      <a:pt x="20" y="25"/>
                    </a:cubicBezTo>
                    <a:cubicBezTo>
                      <a:pt x="19" y="27"/>
                      <a:pt x="12" y="28"/>
                      <a:pt x="12" y="28"/>
                    </a:cubicBezTo>
                    <a:cubicBezTo>
                      <a:pt x="0" y="28"/>
                      <a:pt x="0" y="28"/>
                      <a:pt x="0" y="28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167" y="0"/>
                      <a:pt x="167" y="0"/>
                      <a:pt x="167" y="0"/>
                    </a:cubicBezTo>
                    <a:cubicBezTo>
                      <a:pt x="167" y="13"/>
                      <a:pt x="167" y="13"/>
                      <a:pt x="167" y="13"/>
                    </a:cubicBezTo>
                    <a:lnTo>
                      <a:pt x="176" y="24"/>
                    </a:lnTo>
                    <a:close/>
                  </a:path>
                </a:pathLst>
              </a:custGeom>
              <a:noFill/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6" name="Freeform 264">
                <a:extLst>
                  <a:ext uri="{FF2B5EF4-FFF2-40B4-BE49-F238E27FC236}">
                    <a16:creationId xmlns:a16="http://schemas.microsoft.com/office/drawing/2014/main" id="{3FBC3B4B-007A-8CD0-064A-A86FCA4CB9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90670" y="2652714"/>
                <a:ext cx="550863" cy="1385888"/>
              </a:xfrm>
              <a:custGeom>
                <a:avLst/>
                <a:gdLst>
                  <a:gd name="T0" fmla="*/ 122 w 122"/>
                  <a:gd name="T1" fmla="*/ 307 h 307"/>
                  <a:gd name="T2" fmla="*/ 0 w 122"/>
                  <a:gd name="T3" fmla="*/ 307 h 307"/>
                  <a:gd name="T4" fmla="*/ 0 w 122"/>
                  <a:gd name="T5" fmla="*/ 0 h 307"/>
                  <a:gd name="T6" fmla="*/ 7 w 122"/>
                  <a:gd name="T7" fmla="*/ 10 h 307"/>
                  <a:gd name="T8" fmla="*/ 16 w 122"/>
                  <a:gd name="T9" fmla="*/ 22 h 307"/>
                  <a:gd name="T10" fmla="*/ 28 w 122"/>
                  <a:gd name="T11" fmla="*/ 48 h 307"/>
                  <a:gd name="T12" fmla="*/ 35 w 122"/>
                  <a:gd name="T13" fmla="*/ 60 h 307"/>
                  <a:gd name="T14" fmla="*/ 39 w 122"/>
                  <a:gd name="T15" fmla="*/ 71 h 307"/>
                  <a:gd name="T16" fmla="*/ 43 w 122"/>
                  <a:gd name="T17" fmla="*/ 79 h 307"/>
                  <a:gd name="T18" fmla="*/ 43 w 122"/>
                  <a:gd name="T19" fmla="*/ 103 h 307"/>
                  <a:gd name="T20" fmla="*/ 47 w 122"/>
                  <a:gd name="T21" fmla="*/ 118 h 307"/>
                  <a:gd name="T22" fmla="*/ 51 w 122"/>
                  <a:gd name="T23" fmla="*/ 139 h 307"/>
                  <a:gd name="T24" fmla="*/ 61 w 122"/>
                  <a:gd name="T25" fmla="*/ 178 h 307"/>
                  <a:gd name="T26" fmla="*/ 72 w 122"/>
                  <a:gd name="T27" fmla="*/ 191 h 307"/>
                  <a:gd name="T28" fmla="*/ 72 w 122"/>
                  <a:gd name="T29" fmla="*/ 191 h 307"/>
                  <a:gd name="T30" fmla="*/ 84 w 122"/>
                  <a:gd name="T31" fmla="*/ 218 h 307"/>
                  <a:gd name="T32" fmla="*/ 92 w 122"/>
                  <a:gd name="T33" fmla="*/ 235 h 307"/>
                  <a:gd name="T34" fmla="*/ 101 w 122"/>
                  <a:gd name="T35" fmla="*/ 257 h 307"/>
                  <a:gd name="T36" fmla="*/ 101 w 122"/>
                  <a:gd name="T37" fmla="*/ 267 h 307"/>
                  <a:gd name="T38" fmla="*/ 98 w 122"/>
                  <a:gd name="T39" fmla="*/ 267 h 307"/>
                  <a:gd name="T40" fmla="*/ 95 w 122"/>
                  <a:gd name="T41" fmla="*/ 272 h 307"/>
                  <a:gd name="T42" fmla="*/ 101 w 122"/>
                  <a:gd name="T43" fmla="*/ 279 h 307"/>
                  <a:gd name="T44" fmla="*/ 103 w 122"/>
                  <a:gd name="T45" fmla="*/ 290 h 307"/>
                  <a:gd name="T46" fmla="*/ 103 w 122"/>
                  <a:gd name="T47" fmla="*/ 295 h 307"/>
                  <a:gd name="T48" fmla="*/ 108 w 122"/>
                  <a:gd name="T49" fmla="*/ 295 h 307"/>
                  <a:gd name="T50" fmla="*/ 114 w 122"/>
                  <a:gd name="T51" fmla="*/ 299 h 307"/>
                  <a:gd name="T52" fmla="*/ 120 w 122"/>
                  <a:gd name="T53" fmla="*/ 304 h 307"/>
                  <a:gd name="T54" fmla="*/ 122 w 122"/>
                  <a:gd name="T55" fmla="*/ 307 h 3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122" h="307">
                    <a:moveTo>
                      <a:pt x="122" y="307"/>
                    </a:moveTo>
                    <a:cubicBezTo>
                      <a:pt x="0" y="307"/>
                      <a:pt x="0" y="307"/>
                      <a:pt x="0" y="307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7" y="10"/>
                      <a:pt x="7" y="10"/>
                      <a:pt x="7" y="10"/>
                    </a:cubicBezTo>
                    <a:cubicBezTo>
                      <a:pt x="7" y="10"/>
                      <a:pt x="12" y="12"/>
                      <a:pt x="16" y="22"/>
                    </a:cubicBezTo>
                    <a:cubicBezTo>
                      <a:pt x="19" y="31"/>
                      <a:pt x="27" y="45"/>
                      <a:pt x="28" y="48"/>
                    </a:cubicBezTo>
                    <a:cubicBezTo>
                      <a:pt x="29" y="52"/>
                      <a:pt x="35" y="60"/>
                      <a:pt x="35" y="60"/>
                    </a:cubicBezTo>
                    <a:cubicBezTo>
                      <a:pt x="39" y="71"/>
                      <a:pt x="39" y="71"/>
                      <a:pt x="39" y="71"/>
                    </a:cubicBezTo>
                    <a:cubicBezTo>
                      <a:pt x="39" y="71"/>
                      <a:pt x="43" y="73"/>
                      <a:pt x="43" y="79"/>
                    </a:cubicBezTo>
                    <a:cubicBezTo>
                      <a:pt x="43" y="84"/>
                      <a:pt x="43" y="103"/>
                      <a:pt x="43" y="103"/>
                    </a:cubicBezTo>
                    <a:cubicBezTo>
                      <a:pt x="43" y="103"/>
                      <a:pt x="44" y="111"/>
                      <a:pt x="47" y="118"/>
                    </a:cubicBezTo>
                    <a:cubicBezTo>
                      <a:pt x="50" y="125"/>
                      <a:pt x="51" y="131"/>
                      <a:pt x="51" y="139"/>
                    </a:cubicBezTo>
                    <a:cubicBezTo>
                      <a:pt x="51" y="147"/>
                      <a:pt x="58" y="174"/>
                      <a:pt x="61" y="178"/>
                    </a:cubicBezTo>
                    <a:cubicBezTo>
                      <a:pt x="64" y="182"/>
                      <a:pt x="72" y="191"/>
                      <a:pt x="72" y="191"/>
                    </a:cubicBezTo>
                    <a:cubicBezTo>
                      <a:pt x="72" y="191"/>
                      <a:pt x="72" y="191"/>
                      <a:pt x="72" y="191"/>
                    </a:cubicBezTo>
                    <a:cubicBezTo>
                      <a:pt x="74" y="194"/>
                      <a:pt x="83" y="211"/>
                      <a:pt x="84" y="218"/>
                    </a:cubicBezTo>
                    <a:cubicBezTo>
                      <a:pt x="86" y="225"/>
                      <a:pt x="90" y="230"/>
                      <a:pt x="92" y="235"/>
                    </a:cubicBezTo>
                    <a:cubicBezTo>
                      <a:pt x="95" y="239"/>
                      <a:pt x="100" y="251"/>
                      <a:pt x="101" y="257"/>
                    </a:cubicBezTo>
                    <a:cubicBezTo>
                      <a:pt x="101" y="262"/>
                      <a:pt x="101" y="267"/>
                      <a:pt x="101" y="267"/>
                    </a:cubicBezTo>
                    <a:cubicBezTo>
                      <a:pt x="101" y="267"/>
                      <a:pt x="100" y="267"/>
                      <a:pt x="98" y="267"/>
                    </a:cubicBezTo>
                    <a:cubicBezTo>
                      <a:pt x="96" y="268"/>
                      <a:pt x="93" y="267"/>
                      <a:pt x="95" y="272"/>
                    </a:cubicBezTo>
                    <a:cubicBezTo>
                      <a:pt x="96" y="276"/>
                      <a:pt x="101" y="279"/>
                      <a:pt x="101" y="279"/>
                    </a:cubicBezTo>
                    <a:cubicBezTo>
                      <a:pt x="103" y="290"/>
                      <a:pt x="103" y="290"/>
                      <a:pt x="103" y="290"/>
                    </a:cubicBezTo>
                    <a:cubicBezTo>
                      <a:pt x="103" y="295"/>
                      <a:pt x="103" y="295"/>
                      <a:pt x="103" y="295"/>
                    </a:cubicBezTo>
                    <a:cubicBezTo>
                      <a:pt x="103" y="295"/>
                      <a:pt x="106" y="295"/>
                      <a:pt x="108" y="295"/>
                    </a:cubicBezTo>
                    <a:cubicBezTo>
                      <a:pt x="111" y="296"/>
                      <a:pt x="114" y="299"/>
                      <a:pt x="114" y="299"/>
                    </a:cubicBezTo>
                    <a:cubicBezTo>
                      <a:pt x="120" y="304"/>
                      <a:pt x="120" y="304"/>
                      <a:pt x="120" y="304"/>
                    </a:cubicBezTo>
                    <a:lnTo>
                      <a:pt x="122" y="307"/>
                    </a:lnTo>
                    <a:close/>
                  </a:path>
                </a:pathLst>
              </a:custGeom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7" name="Freeform 265">
                <a:extLst>
                  <a:ext uri="{FF2B5EF4-FFF2-40B4-BE49-F238E27FC236}">
                    <a16:creationId xmlns:a16="http://schemas.microsoft.com/office/drawing/2014/main" id="{C343C05D-BE9A-504E-5B4E-D6032F39C4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91639" y="2995613"/>
                <a:ext cx="107950" cy="393700"/>
              </a:xfrm>
              <a:custGeom>
                <a:avLst/>
                <a:gdLst>
                  <a:gd name="T0" fmla="*/ 2 w 24"/>
                  <a:gd name="T1" fmla="*/ 0 h 87"/>
                  <a:gd name="T2" fmla="*/ 2 w 24"/>
                  <a:gd name="T3" fmla="*/ 6 h 87"/>
                  <a:gd name="T4" fmla="*/ 4 w 24"/>
                  <a:gd name="T5" fmla="*/ 12 h 87"/>
                  <a:gd name="T6" fmla="*/ 5 w 24"/>
                  <a:gd name="T7" fmla="*/ 17 h 87"/>
                  <a:gd name="T8" fmla="*/ 6 w 24"/>
                  <a:gd name="T9" fmla="*/ 26 h 87"/>
                  <a:gd name="T10" fmla="*/ 8 w 24"/>
                  <a:gd name="T11" fmla="*/ 30 h 87"/>
                  <a:gd name="T12" fmla="*/ 8 w 24"/>
                  <a:gd name="T13" fmla="*/ 32 h 87"/>
                  <a:gd name="T14" fmla="*/ 8 w 24"/>
                  <a:gd name="T15" fmla="*/ 49 h 87"/>
                  <a:gd name="T16" fmla="*/ 10 w 24"/>
                  <a:gd name="T17" fmla="*/ 61 h 87"/>
                  <a:gd name="T18" fmla="*/ 10 w 24"/>
                  <a:gd name="T19" fmla="*/ 68 h 87"/>
                  <a:gd name="T20" fmla="*/ 10 w 24"/>
                  <a:gd name="T21" fmla="*/ 69 h 87"/>
                  <a:gd name="T22" fmla="*/ 12 w 24"/>
                  <a:gd name="T23" fmla="*/ 73 h 87"/>
                  <a:gd name="T24" fmla="*/ 13 w 24"/>
                  <a:gd name="T25" fmla="*/ 85 h 87"/>
                  <a:gd name="T26" fmla="*/ 15 w 24"/>
                  <a:gd name="T27" fmla="*/ 87 h 87"/>
                  <a:gd name="T28" fmla="*/ 24 w 24"/>
                  <a:gd name="T29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24" h="87">
                    <a:moveTo>
                      <a:pt x="2" y="0"/>
                    </a:moveTo>
                    <a:cubicBezTo>
                      <a:pt x="2" y="0"/>
                      <a:pt x="0" y="4"/>
                      <a:pt x="2" y="6"/>
                    </a:cubicBezTo>
                    <a:cubicBezTo>
                      <a:pt x="3" y="7"/>
                      <a:pt x="4" y="12"/>
                      <a:pt x="4" y="12"/>
                    </a:cubicBezTo>
                    <a:cubicBezTo>
                      <a:pt x="4" y="12"/>
                      <a:pt x="4" y="14"/>
                      <a:pt x="5" y="17"/>
                    </a:cubicBezTo>
                    <a:cubicBezTo>
                      <a:pt x="5" y="20"/>
                      <a:pt x="5" y="25"/>
                      <a:pt x="6" y="26"/>
                    </a:cubicBezTo>
                    <a:cubicBezTo>
                      <a:pt x="7" y="27"/>
                      <a:pt x="8" y="30"/>
                      <a:pt x="8" y="30"/>
                    </a:cubicBezTo>
                    <a:cubicBezTo>
                      <a:pt x="8" y="32"/>
                      <a:pt x="8" y="32"/>
                      <a:pt x="8" y="32"/>
                    </a:cubicBezTo>
                    <a:cubicBezTo>
                      <a:pt x="8" y="49"/>
                      <a:pt x="8" y="49"/>
                      <a:pt x="8" y="49"/>
                    </a:cubicBezTo>
                    <a:cubicBezTo>
                      <a:pt x="10" y="61"/>
                      <a:pt x="10" y="61"/>
                      <a:pt x="10" y="61"/>
                    </a:cubicBezTo>
                    <a:cubicBezTo>
                      <a:pt x="10" y="68"/>
                      <a:pt x="10" y="68"/>
                      <a:pt x="10" y="68"/>
                    </a:cubicBezTo>
                    <a:cubicBezTo>
                      <a:pt x="10" y="69"/>
                      <a:pt x="10" y="69"/>
                      <a:pt x="10" y="69"/>
                    </a:cubicBezTo>
                    <a:cubicBezTo>
                      <a:pt x="10" y="69"/>
                      <a:pt x="11" y="70"/>
                      <a:pt x="12" y="73"/>
                    </a:cubicBezTo>
                    <a:cubicBezTo>
                      <a:pt x="13" y="76"/>
                      <a:pt x="14" y="84"/>
                      <a:pt x="13" y="85"/>
                    </a:cubicBezTo>
                    <a:cubicBezTo>
                      <a:pt x="13" y="85"/>
                      <a:pt x="14" y="86"/>
                      <a:pt x="15" y="87"/>
                    </a:cubicBezTo>
                    <a:cubicBezTo>
                      <a:pt x="17" y="87"/>
                      <a:pt x="24" y="87"/>
                      <a:pt x="24" y="87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8" name="Freeform 266">
                <a:extLst>
                  <a:ext uri="{FF2B5EF4-FFF2-40B4-BE49-F238E27FC236}">
                    <a16:creationId xmlns:a16="http://schemas.microsoft.com/office/drawing/2014/main" id="{AF378142-F430-93B7-CB22-0E9B3A0C14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55127" y="3294063"/>
                <a:ext cx="95250" cy="117475"/>
              </a:xfrm>
              <a:custGeom>
                <a:avLst/>
                <a:gdLst>
                  <a:gd name="T0" fmla="*/ 18 w 21"/>
                  <a:gd name="T1" fmla="*/ 2 h 26"/>
                  <a:gd name="T2" fmla="*/ 14 w 21"/>
                  <a:gd name="T3" fmla="*/ 0 h 26"/>
                  <a:gd name="T4" fmla="*/ 9 w 21"/>
                  <a:gd name="T5" fmla="*/ 0 h 26"/>
                  <a:gd name="T6" fmla="*/ 7 w 21"/>
                  <a:gd name="T7" fmla="*/ 2 h 26"/>
                  <a:gd name="T8" fmla="*/ 6 w 21"/>
                  <a:gd name="T9" fmla="*/ 4 h 26"/>
                  <a:gd name="T10" fmla="*/ 6 w 21"/>
                  <a:gd name="T11" fmla="*/ 6 h 26"/>
                  <a:gd name="T12" fmla="*/ 2 w 21"/>
                  <a:gd name="T13" fmla="*/ 9 h 26"/>
                  <a:gd name="T14" fmla="*/ 1 w 21"/>
                  <a:gd name="T15" fmla="*/ 11 h 26"/>
                  <a:gd name="T16" fmla="*/ 1 w 21"/>
                  <a:gd name="T17" fmla="*/ 14 h 26"/>
                  <a:gd name="T18" fmla="*/ 0 w 21"/>
                  <a:gd name="T19" fmla="*/ 19 h 26"/>
                  <a:gd name="T20" fmla="*/ 3 w 21"/>
                  <a:gd name="T21" fmla="*/ 22 h 26"/>
                  <a:gd name="T22" fmla="*/ 6 w 21"/>
                  <a:gd name="T23" fmla="*/ 24 h 26"/>
                  <a:gd name="T24" fmla="*/ 9 w 21"/>
                  <a:gd name="T25" fmla="*/ 26 h 26"/>
                  <a:gd name="T26" fmla="*/ 11 w 21"/>
                  <a:gd name="T27" fmla="*/ 26 h 26"/>
                  <a:gd name="T28" fmla="*/ 13 w 21"/>
                  <a:gd name="T29" fmla="*/ 26 h 26"/>
                  <a:gd name="T30" fmla="*/ 16 w 21"/>
                  <a:gd name="T31" fmla="*/ 24 h 26"/>
                  <a:gd name="T32" fmla="*/ 17 w 21"/>
                  <a:gd name="T33" fmla="*/ 23 h 26"/>
                  <a:gd name="T34" fmla="*/ 18 w 21"/>
                  <a:gd name="T35" fmla="*/ 21 h 26"/>
                  <a:gd name="T36" fmla="*/ 21 w 21"/>
                  <a:gd name="T37" fmla="*/ 19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21" h="26">
                    <a:moveTo>
                      <a:pt x="18" y="2"/>
                    </a:moveTo>
                    <a:cubicBezTo>
                      <a:pt x="14" y="0"/>
                      <a:pt x="14" y="0"/>
                      <a:pt x="14" y="0"/>
                    </a:cubicBezTo>
                    <a:cubicBezTo>
                      <a:pt x="9" y="0"/>
                      <a:pt x="9" y="0"/>
                      <a:pt x="9" y="0"/>
                    </a:cubicBezTo>
                    <a:cubicBezTo>
                      <a:pt x="7" y="2"/>
                      <a:pt x="7" y="2"/>
                      <a:pt x="7" y="2"/>
                    </a:cubicBezTo>
                    <a:cubicBezTo>
                      <a:pt x="7" y="2"/>
                      <a:pt x="6" y="3"/>
                      <a:pt x="6" y="4"/>
                    </a:cubicBezTo>
                    <a:cubicBezTo>
                      <a:pt x="5" y="5"/>
                      <a:pt x="7" y="5"/>
                      <a:pt x="6" y="6"/>
                    </a:cubicBezTo>
                    <a:cubicBezTo>
                      <a:pt x="4" y="7"/>
                      <a:pt x="2" y="9"/>
                      <a:pt x="2" y="9"/>
                    </a:cubicBezTo>
                    <a:cubicBezTo>
                      <a:pt x="1" y="11"/>
                      <a:pt x="1" y="11"/>
                      <a:pt x="1" y="11"/>
                    </a:cubicBezTo>
                    <a:cubicBezTo>
                      <a:pt x="1" y="11"/>
                      <a:pt x="2" y="13"/>
                      <a:pt x="1" y="14"/>
                    </a:cubicBezTo>
                    <a:cubicBezTo>
                      <a:pt x="0" y="15"/>
                      <a:pt x="0" y="19"/>
                      <a:pt x="0" y="19"/>
                    </a:cubicBezTo>
                    <a:cubicBezTo>
                      <a:pt x="0" y="19"/>
                      <a:pt x="2" y="22"/>
                      <a:pt x="3" y="22"/>
                    </a:cubicBezTo>
                    <a:cubicBezTo>
                      <a:pt x="4" y="23"/>
                      <a:pt x="6" y="24"/>
                      <a:pt x="6" y="24"/>
                    </a:cubicBezTo>
                    <a:cubicBezTo>
                      <a:pt x="9" y="26"/>
                      <a:pt x="9" y="26"/>
                      <a:pt x="9" y="26"/>
                    </a:cubicBezTo>
                    <a:cubicBezTo>
                      <a:pt x="11" y="26"/>
                      <a:pt x="11" y="26"/>
                      <a:pt x="11" y="26"/>
                    </a:cubicBezTo>
                    <a:cubicBezTo>
                      <a:pt x="13" y="26"/>
                      <a:pt x="13" y="26"/>
                      <a:pt x="13" y="26"/>
                    </a:cubicBezTo>
                    <a:cubicBezTo>
                      <a:pt x="16" y="24"/>
                      <a:pt x="16" y="24"/>
                      <a:pt x="16" y="24"/>
                    </a:cubicBezTo>
                    <a:cubicBezTo>
                      <a:pt x="17" y="23"/>
                      <a:pt x="17" y="23"/>
                      <a:pt x="17" y="23"/>
                    </a:cubicBezTo>
                    <a:cubicBezTo>
                      <a:pt x="18" y="21"/>
                      <a:pt x="18" y="21"/>
                      <a:pt x="18" y="21"/>
                    </a:cubicBezTo>
                    <a:cubicBezTo>
                      <a:pt x="21" y="19"/>
                      <a:pt x="21" y="19"/>
                      <a:pt x="21" y="19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9" name="Freeform 268">
                <a:extLst>
                  <a:ext uri="{FF2B5EF4-FFF2-40B4-BE49-F238E27FC236}">
                    <a16:creationId xmlns:a16="http://schemas.microsoft.com/office/drawing/2014/main" id="{F6596436-8EB8-FC7F-3078-9D1D3782F7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07377" y="3519488"/>
                <a:ext cx="227013" cy="528638"/>
              </a:xfrm>
              <a:custGeom>
                <a:avLst/>
                <a:gdLst>
                  <a:gd name="T0" fmla="*/ 0 w 50"/>
                  <a:gd name="T1" fmla="*/ 0 h 117"/>
                  <a:gd name="T2" fmla="*/ 12 w 50"/>
                  <a:gd name="T3" fmla="*/ 27 h 117"/>
                  <a:gd name="T4" fmla="*/ 20 w 50"/>
                  <a:gd name="T5" fmla="*/ 44 h 117"/>
                  <a:gd name="T6" fmla="*/ 29 w 50"/>
                  <a:gd name="T7" fmla="*/ 66 h 117"/>
                  <a:gd name="T8" fmla="*/ 29 w 50"/>
                  <a:gd name="T9" fmla="*/ 76 h 117"/>
                  <a:gd name="T10" fmla="*/ 26 w 50"/>
                  <a:gd name="T11" fmla="*/ 76 h 117"/>
                  <a:gd name="T12" fmla="*/ 23 w 50"/>
                  <a:gd name="T13" fmla="*/ 81 h 117"/>
                  <a:gd name="T14" fmla="*/ 29 w 50"/>
                  <a:gd name="T15" fmla="*/ 88 h 117"/>
                  <a:gd name="T16" fmla="*/ 31 w 50"/>
                  <a:gd name="T17" fmla="*/ 99 h 117"/>
                  <a:gd name="T18" fmla="*/ 31 w 50"/>
                  <a:gd name="T19" fmla="*/ 104 h 117"/>
                  <a:gd name="T20" fmla="*/ 36 w 50"/>
                  <a:gd name="T21" fmla="*/ 104 h 117"/>
                  <a:gd name="T22" fmla="*/ 42 w 50"/>
                  <a:gd name="T23" fmla="*/ 108 h 117"/>
                  <a:gd name="T24" fmla="*/ 48 w 50"/>
                  <a:gd name="T25" fmla="*/ 113 h 117"/>
                  <a:gd name="T26" fmla="*/ 50 w 50"/>
                  <a:gd name="T27" fmla="*/ 116 h 117"/>
                  <a:gd name="T28" fmla="*/ 50 w 50"/>
                  <a:gd name="T29" fmla="*/ 117 h 1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0" h="117">
                    <a:moveTo>
                      <a:pt x="0" y="0"/>
                    </a:moveTo>
                    <a:cubicBezTo>
                      <a:pt x="2" y="3"/>
                      <a:pt x="11" y="20"/>
                      <a:pt x="12" y="27"/>
                    </a:cubicBezTo>
                    <a:cubicBezTo>
                      <a:pt x="14" y="34"/>
                      <a:pt x="18" y="39"/>
                      <a:pt x="20" y="44"/>
                    </a:cubicBezTo>
                    <a:cubicBezTo>
                      <a:pt x="23" y="48"/>
                      <a:pt x="28" y="60"/>
                      <a:pt x="29" y="66"/>
                    </a:cubicBezTo>
                    <a:cubicBezTo>
                      <a:pt x="29" y="71"/>
                      <a:pt x="29" y="76"/>
                      <a:pt x="29" y="76"/>
                    </a:cubicBezTo>
                    <a:cubicBezTo>
                      <a:pt x="29" y="76"/>
                      <a:pt x="28" y="76"/>
                      <a:pt x="26" y="76"/>
                    </a:cubicBezTo>
                    <a:cubicBezTo>
                      <a:pt x="24" y="77"/>
                      <a:pt x="21" y="76"/>
                      <a:pt x="23" y="81"/>
                    </a:cubicBezTo>
                    <a:cubicBezTo>
                      <a:pt x="24" y="85"/>
                      <a:pt x="29" y="88"/>
                      <a:pt x="29" y="88"/>
                    </a:cubicBezTo>
                    <a:cubicBezTo>
                      <a:pt x="31" y="99"/>
                      <a:pt x="31" y="99"/>
                      <a:pt x="31" y="99"/>
                    </a:cubicBezTo>
                    <a:cubicBezTo>
                      <a:pt x="31" y="104"/>
                      <a:pt x="31" y="104"/>
                      <a:pt x="31" y="104"/>
                    </a:cubicBezTo>
                    <a:cubicBezTo>
                      <a:pt x="31" y="104"/>
                      <a:pt x="34" y="104"/>
                      <a:pt x="36" y="104"/>
                    </a:cubicBezTo>
                    <a:cubicBezTo>
                      <a:pt x="39" y="105"/>
                      <a:pt x="42" y="108"/>
                      <a:pt x="42" y="108"/>
                    </a:cubicBezTo>
                    <a:cubicBezTo>
                      <a:pt x="48" y="113"/>
                      <a:pt x="48" y="113"/>
                      <a:pt x="48" y="113"/>
                    </a:cubicBezTo>
                    <a:cubicBezTo>
                      <a:pt x="50" y="116"/>
                      <a:pt x="50" y="116"/>
                      <a:pt x="50" y="116"/>
                    </a:cubicBezTo>
                    <a:cubicBezTo>
                      <a:pt x="50" y="117"/>
                      <a:pt x="50" y="117"/>
                      <a:pt x="50" y="117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0" name="Freeform 269">
                <a:extLst>
                  <a:ext uri="{FF2B5EF4-FFF2-40B4-BE49-F238E27FC236}">
                    <a16:creationId xmlns:a16="http://schemas.microsoft.com/office/drawing/2014/main" id="{5CC5A906-49BB-E5CD-1828-DCF6304963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83527" y="2657476"/>
                <a:ext cx="323850" cy="862013"/>
              </a:xfrm>
              <a:custGeom>
                <a:avLst/>
                <a:gdLst>
                  <a:gd name="T0" fmla="*/ 0 w 72"/>
                  <a:gd name="T1" fmla="*/ 0 h 191"/>
                  <a:gd name="T2" fmla="*/ 7 w 72"/>
                  <a:gd name="T3" fmla="*/ 10 h 191"/>
                  <a:gd name="T4" fmla="*/ 16 w 72"/>
                  <a:gd name="T5" fmla="*/ 22 h 191"/>
                  <a:gd name="T6" fmla="*/ 28 w 72"/>
                  <a:gd name="T7" fmla="*/ 48 h 191"/>
                  <a:gd name="T8" fmla="*/ 35 w 72"/>
                  <a:gd name="T9" fmla="*/ 60 h 191"/>
                  <a:gd name="T10" fmla="*/ 39 w 72"/>
                  <a:gd name="T11" fmla="*/ 71 h 191"/>
                  <a:gd name="T12" fmla="*/ 43 w 72"/>
                  <a:gd name="T13" fmla="*/ 79 h 191"/>
                  <a:gd name="T14" fmla="*/ 43 w 72"/>
                  <a:gd name="T15" fmla="*/ 103 h 191"/>
                  <a:gd name="T16" fmla="*/ 47 w 72"/>
                  <a:gd name="T17" fmla="*/ 118 h 191"/>
                  <a:gd name="T18" fmla="*/ 51 w 72"/>
                  <a:gd name="T19" fmla="*/ 139 h 191"/>
                  <a:gd name="T20" fmla="*/ 61 w 72"/>
                  <a:gd name="T21" fmla="*/ 178 h 191"/>
                  <a:gd name="T22" fmla="*/ 72 w 72"/>
                  <a:gd name="T23" fmla="*/ 191 h 1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72" h="191">
                    <a:moveTo>
                      <a:pt x="0" y="0"/>
                    </a:moveTo>
                    <a:cubicBezTo>
                      <a:pt x="7" y="10"/>
                      <a:pt x="7" y="10"/>
                      <a:pt x="7" y="10"/>
                    </a:cubicBezTo>
                    <a:cubicBezTo>
                      <a:pt x="7" y="10"/>
                      <a:pt x="12" y="12"/>
                      <a:pt x="16" y="22"/>
                    </a:cubicBezTo>
                    <a:cubicBezTo>
                      <a:pt x="19" y="31"/>
                      <a:pt x="27" y="45"/>
                      <a:pt x="28" y="48"/>
                    </a:cubicBezTo>
                    <a:cubicBezTo>
                      <a:pt x="29" y="52"/>
                      <a:pt x="35" y="60"/>
                      <a:pt x="35" y="60"/>
                    </a:cubicBezTo>
                    <a:cubicBezTo>
                      <a:pt x="39" y="71"/>
                      <a:pt x="39" y="71"/>
                      <a:pt x="39" y="71"/>
                    </a:cubicBezTo>
                    <a:cubicBezTo>
                      <a:pt x="39" y="71"/>
                      <a:pt x="43" y="73"/>
                      <a:pt x="43" y="79"/>
                    </a:cubicBezTo>
                    <a:cubicBezTo>
                      <a:pt x="43" y="84"/>
                      <a:pt x="43" y="103"/>
                      <a:pt x="43" y="103"/>
                    </a:cubicBezTo>
                    <a:cubicBezTo>
                      <a:pt x="43" y="103"/>
                      <a:pt x="44" y="111"/>
                      <a:pt x="47" y="118"/>
                    </a:cubicBezTo>
                    <a:cubicBezTo>
                      <a:pt x="50" y="125"/>
                      <a:pt x="51" y="131"/>
                      <a:pt x="51" y="139"/>
                    </a:cubicBezTo>
                    <a:cubicBezTo>
                      <a:pt x="51" y="147"/>
                      <a:pt x="58" y="174"/>
                      <a:pt x="61" y="178"/>
                    </a:cubicBezTo>
                    <a:cubicBezTo>
                      <a:pt x="64" y="182"/>
                      <a:pt x="72" y="191"/>
                      <a:pt x="72" y="191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1" name="Freeform 270">
                <a:extLst>
                  <a:ext uri="{FF2B5EF4-FFF2-40B4-BE49-F238E27FC236}">
                    <a16:creationId xmlns:a16="http://schemas.microsoft.com/office/drawing/2014/main" id="{1F844EE4-39F4-806D-FD54-42CD4B5316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64552" y="2530476"/>
                <a:ext cx="1449388" cy="1512888"/>
              </a:xfrm>
              <a:custGeom>
                <a:avLst/>
                <a:gdLst>
                  <a:gd name="T0" fmla="*/ 0 w 321"/>
                  <a:gd name="T1" fmla="*/ 335 h 335"/>
                  <a:gd name="T2" fmla="*/ 3 w 321"/>
                  <a:gd name="T3" fmla="*/ 330 h 335"/>
                  <a:gd name="T4" fmla="*/ 14 w 321"/>
                  <a:gd name="T5" fmla="*/ 327 h 335"/>
                  <a:gd name="T6" fmla="*/ 26 w 321"/>
                  <a:gd name="T7" fmla="*/ 327 h 335"/>
                  <a:gd name="T8" fmla="*/ 29 w 321"/>
                  <a:gd name="T9" fmla="*/ 324 h 335"/>
                  <a:gd name="T10" fmla="*/ 38 w 321"/>
                  <a:gd name="T11" fmla="*/ 320 h 335"/>
                  <a:gd name="T12" fmla="*/ 56 w 321"/>
                  <a:gd name="T13" fmla="*/ 320 h 335"/>
                  <a:gd name="T14" fmla="*/ 71 w 321"/>
                  <a:gd name="T15" fmla="*/ 322 h 335"/>
                  <a:gd name="T16" fmla="*/ 82 w 321"/>
                  <a:gd name="T17" fmla="*/ 320 h 335"/>
                  <a:gd name="T18" fmla="*/ 96 w 321"/>
                  <a:gd name="T19" fmla="*/ 315 h 335"/>
                  <a:gd name="T20" fmla="*/ 116 w 321"/>
                  <a:gd name="T21" fmla="*/ 305 h 335"/>
                  <a:gd name="T22" fmla="*/ 146 w 321"/>
                  <a:gd name="T23" fmla="*/ 280 h 335"/>
                  <a:gd name="T24" fmla="*/ 172 w 321"/>
                  <a:gd name="T25" fmla="*/ 247 h 335"/>
                  <a:gd name="T26" fmla="*/ 183 w 321"/>
                  <a:gd name="T27" fmla="*/ 229 h 335"/>
                  <a:gd name="T28" fmla="*/ 193 w 321"/>
                  <a:gd name="T29" fmla="*/ 223 h 335"/>
                  <a:gd name="T30" fmla="*/ 200 w 321"/>
                  <a:gd name="T31" fmla="*/ 207 h 335"/>
                  <a:gd name="T32" fmla="*/ 206 w 321"/>
                  <a:gd name="T33" fmla="*/ 191 h 335"/>
                  <a:gd name="T34" fmla="*/ 207 w 321"/>
                  <a:gd name="T35" fmla="*/ 190 h 335"/>
                  <a:gd name="T36" fmla="*/ 206 w 321"/>
                  <a:gd name="T37" fmla="*/ 177 h 335"/>
                  <a:gd name="T38" fmla="*/ 208 w 321"/>
                  <a:gd name="T39" fmla="*/ 165 h 335"/>
                  <a:gd name="T40" fmla="*/ 228 w 321"/>
                  <a:gd name="T41" fmla="*/ 152 h 335"/>
                  <a:gd name="T42" fmla="*/ 250 w 321"/>
                  <a:gd name="T43" fmla="*/ 135 h 335"/>
                  <a:gd name="T44" fmla="*/ 250 w 321"/>
                  <a:gd name="T45" fmla="*/ 120 h 335"/>
                  <a:gd name="T46" fmla="*/ 250 w 321"/>
                  <a:gd name="T47" fmla="*/ 102 h 335"/>
                  <a:gd name="T48" fmla="*/ 245 w 321"/>
                  <a:gd name="T49" fmla="*/ 80 h 335"/>
                  <a:gd name="T50" fmla="*/ 241 w 321"/>
                  <a:gd name="T51" fmla="*/ 70 h 335"/>
                  <a:gd name="T52" fmla="*/ 248 w 321"/>
                  <a:gd name="T53" fmla="*/ 54 h 335"/>
                  <a:gd name="T54" fmla="*/ 268 w 321"/>
                  <a:gd name="T55" fmla="*/ 37 h 335"/>
                  <a:gd name="T56" fmla="*/ 290 w 321"/>
                  <a:gd name="T57" fmla="*/ 15 h 335"/>
                  <a:gd name="T58" fmla="*/ 303 w 321"/>
                  <a:gd name="T59" fmla="*/ 7 h 335"/>
                  <a:gd name="T60" fmla="*/ 321 w 321"/>
                  <a:gd name="T61" fmla="*/ 0 h 3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321" h="335">
                    <a:moveTo>
                      <a:pt x="0" y="335"/>
                    </a:moveTo>
                    <a:cubicBezTo>
                      <a:pt x="0" y="335"/>
                      <a:pt x="1" y="331"/>
                      <a:pt x="3" y="330"/>
                    </a:cubicBezTo>
                    <a:cubicBezTo>
                      <a:pt x="6" y="328"/>
                      <a:pt x="10" y="327"/>
                      <a:pt x="14" y="327"/>
                    </a:cubicBezTo>
                    <a:cubicBezTo>
                      <a:pt x="18" y="327"/>
                      <a:pt x="26" y="327"/>
                      <a:pt x="26" y="327"/>
                    </a:cubicBezTo>
                    <a:cubicBezTo>
                      <a:pt x="26" y="327"/>
                      <a:pt x="29" y="325"/>
                      <a:pt x="29" y="324"/>
                    </a:cubicBezTo>
                    <a:cubicBezTo>
                      <a:pt x="29" y="322"/>
                      <a:pt x="33" y="321"/>
                      <a:pt x="38" y="320"/>
                    </a:cubicBezTo>
                    <a:cubicBezTo>
                      <a:pt x="42" y="319"/>
                      <a:pt x="53" y="321"/>
                      <a:pt x="56" y="320"/>
                    </a:cubicBezTo>
                    <a:cubicBezTo>
                      <a:pt x="59" y="319"/>
                      <a:pt x="69" y="322"/>
                      <a:pt x="71" y="322"/>
                    </a:cubicBezTo>
                    <a:cubicBezTo>
                      <a:pt x="72" y="323"/>
                      <a:pt x="80" y="322"/>
                      <a:pt x="82" y="320"/>
                    </a:cubicBezTo>
                    <a:cubicBezTo>
                      <a:pt x="85" y="318"/>
                      <a:pt x="93" y="315"/>
                      <a:pt x="96" y="315"/>
                    </a:cubicBezTo>
                    <a:cubicBezTo>
                      <a:pt x="99" y="315"/>
                      <a:pt x="105" y="316"/>
                      <a:pt x="116" y="305"/>
                    </a:cubicBezTo>
                    <a:cubicBezTo>
                      <a:pt x="128" y="295"/>
                      <a:pt x="146" y="280"/>
                      <a:pt x="146" y="280"/>
                    </a:cubicBezTo>
                    <a:cubicBezTo>
                      <a:pt x="172" y="247"/>
                      <a:pt x="172" y="247"/>
                      <a:pt x="172" y="247"/>
                    </a:cubicBezTo>
                    <a:cubicBezTo>
                      <a:pt x="183" y="229"/>
                      <a:pt x="183" y="229"/>
                      <a:pt x="183" y="229"/>
                    </a:cubicBezTo>
                    <a:cubicBezTo>
                      <a:pt x="183" y="229"/>
                      <a:pt x="192" y="223"/>
                      <a:pt x="193" y="223"/>
                    </a:cubicBezTo>
                    <a:cubicBezTo>
                      <a:pt x="195" y="223"/>
                      <a:pt x="198" y="219"/>
                      <a:pt x="200" y="207"/>
                    </a:cubicBezTo>
                    <a:cubicBezTo>
                      <a:pt x="202" y="195"/>
                      <a:pt x="203" y="194"/>
                      <a:pt x="206" y="191"/>
                    </a:cubicBezTo>
                    <a:cubicBezTo>
                      <a:pt x="207" y="191"/>
                      <a:pt x="207" y="190"/>
                      <a:pt x="207" y="190"/>
                    </a:cubicBezTo>
                    <a:cubicBezTo>
                      <a:pt x="208" y="186"/>
                      <a:pt x="206" y="179"/>
                      <a:pt x="206" y="177"/>
                    </a:cubicBezTo>
                    <a:cubicBezTo>
                      <a:pt x="206" y="176"/>
                      <a:pt x="197" y="175"/>
                      <a:pt x="208" y="165"/>
                    </a:cubicBezTo>
                    <a:cubicBezTo>
                      <a:pt x="218" y="155"/>
                      <a:pt x="224" y="152"/>
                      <a:pt x="228" y="152"/>
                    </a:cubicBezTo>
                    <a:cubicBezTo>
                      <a:pt x="232" y="151"/>
                      <a:pt x="249" y="145"/>
                      <a:pt x="250" y="135"/>
                    </a:cubicBezTo>
                    <a:cubicBezTo>
                      <a:pt x="250" y="125"/>
                      <a:pt x="246" y="124"/>
                      <a:pt x="250" y="120"/>
                    </a:cubicBezTo>
                    <a:cubicBezTo>
                      <a:pt x="253" y="115"/>
                      <a:pt x="251" y="109"/>
                      <a:pt x="250" y="102"/>
                    </a:cubicBezTo>
                    <a:cubicBezTo>
                      <a:pt x="248" y="95"/>
                      <a:pt x="245" y="80"/>
                      <a:pt x="245" y="80"/>
                    </a:cubicBezTo>
                    <a:cubicBezTo>
                      <a:pt x="245" y="80"/>
                      <a:pt x="246" y="75"/>
                      <a:pt x="241" y="70"/>
                    </a:cubicBezTo>
                    <a:cubicBezTo>
                      <a:pt x="235" y="65"/>
                      <a:pt x="245" y="59"/>
                      <a:pt x="248" y="54"/>
                    </a:cubicBezTo>
                    <a:cubicBezTo>
                      <a:pt x="252" y="50"/>
                      <a:pt x="268" y="37"/>
                      <a:pt x="268" y="37"/>
                    </a:cubicBezTo>
                    <a:cubicBezTo>
                      <a:pt x="290" y="15"/>
                      <a:pt x="290" y="15"/>
                      <a:pt x="290" y="15"/>
                    </a:cubicBezTo>
                    <a:cubicBezTo>
                      <a:pt x="290" y="15"/>
                      <a:pt x="298" y="8"/>
                      <a:pt x="303" y="7"/>
                    </a:cubicBezTo>
                    <a:cubicBezTo>
                      <a:pt x="308" y="5"/>
                      <a:pt x="321" y="0"/>
                      <a:pt x="321" y="0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2" name="Freeform 271">
                <a:extLst>
                  <a:ext uri="{FF2B5EF4-FFF2-40B4-BE49-F238E27FC236}">
                    <a16:creationId xmlns:a16="http://schemas.microsoft.com/office/drawing/2014/main" id="{4996E4A3-B215-4267-0977-0DF0CDEE3A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83527" y="2439988"/>
                <a:ext cx="842963" cy="195263"/>
              </a:xfrm>
              <a:custGeom>
                <a:avLst/>
                <a:gdLst>
                  <a:gd name="T0" fmla="*/ 0 w 187"/>
                  <a:gd name="T1" fmla="*/ 28 h 43"/>
                  <a:gd name="T2" fmla="*/ 12 w 187"/>
                  <a:gd name="T3" fmla="*/ 28 h 43"/>
                  <a:gd name="T4" fmla="*/ 20 w 187"/>
                  <a:gd name="T5" fmla="*/ 25 h 43"/>
                  <a:gd name="T6" fmla="*/ 28 w 187"/>
                  <a:gd name="T7" fmla="*/ 25 h 43"/>
                  <a:gd name="T8" fmla="*/ 42 w 187"/>
                  <a:gd name="T9" fmla="*/ 34 h 43"/>
                  <a:gd name="T10" fmla="*/ 82 w 187"/>
                  <a:gd name="T11" fmla="*/ 32 h 43"/>
                  <a:gd name="T12" fmla="*/ 97 w 187"/>
                  <a:gd name="T13" fmla="*/ 32 h 43"/>
                  <a:gd name="T14" fmla="*/ 110 w 187"/>
                  <a:gd name="T15" fmla="*/ 34 h 43"/>
                  <a:gd name="T16" fmla="*/ 122 w 187"/>
                  <a:gd name="T17" fmla="*/ 41 h 43"/>
                  <a:gd name="T18" fmla="*/ 169 w 187"/>
                  <a:gd name="T19" fmla="*/ 41 h 43"/>
                  <a:gd name="T20" fmla="*/ 187 w 187"/>
                  <a:gd name="T21" fmla="*/ 37 h 43"/>
                  <a:gd name="T22" fmla="*/ 176 w 187"/>
                  <a:gd name="T23" fmla="*/ 24 h 43"/>
                  <a:gd name="T24" fmla="*/ 167 w 187"/>
                  <a:gd name="T25" fmla="*/ 13 h 43"/>
                  <a:gd name="T26" fmla="*/ 167 w 187"/>
                  <a:gd name="T27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87" h="43">
                    <a:moveTo>
                      <a:pt x="0" y="28"/>
                    </a:moveTo>
                    <a:cubicBezTo>
                      <a:pt x="12" y="28"/>
                      <a:pt x="12" y="28"/>
                      <a:pt x="12" y="28"/>
                    </a:cubicBezTo>
                    <a:cubicBezTo>
                      <a:pt x="12" y="28"/>
                      <a:pt x="19" y="27"/>
                      <a:pt x="20" y="25"/>
                    </a:cubicBezTo>
                    <a:cubicBezTo>
                      <a:pt x="21" y="22"/>
                      <a:pt x="25" y="24"/>
                      <a:pt x="28" y="25"/>
                    </a:cubicBezTo>
                    <a:cubicBezTo>
                      <a:pt x="31" y="26"/>
                      <a:pt x="38" y="35"/>
                      <a:pt x="42" y="34"/>
                    </a:cubicBezTo>
                    <a:cubicBezTo>
                      <a:pt x="45" y="32"/>
                      <a:pt x="82" y="32"/>
                      <a:pt x="82" y="32"/>
                    </a:cubicBezTo>
                    <a:cubicBezTo>
                      <a:pt x="97" y="32"/>
                      <a:pt x="97" y="32"/>
                      <a:pt x="97" y="32"/>
                    </a:cubicBezTo>
                    <a:cubicBezTo>
                      <a:pt x="97" y="32"/>
                      <a:pt x="106" y="32"/>
                      <a:pt x="110" y="34"/>
                    </a:cubicBezTo>
                    <a:cubicBezTo>
                      <a:pt x="113" y="36"/>
                      <a:pt x="109" y="39"/>
                      <a:pt x="122" y="41"/>
                    </a:cubicBezTo>
                    <a:cubicBezTo>
                      <a:pt x="136" y="43"/>
                      <a:pt x="169" y="41"/>
                      <a:pt x="169" y="41"/>
                    </a:cubicBezTo>
                    <a:cubicBezTo>
                      <a:pt x="187" y="37"/>
                      <a:pt x="187" y="37"/>
                      <a:pt x="187" y="37"/>
                    </a:cubicBezTo>
                    <a:cubicBezTo>
                      <a:pt x="176" y="24"/>
                      <a:pt x="176" y="24"/>
                      <a:pt x="176" y="24"/>
                    </a:cubicBezTo>
                    <a:cubicBezTo>
                      <a:pt x="167" y="13"/>
                      <a:pt x="167" y="13"/>
                      <a:pt x="167" y="13"/>
                    </a:cubicBezTo>
                    <a:cubicBezTo>
                      <a:pt x="167" y="0"/>
                      <a:pt x="167" y="0"/>
                      <a:pt x="167" y="0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3" name="Freeform 272">
                <a:extLst>
                  <a:ext uri="{FF2B5EF4-FFF2-40B4-BE49-F238E27FC236}">
                    <a16:creationId xmlns:a16="http://schemas.microsoft.com/office/drawing/2014/main" id="{5AEE6738-2A4D-5FFB-149F-1E40EC067B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07377" y="2593976"/>
                <a:ext cx="655638" cy="957263"/>
              </a:xfrm>
              <a:custGeom>
                <a:avLst/>
                <a:gdLst>
                  <a:gd name="T0" fmla="*/ 115 w 145"/>
                  <a:gd name="T1" fmla="*/ 3 h 212"/>
                  <a:gd name="T2" fmla="*/ 129 w 145"/>
                  <a:gd name="T3" fmla="*/ 0 h 212"/>
                  <a:gd name="T4" fmla="*/ 143 w 145"/>
                  <a:gd name="T5" fmla="*/ 3 h 212"/>
                  <a:gd name="T6" fmla="*/ 140 w 145"/>
                  <a:gd name="T7" fmla="*/ 7 h 212"/>
                  <a:gd name="T8" fmla="*/ 138 w 145"/>
                  <a:gd name="T9" fmla="*/ 8 h 212"/>
                  <a:gd name="T10" fmla="*/ 130 w 145"/>
                  <a:gd name="T11" fmla="*/ 10 h 212"/>
                  <a:gd name="T12" fmla="*/ 122 w 145"/>
                  <a:gd name="T13" fmla="*/ 14 h 212"/>
                  <a:gd name="T14" fmla="*/ 120 w 145"/>
                  <a:gd name="T15" fmla="*/ 18 h 212"/>
                  <a:gd name="T16" fmla="*/ 115 w 145"/>
                  <a:gd name="T17" fmla="*/ 11 h 212"/>
                  <a:gd name="T18" fmla="*/ 106 w 145"/>
                  <a:gd name="T19" fmla="*/ 11 h 212"/>
                  <a:gd name="T20" fmla="*/ 85 w 145"/>
                  <a:gd name="T21" fmla="*/ 14 h 212"/>
                  <a:gd name="T22" fmla="*/ 78 w 145"/>
                  <a:gd name="T23" fmla="*/ 14 h 212"/>
                  <a:gd name="T24" fmla="*/ 78 w 145"/>
                  <a:gd name="T25" fmla="*/ 41 h 212"/>
                  <a:gd name="T26" fmla="*/ 77 w 145"/>
                  <a:gd name="T27" fmla="*/ 64 h 212"/>
                  <a:gd name="T28" fmla="*/ 76 w 145"/>
                  <a:gd name="T29" fmla="*/ 83 h 212"/>
                  <a:gd name="T30" fmla="*/ 63 w 145"/>
                  <a:gd name="T31" fmla="*/ 83 h 212"/>
                  <a:gd name="T32" fmla="*/ 60 w 145"/>
                  <a:gd name="T33" fmla="*/ 136 h 212"/>
                  <a:gd name="T34" fmla="*/ 57 w 145"/>
                  <a:gd name="T35" fmla="*/ 197 h 212"/>
                  <a:gd name="T36" fmla="*/ 57 w 145"/>
                  <a:gd name="T37" fmla="*/ 202 h 212"/>
                  <a:gd name="T38" fmla="*/ 47 w 145"/>
                  <a:gd name="T39" fmla="*/ 208 h 212"/>
                  <a:gd name="T40" fmla="*/ 35 w 145"/>
                  <a:gd name="T41" fmla="*/ 211 h 212"/>
                  <a:gd name="T42" fmla="*/ 19 w 145"/>
                  <a:gd name="T43" fmla="*/ 206 h 212"/>
                  <a:gd name="T44" fmla="*/ 8 w 145"/>
                  <a:gd name="T45" fmla="*/ 200 h 212"/>
                  <a:gd name="T46" fmla="*/ 0 w 145"/>
                  <a:gd name="T47" fmla="*/ 205 h 212"/>
                  <a:gd name="T48" fmla="*/ 0 w 145"/>
                  <a:gd name="T49" fmla="*/ 205 h 2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145" h="212">
                    <a:moveTo>
                      <a:pt x="115" y="3"/>
                    </a:moveTo>
                    <a:cubicBezTo>
                      <a:pt x="115" y="3"/>
                      <a:pt x="123" y="1"/>
                      <a:pt x="129" y="0"/>
                    </a:cubicBezTo>
                    <a:cubicBezTo>
                      <a:pt x="135" y="0"/>
                      <a:pt x="140" y="0"/>
                      <a:pt x="143" y="3"/>
                    </a:cubicBezTo>
                    <a:cubicBezTo>
                      <a:pt x="145" y="6"/>
                      <a:pt x="142" y="7"/>
                      <a:pt x="140" y="7"/>
                    </a:cubicBezTo>
                    <a:cubicBezTo>
                      <a:pt x="139" y="8"/>
                      <a:pt x="138" y="8"/>
                      <a:pt x="138" y="8"/>
                    </a:cubicBezTo>
                    <a:cubicBezTo>
                      <a:pt x="130" y="10"/>
                      <a:pt x="130" y="10"/>
                      <a:pt x="130" y="10"/>
                    </a:cubicBezTo>
                    <a:cubicBezTo>
                      <a:pt x="130" y="10"/>
                      <a:pt x="124" y="10"/>
                      <a:pt x="122" y="14"/>
                    </a:cubicBezTo>
                    <a:cubicBezTo>
                      <a:pt x="120" y="18"/>
                      <a:pt x="120" y="18"/>
                      <a:pt x="120" y="18"/>
                    </a:cubicBezTo>
                    <a:cubicBezTo>
                      <a:pt x="115" y="11"/>
                      <a:pt x="115" y="11"/>
                      <a:pt x="115" y="11"/>
                    </a:cubicBezTo>
                    <a:cubicBezTo>
                      <a:pt x="106" y="11"/>
                      <a:pt x="106" y="11"/>
                      <a:pt x="106" y="11"/>
                    </a:cubicBezTo>
                    <a:cubicBezTo>
                      <a:pt x="85" y="14"/>
                      <a:pt x="85" y="14"/>
                      <a:pt x="85" y="14"/>
                    </a:cubicBezTo>
                    <a:cubicBezTo>
                      <a:pt x="78" y="14"/>
                      <a:pt x="78" y="14"/>
                      <a:pt x="78" y="14"/>
                    </a:cubicBezTo>
                    <a:cubicBezTo>
                      <a:pt x="78" y="41"/>
                      <a:pt x="78" y="41"/>
                      <a:pt x="78" y="41"/>
                    </a:cubicBezTo>
                    <a:cubicBezTo>
                      <a:pt x="77" y="64"/>
                      <a:pt x="77" y="64"/>
                      <a:pt x="77" y="64"/>
                    </a:cubicBezTo>
                    <a:cubicBezTo>
                      <a:pt x="76" y="83"/>
                      <a:pt x="76" y="83"/>
                      <a:pt x="76" y="83"/>
                    </a:cubicBezTo>
                    <a:cubicBezTo>
                      <a:pt x="63" y="83"/>
                      <a:pt x="63" y="83"/>
                      <a:pt x="63" y="83"/>
                    </a:cubicBezTo>
                    <a:cubicBezTo>
                      <a:pt x="60" y="136"/>
                      <a:pt x="60" y="136"/>
                      <a:pt x="60" y="136"/>
                    </a:cubicBezTo>
                    <a:cubicBezTo>
                      <a:pt x="57" y="197"/>
                      <a:pt x="57" y="197"/>
                      <a:pt x="57" y="197"/>
                    </a:cubicBezTo>
                    <a:cubicBezTo>
                      <a:pt x="57" y="202"/>
                      <a:pt x="57" y="202"/>
                      <a:pt x="57" y="202"/>
                    </a:cubicBezTo>
                    <a:cubicBezTo>
                      <a:pt x="57" y="202"/>
                      <a:pt x="48" y="205"/>
                      <a:pt x="47" y="208"/>
                    </a:cubicBezTo>
                    <a:cubicBezTo>
                      <a:pt x="46" y="212"/>
                      <a:pt x="35" y="211"/>
                      <a:pt x="35" y="211"/>
                    </a:cubicBezTo>
                    <a:cubicBezTo>
                      <a:pt x="35" y="211"/>
                      <a:pt x="21" y="210"/>
                      <a:pt x="19" y="206"/>
                    </a:cubicBezTo>
                    <a:cubicBezTo>
                      <a:pt x="16" y="202"/>
                      <a:pt x="12" y="190"/>
                      <a:pt x="8" y="200"/>
                    </a:cubicBezTo>
                    <a:cubicBezTo>
                      <a:pt x="4" y="210"/>
                      <a:pt x="1" y="206"/>
                      <a:pt x="0" y="205"/>
                    </a:cubicBezTo>
                    <a:cubicBezTo>
                      <a:pt x="0" y="205"/>
                      <a:pt x="0" y="205"/>
                      <a:pt x="0" y="205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4" name="Freeform 273">
                <a:extLst>
                  <a:ext uri="{FF2B5EF4-FFF2-40B4-BE49-F238E27FC236}">
                    <a16:creationId xmlns:a16="http://schemas.microsoft.com/office/drawing/2014/main" id="{A1883634-4714-40E4-86AF-56FDBC3AF3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58252" y="2439988"/>
                <a:ext cx="585788" cy="555625"/>
              </a:xfrm>
              <a:custGeom>
                <a:avLst/>
                <a:gdLst>
                  <a:gd name="T0" fmla="*/ 86 w 130"/>
                  <a:gd name="T1" fmla="*/ 0 h 123"/>
                  <a:gd name="T2" fmla="*/ 93 w 130"/>
                  <a:gd name="T3" fmla="*/ 8 h 123"/>
                  <a:gd name="T4" fmla="*/ 109 w 130"/>
                  <a:gd name="T5" fmla="*/ 13 h 123"/>
                  <a:gd name="T6" fmla="*/ 119 w 130"/>
                  <a:gd name="T7" fmla="*/ 17 h 123"/>
                  <a:gd name="T8" fmla="*/ 128 w 130"/>
                  <a:gd name="T9" fmla="*/ 21 h 123"/>
                  <a:gd name="T10" fmla="*/ 128 w 130"/>
                  <a:gd name="T11" fmla="*/ 32 h 123"/>
                  <a:gd name="T12" fmla="*/ 129 w 130"/>
                  <a:gd name="T13" fmla="*/ 46 h 123"/>
                  <a:gd name="T14" fmla="*/ 129 w 130"/>
                  <a:gd name="T15" fmla="*/ 53 h 123"/>
                  <a:gd name="T16" fmla="*/ 122 w 130"/>
                  <a:gd name="T17" fmla="*/ 61 h 123"/>
                  <a:gd name="T18" fmla="*/ 124 w 130"/>
                  <a:gd name="T19" fmla="*/ 71 h 123"/>
                  <a:gd name="T20" fmla="*/ 125 w 130"/>
                  <a:gd name="T21" fmla="*/ 79 h 123"/>
                  <a:gd name="T22" fmla="*/ 122 w 130"/>
                  <a:gd name="T23" fmla="*/ 88 h 123"/>
                  <a:gd name="T24" fmla="*/ 118 w 130"/>
                  <a:gd name="T25" fmla="*/ 100 h 123"/>
                  <a:gd name="T26" fmla="*/ 113 w 130"/>
                  <a:gd name="T27" fmla="*/ 109 h 123"/>
                  <a:gd name="T28" fmla="*/ 105 w 130"/>
                  <a:gd name="T29" fmla="*/ 117 h 123"/>
                  <a:gd name="T30" fmla="*/ 100 w 130"/>
                  <a:gd name="T31" fmla="*/ 123 h 123"/>
                  <a:gd name="T32" fmla="*/ 98 w 130"/>
                  <a:gd name="T33" fmla="*/ 123 h 123"/>
                  <a:gd name="T34" fmla="*/ 73 w 130"/>
                  <a:gd name="T35" fmla="*/ 123 h 123"/>
                  <a:gd name="T36" fmla="*/ 64 w 130"/>
                  <a:gd name="T37" fmla="*/ 121 h 123"/>
                  <a:gd name="T38" fmla="*/ 60 w 130"/>
                  <a:gd name="T39" fmla="*/ 120 h 123"/>
                  <a:gd name="T40" fmla="*/ 60 w 130"/>
                  <a:gd name="T41" fmla="*/ 113 h 123"/>
                  <a:gd name="T42" fmla="*/ 44 w 130"/>
                  <a:gd name="T43" fmla="*/ 109 h 123"/>
                  <a:gd name="T44" fmla="*/ 40 w 130"/>
                  <a:gd name="T45" fmla="*/ 91 h 123"/>
                  <a:gd name="T46" fmla="*/ 35 w 130"/>
                  <a:gd name="T47" fmla="*/ 88 h 123"/>
                  <a:gd name="T48" fmla="*/ 29 w 130"/>
                  <a:gd name="T49" fmla="*/ 80 h 123"/>
                  <a:gd name="T50" fmla="*/ 15 w 130"/>
                  <a:gd name="T51" fmla="*/ 69 h 123"/>
                  <a:gd name="T52" fmla="*/ 9 w 130"/>
                  <a:gd name="T53" fmla="*/ 52 h 123"/>
                  <a:gd name="T54" fmla="*/ 0 w 130"/>
                  <a:gd name="T55" fmla="*/ 42 h 123"/>
                  <a:gd name="T56" fmla="*/ 1 w 130"/>
                  <a:gd name="T57" fmla="*/ 42 h 123"/>
                  <a:gd name="T58" fmla="*/ 9 w 130"/>
                  <a:gd name="T59" fmla="*/ 42 h 123"/>
                  <a:gd name="T60" fmla="*/ 26 w 130"/>
                  <a:gd name="T61" fmla="*/ 46 h 123"/>
                  <a:gd name="T62" fmla="*/ 32 w 130"/>
                  <a:gd name="T63" fmla="*/ 41 h 123"/>
                  <a:gd name="T64" fmla="*/ 46 w 130"/>
                  <a:gd name="T65" fmla="*/ 21 h 123"/>
                  <a:gd name="T66" fmla="*/ 60 w 130"/>
                  <a:gd name="T67" fmla="*/ 15 h 123"/>
                  <a:gd name="T68" fmla="*/ 69 w 130"/>
                  <a:gd name="T69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130" h="123">
                    <a:moveTo>
                      <a:pt x="86" y="0"/>
                    </a:moveTo>
                    <a:cubicBezTo>
                      <a:pt x="86" y="0"/>
                      <a:pt x="87" y="8"/>
                      <a:pt x="93" y="8"/>
                    </a:cubicBezTo>
                    <a:cubicBezTo>
                      <a:pt x="99" y="8"/>
                      <a:pt x="109" y="13"/>
                      <a:pt x="109" y="13"/>
                    </a:cubicBezTo>
                    <a:cubicBezTo>
                      <a:pt x="119" y="17"/>
                      <a:pt x="119" y="17"/>
                      <a:pt x="119" y="17"/>
                    </a:cubicBezTo>
                    <a:cubicBezTo>
                      <a:pt x="128" y="21"/>
                      <a:pt x="128" y="21"/>
                      <a:pt x="128" y="21"/>
                    </a:cubicBezTo>
                    <a:cubicBezTo>
                      <a:pt x="128" y="21"/>
                      <a:pt x="130" y="29"/>
                      <a:pt x="128" y="32"/>
                    </a:cubicBezTo>
                    <a:cubicBezTo>
                      <a:pt x="127" y="34"/>
                      <a:pt x="129" y="46"/>
                      <a:pt x="129" y="46"/>
                    </a:cubicBezTo>
                    <a:cubicBezTo>
                      <a:pt x="129" y="53"/>
                      <a:pt x="129" y="53"/>
                      <a:pt x="129" y="53"/>
                    </a:cubicBezTo>
                    <a:cubicBezTo>
                      <a:pt x="122" y="61"/>
                      <a:pt x="122" y="61"/>
                      <a:pt x="122" y="61"/>
                    </a:cubicBezTo>
                    <a:cubicBezTo>
                      <a:pt x="122" y="61"/>
                      <a:pt x="123" y="67"/>
                      <a:pt x="124" y="71"/>
                    </a:cubicBezTo>
                    <a:cubicBezTo>
                      <a:pt x="125" y="74"/>
                      <a:pt x="125" y="79"/>
                      <a:pt x="125" y="79"/>
                    </a:cubicBezTo>
                    <a:cubicBezTo>
                      <a:pt x="122" y="88"/>
                      <a:pt x="122" y="88"/>
                      <a:pt x="122" y="88"/>
                    </a:cubicBezTo>
                    <a:cubicBezTo>
                      <a:pt x="118" y="100"/>
                      <a:pt x="118" y="100"/>
                      <a:pt x="118" y="100"/>
                    </a:cubicBezTo>
                    <a:cubicBezTo>
                      <a:pt x="118" y="100"/>
                      <a:pt x="115" y="107"/>
                      <a:pt x="113" y="109"/>
                    </a:cubicBezTo>
                    <a:cubicBezTo>
                      <a:pt x="112" y="111"/>
                      <a:pt x="105" y="117"/>
                      <a:pt x="105" y="117"/>
                    </a:cubicBezTo>
                    <a:cubicBezTo>
                      <a:pt x="100" y="123"/>
                      <a:pt x="100" y="123"/>
                      <a:pt x="100" y="123"/>
                    </a:cubicBezTo>
                    <a:cubicBezTo>
                      <a:pt x="98" y="123"/>
                      <a:pt x="98" y="123"/>
                      <a:pt x="98" y="123"/>
                    </a:cubicBezTo>
                    <a:cubicBezTo>
                      <a:pt x="73" y="123"/>
                      <a:pt x="73" y="123"/>
                      <a:pt x="73" y="123"/>
                    </a:cubicBezTo>
                    <a:cubicBezTo>
                      <a:pt x="64" y="121"/>
                      <a:pt x="64" y="121"/>
                      <a:pt x="64" y="121"/>
                    </a:cubicBezTo>
                    <a:cubicBezTo>
                      <a:pt x="60" y="120"/>
                      <a:pt x="60" y="120"/>
                      <a:pt x="60" y="120"/>
                    </a:cubicBezTo>
                    <a:cubicBezTo>
                      <a:pt x="60" y="113"/>
                      <a:pt x="60" y="113"/>
                      <a:pt x="60" y="113"/>
                    </a:cubicBezTo>
                    <a:cubicBezTo>
                      <a:pt x="44" y="109"/>
                      <a:pt x="44" y="109"/>
                      <a:pt x="44" y="109"/>
                    </a:cubicBezTo>
                    <a:cubicBezTo>
                      <a:pt x="40" y="91"/>
                      <a:pt x="40" y="91"/>
                      <a:pt x="40" y="91"/>
                    </a:cubicBezTo>
                    <a:cubicBezTo>
                      <a:pt x="35" y="88"/>
                      <a:pt x="35" y="88"/>
                      <a:pt x="35" y="88"/>
                    </a:cubicBezTo>
                    <a:cubicBezTo>
                      <a:pt x="29" y="80"/>
                      <a:pt x="29" y="80"/>
                      <a:pt x="29" y="80"/>
                    </a:cubicBezTo>
                    <a:cubicBezTo>
                      <a:pt x="15" y="69"/>
                      <a:pt x="15" y="69"/>
                      <a:pt x="15" y="69"/>
                    </a:cubicBezTo>
                    <a:cubicBezTo>
                      <a:pt x="9" y="52"/>
                      <a:pt x="9" y="52"/>
                      <a:pt x="9" y="52"/>
                    </a:cubicBezTo>
                    <a:cubicBezTo>
                      <a:pt x="0" y="42"/>
                      <a:pt x="0" y="42"/>
                      <a:pt x="0" y="42"/>
                    </a:cubicBezTo>
                    <a:cubicBezTo>
                      <a:pt x="0" y="42"/>
                      <a:pt x="0" y="42"/>
                      <a:pt x="1" y="42"/>
                    </a:cubicBezTo>
                    <a:cubicBezTo>
                      <a:pt x="2" y="41"/>
                      <a:pt x="5" y="41"/>
                      <a:pt x="9" y="42"/>
                    </a:cubicBezTo>
                    <a:cubicBezTo>
                      <a:pt x="15" y="43"/>
                      <a:pt x="26" y="46"/>
                      <a:pt x="26" y="46"/>
                    </a:cubicBezTo>
                    <a:cubicBezTo>
                      <a:pt x="26" y="46"/>
                      <a:pt x="28" y="46"/>
                      <a:pt x="32" y="41"/>
                    </a:cubicBezTo>
                    <a:cubicBezTo>
                      <a:pt x="36" y="37"/>
                      <a:pt x="45" y="19"/>
                      <a:pt x="46" y="21"/>
                    </a:cubicBezTo>
                    <a:cubicBezTo>
                      <a:pt x="48" y="22"/>
                      <a:pt x="58" y="17"/>
                      <a:pt x="60" y="15"/>
                    </a:cubicBezTo>
                    <a:cubicBezTo>
                      <a:pt x="62" y="12"/>
                      <a:pt x="69" y="0"/>
                      <a:pt x="69" y="0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5" name="Freeform 274">
                <a:extLst>
                  <a:ext uri="{FF2B5EF4-FFF2-40B4-BE49-F238E27FC236}">
                    <a16:creationId xmlns:a16="http://schemas.microsoft.com/office/drawing/2014/main" id="{1C614B68-5995-D938-4D79-191545A0CE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78839" y="2987676"/>
                <a:ext cx="668338" cy="392113"/>
              </a:xfrm>
              <a:custGeom>
                <a:avLst/>
                <a:gdLst>
                  <a:gd name="T0" fmla="*/ 0 w 148"/>
                  <a:gd name="T1" fmla="*/ 49 h 87"/>
                  <a:gd name="T2" fmla="*/ 8 w 148"/>
                  <a:gd name="T3" fmla="*/ 56 h 87"/>
                  <a:gd name="T4" fmla="*/ 12 w 148"/>
                  <a:gd name="T5" fmla="*/ 70 h 87"/>
                  <a:gd name="T6" fmla="*/ 10 w 148"/>
                  <a:gd name="T7" fmla="*/ 79 h 87"/>
                  <a:gd name="T8" fmla="*/ 10 w 148"/>
                  <a:gd name="T9" fmla="*/ 86 h 87"/>
                  <a:gd name="T10" fmla="*/ 19 w 148"/>
                  <a:gd name="T11" fmla="*/ 86 h 87"/>
                  <a:gd name="T12" fmla="*/ 37 w 148"/>
                  <a:gd name="T13" fmla="*/ 77 h 87"/>
                  <a:gd name="T14" fmla="*/ 46 w 148"/>
                  <a:gd name="T15" fmla="*/ 60 h 87"/>
                  <a:gd name="T16" fmla="*/ 51 w 148"/>
                  <a:gd name="T17" fmla="*/ 56 h 87"/>
                  <a:gd name="T18" fmla="*/ 62 w 148"/>
                  <a:gd name="T19" fmla="*/ 62 h 87"/>
                  <a:gd name="T20" fmla="*/ 79 w 148"/>
                  <a:gd name="T21" fmla="*/ 66 h 87"/>
                  <a:gd name="T22" fmla="*/ 93 w 148"/>
                  <a:gd name="T23" fmla="*/ 56 h 87"/>
                  <a:gd name="T24" fmla="*/ 108 w 148"/>
                  <a:gd name="T25" fmla="*/ 41 h 87"/>
                  <a:gd name="T26" fmla="*/ 111 w 148"/>
                  <a:gd name="T27" fmla="*/ 31 h 87"/>
                  <a:gd name="T28" fmla="*/ 115 w 148"/>
                  <a:gd name="T29" fmla="*/ 24 h 87"/>
                  <a:gd name="T30" fmla="*/ 126 w 148"/>
                  <a:gd name="T31" fmla="*/ 15 h 87"/>
                  <a:gd name="T32" fmla="*/ 134 w 148"/>
                  <a:gd name="T33" fmla="*/ 8 h 87"/>
                  <a:gd name="T34" fmla="*/ 148 w 148"/>
                  <a:gd name="T35" fmla="*/ 0 h 87"/>
                  <a:gd name="T36" fmla="*/ 148 w 148"/>
                  <a:gd name="T37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148" h="87">
                    <a:moveTo>
                      <a:pt x="0" y="49"/>
                    </a:moveTo>
                    <a:cubicBezTo>
                      <a:pt x="0" y="49"/>
                      <a:pt x="6" y="53"/>
                      <a:pt x="8" y="56"/>
                    </a:cubicBezTo>
                    <a:cubicBezTo>
                      <a:pt x="10" y="60"/>
                      <a:pt x="13" y="66"/>
                      <a:pt x="12" y="70"/>
                    </a:cubicBezTo>
                    <a:cubicBezTo>
                      <a:pt x="12" y="74"/>
                      <a:pt x="11" y="74"/>
                      <a:pt x="10" y="79"/>
                    </a:cubicBezTo>
                    <a:cubicBezTo>
                      <a:pt x="9" y="83"/>
                      <a:pt x="8" y="86"/>
                      <a:pt x="10" y="86"/>
                    </a:cubicBezTo>
                    <a:cubicBezTo>
                      <a:pt x="12" y="87"/>
                      <a:pt x="16" y="86"/>
                      <a:pt x="19" y="86"/>
                    </a:cubicBezTo>
                    <a:cubicBezTo>
                      <a:pt x="22" y="86"/>
                      <a:pt x="29" y="87"/>
                      <a:pt x="37" y="77"/>
                    </a:cubicBezTo>
                    <a:cubicBezTo>
                      <a:pt x="45" y="67"/>
                      <a:pt x="46" y="61"/>
                      <a:pt x="46" y="60"/>
                    </a:cubicBezTo>
                    <a:cubicBezTo>
                      <a:pt x="45" y="58"/>
                      <a:pt x="48" y="57"/>
                      <a:pt x="51" y="56"/>
                    </a:cubicBezTo>
                    <a:cubicBezTo>
                      <a:pt x="54" y="56"/>
                      <a:pt x="60" y="61"/>
                      <a:pt x="62" y="62"/>
                    </a:cubicBezTo>
                    <a:cubicBezTo>
                      <a:pt x="64" y="64"/>
                      <a:pt x="72" y="68"/>
                      <a:pt x="79" y="66"/>
                    </a:cubicBezTo>
                    <a:cubicBezTo>
                      <a:pt x="86" y="65"/>
                      <a:pt x="93" y="61"/>
                      <a:pt x="93" y="56"/>
                    </a:cubicBezTo>
                    <a:cubicBezTo>
                      <a:pt x="93" y="52"/>
                      <a:pt x="107" y="40"/>
                      <a:pt x="108" y="41"/>
                    </a:cubicBezTo>
                    <a:cubicBezTo>
                      <a:pt x="109" y="42"/>
                      <a:pt x="110" y="35"/>
                      <a:pt x="111" y="31"/>
                    </a:cubicBezTo>
                    <a:cubicBezTo>
                      <a:pt x="112" y="28"/>
                      <a:pt x="113" y="26"/>
                      <a:pt x="115" y="24"/>
                    </a:cubicBezTo>
                    <a:cubicBezTo>
                      <a:pt x="118" y="22"/>
                      <a:pt x="123" y="20"/>
                      <a:pt x="126" y="15"/>
                    </a:cubicBezTo>
                    <a:cubicBezTo>
                      <a:pt x="130" y="11"/>
                      <a:pt x="132" y="8"/>
                      <a:pt x="134" y="8"/>
                    </a:cubicBezTo>
                    <a:cubicBezTo>
                      <a:pt x="136" y="8"/>
                      <a:pt x="148" y="1"/>
                      <a:pt x="148" y="0"/>
                    </a:cubicBezTo>
                    <a:cubicBezTo>
                      <a:pt x="148" y="0"/>
                      <a:pt x="148" y="0"/>
                      <a:pt x="148" y="0"/>
                    </a:cubicBezTo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6" name="Freeform 275">
                <a:extLst>
                  <a:ext uri="{FF2B5EF4-FFF2-40B4-BE49-F238E27FC236}">
                    <a16:creationId xmlns:a16="http://schemas.microsoft.com/office/drawing/2014/main" id="{1071D0E3-1F44-49AD-73EC-391DEAFD95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970964" y="3524251"/>
                <a:ext cx="166688" cy="176213"/>
              </a:xfrm>
              <a:custGeom>
                <a:avLst/>
                <a:gdLst>
                  <a:gd name="T0" fmla="*/ 5 w 37"/>
                  <a:gd name="T1" fmla="*/ 14 h 39"/>
                  <a:gd name="T2" fmla="*/ 0 w 37"/>
                  <a:gd name="T3" fmla="*/ 17 h 39"/>
                  <a:gd name="T4" fmla="*/ 0 w 37"/>
                  <a:gd name="T5" fmla="*/ 20 h 39"/>
                  <a:gd name="T6" fmla="*/ 0 w 37"/>
                  <a:gd name="T7" fmla="*/ 25 h 39"/>
                  <a:gd name="T8" fmla="*/ 3 w 37"/>
                  <a:gd name="T9" fmla="*/ 29 h 39"/>
                  <a:gd name="T10" fmla="*/ 7 w 37"/>
                  <a:gd name="T11" fmla="*/ 33 h 39"/>
                  <a:gd name="T12" fmla="*/ 10 w 37"/>
                  <a:gd name="T13" fmla="*/ 37 h 39"/>
                  <a:gd name="T14" fmla="*/ 13 w 37"/>
                  <a:gd name="T15" fmla="*/ 39 h 39"/>
                  <a:gd name="T16" fmla="*/ 15 w 37"/>
                  <a:gd name="T17" fmla="*/ 37 h 39"/>
                  <a:gd name="T18" fmla="*/ 17 w 37"/>
                  <a:gd name="T19" fmla="*/ 35 h 39"/>
                  <a:gd name="T20" fmla="*/ 17 w 37"/>
                  <a:gd name="T21" fmla="*/ 30 h 39"/>
                  <a:gd name="T22" fmla="*/ 20 w 37"/>
                  <a:gd name="T23" fmla="*/ 29 h 39"/>
                  <a:gd name="T24" fmla="*/ 22 w 37"/>
                  <a:gd name="T25" fmla="*/ 27 h 39"/>
                  <a:gd name="T26" fmla="*/ 25 w 37"/>
                  <a:gd name="T27" fmla="*/ 27 h 39"/>
                  <a:gd name="T28" fmla="*/ 28 w 37"/>
                  <a:gd name="T29" fmla="*/ 27 h 39"/>
                  <a:gd name="T30" fmla="*/ 31 w 37"/>
                  <a:gd name="T31" fmla="*/ 25 h 39"/>
                  <a:gd name="T32" fmla="*/ 33 w 37"/>
                  <a:gd name="T33" fmla="*/ 22 h 39"/>
                  <a:gd name="T34" fmla="*/ 35 w 37"/>
                  <a:gd name="T35" fmla="*/ 18 h 39"/>
                  <a:gd name="T36" fmla="*/ 37 w 37"/>
                  <a:gd name="T37" fmla="*/ 14 h 39"/>
                  <a:gd name="T38" fmla="*/ 37 w 37"/>
                  <a:gd name="T39" fmla="*/ 11 h 39"/>
                  <a:gd name="T40" fmla="*/ 35 w 37"/>
                  <a:gd name="T41" fmla="*/ 7 h 39"/>
                  <a:gd name="T42" fmla="*/ 31 w 37"/>
                  <a:gd name="T43" fmla="*/ 4 h 39"/>
                  <a:gd name="T44" fmla="*/ 28 w 37"/>
                  <a:gd name="T45" fmla="*/ 0 h 39"/>
                  <a:gd name="T46" fmla="*/ 26 w 37"/>
                  <a:gd name="T47" fmla="*/ 0 h 39"/>
                  <a:gd name="T48" fmla="*/ 21 w 37"/>
                  <a:gd name="T49" fmla="*/ 0 h 39"/>
                  <a:gd name="T50" fmla="*/ 19 w 37"/>
                  <a:gd name="T51" fmla="*/ 3 h 39"/>
                  <a:gd name="T52" fmla="*/ 15 w 37"/>
                  <a:gd name="T53" fmla="*/ 5 h 39"/>
                  <a:gd name="T54" fmla="*/ 12 w 37"/>
                  <a:gd name="T55" fmla="*/ 8 h 39"/>
                  <a:gd name="T56" fmla="*/ 9 w 37"/>
                  <a:gd name="T57" fmla="*/ 10 h 39"/>
                  <a:gd name="T58" fmla="*/ 7 w 37"/>
                  <a:gd name="T59" fmla="*/ 12 h 39"/>
                  <a:gd name="T60" fmla="*/ 5 w 37"/>
                  <a:gd name="T61" fmla="*/ 1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37" h="39">
                    <a:moveTo>
                      <a:pt x="5" y="14"/>
                    </a:moveTo>
                    <a:cubicBezTo>
                      <a:pt x="0" y="17"/>
                      <a:pt x="0" y="17"/>
                      <a:pt x="0" y="17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0" y="25"/>
                      <a:pt x="0" y="25"/>
                      <a:pt x="0" y="25"/>
                    </a:cubicBezTo>
                    <a:cubicBezTo>
                      <a:pt x="3" y="29"/>
                      <a:pt x="3" y="29"/>
                      <a:pt x="3" y="29"/>
                    </a:cubicBezTo>
                    <a:cubicBezTo>
                      <a:pt x="7" y="33"/>
                      <a:pt x="7" y="33"/>
                      <a:pt x="7" y="33"/>
                    </a:cubicBezTo>
                    <a:cubicBezTo>
                      <a:pt x="10" y="37"/>
                      <a:pt x="10" y="37"/>
                      <a:pt x="10" y="37"/>
                    </a:cubicBezTo>
                    <a:cubicBezTo>
                      <a:pt x="13" y="39"/>
                      <a:pt x="13" y="39"/>
                      <a:pt x="13" y="39"/>
                    </a:cubicBezTo>
                    <a:cubicBezTo>
                      <a:pt x="15" y="37"/>
                      <a:pt x="15" y="37"/>
                      <a:pt x="15" y="37"/>
                    </a:cubicBezTo>
                    <a:cubicBezTo>
                      <a:pt x="15" y="37"/>
                      <a:pt x="17" y="36"/>
                      <a:pt x="17" y="35"/>
                    </a:cubicBezTo>
                    <a:cubicBezTo>
                      <a:pt x="18" y="34"/>
                      <a:pt x="17" y="30"/>
                      <a:pt x="17" y="30"/>
                    </a:cubicBezTo>
                    <a:cubicBezTo>
                      <a:pt x="20" y="29"/>
                      <a:pt x="20" y="29"/>
                      <a:pt x="20" y="29"/>
                    </a:cubicBezTo>
                    <a:cubicBezTo>
                      <a:pt x="22" y="27"/>
                      <a:pt x="22" y="27"/>
                      <a:pt x="22" y="27"/>
                    </a:cubicBezTo>
                    <a:cubicBezTo>
                      <a:pt x="25" y="27"/>
                      <a:pt x="25" y="27"/>
                      <a:pt x="25" y="27"/>
                    </a:cubicBezTo>
                    <a:cubicBezTo>
                      <a:pt x="28" y="27"/>
                      <a:pt x="28" y="27"/>
                      <a:pt x="28" y="27"/>
                    </a:cubicBezTo>
                    <a:cubicBezTo>
                      <a:pt x="31" y="25"/>
                      <a:pt x="31" y="25"/>
                      <a:pt x="31" y="25"/>
                    </a:cubicBezTo>
                    <a:cubicBezTo>
                      <a:pt x="33" y="22"/>
                      <a:pt x="33" y="22"/>
                      <a:pt x="33" y="22"/>
                    </a:cubicBezTo>
                    <a:cubicBezTo>
                      <a:pt x="35" y="18"/>
                      <a:pt x="35" y="18"/>
                      <a:pt x="35" y="18"/>
                    </a:cubicBezTo>
                    <a:cubicBezTo>
                      <a:pt x="37" y="14"/>
                      <a:pt x="37" y="14"/>
                      <a:pt x="37" y="14"/>
                    </a:cubicBezTo>
                    <a:cubicBezTo>
                      <a:pt x="37" y="11"/>
                      <a:pt x="37" y="11"/>
                      <a:pt x="37" y="11"/>
                    </a:cubicBezTo>
                    <a:cubicBezTo>
                      <a:pt x="35" y="7"/>
                      <a:pt x="35" y="7"/>
                      <a:pt x="35" y="7"/>
                    </a:cubicBezTo>
                    <a:cubicBezTo>
                      <a:pt x="31" y="4"/>
                      <a:pt x="31" y="4"/>
                      <a:pt x="31" y="4"/>
                    </a:cubicBezTo>
                    <a:cubicBezTo>
                      <a:pt x="28" y="0"/>
                      <a:pt x="28" y="0"/>
                      <a:pt x="28" y="0"/>
                    </a:cubicBezTo>
                    <a:cubicBezTo>
                      <a:pt x="26" y="0"/>
                      <a:pt x="26" y="0"/>
                      <a:pt x="26" y="0"/>
                    </a:cubicBezTo>
                    <a:cubicBezTo>
                      <a:pt x="21" y="0"/>
                      <a:pt x="21" y="0"/>
                      <a:pt x="21" y="0"/>
                    </a:cubicBezTo>
                    <a:cubicBezTo>
                      <a:pt x="19" y="3"/>
                      <a:pt x="19" y="3"/>
                      <a:pt x="19" y="3"/>
                    </a:cubicBezTo>
                    <a:cubicBezTo>
                      <a:pt x="19" y="3"/>
                      <a:pt x="16" y="4"/>
                      <a:pt x="15" y="5"/>
                    </a:cubicBezTo>
                    <a:cubicBezTo>
                      <a:pt x="15" y="7"/>
                      <a:pt x="12" y="8"/>
                      <a:pt x="12" y="8"/>
                    </a:cubicBezTo>
                    <a:cubicBezTo>
                      <a:pt x="9" y="10"/>
                      <a:pt x="9" y="10"/>
                      <a:pt x="9" y="10"/>
                    </a:cubicBezTo>
                    <a:cubicBezTo>
                      <a:pt x="7" y="12"/>
                      <a:pt x="7" y="12"/>
                      <a:pt x="7" y="12"/>
                    </a:cubicBezTo>
                    <a:lnTo>
                      <a:pt x="5" y="14"/>
                    </a:lnTo>
                    <a:close/>
                  </a:path>
                </a:pathLst>
              </a:cu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7" name="Line 276">
                <a:extLst>
                  <a:ext uri="{FF2B5EF4-FFF2-40B4-BE49-F238E27FC236}">
                    <a16:creationId xmlns:a16="http://schemas.microsoft.com/office/drawing/2014/main" id="{A882FA54-7C79-D331-E0A5-72D83286F7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550277" y="2882901"/>
                <a:ext cx="4763" cy="31750"/>
              </a:xfrm>
              <a:prstGeom prst="line">
                <a:avLst/>
              </a:pr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" name="Rectangle 282">
                <a:extLst>
                  <a:ext uri="{FF2B5EF4-FFF2-40B4-BE49-F238E27FC236}">
                    <a16:creationId xmlns:a16="http://schemas.microsoft.com/office/drawing/2014/main" id="{25EBA861-77CA-3FDE-BFE7-D1003CF52D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70658" y="3465956"/>
                <a:ext cx="2260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BGB</a:t>
                </a:r>
                <a:endParaRPr kumimoji="0" lang="de-DE" altLang="de-DE" sz="1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69" name="Rectangle 283">
                <a:extLst>
                  <a:ext uri="{FF2B5EF4-FFF2-40B4-BE49-F238E27FC236}">
                    <a16:creationId xmlns:a16="http://schemas.microsoft.com/office/drawing/2014/main" id="{87D11A8A-453C-9318-1FD5-200073AE44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78610" y="3656035"/>
                <a:ext cx="29815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South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 </a:t>
                </a:r>
                <a:r>
                  <a:rPr kumimoji="0" lang="de-DE" altLang="de-DE" sz="900" i="0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Africa</a:t>
                </a:r>
                <a:endParaRPr kumimoji="0" lang="de-DE" altLang="de-DE" sz="1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0" name="Freeform 277">
                <a:extLst>
                  <a:ext uri="{FF2B5EF4-FFF2-40B4-BE49-F238E27FC236}">
                    <a16:creationId xmlns:a16="http://schemas.microsoft.com/office/drawing/2014/main" id="{4ED5608B-066D-E8E1-C12A-638E972857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22421" y="2910681"/>
                <a:ext cx="858838" cy="830263"/>
              </a:xfrm>
              <a:custGeom>
                <a:avLst/>
                <a:gdLst>
                  <a:gd name="T0" fmla="*/ 1 w 190"/>
                  <a:gd name="T1" fmla="*/ 0 h 184"/>
                  <a:gd name="T2" fmla="*/ 47 w 190"/>
                  <a:gd name="T3" fmla="*/ 0 h 184"/>
                  <a:gd name="T4" fmla="*/ 86 w 190"/>
                  <a:gd name="T5" fmla="*/ 10 h 184"/>
                  <a:gd name="T6" fmla="*/ 127 w 190"/>
                  <a:gd name="T7" fmla="*/ 10 h 184"/>
                  <a:gd name="T8" fmla="*/ 162 w 190"/>
                  <a:gd name="T9" fmla="*/ 8 h 184"/>
                  <a:gd name="T10" fmla="*/ 166 w 190"/>
                  <a:gd name="T11" fmla="*/ 10 h 184"/>
                  <a:gd name="T12" fmla="*/ 169 w 190"/>
                  <a:gd name="T13" fmla="*/ 16 h 184"/>
                  <a:gd name="T14" fmla="*/ 174 w 190"/>
                  <a:gd name="T15" fmla="*/ 31 h 184"/>
                  <a:gd name="T16" fmla="*/ 181 w 190"/>
                  <a:gd name="T17" fmla="*/ 57 h 184"/>
                  <a:gd name="T18" fmla="*/ 181 w 190"/>
                  <a:gd name="T19" fmla="*/ 75 h 184"/>
                  <a:gd name="T20" fmla="*/ 181 w 190"/>
                  <a:gd name="T21" fmla="*/ 91 h 184"/>
                  <a:gd name="T22" fmla="*/ 188 w 190"/>
                  <a:gd name="T23" fmla="*/ 100 h 184"/>
                  <a:gd name="T24" fmla="*/ 190 w 190"/>
                  <a:gd name="T25" fmla="*/ 107 h 184"/>
                  <a:gd name="T26" fmla="*/ 188 w 190"/>
                  <a:gd name="T27" fmla="*/ 114 h 184"/>
                  <a:gd name="T28" fmla="*/ 177 w 190"/>
                  <a:gd name="T29" fmla="*/ 122 h 184"/>
                  <a:gd name="T30" fmla="*/ 159 w 190"/>
                  <a:gd name="T31" fmla="*/ 137 h 184"/>
                  <a:gd name="T32" fmla="*/ 134 w 190"/>
                  <a:gd name="T33" fmla="*/ 152 h 184"/>
                  <a:gd name="T34" fmla="*/ 123 w 190"/>
                  <a:gd name="T35" fmla="*/ 159 h 184"/>
                  <a:gd name="T36" fmla="*/ 109 w 190"/>
                  <a:gd name="T37" fmla="*/ 166 h 184"/>
                  <a:gd name="T38" fmla="*/ 87 w 190"/>
                  <a:gd name="T39" fmla="*/ 176 h 184"/>
                  <a:gd name="T40" fmla="*/ 74 w 190"/>
                  <a:gd name="T41" fmla="*/ 181 h 184"/>
                  <a:gd name="T42" fmla="*/ 51 w 190"/>
                  <a:gd name="T43" fmla="*/ 178 h 184"/>
                  <a:gd name="T44" fmla="*/ 15 w 190"/>
                  <a:gd name="T45" fmla="*/ 152 h 184"/>
                  <a:gd name="T46" fmla="*/ 12 w 190"/>
                  <a:gd name="T47" fmla="*/ 123 h 184"/>
                  <a:gd name="T48" fmla="*/ 14 w 190"/>
                  <a:gd name="T49" fmla="*/ 57 h 184"/>
                  <a:gd name="T50" fmla="*/ 14 w 190"/>
                  <a:gd name="T51" fmla="*/ 28 h 184"/>
                  <a:gd name="T52" fmla="*/ 0 w 190"/>
                  <a:gd name="T53" fmla="*/ 7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90" h="184">
                    <a:moveTo>
                      <a:pt x="1" y="0"/>
                    </a:moveTo>
                    <a:cubicBezTo>
                      <a:pt x="47" y="0"/>
                      <a:pt x="47" y="0"/>
                      <a:pt x="47" y="0"/>
                    </a:cubicBezTo>
                    <a:cubicBezTo>
                      <a:pt x="86" y="10"/>
                      <a:pt x="86" y="10"/>
                      <a:pt x="86" y="10"/>
                    </a:cubicBezTo>
                    <a:cubicBezTo>
                      <a:pt x="127" y="10"/>
                      <a:pt x="127" y="10"/>
                      <a:pt x="127" y="10"/>
                    </a:cubicBezTo>
                    <a:cubicBezTo>
                      <a:pt x="162" y="8"/>
                      <a:pt x="162" y="8"/>
                      <a:pt x="162" y="8"/>
                    </a:cubicBezTo>
                    <a:cubicBezTo>
                      <a:pt x="162" y="8"/>
                      <a:pt x="165" y="8"/>
                      <a:pt x="166" y="10"/>
                    </a:cubicBezTo>
                    <a:cubicBezTo>
                      <a:pt x="168" y="11"/>
                      <a:pt x="169" y="16"/>
                      <a:pt x="169" y="16"/>
                    </a:cubicBezTo>
                    <a:cubicBezTo>
                      <a:pt x="174" y="31"/>
                      <a:pt x="174" y="31"/>
                      <a:pt x="174" y="31"/>
                    </a:cubicBezTo>
                    <a:cubicBezTo>
                      <a:pt x="181" y="57"/>
                      <a:pt x="181" y="57"/>
                      <a:pt x="181" y="57"/>
                    </a:cubicBezTo>
                    <a:cubicBezTo>
                      <a:pt x="181" y="75"/>
                      <a:pt x="181" y="75"/>
                      <a:pt x="181" y="75"/>
                    </a:cubicBezTo>
                    <a:cubicBezTo>
                      <a:pt x="181" y="91"/>
                      <a:pt x="181" y="91"/>
                      <a:pt x="181" y="91"/>
                    </a:cubicBezTo>
                    <a:cubicBezTo>
                      <a:pt x="188" y="100"/>
                      <a:pt x="188" y="100"/>
                      <a:pt x="188" y="100"/>
                    </a:cubicBezTo>
                    <a:cubicBezTo>
                      <a:pt x="190" y="107"/>
                      <a:pt x="190" y="107"/>
                      <a:pt x="190" y="107"/>
                    </a:cubicBezTo>
                    <a:cubicBezTo>
                      <a:pt x="188" y="114"/>
                      <a:pt x="188" y="114"/>
                      <a:pt x="188" y="114"/>
                    </a:cubicBezTo>
                    <a:cubicBezTo>
                      <a:pt x="177" y="122"/>
                      <a:pt x="177" y="122"/>
                      <a:pt x="177" y="122"/>
                    </a:cubicBezTo>
                    <a:cubicBezTo>
                      <a:pt x="159" y="137"/>
                      <a:pt x="159" y="137"/>
                      <a:pt x="159" y="137"/>
                    </a:cubicBezTo>
                    <a:cubicBezTo>
                      <a:pt x="134" y="152"/>
                      <a:pt x="134" y="152"/>
                      <a:pt x="134" y="152"/>
                    </a:cubicBezTo>
                    <a:cubicBezTo>
                      <a:pt x="123" y="159"/>
                      <a:pt x="123" y="159"/>
                      <a:pt x="123" y="159"/>
                    </a:cubicBezTo>
                    <a:cubicBezTo>
                      <a:pt x="109" y="166"/>
                      <a:pt x="109" y="166"/>
                      <a:pt x="109" y="166"/>
                    </a:cubicBezTo>
                    <a:cubicBezTo>
                      <a:pt x="87" y="176"/>
                      <a:pt x="87" y="176"/>
                      <a:pt x="87" y="176"/>
                    </a:cubicBezTo>
                    <a:cubicBezTo>
                      <a:pt x="87" y="176"/>
                      <a:pt x="82" y="180"/>
                      <a:pt x="74" y="181"/>
                    </a:cubicBezTo>
                    <a:cubicBezTo>
                      <a:pt x="65" y="181"/>
                      <a:pt x="61" y="184"/>
                      <a:pt x="51" y="178"/>
                    </a:cubicBezTo>
                    <a:cubicBezTo>
                      <a:pt x="41" y="171"/>
                      <a:pt x="17" y="156"/>
                      <a:pt x="15" y="152"/>
                    </a:cubicBezTo>
                    <a:cubicBezTo>
                      <a:pt x="13" y="147"/>
                      <a:pt x="11" y="131"/>
                      <a:pt x="12" y="123"/>
                    </a:cubicBezTo>
                    <a:cubicBezTo>
                      <a:pt x="13" y="115"/>
                      <a:pt x="14" y="57"/>
                      <a:pt x="14" y="57"/>
                    </a:cubicBezTo>
                    <a:cubicBezTo>
                      <a:pt x="14" y="28"/>
                      <a:pt x="14" y="28"/>
                      <a:pt x="14" y="28"/>
                    </a:cubicBezTo>
                    <a:cubicBezTo>
                      <a:pt x="0" y="7"/>
                      <a:pt x="0" y="7"/>
                      <a:pt x="0" y="7"/>
                    </a:cubicBezTo>
                  </a:path>
                </a:pathLst>
              </a:custGeom>
              <a:solidFill>
                <a:schemeClr val="accent2">
                  <a:lumMod val="40000"/>
                  <a:lumOff val="60000"/>
                  <a:alpha val="75000"/>
                </a:schemeClr>
              </a:solidFill>
              <a:ln w="7938" cap="rnd">
                <a:solidFill>
                  <a:schemeClr val="tx1"/>
                </a:solidFill>
                <a:prstDash val="dash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" name="Freihandform 824">
                <a:extLst>
                  <a:ext uri="{FF2B5EF4-FFF2-40B4-BE49-F238E27FC236}">
                    <a16:creationId xmlns:a16="http://schemas.microsoft.com/office/drawing/2014/main" id="{9976307A-19FB-099D-DFAF-EA2E0D0CD8D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202814" y="3269818"/>
                <a:ext cx="140818" cy="126242"/>
              </a:xfrm>
              <a:custGeom>
                <a:avLst/>
                <a:gdLst>
                  <a:gd name="connsiteX0" fmla="*/ 2388865 w 7040906"/>
                  <a:gd name="connsiteY0" fmla="*/ 2776008 h 6312049"/>
                  <a:gd name="connsiteX1" fmla="*/ 2508608 w 7040906"/>
                  <a:gd name="connsiteY1" fmla="*/ 2449437 h 6312049"/>
                  <a:gd name="connsiteX2" fmla="*/ 2388865 w 7040906"/>
                  <a:gd name="connsiteY2" fmla="*/ 2068437 h 6312049"/>
                  <a:gd name="connsiteX3" fmla="*/ 2018751 w 7040906"/>
                  <a:gd name="connsiteY3" fmla="*/ 1654780 h 6312049"/>
                  <a:gd name="connsiteX4" fmla="*/ 1615980 w 7040906"/>
                  <a:gd name="connsiteY4" fmla="*/ 1393522 h 6312049"/>
                  <a:gd name="connsiteX5" fmla="*/ 1137008 w 7040906"/>
                  <a:gd name="connsiteY5" fmla="*/ 1197580 h 6312049"/>
                  <a:gd name="connsiteX6" fmla="*/ 777780 w 7040906"/>
                  <a:gd name="connsiteY6" fmla="*/ 1360865 h 6312049"/>
                  <a:gd name="connsiteX7" fmla="*/ 734237 w 7040906"/>
                  <a:gd name="connsiteY7" fmla="*/ 1066951 h 6312049"/>
                  <a:gd name="connsiteX8" fmla="*/ 1093465 w 7040906"/>
                  <a:gd name="connsiteY8" fmla="*/ 1034294 h 6312049"/>
                  <a:gd name="connsiteX9" fmla="*/ 1452694 w 7040906"/>
                  <a:gd name="connsiteY9" fmla="*/ 1219351 h 6312049"/>
                  <a:gd name="connsiteX10" fmla="*/ 1942551 w 7040906"/>
                  <a:gd name="connsiteY10" fmla="*/ 1426180 h 6312049"/>
                  <a:gd name="connsiteX11" fmla="*/ 2443294 w 7040906"/>
                  <a:gd name="connsiteY11" fmla="*/ 1654780 h 6312049"/>
                  <a:gd name="connsiteX12" fmla="*/ 3129094 w 7040906"/>
                  <a:gd name="connsiteY12" fmla="*/ 1535037 h 6312049"/>
                  <a:gd name="connsiteX13" fmla="*/ 2791637 w 7040906"/>
                  <a:gd name="connsiteY13" fmla="*/ 1709208 h 6312049"/>
                  <a:gd name="connsiteX14" fmla="*/ 3150865 w 7040906"/>
                  <a:gd name="connsiteY14" fmla="*/ 1894265 h 6312049"/>
                  <a:gd name="connsiteX15" fmla="*/ 3978180 w 7040906"/>
                  <a:gd name="connsiteY15" fmla="*/ 1665665 h 6312049"/>
                  <a:gd name="connsiteX16" fmla="*/ 4250322 w 7040906"/>
                  <a:gd name="connsiteY16" fmla="*/ 1295551 h 6312049"/>
                  <a:gd name="connsiteX17" fmla="*/ 3923751 w 7040906"/>
                  <a:gd name="connsiteY17" fmla="*/ 1143151 h 6312049"/>
                  <a:gd name="connsiteX18" fmla="*/ 4228551 w 7040906"/>
                  <a:gd name="connsiteY18" fmla="*/ 1001637 h 6312049"/>
                  <a:gd name="connsiteX19" fmla="*/ 4936122 w 7040906"/>
                  <a:gd name="connsiteY19" fmla="*/ 718608 h 6312049"/>
                  <a:gd name="connsiteX20" fmla="*/ 5371551 w 7040906"/>
                  <a:gd name="connsiteY20" fmla="*/ 446465 h 6312049"/>
                  <a:gd name="connsiteX21" fmla="*/ 5567494 w 7040906"/>
                  <a:gd name="connsiteY21" fmla="*/ 446465 h 6312049"/>
                  <a:gd name="connsiteX22" fmla="*/ 5698122 w 7040906"/>
                  <a:gd name="connsiteY22" fmla="*/ 206980 h 6312049"/>
                  <a:gd name="connsiteX23" fmla="*/ 5872294 w 7040906"/>
                  <a:gd name="connsiteY23" fmla="*/ 392037 h 6312049"/>
                  <a:gd name="connsiteX24" fmla="*/ 6242408 w 7040906"/>
                  <a:gd name="connsiteY24" fmla="*/ 402922 h 6312049"/>
                  <a:gd name="connsiteX25" fmla="*/ 6514551 w 7040906"/>
                  <a:gd name="connsiteY25" fmla="*/ 315837 h 6312049"/>
                  <a:gd name="connsiteX26" fmla="*/ 7026180 w 7040906"/>
                  <a:gd name="connsiteY26" fmla="*/ 151 h 6312049"/>
                  <a:gd name="connsiteX27" fmla="*/ 6906437 w 7040906"/>
                  <a:gd name="connsiteY27" fmla="*/ 359380 h 6312049"/>
                  <a:gd name="connsiteX28" fmla="*/ 6949980 w 7040906"/>
                  <a:gd name="connsiteY28" fmla="*/ 468237 h 6312049"/>
                  <a:gd name="connsiteX29" fmla="*/ 6830237 w 7040906"/>
                  <a:gd name="connsiteY29" fmla="*/ 675065 h 6312049"/>
                  <a:gd name="connsiteX30" fmla="*/ 6960865 w 7040906"/>
                  <a:gd name="connsiteY30" fmla="*/ 1001637 h 6312049"/>
                  <a:gd name="connsiteX31" fmla="*/ 6841122 w 7040906"/>
                  <a:gd name="connsiteY31" fmla="*/ 1208465 h 6312049"/>
                  <a:gd name="connsiteX32" fmla="*/ 6296837 w 7040906"/>
                  <a:gd name="connsiteY32" fmla="*/ 1535037 h 6312049"/>
                  <a:gd name="connsiteX33" fmla="*/ 6710494 w 7040906"/>
                  <a:gd name="connsiteY33" fmla="*/ 1023408 h 6312049"/>
                  <a:gd name="connsiteX34" fmla="*/ 6264180 w 7040906"/>
                  <a:gd name="connsiteY34" fmla="*/ 1241122 h 6312049"/>
                  <a:gd name="connsiteX35" fmla="*/ 6057351 w 7040906"/>
                  <a:gd name="connsiteY35" fmla="*/ 1491494 h 6312049"/>
                  <a:gd name="connsiteX36" fmla="*/ 5654580 w 7040906"/>
                  <a:gd name="connsiteY36" fmla="*/ 1567694 h 6312049"/>
                  <a:gd name="connsiteX37" fmla="*/ 5415094 w 7040906"/>
                  <a:gd name="connsiteY37" fmla="*/ 1839837 h 6312049"/>
                  <a:gd name="connsiteX38" fmla="*/ 4772837 w 7040906"/>
                  <a:gd name="connsiteY38" fmla="*/ 2090208 h 6312049"/>
                  <a:gd name="connsiteX39" fmla="*/ 4772837 w 7040906"/>
                  <a:gd name="connsiteY39" fmla="*/ 2253494 h 6312049"/>
                  <a:gd name="connsiteX40" fmla="*/ 4337408 w 7040906"/>
                  <a:gd name="connsiteY40" fmla="*/ 2950180 h 6312049"/>
                  <a:gd name="connsiteX41" fmla="*/ 4228551 w 7040906"/>
                  <a:gd name="connsiteY41" fmla="*/ 2895751 h 6312049"/>
                  <a:gd name="connsiteX42" fmla="*/ 4250322 w 7040906"/>
                  <a:gd name="connsiteY42" fmla="*/ 2645380 h 6312049"/>
                  <a:gd name="connsiteX43" fmla="*/ 3956408 w 7040906"/>
                  <a:gd name="connsiteY43" fmla="*/ 3265865 h 6312049"/>
                  <a:gd name="connsiteX44" fmla="*/ 3662494 w 7040906"/>
                  <a:gd name="connsiteY44" fmla="*/ 3614208 h 6312049"/>
                  <a:gd name="connsiteX45" fmla="*/ 3640722 w 7040906"/>
                  <a:gd name="connsiteY45" fmla="*/ 3494465 h 6312049"/>
                  <a:gd name="connsiteX46" fmla="*/ 3455665 w 7040906"/>
                  <a:gd name="connsiteY46" fmla="*/ 4125837 h 6312049"/>
                  <a:gd name="connsiteX47" fmla="*/ 2965808 w 7040906"/>
                  <a:gd name="connsiteY47" fmla="*/ 4441522 h 6312049"/>
                  <a:gd name="connsiteX48" fmla="*/ 2846065 w 7040906"/>
                  <a:gd name="connsiteY48" fmla="*/ 4811637 h 6312049"/>
                  <a:gd name="connsiteX49" fmla="*/ 2715437 w 7040906"/>
                  <a:gd name="connsiteY49" fmla="*/ 5410351 h 6312049"/>
                  <a:gd name="connsiteX50" fmla="*/ 2584808 w 7040906"/>
                  <a:gd name="connsiteY50" fmla="*/ 5617180 h 6312049"/>
                  <a:gd name="connsiteX51" fmla="*/ 2323551 w 7040906"/>
                  <a:gd name="connsiteY51" fmla="*/ 5769580 h 6312049"/>
                  <a:gd name="connsiteX52" fmla="*/ 2269122 w 7040906"/>
                  <a:gd name="connsiteY52" fmla="*/ 5704265 h 6312049"/>
                  <a:gd name="connsiteX53" fmla="*/ 2127608 w 7040906"/>
                  <a:gd name="connsiteY53" fmla="*/ 6063494 h 6312049"/>
                  <a:gd name="connsiteX54" fmla="*/ 2084065 w 7040906"/>
                  <a:gd name="connsiteY54" fmla="*/ 6281208 h 6312049"/>
                  <a:gd name="connsiteX55" fmla="*/ 1811922 w 7040906"/>
                  <a:gd name="connsiteY55" fmla="*/ 6292094 h 6312049"/>
                  <a:gd name="connsiteX56" fmla="*/ 1975208 w 7040906"/>
                  <a:gd name="connsiteY56" fmla="*/ 6107037 h 6312049"/>
                  <a:gd name="connsiteX57" fmla="*/ 2040522 w 7040906"/>
                  <a:gd name="connsiteY57" fmla="*/ 5736922 h 6312049"/>
                  <a:gd name="connsiteX58" fmla="*/ 2149380 w 7040906"/>
                  <a:gd name="connsiteY58" fmla="*/ 5355922 h 6312049"/>
                  <a:gd name="connsiteX59" fmla="*/ 2149380 w 7040906"/>
                  <a:gd name="connsiteY59" fmla="*/ 5170865 h 6312049"/>
                  <a:gd name="connsiteX60" fmla="*/ 1986094 w 7040906"/>
                  <a:gd name="connsiteY60" fmla="*/ 5094665 h 6312049"/>
                  <a:gd name="connsiteX61" fmla="*/ 1703065 w 7040906"/>
                  <a:gd name="connsiteY61" fmla="*/ 5181751 h 6312049"/>
                  <a:gd name="connsiteX62" fmla="*/ 1953437 w 7040906"/>
                  <a:gd name="connsiteY62" fmla="*/ 4811637 h 6312049"/>
                  <a:gd name="connsiteX63" fmla="*/ 1768380 w 7040906"/>
                  <a:gd name="connsiteY63" fmla="*/ 4517722 h 6312049"/>
                  <a:gd name="connsiteX64" fmla="*/ 1539780 w 7040906"/>
                  <a:gd name="connsiteY64" fmla="*/ 4561265 h 6312049"/>
                  <a:gd name="connsiteX65" fmla="*/ 1376494 w 7040906"/>
                  <a:gd name="connsiteY65" fmla="*/ 4702780 h 6312049"/>
                  <a:gd name="connsiteX66" fmla="*/ 1354722 w 7040906"/>
                  <a:gd name="connsiteY66" fmla="*/ 4561265 h 6312049"/>
                  <a:gd name="connsiteX67" fmla="*/ 1213208 w 7040906"/>
                  <a:gd name="connsiteY67" fmla="*/ 4506837 h 6312049"/>
                  <a:gd name="connsiteX68" fmla="*/ 1376494 w 7040906"/>
                  <a:gd name="connsiteY68" fmla="*/ 4397980 h 6312049"/>
                  <a:gd name="connsiteX69" fmla="*/ 1071694 w 7040906"/>
                  <a:gd name="connsiteY69" fmla="*/ 4049637 h 6312049"/>
                  <a:gd name="connsiteX70" fmla="*/ 875751 w 7040906"/>
                  <a:gd name="connsiteY70" fmla="*/ 4038751 h 6312049"/>
                  <a:gd name="connsiteX71" fmla="*/ 919294 w 7040906"/>
                  <a:gd name="connsiteY71" fmla="*/ 4245580 h 6312049"/>
                  <a:gd name="connsiteX72" fmla="*/ 1017265 w 7040906"/>
                  <a:gd name="connsiteY72" fmla="*/ 4648351 h 6312049"/>
                  <a:gd name="connsiteX73" fmla="*/ 886637 w 7040906"/>
                  <a:gd name="connsiteY73" fmla="*/ 4278237 h 6312049"/>
                  <a:gd name="connsiteX74" fmla="*/ 832208 w 7040906"/>
                  <a:gd name="connsiteY74" fmla="*/ 4278237 h 6312049"/>
                  <a:gd name="connsiteX75" fmla="*/ 756008 w 7040906"/>
                  <a:gd name="connsiteY75" fmla="*/ 3886351 h 6312049"/>
                  <a:gd name="connsiteX76" fmla="*/ 157294 w 7040906"/>
                  <a:gd name="connsiteY76" fmla="*/ 3864580 h 6312049"/>
                  <a:gd name="connsiteX77" fmla="*/ 37551 w 7040906"/>
                  <a:gd name="connsiteY77" fmla="*/ 3919008 h 6312049"/>
                  <a:gd name="connsiteX78" fmla="*/ 15780 w 7040906"/>
                  <a:gd name="connsiteY78" fmla="*/ 3788380 h 6312049"/>
                  <a:gd name="connsiteX79" fmla="*/ 255265 w 7040906"/>
                  <a:gd name="connsiteY79" fmla="*/ 3723065 h 6312049"/>
                  <a:gd name="connsiteX80" fmla="*/ 603608 w 7040906"/>
                  <a:gd name="connsiteY80" fmla="*/ 3265865 h 6312049"/>
                  <a:gd name="connsiteX81" fmla="*/ 723351 w 7040906"/>
                  <a:gd name="connsiteY81" fmla="*/ 3363837 h 6312049"/>
                  <a:gd name="connsiteX82" fmla="*/ 745122 w 7040906"/>
                  <a:gd name="connsiteY82" fmla="*/ 3157008 h 6312049"/>
                  <a:gd name="connsiteX83" fmla="*/ 570951 w 7040906"/>
                  <a:gd name="connsiteY83" fmla="*/ 3037265 h 6312049"/>
                  <a:gd name="connsiteX84" fmla="*/ 570951 w 7040906"/>
                  <a:gd name="connsiteY84" fmla="*/ 2580065 h 6312049"/>
                  <a:gd name="connsiteX85" fmla="*/ 396780 w 7040906"/>
                  <a:gd name="connsiteY85" fmla="*/ 2373237 h 6312049"/>
                  <a:gd name="connsiteX86" fmla="*/ 320580 w 7040906"/>
                  <a:gd name="connsiteY86" fmla="*/ 2286151 h 6312049"/>
                  <a:gd name="connsiteX87" fmla="*/ 233494 w 7040906"/>
                  <a:gd name="connsiteY87" fmla="*/ 2384122 h 6312049"/>
                  <a:gd name="connsiteX88" fmla="*/ 233494 w 7040906"/>
                  <a:gd name="connsiteY88" fmla="*/ 2220837 h 6312049"/>
                  <a:gd name="connsiteX89" fmla="*/ 320580 w 7040906"/>
                  <a:gd name="connsiteY89" fmla="*/ 1992237 h 6312049"/>
                  <a:gd name="connsiteX90" fmla="*/ 570951 w 7040906"/>
                  <a:gd name="connsiteY90" fmla="*/ 2144637 h 6312049"/>
                  <a:gd name="connsiteX91" fmla="*/ 462094 w 7040906"/>
                  <a:gd name="connsiteY91" fmla="*/ 2297037 h 6312049"/>
                  <a:gd name="connsiteX92" fmla="*/ 679808 w 7040906"/>
                  <a:gd name="connsiteY92" fmla="*/ 2623608 h 6312049"/>
                  <a:gd name="connsiteX93" fmla="*/ 788665 w 7040906"/>
                  <a:gd name="connsiteY93" fmla="*/ 3015494 h 6312049"/>
                  <a:gd name="connsiteX94" fmla="*/ 1256751 w 7040906"/>
                  <a:gd name="connsiteY94" fmla="*/ 3189665 h 6312049"/>
                  <a:gd name="connsiteX95" fmla="*/ 1234980 w 7040906"/>
                  <a:gd name="connsiteY95" fmla="*/ 2950180 h 6312049"/>
                  <a:gd name="connsiteX96" fmla="*/ 1801037 w 7040906"/>
                  <a:gd name="connsiteY96" fmla="*/ 2884865 h 6312049"/>
                  <a:gd name="connsiteX97" fmla="*/ 2094951 w 7040906"/>
                  <a:gd name="connsiteY97" fmla="*/ 2939294 h 6312049"/>
                  <a:gd name="connsiteX98" fmla="*/ 2388865 w 7040906"/>
                  <a:gd name="connsiteY98" fmla="*/ 2776008 h 63120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</a:cxnLst>
                <a:rect l="l" t="t" r="r" b="b"/>
                <a:pathLst>
                  <a:path w="7040906" h="6312049">
                    <a:moveTo>
                      <a:pt x="2388865" y="2776008"/>
                    </a:moveTo>
                    <a:cubicBezTo>
                      <a:pt x="2457808" y="2694365"/>
                      <a:pt x="2508608" y="2567365"/>
                      <a:pt x="2508608" y="2449437"/>
                    </a:cubicBezTo>
                    <a:cubicBezTo>
                      <a:pt x="2508608" y="2331509"/>
                      <a:pt x="2470508" y="2200880"/>
                      <a:pt x="2388865" y="2068437"/>
                    </a:cubicBezTo>
                    <a:cubicBezTo>
                      <a:pt x="2307222" y="1935994"/>
                      <a:pt x="2147565" y="1767266"/>
                      <a:pt x="2018751" y="1654780"/>
                    </a:cubicBezTo>
                    <a:cubicBezTo>
                      <a:pt x="1889937" y="1542294"/>
                      <a:pt x="1762937" y="1469722"/>
                      <a:pt x="1615980" y="1393522"/>
                    </a:cubicBezTo>
                    <a:cubicBezTo>
                      <a:pt x="1469023" y="1317322"/>
                      <a:pt x="1276708" y="1203023"/>
                      <a:pt x="1137008" y="1197580"/>
                    </a:cubicBezTo>
                    <a:cubicBezTo>
                      <a:pt x="997308" y="1192137"/>
                      <a:pt x="844908" y="1382636"/>
                      <a:pt x="777780" y="1360865"/>
                    </a:cubicBezTo>
                    <a:cubicBezTo>
                      <a:pt x="710652" y="1339094"/>
                      <a:pt x="681623" y="1121379"/>
                      <a:pt x="734237" y="1066951"/>
                    </a:cubicBezTo>
                    <a:cubicBezTo>
                      <a:pt x="786851" y="1012523"/>
                      <a:pt x="973722" y="1008894"/>
                      <a:pt x="1093465" y="1034294"/>
                    </a:cubicBezTo>
                    <a:cubicBezTo>
                      <a:pt x="1213208" y="1059694"/>
                      <a:pt x="1311180" y="1154037"/>
                      <a:pt x="1452694" y="1219351"/>
                    </a:cubicBezTo>
                    <a:cubicBezTo>
                      <a:pt x="1594208" y="1284665"/>
                      <a:pt x="1777451" y="1353608"/>
                      <a:pt x="1942551" y="1426180"/>
                    </a:cubicBezTo>
                    <a:cubicBezTo>
                      <a:pt x="2107651" y="1498751"/>
                      <a:pt x="2245537" y="1636637"/>
                      <a:pt x="2443294" y="1654780"/>
                    </a:cubicBezTo>
                    <a:cubicBezTo>
                      <a:pt x="2641051" y="1672923"/>
                      <a:pt x="3071037" y="1525966"/>
                      <a:pt x="3129094" y="1535037"/>
                    </a:cubicBezTo>
                    <a:cubicBezTo>
                      <a:pt x="3187151" y="1544108"/>
                      <a:pt x="2788009" y="1649337"/>
                      <a:pt x="2791637" y="1709208"/>
                    </a:cubicBezTo>
                    <a:cubicBezTo>
                      <a:pt x="2795265" y="1769079"/>
                      <a:pt x="2953108" y="1901522"/>
                      <a:pt x="3150865" y="1894265"/>
                    </a:cubicBezTo>
                    <a:cubicBezTo>
                      <a:pt x="3348622" y="1887008"/>
                      <a:pt x="3794937" y="1765451"/>
                      <a:pt x="3978180" y="1665665"/>
                    </a:cubicBezTo>
                    <a:cubicBezTo>
                      <a:pt x="4161423" y="1565879"/>
                      <a:pt x="4259393" y="1382637"/>
                      <a:pt x="4250322" y="1295551"/>
                    </a:cubicBezTo>
                    <a:cubicBezTo>
                      <a:pt x="4241251" y="1208465"/>
                      <a:pt x="3927380" y="1192137"/>
                      <a:pt x="3923751" y="1143151"/>
                    </a:cubicBezTo>
                    <a:cubicBezTo>
                      <a:pt x="3920123" y="1094165"/>
                      <a:pt x="4059823" y="1072394"/>
                      <a:pt x="4228551" y="1001637"/>
                    </a:cubicBezTo>
                    <a:cubicBezTo>
                      <a:pt x="4397279" y="930880"/>
                      <a:pt x="4745622" y="811137"/>
                      <a:pt x="4936122" y="718608"/>
                    </a:cubicBezTo>
                    <a:cubicBezTo>
                      <a:pt x="5126622" y="626079"/>
                      <a:pt x="5266322" y="491822"/>
                      <a:pt x="5371551" y="446465"/>
                    </a:cubicBezTo>
                    <a:cubicBezTo>
                      <a:pt x="5476780" y="401108"/>
                      <a:pt x="5513066" y="486379"/>
                      <a:pt x="5567494" y="446465"/>
                    </a:cubicBezTo>
                    <a:cubicBezTo>
                      <a:pt x="5621922" y="406551"/>
                      <a:pt x="5647322" y="216051"/>
                      <a:pt x="5698122" y="206980"/>
                    </a:cubicBezTo>
                    <a:cubicBezTo>
                      <a:pt x="5748922" y="197909"/>
                      <a:pt x="5781580" y="359380"/>
                      <a:pt x="5872294" y="392037"/>
                    </a:cubicBezTo>
                    <a:cubicBezTo>
                      <a:pt x="5963008" y="424694"/>
                      <a:pt x="6135365" y="415622"/>
                      <a:pt x="6242408" y="402922"/>
                    </a:cubicBezTo>
                    <a:cubicBezTo>
                      <a:pt x="6349451" y="390222"/>
                      <a:pt x="6383922" y="382965"/>
                      <a:pt x="6514551" y="315837"/>
                    </a:cubicBezTo>
                    <a:cubicBezTo>
                      <a:pt x="6645180" y="248709"/>
                      <a:pt x="6960866" y="-7106"/>
                      <a:pt x="7026180" y="151"/>
                    </a:cubicBezTo>
                    <a:cubicBezTo>
                      <a:pt x="7091494" y="7408"/>
                      <a:pt x="6919137" y="281366"/>
                      <a:pt x="6906437" y="359380"/>
                    </a:cubicBezTo>
                    <a:cubicBezTo>
                      <a:pt x="6893737" y="437394"/>
                      <a:pt x="6962680" y="415623"/>
                      <a:pt x="6949980" y="468237"/>
                    </a:cubicBezTo>
                    <a:cubicBezTo>
                      <a:pt x="6937280" y="520851"/>
                      <a:pt x="6828423" y="586165"/>
                      <a:pt x="6830237" y="675065"/>
                    </a:cubicBezTo>
                    <a:cubicBezTo>
                      <a:pt x="6832051" y="763965"/>
                      <a:pt x="6959051" y="912737"/>
                      <a:pt x="6960865" y="1001637"/>
                    </a:cubicBezTo>
                    <a:cubicBezTo>
                      <a:pt x="6962679" y="1090537"/>
                      <a:pt x="6951793" y="1119565"/>
                      <a:pt x="6841122" y="1208465"/>
                    </a:cubicBezTo>
                    <a:cubicBezTo>
                      <a:pt x="6730451" y="1297365"/>
                      <a:pt x="6318608" y="1565880"/>
                      <a:pt x="6296837" y="1535037"/>
                    </a:cubicBezTo>
                    <a:cubicBezTo>
                      <a:pt x="6275066" y="1504194"/>
                      <a:pt x="6715937" y="1072394"/>
                      <a:pt x="6710494" y="1023408"/>
                    </a:cubicBezTo>
                    <a:cubicBezTo>
                      <a:pt x="6705051" y="974422"/>
                      <a:pt x="6373037" y="1163108"/>
                      <a:pt x="6264180" y="1241122"/>
                    </a:cubicBezTo>
                    <a:cubicBezTo>
                      <a:pt x="6155323" y="1319136"/>
                      <a:pt x="6158951" y="1437065"/>
                      <a:pt x="6057351" y="1491494"/>
                    </a:cubicBezTo>
                    <a:cubicBezTo>
                      <a:pt x="5955751" y="1545923"/>
                      <a:pt x="5761623" y="1509637"/>
                      <a:pt x="5654580" y="1567694"/>
                    </a:cubicBezTo>
                    <a:cubicBezTo>
                      <a:pt x="5547537" y="1625751"/>
                      <a:pt x="5562051" y="1752751"/>
                      <a:pt x="5415094" y="1839837"/>
                    </a:cubicBezTo>
                    <a:cubicBezTo>
                      <a:pt x="5268137" y="1926923"/>
                      <a:pt x="4879880" y="2021265"/>
                      <a:pt x="4772837" y="2090208"/>
                    </a:cubicBezTo>
                    <a:cubicBezTo>
                      <a:pt x="4665794" y="2159151"/>
                      <a:pt x="4845408" y="2110165"/>
                      <a:pt x="4772837" y="2253494"/>
                    </a:cubicBezTo>
                    <a:cubicBezTo>
                      <a:pt x="4700266" y="2396823"/>
                      <a:pt x="4428122" y="2843137"/>
                      <a:pt x="4337408" y="2950180"/>
                    </a:cubicBezTo>
                    <a:cubicBezTo>
                      <a:pt x="4246694" y="3057223"/>
                      <a:pt x="4243065" y="2946551"/>
                      <a:pt x="4228551" y="2895751"/>
                    </a:cubicBezTo>
                    <a:cubicBezTo>
                      <a:pt x="4214037" y="2844951"/>
                      <a:pt x="4295679" y="2583694"/>
                      <a:pt x="4250322" y="2645380"/>
                    </a:cubicBezTo>
                    <a:cubicBezTo>
                      <a:pt x="4204965" y="2707066"/>
                      <a:pt x="4054379" y="3104394"/>
                      <a:pt x="3956408" y="3265865"/>
                    </a:cubicBezTo>
                    <a:cubicBezTo>
                      <a:pt x="3858437" y="3427336"/>
                      <a:pt x="3715108" y="3576108"/>
                      <a:pt x="3662494" y="3614208"/>
                    </a:cubicBezTo>
                    <a:cubicBezTo>
                      <a:pt x="3609880" y="3652308"/>
                      <a:pt x="3675194" y="3409194"/>
                      <a:pt x="3640722" y="3494465"/>
                    </a:cubicBezTo>
                    <a:cubicBezTo>
                      <a:pt x="3606251" y="3579737"/>
                      <a:pt x="3568151" y="3967994"/>
                      <a:pt x="3455665" y="4125837"/>
                    </a:cubicBezTo>
                    <a:cubicBezTo>
                      <a:pt x="3343179" y="4283680"/>
                      <a:pt x="3067408" y="4327222"/>
                      <a:pt x="2965808" y="4441522"/>
                    </a:cubicBezTo>
                    <a:cubicBezTo>
                      <a:pt x="2864208" y="4555822"/>
                      <a:pt x="2887793" y="4650166"/>
                      <a:pt x="2846065" y="4811637"/>
                    </a:cubicBezTo>
                    <a:cubicBezTo>
                      <a:pt x="2804337" y="4973108"/>
                      <a:pt x="2758980" y="5276094"/>
                      <a:pt x="2715437" y="5410351"/>
                    </a:cubicBezTo>
                    <a:cubicBezTo>
                      <a:pt x="2671894" y="5544608"/>
                      <a:pt x="2650122" y="5557309"/>
                      <a:pt x="2584808" y="5617180"/>
                    </a:cubicBezTo>
                    <a:cubicBezTo>
                      <a:pt x="2519494" y="5677051"/>
                      <a:pt x="2376165" y="5755066"/>
                      <a:pt x="2323551" y="5769580"/>
                    </a:cubicBezTo>
                    <a:cubicBezTo>
                      <a:pt x="2270937" y="5784094"/>
                      <a:pt x="2301779" y="5655279"/>
                      <a:pt x="2269122" y="5704265"/>
                    </a:cubicBezTo>
                    <a:cubicBezTo>
                      <a:pt x="2236465" y="5753251"/>
                      <a:pt x="2158451" y="5967337"/>
                      <a:pt x="2127608" y="6063494"/>
                    </a:cubicBezTo>
                    <a:cubicBezTo>
                      <a:pt x="2096765" y="6159651"/>
                      <a:pt x="2136679" y="6243108"/>
                      <a:pt x="2084065" y="6281208"/>
                    </a:cubicBezTo>
                    <a:cubicBezTo>
                      <a:pt x="2031451" y="6319308"/>
                      <a:pt x="1830065" y="6321122"/>
                      <a:pt x="1811922" y="6292094"/>
                    </a:cubicBezTo>
                    <a:cubicBezTo>
                      <a:pt x="1793779" y="6263066"/>
                      <a:pt x="1937108" y="6199566"/>
                      <a:pt x="1975208" y="6107037"/>
                    </a:cubicBezTo>
                    <a:cubicBezTo>
                      <a:pt x="2013308" y="6014508"/>
                      <a:pt x="2011493" y="5862108"/>
                      <a:pt x="2040522" y="5736922"/>
                    </a:cubicBezTo>
                    <a:cubicBezTo>
                      <a:pt x="2069551" y="5611736"/>
                      <a:pt x="2131237" y="5450265"/>
                      <a:pt x="2149380" y="5355922"/>
                    </a:cubicBezTo>
                    <a:cubicBezTo>
                      <a:pt x="2167523" y="5261579"/>
                      <a:pt x="2176594" y="5214408"/>
                      <a:pt x="2149380" y="5170865"/>
                    </a:cubicBezTo>
                    <a:cubicBezTo>
                      <a:pt x="2122166" y="5127322"/>
                      <a:pt x="2060480" y="5092851"/>
                      <a:pt x="1986094" y="5094665"/>
                    </a:cubicBezTo>
                    <a:cubicBezTo>
                      <a:pt x="1911708" y="5096479"/>
                      <a:pt x="1708508" y="5228922"/>
                      <a:pt x="1703065" y="5181751"/>
                    </a:cubicBezTo>
                    <a:cubicBezTo>
                      <a:pt x="1697622" y="5134580"/>
                      <a:pt x="1942551" y="4922309"/>
                      <a:pt x="1953437" y="4811637"/>
                    </a:cubicBezTo>
                    <a:cubicBezTo>
                      <a:pt x="1964323" y="4700966"/>
                      <a:pt x="1837323" y="4559451"/>
                      <a:pt x="1768380" y="4517722"/>
                    </a:cubicBezTo>
                    <a:cubicBezTo>
                      <a:pt x="1699437" y="4475993"/>
                      <a:pt x="1605094" y="4530422"/>
                      <a:pt x="1539780" y="4561265"/>
                    </a:cubicBezTo>
                    <a:cubicBezTo>
                      <a:pt x="1474466" y="4592108"/>
                      <a:pt x="1407337" y="4702780"/>
                      <a:pt x="1376494" y="4702780"/>
                    </a:cubicBezTo>
                    <a:cubicBezTo>
                      <a:pt x="1345651" y="4702780"/>
                      <a:pt x="1381936" y="4593922"/>
                      <a:pt x="1354722" y="4561265"/>
                    </a:cubicBezTo>
                    <a:cubicBezTo>
                      <a:pt x="1327508" y="4528608"/>
                      <a:pt x="1209579" y="4534051"/>
                      <a:pt x="1213208" y="4506837"/>
                    </a:cubicBezTo>
                    <a:cubicBezTo>
                      <a:pt x="1216837" y="4479623"/>
                      <a:pt x="1400080" y="4474180"/>
                      <a:pt x="1376494" y="4397980"/>
                    </a:cubicBezTo>
                    <a:cubicBezTo>
                      <a:pt x="1352908" y="4321780"/>
                      <a:pt x="1155151" y="4109509"/>
                      <a:pt x="1071694" y="4049637"/>
                    </a:cubicBezTo>
                    <a:cubicBezTo>
                      <a:pt x="988237" y="3989766"/>
                      <a:pt x="901151" y="4006094"/>
                      <a:pt x="875751" y="4038751"/>
                    </a:cubicBezTo>
                    <a:cubicBezTo>
                      <a:pt x="850351" y="4071408"/>
                      <a:pt x="895708" y="4143980"/>
                      <a:pt x="919294" y="4245580"/>
                    </a:cubicBezTo>
                    <a:cubicBezTo>
                      <a:pt x="942880" y="4347180"/>
                      <a:pt x="1022708" y="4642908"/>
                      <a:pt x="1017265" y="4648351"/>
                    </a:cubicBezTo>
                    <a:cubicBezTo>
                      <a:pt x="1011822" y="4653794"/>
                      <a:pt x="917480" y="4339923"/>
                      <a:pt x="886637" y="4278237"/>
                    </a:cubicBezTo>
                    <a:cubicBezTo>
                      <a:pt x="855794" y="4216551"/>
                      <a:pt x="853979" y="4343551"/>
                      <a:pt x="832208" y="4278237"/>
                    </a:cubicBezTo>
                    <a:cubicBezTo>
                      <a:pt x="810437" y="4212923"/>
                      <a:pt x="868494" y="3955294"/>
                      <a:pt x="756008" y="3886351"/>
                    </a:cubicBezTo>
                    <a:cubicBezTo>
                      <a:pt x="643522" y="3817408"/>
                      <a:pt x="277037" y="3859137"/>
                      <a:pt x="157294" y="3864580"/>
                    </a:cubicBezTo>
                    <a:cubicBezTo>
                      <a:pt x="37551" y="3870023"/>
                      <a:pt x="61137" y="3931708"/>
                      <a:pt x="37551" y="3919008"/>
                    </a:cubicBezTo>
                    <a:cubicBezTo>
                      <a:pt x="13965" y="3906308"/>
                      <a:pt x="-20506" y="3821037"/>
                      <a:pt x="15780" y="3788380"/>
                    </a:cubicBezTo>
                    <a:cubicBezTo>
                      <a:pt x="52066" y="3755723"/>
                      <a:pt x="157294" y="3810151"/>
                      <a:pt x="255265" y="3723065"/>
                    </a:cubicBezTo>
                    <a:cubicBezTo>
                      <a:pt x="353236" y="3635979"/>
                      <a:pt x="525594" y="3325736"/>
                      <a:pt x="603608" y="3265865"/>
                    </a:cubicBezTo>
                    <a:cubicBezTo>
                      <a:pt x="681622" y="3205994"/>
                      <a:pt x="699765" y="3381980"/>
                      <a:pt x="723351" y="3363837"/>
                    </a:cubicBezTo>
                    <a:cubicBezTo>
                      <a:pt x="746937" y="3345694"/>
                      <a:pt x="770522" y="3211437"/>
                      <a:pt x="745122" y="3157008"/>
                    </a:cubicBezTo>
                    <a:cubicBezTo>
                      <a:pt x="719722" y="3102579"/>
                      <a:pt x="599979" y="3133422"/>
                      <a:pt x="570951" y="3037265"/>
                    </a:cubicBezTo>
                    <a:cubicBezTo>
                      <a:pt x="541922" y="2941108"/>
                      <a:pt x="599979" y="2690736"/>
                      <a:pt x="570951" y="2580065"/>
                    </a:cubicBezTo>
                    <a:cubicBezTo>
                      <a:pt x="541922" y="2469394"/>
                      <a:pt x="438508" y="2422223"/>
                      <a:pt x="396780" y="2373237"/>
                    </a:cubicBezTo>
                    <a:cubicBezTo>
                      <a:pt x="355052" y="2324251"/>
                      <a:pt x="347794" y="2284337"/>
                      <a:pt x="320580" y="2286151"/>
                    </a:cubicBezTo>
                    <a:cubicBezTo>
                      <a:pt x="293366" y="2287965"/>
                      <a:pt x="248008" y="2395008"/>
                      <a:pt x="233494" y="2384122"/>
                    </a:cubicBezTo>
                    <a:cubicBezTo>
                      <a:pt x="218980" y="2373236"/>
                      <a:pt x="218980" y="2286151"/>
                      <a:pt x="233494" y="2220837"/>
                    </a:cubicBezTo>
                    <a:cubicBezTo>
                      <a:pt x="248008" y="2155523"/>
                      <a:pt x="264337" y="2004937"/>
                      <a:pt x="320580" y="1992237"/>
                    </a:cubicBezTo>
                    <a:cubicBezTo>
                      <a:pt x="376823" y="1979537"/>
                      <a:pt x="547365" y="2093837"/>
                      <a:pt x="570951" y="2144637"/>
                    </a:cubicBezTo>
                    <a:cubicBezTo>
                      <a:pt x="594537" y="2195437"/>
                      <a:pt x="443951" y="2217209"/>
                      <a:pt x="462094" y="2297037"/>
                    </a:cubicBezTo>
                    <a:cubicBezTo>
                      <a:pt x="480237" y="2376865"/>
                      <a:pt x="625380" y="2503865"/>
                      <a:pt x="679808" y="2623608"/>
                    </a:cubicBezTo>
                    <a:cubicBezTo>
                      <a:pt x="734236" y="2743351"/>
                      <a:pt x="692508" y="2921151"/>
                      <a:pt x="788665" y="3015494"/>
                    </a:cubicBezTo>
                    <a:cubicBezTo>
                      <a:pt x="884822" y="3109837"/>
                      <a:pt x="1182365" y="3200551"/>
                      <a:pt x="1256751" y="3189665"/>
                    </a:cubicBezTo>
                    <a:cubicBezTo>
                      <a:pt x="1331137" y="3178779"/>
                      <a:pt x="1144266" y="3000980"/>
                      <a:pt x="1234980" y="2950180"/>
                    </a:cubicBezTo>
                    <a:cubicBezTo>
                      <a:pt x="1325694" y="2899380"/>
                      <a:pt x="1657709" y="2886679"/>
                      <a:pt x="1801037" y="2884865"/>
                    </a:cubicBezTo>
                    <a:cubicBezTo>
                      <a:pt x="1944365" y="2883051"/>
                      <a:pt x="1996980" y="2962880"/>
                      <a:pt x="2094951" y="2939294"/>
                    </a:cubicBezTo>
                    <a:cubicBezTo>
                      <a:pt x="2192922" y="2915708"/>
                      <a:pt x="2319922" y="2857651"/>
                      <a:pt x="2388865" y="2776008"/>
                    </a:cubicBez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2" name="Line 281">
                <a:extLst>
                  <a:ext uri="{FF2B5EF4-FFF2-40B4-BE49-F238E27FC236}">
                    <a16:creationId xmlns:a16="http://schemas.microsoft.com/office/drawing/2014/main" id="{596616C0-7D9C-8B3A-B61E-8D7EE9E2AF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04339" y="3344066"/>
                <a:ext cx="149225" cy="113506"/>
              </a:xfrm>
              <a:prstGeom prst="line">
                <a:avLst/>
              </a:prstGeom>
              <a:noFill/>
              <a:ln w="7938" cap="rnd">
                <a:solidFill>
                  <a:srgbClr val="23202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" name="Rectangle 282">
                <a:extLst>
                  <a:ext uri="{FF2B5EF4-FFF2-40B4-BE49-F238E27FC236}">
                    <a16:creationId xmlns:a16="http://schemas.microsoft.com/office/drawing/2014/main" id="{11FA753F-C110-9832-4921-6C45573B06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2307" y="3079039"/>
                <a:ext cx="482504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i="1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Kaapvaal</a:t>
                </a:r>
                <a:endParaRPr kumimoji="0" lang="de-DE" altLang="de-DE" sz="1000" i="1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de-DE" altLang="de-DE" sz="1000" i="1" dirty="0" err="1">
                    <a:solidFill>
                      <a:srgbClr val="232021"/>
                    </a:solidFill>
                    <a:latin typeface="+mn-lt"/>
                  </a:rPr>
                  <a:t>Craton</a:t>
                </a:r>
                <a:endParaRPr kumimoji="0" lang="de-DE" altLang="de-DE" sz="18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</p:grpSp>
        <p:sp>
          <p:nvSpPr>
            <p:cNvPr id="74" name="Textfeld 45">
              <a:extLst>
                <a:ext uri="{FF2B5EF4-FFF2-40B4-BE49-F238E27FC236}">
                  <a16:creationId xmlns:a16="http://schemas.microsoft.com/office/drawing/2014/main" id="{B251024D-8098-4644-191C-47A024F83A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712759">
              <a:off x="1710139" y="3968357"/>
              <a:ext cx="1041165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de-DE" sz="1000" i="1" dirty="0" err="1">
                  <a:latin typeface="Calibri" pitchFamily="34" charset="0"/>
                </a:rPr>
                <a:t>Onverwacht</a:t>
              </a:r>
              <a:r>
                <a:rPr lang="de-DE" sz="1000" i="1" dirty="0">
                  <a:latin typeface="Calibri" pitchFamily="34" charset="0"/>
                </a:rPr>
                <a:t> </a:t>
              </a:r>
              <a:r>
                <a:rPr lang="de-DE" sz="1000" i="1" dirty="0" err="1">
                  <a:latin typeface="Calibri" pitchFamily="34" charset="0"/>
                </a:rPr>
                <a:t>Anticline</a:t>
              </a:r>
              <a:endParaRPr lang="de-DE" sz="1000" i="1" dirty="0">
                <a:latin typeface="Calibri" pitchFamily="34" charset="0"/>
              </a:endParaRPr>
            </a:p>
          </p:txBody>
        </p:sp>
        <p:sp>
          <p:nvSpPr>
            <p:cNvPr id="75" name="Textfeld 44">
              <a:extLst>
                <a:ext uri="{FF2B5EF4-FFF2-40B4-BE49-F238E27FC236}">
                  <a16:creationId xmlns:a16="http://schemas.microsoft.com/office/drawing/2014/main" id="{CC07E9DD-0A91-B164-2226-6ABC0CDC5B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00084" y="1577813"/>
              <a:ext cx="728788" cy="600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1100" i="1" dirty="0">
                  <a:latin typeface="Calibri" pitchFamily="34" charset="0"/>
                </a:rPr>
                <a:t>Eureka </a:t>
              </a:r>
              <a:r>
                <a:rPr lang="de-DE" sz="1100" i="1" dirty="0" err="1">
                  <a:latin typeface="Calibri" pitchFamily="34" charset="0"/>
                </a:rPr>
                <a:t>Syncline</a:t>
              </a:r>
              <a:endParaRPr lang="de-DE" sz="1100" i="1" dirty="0">
                <a:latin typeface="Calibri" pitchFamily="34" charset="0"/>
              </a:endParaRPr>
            </a:p>
            <a:p>
              <a:pPr eaLnBrk="1" hangingPunct="1"/>
              <a:r>
                <a:rPr lang="de-DE" sz="1100" i="1" dirty="0">
                  <a:latin typeface="Calibri" pitchFamily="34" charset="0"/>
                </a:rPr>
                <a:t> </a:t>
              </a:r>
            </a:p>
          </p:txBody>
        </p:sp>
        <p:sp>
          <p:nvSpPr>
            <p:cNvPr id="104" name="Textfeld 40">
              <a:extLst>
                <a:ext uri="{FF2B5EF4-FFF2-40B4-BE49-F238E27FC236}">
                  <a16:creationId xmlns:a16="http://schemas.microsoft.com/office/drawing/2014/main" id="{F5239034-5E11-032E-AE2E-C1FECFA821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1540000">
              <a:off x="4101735" y="3923729"/>
              <a:ext cx="676953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de-DE" sz="1200" i="1" dirty="0" err="1">
                  <a:latin typeface="Calibri" pitchFamily="34" charset="0"/>
                </a:rPr>
                <a:t>Piggs</a:t>
              </a:r>
              <a:r>
                <a:rPr lang="de-DE" sz="1200" i="1" dirty="0">
                  <a:latin typeface="Calibri" pitchFamily="34" charset="0"/>
                </a:rPr>
                <a:t> Peak</a:t>
              </a:r>
            </a:p>
          </p:txBody>
        </p:sp>
        <p:sp>
          <p:nvSpPr>
            <p:cNvPr id="105" name="Ellipse 104">
              <a:extLst>
                <a:ext uri="{FF2B5EF4-FFF2-40B4-BE49-F238E27FC236}">
                  <a16:creationId xmlns:a16="http://schemas.microsoft.com/office/drawing/2014/main" id="{FA03E8E5-6AB7-039C-848A-B0B4E836CBB2}"/>
                </a:ext>
              </a:extLst>
            </p:cNvPr>
            <p:cNvSpPr/>
            <p:nvPr/>
          </p:nvSpPr>
          <p:spPr>
            <a:xfrm rot="21540000">
              <a:off x="3962999" y="4054438"/>
              <a:ext cx="147791" cy="134084"/>
            </a:xfrm>
            <a:prstGeom prst="ellipse">
              <a:avLst/>
            </a:prstGeom>
            <a:solidFill>
              <a:schemeClr val="tx1">
                <a:lumMod val="65000"/>
                <a:lumOff val="3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/>
            </a:p>
          </p:txBody>
        </p:sp>
        <p:grpSp>
          <p:nvGrpSpPr>
            <p:cNvPr id="391" name="Gruppieren 390">
              <a:extLst>
                <a:ext uri="{FF2B5EF4-FFF2-40B4-BE49-F238E27FC236}">
                  <a16:creationId xmlns:a16="http://schemas.microsoft.com/office/drawing/2014/main" id="{C100EA9B-C17A-3A8D-4294-BAD5B6FCE5E2}"/>
                </a:ext>
              </a:extLst>
            </p:cNvPr>
            <p:cNvGrpSpPr/>
            <p:nvPr/>
          </p:nvGrpSpPr>
          <p:grpSpPr>
            <a:xfrm>
              <a:off x="580555" y="4845226"/>
              <a:ext cx="2258997" cy="1664605"/>
              <a:chOff x="-959193" y="6132713"/>
              <a:chExt cx="2258997" cy="1664605"/>
            </a:xfrm>
          </p:grpSpPr>
          <p:sp>
            <p:nvSpPr>
              <p:cNvPr id="392" name="Freeform 77">
                <a:extLst>
                  <a:ext uri="{FF2B5EF4-FFF2-40B4-BE49-F238E27FC236}">
                    <a16:creationId xmlns:a16="http://schemas.microsoft.com/office/drawing/2014/main" id="{2D655B86-B600-795F-AED8-D4DDD30242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-959193" y="6132713"/>
                <a:ext cx="2258997" cy="1664605"/>
              </a:xfrm>
              <a:custGeom>
                <a:avLst/>
                <a:gdLst>
                  <a:gd name="T0" fmla="*/ 509 w 516"/>
                  <a:gd name="T1" fmla="*/ 181 h 380"/>
                  <a:gd name="T2" fmla="*/ 508 w 516"/>
                  <a:gd name="T3" fmla="*/ 191 h 380"/>
                  <a:gd name="T4" fmla="*/ 492 w 516"/>
                  <a:gd name="T5" fmla="*/ 229 h 380"/>
                  <a:gd name="T6" fmla="*/ 485 w 516"/>
                  <a:gd name="T7" fmla="*/ 245 h 380"/>
                  <a:gd name="T8" fmla="*/ 481 w 516"/>
                  <a:gd name="T9" fmla="*/ 264 h 380"/>
                  <a:gd name="T10" fmla="*/ 483 w 516"/>
                  <a:gd name="T11" fmla="*/ 296 h 380"/>
                  <a:gd name="T12" fmla="*/ 478 w 516"/>
                  <a:gd name="T13" fmla="*/ 308 h 380"/>
                  <a:gd name="T14" fmla="*/ 474 w 516"/>
                  <a:gd name="T15" fmla="*/ 333 h 380"/>
                  <a:gd name="T16" fmla="*/ 462 w 516"/>
                  <a:gd name="T17" fmla="*/ 354 h 380"/>
                  <a:gd name="T18" fmla="*/ 454 w 516"/>
                  <a:gd name="T19" fmla="*/ 358 h 380"/>
                  <a:gd name="T20" fmla="*/ 448 w 516"/>
                  <a:gd name="T21" fmla="*/ 361 h 380"/>
                  <a:gd name="T22" fmla="*/ 445 w 516"/>
                  <a:gd name="T23" fmla="*/ 364 h 380"/>
                  <a:gd name="T24" fmla="*/ 442 w 516"/>
                  <a:gd name="T25" fmla="*/ 372 h 380"/>
                  <a:gd name="T26" fmla="*/ 440 w 516"/>
                  <a:gd name="T27" fmla="*/ 380 h 380"/>
                  <a:gd name="T28" fmla="*/ 0 w 516"/>
                  <a:gd name="T29" fmla="*/ 380 h 380"/>
                  <a:gd name="T30" fmla="*/ 0 w 516"/>
                  <a:gd name="T31" fmla="*/ 77 h 380"/>
                  <a:gd name="T32" fmla="*/ 14 w 516"/>
                  <a:gd name="T33" fmla="*/ 64 h 380"/>
                  <a:gd name="T34" fmla="*/ 30 w 516"/>
                  <a:gd name="T35" fmla="*/ 46 h 380"/>
                  <a:gd name="T36" fmla="*/ 39 w 516"/>
                  <a:gd name="T37" fmla="*/ 31 h 380"/>
                  <a:gd name="T38" fmla="*/ 53 w 516"/>
                  <a:gd name="T39" fmla="*/ 15 h 380"/>
                  <a:gd name="T40" fmla="*/ 91 w 516"/>
                  <a:gd name="T41" fmla="*/ 21 h 380"/>
                  <a:gd name="T42" fmla="*/ 129 w 516"/>
                  <a:gd name="T43" fmla="*/ 49 h 380"/>
                  <a:gd name="T44" fmla="*/ 153 w 516"/>
                  <a:gd name="T45" fmla="*/ 66 h 380"/>
                  <a:gd name="T46" fmla="*/ 190 w 516"/>
                  <a:gd name="T47" fmla="*/ 84 h 380"/>
                  <a:gd name="T48" fmla="*/ 228 w 516"/>
                  <a:gd name="T49" fmla="*/ 82 h 380"/>
                  <a:gd name="T50" fmla="*/ 259 w 516"/>
                  <a:gd name="T51" fmla="*/ 82 h 380"/>
                  <a:gd name="T52" fmla="*/ 284 w 516"/>
                  <a:gd name="T53" fmla="*/ 86 h 380"/>
                  <a:gd name="T54" fmla="*/ 307 w 516"/>
                  <a:gd name="T55" fmla="*/ 86 h 380"/>
                  <a:gd name="T56" fmla="*/ 320 w 516"/>
                  <a:gd name="T57" fmla="*/ 88 h 380"/>
                  <a:gd name="T58" fmla="*/ 338 w 516"/>
                  <a:gd name="T59" fmla="*/ 104 h 380"/>
                  <a:gd name="T60" fmla="*/ 351 w 516"/>
                  <a:gd name="T61" fmla="*/ 114 h 380"/>
                  <a:gd name="T62" fmla="*/ 387 w 516"/>
                  <a:gd name="T63" fmla="*/ 129 h 380"/>
                  <a:gd name="T64" fmla="*/ 418 w 516"/>
                  <a:gd name="T65" fmla="*/ 124 h 380"/>
                  <a:gd name="T66" fmla="*/ 421 w 516"/>
                  <a:gd name="T67" fmla="*/ 139 h 380"/>
                  <a:gd name="T68" fmla="*/ 428 w 516"/>
                  <a:gd name="T69" fmla="*/ 145 h 380"/>
                  <a:gd name="T70" fmla="*/ 465 w 516"/>
                  <a:gd name="T71" fmla="*/ 155 h 380"/>
                  <a:gd name="T72" fmla="*/ 488 w 516"/>
                  <a:gd name="T73" fmla="*/ 160 h 380"/>
                  <a:gd name="T74" fmla="*/ 499 w 516"/>
                  <a:gd name="T75" fmla="*/ 162 h 380"/>
                  <a:gd name="T76" fmla="*/ 509 w 516"/>
                  <a:gd name="T77" fmla="*/ 160 h 380"/>
                  <a:gd name="T78" fmla="*/ 509 w 516"/>
                  <a:gd name="T79" fmla="*/ 181 h 3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516" h="380">
                    <a:moveTo>
                      <a:pt x="509" y="181"/>
                    </a:moveTo>
                    <a:cubicBezTo>
                      <a:pt x="516" y="177"/>
                      <a:pt x="512" y="184"/>
                      <a:pt x="508" y="191"/>
                    </a:cubicBezTo>
                    <a:cubicBezTo>
                      <a:pt x="503" y="198"/>
                      <a:pt x="495" y="219"/>
                      <a:pt x="492" y="229"/>
                    </a:cubicBezTo>
                    <a:cubicBezTo>
                      <a:pt x="489" y="240"/>
                      <a:pt x="486" y="242"/>
                      <a:pt x="485" y="245"/>
                    </a:cubicBezTo>
                    <a:cubicBezTo>
                      <a:pt x="483" y="248"/>
                      <a:pt x="481" y="264"/>
                      <a:pt x="481" y="264"/>
                    </a:cubicBezTo>
                    <a:cubicBezTo>
                      <a:pt x="481" y="264"/>
                      <a:pt x="482" y="290"/>
                      <a:pt x="483" y="296"/>
                    </a:cubicBezTo>
                    <a:cubicBezTo>
                      <a:pt x="484" y="302"/>
                      <a:pt x="479" y="304"/>
                      <a:pt x="478" y="308"/>
                    </a:cubicBezTo>
                    <a:cubicBezTo>
                      <a:pt x="476" y="313"/>
                      <a:pt x="475" y="314"/>
                      <a:pt x="474" y="333"/>
                    </a:cubicBezTo>
                    <a:cubicBezTo>
                      <a:pt x="474" y="352"/>
                      <a:pt x="462" y="354"/>
                      <a:pt x="462" y="354"/>
                    </a:cubicBezTo>
                    <a:cubicBezTo>
                      <a:pt x="454" y="358"/>
                      <a:pt x="454" y="358"/>
                      <a:pt x="454" y="358"/>
                    </a:cubicBezTo>
                    <a:cubicBezTo>
                      <a:pt x="448" y="361"/>
                      <a:pt x="448" y="361"/>
                      <a:pt x="448" y="361"/>
                    </a:cubicBezTo>
                    <a:cubicBezTo>
                      <a:pt x="445" y="364"/>
                      <a:pt x="445" y="364"/>
                      <a:pt x="445" y="364"/>
                    </a:cubicBezTo>
                    <a:cubicBezTo>
                      <a:pt x="442" y="372"/>
                      <a:pt x="442" y="372"/>
                      <a:pt x="442" y="372"/>
                    </a:cubicBezTo>
                    <a:cubicBezTo>
                      <a:pt x="440" y="380"/>
                      <a:pt x="440" y="380"/>
                      <a:pt x="440" y="380"/>
                    </a:cubicBezTo>
                    <a:cubicBezTo>
                      <a:pt x="0" y="380"/>
                      <a:pt x="0" y="380"/>
                      <a:pt x="0" y="380"/>
                    </a:cubicBezTo>
                    <a:cubicBezTo>
                      <a:pt x="0" y="77"/>
                      <a:pt x="0" y="77"/>
                      <a:pt x="0" y="77"/>
                    </a:cubicBezTo>
                    <a:cubicBezTo>
                      <a:pt x="0" y="77"/>
                      <a:pt x="8" y="73"/>
                      <a:pt x="14" y="64"/>
                    </a:cubicBezTo>
                    <a:cubicBezTo>
                      <a:pt x="19" y="55"/>
                      <a:pt x="24" y="51"/>
                      <a:pt x="30" y="46"/>
                    </a:cubicBezTo>
                    <a:cubicBezTo>
                      <a:pt x="36" y="41"/>
                      <a:pt x="37" y="35"/>
                      <a:pt x="39" y="31"/>
                    </a:cubicBezTo>
                    <a:cubicBezTo>
                      <a:pt x="41" y="28"/>
                      <a:pt x="50" y="17"/>
                      <a:pt x="53" y="15"/>
                    </a:cubicBezTo>
                    <a:cubicBezTo>
                      <a:pt x="57" y="13"/>
                      <a:pt x="65" y="0"/>
                      <a:pt x="91" y="21"/>
                    </a:cubicBezTo>
                    <a:cubicBezTo>
                      <a:pt x="116" y="42"/>
                      <a:pt x="129" y="49"/>
                      <a:pt x="129" y="49"/>
                    </a:cubicBezTo>
                    <a:cubicBezTo>
                      <a:pt x="129" y="49"/>
                      <a:pt x="144" y="57"/>
                      <a:pt x="153" y="66"/>
                    </a:cubicBezTo>
                    <a:cubicBezTo>
                      <a:pt x="163" y="74"/>
                      <a:pt x="170" y="84"/>
                      <a:pt x="190" y="84"/>
                    </a:cubicBezTo>
                    <a:cubicBezTo>
                      <a:pt x="209" y="83"/>
                      <a:pt x="219" y="78"/>
                      <a:pt x="228" y="82"/>
                    </a:cubicBezTo>
                    <a:cubicBezTo>
                      <a:pt x="238" y="85"/>
                      <a:pt x="249" y="85"/>
                      <a:pt x="259" y="82"/>
                    </a:cubicBezTo>
                    <a:cubicBezTo>
                      <a:pt x="269" y="78"/>
                      <a:pt x="275" y="85"/>
                      <a:pt x="284" y="86"/>
                    </a:cubicBezTo>
                    <a:cubicBezTo>
                      <a:pt x="294" y="86"/>
                      <a:pt x="307" y="86"/>
                      <a:pt x="307" y="86"/>
                    </a:cubicBezTo>
                    <a:cubicBezTo>
                      <a:pt x="307" y="86"/>
                      <a:pt x="316" y="85"/>
                      <a:pt x="320" y="88"/>
                    </a:cubicBezTo>
                    <a:cubicBezTo>
                      <a:pt x="322" y="91"/>
                      <a:pt x="330" y="98"/>
                      <a:pt x="338" y="104"/>
                    </a:cubicBezTo>
                    <a:cubicBezTo>
                      <a:pt x="342" y="108"/>
                      <a:pt x="347" y="112"/>
                      <a:pt x="351" y="114"/>
                    </a:cubicBezTo>
                    <a:cubicBezTo>
                      <a:pt x="360" y="119"/>
                      <a:pt x="371" y="130"/>
                      <a:pt x="387" y="129"/>
                    </a:cubicBezTo>
                    <a:cubicBezTo>
                      <a:pt x="404" y="128"/>
                      <a:pt x="418" y="124"/>
                      <a:pt x="418" y="124"/>
                    </a:cubicBezTo>
                    <a:cubicBezTo>
                      <a:pt x="413" y="133"/>
                      <a:pt x="412" y="140"/>
                      <a:pt x="421" y="139"/>
                    </a:cubicBezTo>
                    <a:cubicBezTo>
                      <a:pt x="421" y="139"/>
                      <a:pt x="420" y="142"/>
                      <a:pt x="428" y="145"/>
                    </a:cubicBezTo>
                    <a:cubicBezTo>
                      <a:pt x="436" y="149"/>
                      <a:pt x="456" y="154"/>
                      <a:pt x="465" y="155"/>
                    </a:cubicBezTo>
                    <a:cubicBezTo>
                      <a:pt x="475" y="157"/>
                      <a:pt x="481" y="159"/>
                      <a:pt x="488" y="160"/>
                    </a:cubicBezTo>
                    <a:cubicBezTo>
                      <a:pt x="495" y="162"/>
                      <a:pt x="499" y="162"/>
                      <a:pt x="499" y="162"/>
                    </a:cubicBezTo>
                    <a:cubicBezTo>
                      <a:pt x="509" y="160"/>
                      <a:pt x="509" y="160"/>
                      <a:pt x="509" y="160"/>
                    </a:cubicBezTo>
                    <a:cubicBezTo>
                      <a:pt x="501" y="169"/>
                      <a:pt x="502" y="184"/>
                      <a:pt x="509" y="181"/>
                    </a:cubicBezTo>
                    <a:close/>
                  </a:path>
                </a:pathLst>
              </a:cu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3" name="Rectangle 240">
                <a:extLst>
                  <a:ext uri="{FF2B5EF4-FFF2-40B4-BE49-F238E27FC236}">
                    <a16:creationId xmlns:a16="http://schemas.microsoft.com/office/drawing/2014/main" id="{49F072ED-C4E9-D4B5-CA26-9A6DC6EB0D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08003" y="6769266"/>
                <a:ext cx="733981" cy="179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200" i="0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Onverwacht</a:t>
                </a:r>
                <a:endParaRPr kumimoji="0" lang="de-DE" altLang="de-DE" sz="12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94" name="Rectangle 256">
                <a:extLst>
                  <a:ext uri="{FF2B5EF4-FFF2-40B4-BE49-F238E27FC236}">
                    <a16:creationId xmlns:a16="http://schemas.microsoft.com/office/drawing/2014/main" id="{7D523115-CF39-0321-97DB-966F53E34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13545" y="6163590"/>
                <a:ext cx="432705" cy="219156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 w="7938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5" name="Rectangle 256">
                <a:extLst>
                  <a:ext uri="{FF2B5EF4-FFF2-40B4-BE49-F238E27FC236}">
                    <a16:creationId xmlns:a16="http://schemas.microsoft.com/office/drawing/2014/main" id="{13DAC089-FC41-09EF-094C-7B8B5F93DC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12580" y="6454133"/>
                <a:ext cx="432705" cy="222287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7938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6" name="Rectangle 240">
                <a:extLst>
                  <a:ext uri="{FF2B5EF4-FFF2-40B4-BE49-F238E27FC236}">
                    <a16:creationId xmlns:a16="http://schemas.microsoft.com/office/drawing/2014/main" id="{2C850797-46B9-4DEB-5181-A5C53D9C47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13488" y="6480192"/>
                <a:ext cx="469210" cy="179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200" i="0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Fig</a:t>
                </a:r>
                <a:r>
                  <a:rPr kumimoji="0" lang="de-DE" altLang="de-DE" sz="12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 </a:t>
                </a:r>
                <a:r>
                  <a:rPr lang="de-DE" altLang="de-DE" sz="1200" dirty="0" err="1">
                    <a:solidFill>
                      <a:srgbClr val="232021"/>
                    </a:solidFill>
                    <a:latin typeface="+mn-lt"/>
                  </a:rPr>
                  <a:t>T</a:t>
                </a:r>
                <a:r>
                  <a:rPr kumimoji="0" lang="de-DE" altLang="de-DE" sz="1200" i="0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ree</a:t>
                </a:r>
                <a:endParaRPr kumimoji="0" lang="de-DE" altLang="de-DE" sz="12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97" name="Rectangle 240">
                <a:extLst>
                  <a:ext uri="{FF2B5EF4-FFF2-40B4-BE49-F238E27FC236}">
                    <a16:creationId xmlns:a16="http://schemas.microsoft.com/office/drawing/2014/main" id="{7D2773A9-620B-8623-D646-6B5C95E478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26736" y="6180452"/>
                <a:ext cx="531780" cy="179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200" i="0" u="none" strike="noStrike" cap="none" normalizeH="0" baseline="0" dirty="0" err="1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Moodies</a:t>
                </a:r>
                <a:endParaRPr kumimoji="0" lang="de-DE" altLang="de-DE" sz="12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98" name="Rectangle 256">
                <a:extLst>
                  <a:ext uri="{FF2B5EF4-FFF2-40B4-BE49-F238E27FC236}">
                    <a16:creationId xmlns:a16="http://schemas.microsoft.com/office/drawing/2014/main" id="{76BD3237-F10F-6BE0-AA22-70E75098C1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12546" y="6748680"/>
                <a:ext cx="432705" cy="221393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7938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99" name="Rectangle 240">
                <a:extLst>
                  <a:ext uri="{FF2B5EF4-FFF2-40B4-BE49-F238E27FC236}">
                    <a16:creationId xmlns:a16="http://schemas.microsoft.com/office/drawing/2014/main" id="{E9D244E6-4AA7-65B2-1377-85AC6F2B60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13522" y="7095376"/>
                <a:ext cx="1327504" cy="26167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1pPr>
                <a:lvl2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2pPr>
                <a:lvl3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3pPr>
                <a:lvl4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4pPr>
                <a:lvl5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5pPr>
                <a:lvl6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6pPr>
                <a:lvl7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7pPr>
                <a:lvl8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8pPr>
                <a:lvl9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9pPr>
              </a:lstStyle>
              <a:p>
                <a:pPr defTabSz="914378">
                  <a:lnSpc>
                    <a:spcPts val="1000"/>
                  </a:lnSpc>
                  <a:defRPr/>
                </a:pPr>
                <a:r>
                  <a:rPr lang="en-US" sz="1100" dirty="0">
                    <a:solidFill>
                      <a:srgbClr val="232021"/>
                    </a:solidFill>
                    <a:latin typeface="Calibri"/>
                  </a:rPr>
                  <a:t>Ancient Gneiss Complex</a:t>
                </a:r>
                <a:endParaRPr lang="en-US" sz="1100" dirty="0">
                  <a:latin typeface="Calibri"/>
                </a:endParaRPr>
              </a:p>
            </p:txBody>
          </p:sp>
          <p:sp>
            <p:nvSpPr>
              <p:cNvPr id="410" name="Rectangle 256">
                <a:extLst>
                  <a:ext uri="{FF2B5EF4-FFF2-40B4-BE49-F238E27FC236}">
                    <a16:creationId xmlns:a16="http://schemas.microsoft.com/office/drawing/2014/main" id="{A3223898-A9BB-F495-B4CE-A25EDCDCDF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10631" y="7054031"/>
                <a:ext cx="428074" cy="218993"/>
              </a:xfrm>
              <a:prstGeom prst="rect">
                <a:avLst/>
              </a:prstGeom>
              <a:solidFill>
                <a:srgbClr val="828282"/>
              </a:solidFill>
              <a:ln w="7938" cap="flat">
                <a:noFill/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>
                  <a:defRPr/>
                </a:pPr>
                <a:endParaRPr lang="de-DE"/>
              </a:p>
            </p:txBody>
          </p:sp>
          <p:sp>
            <p:nvSpPr>
              <p:cNvPr id="402" name="Rectangle 240">
                <a:extLst>
                  <a:ext uri="{FF2B5EF4-FFF2-40B4-BE49-F238E27FC236}">
                    <a16:creationId xmlns:a16="http://schemas.microsoft.com/office/drawing/2014/main" id="{13A1D0EC-048D-FE10-DC93-A403514883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308009" y="6438376"/>
                <a:ext cx="390235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1pPr>
                <a:lvl2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2pPr>
                <a:lvl3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3pPr>
                <a:lvl4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4pPr>
                <a:lvl5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5pPr>
                <a:lvl6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6pPr>
                <a:lvl7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7pPr>
                <a:lvl8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8pPr>
                <a:lvl9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9pPr>
              </a:lstStyle>
              <a:p>
                <a:pPr defTabSz="914378">
                  <a:defRPr/>
                </a:pPr>
                <a:r>
                  <a:rPr lang="de-DE" sz="1200" dirty="0">
                    <a:solidFill>
                      <a:srgbClr val="232021"/>
                    </a:solidFill>
                    <a:latin typeface="Calibri"/>
                  </a:rPr>
                  <a:t>Group</a:t>
                </a:r>
                <a:endParaRPr lang="de-DE" sz="1200" dirty="0">
                  <a:latin typeface="Calibri"/>
                </a:endParaRPr>
              </a:p>
            </p:txBody>
          </p:sp>
          <p:cxnSp>
            <p:nvCxnSpPr>
              <p:cNvPr id="403" name="Gerader Verbinder 402">
                <a:extLst>
                  <a:ext uri="{FF2B5EF4-FFF2-40B4-BE49-F238E27FC236}">
                    <a16:creationId xmlns:a16="http://schemas.microsoft.com/office/drawing/2014/main" id="{1BC13B7B-A7FE-4258-D0A3-BD90C405956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393135" y="6221963"/>
                <a:ext cx="0" cy="65539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15" name="Gerader Verbinder 414">
              <a:extLst>
                <a:ext uri="{FF2B5EF4-FFF2-40B4-BE49-F238E27FC236}">
                  <a16:creationId xmlns:a16="http://schemas.microsoft.com/office/drawing/2014/main" id="{6ADD1E9F-AC71-3007-71B9-576CEADD29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72181" y="1896447"/>
              <a:ext cx="201336" cy="4643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Freihandform: Form 3">
              <a:extLst>
                <a:ext uri="{FF2B5EF4-FFF2-40B4-BE49-F238E27FC236}">
                  <a16:creationId xmlns:a16="http://schemas.microsoft.com/office/drawing/2014/main" id="{4B666EB9-34A4-DCC0-8500-D8932C215C93}"/>
                </a:ext>
              </a:extLst>
            </p:cNvPr>
            <p:cNvSpPr/>
            <p:nvPr/>
          </p:nvSpPr>
          <p:spPr>
            <a:xfrm>
              <a:off x="1904852" y="2260682"/>
              <a:ext cx="2292635" cy="1327447"/>
            </a:xfrm>
            <a:custGeom>
              <a:avLst/>
              <a:gdLst>
                <a:gd name="connsiteX0" fmla="*/ 2455068 w 2455068"/>
                <a:gd name="connsiteY0" fmla="*/ 0 h 1464469"/>
                <a:gd name="connsiteX1" fmla="*/ 2209800 w 2455068"/>
                <a:gd name="connsiteY1" fmla="*/ 85725 h 1464469"/>
                <a:gd name="connsiteX2" fmla="*/ 2090737 w 2455068"/>
                <a:gd name="connsiteY2" fmla="*/ 130969 h 1464469"/>
                <a:gd name="connsiteX3" fmla="*/ 2005012 w 2455068"/>
                <a:gd name="connsiteY3" fmla="*/ 145257 h 1464469"/>
                <a:gd name="connsiteX4" fmla="*/ 1888331 w 2455068"/>
                <a:gd name="connsiteY4" fmla="*/ 176213 h 1464469"/>
                <a:gd name="connsiteX5" fmla="*/ 1693068 w 2455068"/>
                <a:gd name="connsiteY5" fmla="*/ 200025 h 1464469"/>
                <a:gd name="connsiteX6" fmla="*/ 1602581 w 2455068"/>
                <a:gd name="connsiteY6" fmla="*/ 202407 h 1464469"/>
                <a:gd name="connsiteX7" fmla="*/ 1457325 w 2455068"/>
                <a:gd name="connsiteY7" fmla="*/ 157163 h 1464469"/>
                <a:gd name="connsiteX8" fmla="*/ 1345406 w 2455068"/>
                <a:gd name="connsiteY8" fmla="*/ 142875 h 1464469"/>
                <a:gd name="connsiteX9" fmla="*/ 1228725 w 2455068"/>
                <a:gd name="connsiteY9" fmla="*/ 233363 h 1464469"/>
                <a:gd name="connsiteX10" fmla="*/ 1159668 w 2455068"/>
                <a:gd name="connsiteY10" fmla="*/ 354807 h 1464469"/>
                <a:gd name="connsiteX11" fmla="*/ 1126331 w 2455068"/>
                <a:gd name="connsiteY11" fmla="*/ 459582 h 1464469"/>
                <a:gd name="connsiteX12" fmla="*/ 1140618 w 2455068"/>
                <a:gd name="connsiteY12" fmla="*/ 514350 h 1464469"/>
                <a:gd name="connsiteX13" fmla="*/ 1085850 w 2455068"/>
                <a:gd name="connsiteY13" fmla="*/ 578644 h 1464469"/>
                <a:gd name="connsiteX14" fmla="*/ 1076325 w 2455068"/>
                <a:gd name="connsiteY14" fmla="*/ 659607 h 1464469"/>
                <a:gd name="connsiteX15" fmla="*/ 1042987 w 2455068"/>
                <a:gd name="connsiteY15" fmla="*/ 700088 h 1464469"/>
                <a:gd name="connsiteX16" fmla="*/ 1045368 w 2455068"/>
                <a:gd name="connsiteY16" fmla="*/ 747713 h 1464469"/>
                <a:gd name="connsiteX17" fmla="*/ 981075 w 2455068"/>
                <a:gd name="connsiteY17" fmla="*/ 785813 h 1464469"/>
                <a:gd name="connsiteX18" fmla="*/ 933450 w 2455068"/>
                <a:gd name="connsiteY18" fmla="*/ 835819 h 1464469"/>
                <a:gd name="connsiteX19" fmla="*/ 926306 w 2455068"/>
                <a:gd name="connsiteY19" fmla="*/ 909638 h 1464469"/>
                <a:gd name="connsiteX20" fmla="*/ 785812 w 2455068"/>
                <a:gd name="connsiteY20" fmla="*/ 1007269 h 1464469"/>
                <a:gd name="connsiteX21" fmla="*/ 716756 w 2455068"/>
                <a:gd name="connsiteY21" fmla="*/ 1102519 h 1464469"/>
                <a:gd name="connsiteX22" fmla="*/ 421481 w 2455068"/>
                <a:gd name="connsiteY22" fmla="*/ 1183482 h 1464469"/>
                <a:gd name="connsiteX23" fmla="*/ 233362 w 2455068"/>
                <a:gd name="connsiteY23" fmla="*/ 1226344 h 1464469"/>
                <a:gd name="connsiteX24" fmla="*/ 54768 w 2455068"/>
                <a:gd name="connsiteY24" fmla="*/ 1295400 h 1464469"/>
                <a:gd name="connsiteX25" fmla="*/ 33337 w 2455068"/>
                <a:gd name="connsiteY25" fmla="*/ 1407319 h 1464469"/>
                <a:gd name="connsiteX26" fmla="*/ 0 w 2455068"/>
                <a:gd name="connsiteY26" fmla="*/ 1464469 h 14644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</a:cxnLst>
              <a:rect l="l" t="t" r="r" b="b"/>
              <a:pathLst>
                <a:path w="2455068" h="1464469">
                  <a:moveTo>
                    <a:pt x="2455068" y="0"/>
                  </a:moveTo>
                  <a:lnTo>
                    <a:pt x="2209800" y="85725"/>
                  </a:lnTo>
                  <a:cubicBezTo>
                    <a:pt x="2149078" y="107553"/>
                    <a:pt x="2124868" y="121047"/>
                    <a:pt x="2090737" y="130969"/>
                  </a:cubicBezTo>
                  <a:cubicBezTo>
                    <a:pt x="2056606" y="140891"/>
                    <a:pt x="2038746" y="137716"/>
                    <a:pt x="2005012" y="145257"/>
                  </a:cubicBezTo>
                  <a:cubicBezTo>
                    <a:pt x="1971278" y="152798"/>
                    <a:pt x="1940322" y="167085"/>
                    <a:pt x="1888331" y="176213"/>
                  </a:cubicBezTo>
                  <a:cubicBezTo>
                    <a:pt x="1836340" y="185341"/>
                    <a:pt x="1740693" y="195659"/>
                    <a:pt x="1693068" y="200025"/>
                  </a:cubicBezTo>
                  <a:cubicBezTo>
                    <a:pt x="1645443" y="204391"/>
                    <a:pt x="1641871" y="209551"/>
                    <a:pt x="1602581" y="202407"/>
                  </a:cubicBezTo>
                  <a:cubicBezTo>
                    <a:pt x="1563291" y="195263"/>
                    <a:pt x="1500187" y="167085"/>
                    <a:pt x="1457325" y="157163"/>
                  </a:cubicBezTo>
                  <a:cubicBezTo>
                    <a:pt x="1414463" y="147241"/>
                    <a:pt x="1383506" y="130175"/>
                    <a:pt x="1345406" y="142875"/>
                  </a:cubicBezTo>
                  <a:cubicBezTo>
                    <a:pt x="1307306" y="155575"/>
                    <a:pt x="1259681" y="198041"/>
                    <a:pt x="1228725" y="233363"/>
                  </a:cubicBezTo>
                  <a:cubicBezTo>
                    <a:pt x="1197769" y="268685"/>
                    <a:pt x="1176734" y="317104"/>
                    <a:pt x="1159668" y="354807"/>
                  </a:cubicBezTo>
                  <a:cubicBezTo>
                    <a:pt x="1142602" y="392510"/>
                    <a:pt x="1129506" y="432992"/>
                    <a:pt x="1126331" y="459582"/>
                  </a:cubicBezTo>
                  <a:cubicBezTo>
                    <a:pt x="1123156" y="486172"/>
                    <a:pt x="1147365" y="494506"/>
                    <a:pt x="1140618" y="514350"/>
                  </a:cubicBezTo>
                  <a:cubicBezTo>
                    <a:pt x="1133871" y="534194"/>
                    <a:pt x="1096565" y="554435"/>
                    <a:pt x="1085850" y="578644"/>
                  </a:cubicBezTo>
                  <a:cubicBezTo>
                    <a:pt x="1075135" y="602853"/>
                    <a:pt x="1083469" y="639366"/>
                    <a:pt x="1076325" y="659607"/>
                  </a:cubicBezTo>
                  <a:cubicBezTo>
                    <a:pt x="1069181" y="679848"/>
                    <a:pt x="1048147" y="685404"/>
                    <a:pt x="1042987" y="700088"/>
                  </a:cubicBezTo>
                  <a:cubicBezTo>
                    <a:pt x="1037827" y="714772"/>
                    <a:pt x="1055687" y="733426"/>
                    <a:pt x="1045368" y="747713"/>
                  </a:cubicBezTo>
                  <a:cubicBezTo>
                    <a:pt x="1035049" y="762000"/>
                    <a:pt x="999728" y="771129"/>
                    <a:pt x="981075" y="785813"/>
                  </a:cubicBezTo>
                  <a:cubicBezTo>
                    <a:pt x="962422" y="800497"/>
                    <a:pt x="942578" y="815182"/>
                    <a:pt x="933450" y="835819"/>
                  </a:cubicBezTo>
                  <a:cubicBezTo>
                    <a:pt x="924322" y="856456"/>
                    <a:pt x="950912" y="881063"/>
                    <a:pt x="926306" y="909638"/>
                  </a:cubicBezTo>
                  <a:cubicBezTo>
                    <a:pt x="901700" y="938213"/>
                    <a:pt x="820737" y="975122"/>
                    <a:pt x="785812" y="1007269"/>
                  </a:cubicBezTo>
                  <a:cubicBezTo>
                    <a:pt x="750887" y="1039416"/>
                    <a:pt x="777478" y="1073150"/>
                    <a:pt x="716756" y="1102519"/>
                  </a:cubicBezTo>
                  <a:cubicBezTo>
                    <a:pt x="656034" y="1131888"/>
                    <a:pt x="502046" y="1162845"/>
                    <a:pt x="421481" y="1183482"/>
                  </a:cubicBezTo>
                  <a:cubicBezTo>
                    <a:pt x="340916" y="1204119"/>
                    <a:pt x="294481" y="1207691"/>
                    <a:pt x="233362" y="1226344"/>
                  </a:cubicBezTo>
                  <a:cubicBezTo>
                    <a:pt x="172243" y="1244997"/>
                    <a:pt x="88105" y="1265238"/>
                    <a:pt x="54768" y="1295400"/>
                  </a:cubicBezTo>
                  <a:cubicBezTo>
                    <a:pt x="21431" y="1325562"/>
                    <a:pt x="42465" y="1379141"/>
                    <a:pt x="33337" y="1407319"/>
                  </a:cubicBezTo>
                  <a:cubicBezTo>
                    <a:pt x="24209" y="1435497"/>
                    <a:pt x="12104" y="1449983"/>
                    <a:pt x="0" y="1464469"/>
                  </a:cubicBezTo>
                </a:path>
              </a:pathLst>
            </a:cu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5DFCA5F0-0FC0-4250-15EF-FAB255E72657}"/>
                </a:ext>
              </a:extLst>
            </p:cNvPr>
            <p:cNvSpPr txBox="1"/>
            <p:nvPr/>
          </p:nvSpPr>
          <p:spPr>
            <a:xfrm>
              <a:off x="1670373" y="2253652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ig. 2</a:t>
              </a:r>
            </a:p>
          </p:txBody>
        </p:sp>
        <p:sp>
          <p:nvSpPr>
            <p:cNvPr id="7" name="Textfeld 44">
              <a:extLst>
                <a:ext uri="{FF2B5EF4-FFF2-40B4-BE49-F238E27FC236}">
                  <a16:creationId xmlns:a16="http://schemas.microsoft.com/office/drawing/2014/main" id="{862F13E7-581B-1DE5-9F91-C476DD6186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78647" y="1514353"/>
              <a:ext cx="604651" cy="5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900" i="1" dirty="0">
                  <a:latin typeface="Calibri" pitchFamily="34" charset="0"/>
                </a:rPr>
                <a:t>Sheba Fault</a:t>
              </a:r>
            </a:p>
            <a:p>
              <a:pPr eaLnBrk="1" hangingPunct="1"/>
              <a:r>
                <a:rPr lang="de-DE" sz="900" i="1" dirty="0">
                  <a:latin typeface="Calibri" pitchFamily="34" charset="0"/>
                </a:rPr>
                <a:t> </a:t>
              </a:r>
            </a:p>
          </p:txBody>
        </p: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6973F690-F943-1002-A738-78F230C82F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47796" y="1832987"/>
              <a:ext cx="180148" cy="4178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45">
              <a:extLst>
                <a:ext uri="{FF2B5EF4-FFF2-40B4-BE49-F238E27FC236}">
                  <a16:creationId xmlns:a16="http://schemas.microsoft.com/office/drawing/2014/main" id="{D48F1201-EDAE-7707-CA6E-40BE02E372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447431">
              <a:off x="2874528" y="2522046"/>
              <a:ext cx="5751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800" i="1" dirty="0" err="1">
                  <a:latin typeface="Calibri" pitchFamily="34" charset="0"/>
                </a:rPr>
                <a:t>Ulundi</a:t>
              </a:r>
              <a:endParaRPr lang="de-DE" sz="800" i="1" dirty="0">
                <a:latin typeface="Calibri" pitchFamily="34" charset="0"/>
              </a:endParaRPr>
            </a:p>
          </p:txBody>
        </p:sp>
        <p:sp>
          <p:nvSpPr>
            <p:cNvPr id="11" name="Textfeld 45">
              <a:extLst>
                <a:ext uri="{FF2B5EF4-FFF2-40B4-BE49-F238E27FC236}">
                  <a16:creationId xmlns:a16="http://schemas.microsoft.com/office/drawing/2014/main" id="{EFB7EF78-A45A-9D5C-73DE-AA2CA97767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36087">
              <a:off x="3309425" y="2466137"/>
              <a:ext cx="53020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800" i="1" dirty="0" err="1">
                  <a:latin typeface="Calibri" pitchFamily="34" charset="0"/>
                </a:rPr>
                <a:t>Syncline</a:t>
              </a:r>
              <a:endParaRPr lang="de-DE" sz="800" i="1" dirty="0">
                <a:latin typeface="Calibri" pitchFamily="34" charset="0"/>
              </a:endParaRPr>
            </a:p>
          </p:txBody>
        </p:sp>
        <p:sp>
          <p:nvSpPr>
            <p:cNvPr id="13" name="Textfeld 44">
              <a:extLst>
                <a:ext uri="{FF2B5EF4-FFF2-40B4-BE49-F238E27FC236}">
                  <a16:creationId xmlns:a16="http://schemas.microsoft.com/office/drawing/2014/main" id="{267F0B51-6823-C5D2-3A45-9BCE60D64E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207339">
              <a:off x="2465062" y="3064940"/>
              <a:ext cx="72878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800" i="1" dirty="0" err="1">
                  <a:latin typeface="Calibri" pitchFamily="34" charset="0"/>
                </a:rPr>
                <a:t>Saddleback</a:t>
              </a:r>
              <a:endParaRPr lang="de-DE" sz="800" i="1" dirty="0">
                <a:latin typeface="Calibri" pitchFamily="34" charset="0"/>
              </a:endParaRPr>
            </a:p>
          </p:txBody>
        </p:sp>
        <p:sp>
          <p:nvSpPr>
            <p:cNvPr id="14" name="Textfeld 44">
              <a:extLst>
                <a:ext uri="{FF2B5EF4-FFF2-40B4-BE49-F238E27FC236}">
                  <a16:creationId xmlns:a16="http://schemas.microsoft.com/office/drawing/2014/main" id="{E178FF26-9B8D-EDE2-F117-C5FE4CBB91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904143">
              <a:off x="2928724" y="2788929"/>
              <a:ext cx="5717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/>
              <a:r>
                <a:rPr lang="de-DE" sz="800" i="1" dirty="0" err="1">
                  <a:latin typeface="Calibri" pitchFamily="34" charset="0"/>
                </a:rPr>
                <a:t>Syncline</a:t>
              </a:r>
              <a:endParaRPr lang="de-DE" sz="800" i="1" dirty="0">
                <a:latin typeface="Calibri" pitchFamily="34" charset="0"/>
              </a:endParaRPr>
            </a:p>
          </p:txBody>
        </p:sp>
        <p:sp>
          <p:nvSpPr>
            <p:cNvPr id="12" name="Freihandform: Form 11">
              <a:extLst>
                <a:ext uri="{FF2B5EF4-FFF2-40B4-BE49-F238E27FC236}">
                  <a16:creationId xmlns:a16="http://schemas.microsoft.com/office/drawing/2014/main" id="{AE011154-0459-C065-3DA1-93D3460B8958}"/>
                </a:ext>
              </a:extLst>
            </p:cNvPr>
            <p:cNvSpPr/>
            <p:nvPr/>
          </p:nvSpPr>
          <p:spPr>
            <a:xfrm rot="15345072" flipH="1">
              <a:off x="2346110" y="2168713"/>
              <a:ext cx="248801" cy="516048"/>
            </a:xfrm>
            <a:custGeom>
              <a:avLst/>
              <a:gdLst>
                <a:gd name="connsiteX0" fmla="*/ 0 w 176213"/>
                <a:gd name="connsiteY0" fmla="*/ 0 h 233363"/>
                <a:gd name="connsiteX1" fmla="*/ 166688 w 176213"/>
                <a:gd name="connsiteY1" fmla="*/ 233363 h 233363"/>
                <a:gd name="connsiteX2" fmla="*/ 166688 w 176213"/>
                <a:gd name="connsiteY2" fmla="*/ 233363 h 233363"/>
                <a:gd name="connsiteX3" fmla="*/ 176213 w 176213"/>
                <a:gd name="connsiteY3" fmla="*/ 233363 h 233363"/>
                <a:gd name="connsiteX0" fmla="*/ 0 w 166688"/>
                <a:gd name="connsiteY0" fmla="*/ 0 h 233363"/>
                <a:gd name="connsiteX1" fmla="*/ 166688 w 166688"/>
                <a:gd name="connsiteY1" fmla="*/ 233363 h 233363"/>
                <a:gd name="connsiteX2" fmla="*/ 166688 w 166688"/>
                <a:gd name="connsiteY2" fmla="*/ 233363 h 233363"/>
                <a:gd name="connsiteX0" fmla="*/ 0 w 166688"/>
                <a:gd name="connsiteY0" fmla="*/ 0 h 233363"/>
                <a:gd name="connsiteX1" fmla="*/ 166688 w 166688"/>
                <a:gd name="connsiteY1" fmla="*/ 233363 h 233363"/>
                <a:gd name="connsiteX2" fmla="*/ 166688 w 166688"/>
                <a:gd name="connsiteY2" fmla="*/ 233363 h 233363"/>
                <a:gd name="connsiteX0" fmla="*/ 0 w 166688"/>
                <a:gd name="connsiteY0" fmla="*/ 0 h 233363"/>
                <a:gd name="connsiteX1" fmla="*/ 166688 w 166688"/>
                <a:gd name="connsiteY1" fmla="*/ 233363 h 233363"/>
                <a:gd name="connsiteX2" fmla="*/ 166688 w 166688"/>
                <a:gd name="connsiteY2" fmla="*/ 233363 h 2333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688" h="233363">
                  <a:moveTo>
                    <a:pt x="0" y="0"/>
                  </a:moveTo>
                  <a:cubicBezTo>
                    <a:pt x="12700" y="111125"/>
                    <a:pt x="44450" y="160337"/>
                    <a:pt x="166688" y="233363"/>
                  </a:cubicBezTo>
                  <a:lnTo>
                    <a:pt x="166688" y="233363"/>
                  </a:ln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Rechteck 16">
              <a:extLst>
                <a:ext uri="{FF2B5EF4-FFF2-40B4-BE49-F238E27FC236}">
                  <a16:creationId xmlns:a16="http://schemas.microsoft.com/office/drawing/2014/main" id="{91B2A3F0-3D2F-EF1E-9566-7DFC6C4A5E71}"/>
                </a:ext>
              </a:extLst>
            </p:cNvPr>
            <p:cNvSpPr/>
            <p:nvPr/>
          </p:nvSpPr>
          <p:spPr>
            <a:xfrm>
              <a:off x="4115101" y="4492453"/>
              <a:ext cx="1392365" cy="18369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9" name="Rechteck 18">
              <a:extLst>
                <a:ext uri="{FF2B5EF4-FFF2-40B4-BE49-F238E27FC236}">
                  <a16:creationId xmlns:a16="http://schemas.microsoft.com/office/drawing/2014/main" id="{E3CCA852-59CA-032F-7D00-53BDEC44A50E}"/>
                </a:ext>
              </a:extLst>
            </p:cNvPr>
            <p:cNvSpPr/>
            <p:nvPr/>
          </p:nvSpPr>
          <p:spPr>
            <a:xfrm>
              <a:off x="4295494" y="5862434"/>
              <a:ext cx="2690566" cy="5540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18" name="Gruppieren 17">
              <a:extLst>
                <a:ext uri="{FF2B5EF4-FFF2-40B4-BE49-F238E27FC236}">
                  <a16:creationId xmlns:a16="http://schemas.microsoft.com/office/drawing/2014/main" id="{C0680758-EA8C-9F71-C391-A6AB1738F837}"/>
                </a:ext>
              </a:extLst>
            </p:cNvPr>
            <p:cNvGrpSpPr/>
            <p:nvPr/>
          </p:nvGrpSpPr>
          <p:grpSpPr>
            <a:xfrm>
              <a:off x="5606165" y="1045454"/>
              <a:ext cx="2685824" cy="5361302"/>
              <a:chOff x="6348842" y="1061660"/>
              <a:chExt cx="2685824" cy="5361302"/>
            </a:xfrm>
          </p:grpSpPr>
          <p:grpSp>
            <p:nvGrpSpPr>
              <p:cNvPr id="2" name="Gruppieren 1">
                <a:extLst>
                  <a:ext uri="{FF2B5EF4-FFF2-40B4-BE49-F238E27FC236}">
                    <a16:creationId xmlns:a16="http://schemas.microsoft.com/office/drawing/2014/main" id="{223A92BA-AF48-31D9-3A1B-86F32799E7DE}"/>
                  </a:ext>
                </a:extLst>
              </p:cNvPr>
              <p:cNvGrpSpPr/>
              <p:nvPr/>
            </p:nvGrpSpPr>
            <p:grpSpPr>
              <a:xfrm>
                <a:off x="6467558" y="1061660"/>
                <a:ext cx="2567108" cy="5361302"/>
                <a:chOff x="6467558" y="1061660"/>
                <a:chExt cx="2567108" cy="5361302"/>
              </a:xfrm>
            </p:grpSpPr>
            <p:sp>
              <p:nvSpPr>
                <p:cNvPr id="119" name="Rectangle 9" descr="70%">
                  <a:extLst>
                    <a:ext uri="{FF2B5EF4-FFF2-40B4-BE49-F238E27FC236}">
                      <a16:creationId xmlns:a16="http://schemas.microsoft.com/office/drawing/2014/main" id="{19EAE7B5-5441-2897-40E7-E01DC7245B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 flipV="1">
                  <a:off x="7750696" y="3665200"/>
                  <a:ext cx="584477" cy="202786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121" name="Text Box 6">
                  <a:extLst>
                    <a:ext uri="{FF2B5EF4-FFF2-40B4-BE49-F238E27FC236}">
                      <a16:creationId xmlns:a16="http://schemas.microsoft.com/office/drawing/2014/main" id="{08F3FA82-A7DA-21D8-DEE7-ABEE934EBB2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67558" y="6151158"/>
                  <a:ext cx="1959730" cy="2572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de-DE" sz="1050" dirty="0" err="1">
                      <a:latin typeface="+mn-lt"/>
                    </a:rPr>
                    <a:t>Schoongezicht</a:t>
                  </a:r>
                  <a:r>
                    <a:rPr lang="de-DE" sz="1050" dirty="0">
                      <a:latin typeface="+mn-lt"/>
                    </a:rPr>
                    <a:t> Fm., Fig </a:t>
                  </a:r>
                  <a:r>
                    <a:rPr lang="de-DE" sz="1050" dirty="0" err="1">
                      <a:latin typeface="+mn-lt"/>
                    </a:rPr>
                    <a:t>Tree</a:t>
                  </a:r>
                  <a:r>
                    <a:rPr lang="de-DE" sz="1050" dirty="0">
                      <a:latin typeface="+mn-lt"/>
                    </a:rPr>
                    <a:t> </a:t>
                  </a:r>
                  <a:r>
                    <a:rPr lang="de-DE" sz="1050" dirty="0" err="1">
                      <a:latin typeface="+mn-lt"/>
                    </a:rPr>
                    <a:t>Gp</a:t>
                  </a:r>
                  <a:r>
                    <a:rPr lang="de-DE" sz="1050" dirty="0">
                      <a:latin typeface="+mn-lt"/>
                    </a:rPr>
                    <a:t>. </a:t>
                  </a:r>
                </a:p>
              </p:txBody>
            </p:sp>
            <p:sp>
              <p:nvSpPr>
                <p:cNvPr id="125" name="Rectangle 9" descr="70%">
                  <a:extLst>
                    <a:ext uri="{FF2B5EF4-FFF2-40B4-BE49-F238E27FC236}">
                      <a16:creationId xmlns:a16="http://schemas.microsoft.com/office/drawing/2014/main" id="{681C6E24-3C6A-73AA-1742-CB285A73AA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550916" y="5931043"/>
                  <a:ext cx="783936" cy="190407"/>
                </a:xfrm>
                <a:prstGeom prst="rect">
                  <a:avLst/>
                </a:prstGeom>
                <a:solidFill>
                  <a:srgbClr val="C55A1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cxnSp>
              <p:nvCxnSpPr>
                <p:cNvPr id="126" name="Gerade Verbindung 596">
                  <a:extLst>
                    <a:ext uri="{FF2B5EF4-FFF2-40B4-BE49-F238E27FC236}">
                      <a16:creationId xmlns:a16="http://schemas.microsoft.com/office/drawing/2014/main" id="{E10B6DC9-0FBE-DC8B-D71A-50D66E95E991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282797" y="5967944"/>
                  <a:ext cx="1045841" cy="25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1" name="Rectangle 9" descr="70%">
                  <a:extLst>
                    <a:ext uri="{FF2B5EF4-FFF2-40B4-BE49-F238E27FC236}">
                      <a16:creationId xmlns:a16="http://schemas.microsoft.com/office/drawing/2014/main" id="{DBC2BEE9-FD6A-C9F8-8E2D-D70742E240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757484" y="1851612"/>
                  <a:ext cx="579860" cy="169112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132" name="Rectangle 9" descr="70%">
                  <a:extLst>
                    <a:ext uri="{FF2B5EF4-FFF2-40B4-BE49-F238E27FC236}">
                      <a16:creationId xmlns:a16="http://schemas.microsoft.com/office/drawing/2014/main" id="{0B82A41B-387B-A811-6135-2E0959BFF4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682122" y="2769970"/>
                  <a:ext cx="653355" cy="396428"/>
                </a:xfrm>
                <a:prstGeom prst="rect">
                  <a:avLst/>
                </a:prstGeom>
                <a:solidFill>
                  <a:srgbClr val="FFD966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148" name="Rectangle 9" descr="70%">
                  <a:extLst>
                    <a:ext uri="{FF2B5EF4-FFF2-40B4-BE49-F238E27FC236}">
                      <a16:creationId xmlns:a16="http://schemas.microsoft.com/office/drawing/2014/main" id="{B4430531-9013-7020-A3BD-73D81A5307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749757" y="2133420"/>
                  <a:ext cx="587586" cy="81340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cxnSp>
              <p:nvCxnSpPr>
                <p:cNvPr id="179" name="Gerade Verbindung 347">
                  <a:extLst>
                    <a:ext uri="{FF2B5EF4-FFF2-40B4-BE49-F238E27FC236}">
                      <a16:creationId xmlns:a16="http://schemas.microsoft.com/office/drawing/2014/main" id="{0E4DD46B-DDA7-9D73-9200-7F7C23551B2C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808204" y="2069507"/>
                  <a:ext cx="320841" cy="0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" name="Rectangle 9" descr="70%">
                  <a:extLst>
                    <a:ext uri="{FF2B5EF4-FFF2-40B4-BE49-F238E27FC236}">
                      <a16:creationId xmlns:a16="http://schemas.microsoft.com/office/drawing/2014/main" id="{CFDD900C-FCC9-B338-8C0A-FD98B46CF4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749758" y="1683139"/>
                  <a:ext cx="586964" cy="12612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59" name="Rectangle 9" descr="70%">
                  <a:extLst>
                    <a:ext uri="{FF2B5EF4-FFF2-40B4-BE49-F238E27FC236}">
                      <a16:creationId xmlns:a16="http://schemas.microsoft.com/office/drawing/2014/main" id="{13DA820A-6FDE-6065-DE3B-046540739C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935834" y="1237909"/>
                  <a:ext cx="401509" cy="354873"/>
                </a:xfrm>
                <a:prstGeom prst="rect">
                  <a:avLst/>
                </a:prstGeom>
                <a:solidFill>
                  <a:srgbClr val="CAD48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60" name="Rectangle 9" descr="70%">
                  <a:extLst>
                    <a:ext uri="{FF2B5EF4-FFF2-40B4-BE49-F238E27FC236}">
                      <a16:creationId xmlns:a16="http://schemas.microsoft.com/office/drawing/2014/main" id="{713E9B45-EBD7-B53B-ED55-BF7F53FF37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839941" y="1594665"/>
                  <a:ext cx="495537" cy="90359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cxnSp>
              <p:nvCxnSpPr>
                <p:cNvPr id="261" name="Gerade Verbindung 357">
                  <a:extLst>
                    <a:ext uri="{FF2B5EF4-FFF2-40B4-BE49-F238E27FC236}">
                      <a16:creationId xmlns:a16="http://schemas.microsoft.com/office/drawing/2014/main" id="{037A0283-EF03-F59E-2F94-F7B7CC03633A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953703" y="1558741"/>
                  <a:ext cx="322084" cy="2566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Gerade Verbindung 358">
                  <a:extLst>
                    <a:ext uri="{FF2B5EF4-FFF2-40B4-BE49-F238E27FC236}">
                      <a16:creationId xmlns:a16="http://schemas.microsoft.com/office/drawing/2014/main" id="{BC2D1591-10C9-18C6-AF61-28D30F8C7B84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895256" y="1533075"/>
                  <a:ext cx="322084" cy="0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Gerade Verbindung 359">
                  <a:extLst>
                    <a:ext uri="{FF2B5EF4-FFF2-40B4-BE49-F238E27FC236}">
                      <a16:creationId xmlns:a16="http://schemas.microsoft.com/office/drawing/2014/main" id="{665CDA18-8D3F-86A7-9BC3-FE6EF2540EB1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815666" y="1322609"/>
                  <a:ext cx="322084" cy="2566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Gerade Verbindung 360">
                  <a:extLst>
                    <a:ext uri="{FF2B5EF4-FFF2-40B4-BE49-F238E27FC236}">
                      <a16:creationId xmlns:a16="http://schemas.microsoft.com/office/drawing/2014/main" id="{330A9866-A6EC-D0C5-3169-232F068468CB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808204" y="1574141"/>
                  <a:ext cx="320841" cy="0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Line 15">
                  <a:extLst>
                    <a:ext uri="{FF2B5EF4-FFF2-40B4-BE49-F238E27FC236}">
                      <a16:creationId xmlns:a16="http://schemas.microsoft.com/office/drawing/2014/main" id="{D00E3475-D356-CCDE-79ED-EF5B35E461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725534" y="1778206"/>
                  <a:ext cx="364366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>
                    <a:defRPr/>
                  </a:pPr>
                  <a:endParaRPr lang="de-DE"/>
                </a:p>
              </p:txBody>
            </p:sp>
            <p:cxnSp>
              <p:nvCxnSpPr>
                <p:cNvPr id="266" name="Gerade Verbindung 363">
                  <a:extLst>
                    <a:ext uri="{FF2B5EF4-FFF2-40B4-BE49-F238E27FC236}">
                      <a16:creationId xmlns:a16="http://schemas.microsoft.com/office/drawing/2014/main" id="{34E05320-8DBD-B3EB-89A0-A8F663E9E1F1}"/>
                    </a:ext>
                  </a:extLst>
                </p:cNvPr>
                <p:cNvCxnSpPr/>
                <p:nvPr/>
              </p:nvCxnSpPr>
              <p:spPr bwMode="auto">
                <a:xfrm rot="10800000" flipV="1">
                  <a:off x="7875358" y="1357257"/>
                  <a:ext cx="322084" cy="2566"/>
                </a:xfrm>
                <a:prstGeom prst="line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7" name="Rectangle 9" descr="70%">
                  <a:extLst>
                    <a:ext uri="{FF2B5EF4-FFF2-40B4-BE49-F238E27FC236}">
                      <a16:creationId xmlns:a16="http://schemas.microsoft.com/office/drawing/2014/main" id="{AFDEAFEA-09D5-36E4-712F-8E9CDE89F7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683542" y="3872373"/>
                  <a:ext cx="651631" cy="516737"/>
                </a:xfrm>
                <a:prstGeom prst="rect">
                  <a:avLst/>
                </a:prstGeom>
                <a:solidFill>
                  <a:srgbClr val="FFD966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68" name="Rectangle 9" descr="70%">
                  <a:extLst>
                    <a:ext uri="{FF2B5EF4-FFF2-40B4-BE49-F238E27FC236}">
                      <a16:creationId xmlns:a16="http://schemas.microsoft.com/office/drawing/2014/main" id="{1228416A-2C30-A95F-1412-4AD6847A3C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423322" y="3240710"/>
                  <a:ext cx="914023" cy="232282"/>
                </a:xfrm>
                <a:prstGeom prst="rect">
                  <a:avLst/>
                </a:prstGeom>
                <a:solidFill>
                  <a:srgbClr val="F4B183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69" name="Rectangle 9" descr="70%">
                  <a:extLst>
                    <a:ext uri="{FF2B5EF4-FFF2-40B4-BE49-F238E27FC236}">
                      <a16:creationId xmlns:a16="http://schemas.microsoft.com/office/drawing/2014/main" id="{E44FC40D-F901-8F69-1C8B-9B5FECEDCE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 flipV="1">
                  <a:off x="7420217" y="2480064"/>
                  <a:ext cx="917123" cy="57938"/>
                </a:xfrm>
                <a:prstGeom prst="rect">
                  <a:avLst/>
                </a:prstGeom>
                <a:solidFill>
                  <a:srgbClr val="F4B183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70" name="Rectangle 9" descr="70%">
                  <a:extLst>
                    <a:ext uri="{FF2B5EF4-FFF2-40B4-BE49-F238E27FC236}">
                      <a16:creationId xmlns:a16="http://schemas.microsoft.com/office/drawing/2014/main" id="{928FAC60-829C-0E60-A8FE-5C595A0C11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548473" y="4582269"/>
                  <a:ext cx="787177" cy="1348781"/>
                </a:xfrm>
                <a:prstGeom prst="rect">
                  <a:avLst/>
                </a:prstGeom>
                <a:solidFill>
                  <a:srgbClr val="C55A1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grpSp>
              <p:nvGrpSpPr>
                <p:cNvPr id="271" name="Group 10">
                  <a:extLst>
                    <a:ext uri="{FF2B5EF4-FFF2-40B4-BE49-F238E27FC236}">
                      <a16:creationId xmlns:a16="http://schemas.microsoft.com/office/drawing/2014/main" id="{D22ED393-13F0-E93E-5C82-22CD1E87E197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555139" y="4694962"/>
                  <a:ext cx="758578" cy="602729"/>
                  <a:chOff x="3130" y="2921"/>
                  <a:chExt cx="1754" cy="430"/>
                </a:xfrm>
                <a:noFill/>
              </p:grpSpPr>
              <p:sp>
                <p:nvSpPr>
                  <p:cNvPr id="387" name="Line 11">
                    <a:extLst>
                      <a:ext uri="{FF2B5EF4-FFF2-40B4-BE49-F238E27FC236}">
                        <a16:creationId xmlns:a16="http://schemas.microsoft.com/office/drawing/2014/main" id="{262C985B-3D81-D0F1-8B3A-1EF860DA68B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130" y="3232"/>
                    <a:ext cx="1233" cy="0"/>
                  </a:xfrm>
                  <a:prstGeom prst="lin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>
                      <a:defRPr/>
                    </a:pPr>
                    <a:endParaRPr lang="de-DE"/>
                  </a:p>
                </p:txBody>
              </p:sp>
              <p:sp>
                <p:nvSpPr>
                  <p:cNvPr id="388" name="Line 12">
                    <a:extLst>
                      <a:ext uri="{FF2B5EF4-FFF2-40B4-BE49-F238E27FC236}">
                        <a16:creationId xmlns:a16="http://schemas.microsoft.com/office/drawing/2014/main" id="{3FD66FE0-2781-C887-4811-65C9D30A7BD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90" y="3351"/>
                    <a:ext cx="1234" cy="0"/>
                  </a:xfrm>
                  <a:prstGeom prst="lin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>
                      <a:defRPr/>
                    </a:pPr>
                    <a:endParaRPr lang="de-DE"/>
                  </a:p>
                </p:txBody>
              </p:sp>
              <p:sp>
                <p:nvSpPr>
                  <p:cNvPr id="389" name="Line 13">
                    <a:extLst>
                      <a:ext uri="{FF2B5EF4-FFF2-40B4-BE49-F238E27FC236}">
                        <a16:creationId xmlns:a16="http://schemas.microsoft.com/office/drawing/2014/main" id="{F701FCC6-EA72-3BD6-5C72-48810A40EDE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651" y="2921"/>
                    <a:ext cx="1233" cy="0"/>
                  </a:xfrm>
                  <a:prstGeom prst="lin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>
                      <a:defRPr/>
                    </a:pPr>
                    <a:endParaRPr lang="de-DE"/>
                  </a:p>
                </p:txBody>
              </p:sp>
            </p:grpSp>
            <p:sp>
              <p:nvSpPr>
                <p:cNvPr id="272" name="Line 22">
                  <a:extLst>
                    <a:ext uri="{FF2B5EF4-FFF2-40B4-BE49-F238E27FC236}">
                      <a16:creationId xmlns:a16="http://schemas.microsoft.com/office/drawing/2014/main" id="{64811A6C-76F3-8663-6F92-2B2182E01A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453167" y="3043556"/>
                  <a:ext cx="53349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lg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3" name="AutoShape 23" descr="20%">
                  <a:extLst>
                    <a:ext uri="{FF2B5EF4-FFF2-40B4-BE49-F238E27FC236}">
                      <a16:creationId xmlns:a16="http://schemas.microsoft.com/office/drawing/2014/main" id="{6184E9B7-EB44-E20D-0729-AF03156E85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011700" y="1506124"/>
                  <a:ext cx="1325643" cy="227150"/>
                </a:xfrm>
                <a:prstGeom prst="rtTriangle">
                  <a:avLst/>
                </a:prstGeom>
                <a:solidFill>
                  <a:srgbClr val="843C0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74" name="AutoShape 24" descr="20%">
                  <a:extLst>
                    <a:ext uri="{FF2B5EF4-FFF2-40B4-BE49-F238E27FC236}">
                      <a16:creationId xmlns:a16="http://schemas.microsoft.com/office/drawing/2014/main" id="{361911CB-FE7A-DDC2-5DC4-4ACFC41593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011700" y="1674241"/>
                  <a:ext cx="1325643" cy="174533"/>
                </a:xfrm>
                <a:prstGeom prst="rtTriangle">
                  <a:avLst/>
                </a:prstGeom>
                <a:solidFill>
                  <a:srgbClr val="843C0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75" name="AutoShape 25" descr="20%">
                  <a:extLst>
                    <a:ext uri="{FF2B5EF4-FFF2-40B4-BE49-F238E27FC236}">
                      <a16:creationId xmlns:a16="http://schemas.microsoft.com/office/drawing/2014/main" id="{4AC05195-3002-8A6D-F446-416224D27F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010457" y="1954007"/>
                  <a:ext cx="1326887" cy="171967"/>
                </a:xfrm>
                <a:prstGeom prst="rtTriangle">
                  <a:avLst/>
                </a:prstGeom>
                <a:solidFill>
                  <a:srgbClr val="843C0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276" name="AutoShape 26" descr="20%">
                  <a:extLst>
                    <a:ext uri="{FF2B5EF4-FFF2-40B4-BE49-F238E27FC236}">
                      <a16:creationId xmlns:a16="http://schemas.microsoft.com/office/drawing/2014/main" id="{E375ACAC-2B2C-1B3F-7672-B79E4C02A3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084620" y="5680800"/>
                  <a:ext cx="1251030" cy="250251"/>
                </a:xfrm>
                <a:prstGeom prst="rtTriangle">
                  <a:avLst/>
                </a:prstGeom>
                <a:solidFill>
                  <a:srgbClr val="843C0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grpSp>
              <p:nvGrpSpPr>
                <p:cNvPr id="277" name="Group 27">
                  <a:extLst>
                    <a:ext uri="{FF2B5EF4-FFF2-40B4-BE49-F238E27FC236}">
                      <a16:creationId xmlns:a16="http://schemas.microsoft.com/office/drawing/2014/main" id="{E603A003-D9B6-F15A-603E-9A1A9D345EC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848621" y="5720585"/>
                  <a:ext cx="446442" cy="139882"/>
                  <a:chOff x="2079" y="2350"/>
                  <a:chExt cx="650" cy="190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84" name="Oval 28">
                    <a:extLst>
                      <a:ext uri="{FF2B5EF4-FFF2-40B4-BE49-F238E27FC236}">
                        <a16:creationId xmlns:a16="http://schemas.microsoft.com/office/drawing/2014/main" id="{91E36901-BD25-81F8-D0D5-35412553DA5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079" y="2421"/>
                    <a:ext cx="279" cy="108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5" name="Oval 29">
                    <a:extLst>
                      <a:ext uri="{FF2B5EF4-FFF2-40B4-BE49-F238E27FC236}">
                        <a16:creationId xmlns:a16="http://schemas.microsoft.com/office/drawing/2014/main" id="{8260D726-E384-3F3B-3857-2684B7A9385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350"/>
                    <a:ext cx="162" cy="126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6" name="Oval 30">
                    <a:extLst>
                      <a:ext uri="{FF2B5EF4-FFF2-40B4-BE49-F238E27FC236}">
                        <a16:creationId xmlns:a16="http://schemas.microsoft.com/office/drawing/2014/main" id="{3F89F21E-722A-368C-469F-86C851E9BF0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1" y="2432"/>
                    <a:ext cx="108" cy="108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sp>
              <p:nvSpPr>
                <p:cNvPr id="278" name="Rectangle 39">
                  <a:extLst>
                    <a:ext uri="{FF2B5EF4-FFF2-40B4-BE49-F238E27FC236}">
                      <a16:creationId xmlns:a16="http://schemas.microsoft.com/office/drawing/2014/main" id="{FB27B4E0-A97C-1DF2-EEF8-B6D60AD17F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807547" y="3168602"/>
                  <a:ext cx="526651" cy="70351"/>
                </a:xfrm>
                <a:prstGeom prst="rect">
                  <a:avLst/>
                </a:prstGeom>
                <a:solidFill>
                  <a:srgbClr val="548235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grpSp>
              <p:nvGrpSpPr>
                <p:cNvPr id="279" name="Group 57">
                  <a:extLst>
                    <a:ext uri="{FF2B5EF4-FFF2-40B4-BE49-F238E27FC236}">
                      <a16:creationId xmlns:a16="http://schemas.microsoft.com/office/drawing/2014/main" id="{3B7194DA-3D2E-927E-51B6-CFC8677F400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826238" y="1554891"/>
                  <a:ext cx="489965" cy="576214"/>
                  <a:chOff x="2085" y="1876"/>
                  <a:chExt cx="898" cy="613"/>
                </a:xfrm>
                <a:noFill/>
              </p:grpSpPr>
              <p:sp>
                <p:nvSpPr>
                  <p:cNvPr id="378" name="Oval 58">
                    <a:extLst>
                      <a:ext uri="{FF2B5EF4-FFF2-40B4-BE49-F238E27FC236}">
                        <a16:creationId xmlns:a16="http://schemas.microsoft.com/office/drawing/2014/main" id="{CB39B27B-0626-F97D-1D2E-1004A886C6F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160" y="2425"/>
                    <a:ext cx="153" cy="39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79" name="Oval 59">
                    <a:extLst>
                      <a:ext uri="{FF2B5EF4-FFF2-40B4-BE49-F238E27FC236}">
                        <a16:creationId xmlns:a16="http://schemas.microsoft.com/office/drawing/2014/main" id="{3FB8BFAC-6EB1-1285-7888-28F1E57AB57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13" y="2441"/>
                    <a:ext cx="91" cy="45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0" name="Oval 60">
                    <a:extLst>
                      <a:ext uri="{FF2B5EF4-FFF2-40B4-BE49-F238E27FC236}">
                        <a16:creationId xmlns:a16="http://schemas.microsoft.com/office/drawing/2014/main" id="{7C986732-BEA7-2279-A3CE-83592349E59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847487">
                    <a:off x="2549" y="2421"/>
                    <a:ext cx="95" cy="68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1" name="Oval 59">
                    <a:extLst>
                      <a:ext uri="{FF2B5EF4-FFF2-40B4-BE49-F238E27FC236}">
                        <a16:creationId xmlns:a16="http://schemas.microsoft.com/office/drawing/2014/main" id="{25D7EFCF-EEE8-025C-39B6-299D3B54AE0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412"/>
                    <a:ext cx="91" cy="45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2" name="Oval 59">
                    <a:extLst>
                      <a:ext uri="{FF2B5EF4-FFF2-40B4-BE49-F238E27FC236}">
                        <a16:creationId xmlns:a16="http://schemas.microsoft.com/office/drawing/2014/main" id="{BC2EC3F5-7803-B468-6221-AB04E8A172B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889" y="2103"/>
                    <a:ext cx="91" cy="45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83" name="Oval 59">
                    <a:extLst>
                      <a:ext uri="{FF2B5EF4-FFF2-40B4-BE49-F238E27FC236}">
                        <a16:creationId xmlns:a16="http://schemas.microsoft.com/office/drawing/2014/main" id="{AB2AAA98-3F7D-1FCC-8623-20E4E154BD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085" y="1876"/>
                    <a:ext cx="91" cy="45"/>
                  </a:xfrm>
                  <a:prstGeom prst="ellips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grpSp>
              <p:nvGrpSpPr>
                <p:cNvPr id="280" name="Group 61">
                  <a:extLst>
                    <a:ext uri="{FF2B5EF4-FFF2-40B4-BE49-F238E27FC236}">
                      <a16:creationId xmlns:a16="http://schemas.microsoft.com/office/drawing/2014/main" id="{6980D546-B3A5-DF34-003E-6D8D91FD0954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885930" y="1770490"/>
                  <a:ext cx="282290" cy="93682"/>
                  <a:chOff x="2200" y="2440"/>
                  <a:chExt cx="519" cy="100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75" name="Oval 62">
                    <a:extLst>
                      <a:ext uri="{FF2B5EF4-FFF2-40B4-BE49-F238E27FC236}">
                        <a16:creationId xmlns:a16="http://schemas.microsoft.com/office/drawing/2014/main" id="{DCA29E87-E138-A2BA-AA82-8DD91D5CE39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00" y="2459"/>
                    <a:ext cx="94" cy="40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76" name="Oval 63">
                    <a:extLst>
                      <a:ext uri="{FF2B5EF4-FFF2-40B4-BE49-F238E27FC236}">
                        <a16:creationId xmlns:a16="http://schemas.microsoft.com/office/drawing/2014/main" id="{96041B82-2EC2-8EE2-1ADE-0EEB7E2B332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52" y="2440"/>
                    <a:ext cx="139" cy="67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77" name="Oval 64">
                    <a:extLst>
                      <a:ext uri="{FF2B5EF4-FFF2-40B4-BE49-F238E27FC236}">
                        <a16:creationId xmlns:a16="http://schemas.microsoft.com/office/drawing/2014/main" id="{A65E500A-32CC-B5AC-C63B-653C0669955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1" y="2488"/>
                    <a:ext cx="98" cy="52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grpSp>
              <p:nvGrpSpPr>
                <p:cNvPr id="281" name="Group 65">
                  <a:extLst>
                    <a:ext uri="{FF2B5EF4-FFF2-40B4-BE49-F238E27FC236}">
                      <a16:creationId xmlns:a16="http://schemas.microsoft.com/office/drawing/2014/main" id="{DCEC197B-4270-194F-AD76-ACB15E19EDF9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982926" y="1578103"/>
                  <a:ext cx="279803" cy="143622"/>
                  <a:chOff x="2211" y="2386"/>
                  <a:chExt cx="512" cy="154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72" name="Oval 66">
                    <a:extLst>
                      <a:ext uri="{FF2B5EF4-FFF2-40B4-BE49-F238E27FC236}">
                        <a16:creationId xmlns:a16="http://schemas.microsoft.com/office/drawing/2014/main" id="{76D9AF42-B598-E98F-140E-1C8F246AB62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11" y="2421"/>
                    <a:ext cx="147" cy="81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73" name="Oval 67">
                    <a:extLst>
                      <a:ext uri="{FF2B5EF4-FFF2-40B4-BE49-F238E27FC236}">
                        <a16:creationId xmlns:a16="http://schemas.microsoft.com/office/drawing/2014/main" id="{97581305-0B94-F976-AB2A-EFECF556CF1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4459783">
                    <a:off x="2425" y="2345"/>
                    <a:ext cx="84" cy="166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74" name="Oval 68">
                    <a:extLst>
                      <a:ext uri="{FF2B5EF4-FFF2-40B4-BE49-F238E27FC236}">
                        <a16:creationId xmlns:a16="http://schemas.microsoft.com/office/drawing/2014/main" id="{FB71F1FC-E584-1134-D3E4-2594A52603B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1" y="2478"/>
                    <a:ext cx="102" cy="62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grpSp>
              <p:nvGrpSpPr>
                <p:cNvPr id="282" name="Group 75">
                  <a:extLst>
                    <a:ext uri="{FF2B5EF4-FFF2-40B4-BE49-F238E27FC236}">
                      <a16:creationId xmlns:a16="http://schemas.microsoft.com/office/drawing/2014/main" id="{39F7BA70-7DC2-2C1A-8432-F84AA462687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149735" y="2947306"/>
                  <a:ext cx="1187608" cy="127049"/>
                  <a:chOff x="4764" y="1110"/>
                  <a:chExt cx="891" cy="139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367" name="AutoShape 70" descr="20%">
                    <a:extLst>
                      <a:ext uri="{FF2B5EF4-FFF2-40B4-BE49-F238E27FC236}">
                        <a16:creationId xmlns:a16="http://schemas.microsoft.com/office/drawing/2014/main" id="{47350F4D-1B40-A427-F32C-C9D39BD5722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64" y="1110"/>
                    <a:ext cx="891" cy="126"/>
                  </a:xfrm>
                  <a:prstGeom prst="rtTriangle">
                    <a:avLst/>
                  </a:prstGeom>
                  <a:solidFill>
                    <a:srgbClr val="843C0C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grpSp>
                <p:nvGrpSpPr>
                  <p:cNvPr id="368" name="Group 71">
                    <a:extLst>
                      <a:ext uri="{FF2B5EF4-FFF2-40B4-BE49-F238E27FC236}">
                        <a16:creationId xmlns:a16="http://schemas.microsoft.com/office/drawing/2014/main" id="{5E0F798E-7A30-9655-39F6-0D0A27F673EE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4786" y="1148"/>
                    <a:ext cx="291" cy="101"/>
                    <a:chOff x="2079" y="2378"/>
                    <a:chExt cx="496" cy="152"/>
                  </a:xfrm>
                  <a:grpFill/>
                </p:grpSpPr>
                <p:sp>
                  <p:nvSpPr>
                    <p:cNvPr id="369" name="Oval 72">
                      <a:extLst>
                        <a:ext uri="{FF2B5EF4-FFF2-40B4-BE49-F238E27FC236}">
                          <a16:creationId xmlns:a16="http://schemas.microsoft.com/office/drawing/2014/main" id="{EB63A475-7D47-D014-CA4A-DF01CC6E0D7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79" y="2421"/>
                      <a:ext cx="138" cy="108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70" name="Oval 73">
                      <a:extLst>
                        <a:ext uri="{FF2B5EF4-FFF2-40B4-BE49-F238E27FC236}">
                          <a16:creationId xmlns:a16="http://schemas.microsoft.com/office/drawing/2014/main" id="{2D137479-2DCA-3C90-9DE2-809EDA07030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95" y="2378"/>
                      <a:ext cx="90" cy="98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71" name="Oval 74">
                      <a:extLst>
                        <a:ext uri="{FF2B5EF4-FFF2-40B4-BE49-F238E27FC236}">
                          <a16:creationId xmlns:a16="http://schemas.microsoft.com/office/drawing/2014/main" id="{39D03E83-FA67-D33C-B29A-088C2249318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01" y="2418"/>
                      <a:ext cx="74" cy="112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83" name="Gruppieren 232">
                  <a:extLst>
                    <a:ext uri="{FF2B5EF4-FFF2-40B4-BE49-F238E27FC236}">
                      <a16:creationId xmlns:a16="http://schemas.microsoft.com/office/drawing/2014/main" id="{46A71465-621E-5D85-9D08-669F9E4D36F0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582008" y="3745407"/>
                  <a:ext cx="753643" cy="836878"/>
                  <a:chOff x="1015672" y="3821939"/>
                  <a:chExt cx="1154328" cy="824244"/>
                </a:xfrm>
                <a:solidFill>
                  <a:schemeClr val="bg1">
                    <a:lumMod val="85000"/>
                  </a:schemeClr>
                </a:solidFill>
              </p:grpSpPr>
              <p:sp>
                <p:nvSpPr>
                  <p:cNvPr id="360" name="Rectangle 9" descr="70%">
                    <a:extLst>
                      <a:ext uri="{FF2B5EF4-FFF2-40B4-BE49-F238E27FC236}">
                        <a16:creationId xmlns:a16="http://schemas.microsoft.com/office/drawing/2014/main" id="{11D18EE4-D425-4A0F-F30F-19907E6716E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15672" y="4454062"/>
                    <a:ext cx="1144938" cy="192121"/>
                  </a:xfrm>
                  <a:prstGeom prst="rect">
                    <a:avLst/>
                  </a:prstGeom>
                  <a:solidFill>
                    <a:srgbClr val="F4B183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cxnSp>
                <p:nvCxnSpPr>
                  <p:cNvPr id="361" name="Gerade Verbindung 522">
                    <a:extLst>
                      <a:ext uri="{FF2B5EF4-FFF2-40B4-BE49-F238E27FC236}">
                        <a16:creationId xmlns:a16="http://schemas.microsoft.com/office/drawing/2014/main" id="{FB5E7226-8EF4-535A-73F9-3E7FC26FA8D2}"/>
                      </a:ext>
                    </a:extLst>
                  </p:cNvPr>
                  <p:cNvCxnSpPr>
                    <a:cxnSpLocks/>
                    <a:stCxn id="360" idx="1"/>
                  </p:cNvCxnSpPr>
                  <p:nvPr/>
                </p:nvCxnSpPr>
                <p:spPr bwMode="auto">
                  <a:xfrm>
                    <a:off x="1015672" y="4550113"/>
                    <a:ext cx="830450" cy="7595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2" name="Gerade Verbindung 523">
                    <a:extLst>
                      <a:ext uri="{FF2B5EF4-FFF2-40B4-BE49-F238E27FC236}">
                        <a16:creationId xmlns:a16="http://schemas.microsoft.com/office/drawing/2014/main" id="{7A266F47-4B21-507A-B411-A305CD352672}"/>
                      </a:ext>
                    </a:extLst>
                  </p:cNvPr>
                  <p:cNvCxnSpPr/>
                  <p:nvPr/>
                </p:nvCxnSpPr>
                <p:spPr bwMode="auto">
                  <a:xfrm rot="10800000" flipH="1" flipV="1">
                    <a:off x="1168312" y="4581722"/>
                    <a:ext cx="830456" cy="2528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3" name="Gerade Verbindung 524">
                    <a:extLst>
                      <a:ext uri="{FF2B5EF4-FFF2-40B4-BE49-F238E27FC236}">
                        <a16:creationId xmlns:a16="http://schemas.microsoft.com/office/drawing/2014/main" id="{7FC1D1E9-42DA-CA2C-DD06-BDDE22D6F3D7}"/>
                      </a:ext>
                    </a:extLst>
                  </p:cNvPr>
                  <p:cNvCxnSpPr/>
                  <p:nvPr/>
                </p:nvCxnSpPr>
                <p:spPr bwMode="auto">
                  <a:xfrm rot="10800000" flipH="1" flipV="1">
                    <a:off x="1185460" y="4275836"/>
                    <a:ext cx="830456" cy="0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4" name="Gerade Verbindung 525">
                    <a:extLst>
                      <a:ext uri="{FF2B5EF4-FFF2-40B4-BE49-F238E27FC236}">
                        <a16:creationId xmlns:a16="http://schemas.microsoft.com/office/drawing/2014/main" id="{B4A1B7B2-39B3-D4FA-7A98-AF5B02A5B692}"/>
                      </a:ext>
                    </a:extLst>
                  </p:cNvPr>
                  <p:cNvCxnSpPr/>
                  <p:nvPr/>
                </p:nvCxnSpPr>
                <p:spPr bwMode="auto">
                  <a:xfrm rot="10800000" flipH="1" flipV="1">
                    <a:off x="1341449" y="4494800"/>
                    <a:ext cx="828551" cy="1264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5" name="Gerade Verbindung 526">
                    <a:extLst>
                      <a:ext uri="{FF2B5EF4-FFF2-40B4-BE49-F238E27FC236}">
                        <a16:creationId xmlns:a16="http://schemas.microsoft.com/office/drawing/2014/main" id="{FA202FFB-F615-6EF4-3F23-092EBC25215F}"/>
                      </a:ext>
                    </a:extLst>
                  </p:cNvPr>
                  <p:cNvCxnSpPr/>
                  <p:nvPr/>
                </p:nvCxnSpPr>
                <p:spPr bwMode="auto">
                  <a:xfrm rot="10800000" flipH="1" flipV="1">
                    <a:off x="1339543" y="4614585"/>
                    <a:ext cx="830456" cy="1264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6" name="Gerade Verbindung 524">
                    <a:extLst>
                      <a:ext uri="{FF2B5EF4-FFF2-40B4-BE49-F238E27FC236}">
                        <a16:creationId xmlns:a16="http://schemas.microsoft.com/office/drawing/2014/main" id="{102C08E0-1522-AD19-074D-16A50C2B8455}"/>
                      </a:ext>
                    </a:extLst>
                  </p:cNvPr>
                  <p:cNvCxnSpPr/>
                  <p:nvPr/>
                </p:nvCxnSpPr>
                <p:spPr bwMode="auto">
                  <a:xfrm rot="10800000" flipH="1" flipV="1">
                    <a:off x="1075245" y="3821939"/>
                    <a:ext cx="830456" cy="0"/>
                  </a:xfrm>
                  <a:prstGeom prst="lin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4" name="Group 27">
                  <a:extLst>
                    <a:ext uri="{FF2B5EF4-FFF2-40B4-BE49-F238E27FC236}">
                      <a16:creationId xmlns:a16="http://schemas.microsoft.com/office/drawing/2014/main" id="{C64C40B8-1C1D-5DD4-78D1-F9DE8AEB9C72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8081169" y="5188001"/>
                  <a:ext cx="221354" cy="70584"/>
                  <a:chOff x="2079" y="2403"/>
                  <a:chExt cx="650" cy="137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57" name="Oval 28">
                    <a:extLst>
                      <a:ext uri="{FF2B5EF4-FFF2-40B4-BE49-F238E27FC236}">
                        <a16:creationId xmlns:a16="http://schemas.microsoft.com/office/drawing/2014/main" id="{33138D92-09E6-0594-91E4-93171D2CC4C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079" y="2421"/>
                    <a:ext cx="279" cy="108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8" name="Oval 29">
                    <a:extLst>
                      <a:ext uri="{FF2B5EF4-FFF2-40B4-BE49-F238E27FC236}">
                        <a16:creationId xmlns:a16="http://schemas.microsoft.com/office/drawing/2014/main" id="{5807F171-D813-AB8C-8070-87DFDAB79B1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403"/>
                    <a:ext cx="162" cy="73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9" name="Oval 30">
                    <a:extLst>
                      <a:ext uri="{FF2B5EF4-FFF2-40B4-BE49-F238E27FC236}">
                        <a16:creationId xmlns:a16="http://schemas.microsoft.com/office/drawing/2014/main" id="{872929AB-17B4-505B-776C-3D1FEA416FD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3" y="2468"/>
                    <a:ext cx="106" cy="72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grpSp>
              <p:nvGrpSpPr>
                <p:cNvPr id="285" name="Group 27">
                  <a:extLst>
                    <a:ext uri="{FF2B5EF4-FFF2-40B4-BE49-F238E27FC236}">
                      <a16:creationId xmlns:a16="http://schemas.microsoft.com/office/drawing/2014/main" id="{2467881E-C719-76AF-2C22-127E2EF05D5A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8800903" flipH="1">
                  <a:off x="8074182" y="4691914"/>
                  <a:ext cx="170726" cy="174268"/>
                  <a:chOff x="2079" y="2232"/>
                  <a:chExt cx="573" cy="297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54" name="Oval 28">
                    <a:extLst>
                      <a:ext uri="{FF2B5EF4-FFF2-40B4-BE49-F238E27FC236}">
                        <a16:creationId xmlns:a16="http://schemas.microsoft.com/office/drawing/2014/main" id="{CA783C45-31B5-0C23-8F1B-0126D1DAF87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9062542">
                    <a:off x="2079" y="2421"/>
                    <a:ext cx="279" cy="108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5" name="Oval 29">
                    <a:extLst>
                      <a:ext uri="{FF2B5EF4-FFF2-40B4-BE49-F238E27FC236}">
                        <a16:creationId xmlns:a16="http://schemas.microsoft.com/office/drawing/2014/main" id="{EDA9ABBC-CEE7-5082-B547-ECEC9BC527D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350"/>
                    <a:ext cx="162" cy="126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6" name="Oval 30">
                    <a:extLst>
                      <a:ext uri="{FF2B5EF4-FFF2-40B4-BE49-F238E27FC236}">
                        <a16:creationId xmlns:a16="http://schemas.microsoft.com/office/drawing/2014/main" id="{9A83A8E0-43AC-6298-EA46-7A826CF6573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02" y="2232"/>
                    <a:ext cx="150" cy="90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grpSp>
              <p:nvGrpSpPr>
                <p:cNvPr id="286" name="Group 27">
                  <a:extLst>
                    <a:ext uri="{FF2B5EF4-FFF2-40B4-BE49-F238E27FC236}">
                      <a16:creationId xmlns:a16="http://schemas.microsoft.com/office/drawing/2014/main" id="{42999C56-CBCA-20BA-DBAB-C5A7CBF7F897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806209" y="4788248"/>
                  <a:ext cx="221354" cy="69301"/>
                  <a:chOff x="2079" y="2404"/>
                  <a:chExt cx="647" cy="136"/>
                </a:xfrm>
                <a:solidFill>
                  <a:schemeClr val="bg1">
                    <a:lumMod val="50000"/>
                  </a:schemeClr>
                </a:solidFill>
              </p:grpSpPr>
              <p:sp>
                <p:nvSpPr>
                  <p:cNvPr id="351" name="Oval 28">
                    <a:extLst>
                      <a:ext uri="{FF2B5EF4-FFF2-40B4-BE49-F238E27FC236}">
                        <a16:creationId xmlns:a16="http://schemas.microsoft.com/office/drawing/2014/main" id="{695EA568-A2C3-CCB8-AA6C-08BA0ADB14B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079" y="2421"/>
                    <a:ext cx="279" cy="108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2" name="Oval 29">
                    <a:extLst>
                      <a:ext uri="{FF2B5EF4-FFF2-40B4-BE49-F238E27FC236}">
                        <a16:creationId xmlns:a16="http://schemas.microsoft.com/office/drawing/2014/main" id="{2D18FCC8-D700-5631-BEE5-0DAE6717EF9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404"/>
                    <a:ext cx="162" cy="72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sp>
                <p:nvSpPr>
                  <p:cNvPr id="353" name="Oval 30">
                    <a:extLst>
                      <a:ext uri="{FF2B5EF4-FFF2-40B4-BE49-F238E27FC236}">
                        <a16:creationId xmlns:a16="http://schemas.microsoft.com/office/drawing/2014/main" id="{CB5A7B38-D16C-F618-F10B-DA23A2ED0C0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621" y="2468"/>
                    <a:ext cx="105" cy="72"/>
                  </a:xfrm>
                  <a:prstGeom prst="ellipse">
                    <a:avLst/>
                  </a:prstGeom>
                  <a:grp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</p:grpSp>
            <p:cxnSp>
              <p:nvCxnSpPr>
                <p:cNvPr id="287" name="Gerade Verbindung 552">
                  <a:extLst>
                    <a:ext uri="{FF2B5EF4-FFF2-40B4-BE49-F238E27FC236}">
                      <a16:creationId xmlns:a16="http://schemas.microsoft.com/office/drawing/2014/main" id="{24717BB9-4376-3381-45A4-412E183DFF92}"/>
                    </a:ext>
                  </a:extLst>
                </p:cNvPr>
                <p:cNvCxnSpPr/>
                <p:nvPr/>
              </p:nvCxnSpPr>
              <p:spPr bwMode="auto">
                <a:xfrm flipH="1">
                  <a:off x="7964273" y="3302788"/>
                  <a:ext cx="170369" cy="7058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8" name="Gerade Verbindung 554">
                  <a:extLst>
                    <a:ext uri="{FF2B5EF4-FFF2-40B4-BE49-F238E27FC236}">
                      <a16:creationId xmlns:a16="http://schemas.microsoft.com/office/drawing/2014/main" id="{4470311E-04D0-C893-1FC5-AB4C7DF22C3B}"/>
                    </a:ext>
                  </a:extLst>
                </p:cNvPr>
                <p:cNvCxnSpPr/>
                <p:nvPr/>
              </p:nvCxnSpPr>
              <p:spPr bwMode="auto">
                <a:xfrm flipH="1">
                  <a:off x="7787687" y="3302788"/>
                  <a:ext cx="169126" cy="7058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9" name="Gerade Verbindung 555">
                  <a:extLst>
                    <a:ext uri="{FF2B5EF4-FFF2-40B4-BE49-F238E27FC236}">
                      <a16:creationId xmlns:a16="http://schemas.microsoft.com/office/drawing/2014/main" id="{25A3F50B-1F16-1CC5-F704-1E64BEF36040}"/>
                    </a:ext>
                  </a:extLst>
                </p:cNvPr>
                <p:cNvCxnSpPr/>
                <p:nvPr/>
              </p:nvCxnSpPr>
              <p:spPr bwMode="auto">
                <a:xfrm flipH="1">
                  <a:off x="8098577" y="3369523"/>
                  <a:ext cx="170369" cy="7058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0" name="Gerade Verbindung 557">
                  <a:extLst>
                    <a:ext uri="{FF2B5EF4-FFF2-40B4-BE49-F238E27FC236}">
                      <a16:creationId xmlns:a16="http://schemas.microsoft.com/office/drawing/2014/main" id="{C3AA1468-2D9D-7CDC-848A-4D1698B76711}"/>
                    </a:ext>
                  </a:extLst>
                </p:cNvPr>
                <p:cNvCxnSpPr/>
                <p:nvPr/>
              </p:nvCxnSpPr>
              <p:spPr bwMode="auto">
                <a:xfrm flipH="1">
                  <a:off x="7921991" y="3369523"/>
                  <a:ext cx="169126" cy="7058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91" name="Group 75">
                  <a:extLst>
                    <a:ext uri="{FF2B5EF4-FFF2-40B4-BE49-F238E27FC236}">
                      <a16:creationId xmlns:a16="http://schemas.microsoft.com/office/drawing/2014/main" id="{CDEABCCE-1EFE-A749-104D-6217107A3DBD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148042" y="6013184"/>
                  <a:ext cx="1187608" cy="145016"/>
                  <a:chOff x="4764" y="1110"/>
                  <a:chExt cx="891" cy="126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346" name="AutoShape 70" descr="20%">
                    <a:extLst>
                      <a:ext uri="{FF2B5EF4-FFF2-40B4-BE49-F238E27FC236}">
                        <a16:creationId xmlns:a16="http://schemas.microsoft.com/office/drawing/2014/main" id="{304306EE-4908-BE72-71B2-958E7C0DFD6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64" y="1110"/>
                    <a:ext cx="891" cy="126"/>
                  </a:xfrm>
                  <a:prstGeom prst="rtTriangle">
                    <a:avLst/>
                  </a:prstGeom>
                  <a:solidFill>
                    <a:srgbClr val="843C0C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grpSp>
                <p:nvGrpSpPr>
                  <p:cNvPr id="347" name="Group 71">
                    <a:extLst>
                      <a:ext uri="{FF2B5EF4-FFF2-40B4-BE49-F238E27FC236}">
                        <a16:creationId xmlns:a16="http://schemas.microsoft.com/office/drawing/2014/main" id="{5CF2083B-7CDF-01A0-4CD8-83E53C11282B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4786" y="1154"/>
                    <a:ext cx="291" cy="82"/>
                    <a:chOff x="2079" y="2418"/>
                    <a:chExt cx="496" cy="125"/>
                  </a:xfrm>
                  <a:grpFill/>
                </p:grpSpPr>
                <p:sp>
                  <p:nvSpPr>
                    <p:cNvPr id="348" name="Oval 73">
                      <a:extLst>
                        <a:ext uri="{FF2B5EF4-FFF2-40B4-BE49-F238E27FC236}">
                          <a16:creationId xmlns:a16="http://schemas.microsoft.com/office/drawing/2014/main" id="{5F245883-E5AA-5533-1BE1-91C9C8D5BA6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54" y="2424"/>
                      <a:ext cx="90" cy="99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49" name="Oval 74">
                      <a:extLst>
                        <a:ext uri="{FF2B5EF4-FFF2-40B4-BE49-F238E27FC236}">
                          <a16:creationId xmlns:a16="http://schemas.microsoft.com/office/drawing/2014/main" id="{0AA9B48B-3D54-2C59-588C-1A47EC916C1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01" y="2418"/>
                      <a:ext cx="74" cy="100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50" name="Oval 72">
                      <a:extLst>
                        <a:ext uri="{FF2B5EF4-FFF2-40B4-BE49-F238E27FC236}">
                          <a16:creationId xmlns:a16="http://schemas.microsoft.com/office/drawing/2014/main" id="{27945082-F678-C914-2D50-7D020DB7D4F6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79" y="2459"/>
                      <a:ext cx="100" cy="84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92" name="Group 75">
                  <a:extLst>
                    <a:ext uri="{FF2B5EF4-FFF2-40B4-BE49-F238E27FC236}">
                      <a16:creationId xmlns:a16="http://schemas.microsoft.com/office/drawing/2014/main" id="{9F822254-F739-0A85-13F1-3BB205962D97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flipH="1">
                  <a:off x="7206491" y="5936183"/>
                  <a:ext cx="1129159" cy="132183"/>
                  <a:chOff x="4764" y="1110"/>
                  <a:chExt cx="891" cy="145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341" name="AutoShape 70" descr="20%">
                    <a:extLst>
                      <a:ext uri="{FF2B5EF4-FFF2-40B4-BE49-F238E27FC236}">
                        <a16:creationId xmlns:a16="http://schemas.microsoft.com/office/drawing/2014/main" id="{F1ED4C4A-07FB-0F2B-A2AE-BDC9D3156D5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64" y="1110"/>
                    <a:ext cx="891" cy="126"/>
                  </a:xfrm>
                  <a:prstGeom prst="rtTriangle">
                    <a:avLst/>
                  </a:prstGeom>
                  <a:solidFill>
                    <a:srgbClr val="843C0C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de-DE">
                      <a:latin typeface="Calibri" pitchFamily="34" charset="0"/>
                    </a:endParaRPr>
                  </a:p>
                </p:txBody>
              </p:sp>
              <p:grpSp>
                <p:nvGrpSpPr>
                  <p:cNvPr id="342" name="Group 71">
                    <a:extLst>
                      <a:ext uri="{FF2B5EF4-FFF2-40B4-BE49-F238E27FC236}">
                        <a16:creationId xmlns:a16="http://schemas.microsoft.com/office/drawing/2014/main" id="{D3E40E15-1861-18A9-E774-E0FE4E4DA383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4795" y="1169"/>
                    <a:ext cx="332" cy="86"/>
                    <a:chOff x="2079" y="2400"/>
                    <a:chExt cx="562" cy="129"/>
                  </a:xfrm>
                  <a:grpFill/>
                </p:grpSpPr>
                <p:sp>
                  <p:nvSpPr>
                    <p:cNvPr id="343" name="Oval 72">
                      <a:extLst>
                        <a:ext uri="{FF2B5EF4-FFF2-40B4-BE49-F238E27FC236}">
                          <a16:creationId xmlns:a16="http://schemas.microsoft.com/office/drawing/2014/main" id="{124FE2F2-CF02-7EA2-C868-8EAB94B14B6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79" y="2421"/>
                      <a:ext cx="138" cy="108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44" name="Oval 73">
                      <a:extLst>
                        <a:ext uri="{FF2B5EF4-FFF2-40B4-BE49-F238E27FC236}">
                          <a16:creationId xmlns:a16="http://schemas.microsoft.com/office/drawing/2014/main" id="{FD4248B7-114E-EAB2-9BF1-764E6B733AD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17" y="2400"/>
                      <a:ext cx="64" cy="76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  <p:sp>
                  <p:nvSpPr>
                    <p:cNvPr id="345" name="Oval 74">
                      <a:extLst>
                        <a:ext uri="{FF2B5EF4-FFF2-40B4-BE49-F238E27FC236}">
                          <a16:creationId xmlns:a16="http://schemas.microsoft.com/office/drawing/2014/main" id="{8B27165B-C97F-95FB-5ECA-58900E27CEF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53" y="2408"/>
                      <a:ext cx="88" cy="112"/>
                    </a:xfrm>
                    <a:prstGeom prst="ellipse">
                      <a:avLst/>
                    </a:prstGeom>
                    <a:solidFill>
                      <a:schemeClr val="bg1">
                        <a:lumMod val="50000"/>
                      </a:schemeClr>
                    </a:solidFill>
                    <a:ln w="9525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  <p:txBody>
                    <a:bodyPr wrap="none" anchor="ctr"/>
                    <a:lstStyle/>
                    <a:p>
                      <a:pPr>
                        <a:defRPr/>
                      </a:pPr>
                      <a:endParaRPr lang="de-DE">
                        <a:latin typeface="Calibri" pitchFamily="34" charset="0"/>
                      </a:endParaRPr>
                    </a:p>
                  </p:txBody>
                </p:sp>
              </p:grpSp>
            </p:grpSp>
            <p:cxnSp>
              <p:nvCxnSpPr>
                <p:cNvPr id="293" name="Gerade Verbindung 598">
                  <a:extLst>
                    <a:ext uri="{FF2B5EF4-FFF2-40B4-BE49-F238E27FC236}">
                      <a16:creationId xmlns:a16="http://schemas.microsoft.com/office/drawing/2014/main" id="{2F2B574A-4470-C07B-97A3-178FD1E81FEF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279066" y="4125404"/>
                  <a:ext cx="1047084" cy="25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4" name="Gerade Verbindung 599">
                  <a:extLst>
                    <a:ext uri="{FF2B5EF4-FFF2-40B4-BE49-F238E27FC236}">
                      <a16:creationId xmlns:a16="http://schemas.microsoft.com/office/drawing/2014/main" id="{08DA02AD-8C1F-E140-BD22-B4DAC958150D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279066" y="3132106"/>
                  <a:ext cx="1047084" cy="25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5" name="Gerade Verbindung 601">
                  <a:extLst>
                    <a:ext uri="{FF2B5EF4-FFF2-40B4-BE49-F238E27FC236}">
                      <a16:creationId xmlns:a16="http://schemas.microsoft.com/office/drawing/2014/main" id="{D7A82F9D-E97C-611A-DBF8-3A026975913F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499180" y="3979103"/>
                  <a:ext cx="834434" cy="1283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6" name="Gerade Verbindung 602">
                  <a:extLst>
                    <a:ext uri="{FF2B5EF4-FFF2-40B4-BE49-F238E27FC236}">
                      <a16:creationId xmlns:a16="http://schemas.microsoft.com/office/drawing/2014/main" id="{B27E8295-C14C-5564-49A9-00803B28F1E6}"/>
                    </a:ext>
                  </a:extLst>
                </p:cNvPr>
                <p:cNvCxnSpPr/>
                <p:nvPr/>
              </p:nvCxnSpPr>
              <p:spPr bwMode="auto">
                <a:xfrm flipH="1">
                  <a:off x="7499180" y="3163469"/>
                  <a:ext cx="834434" cy="2568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7" name="Gerade Verbindung 604">
                  <a:extLst>
                    <a:ext uri="{FF2B5EF4-FFF2-40B4-BE49-F238E27FC236}">
                      <a16:creationId xmlns:a16="http://schemas.microsoft.com/office/drawing/2014/main" id="{9F86B97F-F607-E37F-A41B-4CC6B7A34774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505396" y="1476608"/>
                  <a:ext cx="828218" cy="1283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8" name="Gerade Verbindung 604">
                  <a:extLst>
                    <a:ext uri="{FF2B5EF4-FFF2-40B4-BE49-F238E27FC236}">
                      <a16:creationId xmlns:a16="http://schemas.microsoft.com/office/drawing/2014/main" id="{D1DAAB7E-1EE8-DE20-DE3C-F26A6B567BD8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513313" y="1932502"/>
                  <a:ext cx="828218" cy="1283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9" name="Gleichschenkliges Dreieck 7">
                  <a:extLst>
                    <a:ext uri="{FF2B5EF4-FFF2-40B4-BE49-F238E27FC236}">
                      <a16:creationId xmlns:a16="http://schemas.microsoft.com/office/drawing/2014/main" id="{7D61A02D-8A87-CBE2-9B07-4BE6512D0572}"/>
                    </a:ext>
                  </a:extLst>
                </p:cNvPr>
                <p:cNvSpPr/>
                <p:nvPr/>
              </p:nvSpPr>
              <p:spPr>
                <a:xfrm rot="10399632" flipH="1">
                  <a:off x="8003993" y="1233500"/>
                  <a:ext cx="62654" cy="215265"/>
                </a:xfrm>
                <a:custGeom>
                  <a:avLst/>
                  <a:gdLst>
                    <a:gd name="connsiteX0" fmla="*/ 0 w 131286"/>
                    <a:gd name="connsiteY0" fmla="*/ 440236 h 440236"/>
                    <a:gd name="connsiteX1" fmla="*/ 65643 w 131286"/>
                    <a:gd name="connsiteY1" fmla="*/ 0 h 440236"/>
                    <a:gd name="connsiteX2" fmla="*/ 131286 w 131286"/>
                    <a:gd name="connsiteY2" fmla="*/ 440236 h 440236"/>
                    <a:gd name="connsiteX3" fmla="*/ 0 w 131286"/>
                    <a:gd name="connsiteY3" fmla="*/ 440236 h 440236"/>
                    <a:gd name="connsiteX0" fmla="*/ 0 w 114156"/>
                    <a:gd name="connsiteY0" fmla="*/ 440236 h 440236"/>
                    <a:gd name="connsiteX1" fmla="*/ 65643 w 114156"/>
                    <a:gd name="connsiteY1" fmla="*/ 0 h 440236"/>
                    <a:gd name="connsiteX2" fmla="*/ 114156 w 114156"/>
                    <a:gd name="connsiteY2" fmla="*/ 252840 h 440236"/>
                    <a:gd name="connsiteX3" fmla="*/ 0 w 114156"/>
                    <a:gd name="connsiteY3" fmla="*/ 440236 h 440236"/>
                    <a:gd name="connsiteX0" fmla="*/ 0 w 80234"/>
                    <a:gd name="connsiteY0" fmla="*/ 258854 h 258854"/>
                    <a:gd name="connsiteX1" fmla="*/ 31721 w 80234"/>
                    <a:gd name="connsiteY1" fmla="*/ 0 h 258854"/>
                    <a:gd name="connsiteX2" fmla="*/ 80234 w 80234"/>
                    <a:gd name="connsiteY2" fmla="*/ 252840 h 258854"/>
                    <a:gd name="connsiteX3" fmla="*/ 0 w 80234"/>
                    <a:gd name="connsiteY3" fmla="*/ 258854 h 258854"/>
                    <a:gd name="connsiteX0" fmla="*/ 0 w 80234"/>
                    <a:gd name="connsiteY0" fmla="*/ 220307 h 220307"/>
                    <a:gd name="connsiteX1" fmla="*/ 50616 w 80234"/>
                    <a:gd name="connsiteY1" fmla="*/ 0 h 220307"/>
                    <a:gd name="connsiteX2" fmla="*/ 80234 w 80234"/>
                    <a:gd name="connsiteY2" fmla="*/ 214293 h 220307"/>
                    <a:gd name="connsiteX3" fmla="*/ 0 w 80234"/>
                    <a:gd name="connsiteY3" fmla="*/ 220307 h 220307"/>
                    <a:gd name="connsiteX0" fmla="*/ 0 w 50616"/>
                    <a:gd name="connsiteY0" fmla="*/ 220307 h 220307"/>
                    <a:gd name="connsiteX1" fmla="*/ 50616 w 50616"/>
                    <a:gd name="connsiteY1" fmla="*/ 0 h 220307"/>
                    <a:gd name="connsiteX2" fmla="*/ 48104 w 50616"/>
                    <a:gd name="connsiteY2" fmla="*/ 206064 h 220307"/>
                    <a:gd name="connsiteX3" fmla="*/ 0 w 50616"/>
                    <a:gd name="connsiteY3" fmla="*/ 220307 h 220307"/>
                    <a:gd name="connsiteX0" fmla="*/ 0 w 53223"/>
                    <a:gd name="connsiteY0" fmla="*/ 220307 h 220307"/>
                    <a:gd name="connsiteX1" fmla="*/ 50616 w 53223"/>
                    <a:gd name="connsiteY1" fmla="*/ 0 h 220307"/>
                    <a:gd name="connsiteX2" fmla="*/ 53112 w 53223"/>
                    <a:gd name="connsiteY2" fmla="*/ 207877 h 220307"/>
                    <a:gd name="connsiteX3" fmla="*/ 0 w 53223"/>
                    <a:gd name="connsiteY3" fmla="*/ 220307 h 220307"/>
                    <a:gd name="connsiteX0" fmla="*/ 0 w 56100"/>
                    <a:gd name="connsiteY0" fmla="*/ 220307 h 220307"/>
                    <a:gd name="connsiteX1" fmla="*/ 50616 w 56100"/>
                    <a:gd name="connsiteY1" fmla="*/ 0 h 220307"/>
                    <a:gd name="connsiteX2" fmla="*/ 56032 w 56100"/>
                    <a:gd name="connsiteY2" fmla="*/ 212330 h 220307"/>
                    <a:gd name="connsiteX3" fmla="*/ 0 w 56100"/>
                    <a:gd name="connsiteY3" fmla="*/ 220307 h 22030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6100" h="220307">
                      <a:moveTo>
                        <a:pt x="0" y="220307"/>
                      </a:moveTo>
                      <a:lnTo>
                        <a:pt x="50616" y="0"/>
                      </a:lnTo>
                      <a:cubicBezTo>
                        <a:pt x="49779" y="68688"/>
                        <a:pt x="56869" y="143642"/>
                        <a:pt x="56032" y="212330"/>
                      </a:cubicBezTo>
                      <a:lnTo>
                        <a:pt x="0" y="220307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00" name="Text Box 6">
                  <a:extLst>
                    <a:ext uri="{FF2B5EF4-FFF2-40B4-BE49-F238E27FC236}">
                      <a16:creationId xmlns:a16="http://schemas.microsoft.com/office/drawing/2014/main" id="{89219D2C-79BC-E4F2-B629-908E216B307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834033" y="1061660"/>
                  <a:ext cx="559963" cy="321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de-DE" sz="900" i="1" dirty="0" err="1">
                      <a:latin typeface="+mn-lt"/>
                    </a:rPr>
                    <a:t>dike</a:t>
                  </a:r>
                  <a:endParaRPr lang="de-DE" sz="900" i="1" dirty="0">
                    <a:latin typeface="+mn-lt"/>
                  </a:endParaRPr>
                </a:p>
              </p:txBody>
            </p:sp>
            <p:sp>
              <p:nvSpPr>
                <p:cNvPr id="301" name="Rechteck 300">
                  <a:extLst>
                    <a:ext uri="{FF2B5EF4-FFF2-40B4-BE49-F238E27FC236}">
                      <a16:creationId xmlns:a16="http://schemas.microsoft.com/office/drawing/2014/main" id="{FC6760CC-F206-190A-44BA-006E92FF798A}"/>
                    </a:ext>
                  </a:extLst>
                </p:cNvPr>
                <p:cNvSpPr/>
                <p:nvPr/>
              </p:nvSpPr>
              <p:spPr>
                <a:xfrm>
                  <a:off x="7939232" y="3476002"/>
                  <a:ext cx="394708" cy="189198"/>
                </a:xfrm>
                <a:prstGeom prst="rect">
                  <a:avLst/>
                </a:prstGeom>
                <a:solidFill>
                  <a:srgbClr val="CAD48C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grpSp>
              <p:nvGrpSpPr>
                <p:cNvPr id="302" name="Gruppieren 301">
                  <a:extLst>
                    <a:ext uri="{FF2B5EF4-FFF2-40B4-BE49-F238E27FC236}">
                      <a16:creationId xmlns:a16="http://schemas.microsoft.com/office/drawing/2014/main" id="{10F7233D-687E-7D3D-1CD5-0C152FF44D12}"/>
                    </a:ext>
                  </a:extLst>
                </p:cNvPr>
                <p:cNvGrpSpPr/>
                <p:nvPr/>
              </p:nvGrpSpPr>
              <p:grpSpPr>
                <a:xfrm>
                  <a:off x="6683592" y="4200931"/>
                  <a:ext cx="363845" cy="1792683"/>
                  <a:chOff x="5123491" y="4724902"/>
                  <a:chExt cx="411297" cy="1892657"/>
                </a:xfrm>
              </p:grpSpPr>
              <p:sp>
                <p:nvSpPr>
                  <p:cNvPr id="337" name="Text Box 6">
                    <a:extLst>
                      <a:ext uri="{FF2B5EF4-FFF2-40B4-BE49-F238E27FC236}">
                        <a16:creationId xmlns:a16="http://schemas.microsoft.com/office/drawing/2014/main" id="{8E932A16-2152-1DE5-F925-33E54DF360E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23491" y="4724902"/>
                    <a:ext cx="345039" cy="25391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1</a:t>
                    </a:r>
                  </a:p>
                </p:txBody>
              </p:sp>
              <p:sp>
                <p:nvSpPr>
                  <p:cNvPr id="338" name="Text Box 6">
                    <a:extLst>
                      <a:ext uri="{FF2B5EF4-FFF2-40B4-BE49-F238E27FC236}">
                        <a16:creationId xmlns:a16="http://schemas.microsoft.com/office/drawing/2014/main" id="{447549A6-4559-CDAC-F3C4-92F8360EEFD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29792" y="6363643"/>
                    <a:ext cx="345039" cy="25391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0</a:t>
                    </a:r>
                  </a:p>
                </p:txBody>
              </p:sp>
              <p:sp>
                <p:nvSpPr>
                  <p:cNvPr id="339" name="Text Box 6">
                    <a:extLst>
                      <a:ext uri="{FF2B5EF4-FFF2-40B4-BE49-F238E27FC236}">
                        <a16:creationId xmlns:a16="http://schemas.microsoft.com/office/drawing/2014/main" id="{603B5193-08C6-2FB8-04E9-79F103C101D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5202024" y="5547769"/>
                    <a:ext cx="411612" cy="25391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km</a:t>
                    </a:r>
                  </a:p>
                </p:txBody>
              </p:sp>
              <p:cxnSp>
                <p:nvCxnSpPr>
                  <p:cNvPr id="340" name="Gerader Verbinder 339">
                    <a:extLst>
                      <a:ext uri="{FF2B5EF4-FFF2-40B4-BE49-F238E27FC236}">
                        <a16:creationId xmlns:a16="http://schemas.microsoft.com/office/drawing/2014/main" id="{D4E87B9A-D44C-97C5-7AC1-A7A719D655C9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276911" y="4950254"/>
                    <a:ext cx="0" cy="144000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03" name="Rectangle 9" descr="70%">
                  <a:extLst>
                    <a:ext uri="{FF2B5EF4-FFF2-40B4-BE49-F238E27FC236}">
                      <a16:creationId xmlns:a16="http://schemas.microsoft.com/office/drawing/2014/main" id="{2A478522-BBB1-7619-257F-8CC168FD5C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 flipV="1">
                  <a:off x="7752028" y="2567795"/>
                  <a:ext cx="584477" cy="71800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cxnSp>
              <p:nvCxnSpPr>
                <p:cNvPr id="304" name="Gerade Verbindung 233">
                  <a:extLst>
                    <a:ext uri="{FF2B5EF4-FFF2-40B4-BE49-F238E27FC236}">
                      <a16:creationId xmlns:a16="http://schemas.microsoft.com/office/drawing/2014/main" id="{4C284A76-D797-E6E7-AF71-5032140EAE96}"/>
                    </a:ext>
                  </a:extLst>
                </p:cNvPr>
                <p:cNvCxnSpPr/>
                <p:nvPr/>
              </p:nvCxnSpPr>
              <p:spPr>
                <a:xfrm>
                  <a:off x="6531051" y="6164601"/>
                  <a:ext cx="56744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05" name="Gruppieren 304">
                  <a:extLst>
                    <a:ext uri="{FF2B5EF4-FFF2-40B4-BE49-F238E27FC236}">
                      <a16:creationId xmlns:a16="http://schemas.microsoft.com/office/drawing/2014/main" id="{73928EDD-DAF9-AB12-D735-9683C5CEAF62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8249386" y="1205628"/>
                  <a:ext cx="785280" cy="5217334"/>
                  <a:chOff x="9561488" y="759269"/>
                  <a:chExt cx="997744" cy="6628924"/>
                </a:xfrm>
              </p:grpSpPr>
              <p:sp>
                <p:nvSpPr>
                  <p:cNvPr id="316" name="Text Box 6">
                    <a:extLst>
                      <a:ext uri="{FF2B5EF4-FFF2-40B4-BE49-F238E27FC236}">
                        <a16:creationId xmlns:a16="http://schemas.microsoft.com/office/drawing/2014/main" id="{EBBF1D11-656A-1E30-D5B4-83B89C10342D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7" y="2233220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Q3</a:t>
                    </a:r>
                  </a:p>
                </p:txBody>
              </p:sp>
              <p:sp>
                <p:nvSpPr>
                  <p:cNvPr id="317" name="Text Box 6">
                    <a:extLst>
                      <a:ext uri="{FF2B5EF4-FFF2-40B4-BE49-F238E27FC236}">
                        <a16:creationId xmlns:a16="http://schemas.microsoft.com/office/drawing/2014/main" id="{122ACE60-5729-0E47-CD02-A47614CBEB8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8" y="969507"/>
                    <a:ext cx="963614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I4</a:t>
                    </a:r>
                  </a:p>
                </p:txBody>
              </p:sp>
              <p:sp>
                <p:nvSpPr>
                  <p:cNvPr id="318" name="Text Box 6">
                    <a:extLst>
                      <a:ext uri="{FF2B5EF4-FFF2-40B4-BE49-F238E27FC236}">
                        <a16:creationId xmlns:a16="http://schemas.microsoft.com/office/drawing/2014/main" id="{198803E0-A14D-6566-94D1-26FC1DAEC5B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0597" y="759269"/>
                    <a:ext cx="963615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S4</a:t>
                    </a:r>
                  </a:p>
                </p:txBody>
              </p:sp>
              <p:sp>
                <p:nvSpPr>
                  <p:cNvPr id="319" name="Text Box 6">
                    <a:extLst>
                      <a:ext uri="{FF2B5EF4-FFF2-40B4-BE49-F238E27FC236}">
                        <a16:creationId xmlns:a16="http://schemas.microsoft.com/office/drawing/2014/main" id="{D95EFBA7-6C5D-4868-D7D1-BDDF8E7DA50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728126" y="3117977"/>
                    <a:ext cx="664462" cy="30307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100" dirty="0">
                        <a:latin typeface="+mn-lt"/>
                      </a:rPr>
                      <a:t>MdL2</a:t>
                    </a:r>
                  </a:p>
                </p:txBody>
              </p:sp>
              <p:cxnSp>
                <p:nvCxnSpPr>
                  <p:cNvPr id="320" name="Gerade Verbindung 301">
                    <a:extLst>
                      <a:ext uri="{FF2B5EF4-FFF2-40B4-BE49-F238E27FC236}">
                        <a16:creationId xmlns:a16="http://schemas.microsoft.com/office/drawing/2014/main" id="{6B809696-4C41-54C5-8CD0-6AA62925FAE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27871" y="2491183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1" name="Gerade Verbindung 302">
                    <a:extLst>
                      <a:ext uri="{FF2B5EF4-FFF2-40B4-BE49-F238E27FC236}">
                        <a16:creationId xmlns:a16="http://schemas.microsoft.com/office/drawing/2014/main" id="{0B1D163C-3C8E-5696-AD30-96D2BA71266D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5" y="7056719"/>
                    <a:ext cx="544512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Gerade Verbindung 303">
                    <a:extLst>
                      <a:ext uri="{FF2B5EF4-FFF2-40B4-BE49-F238E27FC236}">
                        <a16:creationId xmlns:a16="http://schemas.microsoft.com/office/drawing/2014/main" id="{62C97E8F-4D3E-BB0B-488A-EBB581151DAA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5" y="6468412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3" name="Gerade Verbindung 304">
                    <a:extLst>
                      <a:ext uri="{FF2B5EF4-FFF2-40B4-BE49-F238E27FC236}">
                        <a16:creationId xmlns:a16="http://schemas.microsoft.com/office/drawing/2014/main" id="{93005919-E8FB-0C20-8915-6761CCFA3D38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5" y="5059167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4" name="Gerade Verbindung 305">
                    <a:extLst>
                      <a:ext uri="{FF2B5EF4-FFF2-40B4-BE49-F238E27FC236}">
                        <a16:creationId xmlns:a16="http://schemas.microsoft.com/office/drawing/2014/main" id="{BDC51F56-E8FD-153A-BB4C-330B2BD7B293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11933" y="3361760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5" name="Gerade Verbindung 306">
                    <a:extLst>
                      <a:ext uri="{FF2B5EF4-FFF2-40B4-BE49-F238E27FC236}">
                        <a16:creationId xmlns:a16="http://schemas.microsoft.com/office/drawing/2014/main" id="{530DDF7C-90D5-AD8D-87FF-7CD5C16B0D5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7" y="3648558"/>
                    <a:ext cx="544513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6" name="Gerade Verbindung 307">
                    <a:extLst>
                      <a:ext uri="{FF2B5EF4-FFF2-40B4-BE49-F238E27FC236}">
                        <a16:creationId xmlns:a16="http://schemas.microsoft.com/office/drawing/2014/main" id="{ABD0345A-4CCD-5D24-F042-91D8920B28C5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11932" y="2296493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7" name="Text Box 6">
                    <a:extLst>
                      <a:ext uri="{FF2B5EF4-FFF2-40B4-BE49-F238E27FC236}">
                        <a16:creationId xmlns:a16="http://schemas.microsoft.com/office/drawing/2014/main" id="{3EBFFBD9-65C3-A5D2-6883-4E141DF2276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6" y="6777061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 err="1">
                        <a:latin typeface="+mn-lt"/>
                      </a:rPr>
                      <a:t>MdbC</a:t>
                    </a:r>
                    <a:endParaRPr lang="de-DE" sz="1050" dirty="0">
                      <a:latin typeface="+mn-lt"/>
                    </a:endParaRPr>
                  </a:p>
                </p:txBody>
              </p:sp>
              <p:sp>
                <p:nvSpPr>
                  <p:cNvPr id="328" name="Text Box 6">
                    <a:extLst>
                      <a:ext uri="{FF2B5EF4-FFF2-40B4-BE49-F238E27FC236}">
                        <a16:creationId xmlns:a16="http://schemas.microsoft.com/office/drawing/2014/main" id="{41E97BBB-E283-5D36-62ED-3E9BF24B9BD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6" y="5654699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Q1</a:t>
                    </a:r>
                  </a:p>
                </p:txBody>
              </p:sp>
              <p:sp>
                <p:nvSpPr>
                  <p:cNvPr id="329" name="Text Box 6">
                    <a:extLst>
                      <a:ext uri="{FF2B5EF4-FFF2-40B4-BE49-F238E27FC236}">
                        <a16:creationId xmlns:a16="http://schemas.microsoft.com/office/drawing/2014/main" id="{2C02E766-8A2D-2C1E-E506-D302C316B50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6" y="4152925"/>
                    <a:ext cx="963612" cy="52791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S1, MdI1</a:t>
                    </a:r>
                  </a:p>
                </p:txBody>
              </p:sp>
              <p:sp>
                <p:nvSpPr>
                  <p:cNvPr id="330" name="Text Box 6">
                    <a:extLst>
                      <a:ext uri="{FF2B5EF4-FFF2-40B4-BE49-F238E27FC236}">
                        <a16:creationId xmlns:a16="http://schemas.microsoft.com/office/drawing/2014/main" id="{D4C1B0A8-A597-3827-E09B-F35C15BA90D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4" y="3379746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Q2</a:t>
                    </a:r>
                  </a:p>
                </p:txBody>
              </p:sp>
              <p:sp>
                <p:nvSpPr>
                  <p:cNvPr id="331" name="Text Box 6">
                    <a:extLst>
                      <a:ext uri="{FF2B5EF4-FFF2-40B4-BE49-F238E27FC236}">
                        <a16:creationId xmlns:a16="http://schemas.microsoft.com/office/drawing/2014/main" id="{3C7C4778-A648-2D67-13A8-DBFCF3DC65C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81396" y="2591171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S2</a:t>
                    </a:r>
                  </a:p>
                </p:txBody>
              </p:sp>
              <p:sp>
                <p:nvSpPr>
                  <p:cNvPr id="332" name="Text Box 6">
                    <a:extLst>
                      <a:ext uri="{FF2B5EF4-FFF2-40B4-BE49-F238E27FC236}">
                        <a16:creationId xmlns:a16="http://schemas.microsoft.com/office/drawing/2014/main" id="{335E5C35-2C4E-9054-C1A7-0FB2804C739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6" y="1633113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S3</a:t>
                    </a:r>
                  </a:p>
                </p:txBody>
              </p:sp>
              <p:sp>
                <p:nvSpPr>
                  <p:cNvPr id="333" name="Text Box 6">
                    <a:extLst>
                      <a:ext uri="{FF2B5EF4-FFF2-40B4-BE49-F238E27FC236}">
                        <a16:creationId xmlns:a16="http://schemas.microsoft.com/office/drawing/2014/main" id="{03B5DE45-0B67-AA06-E733-A9F28084880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95616" y="7094033"/>
                    <a:ext cx="963612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FT Sch</a:t>
                    </a:r>
                  </a:p>
                </p:txBody>
              </p:sp>
              <p:cxnSp>
                <p:nvCxnSpPr>
                  <p:cNvPr id="334" name="Gerade Verbindung 413">
                    <a:extLst>
                      <a:ext uri="{FF2B5EF4-FFF2-40B4-BE49-F238E27FC236}">
                        <a16:creationId xmlns:a16="http://schemas.microsoft.com/office/drawing/2014/main" id="{CEB2C2D0-8804-0AAE-CBE7-E4D773D70E9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6" y="1233520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5" name="Gerade Verbindung 414">
                    <a:extLst>
                      <a:ext uri="{FF2B5EF4-FFF2-40B4-BE49-F238E27FC236}">
                        <a16:creationId xmlns:a16="http://schemas.microsoft.com/office/drawing/2014/main" id="{48F75E94-E9A5-4B39-6B95-5684BFF5157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842316" y="814411"/>
                    <a:ext cx="544512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6" name="Text Box 6">
                    <a:extLst>
                      <a:ext uri="{FF2B5EF4-FFF2-40B4-BE49-F238E27FC236}">
                        <a16:creationId xmlns:a16="http://schemas.microsoft.com/office/drawing/2014/main" id="{4ADDB6AD-7538-C342-CD03-4176C7D1E88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61488" y="2908114"/>
                    <a:ext cx="963613" cy="29416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de-DE" sz="1050" dirty="0">
                        <a:latin typeface="+mn-lt"/>
                      </a:rPr>
                      <a:t>MdI2</a:t>
                    </a:r>
                  </a:p>
                </p:txBody>
              </p:sp>
            </p:grpSp>
            <p:sp>
              <p:nvSpPr>
                <p:cNvPr id="306" name="Freihandform 691">
                  <a:extLst>
                    <a:ext uri="{FF2B5EF4-FFF2-40B4-BE49-F238E27FC236}">
                      <a16:creationId xmlns:a16="http://schemas.microsoft.com/office/drawing/2014/main" id="{587AE729-48A6-5E21-199D-440A1EC55C8B}"/>
                    </a:ext>
                  </a:extLst>
                </p:cNvPr>
                <p:cNvSpPr/>
                <p:nvPr/>
              </p:nvSpPr>
              <p:spPr>
                <a:xfrm>
                  <a:off x="8166140" y="3104838"/>
                  <a:ext cx="712856" cy="78229"/>
                </a:xfrm>
                <a:custGeom>
                  <a:avLst/>
                  <a:gdLst>
                    <a:gd name="connsiteX0" fmla="*/ 0 w 600075"/>
                    <a:gd name="connsiteY0" fmla="*/ 157162 h 157162"/>
                    <a:gd name="connsiteX1" fmla="*/ 271463 w 600075"/>
                    <a:gd name="connsiteY1" fmla="*/ 157162 h 157162"/>
                    <a:gd name="connsiteX2" fmla="*/ 385763 w 600075"/>
                    <a:gd name="connsiteY2" fmla="*/ 4762 h 157162"/>
                    <a:gd name="connsiteX3" fmla="*/ 600075 w 600075"/>
                    <a:gd name="connsiteY3" fmla="*/ 0 h 157162"/>
                    <a:gd name="connsiteX0" fmla="*/ 0 w 600075"/>
                    <a:gd name="connsiteY0" fmla="*/ 157162 h 166984"/>
                    <a:gd name="connsiteX1" fmla="*/ 111919 w 600075"/>
                    <a:gd name="connsiteY1" fmla="*/ 166984 h 166984"/>
                    <a:gd name="connsiteX2" fmla="*/ 385763 w 600075"/>
                    <a:gd name="connsiteY2" fmla="*/ 4762 h 166984"/>
                    <a:gd name="connsiteX3" fmla="*/ 600075 w 600075"/>
                    <a:gd name="connsiteY3" fmla="*/ 0 h 166984"/>
                    <a:gd name="connsiteX0" fmla="*/ 0 w 600075"/>
                    <a:gd name="connsiteY0" fmla="*/ 157310 h 167132"/>
                    <a:gd name="connsiteX1" fmla="*/ 111919 w 600075"/>
                    <a:gd name="connsiteY1" fmla="*/ 167132 h 167132"/>
                    <a:gd name="connsiteX2" fmla="*/ 145256 w 600075"/>
                    <a:gd name="connsiteY2" fmla="*/ 0 h 167132"/>
                    <a:gd name="connsiteX3" fmla="*/ 600075 w 600075"/>
                    <a:gd name="connsiteY3" fmla="*/ 148 h 167132"/>
                    <a:gd name="connsiteX0" fmla="*/ 0 w 600075"/>
                    <a:gd name="connsiteY0" fmla="*/ 176956 h 176956"/>
                    <a:gd name="connsiteX1" fmla="*/ 111919 w 600075"/>
                    <a:gd name="connsiteY1" fmla="*/ 167132 h 176956"/>
                    <a:gd name="connsiteX2" fmla="*/ 145256 w 600075"/>
                    <a:gd name="connsiteY2" fmla="*/ 0 h 176956"/>
                    <a:gd name="connsiteX3" fmla="*/ 600075 w 600075"/>
                    <a:gd name="connsiteY3" fmla="*/ 148 h 176956"/>
                    <a:gd name="connsiteX0" fmla="*/ 0 w 597694"/>
                    <a:gd name="connsiteY0" fmla="*/ 167132 h 167132"/>
                    <a:gd name="connsiteX1" fmla="*/ 109538 w 597694"/>
                    <a:gd name="connsiteY1" fmla="*/ 167132 h 167132"/>
                    <a:gd name="connsiteX2" fmla="*/ 142875 w 597694"/>
                    <a:gd name="connsiteY2" fmla="*/ 0 h 167132"/>
                    <a:gd name="connsiteX3" fmla="*/ 597694 w 597694"/>
                    <a:gd name="connsiteY3" fmla="*/ 148 h 167132"/>
                    <a:gd name="connsiteX0" fmla="*/ 0 w 597694"/>
                    <a:gd name="connsiteY0" fmla="*/ 176954 h 176954"/>
                    <a:gd name="connsiteX1" fmla="*/ 109538 w 597694"/>
                    <a:gd name="connsiteY1" fmla="*/ 176954 h 176954"/>
                    <a:gd name="connsiteX2" fmla="*/ 142875 w 597694"/>
                    <a:gd name="connsiteY2" fmla="*/ 0 h 176954"/>
                    <a:gd name="connsiteX3" fmla="*/ 597694 w 597694"/>
                    <a:gd name="connsiteY3" fmla="*/ 9970 h 176954"/>
                    <a:gd name="connsiteX0" fmla="*/ 0 w 781812"/>
                    <a:gd name="connsiteY0" fmla="*/ 176954 h 176954"/>
                    <a:gd name="connsiteX1" fmla="*/ 109538 w 781812"/>
                    <a:gd name="connsiteY1" fmla="*/ 176954 h 176954"/>
                    <a:gd name="connsiteX2" fmla="*/ 142875 w 781812"/>
                    <a:gd name="connsiteY2" fmla="*/ 0 h 176954"/>
                    <a:gd name="connsiteX3" fmla="*/ 781812 w 781812"/>
                    <a:gd name="connsiteY3" fmla="*/ 9970 h 1769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1812" h="176954">
                      <a:moveTo>
                        <a:pt x="0" y="176954"/>
                      </a:moveTo>
                      <a:lnTo>
                        <a:pt x="109538" y="176954"/>
                      </a:lnTo>
                      <a:lnTo>
                        <a:pt x="142875" y="0"/>
                      </a:lnTo>
                      <a:lnTo>
                        <a:pt x="781812" y="9970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07" name="Freihandform 692">
                  <a:extLst>
                    <a:ext uri="{FF2B5EF4-FFF2-40B4-BE49-F238E27FC236}">
                      <a16:creationId xmlns:a16="http://schemas.microsoft.com/office/drawing/2014/main" id="{24551D59-0BA0-8B77-DF3C-7AD402B8AE95}"/>
                    </a:ext>
                  </a:extLst>
                </p:cNvPr>
                <p:cNvSpPr/>
                <p:nvPr/>
              </p:nvSpPr>
              <p:spPr>
                <a:xfrm>
                  <a:off x="8162026" y="2937383"/>
                  <a:ext cx="723980" cy="215130"/>
                </a:xfrm>
                <a:custGeom>
                  <a:avLst/>
                  <a:gdLst>
                    <a:gd name="connsiteX0" fmla="*/ 0 w 600075"/>
                    <a:gd name="connsiteY0" fmla="*/ 157162 h 157162"/>
                    <a:gd name="connsiteX1" fmla="*/ 271463 w 600075"/>
                    <a:gd name="connsiteY1" fmla="*/ 157162 h 157162"/>
                    <a:gd name="connsiteX2" fmla="*/ 385763 w 600075"/>
                    <a:gd name="connsiteY2" fmla="*/ 4762 h 157162"/>
                    <a:gd name="connsiteX3" fmla="*/ 600075 w 600075"/>
                    <a:gd name="connsiteY3" fmla="*/ 0 h 157162"/>
                    <a:gd name="connsiteX0" fmla="*/ 0 w 600075"/>
                    <a:gd name="connsiteY0" fmla="*/ 157162 h 158799"/>
                    <a:gd name="connsiteX1" fmla="*/ 92870 w 600075"/>
                    <a:gd name="connsiteY1" fmla="*/ 158799 h 158799"/>
                    <a:gd name="connsiteX2" fmla="*/ 385763 w 600075"/>
                    <a:gd name="connsiteY2" fmla="*/ 4762 h 158799"/>
                    <a:gd name="connsiteX3" fmla="*/ 600075 w 600075"/>
                    <a:gd name="connsiteY3" fmla="*/ 0 h 158799"/>
                    <a:gd name="connsiteX0" fmla="*/ 0 w 600075"/>
                    <a:gd name="connsiteY0" fmla="*/ 160587 h 162224"/>
                    <a:gd name="connsiteX1" fmla="*/ 92870 w 600075"/>
                    <a:gd name="connsiteY1" fmla="*/ 162224 h 162224"/>
                    <a:gd name="connsiteX2" fmla="*/ 159544 w 600075"/>
                    <a:gd name="connsiteY2" fmla="*/ 0 h 162224"/>
                    <a:gd name="connsiteX3" fmla="*/ 600075 w 600075"/>
                    <a:gd name="connsiteY3" fmla="*/ 3425 h 162224"/>
                    <a:gd name="connsiteX0" fmla="*/ 0 w 794011"/>
                    <a:gd name="connsiteY0" fmla="*/ 160587 h 162224"/>
                    <a:gd name="connsiteX1" fmla="*/ 92870 w 794011"/>
                    <a:gd name="connsiteY1" fmla="*/ 162224 h 162224"/>
                    <a:gd name="connsiteX2" fmla="*/ 159544 w 794011"/>
                    <a:gd name="connsiteY2" fmla="*/ 0 h 162224"/>
                    <a:gd name="connsiteX3" fmla="*/ 794011 w 794011"/>
                    <a:gd name="connsiteY3" fmla="*/ 5113 h 16222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94011" h="162224">
                      <a:moveTo>
                        <a:pt x="0" y="160587"/>
                      </a:moveTo>
                      <a:lnTo>
                        <a:pt x="92870" y="162224"/>
                      </a:lnTo>
                      <a:lnTo>
                        <a:pt x="159544" y="0"/>
                      </a:lnTo>
                      <a:lnTo>
                        <a:pt x="794011" y="5113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08" name="Rechteck 307">
                  <a:extLst>
                    <a:ext uri="{FF2B5EF4-FFF2-40B4-BE49-F238E27FC236}">
                      <a16:creationId xmlns:a16="http://schemas.microsoft.com/office/drawing/2014/main" id="{4F2979E5-0317-6FBD-CF0A-28FD56AEC993}"/>
                    </a:ext>
                  </a:extLst>
                </p:cNvPr>
                <p:cNvSpPr/>
                <p:nvPr/>
              </p:nvSpPr>
              <p:spPr>
                <a:xfrm>
                  <a:off x="7942632" y="2640045"/>
                  <a:ext cx="394708" cy="49226"/>
                </a:xfrm>
                <a:prstGeom prst="rect">
                  <a:avLst/>
                </a:prstGeom>
                <a:solidFill>
                  <a:srgbClr val="CAD48C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09" name="Rectangle 9" descr="70%">
                  <a:extLst>
                    <a:ext uri="{FF2B5EF4-FFF2-40B4-BE49-F238E27FC236}">
                      <a16:creationId xmlns:a16="http://schemas.microsoft.com/office/drawing/2014/main" id="{84FA4A62-1799-4293-8FEF-759A3462AA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 flipV="1">
                  <a:off x="7752577" y="2688605"/>
                  <a:ext cx="584477" cy="84187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310" name="Rectangle 9" descr="70%">
                  <a:extLst>
                    <a:ext uri="{FF2B5EF4-FFF2-40B4-BE49-F238E27FC236}">
                      <a16:creationId xmlns:a16="http://schemas.microsoft.com/office/drawing/2014/main" id="{C5D284EB-BFAD-A8C0-C7C5-45BD32D3F0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749756" y="2261571"/>
                  <a:ext cx="587586" cy="109185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311" name="Rechteck 310">
                  <a:extLst>
                    <a:ext uri="{FF2B5EF4-FFF2-40B4-BE49-F238E27FC236}">
                      <a16:creationId xmlns:a16="http://schemas.microsoft.com/office/drawing/2014/main" id="{D5D35598-8D90-921B-437B-86FD42DFDD17}"/>
                    </a:ext>
                  </a:extLst>
                </p:cNvPr>
                <p:cNvSpPr/>
                <p:nvPr/>
              </p:nvSpPr>
              <p:spPr>
                <a:xfrm>
                  <a:off x="7939790" y="2214222"/>
                  <a:ext cx="394708" cy="49226"/>
                </a:xfrm>
                <a:prstGeom prst="rect">
                  <a:avLst/>
                </a:prstGeom>
                <a:solidFill>
                  <a:srgbClr val="CAD48C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12" name="Rechteck 311">
                  <a:extLst>
                    <a:ext uri="{FF2B5EF4-FFF2-40B4-BE49-F238E27FC236}">
                      <a16:creationId xmlns:a16="http://schemas.microsoft.com/office/drawing/2014/main" id="{2A3688C7-E7C8-3791-95FE-6836868A9976}"/>
                    </a:ext>
                  </a:extLst>
                </p:cNvPr>
                <p:cNvSpPr/>
                <p:nvPr/>
              </p:nvSpPr>
              <p:spPr>
                <a:xfrm>
                  <a:off x="7943064" y="2372512"/>
                  <a:ext cx="394708" cy="49226"/>
                </a:xfrm>
                <a:prstGeom prst="rect">
                  <a:avLst/>
                </a:prstGeom>
                <a:solidFill>
                  <a:srgbClr val="CAD48C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cxnSp>
              <p:nvCxnSpPr>
                <p:cNvPr id="313" name="Gerade Verbindung 599">
                  <a:extLst>
                    <a:ext uri="{FF2B5EF4-FFF2-40B4-BE49-F238E27FC236}">
                      <a16:creationId xmlns:a16="http://schemas.microsoft.com/office/drawing/2014/main" id="{3E15FC34-BFF5-64AC-3F58-C23305B205EE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7284822" y="2270528"/>
                  <a:ext cx="1047084" cy="25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4" name="AutoShape 24" descr="20%">
                  <a:extLst>
                    <a:ext uri="{FF2B5EF4-FFF2-40B4-BE49-F238E27FC236}">
                      <a16:creationId xmlns:a16="http://schemas.microsoft.com/office/drawing/2014/main" id="{880B4D29-BAC5-A237-6B0C-6ACD7D6EAD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7011699" y="2468127"/>
                  <a:ext cx="1325643" cy="97257"/>
                </a:xfrm>
                <a:prstGeom prst="rtTriangle">
                  <a:avLst/>
                </a:prstGeom>
                <a:solidFill>
                  <a:srgbClr val="843C0C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315" name="Rectangle 9" descr="70%">
                  <a:extLst>
                    <a:ext uri="{FF2B5EF4-FFF2-40B4-BE49-F238E27FC236}">
                      <a16:creationId xmlns:a16="http://schemas.microsoft.com/office/drawing/2014/main" id="{DE17AFCA-95AF-121D-B0DC-DC32DD7B36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 flipV="1">
                  <a:off x="7752846" y="2424807"/>
                  <a:ext cx="584477" cy="54574"/>
                </a:xfrm>
                <a:prstGeom prst="rect">
                  <a:avLst/>
                </a:prstGeom>
                <a:solidFill>
                  <a:srgbClr val="FFE699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</p:grpSp>
          <p:cxnSp>
            <p:nvCxnSpPr>
              <p:cNvPr id="416" name="Gerade Verbindung mit Pfeil 415">
                <a:extLst>
                  <a:ext uri="{FF2B5EF4-FFF2-40B4-BE49-F238E27FC236}">
                    <a16:creationId xmlns:a16="http://schemas.microsoft.com/office/drawing/2014/main" id="{FB38CDBA-F48C-48FD-4E34-6509AA0A2C93}"/>
                  </a:ext>
                </a:extLst>
              </p:cNvPr>
              <p:cNvCxnSpPr/>
              <p:nvPr/>
            </p:nvCxnSpPr>
            <p:spPr>
              <a:xfrm>
                <a:off x="7084842" y="2779065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7" name="Textfeld 44">
                <a:extLst>
                  <a:ext uri="{FF2B5EF4-FFF2-40B4-BE49-F238E27FC236}">
                    <a16:creationId xmlns:a16="http://schemas.microsoft.com/office/drawing/2014/main" id="{67B7CFA9-B56B-2E34-8078-D646DD3AD6A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48842" y="2564905"/>
                <a:ext cx="793020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/>
                <a:r>
                  <a:rPr lang="de-DE" sz="1100" i="1" dirty="0" err="1">
                    <a:latin typeface="Calibri" pitchFamily="34" charset="0"/>
                  </a:rPr>
                  <a:t>sampled</a:t>
                </a:r>
                <a:r>
                  <a:rPr lang="de-DE" sz="1100" i="1" dirty="0">
                    <a:latin typeface="Calibri" pitchFamily="34" charset="0"/>
                  </a:rPr>
                  <a:t> </a:t>
                </a:r>
                <a:r>
                  <a:rPr lang="de-DE" sz="1100" i="1" dirty="0" err="1">
                    <a:latin typeface="Calibri" pitchFamily="34" charset="0"/>
                  </a:rPr>
                  <a:t>section</a:t>
                </a:r>
                <a:endParaRPr lang="de-DE" sz="1100" i="1" dirty="0">
                  <a:latin typeface="Calibri" pitchFamily="34" charset="0"/>
                </a:endParaRPr>
              </a:p>
            </p:txBody>
          </p:sp>
          <p:sp>
            <p:nvSpPr>
              <p:cNvPr id="3" name="Rechteck 2">
                <a:extLst>
                  <a:ext uri="{FF2B5EF4-FFF2-40B4-BE49-F238E27FC236}">
                    <a16:creationId xmlns:a16="http://schemas.microsoft.com/office/drawing/2014/main" id="{9F2CE545-A7A4-4CDE-599E-5F81ABAC9F7C}"/>
                  </a:ext>
                </a:extLst>
              </p:cNvPr>
              <p:cNvSpPr/>
              <p:nvPr/>
            </p:nvSpPr>
            <p:spPr>
              <a:xfrm>
                <a:off x="7353374" y="2589102"/>
                <a:ext cx="1074347" cy="360081"/>
              </a:xfrm>
              <a:prstGeom prst="rect">
                <a:avLst/>
              </a:prstGeom>
              <a:solidFill>
                <a:schemeClr val="bg1">
                  <a:lumMod val="75000"/>
                  <a:alpha val="72000"/>
                </a:schemeClr>
              </a:solidFill>
              <a:ln w="6350"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</p:grpSp>
        <p:grpSp>
          <p:nvGrpSpPr>
            <p:cNvPr id="20" name="Gruppieren 19">
              <a:extLst>
                <a:ext uri="{FF2B5EF4-FFF2-40B4-BE49-F238E27FC236}">
                  <a16:creationId xmlns:a16="http://schemas.microsoft.com/office/drawing/2014/main" id="{C9B12F8B-F17D-2E5D-37C3-7D8C605E26DF}"/>
                </a:ext>
              </a:extLst>
            </p:cNvPr>
            <p:cNvGrpSpPr/>
            <p:nvPr/>
          </p:nvGrpSpPr>
          <p:grpSpPr>
            <a:xfrm>
              <a:off x="3939873" y="4324578"/>
              <a:ext cx="1893185" cy="1879561"/>
              <a:chOff x="4640879" y="3931333"/>
              <a:chExt cx="1951737" cy="1937692"/>
            </a:xfrm>
          </p:grpSpPr>
          <p:cxnSp>
            <p:nvCxnSpPr>
              <p:cNvPr id="21" name="Gerader Verbinder 20">
                <a:extLst>
                  <a:ext uri="{FF2B5EF4-FFF2-40B4-BE49-F238E27FC236}">
                    <a16:creationId xmlns:a16="http://schemas.microsoft.com/office/drawing/2014/main" id="{C78D0C71-DD21-21BC-4AC5-4E6CE28246C5}"/>
                  </a:ext>
                </a:extLst>
              </p:cNvPr>
              <p:cNvCxnSpPr/>
              <p:nvPr/>
            </p:nvCxnSpPr>
            <p:spPr>
              <a:xfrm rot="5400000">
                <a:off x="5415917" y="4845174"/>
                <a:ext cx="12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feld 21">
                <a:extLst>
                  <a:ext uri="{FF2B5EF4-FFF2-40B4-BE49-F238E27FC236}">
                    <a16:creationId xmlns:a16="http://schemas.microsoft.com/office/drawing/2014/main" id="{F5CE202D-A1AD-9F78-E78C-7666445B3D3A}"/>
                  </a:ext>
                </a:extLst>
              </p:cNvPr>
              <p:cNvSpPr txBox="1"/>
              <p:nvPr/>
            </p:nvSpPr>
            <p:spPr>
              <a:xfrm>
                <a:off x="4700243" y="5622804"/>
                <a:ext cx="9252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Conglomerate</a:t>
                </a:r>
                <a:endParaRPr lang="de-DE" sz="1000" dirty="0"/>
              </a:p>
            </p:txBody>
          </p:sp>
          <p:sp>
            <p:nvSpPr>
              <p:cNvPr id="49" name="Textfeld 48">
                <a:extLst>
                  <a:ext uri="{FF2B5EF4-FFF2-40B4-BE49-F238E27FC236}">
                    <a16:creationId xmlns:a16="http://schemas.microsoft.com/office/drawing/2014/main" id="{82F328C8-00C2-3499-450E-FB83AD7E483F}"/>
                  </a:ext>
                </a:extLst>
              </p:cNvPr>
              <p:cNvSpPr txBox="1"/>
              <p:nvPr/>
            </p:nvSpPr>
            <p:spPr>
              <a:xfrm>
                <a:off x="4795404" y="5442236"/>
                <a:ext cx="6078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Gravelly</a:t>
                </a:r>
                <a:endParaRPr lang="de-DE" sz="1000" dirty="0"/>
              </a:p>
            </p:txBody>
          </p:sp>
          <p:sp>
            <p:nvSpPr>
              <p:cNvPr id="106" name="Textfeld 105">
                <a:extLst>
                  <a:ext uri="{FF2B5EF4-FFF2-40B4-BE49-F238E27FC236}">
                    <a16:creationId xmlns:a16="http://schemas.microsoft.com/office/drawing/2014/main" id="{DDFF92CE-2A05-9083-2146-072824E07CE6}"/>
                  </a:ext>
                </a:extLst>
              </p:cNvPr>
              <p:cNvSpPr txBox="1"/>
              <p:nvPr/>
            </p:nvSpPr>
            <p:spPr>
              <a:xfrm>
                <a:off x="4724235" y="5212458"/>
                <a:ext cx="57900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Coarse</a:t>
                </a:r>
                <a:r>
                  <a:rPr lang="de-DE" sz="1000" dirty="0"/>
                  <a:t>-</a:t>
                </a:r>
              </a:p>
            </p:txBody>
          </p:sp>
          <p:sp>
            <p:nvSpPr>
              <p:cNvPr id="109" name="Textfeld 108">
                <a:extLst>
                  <a:ext uri="{FF2B5EF4-FFF2-40B4-BE49-F238E27FC236}">
                    <a16:creationId xmlns:a16="http://schemas.microsoft.com/office/drawing/2014/main" id="{75C42DDB-830F-AF20-A609-C6682A03F2BB}"/>
                  </a:ext>
                </a:extLst>
              </p:cNvPr>
              <p:cNvSpPr txBox="1"/>
              <p:nvPr/>
            </p:nvSpPr>
            <p:spPr>
              <a:xfrm>
                <a:off x="4640879" y="4960248"/>
                <a:ext cx="6623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/>
                  <a:t>Medium-</a:t>
                </a:r>
                <a:endParaRPr lang="de-DE" sz="800" dirty="0"/>
              </a:p>
            </p:txBody>
          </p:sp>
          <p:sp>
            <p:nvSpPr>
              <p:cNvPr id="110" name="Textfeld 109">
                <a:extLst>
                  <a:ext uri="{FF2B5EF4-FFF2-40B4-BE49-F238E27FC236}">
                    <a16:creationId xmlns:a16="http://schemas.microsoft.com/office/drawing/2014/main" id="{E24A62CD-6444-D936-679D-75AD1929DDBE}"/>
                  </a:ext>
                </a:extLst>
              </p:cNvPr>
              <p:cNvSpPr txBox="1"/>
              <p:nvPr/>
            </p:nvSpPr>
            <p:spPr>
              <a:xfrm>
                <a:off x="4860491" y="4738375"/>
                <a:ext cx="4427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/>
                  <a:t>Fine-</a:t>
                </a:r>
              </a:p>
            </p:txBody>
          </p:sp>
          <p:sp>
            <p:nvSpPr>
              <p:cNvPr id="111" name="Textfeld 110">
                <a:extLst>
                  <a:ext uri="{FF2B5EF4-FFF2-40B4-BE49-F238E27FC236}">
                    <a16:creationId xmlns:a16="http://schemas.microsoft.com/office/drawing/2014/main" id="{A7BD33A0-92CF-CC3C-18B7-EA5AD2539446}"/>
                  </a:ext>
                </a:extLst>
              </p:cNvPr>
              <p:cNvSpPr txBox="1"/>
              <p:nvPr/>
            </p:nvSpPr>
            <p:spPr>
              <a:xfrm>
                <a:off x="4988783" y="4527546"/>
                <a:ext cx="63671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Siltstone</a:t>
                </a:r>
                <a:endParaRPr lang="de-DE" sz="1000" dirty="0"/>
              </a:p>
            </p:txBody>
          </p:sp>
          <p:sp>
            <p:nvSpPr>
              <p:cNvPr id="112" name="Textfeld 111">
                <a:extLst>
                  <a:ext uri="{FF2B5EF4-FFF2-40B4-BE49-F238E27FC236}">
                    <a16:creationId xmlns:a16="http://schemas.microsoft.com/office/drawing/2014/main" id="{549C7DC8-92A9-3F2B-6CDF-41959F62BB7F}"/>
                  </a:ext>
                </a:extLst>
              </p:cNvPr>
              <p:cNvSpPr txBox="1"/>
              <p:nvPr/>
            </p:nvSpPr>
            <p:spPr>
              <a:xfrm>
                <a:off x="5930947" y="4422851"/>
                <a:ext cx="661669" cy="4124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/>
                  <a:t>Air-fall Tuff</a:t>
                </a:r>
              </a:p>
            </p:txBody>
          </p:sp>
          <p:sp>
            <p:nvSpPr>
              <p:cNvPr id="113" name="Textfeld 112">
                <a:extLst>
                  <a:ext uri="{FF2B5EF4-FFF2-40B4-BE49-F238E27FC236}">
                    <a16:creationId xmlns:a16="http://schemas.microsoft.com/office/drawing/2014/main" id="{B5330C4F-C92B-7697-B476-05B846E9E9F1}"/>
                  </a:ext>
                </a:extLst>
              </p:cNvPr>
              <p:cNvSpPr txBox="1"/>
              <p:nvPr/>
            </p:nvSpPr>
            <p:spPr>
              <a:xfrm>
                <a:off x="5933671" y="3931333"/>
                <a:ext cx="61233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/>
                  <a:t>BIF, </a:t>
                </a:r>
                <a:r>
                  <a:rPr lang="de-DE" sz="1000" dirty="0" err="1"/>
                  <a:t>Jaspilite</a:t>
                </a:r>
                <a:endParaRPr lang="de-DE" sz="1000" dirty="0"/>
              </a:p>
            </p:txBody>
          </p:sp>
          <p:sp>
            <p:nvSpPr>
              <p:cNvPr id="114" name="Textfeld 113">
                <a:extLst>
                  <a:ext uri="{FF2B5EF4-FFF2-40B4-BE49-F238E27FC236}">
                    <a16:creationId xmlns:a16="http://schemas.microsoft.com/office/drawing/2014/main" id="{695CCAD6-1609-F7AA-01EB-3EF4AD2A709C}"/>
                  </a:ext>
                </a:extLst>
              </p:cNvPr>
              <p:cNvSpPr txBox="1"/>
              <p:nvPr/>
            </p:nvSpPr>
            <p:spPr>
              <a:xfrm>
                <a:off x="4780393" y="4099845"/>
                <a:ext cx="8451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Basaltic</a:t>
                </a:r>
                <a:r>
                  <a:rPr lang="de-DE" sz="1000" dirty="0"/>
                  <a:t> Lava</a:t>
                </a:r>
              </a:p>
            </p:txBody>
          </p:sp>
          <p:sp>
            <p:nvSpPr>
              <p:cNvPr id="115" name="Textfeld 114">
                <a:extLst>
                  <a:ext uri="{FF2B5EF4-FFF2-40B4-BE49-F238E27FC236}">
                    <a16:creationId xmlns:a16="http://schemas.microsoft.com/office/drawing/2014/main" id="{EB26CC53-F4A4-F715-4A79-A10B26D12869}"/>
                  </a:ext>
                </a:extLst>
              </p:cNvPr>
              <p:cNvSpPr txBox="1"/>
              <p:nvPr/>
            </p:nvSpPr>
            <p:spPr>
              <a:xfrm rot="5400000">
                <a:off x="5078059" y="5001111"/>
                <a:ext cx="73128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/>
                  <a:t>-</a:t>
                </a:r>
                <a:r>
                  <a:rPr lang="de-DE" sz="1000" dirty="0" err="1"/>
                  <a:t>grained</a:t>
                </a:r>
                <a:endParaRPr lang="de-DE" sz="1000" dirty="0"/>
              </a:p>
              <a:p>
                <a:pPr algn="ctr"/>
                <a:r>
                  <a:rPr lang="de-DE" sz="1000" dirty="0" err="1"/>
                  <a:t>Sandstone</a:t>
                </a:r>
                <a:endParaRPr lang="de-DE" sz="1000" dirty="0"/>
              </a:p>
            </p:txBody>
          </p:sp>
          <p:sp>
            <p:nvSpPr>
              <p:cNvPr id="116" name="Textfeld 115">
                <a:extLst>
                  <a:ext uri="{FF2B5EF4-FFF2-40B4-BE49-F238E27FC236}">
                    <a16:creationId xmlns:a16="http://schemas.microsoft.com/office/drawing/2014/main" id="{FA616D31-1E81-1434-90C9-D57B6243904A}"/>
                  </a:ext>
                </a:extLst>
              </p:cNvPr>
              <p:cNvSpPr txBox="1"/>
              <p:nvPr/>
            </p:nvSpPr>
            <p:spPr>
              <a:xfrm>
                <a:off x="5160304" y="4289906"/>
                <a:ext cx="4651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dirty="0" err="1"/>
                  <a:t>Shale</a:t>
                </a:r>
                <a:endParaRPr lang="de-DE" sz="1000" dirty="0"/>
              </a:p>
            </p:txBody>
          </p:sp>
          <p:sp>
            <p:nvSpPr>
              <p:cNvPr id="117" name="Rechteck 116">
                <a:extLst>
                  <a:ext uri="{FF2B5EF4-FFF2-40B4-BE49-F238E27FC236}">
                    <a16:creationId xmlns:a16="http://schemas.microsoft.com/office/drawing/2014/main" id="{5908A0A1-07DB-8E95-9DAE-3A40135825A3}"/>
                  </a:ext>
                </a:extLst>
              </p:cNvPr>
              <p:cNvSpPr/>
              <p:nvPr/>
            </p:nvSpPr>
            <p:spPr>
              <a:xfrm>
                <a:off x="5627017" y="5224655"/>
                <a:ext cx="239364" cy="253535"/>
              </a:xfrm>
              <a:prstGeom prst="rect">
                <a:avLst/>
              </a:prstGeom>
              <a:solidFill>
                <a:srgbClr val="F4B18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18" name="Rechteck 117">
                <a:extLst>
                  <a:ext uri="{FF2B5EF4-FFF2-40B4-BE49-F238E27FC236}">
                    <a16:creationId xmlns:a16="http://schemas.microsoft.com/office/drawing/2014/main" id="{9D53ED9B-0174-FF53-64A5-56139AC7993C}"/>
                  </a:ext>
                </a:extLst>
              </p:cNvPr>
              <p:cNvSpPr/>
              <p:nvPr/>
            </p:nvSpPr>
            <p:spPr>
              <a:xfrm>
                <a:off x="5627017" y="4982961"/>
                <a:ext cx="211019" cy="233023"/>
              </a:xfrm>
              <a:prstGeom prst="rect">
                <a:avLst/>
              </a:prstGeom>
              <a:solidFill>
                <a:srgbClr val="FFD966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20" name="Rechteck 119">
                <a:extLst>
                  <a:ext uri="{FF2B5EF4-FFF2-40B4-BE49-F238E27FC236}">
                    <a16:creationId xmlns:a16="http://schemas.microsoft.com/office/drawing/2014/main" id="{7E686442-FFBB-6051-1A0E-43204F3CB70E}"/>
                  </a:ext>
                </a:extLst>
              </p:cNvPr>
              <p:cNvSpPr/>
              <p:nvPr/>
            </p:nvSpPr>
            <p:spPr>
              <a:xfrm>
                <a:off x="5627017" y="4755142"/>
                <a:ext cx="182671" cy="216763"/>
              </a:xfrm>
              <a:prstGeom prst="rect">
                <a:avLst/>
              </a:prstGeom>
              <a:solidFill>
                <a:srgbClr val="FFE699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22" name="Rechteck 121">
                <a:extLst>
                  <a:ext uri="{FF2B5EF4-FFF2-40B4-BE49-F238E27FC236}">
                    <a16:creationId xmlns:a16="http://schemas.microsoft.com/office/drawing/2014/main" id="{01EC6080-4BA2-2DCB-5443-46A6CA73F0D7}"/>
                  </a:ext>
                </a:extLst>
              </p:cNvPr>
              <p:cNvSpPr/>
              <p:nvPr/>
            </p:nvSpPr>
            <p:spPr>
              <a:xfrm>
                <a:off x="5627017" y="4566553"/>
                <a:ext cx="157474" cy="179917"/>
              </a:xfrm>
              <a:prstGeom prst="rect">
                <a:avLst/>
              </a:prstGeom>
              <a:solidFill>
                <a:srgbClr val="CAD48C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23" name="Rechteck 122">
                <a:extLst>
                  <a:ext uri="{FF2B5EF4-FFF2-40B4-BE49-F238E27FC236}">
                    <a16:creationId xmlns:a16="http://schemas.microsoft.com/office/drawing/2014/main" id="{EDD724B2-CC1D-A90E-6F2E-38F6D812A311}"/>
                  </a:ext>
                </a:extLst>
              </p:cNvPr>
              <p:cNvSpPr/>
              <p:nvPr/>
            </p:nvSpPr>
            <p:spPr>
              <a:xfrm>
                <a:off x="5627017" y="4315162"/>
                <a:ext cx="125980" cy="229289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124" name="Gerader Verbinder 123">
                <a:extLst>
                  <a:ext uri="{FF2B5EF4-FFF2-40B4-BE49-F238E27FC236}">
                    <a16:creationId xmlns:a16="http://schemas.microsoft.com/office/drawing/2014/main" id="{8E65EDE0-98BC-167A-F1C3-D2CE1C42553E}"/>
                  </a:ext>
                </a:extLst>
              </p:cNvPr>
              <p:cNvCxnSpPr/>
              <p:nvPr/>
            </p:nvCxnSpPr>
            <p:spPr>
              <a:xfrm>
                <a:off x="5627016" y="4171642"/>
                <a:ext cx="360000" cy="2088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Rechteck 126">
                <a:extLst>
                  <a:ext uri="{FF2B5EF4-FFF2-40B4-BE49-F238E27FC236}">
                    <a16:creationId xmlns:a16="http://schemas.microsoft.com/office/drawing/2014/main" id="{F556E973-5671-22CF-F325-6BB934CDDBED}"/>
                  </a:ext>
                </a:extLst>
              </p:cNvPr>
              <p:cNvSpPr/>
              <p:nvPr/>
            </p:nvSpPr>
            <p:spPr>
              <a:xfrm>
                <a:off x="5627017" y="4179784"/>
                <a:ext cx="188970" cy="124329"/>
              </a:xfrm>
              <a:prstGeom prst="rect">
                <a:avLst/>
              </a:prstGeom>
              <a:solidFill>
                <a:srgbClr val="548235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28" name="Rechteck 127">
                <a:extLst>
                  <a:ext uri="{FF2B5EF4-FFF2-40B4-BE49-F238E27FC236}">
                    <a16:creationId xmlns:a16="http://schemas.microsoft.com/office/drawing/2014/main" id="{2CF8FD61-0BC3-7EE7-FCC3-AB29674FB771}"/>
                  </a:ext>
                </a:extLst>
              </p:cNvPr>
              <p:cNvSpPr/>
              <p:nvPr/>
            </p:nvSpPr>
            <p:spPr>
              <a:xfrm>
                <a:off x="5627017" y="5489348"/>
                <a:ext cx="261411" cy="173928"/>
              </a:xfrm>
              <a:prstGeom prst="rect">
                <a:avLst/>
              </a:prstGeom>
              <a:solidFill>
                <a:srgbClr val="C55A1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129" name="Gerader Verbinder 128">
                <a:extLst>
                  <a:ext uri="{FF2B5EF4-FFF2-40B4-BE49-F238E27FC236}">
                    <a16:creationId xmlns:a16="http://schemas.microsoft.com/office/drawing/2014/main" id="{D1C9AAD3-26D4-3CF3-EB2F-3F35AFE49E8B}"/>
                  </a:ext>
                </a:extLst>
              </p:cNvPr>
              <p:cNvCxnSpPr/>
              <p:nvPr/>
            </p:nvCxnSpPr>
            <p:spPr>
              <a:xfrm>
                <a:off x="5624255" y="4556474"/>
                <a:ext cx="360000" cy="1787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0" name="Gruppieren 129">
                <a:extLst>
                  <a:ext uri="{FF2B5EF4-FFF2-40B4-BE49-F238E27FC236}">
                    <a16:creationId xmlns:a16="http://schemas.microsoft.com/office/drawing/2014/main" id="{C60E4B4A-3FF9-1DB8-F568-F6A9B1AB8C5B}"/>
                  </a:ext>
                </a:extLst>
              </p:cNvPr>
              <p:cNvGrpSpPr/>
              <p:nvPr/>
            </p:nvGrpSpPr>
            <p:grpSpPr>
              <a:xfrm>
                <a:off x="5627611" y="5673662"/>
                <a:ext cx="374039" cy="158417"/>
                <a:chOff x="4763961" y="6415088"/>
                <a:chExt cx="282798" cy="130968"/>
              </a:xfrm>
            </p:grpSpPr>
            <p:sp>
              <p:nvSpPr>
                <p:cNvPr id="134" name="Freihandform 858">
                  <a:extLst>
                    <a:ext uri="{FF2B5EF4-FFF2-40B4-BE49-F238E27FC236}">
                      <a16:creationId xmlns:a16="http://schemas.microsoft.com/office/drawing/2014/main" id="{64380CA2-27E7-8D0B-5D5F-C44ECDC79D36}"/>
                    </a:ext>
                  </a:extLst>
                </p:cNvPr>
                <p:cNvSpPr/>
                <p:nvPr/>
              </p:nvSpPr>
              <p:spPr>
                <a:xfrm>
                  <a:off x="4763961" y="6415088"/>
                  <a:ext cx="282798" cy="130968"/>
                </a:xfrm>
                <a:custGeom>
                  <a:avLst/>
                  <a:gdLst>
                    <a:gd name="connsiteX0" fmla="*/ 0 w 280988"/>
                    <a:gd name="connsiteY0" fmla="*/ 0 h 130968"/>
                    <a:gd name="connsiteX1" fmla="*/ 280988 w 280988"/>
                    <a:gd name="connsiteY1" fmla="*/ 0 h 130968"/>
                    <a:gd name="connsiteX2" fmla="*/ 271463 w 280988"/>
                    <a:gd name="connsiteY2" fmla="*/ 61912 h 130968"/>
                    <a:gd name="connsiteX3" fmla="*/ 278606 w 280988"/>
                    <a:gd name="connsiteY3" fmla="*/ 104775 h 130968"/>
                    <a:gd name="connsiteX4" fmla="*/ 204788 w 280988"/>
                    <a:gd name="connsiteY4" fmla="*/ 130968 h 130968"/>
                    <a:gd name="connsiteX5" fmla="*/ 133350 w 280988"/>
                    <a:gd name="connsiteY5" fmla="*/ 121443 h 130968"/>
                    <a:gd name="connsiteX6" fmla="*/ 61913 w 280988"/>
                    <a:gd name="connsiteY6" fmla="*/ 123825 h 130968"/>
                    <a:gd name="connsiteX7" fmla="*/ 2381 w 280988"/>
                    <a:gd name="connsiteY7" fmla="*/ 116681 h 130968"/>
                    <a:gd name="connsiteX8" fmla="*/ 0 w 280988"/>
                    <a:gd name="connsiteY8" fmla="*/ 0 h 130968"/>
                    <a:gd name="connsiteX0" fmla="*/ 0 w 298965"/>
                    <a:gd name="connsiteY0" fmla="*/ 0 h 130968"/>
                    <a:gd name="connsiteX1" fmla="*/ 280988 w 298965"/>
                    <a:gd name="connsiteY1" fmla="*/ 0 h 130968"/>
                    <a:gd name="connsiteX2" fmla="*/ 271463 w 298965"/>
                    <a:gd name="connsiteY2" fmla="*/ 61912 h 130968"/>
                    <a:gd name="connsiteX3" fmla="*/ 278606 w 298965"/>
                    <a:gd name="connsiteY3" fmla="*/ 104775 h 130968"/>
                    <a:gd name="connsiteX4" fmla="*/ 204788 w 298965"/>
                    <a:gd name="connsiteY4" fmla="*/ 130968 h 130968"/>
                    <a:gd name="connsiteX5" fmla="*/ 133350 w 298965"/>
                    <a:gd name="connsiteY5" fmla="*/ 121443 h 130968"/>
                    <a:gd name="connsiteX6" fmla="*/ 61913 w 298965"/>
                    <a:gd name="connsiteY6" fmla="*/ 123825 h 130968"/>
                    <a:gd name="connsiteX7" fmla="*/ 2381 w 298965"/>
                    <a:gd name="connsiteY7" fmla="*/ 116681 h 130968"/>
                    <a:gd name="connsiteX8" fmla="*/ 0 w 298965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3794"/>
                    <a:gd name="connsiteY0" fmla="*/ 0 h 130968"/>
                    <a:gd name="connsiteX1" fmla="*/ 280988 w 283794"/>
                    <a:gd name="connsiteY1" fmla="*/ 0 h 130968"/>
                    <a:gd name="connsiteX2" fmla="*/ 271463 w 283794"/>
                    <a:gd name="connsiteY2" fmla="*/ 61912 h 130968"/>
                    <a:gd name="connsiteX3" fmla="*/ 278606 w 283794"/>
                    <a:gd name="connsiteY3" fmla="*/ 104775 h 130968"/>
                    <a:gd name="connsiteX4" fmla="*/ 204788 w 283794"/>
                    <a:gd name="connsiteY4" fmla="*/ 130968 h 130968"/>
                    <a:gd name="connsiteX5" fmla="*/ 133350 w 283794"/>
                    <a:gd name="connsiteY5" fmla="*/ 121443 h 130968"/>
                    <a:gd name="connsiteX6" fmla="*/ 61913 w 283794"/>
                    <a:gd name="connsiteY6" fmla="*/ 123825 h 130968"/>
                    <a:gd name="connsiteX7" fmla="*/ 2381 w 283794"/>
                    <a:gd name="connsiteY7" fmla="*/ 116681 h 130968"/>
                    <a:gd name="connsiteX8" fmla="*/ 0 w 283794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04775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  <a:gd name="connsiteX0" fmla="*/ 0 w 282798"/>
                    <a:gd name="connsiteY0" fmla="*/ 0 h 130968"/>
                    <a:gd name="connsiteX1" fmla="*/ 280988 w 282798"/>
                    <a:gd name="connsiteY1" fmla="*/ 0 h 130968"/>
                    <a:gd name="connsiteX2" fmla="*/ 271463 w 282798"/>
                    <a:gd name="connsiteY2" fmla="*/ 61912 h 130968"/>
                    <a:gd name="connsiteX3" fmla="*/ 278606 w 282798"/>
                    <a:gd name="connsiteY3" fmla="*/ 116681 h 130968"/>
                    <a:gd name="connsiteX4" fmla="*/ 204788 w 282798"/>
                    <a:gd name="connsiteY4" fmla="*/ 130968 h 130968"/>
                    <a:gd name="connsiteX5" fmla="*/ 133350 w 282798"/>
                    <a:gd name="connsiteY5" fmla="*/ 121443 h 130968"/>
                    <a:gd name="connsiteX6" fmla="*/ 61913 w 282798"/>
                    <a:gd name="connsiteY6" fmla="*/ 123825 h 130968"/>
                    <a:gd name="connsiteX7" fmla="*/ 2381 w 282798"/>
                    <a:gd name="connsiteY7" fmla="*/ 116681 h 130968"/>
                    <a:gd name="connsiteX8" fmla="*/ 0 w 282798"/>
                    <a:gd name="connsiteY8" fmla="*/ 0 h 13096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282798" h="130968">
                      <a:moveTo>
                        <a:pt x="0" y="0"/>
                      </a:moveTo>
                      <a:lnTo>
                        <a:pt x="280988" y="0"/>
                      </a:lnTo>
                      <a:cubicBezTo>
                        <a:pt x="288132" y="24606"/>
                        <a:pt x="271860" y="42465"/>
                        <a:pt x="271463" y="61912"/>
                      </a:cubicBezTo>
                      <a:cubicBezTo>
                        <a:pt x="271066" y="81359"/>
                        <a:pt x="281778" y="104188"/>
                        <a:pt x="278606" y="116681"/>
                      </a:cubicBezTo>
                      <a:cubicBezTo>
                        <a:pt x="242933" y="124908"/>
                        <a:pt x="229394" y="122237"/>
                        <a:pt x="204788" y="130968"/>
                      </a:cubicBezTo>
                      <a:lnTo>
                        <a:pt x="133350" y="121443"/>
                      </a:lnTo>
                      <a:lnTo>
                        <a:pt x="61913" y="123825"/>
                      </a:lnTo>
                      <a:lnTo>
                        <a:pt x="2381" y="116681"/>
                      </a:lnTo>
                      <a:cubicBezTo>
                        <a:pt x="1587" y="77787"/>
                        <a:pt x="794" y="38894"/>
                        <a:pt x="0" y="0"/>
                      </a:cubicBezTo>
                      <a:close/>
                    </a:path>
                  </a:pathLst>
                </a:custGeom>
                <a:solidFill>
                  <a:schemeClr val="accent2">
                    <a:lumMod val="5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135" name="Ellipse 134">
                  <a:extLst>
                    <a:ext uri="{FF2B5EF4-FFF2-40B4-BE49-F238E27FC236}">
                      <a16:creationId xmlns:a16="http://schemas.microsoft.com/office/drawing/2014/main" id="{5829D4AF-E0C0-80F2-1446-EBFA1E8FB269}"/>
                    </a:ext>
                  </a:extLst>
                </p:cNvPr>
                <p:cNvSpPr/>
                <p:nvPr/>
              </p:nvSpPr>
              <p:spPr>
                <a:xfrm>
                  <a:off x="4800600" y="6443187"/>
                  <a:ext cx="64294" cy="45719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136" name="Ellipse 135">
                  <a:extLst>
                    <a:ext uri="{FF2B5EF4-FFF2-40B4-BE49-F238E27FC236}">
                      <a16:creationId xmlns:a16="http://schemas.microsoft.com/office/drawing/2014/main" id="{D5065575-AF7B-5CBE-9A5A-0991B646D7D7}"/>
                    </a:ext>
                  </a:extLst>
                </p:cNvPr>
                <p:cNvSpPr/>
                <p:nvPr/>
              </p:nvSpPr>
              <p:spPr>
                <a:xfrm rot="20361425">
                  <a:off x="4866713" y="6471004"/>
                  <a:ext cx="87016" cy="45719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137" name="Ellipse 136">
                  <a:extLst>
                    <a:ext uri="{FF2B5EF4-FFF2-40B4-BE49-F238E27FC236}">
                      <a16:creationId xmlns:a16="http://schemas.microsoft.com/office/drawing/2014/main" id="{DDED2936-B916-BD13-6121-770C2B3C6352}"/>
                    </a:ext>
                  </a:extLst>
                </p:cNvPr>
                <p:cNvSpPr/>
                <p:nvPr/>
              </p:nvSpPr>
              <p:spPr>
                <a:xfrm rot="20361425">
                  <a:off x="4972644" y="6436936"/>
                  <a:ext cx="45719" cy="45719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</p:grpSp>
          <p:cxnSp>
            <p:nvCxnSpPr>
              <p:cNvPr id="133" name="Gerader Verbinder 132">
                <a:extLst>
                  <a:ext uri="{FF2B5EF4-FFF2-40B4-BE49-F238E27FC236}">
                    <a16:creationId xmlns:a16="http://schemas.microsoft.com/office/drawing/2014/main" id="{9B649F1F-839E-B583-2609-2900A54A1D3F}"/>
                  </a:ext>
                </a:extLst>
              </p:cNvPr>
              <p:cNvCxnSpPr/>
              <p:nvPr/>
            </p:nvCxnSpPr>
            <p:spPr>
              <a:xfrm rot="5400000">
                <a:off x="5415911" y="5566693"/>
                <a:ext cx="12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AF0F30B0-231B-6EC9-B06F-2F8013569DB6}"/>
                </a:ext>
              </a:extLst>
            </p:cNvPr>
            <p:cNvSpPr/>
            <p:nvPr/>
          </p:nvSpPr>
          <p:spPr>
            <a:xfrm>
              <a:off x="2764094" y="2209949"/>
              <a:ext cx="351424" cy="556019"/>
            </a:xfrm>
            <a:prstGeom prst="rect">
              <a:avLst/>
            </a:prstGeom>
            <a:solidFill>
              <a:schemeClr val="bg1">
                <a:lumMod val="75000"/>
                <a:alpha val="72000"/>
              </a:schemeClr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3079365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563E8E-0A48-667D-2837-C2251625E9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CF1EA9C-D5C8-1D32-3E3E-15F23E4D81E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173" y="5984"/>
            <a:ext cx="9100827" cy="643934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7" name="Rechteck 26">
            <a:extLst>
              <a:ext uri="{FF2B5EF4-FFF2-40B4-BE49-F238E27FC236}">
                <a16:creationId xmlns:a16="http://schemas.microsoft.com/office/drawing/2014/main" id="{50C48690-0A0D-15A1-D27D-0FFF745E412E}"/>
              </a:ext>
            </a:extLst>
          </p:cNvPr>
          <p:cNvSpPr/>
          <p:nvPr/>
        </p:nvSpPr>
        <p:spPr>
          <a:xfrm>
            <a:off x="3713545" y="2138117"/>
            <a:ext cx="351424" cy="556019"/>
          </a:xfrm>
          <a:prstGeom prst="rect">
            <a:avLst/>
          </a:prstGeom>
          <a:solidFill>
            <a:schemeClr val="bg1">
              <a:lumMod val="75000"/>
              <a:alpha val="72000"/>
            </a:schemeClr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CB080F8C-4E2D-646F-BD29-ADC650229C19}"/>
              </a:ext>
            </a:extLst>
          </p:cNvPr>
          <p:cNvSpPr txBox="1"/>
          <p:nvPr/>
        </p:nvSpPr>
        <p:spPr>
          <a:xfrm>
            <a:off x="3045600" y="2297860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sp>
        <p:nvSpPr>
          <p:cNvPr id="32" name="AutoShape 3">
            <a:extLst>
              <a:ext uri="{FF2B5EF4-FFF2-40B4-BE49-F238E27FC236}">
                <a16:creationId xmlns:a16="http://schemas.microsoft.com/office/drawing/2014/main" id="{7157A4CE-B905-E374-F03B-A5CF5270E58F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55684" y="82851"/>
            <a:ext cx="7064947" cy="6331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3" name="Freeform 8">
            <a:extLst>
              <a:ext uri="{FF2B5EF4-FFF2-40B4-BE49-F238E27FC236}">
                <a16:creationId xmlns:a16="http://schemas.microsoft.com/office/drawing/2014/main" id="{9AE4E412-E3B1-C775-DB86-6ECEA6816CF3}"/>
              </a:ext>
            </a:extLst>
          </p:cNvPr>
          <p:cNvSpPr>
            <a:spLocks noEditPoints="1"/>
          </p:cNvSpPr>
          <p:nvPr/>
        </p:nvSpPr>
        <p:spPr bwMode="auto">
          <a:xfrm>
            <a:off x="532254" y="92090"/>
            <a:ext cx="6575267" cy="1738519"/>
          </a:xfrm>
          <a:custGeom>
            <a:avLst/>
            <a:gdLst>
              <a:gd name="T0" fmla="*/ 716 w 1502"/>
              <a:gd name="T1" fmla="*/ 349 h 397"/>
              <a:gd name="T2" fmla="*/ 580 w 1502"/>
              <a:gd name="T3" fmla="*/ 390 h 397"/>
              <a:gd name="T4" fmla="*/ 371 w 1502"/>
              <a:gd name="T5" fmla="*/ 324 h 397"/>
              <a:gd name="T6" fmla="*/ 231 w 1502"/>
              <a:gd name="T7" fmla="*/ 294 h 397"/>
              <a:gd name="T8" fmla="*/ 185 w 1502"/>
              <a:gd name="T9" fmla="*/ 279 h 397"/>
              <a:gd name="T10" fmla="*/ 121 w 1502"/>
              <a:gd name="T11" fmla="*/ 285 h 397"/>
              <a:gd name="T12" fmla="*/ 109 w 1502"/>
              <a:gd name="T13" fmla="*/ 269 h 397"/>
              <a:gd name="T14" fmla="*/ 71 w 1502"/>
              <a:gd name="T15" fmla="*/ 245 h 397"/>
              <a:gd name="T16" fmla="*/ 37 w 1502"/>
              <a:gd name="T17" fmla="*/ 295 h 397"/>
              <a:gd name="T18" fmla="*/ 32 w 1502"/>
              <a:gd name="T19" fmla="*/ 212 h 397"/>
              <a:gd name="T20" fmla="*/ 15 w 1502"/>
              <a:gd name="T21" fmla="*/ 182 h 397"/>
              <a:gd name="T22" fmla="*/ 48 w 1502"/>
              <a:gd name="T23" fmla="*/ 160 h 397"/>
              <a:gd name="T24" fmla="*/ 114 w 1502"/>
              <a:gd name="T25" fmla="*/ 172 h 397"/>
              <a:gd name="T26" fmla="*/ 159 w 1502"/>
              <a:gd name="T27" fmla="*/ 146 h 397"/>
              <a:gd name="T28" fmla="*/ 116 w 1502"/>
              <a:gd name="T29" fmla="*/ 65 h 397"/>
              <a:gd name="T30" fmla="*/ 75 w 1502"/>
              <a:gd name="T31" fmla="*/ 8 h 397"/>
              <a:gd name="T32" fmla="*/ 1497 w 1502"/>
              <a:gd name="T33" fmla="*/ 14 h 397"/>
              <a:gd name="T34" fmla="*/ 1502 w 1502"/>
              <a:gd name="T35" fmla="*/ 45 h 397"/>
              <a:gd name="T36" fmla="*/ 1445 w 1502"/>
              <a:gd name="T37" fmla="*/ 76 h 397"/>
              <a:gd name="T38" fmla="*/ 1400 w 1502"/>
              <a:gd name="T39" fmla="*/ 190 h 397"/>
              <a:gd name="T40" fmla="*/ 1399 w 1502"/>
              <a:gd name="T41" fmla="*/ 177 h 397"/>
              <a:gd name="T42" fmla="*/ 1335 w 1502"/>
              <a:gd name="T43" fmla="*/ 147 h 397"/>
              <a:gd name="T44" fmla="*/ 1356 w 1502"/>
              <a:gd name="T45" fmla="*/ 139 h 397"/>
              <a:gd name="T46" fmla="*/ 1397 w 1502"/>
              <a:gd name="T47" fmla="*/ 132 h 397"/>
              <a:gd name="T48" fmla="*/ 1380 w 1502"/>
              <a:gd name="T49" fmla="*/ 120 h 397"/>
              <a:gd name="T50" fmla="*/ 1337 w 1502"/>
              <a:gd name="T51" fmla="*/ 139 h 397"/>
              <a:gd name="T52" fmla="*/ 1301 w 1502"/>
              <a:gd name="T53" fmla="*/ 138 h 397"/>
              <a:gd name="T54" fmla="*/ 1268 w 1502"/>
              <a:gd name="T55" fmla="*/ 136 h 397"/>
              <a:gd name="T56" fmla="*/ 1241 w 1502"/>
              <a:gd name="T57" fmla="*/ 132 h 397"/>
              <a:gd name="T58" fmla="*/ 1221 w 1502"/>
              <a:gd name="T59" fmla="*/ 102 h 397"/>
              <a:gd name="T60" fmla="*/ 1211 w 1502"/>
              <a:gd name="T61" fmla="*/ 110 h 397"/>
              <a:gd name="T62" fmla="*/ 1189 w 1502"/>
              <a:gd name="T63" fmla="*/ 145 h 397"/>
              <a:gd name="T64" fmla="*/ 1153 w 1502"/>
              <a:gd name="T65" fmla="*/ 153 h 397"/>
              <a:gd name="T66" fmla="*/ 1130 w 1502"/>
              <a:gd name="T67" fmla="*/ 151 h 397"/>
              <a:gd name="T68" fmla="*/ 1093 w 1502"/>
              <a:gd name="T69" fmla="*/ 185 h 397"/>
              <a:gd name="T70" fmla="*/ 1029 w 1502"/>
              <a:gd name="T71" fmla="*/ 214 h 397"/>
              <a:gd name="T72" fmla="*/ 937 w 1502"/>
              <a:gd name="T73" fmla="*/ 244 h 397"/>
              <a:gd name="T74" fmla="*/ 847 w 1502"/>
              <a:gd name="T75" fmla="*/ 279 h 397"/>
              <a:gd name="T76" fmla="*/ 816 w 1502"/>
              <a:gd name="T77" fmla="*/ 308 h 397"/>
              <a:gd name="T78" fmla="*/ 658 w 1502"/>
              <a:gd name="T79" fmla="*/ 322 h 397"/>
              <a:gd name="T80" fmla="*/ 638 w 1502"/>
              <a:gd name="T81" fmla="*/ 336 h 397"/>
              <a:gd name="T82" fmla="*/ 634 w 1502"/>
              <a:gd name="T83" fmla="*/ 344 h 397"/>
              <a:gd name="T84" fmla="*/ 581 w 1502"/>
              <a:gd name="T85" fmla="*/ 383 h 397"/>
              <a:gd name="T86" fmla="*/ 619 w 1502"/>
              <a:gd name="T87" fmla="*/ 368 h 3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1502" h="397">
                <a:moveTo>
                  <a:pt x="812" y="310"/>
                </a:moveTo>
                <a:cubicBezTo>
                  <a:pt x="811" y="311"/>
                  <a:pt x="794" y="317"/>
                  <a:pt x="772" y="329"/>
                </a:cubicBezTo>
                <a:cubicBezTo>
                  <a:pt x="749" y="341"/>
                  <a:pt x="722" y="348"/>
                  <a:pt x="716" y="349"/>
                </a:cubicBezTo>
                <a:cubicBezTo>
                  <a:pt x="709" y="350"/>
                  <a:pt x="656" y="363"/>
                  <a:pt x="637" y="374"/>
                </a:cubicBezTo>
                <a:cubicBezTo>
                  <a:pt x="623" y="382"/>
                  <a:pt x="623" y="383"/>
                  <a:pt x="606" y="386"/>
                </a:cubicBezTo>
                <a:cubicBezTo>
                  <a:pt x="600" y="387"/>
                  <a:pt x="592" y="388"/>
                  <a:pt x="580" y="390"/>
                </a:cubicBezTo>
                <a:cubicBezTo>
                  <a:pt x="536" y="397"/>
                  <a:pt x="529" y="383"/>
                  <a:pt x="516" y="377"/>
                </a:cubicBezTo>
                <a:cubicBezTo>
                  <a:pt x="503" y="372"/>
                  <a:pt x="478" y="355"/>
                  <a:pt x="460" y="348"/>
                </a:cubicBezTo>
                <a:cubicBezTo>
                  <a:pt x="442" y="341"/>
                  <a:pt x="388" y="327"/>
                  <a:pt x="371" y="324"/>
                </a:cubicBezTo>
                <a:cubicBezTo>
                  <a:pt x="354" y="321"/>
                  <a:pt x="353" y="316"/>
                  <a:pt x="316" y="302"/>
                </a:cubicBezTo>
                <a:cubicBezTo>
                  <a:pt x="278" y="289"/>
                  <a:pt x="242" y="298"/>
                  <a:pt x="242" y="298"/>
                </a:cubicBezTo>
                <a:cubicBezTo>
                  <a:pt x="231" y="294"/>
                  <a:pt x="231" y="294"/>
                  <a:pt x="231" y="294"/>
                </a:cubicBezTo>
                <a:cubicBezTo>
                  <a:pt x="214" y="287"/>
                  <a:pt x="214" y="287"/>
                  <a:pt x="214" y="287"/>
                </a:cubicBezTo>
                <a:cubicBezTo>
                  <a:pt x="198" y="281"/>
                  <a:pt x="198" y="281"/>
                  <a:pt x="198" y="281"/>
                </a:cubicBezTo>
                <a:cubicBezTo>
                  <a:pt x="185" y="279"/>
                  <a:pt x="185" y="279"/>
                  <a:pt x="185" y="279"/>
                </a:cubicBezTo>
                <a:cubicBezTo>
                  <a:pt x="172" y="279"/>
                  <a:pt x="172" y="279"/>
                  <a:pt x="172" y="279"/>
                </a:cubicBezTo>
                <a:cubicBezTo>
                  <a:pt x="162" y="281"/>
                  <a:pt x="162" y="281"/>
                  <a:pt x="162" y="281"/>
                </a:cubicBezTo>
                <a:cubicBezTo>
                  <a:pt x="162" y="281"/>
                  <a:pt x="141" y="286"/>
                  <a:pt x="121" y="285"/>
                </a:cubicBezTo>
                <a:cubicBezTo>
                  <a:pt x="119" y="285"/>
                  <a:pt x="117" y="285"/>
                  <a:pt x="115" y="285"/>
                </a:cubicBezTo>
                <a:cubicBezTo>
                  <a:pt x="115" y="285"/>
                  <a:pt x="115" y="285"/>
                  <a:pt x="115" y="285"/>
                </a:cubicBezTo>
                <a:cubicBezTo>
                  <a:pt x="113" y="285"/>
                  <a:pt x="110" y="284"/>
                  <a:pt x="109" y="269"/>
                </a:cubicBezTo>
                <a:cubicBezTo>
                  <a:pt x="109" y="251"/>
                  <a:pt x="100" y="254"/>
                  <a:pt x="95" y="254"/>
                </a:cubicBezTo>
                <a:cubicBezTo>
                  <a:pt x="90" y="254"/>
                  <a:pt x="91" y="252"/>
                  <a:pt x="88" y="248"/>
                </a:cubicBezTo>
                <a:cubicBezTo>
                  <a:pt x="85" y="244"/>
                  <a:pt x="87" y="236"/>
                  <a:pt x="71" y="245"/>
                </a:cubicBezTo>
                <a:cubicBezTo>
                  <a:pt x="54" y="254"/>
                  <a:pt x="63" y="258"/>
                  <a:pt x="69" y="270"/>
                </a:cubicBezTo>
                <a:cubicBezTo>
                  <a:pt x="74" y="280"/>
                  <a:pt x="62" y="282"/>
                  <a:pt x="68" y="295"/>
                </a:cubicBezTo>
                <a:cubicBezTo>
                  <a:pt x="68" y="295"/>
                  <a:pt x="49" y="296"/>
                  <a:pt x="37" y="295"/>
                </a:cubicBezTo>
                <a:cubicBezTo>
                  <a:pt x="26" y="294"/>
                  <a:pt x="29" y="276"/>
                  <a:pt x="29" y="276"/>
                </a:cubicBezTo>
                <a:cubicBezTo>
                  <a:pt x="29" y="276"/>
                  <a:pt x="35" y="242"/>
                  <a:pt x="37" y="234"/>
                </a:cubicBezTo>
                <a:cubicBezTo>
                  <a:pt x="39" y="226"/>
                  <a:pt x="35" y="216"/>
                  <a:pt x="32" y="212"/>
                </a:cubicBezTo>
                <a:cubicBezTo>
                  <a:pt x="29" y="210"/>
                  <a:pt x="29" y="199"/>
                  <a:pt x="29" y="199"/>
                </a:cubicBezTo>
                <a:cubicBezTo>
                  <a:pt x="30" y="198"/>
                  <a:pt x="32" y="196"/>
                  <a:pt x="34" y="194"/>
                </a:cubicBezTo>
                <a:cubicBezTo>
                  <a:pt x="50" y="178"/>
                  <a:pt x="31" y="184"/>
                  <a:pt x="15" y="182"/>
                </a:cubicBezTo>
                <a:cubicBezTo>
                  <a:pt x="0" y="181"/>
                  <a:pt x="25" y="178"/>
                  <a:pt x="14" y="173"/>
                </a:cubicBezTo>
                <a:cubicBezTo>
                  <a:pt x="3" y="168"/>
                  <a:pt x="16" y="164"/>
                  <a:pt x="16" y="164"/>
                </a:cubicBezTo>
                <a:cubicBezTo>
                  <a:pt x="16" y="164"/>
                  <a:pt x="36" y="161"/>
                  <a:pt x="48" y="160"/>
                </a:cubicBezTo>
                <a:cubicBezTo>
                  <a:pt x="52" y="160"/>
                  <a:pt x="55" y="160"/>
                  <a:pt x="57" y="160"/>
                </a:cubicBezTo>
                <a:cubicBezTo>
                  <a:pt x="62" y="161"/>
                  <a:pt x="72" y="164"/>
                  <a:pt x="81" y="169"/>
                </a:cubicBezTo>
                <a:cubicBezTo>
                  <a:pt x="90" y="174"/>
                  <a:pt x="106" y="172"/>
                  <a:pt x="114" y="172"/>
                </a:cubicBezTo>
                <a:cubicBezTo>
                  <a:pt x="123" y="172"/>
                  <a:pt x="134" y="166"/>
                  <a:pt x="141" y="165"/>
                </a:cubicBezTo>
                <a:cubicBezTo>
                  <a:pt x="148" y="164"/>
                  <a:pt x="132" y="164"/>
                  <a:pt x="157" y="160"/>
                </a:cubicBezTo>
                <a:cubicBezTo>
                  <a:pt x="181" y="158"/>
                  <a:pt x="181" y="148"/>
                  <a:pt x="159" y="146"/>
                </a:cubicBezTo>
                <a:cubicBezTo>
                  <a:pt x="138" y="144"/>
                  <a:pt x="135" y="126"/>
                  <a:pt x="135" y="126"/>
                </a:cubicBezTo>
                <a:cubicBezTo>
                  <a:pt x="135" y="126"/>
                  <a:pt x="135" y="116"/>
                  <a:pt x="131" y="112"/>
                </a:cubicBezTo>
                <a:cubicBezTo>
                  <a:pt x="127" y="108"/>
                  <a:pt x="118" y="74"/>
                  <a:pt x="116" y="65"/>
                </a:cubicBezTo>
                <a:cubicBezTo>
                  <a:pt x="114" y="57"/>
                  <a:pt x="114" y="48"/>
                  <a:pt x="100" y="35"/>
                </a:cubicBezTo>
                <a:cubicBezTo>
                  <a:pt x="98" y="34"/>
                  <a:pt x="95" y="32"/>
                  <a:pt x="92" y="30"/>
                </a:cubicBezTo>
                <a:cubicBezTo>
                  <a:pt x="71" y="14"/>
                  <a:pt x="75" y="8"/>
                  <a:pt x="75" y="8"/>
                </a:cubicBezTo>
                <a:cubicBezTo>
                  <a:pt x="79" y="0"/>
                  <a:pt x="79" y="0"/>
                  <a:pt x="79" y="0"/>
                </a:cubicBezTo>
                <a:cubicBezTo>
                  <a:pt x="1498" y="0"/>
                  <a:pt x="1498" y="0"/>
                  <a:pt x="1498" y="0"/>
                </a:cubicBezTo>
                <a:cubicBezTo>
                  <a:pt x="1497" y="14"/>
                  <a:pt x="1497" y="14"/>
                  <a:pt x="1497" y="14"/>
                </a:cubicBezTo>
                <a:cubicBezTo>
                  <a:pt x="1498" y="23"/>
                  <a:pt x="1498" y="23"/>
                  <a:pt x="1498" y="23"/>
                </a:cubicBezTo>
                <a:cubicBezTo>
                  <a:pt x="1501" y="33"/>
                  <a:pt x="1501" y="33"/>
                  <a:pt x="1501" y="33"/>
                </a:cubicBezTo>
                <a:cubicBezTo>
                  <a:pt x="1502" y="45"/>
                  <a:pt x="1502" y="45"/>
                  <a:pt x="1502" y="45"/>
                </a:cubicBezTo>
                <a:cubicBezTo>
                  <a:pt x="1483" y="54"/>
                  <a:pt x="1483" y="54"/>
                  <a:pt x="1483" y="54"/>
                </a:cubicBezTo>
                <a:cubicBezTo>
                  <a:pt x="1465" y="62"/>
                  <a:pt x="1465" y="62"/>
                  <a:pt x="1465" y="62"/>
                </a:cubicBezTo>
                <a:cubicBezTo>
                  <a:pt x="1465" y="62"/>
                  <a:pt x="1455" y="66"/>
                  <a:pt x="1445" y="76"/>
                </a:cubicBezTo>
                <a:cubicBezTo>
                  <a:pt x="1434" y="86"/>
                  <a:pt x="1421" y="90"/>
                  <a:pt x="1438" y="108"/>
                </a:cubicBezTo>
                <a:cubicBezTo>
                  <a:pt x="1455" y="126"/>
                  <a:pt x="1431" y="158"/>
                  <a:pt x="1429" y="159"/>
                </a:cubicBezTo>
                <a:cubicBezTo>
                  <a:pt x="1428" y="160"/>
                  <a:pt x="1401" y="189"/>
                  <a:pt x="1400" y="190"/>
                </a:cubicBezTo>
                <a:cubicBezTo>
                  <a:pt x="1400" y="191"/>
                  <a:pt x="1397" y="193"/>
                  <a:pt x="1394" y="197"/>
                </a:cubicBezTo>
                <a:cubicBezTo>
                  <a:pt x="1394" y="197"/>
                  <a:pt x="1395" y="194"/>
                  <a:pt x="1395" y="191"/>
                </a:cubicBezTo>
                <a:cubicBezTo>
                  <a:pt x="1396" y="188"/>
                  <a:pt x="1397" y="188"/>
                  <a:pt x="1399" y="177"/>
                </a:cubicBezTo>
                <a:cubicBezTo>
                  <a:pt x="1400" y="166"/>
                  <a:pt x="1392" y="163"/>
                  <a:pt x="1385" y="158"/>
                </a:cubicBezTo>
                <a:cubicBezTo>
                  <a:pt x="1379" y="152"/>
                  <a:pt x="1371" y="152"/>
                  <a:pt x="1353" y="152"/>
                </a:cubicBezTo>
                <a:cubicBezTo>
                  <a:pt x="1335" y="153"/>
                  <a:pt x="1335" y="147"/>
                  <a:pt x="1335" y="147"/>
                </a:cubicBezTo>
                <a:cubicBezTo>
                  <a:pt x="1342" y="145"/>
                  <a:pt x="1342" y="145"/>
                  <a:pt x="1342" y="145"/>
                </a:cubicBezTo>
                <a:cubicBezTo>
                  <a:pt x="1349" y="143"/>
                  <a:pt x="1349" y="143"/>
                  <a:pt x="1349" y="143"/>
                </a:cubicBezTo>
                <a:cubicBezTo>
                  <a:pt x="1356" y="139"/>
                  <a:pt x="1356" y="139"/>
                  <a:pt x="1356" y="139"/>
                </a:cubicBezTo>
                <a:cubicBezTo>
                  <a:pt x="1365" y="135"/>
                  <a:pt x="1365" y="135"/>
                  <a:pt x="1365" y="135"/>
                </a:cubicBezTo>
                <a:cubicBezTo>
                  <a:pt x="1376" y="132"/>
                  <a:pt x="1376" y="132"/>
                  <a:pt x="1376" y="132"/>
                </a:cubicBezTo>
                <a:cubicBezTo>
                  <a:pt x="1376" y="132"/>
                  <a:pt x="1382" y="131"/>
                  <a:pt x="1397" y="132"/>
                </a:cubicBezTo>
                <a:cubicBezTo>
                  <a:pt x="1412" y="134"/>
                  <a:pt x="1402" y="128"/>
                  <a:pt x="1402" y="128"/>
                </a:cubicBezTo>
                <a:cubicBezTo>
                  <a:pt x="1402" y="128"/>
                  <a:pt x="1402" y="128"/>
                  <a:pt x="1394" y="122"/>
                </a:cubicBezTo>
                <a:cubicBezTo>
                  <a:pt x="1386" y="116"/>
                  <a:pt x="1380" y="120"/>
                  <a:pt x="1380" y="120"/>
                </a:cubicBezTo>
                <a:cubicBezTo>
                  <a:pt x="1372" y="124"/>
                  <a:pt x="1372" y="124"/>
                  <a:pt x="1372" y="124"/>
                </a:cubicBezTo>
                <a:cubicBezTo>
                  <a:pt x="1354" y="132"/>
                  <a:pt x="1354" y="132"/>
                  <a:pt x="1354" y="132"/>
                </a:cubicBezTo>
                <a:cubicBezTo>
                  <a:pt x="1337" y="139"/>
                  <a:pt x="1337" y="139"/>
                  <a:pt x="1337" y="139"/>
                </a:cubicBezTo>
                <a:cubicBezTo>
                  <a:pt x="1323" y="140"/>
                  <a:pt x="1323" y="140"/>
                  <a:pt x="1323" y="140"/>
                </a:cubicBezTo>
                <a:cubicBezTo>
                  <a:pt x="1311" y="140"/>
                  <a:pt x="1311" y="140"/>
                  <a:pt x="1311" y="140"/>
                </a:cubicBezTo>
                <a:cubicBezTo>
                  <a:pt x="1301" y="138"/>
                  <a:pt x="1301" y="138"/>
                  <a:pt x="1301" y="138"/>
                </a:cubicBezTo>
                <a:cubicBezTo>
                  <a:pt x="1287" y="133"/>
                  <a:pt x="1287" y="133"/>
                  <a:pt x="1287" y="133"/>
                </a:cubicBezTo>
                <a:cubicBezTo>
                  <a:pt x="1276" y="132"/>
                  <a:pt x="1276" y="132"/>
                  <a:pt x="1276" y="132"/>
                </a:cubicBezTo>
                <a:cubicBezTo>
                  <a:pt x="1268" y="136"/>
                  <a:pt x="1268" y="136"/>
                  <a:pt x="1268" y="136"/>
                </a:cubicBezTo>
                <a:cubicBezTo>
                  <a:pt x="1258" y="138"/>
                  <a:pt x="1258" y="138"/>
                  <a:pt x="1258" y="138"/>
                </a:cubicBezTo>
                <a:cubicBezTo>
                  <a:pt x="1248" y="136"/>
                  <a:pt x="1248" y="136"/>
                  <a:pt x="1248" y="136"/>
                </a:cubicBezTo>
                <a:cubicBezTo>
                  <a:pt x="1241" y="132"/>
                  <a:pt x="1241" y="132"/>
                  <a:pt x="1241" y="132"/>
                </a:cubicBezTo>
                <a:cubicBezTo>
                  <a:pt x="1236" y="128"/>
                  <a:pt x="1236" y="128"/>
                  <a:pt x="1236" y="128"/>
                </a:cubicBezTo>
                <a:cubicBezTo>
                  <a:pt x="1231" y="121"/>
                  <a:pt x="1231" y="121"/>
                  <a:pt x="1231" y="121"/>
                </a:cubicBezTo>
                <a:cubicBezTo>
                  <a:pt x="1231" y="121"/>
                  <a:pt x="1227" y="117"/>
                  <a:pt x="1221" y="102"/>
                </a:cubicBezTo>
                <a:cubicBezTo>
                  <a:pt x="1216" y="88"/>
                  <a:pt x="1215" y="98"/>
                  <a:pt x="1215" y="98"/>
                </a:cubicBezTo>
                <a:cubicBezTo>
                  <a:pt x="1213" y="104"/>
                  <a:pt x="1213" y="104"/>
                  <a:pt x="1213" y="104"/>
                </a:cubicBezTo>
                <a:cubicBezTo>
                  <a:pt x="1211" y="110"/>
                  <a:pt x="1211" y="110"/>
                  <a:pt x="1211" y="110"/>
                </a:cubicBezTo>
                <a:cubicBezTo>
                  <a:pt x="1205" y="128"/>
                  <a:pt x="1205" y="128"/>
                  <a:pt x="1205" y="128"/>
                </a:cubicBezTo>
                <a:cubicBezTo>
                  <a:pt x="1201" y="136"/>
                  <a:pt x="1201" y="136"/>
                  <a:pt x="1201" y="136"/>
                </a:cubicBezTo>
                <a:cubicBezTo>
                  <a:pt x="1189" y="145"/>
                  <a:pt x="1189" y="145"/>
                  <a:pt x="1189" y="145"/>
                </a:cubicBezTo>
                <a:cubicBezTo>
                  <a:pt x="1183" y="149"/>
                  <a:pt x="1183" y="149"/>
                  <a:pt x="1183" y="149"/>
                </a:cubicBezTo>
                <a:cubicBezTo>
                  <a:pt x="1171" y="152"/>
                  <a:pt x="1171" y="152"/>
                  <a:pt x="1171" y="152"/>
                </a:cubicBezTo>
                <a:cubicBezTo>
                  <a:pt x="1171" y="152"/>
                  <a:pt x="1156" y="153"/>
                  <a:pt x="1153" y="153"/>
                </a:cubicBezTo>
                <a:cubicBezTo>
                  <a:pt x="1150" y="154"/>
                  <a:pt x="1143" y="156"/>
                  <a:pt x="1143" y="146"/>
                </a:cubicBezTo>
                <a:cubicBezTo>
                  <a:pt x="1142" y="136"/>
                  <a:pt x="1136" y="144"/>
                  <a:pt x="1136" y="144"/>
                </a:cubicBezTo>
                <a:cubicBezTo>
                  <a:pt x="1130" y="151"/>
                  <a:pt x="1130" y="151"/>
                  <a:pt x="1130" y="151"/>
                </a:cubicBezTo>
                <a:cubicBezTo>
                  <a:pt x="1120" y="165"/>
                  <a:pt x="1120" y="165"/>
                  <a:pt x="1120" y="165"/>
                </a:cubicBezTo>
                <a:cubicBezTo>
                  <a:pt x="1108" y="177"/>
                  <a:pt x="1108" y="177"/>
                  <a:pt x="1108" y="177"/>
                </a:cubicBezTo>
                <a:cubicBezTo>
                  <a:pt x="1108" y="177"/>
                  <a:pt x="1101" y="182"/>
                  <a:pt x="1093" y="185"/>
                </a:cubicBezTo>
                <a:cubicBezTo>
                  <a:pt x="1086" y="188"/>
                  <a:pt x="1080" y="189"/>
                  <a:pt x="1080" y="189"/>
                </a:cubicBezTo>
                <a:cubicBezTo>
                  <a:pt x="1060" y="201"/>
                  <a:pt x="1060" y="201"/>
                  <a:pt x="1060" y="201"/>
                </a:cubicBezTo>
                <a:cubicBezTo>
                  <a:pt x="1029" y="214"/>
                  <a:pt x="1029" y="214"/>
                  <a:pt x="1029" y="214"/>
                </a:cubicBezTo>
                <a:cubicBezTo>
                  <a:pt x="1029" y="214"/>
                  <a:pt x="1005" y="220"/>
                  <a:pt x="997" y="225"/>
                </a:cubicBezTo>
                <a:cubicBezTo>
                  <a:pt x="988" y="230"/>
                  <a:pt x="966" y="234"/>
                  <a:pt x="966" y="234"/>
                </a:cubicBezTo>
                <a:cubicBezTo>
                  <a:pt x="937" y="244"/>
                  <a:pt x="937" y="244"/>
                  <a:pt x="937" y="244"/>
                </a:cubicBezTo>
                <a:cubicBezTo>
                  <a:pt x="937" y="244"/>
                  <a:pt x="909" y="252"/>
                  <a:pt x="898" y="265"/>
                </a:cubicBezTo>
                <a:cubicBezTo>
                  <a:pt x="886" y="279"/>
                  <a:pt x="874" y="268"/>
                  <a:pt x="871" y="275"/>
                </a:cubicBezTo>
                <a:cubicBezTo>
                  <a:pt x="868" y="282"/>
                  <a:pt x="856" y="280"/>
                  <a:pt x="847" y="279"/>
                </a:cubicBezTo>
                <a:cubicBezTo>
                  <a:pt x="838" y="278"/>
                  <a:pt x="834" y="278"/>
                  <a:pt x="826" y="285"/>
                </a:cubicBezTo>
                <a:cubicBezTo>
                  <a:pt x="817" y="291"/>
                  <a:pt x="804" y="298"/>
                  <a:pt x="823" y="298"/>
                </a:cubicBezTo>
                <a:cubicBezTo>
                  <a:pt x="843" y="298"/>
                  <a:pt x="831" y="301"/>
                  <a:pt x="816" y="308"/>
                </a:cubicBezTo>
                <a:cubicBezTo>
                  <a:pt x="814" y="309"/>
                  <a:pt x="813" y="310"/>
                  <a:pt x="812" y="310"/>
                </a:cubicBezTo>
                <a:close/>
                <a:moveTo>
                  <a:pt x="652" y="329"/>
                </a:moveTo>
                <a:cubicBezTo>
                  <a:pt x="652" y="329"/>
                  <a:pt x="665" y="322"/>
                  <a:pt x="658" y="322"/>
                </a:cubicBezTo>
                <a:cubicBezTo>
                  <a:pt x="652" y="322"/>
                  <a:pt x="652" y="322"/>
                  <a:pt x="652" y="322"/>
                </a:cubicBezTo>
                <a:cubicBezTo>
                  <a:pt x="646" y="324"/>
                  <a:pt x="635" y="331"/>
                  <a:pt x="635" y="331"/>
                </a:cubicBezTo>
                <a:cubicBezTo>
                  <a:pt x="635" y="331"/>
                  <a:pt x="629" y="338"/>
                  <a:pt x="638" y="336"/>
                </a:cubicBezTo>
                <a:cubicBezTo>
                  <a:pt x="647" y="334"/>
                  <a:pt x="652" y="329"/>
                  <a:pt x="652" y="329"/>
                </a:cubicBezTo>
                <a:close/>
                <a:moveTo>
                  <a:pt x="640" y="348"/>
                </a:moveTo>
                <a:cubicBezTo>
                  <a:pt x="640" y="348"/>
                  <a:pt x="654" y="337"/>
                  <a:pt x="634" y="344"/>
                </a:cubicBezTo>
                <a:cubicBezTo>
                  <a:pt x="613" y="351"/>
                  <a:pt x="604" y="358"/>
                  <a:pt x="604" y="358"/>
                </a:cubicBezTo>
                <a:cubicBezTo>
                  <a:pt x="589" y="368"/>
                  <a:pt x="589" y="368"/>
                  <a:pt x="589" y="368"/>
                </a:cubicBezTo>
                <a:cubicBezTo>
                  <a:pt x="589" y="368"/>
                  <a:pt x="564" y="383"/>
                  <a:pt x="581" y="383"/>
                </a:cubicBezTo>
                <a:cubicBezTo>
                  <a:pt x="599" y="382"/>
                  <a:pt x="606" y="380"/>
                  <a:pt x="606" y="380"/>
                </a:cubicBezTo>
                <a:cubicBezTo>
                  <a:pt x="612" y="380"/>
                  <a:pt x="612" y="380"/>
                  <a:pt x="612" y="380"/>
                </a:cubicBezTo>
                <a:cubicBezTo>
                  <a:pt x="612" y="380"/>
                  <a:pt x="618" y="369"/>
                  <a:pt x="619" y="368"/>
                </a:cubicBezTo>
                <a:cubicBezTo>
                  <a:pt x="620" y="367"/>
                  <a:pt x="624" y="362"/>
                  <a:pt x="628" y="359"/>
                </a:cubicBezTo>
                <a:cubicBezTo>
                  <a:pt x="631" y="356"/>
                  <a:pt x="640" y="348"/>
                  <a:pt x="640" y="348"/>
                </a:cubicBezTo>
                <a:close/>
              </a:path>
            </a:pathLst>
          </a:cu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4" name="Freeform 33">
            <a:extLst>
              <a:ext uri="{FF2B5EF4-FFF2-40B4-BE49-F238E27FC236}">
                <a16:creationId xmlns:a16="http://schemas.microsoft.com/office/drawing/2014/main" id="{52183987-C950-77CE-39B1-C42DD89E3A17}"/>
              </a:ext>
            </a:extLst>
          </p:cNvPr>
          <p:cNvSpPr>
            <a:spLocks/>
          </p:cNvSpPr>
          <p:nvPr/>
        </p:nvSpPr>
        <p:spPr bwMode="auto">
          <a:xfrm>
            <a:off x="2982896" y="1448721"/>
            <a:ext cx="1489060" cy="674465"/>
          </a:xfrm>
          <a:custGeom>
            <a:avLst/>
            <a:gdLst>
              <a:gd name="T0" fmla="*/ 326 w 340"/>
              <a:gd name="T1" fmla="*/ 29 h 154"/>
              <a:gd name="T2" fmla="*/ 336 w 340"/>
              <a:gd name="T3" fmla="*/ 44 h 154"/>
              <a:gd name="T4" fmla="*/ 318 w 340"/>
              <a:gd name="T5" fmla="*/ 72 h 154"/>
              <a:gd name="T6" fmla="*/ 248 w 340"/>
              <a:gd name="T7" fmla="*/ 110 h 154"/>
              <a:gd name="T8" fmla="*/ 214 w 340"/>
              <a:gd name="T9" fmla="*/ 118 h 154"/>
              <a:gd name="T10" fmla="*/ 183 w 340"/>
              <a:gd name="T11" fmla="*/ 128 h 154"/>
              <a:gd name="T12" fmla="*/ 120 w 340"/>
              <a:gd name="T13" fmla="*/ 148 h 154"/>
              <a:gd name="T14" fmla="*/ 74 w 340"/>
              <a:gd name="T15" fmla="*/ 152 h 154"/>
              <a:gd name="T16" fmla="*/ 74 w 340"/>
              <a:gd name="T17" fmla="*/ 152 h 154"/>
              <a:gd name="T18" fmla="*/ 63 w 340"/>
              <a:gd name="T19" fmla="*/ 149 h 154"/>
              <a:gd name="T20" fmla="*/ 63 w 340"/>
              <a:gd name="T21" fmla="*/ 149 h 154"/>
              <a:gd name="T22" fmla="*/ 61 w 340"/>
              <a:gd name="T23" fmla="*/ 148 h 154"/>
              <a:gd name="T24" fmla="*/ 11 w 340"/>
              <a:gd name="T25" fmla="*/ 117 h 154"/>
              <a:gd name="T26" fmla="*/ 14 w 340"/>
              <a:gd name="T27" fmla="*/ 105 h 154"/>
              <a:gd name="T28" fmla="*/ 40 w 340"/>
              <a:gd name="T29" fmla="*/ 100 h 154"/>
              <a:gd name="T30" fmla="*/ 81 w 340"/>
              <a:gd name="T31" fmla="*/ 80 h 154"/>
              <a:gd name="T32" fmla="*/ 69 w 340"/>
              <a:gd name="T33" fmla="*/ 80 h 154"/>
              <a:gd name="T34" fmla="*/ 51 w 340"/>
              <a:gd name="T35" fmla="*/ 86 h 154"/>
              <a:gd name="T36" fmla="*/ 49 w 340"/>
              <a:gd name="T37" fmla="*/ 87 h 154"/>
              <a:gd name="T38" fmla="*/ 48 w 340"/>
              <a:gd name="T39" fmla="*/ 76 h 154"/>
              <a:gd name="T40" fmla="*/ 79 w 340"/>
              <a:gd name="T41" fmla="*/ 64 h 154"/>
              <a:gd name="T42" fmla="*/ 158 w 340"/>
              <a:gd name="T43" fmla="*/ 39 h 154"/>
              <a:gd name="T44" fmla="*/ 214 w 340"/>
              <a:gd name="T45" fmla="*/ 19 h 154"/>
              <a:gd name="T46" fmla="*/ 254 w 340"/>
              <a:gd name="T47" fmla="*/ 0 h 154"/>
              <a:gd name="T48" fmla="*/ 266 w 340"/>
              <a:gd name="T49" fmla="*/ 4 h 154"/>
              <a:gd name="T50" fmla="*/ 279 w 340"/>
              <a:gd name="T51" fmla="*/ 6 h 154"/>
              <a:gd name="T52" fmla="*/ 314 w 340"/>
              <a:gd name="T53" fmla="*/ 16 h 154"/>
              <a:gd name="T54" fmla="*/ 326 w 340"/>
              <a:gd name="T55" fmla="*/ 29 h 1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340" h="154">
                <a:moveTo>
                  <a:pt x="326" y="29"/>
                </a:moveTo>
                <a:cubicBezTo>
                  <a:pt x="340" y="28"/>
                  <a:pt x="336" y="34"/>
                  <a:pt x="336" y="44"/>
                </a:cubicBezTo>
                <a:cubicBezTo>
                  <a:pt x="336" y="53"/>
                  <a:pt x="328" y="60"/>
                  <a:pt x="318" y="72"/>
                </a:cubicBezTo>
                <a:cubicBezTo>
                  <a:pt x="308" y="84"/>
                  <a:pt x="248" y="110"/>
                  <a:pt x="248" y="110"/>
                </a:cubicBezTo>
                <a:cubicBezTo>
                  <a:pt x="214" y="118"/>
                  <a:pt x="214" y="118"/>
                  <a:pt x="214" y="118"/>
                </a:cubicBezTo>
                <a:cubicBezTo>
                  <a:pt x="183" y="128"/>
                  <a:pt x="183" y="128"/>
                  <a:pt x="183" y="128"/>
                </a:cubicBezTo>
                <a:cubicBezTo>
                  <a:pt x="183" y="128"/>
                  <a:pt x="151" y="138"/>
                  <a:pt x="120" y="148"/>
                </a:cubicBezTo>
                <a:cubicBezTo>
                  <a:pt x="98" y="154"/>
                  <a:pt x="85" y="154"/>
                  <a:pt x="74" y="152"/>
                </a:cubicBezTo>
                <a:cubicBezTo>
                  <a:pt x="74" y="152"/>
                  <a:pt x="74" y="152"/>
                  <a:pt x="74" y="152"/>
                </a:cubicBezTo>
                <a:cubicBezTo>
                  <a:pt x="70" y="151"/>
                  <a:pt x="66" y="150"/>
                  <a:pt x="63" y="149"/>
                </a:cubicBezTo>
                <a:cubicBezTo>
                  <a:pt x="63" y="149"/>
                  <a:pt x="63" y="149"/>
                  <a:pt x="63" y="149"/>
                </a:cubicBezTo>
                <a:cubicBezTo>
                  <a:pt x="63" y="149"/>
                  <a:pt x="62" y="148"/>
                  <a:pt x="61" y="148"/>
                </a:cubicBezTo>
                <a:cubicBezTo>
                  <a:pt x="50" y="144"/>
                  <a:pt x="22" y="130"/>
                  <a:pt x="11" y="117"/>
                </a:cubicBezTo>
                <a:cubicBezTo>
                  <a:pt x="0" y="104"/>
                  <a:pt x="14" y="105"/>
                  <a:pt x="14" y="105"/>
                </a:cubicBezTo>
                <a:cubicBezTo>
                  <a:pt x="14" y="105"/>
                  <a:pt x="20" y="104"/>
                  <a:pt x="40" y="100"/>
                </a:cubicBezTo>
                <a:cubicBezTo>
                  <a:pt x="60" y="96"/>
                  <a:pt x="63" y="94"/>
                  <a:pt x="81" y="80"/>
                </a:cubicBezTo>
                <a:cubicBezTo>
                  <a:pt x="99" y="64"/>
                  <a:pt x="76" y="75"/>
                  <a:pt x="69" y="80"/>
                </a:cubicBezTo>
                <a:cubicBezTo>
                  <a:pt x="63" y="84"/>
                  <a:pt x="51" y="86"/>
                  <a:pt x="51" y="86"/>
                </a:cubicBezTo>
                <a:cubicBezTo>
                  <a:pt x="51" y="86"/>
                  <a:pt x="51" y="86"/>
                  <a:pt x="49" y="87"/>
                </a:cubicBezTo>
                <a:cubicBezTo>
                  <a:pt x="48" y="76"/>
                  <a:pt x="48" y="76"/>
                  <a:pt x="48" y="76"/>
                </a:cubicBezTo>
                <a:cubicBezTo>
                  <a:pt x="65" y="73"/>
                  <a:pt x="65" y="72"/>
                  <a:pt x="79" y="64"/>
                </a:cubicBezTo>
                <a:cubicBezTo>
                  <a:pt x="98" y="53"/>
                  <a:pt x="151" y="40"/>
                  <a:pt x="158" y="39"/>
                </a:cubicBezTo>
                <a:cubicBezTo>
                  <a:pt x="164" y="38"/>
                  <a:pt x="191" y="31"/>
                  <a:pt x="214" y="19"/>
                </a:cubicBezTo>
                <a:cubicBezTo>
                  <a:pt x="236" y="7"/>
                  <a:pt x="253" y="1"/>
                  <a:pt x="254" y="0"/>
                </a:cubicBezTo>
                <a:cubicBezTo>
                  <a:pt x="250" y="4"/>
                  <a:pt x="265" y="1"/>
                  <a:pt x="266" y="4"/>
                </a:cubicBezTo>
                <a:cubicBezTo>
                  <a:pt x="267" y="6"/>
                  <a:pt x="268" y="6"/>
                  <a:pt x="279" y="6"/>
                </a:cubicBezTo>
                <a:cubicBezTo>
                  <a:pt x="289" y="6"/>
                  <a:pt x="304" y="10"/>
                  <a:pt x="314" y="16"/>
                </a:cubicBezTo>
                <a:cubicBezTo>
                  <a:pt x="324" y="22"/>
                  <a:pt x="312" y="30"/>
                  <a:pt x="326" y="29"/>
                </a:cubicBezTo>
                <a:close/>
              </a:path>
            </a:pathLst>
          </a:cu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5" name="Freeform 52">
            <a:extLst>
              <a:ext uri="{FF2B5EF4-FFF2-40B4-BE49-F238E27FC236}">
                <a16:creationId xmlns:a16="http://schemas.microsoft.com/office/drawing/2014/main" id="{67071F74-BA8C-20F2-99CC-ABF2040A9CED}"/>
              </a:ext>
            </a:extLst>
          </p:cNvPr>
          <p:cNvSpPr>
            <a:spLocks/>
          </p:cNvSpPr>
          <p:nvPr/>
        </p:nvSpPr>
        <p:spPr bwMode="auto">
          <a:xfrm>
            <a:off x="1600088" y="1357868"/>
            <a:ext cx="1598390" cy="591312"/>
          </a:xfrm>
          <a:custGeom>
            <a:avLst/>
            <a:gdLst>
              <a:gd name="T0" fmla="*/ 364 w 365"/>
              <a:gd name="T1" fmla="*/ 97 h 135"/>
              <a:gd name="T2" fmla="*/ 365 w 365"/>
              <a:gd name="T3" fmla="*/ 108 h 135"/>
              <a:gd name="T4" fmla="*/ 296 w 365"/>
              <a:gd name="T5" fmla="*/ 123 h 135"/>
              <a:gd name="T6" fmla="*/ 229 w 365"/>
              <a:gd name="T7" fmla="*/ 118 h 135"/>
              <a:gd name="T8" fmla="*/ 190 w 365"/>
              <a:gd name="T9" fmla="*/ 91 h 135"/>
              <a:gd name="T10" fmla="*/ 181 w 365"/>
              <a:gd name="T11" fmla="*/ 87 h 135"/>
              <a:gd name="T12" fmla="*/ 165 w 365"/>
              <a:gd name="T13" fmla="*/ 82 h 135"/>
              <a:gd name="T14" fmla="*/ 150 w 365"/>
              <a:gd name="T15" fmla="*/ 78 h 135"/>
              <a:gd name="T16" fmla="*/ 127 w 365"/>
              <a:gd name="T17" fmla="*/ 74 h 135"/>
              <a:gd name="T18" fmla="*/ 116 w 365"/>
              <a:gd name="T19" fmla="*/ 69 h 135"/>
              <a:gd name="T20" fmla="*/ 107 w 365"/>
              <a:gd name="T21" fmla="*/ 65 h 135"/>
              <a:gd name="T22" fmla="*/ 99 w 365"/>
              <a:gd name="T23" fmla="*/ 59 h 135"/>
              <a:gd name="T24" fmla="*/ 89 w 365"/>
              <a:gd name="T25" fmla="*/ 50 h 135"/>
              <a:gd name="T26" fmla="*/ 71 w 365"/>
              <a:gd name="T27" fmla="*/ 40 h 135"/>
              <a:gd name="T28" fmla="*/ 57 w 365"/>
              <a:gd name="T29" fmla="*/ 34 h 135"/>
              <a:gd name="T30" fmla="*/ 45 w 365"/>
              <a:gd name="T31" fmla="*/ 31 h 135"/>
              <a:gd name="T32" fmla="*/ 39 w 365"/>
              <a:gd name="T33" fmla="*/ 27 h 135"/>
              <a:gd name="T34" fmla="*/ 23 w 365"/>
              <a:gd name="T35" fmla="*/ 19 h 135"/>
              <a:gd name="T36" fmla="*/ 0 w 365"/>
              <a:gd name="T37" fmla="*/ 9 h 135"/>
              <a:gd name="T38" fmla="*/ 74 w 365"/>
              <a:gd name="T39" fmla="*/ 13 h 135"/>
              <a:gd name="T40" fmla="*/ 129 w 365"/>
              <a:gd name="T41" fmla="*/ 35 h 135"/>
              <a:gd name="T42" fmla="*/ 218 w 365"/>
              <a:gd name="T43" fmla="*/ 59 h 135"/>
              <a:gd name="T44" fmla="*/ 274 w 365"/>
              <a:gd name="T45" fmla="*/ 88 h 135"/>
              <a:gd name="T46" fmla="*/ 338 w 365"/>
              <a:gd name="T47" fmla="*/ 101 h 135"/>
              <a:gd name="T48" fmla="*/ 364 w 365"/>
              <a:gd name="T49" fmla="*/ 97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</a:cxnLst>
            <a:rect l="0" t="0" r="r" b="b"/>
            <a:pathLst>
              <a:path w="365" h="135">
                <a:moveTo>
                  <a:pt x="364" y="97"/>
                </a:moveTo>
                <a:cubicBezTo>
                  <a:pt x="365" y="108"/>
                  <a:pt x="365" y="108"/>
                  <a:pt x="365" y="108"/>
                </a:cubicBezTo>
                <a:cubicBezTo>
                  <a:pt x="360" y="109"/>
                  <a:pt x="342" y="113"/>
                  <a:pt x="296" y="123"/>
                </a:cubicBezTo>
                <a:cubicBezTo>
                  <a:pt x="239" y="135"/>
                  <a:pt x="229" y="118"/>
                  <a:pt x="229" y="118"/>
                </a:cubicBezTo>
                <a:cubicBezTo>
                  <a:pt x="190" y="91"/>
                  <a:pt x="190" y="91"/>
                  <a:pt x="190" y="91"/>
                </a:cubicBezTo>
                <a:cubicBezTo>
                  <a:pt x="181" y="87"/>
                  <a:pt x="181" y="87"/>
                  <a:pt x="181" y="87"/>
                </a:cubicBezTo>
                <a:cubicBezTo>
                  <a:pt x="165" y="82"/>
                  <a:pt x="165" y="82"/>
                  <a:pt x="165" y="82"/>
                </a:cubicBezTo>
                <a:cubicBezTo>
                  <a:pt x="150" y="78"/>
                  <a:pt x="150" y="78"/>
                  <a:pt x="150" y="78"/>
                </a:cubicBezTo>
                <a:cubicBezTo>
                  <a:pt x="127" y="74"/>
                  <a:pt x="127" y="74"/>
                  <a:pt x="127" y="74"/>
                </a:cubicBezTo>
                <a:cubicBezTo>
                  <a:pt x="116" y="69"/>
                  <a:pt x="116" y="69"/>
                  <a:pt x="116" y="69"/>
                </a:cubicBezTo>
                <a:cubicBezTo>
                  <a:pt x="107" y="65"/>
                  <a:pt x="107" y="65"/>
                  <a:pt x="107" y="65"/>
                </a:cubicBezTo>
                <a:cubicBezTo>
                  <a:pt x="99" y="59"/>
                  <a:pt x="99" y="59"/>
                  <a:pt x="99" y="59"/>
                </a:cubicBezTo>
                <a:cubicBezTo>
                  <a:pt x="89" y="50"/>
                  <a:pt x="89" y="50"/>
                  <a:pt x="89" y="50"/>
                </a:cubicBezTo>
                <a:cubicBezTo>
                  <a:pt x="71" y="40"/>
                  <a:pt x="71" y="40"/>
                  <a:pt x="71" y="40"/>
                </a:cubicBezTo>
                <a:cubicBezTo>
                  <a:pt x="57" y="34"/>
                  <a:pt x="57" y="34"/>
                  <a:pt x="57" y="34"/>
                </a:cubicBezTo>
                <a:cubicBezTo>
                  <a:pt x="45" y="31"/>
                  <a:pt x="45" y="31"/>
                  <a:pt x="45" y="31"/>
                </a:cubicBezTo>
                <a:cubicBezTo>
                  <a:pt x="39" y="27"/>
                  <a:pt x="39" y="27"/>
                  <a:pt x="39" y="27"/>
                </a:cubicBezTo>
                <a:cubicBezTo>
                  <a:pt x="23" y="19"/>
                  <a:pt x="23" y="19"/>
                  <a:pt x="23" y="19"/>
                </a:cubicBezTo>
                <a:cubicBezTo>
                  <a:pt x="0" y="9"/>
                  <a:pt x="0" y="9"/>
                  <a:pt x="0" y="9"/>
                </a:cubicBezTo>
                <a:cubicBezTo>
                  <a:pt x="0" y="9"/>
                  <a:pt x="36" y="0"/>
                  <a:pt x="74" y="13"/>
                </a:cubicBezTo>
                <a:cubicBezTo>
                  <a:pt x="111" y="27"/>
                  <a:pt x="112" y="32"/>
                  <a:pt x="129" y="35"/>
                </a:cubicBezTo>
                <a:cubicBezTo>
                  <a:pt x="146" y="38"/>
                  <a:pt x="200" y="52"/>
                  <a:pt x="218" y="59"/>
                </a:cubicBezTo>
                <a:cubicBezTo>
                  <a:pt x="236" y="66"/>
                  <a:pt x="261" y="83"/>
                  <a:pt x="274" y="88"/>
                </a:cubicBezTo>
                <a:cubicBezTo>
                  <a:pt x="287" y="94"/>
                  <a:pt x="294" y="108"/>
                  <a:pt x="338" y="101"/>
                </a:cubicBezTo>
                <a:cubicBezTo>
                  <a:pt x="350" y="99"/>
                  <a:pt x="358" y="98"/>
                  <a:pt x="364" y="97"/>
                </a:cubicBezTo>
                <a:close/>
              </a:path>
            </a:pathLst>
          </a:cu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6" name="Freeform 70">
            <a:extLst>
              <a:ext uri="{FF2B5EF4-FFF2-40B4-BE49-F238E27FC236}">
                <a16:creationId xmlns:a16="http://schemas.microsoft.com/office/drawing/2014/main" id="{38086254-ABE5-FFAD-38B2-68215286C4A4}"/>
              </a:ext>
            </a:extLst>
          </p:cNvPr>
          <p:cNvSpPr>
            <a:spLocks/>
          </p:cNvSpPr>
          <p:nvPr/>
        </p:nvSpPr>
        <p:spPr bwMode="auto">
          <a:xfrm>
            <a:off x="768556" y="1444101"/>
            <a:ext cx="2009537" cy="1984899"/>
          </a:xfrm>
          <a:custGeom>
            <a:avLst/>
            <a:gdLst>
              <a:gd name="T0" fmla="*/ 455 w 459"/>
              <a:gd name="T1" fmla="*/ 234 h 453"/>
              <a:gd name="T2" fmla="*/ 457 w 459"/>
              <a:gd name="T3" fmla="*/ 283 h 453"/>
              <a:gd name="T4" fmla="*/ 457 w 459"/>
              <a:gd name="T5" fmla="*/ 292 h 453"/>
              <a:gd name="T6" fmla="*/ 433 w 459"/>
              <a:gd name="T7" fmla="*/ 353 h 453"/>
              <a:gd name="T8" fmla="*/ 422 w 459"/>
              <a:gd name="T9" fmla="*/ 359 h 453"/>
              <a:gd name="T10" fmla="*/ 387 w 459"/>
              <a:gd name="T11" fmla="*/ 378 h 453"/>
              <a:gd name="T12" fmla="*/ 358 w 459"/>
              <a:gd name="T13" fmla="*/ 384 h 453"/>
              <a:gd name="T14" fmla="*/ 346 w 459"/>
              <a:gd name="T15" fmla="*/ 381 h 453"/>
              <a:gd name="T16" fmla="*/ 337 w 459"/>
              <a:gd name="T17" fmla="*/ 381 h 453"/>
              <a:gd name="T18" fmla="*/ 317 w 459"/>
              <a:gd name="T19" fmla="*/ 382 h 453"/>
              <a:gd name="T20" fmla="*/ 294 w 459"/>
              <a:gd name="T21" fmla="*/ 377 h 453"/>
              <a:gd name="T22" fmla="*/ 267 w 459"/>
              <a:gd name="T23" fmla="*/ 378 h 453"/>
              <a:gd name="T24" fmla="*/ 210 w 459"/>
              <a:gd name="T25" fmla="*/ 377 h 453"/>
              <a:gd name="T26" fmla="*/ 174 w 459"/>
              <a:gd name="T27" fmla="*/ 390 h 453"/>
              <a:gd name="T28" fmla="*/ 174 w 459"/>
              <a:gd name="T29" fmla="*/ 408 h 453"/>
              <a:gd name="T30" fmla="*/ 185 w 459"/>
              <a:gd name="T31" fmla="*/ 436 h 453"/>
              <a:gd name="T32" fmla="*/ 171 w 459"/>
              <a:gd name="T33" fmla="*/ 447 h 453"/>
              <a:gd name="T34" fmla="*/ 153 w 459"/>
              <a:gd name="T35" fmla="*/ 441 h 453"/>
              <a:gd name="T36" fmla="*/ 140 w 459"/>
              <a:gd name="T37" fmla="*/ 439 h 453"/>
              <a:gd name="T38" fmla="*/ 127 w 459"/>
              <a:gd name="T39" fmla="*/ 438 h 453"/>
              <a:gd name="T40" fmla="*/ 118 w 459"/>
              <a:gd name="T41" fmla="*/ 437 h 453"/>
              <a:gd name="T42" fmla="*/ 99 w 459"/>
              <a:gd name="T43" fmla="*/ 427 h 453"/>
              <a:gd name="T44" fmla="*/ 84 w 459"/>
              <a:gd name="T45" fmla="*/ 420 h 453"/>
              <a:gd name="T46" fmla="*/ 75 w 459"/>
              <a:gd name="T47" fmla="*/ 411 h 453"/>
              <a:gd name="T48" fmla="*/ 70 w 459"/>
              <a:gd name="T49" fmla="*/ 397 h 453"/>
              <a:gd name="T50" fmla="*/ 66 w 459"/>
              <a:gd name="T51" fmla="*/ 385 h 453"/>
              <a:gd name="T52" fmla="*/ 65 w 459"/>
              <a:gd name="T53" fmla="*/ 375 h 453"/>
              <a:gd name="T54" fmla="*/ 58 w 459"/>
              <a:gd name="T55" fmla="*/ 343 h 453"/>
              <a:gd name="T56" fmla="*/ 37 w 459"/>
              <a:gd name="T57" fmla="*/ 309 h 453"/>
              <a:gd name="T58" fmla="*/ 28 w 459"/>
              <a:gd name="T59" fmla="*/ 304 h 453"/>
              <a:gd name="T60" fmla="*/ 28 w 459"/>
              <a:gd name="T61" fmla="*/ 304 h 453"/>
              <a:gd name="T62" fmla="*/ 10 w 459"/>
              <a:gd name="T63" fmla="*/ 284 h 453"/>
              <a:gd name="T64" fmla="*/ 2 w 459"/>
              <a:gd name="T65" fmla="*/ 265 h 453"/>
              <a:gd name="T66" fmla="*/ 10 w 459"/>
              <a:gd name="T67" fmla="*/ 229 h 453"/>
              <a:gd name="T68" fmla="*/ 28 w 459"/>
              <a:gd name="T69" fmla="*/ 214 h 453"/>
              <a:gd name="T70" fmla="*/ 32 w 459"/>
              <a:gd name="T71" fmla="*/ 217 h 453"/>
              <a:gd name="T72" fmla="*/ 37 w 459"/>
              <a:gd name="T73" fmla="*/ 207 h 453"/>
              <a:gd name="T74" fmla="*/ 28 w 459"/>
              <a:gd name="T75" fmla="*/ 191 h 453"/>
              <a:gd name="T76" fmla="*/ 32 w 459"/>
              <a:gd name="T77" fmla="*/ 156 h 453"/>
              <a:gd name="T78" fmla="*/ 56 w 459"/>
              <a:gd name="T79" fmla="*/ 105 h 453"/>
              <a:gd name="T80" fmla="*/ 59 w 459"/>
              <a:gd name="T81" fmla="*/ 75 h 453"/>
              <a:gd name="T82" fmla="*/ 70 w 459"/>
              <a:gd name="T83" fmla="*/ 42 h 453"/>
              <a:gd name="T84" fmla="*/ 78 w 459"/>
              <a:gd name="T85" fmla="*/ 32 h 453"/>
              <a:gd name="T86" fmla="*/ 99 w 459"/>
              <a:gd name="T87" fmla="*/ 14 h 453"/>
              <a:gd name="T88" fmla="*/ 160 w 459"/>
              <a:gd name="T89" fmla="*/ 2 h 453"/>
              <a:gd name="T90" fmla="*/ 193 w 459"/>
              <a:gd name="T91" fmla="*/ 16 h 453"/>
              <a:gd name="T92" fmla="*/ 237 w 459"/>
              <a:gd name="T93" fmla="*/ 33 h 453"/>
              <a:gd name="T94" fmla="*/ 273 w 459"/>
              <a:gd name="T95" fmla="*/ 58 h 453"/>
              <a:gd name="T96" fmla="*/ 288 w 459"/>
              <a:gd name="T97" fmla="*/ 72 h 453"/>
              <a:gd name="T98" fmla="*/ 303 w 459"/>
              <a:gd name="T99" fmla="*/ 83 h 453"/>
              <a:gd name="T100" fmla="*/ 314 w 459"/>
              <a:gd name="T101" fmla="*/ 87 h 453"/>
              <a:gd name="T102" fmla="*/ 322 w 459"/>
              <a:gd name="T103" fmla="*/ 90 h 453"/>
              <a:gd name="T104" fmla="*/ 326 w 459"/>
              <a:gd name="T105" fmla="*/ 93 h 453"/>
              <a:gd name="T106" fmla="*/ 337 w 459"/>
              <a:gd name="T107" fmla="*/ 102 h 453"/>
              <a:gd name="T108" fmla="*/ 371 w 459"/>
              <a:gd name="T109" fmla="*/ 139 h 453"/>
              <a:gd name="T110" fmla="*/ 377 w 459"/>
              <a:gd name="T111" fmla="*/ 144 h 453"/>
              <a:gd name="T112" fmla="*/ 392 w 459"/>
              <a:gd name="T113" fmla="*/ 158 h 453"/>
              <a:gd name="T114" fmla="*/ 413 w 459"/>
              <a:gd name="T115" fmla="*/ 183 h 453"/>
              <a:gd name="T116" fmla="*/ 428 w 459"/>
              <a:gd name="T117" fmla="*/ 199 h 453"/>
              <a:gd name="T118" fmla="*/ 455 w 459"/>
              <a:gd name="T119" fmla="*/ 234 h 4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459" h="453">
                <a:moveTo>
                  <a:pt x="455" y="234"/>
                </a:moveTo>
                <a:cubicBezTo>
                  <a:pt x="459" y="243"/>
                  <a:pt x="459" y="258"/>
                  <a:pt x="457" y="283"/>
                </a:cubicBezTo>
                <a:cubicBezTo>
                  <a:pt x="457" y="286"/>
                  <a:pt x="457" y="289"/>
                  <a:pt x="457" y="292"/>
                </a:cubicBezTo>
                <a:cubicBezTo>
                  <a:pt x="455" y="321"/>
                  <a:pt x="433" y="353"/>
                  <a:pt x="433" y="353"/>
                </a:cubicBezTo>
                <a:cubicBezTo>
                  <a:pt x="422" y="359"/>
                  <a:pt x="422" y="359"/>
                  <a:pt x="422" y="359"/>
                </a:cubicBezTo>
                <a:cubicBezTo>
                  <a:pt x="422" y="359"/>
                  <a:pt x="410" y="366"/>
                  <a:pt x="387" y="378"/>
                </a:cubicBezTo>
                <a:cubicBezTo>
                  <a:pt x="364" y="390"/>
                  <a:pt x="358" y="384"/>
                  <a:pt x="358" y="384"/>
                </a:cubicBezTo>
                <a:cubicBezTo>
                  <a:pt x="346" y="381"/>
                  <a:pt x="346" y="381"/>
                  <a:pt x="346" y="381"/>
                </a:cubicBezTo>
                <a:cubicBezTo>
                  <a:pt x="337" y="381"/>
                  <a:pt x="337" y="381"/>
                  <a:pt x="337" y="381"/>
                </a:cubicBezTo>
                <a:cubicBezTo>
                  <a:pt x="337" y="381"/>
                  <a:pt x="323" y="381"/>
                  <a:pt x="317" y="382"/>
                </a:cubicBezTo>
                <a:cubicBezTo>
                  <a:pt x="311" y="383"/>
                  <a:pt x="301" y="376"/>
                  <a:pt x="294" y="377"/>
                </a:cubicBezTo>
                <a:cubicBezTo>
                  <a:pt x="287" y="378"/>
                  <a:pt x="283" y="385"/>
                  <a:pt x="267" y="378"/>
                </a:cubicBezTo>
                <a:cubicBezTo>
                  <a:pt x="251" y="371"/>
                  <a:pt x="225" y="374"/>
                  <a:pt x="210" y="377"/>
                </a:cubicBezTo>
                <a:cubicBezTo>
                  <a:pt x="195" y="380"/>
                  <a:pt x="191" y="384"/>
                  <a:pt x="174" y="390"/>
                </a:cubicBezTo>
                <a:cubicBezTo>
                  <a:pt x="157" y="395"/>
                  <a:pt x="174" y="408"/>
                  <a:pt x="174" y="408"/>
                </a:cubicBezTo>
                <a:cubicBezTo>
                  <a:pt x="174" y="408"/>
                  <a:pt x="181" y="418"/>
                  <a:pt x="185" y="436"/>
                </a:cubicBezTo>
                <a:cubicBezTo>
                  <a:pt x="188" y="453"/>
                  <a:pt x="177" y="447"/>
                  <a:pt x="171" y="447"/>
                </a:cubicBezTo>
                <a:cubicBezTo>
                  <a:pt x="165" y="447"/>
                  <a:pt x="162" y="441"/>
                  <a:pt x="153" y="441"/>
                </a:cubicBezTo>
                <a:cubicBezTo>
                  <a:pt x="145" y="441"/>
                  <a:pt x="143" y="445"/>
                  <a:pt x="140" y="439"/>
                </a:cubicBezTo>
                <a:cubicBezTo>
                  <a:pt x="136" y="433"/>
                  <a:pt x="127" y="438"/>
                  <a:pt x="127" y="438"/>
                </a:cubicBezTo>
                <a:cubicBezTo>
                  <a:pt x="118" y="437"/>
                  <a:pt x="118" y="437"/>
                  <a:pt x="118" y="437"/>
                </a:cubicBezTo>
                <a:cubicBezTo>
                  <a:pt x="99" y="427"/>
                  <a:pt x="99" y="427"/>
                  <a:pt x="99" y="427"/>
                </a:cubicBezTo>
                <a:cubicBezTo>
                  <a:pt x="84" y="420"/>
                  <a:pt x="84" y="420"/>
                  <a:pt x="84" y="420"/>
                </a:cubicBezTo>
                <a:cubicBezTo>
                  <a:pt x="75" y="411"/>
                  <a:pt x="75" y="411"/>
                  <a:pt x="75" y="411"/>
                </a:cubicBezTo>
                <a:cubicBezTo>
                  <a:pt x="70" y="397"/>
                  <a:pt x="70" y="397"/>
                  <a:pt x="70" y="397"/>
                </a:cubicBezTo>
                <a:cubicBezTo>
                  <a:pt x="66" y="385"/>
                  <a:pt x="66" y="385"/>
                  <a:pt x="66" y="385"/>
                </a:cubicBezTo>
                <a:cubicBezTo>
                  <a:pt x="65" y="375"/>
                  <a:pt x="65" y="375"/>
                  <a:pt x="65" y="375"/>
                </a:cubicBezTo>
                <a:cubicBezTo>
                  <a:pt x="65" y="375"/>
                  <a:pt x="61" y="357"/>
                  <a:pt x="58" y="343"/>
                </a:cubicBezTo>
                <a:cubicBezTo>
                  <a:pt x="55" y="329"/>
                  <a:pt x="52" y="327"/>
                  <a:pt x="37" y="309"/>
                </a:cubicBezTo>
                <a:cubicBezTo>
                  <a:pt x="31" y="303"/>
                  <a:pt x="28" y="302"/>
                  <a:pt x="28" y="304"/>
                </a:cubicBezTo>
                <a:cubicBezTo>
                  <a:pt x="28" y="304"/>
                  <a:pt x="28" y="304"/>
                  <a:pt x="28" y="304"/>
                </a:cubicBezTo>
                <a:cubicBezTo>
                  <a:pt x="28" y="304"/>
                  <a:pt x="24" y="292"/>
                  <a:pt x="10" y="284"/>
                </a:cubicBezTo>
                <a:cubicBezTo>
                  <a:pt x="5" y="281"/>
                  <a:pt x="3" y="274"/>
                  <a:pt x="2" y="265"/>
                </a:cubicBezTo>
                <a:cubicBezTo>
                  <a:pt x="0" y="251"/>
                  <a:pt x="4" y="235"/>
                  <a:pt x="10" y="229"/>
                </a:cubicBezTo>
                <a:cubicBezTo>
                  <a:pt x="21" y="220"/>
                  <a:pt x="28" y="214"/>
                  <a:pt x="28" y="214"/>
                </a:cubicBezTo>
                <a:cubicBezTo>
                  <a:pt x="29" y="215"/>
                  <a:pt x="31" y="216"/>
                  <a:pt x="32" y="217"/>
                </a:cubicBezTo>
                <a:cubicBezTo>
                  <a:pt x="57" y="233"/>
                  <a:pt x="40" y="211"/>
                  <a:pt x="37" y="207"/>
                </a:cubicBezTo>
                <a:cubicBezTo>
                  <a:pt x="35" y="205"/>
                  <a:pt x="27" y="193"/>
                  <a:pt x="28" y="191"/>
                </a:cubicBezTo>
                <a:cubicBezTo>
                  <a:pt x="28" y="188"/>
                  <a:pt x="22" y="169"/>
                  <a:pt x="32" y="156"/>
                </a:cubicBezTo>
                <a:cubicBezTo>
                  <a:pt x="43" y="143"/>
                  <a:pt x="50" y="115"/>
                  <a:pt x="56" y="105"/>
                </a:cubicBezTo>
                <a:cubicBezTo>
                  <a:pt x="61" y="97"/>
                  <a:pt x="52" y="85"/>
                  <a:pt x="59" y="75"/>
                </a:cubicBezTo>
                <a:cubicBezTo>
                  <a:pt x="67" y="65"/>
                  <a:pt x="70" y="42"/>
                  <a:pt x="70" y="42"/>
                </a:cubicBezTo>
                <a:cubicBezTo>
                  <a:pt x="73" y="41"/>
                  <a:pt x="77" y="34"/>
                  <a:pt x="78" y="32"/>
                </a:cubicBezTo>
                <a:cubicBezTo>
                  <a:pt x="82" y="27"/>
                  <a:pt x="87" y="22"/>
                  <a:pt x="99" y="14"/>
                </a:cubicBezTo>
                <a:cubicBezTo>
                  <a:pt x="112" y="5"/>
                  <a:pt x="142" y="0"/>
                  <a:pt x="160" y="2"/>
                </a:cubicBezTo>
                <a:cubicBezTo>
                  <a:pt x="179" y="4"/>
                  <a:pt x="176" y="6"/>
                  <a:pt x="193" y="16"/>
                </a:cubicBezTo>
                <a:cubicBezTo>
                  <a:pt x="211" y="26"/>
                  <a:pt x="216" y="29"/>
                  <a:pt x="237" y="33"/>
                </a:cubicBezTo>
                <a:cubicBezTo>
                  <a:pt x="257" y="36"/>
                  <a:pt x="273" y="58"/>
                  <a:pt x="273" y="58"/>
                </a:cubicBezTo>
                <a:cubicBezTo>
                  <a:pt x="288" y="72"/>
                  <a:pt x="288" y="72"/>
                  <a:pt x="288" y="72"/>
                </a:cubicBezTo>
                <a:cubicBezTo>
                  <a:pt x="303" y="83"/>
                  <a:pt x="303" y="83"/>
                  <a:pt x="303" y="83"/>
                </a:cubicBezTo>
                <a:cubicBezTo>
                  <a:pt x="314" y="87"/>
                  <a:pt x="314" y="87"/>
                  <a:pt x="314" y="87"/>
                </a:cubicBezTo>
                <a:cubicBezTo>
                  <a:pt x="322" y="90"/>
                  <a:pt x="322" y="90"/>
                  <a:pt x="322" y="90"/>
                </a:cubicBezTo>
                <a:cubicBezTo>
                  <a:pt x="326" y="93"/>
                  <a:pt x="326" y="93"/>
                  <a:pt x="326" y="93"/>
                </a:cubicBezTo>
                <a:cubicBezTo>
                  <a:pt x="337" y="102"/>
                  <a:pt x="337" y="102"/>
                  <a:pt x="337" y="102"/>
                </a:cubicBezTo>
                <a:cubicBezTo>
                  <a:pt x="371" y="139"/>
                  <a:pt x="371" y="139"/>
                  <a:pt x="371" y="139"/>
                </a:cubicBezTo>
                <a:cubicBezTo>
                  <a:pt x="377" y="144"/>
                  <a:pt x="377" y="144"/>
                  <a:pt x="377" y="144"/>
                </a:cubicBezTo>
                <a:cubicBezTo>
                  <a:pt x="377" y="144"/>
                  <a:pt x="382" y="150"/>
                  <a:pt x="392" y="158"/>
                </a:cubicBezTo>
                <a:cubicBezTo>
                  <a:pt x="401" y="167"/>
                  <a:pt x="408" y="173"/>
                  <a:pt x="413" y="183"/>
                </a:cubicBezTo>
                <a:cubicBezTo>
                  <a:pt x="418" y="193"/>
                  <a:pt x="421" y="191"/>
                  <a:pt x="428" y="199"/>
                </a:cubicBezTo>
                <a:cubicBezTo>
                  <a:pt x="435" y="208"/>
                  <a:pt x="452" y="223"/>
                  <a:pt x="455" y="234"/>
                </a:cubicBezTo>
                <a:close/>
              </a:path>
            </a:pathLst>
          </a:cu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dirty="0"/>
          </a:p>
        </p:txBody>
      </p:sp>
      <p:sp>
        <p:nvSpPr>
          <p:cNvPr id="37" name="Freeform 82">
            <a:extLst>
              <a:ext uri="{FF2B5EF4-FFF2-40B4-BE49-F238E27FC236}">
                <a16:creationId xmlns:a16="http://schemas.microsoft.com/office/drawing/2014/main" id="{14A2EAEA-B438-9704-4CAA-7953DB87E6E8}"/>
              </a:ext>
            </a:extLst>
          </p:cNvPr>
          <p:cNvSpPr>
            <a:spLocks/>
          </p:cNvSpPr>
          <p:nvPr/>
        </p:nvSpPr>
        <p:spPr bwMode="auto">
          <a:xfrm>
            <a:off x="1963499" y="3410521"/>
            <a:ext cx="47737" cy="4620"/>
          </a:xfrm>
          <a:custGeom>
            <a:avLst/>
            <a:gdLst>
              <a:gd name="T0" fmla="*/ 11 w 11"/>
              <a:gd name="T1" fmla="*/ 0 h 1"/>
              <a:gd name="T2" fmla="*/ 0 w 11"/>
              <a:gd name="T3" fmla="*/ 1 h 1"/>
              <a:gd name="T4" fmla="*/ 11 w 11"/>
              <a:gd name="T5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1">
                <a:moveTo>
                  <a:pt x="11" y="0"/>
                </a:moveTo>
                <a:cubicBezTo>
                  <a:pt x="0" y="1"/>
                  <a:pt x="0" y="1"/>
                  <a:pt x="0" y="1"/>
                </a:cubicBezTo>
                <a:cubicBezTo>
                  <a:pt x="5" y="1"/>
                  <a:pt x="9" y="0"/>
                  <a:pt x="11" y="0"/>
                </a:cubicBezTo>
                <a:close/>
              </a:path>
            </a:pathLst>
          </a:custGeom>
          <a:solidFill>
            <a:srgbClr val="00693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5" name="Freeform 83">
            <a:extLst>
              <a:ext uri="{FF2B5EF4-FFF2-40B4-BE49-F238E27FC236}">
                <a16:creationId xmlns:a16="http://schemas.microsoft.com/office/drawing/2014/main" id="{592E33D5-462A-C219-E3C7-29C9E4FE7BD2}"/>
              </a:ext>
            </a:extLst>
          </p:cNvPr>
          <p:cNvSpPr>
            <a:spLocks/>
          </p:cNvSpPr>
          <p:nvPr/>
        </p:nvSpPr>
        <p:spPr bwMode="auto">
          <a:xfrm>
            <a:off x="1889585" y="3415141"/>
            <a:ext cx="73914" cy="9239"/>
          </a:xfrm>
          <a:custGeom>
            <a:avLst/>
            <a:gdLst>
              <a:gd name="T0" fmla="*/ 17 w 17"/>
              <a:gd name="T1" fmla="*/ 0 h 2"/>
              <a:gd name="T2" fmla="*/ 15 w 17"/>
              <a:gd name="T3" fmla="*/ 0 h 2"/>
              <a:gd name="T4" fmla="*/ 6 w 17"/>
              <a:gd name="T5" fmla="*/ 2 h 2"/>
              <a:gd name="T6" fmla="*/ 5 w 17"/>
              <a:gd name="T7" fmla="*/ 2 h 2"/>
              <a:gd name="T8" fmla="*/ 0 w 17"/>
              <a:gd name="T9" fmla="*/ 2 h 2"/>
              <a:gd name="T10" fmla="*/ 17 w 17"/>
              <a:gd name="T11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" h="2">
                <a:moveTo>
                  <a:pt x="17" y="0"/>
                </a:moveTo>
                <a:cubicBezTo>
                  <a:pt x="15" y="0"/>
                  <a:pt x="15" y="0"/>
                  <a:pt x="15" y="0"/>
                </a:cubicBezTo>
                <a:cubicBezTo>
                  <a:pt x="6" y="2"/>
                  <a:pt x="6" y="2"/>
                  <a:pt x="6" y="2"/>
                </a:cubicBezTo>
                <a:cubicBezTo>
                  <a:pt x="5" y="2"/>
                  <a:pt x="5" y="2"/>
                  <a:pt x="5" y="2"/>
                </a:cubicBezTo>
                <a:cubicBezTo>
                  <a:pt x="0" y="2"/>
                  <a:pt x="0" y="2"/>
                  <a:pt x="0" y="2"/>
                </a:cubicBezTo>
                <a:cubicBezTo>
                  <a:pt x="5" y="2"/>
                  <a:pt x="11" y="1"/>
                  <a:pt x="17" y="0"/>
                </a:cubicBezTo>
                <a:close/>
              </a:path>
            </a:pathLst>
          </a:custGeom>
          <a:solidFill>
            <a:srgbClr val="00693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7" name="Freeform 84">
            <a:extLst>
              <a:ext uri="{FF2B5EF4-FFF2-40B4-BE49-F238E27FC236}">
                <a16:creationId xmlns:a16="http://schemas.microsoft.com/office/drawing/2014/main" id="{72AAEA41-A47F-8509-33CC-A60CC32B10CD}"/>
              </a:ext>
            </a:extLst>
          </p:cNvPr>
          <p:cNvSpPr>
            <a:spLocks/>
          </p:cNvSpPr>
          <p:nvPr/>
        </p:nvSpPr>
        <p:spPr bwMode="auto">
          <a:xfrm>
            <a:off x="1871106" y="3424380"/>
            <a:ext cx="18479" cy="0"/>
          </a:xfrm>
          <a:custGeom>
            <a:avLst/>
            <a:gdLst>
              <a:gd name="T0" fmla="*/ 4 w 4"/>
              <a:gd name="T1" fmla="*/ 0 w 4"/>
              <a:gd name="T2" fmla="*/ 4 w 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4">
                <a:moveTo>
                  <a:pt x="4" y="0"/>
                </a:moveTo>
                <a:cubicBezTo>
                  <a:pt x="3" y="0"/>
                  <a:pt x="1" y="0"/>
                  <a:pt x="0" y="0"/>
                </a:cubicBezTo>
                <a:lnTo>
                  <a:pt x="4" y="0"/>
                </a:lnTo>
                <a:close/>
              </a:path>
            </a:pathLst>
          </a:custGeom>
          <a:solidFill>
            <a:srgbClr val="FFEE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8" name="Freeform 87">
            <a:extLst>
              <a:ext uri="{FF2B5EF4-FFF2-40B4-BE49-F238E27FC236}">
                <a16:creationId xmlns:a16="http://schemas.microsoft.com/office/drawing/2014/main" id="{6C4C6F55-9C91-BFCD-251B-B75A94DE384D}"/>
              </a:ext>
            </a:extLst>
          </p:cNvPr>
          <p:cNvSpPr>
            <a:spLocks noEditPoints="1"/>
          </p:cNvSpPr>
          <p:nvPr/>
        </p:nvSpPr>
        <p:spPr bwMode="auto">
          <a:xfrm>
            <a:off x="160305" y="2605166"/>
            <a:ext cx="1496759" cy="2583910"/>
          </a:xfrm>
          <a:custGeom>
            <a:avLst/>
            <a:gdLst>
              <a:gd name="T0" fmla="*/ 338 w 342"/>
              <a:gd name="T1" fmla="*/ 565 h 590"/>
              <a:gd name="T2" fmla="*/ 320 w 342"/>
              <a:gd name="T3" fmla="*/ 574 h 590"/>
              <a:gd name="T4" fmla="*/ 259 w 342"/>
              <a:gd name="T5" fmla="*/ 568 h 590"/>
              <a:gd name="T6" fmla="*/ 153 w 342"/>
              <a:gd name="T7" fmla="*/ 552 h 590"/>
              <a:gd name="T8" fmla="*/ 53 w 342"/>
              <a:gd name="T9" fmla="*/ 501 h 590"/>
              <a:gd name="T10" fmla="*/ 14 w 342"/>
              <a:gd name="T11" fmla="*/ 550 h 590"/>
              <a:gd name="T12" fmla="*/ 9 w 342"/>
              <a:gd name="T13" fmla="*/ 198 h 590"/>
              <a:gd name="T14" fmla="*/ 39 w 342"/>
              <a:gd name="T15" fmla="*/ 182 h 590"/>
              <a:gd name="T16" fmla="*/ 63 w 342"/>
              <a:gd name="T17" fmla="*/ 164 h 590"/>
              <a:gd name="T18" fmla="*/ 71 w 342"/>
              <a:gd name="T19" fmla="*/ 132 h 590"/>
              <a:gd name="T20" fmla="*/ 66 w 342"/>
              <a:gd name="T21" fmla="*/ 82 h 590"/>
              <a:gd name="T22" fmla="*/ 103 w 342"/>
              <a:gd name="T23" fmla="*/ 100 h 590"/>
              <a:gd name="T24" fmla="*/ 126 w 342"/>
              <a:gd name="T25" fmla="*/ 9 h 590"/>
              <a:gd name="T26" fmla="*/ 149 w 342"/>
              <a:gd name="T27" fmla="*/ 19 h 590"/>
              <a:gd name="T28" fmla="*/ 177 w 342"/>
              <a:gd name="T29" fmla="*/ 66 h 590"/>
              <a:gd name="T30" fmla="*/ 181 w 342"/>
              <a:gd name="T31" fmla="*/ 112 h 590"/>
              <a:gd name="T32" fmla="*/ 183 w 342"/>
              <a:gd name="T33" fmla="*/ 158 h 590"/>
              <a:gd name="T34" fmla="*/ 189 w 342"/>
              <a:gd name="T35" fmla="*/ 178 h 590"/>
              <a:gd name="T36" fmla="*/ 180 w 342"/>
              <a:gd name="T37" fmla="*/ 197 h 590"/>
              <a:gd name="T38" fmla="*/ 158 w 342"/>
              <a:gd name="T39" fmla="*/ 209 h 590"/>
              <a:gd name="T40" fmla="*/ 143 w 342"/>
              <a:gd name="T41" fmla="*/ 228 h 590"/>
              <a:gd name="T42" fmla="*/ 103 w 342"/>
              <a:gd name="T43" fmla="*/ 285 h 590"/>
              <a:gd name="T44" fmla="*/ 45 w 342"/>
              <a:gd name="T45" fmla="*/ 320 h 590"/>
              <a:gd name="T46" fmla="*/ 44 w 342"/>
              <a:gd name="T47" fmla="*/ 336 h 590"/>
              <a:gd name="T48" fmla="*/ 120 w 342"/>
              <a:gd name="T49" fmla="*/ 327 h 590"/>
              <a:gd name="T50" fmla="*/ 207 w 342"/>
              <a:gd name="T51" fmla="*/ 346 h 590"/>
              <a:gd name="T52" fmla="*/ 212 w 342"/>
              <a:gd name="T53" fmla="*/ 373 h 590"/>
              <a:gd name="T54" fmla="*/ 224 w 342"/>
              <a:gd name="T55" fmla="*/ 421 h 590"/>
              <a:gd name="T56" fmla="*/ 254 w 342"/>
              <a:gd name="T57" fmla="*/ 478 h 590"/>
              <a:gd name="T58" fmla="*/ 281 w 342"/>
              <a:gd name="T59" fmla="*/ 495 h 590"/>
              <a:gd name="T60" fmla="*/ 294 w 342"/>
              <a:gd name="T61" fmla="*/ 509 h 590"/>
              <a:gd name="T62" fmla="*/ 309 w 342"/>
              <a:gd name="T63" fmla="*/ 502 h 590"/>
              <a:gd name="T64" fmla="*/ 316 w 342"/>
              <a:gd name="T65" fmla="*/ 495 h 590"/>
              <a:gd name="T66" fmla="*/ 312 w 342"/>
              <a:gd name="T67" fmla="*/ 484 h 590"/>
              <a:gd name="T68" fmla="*/ 299 w 342"/>
              <a:gd name="T69" fmla="*/ 472 h 590"/>
              <a:gd name="T70" fmla="*/ 337 w 342"/>
              <a:gd name="T71" fmla="*/ 486 h 590"/>
              <a:gd name="T72" fmla="*/ 342 w 342"/>
              <a:gd name="T73" fmla="*/ 525 h 590"/>
              <a:gd name="T74" fmla="*/ 230 w 342"/>
              <a:gd name="T75" fmla="*/ 471 h 590"/>
              <a:gd name="T76" fmla="*/ 209 w 342"/>
              <a:gd name="T77" fmla="*/ 440 h 590"/>
              <a:gd name="T78" fmla="*/ 156 w 342"/>
              <a:gd name="T79" fmla="*/ 424 h 590"/>
              <a:gd name="T80" fmla="*/ 155 w 342"/>
              <a:gd name="T81" fmla="*/ 444 h 590"/>
              <a:gd name="T82" fmla="*/ 165 w 342"/>
              <a:gd name="T83" fmla="*/ 444 h 590"/>
              <a:gd name="T84" fmla="*/ 200 w 342"/>
              <a:gd name="T85" fmla="*/ 450 h 590"/>
              <a:gd name="T86" fmla="*/ 224 w 342"/>
              <a:gd name="T87" fmla="*/ 480 h 590"/>
              <a:gd name="T88" fmla="*/ 240 w 342"/>
              <a:gd name="T89" fmla="*/ 510 h 5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342" h="590">
                <a:moveTo>
                  <a:pt x="342" y="525"/>
                </a:moveTo>
                <a:cubicBezTo>
                  <a:pt x="339" y="547"/>
                  <a:pt x="339" y="547"/>
                  <a:pt x="339" y="547"/>
                </a:cubicBezTo>
                <a:cubicBezTo>
                  <a:pt x="339" y="547"/>
                  <a:pt x="339" y="558"/>
                  <a:pt x="338" y="565"/>
                </a:cubicBezTo>
                <a:cubicBezTo>
                  <a:pt x="337" y="572"/>
                  <a:pt x="338" y="581"/>
                  <a:pt x="338" y="581"/>
                </a:cubicBezTo>
                <a:cubicBezTo>
                  <a:pt x="338" y="590"/>
                  <a:pt x="338" y="590"/>
                  <a:pt x="338" y="590"/>
                </a:cubicBezTo>
                <a:cubicBezTo>
                  <a:pt x="330" y="584"/>
                  <a:pt x="322" y="577"/>
                  <a:pt x="320" y="574"/>
                </a:cubicBezTo>
                <a:cubicBezTo>
                  <a:pt x="316" y="571"/>
                  <a:pt x="307" y="572"/>
                  <a:pt x="307" y="572"/>
                </a:cubicBezTo>
                <a:cubicBezTo>
                  <a:pt x="307" y="572"/>
                  <a:pt x="294" y="572"/>
                  <a:pt x="284" y="572"/>
                </a:cubicBezTo>
                <a:cubicBezTo>
                  <a:pt x="275" y="571"/>
                  <a:pt x="269" y="564"/>
                  <a:pt x="259" y="568"/>
                </a:cubicBezTo>
                <a:cubicBezTo>
                  <a:pt x="249" y="571"/>
                  <a:pt x="238" y="571"/>
                  <a:pt x="228" y="568"/>
                </a:cubicBezTo>
                <a:cubicBezTo>
                  <a:pt x="219" y="564"/>
                  <a:pt x="209" y="569"/>
                  <a:pt x="190" y="570"/>
                </a:cubicBezTo>
                <a:cubicBezTo>
                  <a:pt x="170" y="570"/>
                  <a:pt x="163" y="560"/>
                  <a:pt x="153" y="552"/>
                </a:cubicBezTo>
                <a:cubicBezTo>
                  <a:pt x="144" y="543"/>
                  <a:pt x="129" y="535"/>
                  <a:pt x="129" y="535"/>
                </a:cubicBezTo>
                <a:cubicBezTo>
                  <a:pt x="129" y="535"/>
                  <a:pt x="116" y="528"/>
                  <a:pt x="91" y="507"/>
                </a:cubicBezTo>
                <a:cubicBezTo>
                  <a:pt x="65" y="486"/>
                  <a:pt x="57" y="499"/>
                  <a:pt x="53" y="501"/>
                </a:cubicBezTo>
                <a:cubicBezTo>
                  <a:pt x="50" y="503"/>
                  <a:pt x="41" y="514"/>
                  <a:pt x="39" y="517"/>
                </a:cubicBezTo>
                <a:cubicBezTo>
                  <a:pt x="37" y="521"/>
                  <a:pt x="36" y="527"/>
                  <a:pt x="30" y="532"/>
                </a:cubicBezTo>
                <a:cubicBezTo>
                  <a:pt x="24" y="537"/>
                  <a:pt x="19" y="541"/>
                  <a:pt x="14" y="550"/>
                </a:cubicBezTo>
                <a:cubicBezTo>
                  <a:pt x="8" y="559"/>
                  <a:pt x="0" y="563"/>
                  <a:pt x="0" y="563"/>
                </a:cubicBezTo>
                <a:cubicBezTo>
                  <a:pt x="0" y="205"/>
                  <a:pt x="0" y="205"/>
                  <a:pt x="0" y="205"/>
                </a:cubicBezTo>
                <a:cubicBezTo>
                  <a:pt x="0" y="205"/>
                  <a:pt x="7" y="202"/>
                  <a:pt x="9" y="198"/>
                </a:cubicBezTo>
                <a:cubicBezTo>
                  <a:pt x="11" y="195"/>
                  <a:pt x="14" y="180"/>
                  <a:pt x="15" y="173"/>
                </a:cubicBezTo>
                <a:cubicBezTo>
                  <a:pt x="16" y="167"/>
                  <a:pt x="20" y="164"/>
                  <a:pt x="31" y="178"/>
                </a:cubicBezTo>
                <a:cubicBezTo>
                  <a:pt x="43" y="192"/>
                  <a:pt x="38" y="186"/>
                  <a:pt x="39" y="182"/>
                </a:cubicBezTo>
                <a:cubicBezTo>
                  <a:pt x="40" y="178"/>
                  <a:pt x="41" y="173"/>
                  <a:pt x="49" y="173"/>
                </a:cubicBezTo>
                <a:cubicBezTo>
                  <a:pt x="57" y="174"/>
                  <a:pt x="57" y="172"/>
                  <a:pt x="59" y="168"/>
                </a:cubicBezTo>
                <a:cubicBezTo>
                  <a:pt x="61" y="165"/>
                  <a:pt x="59" y="164"/>
                  <a:pt x="63" y="164"/>
                </a:cubicBezTo>
                <a:cubicBezTo>
                  <a:pt x="67" y="163"/>
                  <a:pt x="70" y="164"/>
                  <a:pt x="73" y="160"/>
                </a:cubicBezTo>
                <a:cubicBezTo>
                  <a:pt x="75" y="156"/>
                  <a:pt x="76" y="152"/>
                  <a:pt x="78" y="146"/>
                </a:cubicBezTo>
                <a:cubicBezTo>
                  <a:pt x="80" y="140"/>
                  <a:pt x="76" y="138"/>
                  <a:pt x="71" y="132"/>
                </a:cubicBezTo>
                <a:cubicBezTo>
                  <a:pt x="66" y="126"/>
                  <a:pt x="66" y="122"/>
                  <a:pt x="70" y="112"/>
                </a:cubicBezTo>
                <a:cubicBezTo>
                  <a:pt x="74" y="102"/>
                  <a:pt x="66" y="98"/>
                  <a:pt x="62" y="86"/>
                </a:cubicBezTo>
                <a:cubicBezTo>
                  <a:pt x="57" y="74"/>
                  <a:pt x="66" y="82"/>
                  <a:pt x="66" y="82"/>
                </a:cubicBezTo>
                <a:cubicBezTo>
                  <a:pt x="73" y="88"/>
                  <a:pt x="73" y="88"/>
                  <a:pt x="73" y="88"/>
                </a:cubicBezTo>
                <a:cubicBezTo>
                  <a:pt x="73" y="88"/>
                  <a:pt x="79" y="99"/>
                  <a:pt x="99" y="114"/>
                </a:cubicBezTo>
                <a:cubicBezTo>
                  <a:pt x="118" y="130"/>
                  <a:pt x="105" y="108"/>
                  <a:pt x="103" y="100"/>
                </a:cubicBezTo>
                <a:cubicBezTo>
                  <a:pt x="101" y="92"/>
                  <a:pt x="105" y="68"/>
                  <a:pt x="106" y="63"/>
                </a:cubicBezTo>
                <a:cubicBezTo>
                  <a:pt x="107" y="58"/>
                  <a:pt x="107" y="45"/>
                  <a:pt x="110" y="35"/>
                </a:cubicBezTo>
                <a:cubicBezTo>
                  <a:pt x="113" y="25"/>
                  <a:pt x="111" y="19"/>
                  <a:pt x="126" y="9"/>
                </a:cubicBezTo>
                <a:cubicBezTo>
                  <a:pt x="132" y="4"/>
                  <a:pt x="134" y="2"/>
                  <a:pt x="134" y="0"/>
                </a:cubicBezTo>
                <a:cubicBezTo>
                  <a:pt x="141" y="0"/>
                  <a:pt x="141" y="0"/>
                  <a:pt x="141" y="0"/>
                </a:cubicBezTo>
                <a:cubicBezTo>
                  <a:pt x="142" y="9"/>
                  <a:pt x="144" y="16"/>
                  <a:pt x="149" y="19"/>
                </a:cubicBezTo>
                <a:cubicBezTo>
                  <a:pt x="163" y="27"/>
                  <a:pt x="167" y="39"/>
                  <a:pt x="167" y="39"/>
                </a:cubicBezTo>
                <a:cubicBezTo>
                  <a:pt x="167" y="39"/>
                  <a:pt x="167" y="39"/>
                  <a:pt x="167" y="39"/>
                </a:cubicBezTo>
                <a:cubicBezTo>
                  <a:pt x="166" y="42"/>
                  <a:pt x="171" y="54"/>
                  <a:pt x="177" y="66"/>
                </a:cubicBezTo>
                <a:cubicBezTo>
                  <a:pt x="188" y="84"/>
                  <a:pt x="186" y="88"/>
                  <a:pt x="181" y="92"/>
                </a:cubicBezTo>
                <a:cubicBezTo>
                  <a:pt x="177" y="97"/>
                  <a:pt x="178" y="98"/>
                  <a:pt x="181" y="103"/>
                </a:cubicBezTo>
                <a:cubicBezTo>
                  <a:pt x="184" y="108"/>
                  <a:pt x="181" y="112"/>
                  <a:pt x="181" y="112"/>
                </a:cubicBezTo>
                <a:cubicBezTo>
                  <a:pt x="181" y="112"/>
                  <a:pt x="176" y="120"/>
                  <a:pt x="171" y="128"/>
                </a:cubicBezTo>
                <a:cubicBezTo>
                  <a:pt x="166" y="136"/>
                  <a:pt x="167" y="140"/>
                  <a:pt x="167" y="140"/>
                </a:cubicBezTo>
                <a:cubicBezTo>
                  <a:pt x="167" y="140"/>
                  <a:pt x="173" y="148"/>
                  <a:pt x="183" y="158"/>
                </a:cubicBezTo>
                <a:cubicBezTo>
                  <a:pt x="193" y="169"/>
                  <a:pt x="190" y="166"/>
                  <a:pt x="184" y="169"/>
                </a:cubicBezTo>
                <a:cubicBezTo>
                  <a:pt x="178" y="172"/>
                  <a:pt x="178" y="173"/>
                  <a:pt x="177" y="179"/>
                </a:cubicBezTo>
                <a:cubicBezTo>
                  <a:pt x="175" y="186"/>
                  <a:pt x="177" y="182"/>
                  <a:pt x="189" y="178"/>
                </a:cubicBezTo>
                <a:cubicBezTo>
                  <a:pt x="200" y="174"/>
                  <a:pt x="196" y="186"/>
                  <a:pt x="193" y="188"/>
                </a:cubicBezTo>
                <a:cubicBezTo>
                  <a:pt x="190" y="191"/>
                  <a:pt x="188" y="187"/>
                  <a:pt x="191" y="201"/>
                </a:cubicBezTo>
                <a:cubicBezTo>
                  <a:pt x="194" y="214"/>
                  <a:pt x="184" y="203"/>
                  <a:pt x="180" y="197"/>
                </a:cubicBezTo>
                <a:cubicBezTo>
                  <a:pt x="177" y="191"/>
                  <a:pt x="167" y="197"/>
                  <a:pt x="167" y="197"/>
                </a:cubicBezTo>
                <a:cubicBezTo>
                  <a:pt x="163" y="201"/>
                  <a:pt x="163" y="201"/>
                  <a:pt x="163" y="201"/>
                </a:cubicBezTo>
                <a:cubicBezTo>
                  <a:pt x="158" y="209"/>
                  <a:pt x="158" y="209"/>
                  <a:pt x="158" y="209"/>
                </a:cubicBezTo>
                <a:cubicBezTo>
                  <a:pt x="151" y="216"/>
                  <a:pt x="151" y="216"/>
                  <a:pt x="151" y="216"/>
                </a:cubicBezTo>
                <a:cubicBezTo>
                  <a:pt x="146" y="223"/>
                  <a:pt x="146" y="223"/>
                  <a:pt x="146" y="223"/>
                </a:cubicBezTo>
                <a:cubicBezTo>
                  <a:pt x="143" y="228"/>
                  <a:pt x="143" y="228"/>
                  <a:pt x="143" y="228"/>
                </a:cubicBezTo>
                <a:cubicBezTo>
                  <a:pt x="138" y="235"/>
                  <a:pt x="138" y="235"/>
                  <a:pt x="138" y="235"/>
                </a:cubicBezTo>
                <a:cubicBezTo>
                  <a:pt x="138" y="235"/>
                  <a:pt x="130" y="240"/>
                  <a:pt x="121" y="250"/>
                </a:cubicBezTo>
                <a:cubicBezTo>
                  <a:pt x="111" y="259"/>
                  <a:pt x="118" y="258"/>
                  <a:pt x="103" y="285"/>
                </a:cubicBezTo>
                <a:cubicBezTo>
                  <a:pt x="88" y="313"/>
                  <a:pt x="76" y="305"/>
                  <a:pt x="53" y="307"/>
                </a:cubicBezTo>
                <a:cubicBezTo>
                  <a:pt x="33" y="309"/>
                  <a:pt x="39" y="313"/>
                  <a:pt x="44" y="318"/>
                </a:cubicBezTo>
                <a:cubicBezTo>
                  <a:pt x="44" y="319"/>
                  <a:pt x="45" y="319"/>
                  <a:pt x="45" y="320"/>
                </a:cubicBezTo>
                <a:cubicBezTo>
                  <a:pt x="46" y="321"/>
                  <a:pt x="47" y="322"/>
                  <a:pt x="47" y="323"/>
                </a:cubicBezTo>
                <a:cubicBezTo>
                  <a:pt x="47" y="323"/>
                  <a:pt x="47" y="323"/>
                  <a:pt x="47" y="323"/>
                </a:cubicBezTo>
                <a:cubicBezTo>
                  <a:pt x="48" y="326"/>
                  <a:pt x="47" y="328"/>
                  <a:pt x="44" y="336"/>
                </a:cubicBezTo>
                <a:cubicBezTo>
                  <a:pt x="41" y="345"/>
                  <a:pt x="56" y="340"/>
                  <a:pt x="70" y="330"/>
                </a:cubicBezTo>
                <a:cubicBezTo>
                  <a:pt x="85" y="321"/>
                  <a:pt x="102" y="325"/>
                  <a:pt x="102" y="325"/>
                </a:cubicBezTo>
                <a:cubicBezTo>
                  <a:pt x="120" y="327"/>
                  <a:pt x="120" y="327"/>
                  <a:pt x="120" y="327"/>
                </a:cubicBezTo>
                <a:cubicBezTo>
                  <a:pt x="141" y="330"/>
                  <a:pt x="141" y="330"/>
                  <a:pt x="141" y="330"/>
                </a:cubicBezTo>
                <a:cubicBezTo>
                  <a:pt x="141" y="330"/>
                  <a:pt x="146" y="330"/>
                  <a:pt x="177" y="330"/>
                </a:cubicBezTo>
                <a:cubicBezTo>
                  <a:pt x="207" y="331"/>
                  <a:pt x="207" y="345"/>
                  <a:pt x="207" y="346"/>
                </a:cubicBezTo>
                <a:cubicBezTo>
                  <a:pt x="209" y="353"/>
                  <a:pt x="209" y="353"/>
                  <a:pt x="209" y="353"/>
                </a:cubicBezTo>
                <a:cubicBezTo>
                  <a:pt x="209" y="366"/>
                  <a:pt x="209" y="366"/>
                  <a:pt x="209" y="366"/>
                </a:cubicBezTo>
                <a:cubicBezTo>
                  <a:pt x="212" y="373"/>
                  <a:pt x="212" y="373"/>
                  <a:pt x="212" y="373"/>
                </a:cubicBezTo>
                <a:cubicBezTo>
                  <a:pt x="212" y="389"/>
                  <a:pt x="212" y="389"/>
                  <a:pt x="212" y="389"/>
                </a:cubicBezTo>
                <a:cubicBezTo>
                  <a:pt x="212" y="389"/>
                  <a:pt x="211" y="406"/>
                  <a:pt x="214" y="417"/>
                </a:cubicBezTo>
                <a:cubicBezTo>
                  <a:pt x="218" y="427"/>
                  <a:pt x="219" y="428"/>
                  <a:pt x="224" y="421"/>
                </a:cubicBezTo>
                <a:cubicBezTo>
                  <a:pt x="228" y="413"/>
                  <a:pt x="243" y="438"/>
                  <a:pt x="243" y="438"/>
                </a:cubicBezTo>
                <a:cubicBezTo>
                  <a:pt x="243" y="438"/>
                  <a:pt x="240" y="450"/>
                  <a:pt x="246" y="456"/>
                </a:cubicBezTo>
                <a:cubicBezTo>
                  <a:pt x="252" y="463"/>
                  <a:pt x="253" y="472"/>
                  <a:pt x="254" y="478"/>
                </a:cubicBezTo>
                <a:cubicBezTo>
                  <a:pt x="255" y="483"/>
                  <a:pt x="257" y="489"/>
                  <a:pt x="267" y="500"/>
                </a:cubicBezTo>
                <a:cubicBezTo>
                  <a:pt x="277" y="510"/>
                  <a:pt x="273" y="498"/>
                  <a:pt x="272" y="495"/>
                </a:cubicBezTo>
                <a:cubicBezTo>
                  <a:pt x="281" y="495"/>
                  <a:pt x="281" y="495"/>
                  <a:pt x="281" y="495"/>
                </a:cubicBezTo>
                <a:cubicBezTo>
                  <a:pt x="287" y="504"/>
                  <a:pt x="287" y="504"/>
                  <a:pt x="287" y="504"/>
                </a:cubicBezTo>
                <a:cubicBezTo>
                  <a:pt x="291" y="509"/>
                  <a:pt x="291" y="509"/>
                  <a:pt x="291" y="509"/>
                </a:cubicBezTo>
                <a:cubicBezTo>
                  <a:pt x="294" y="509"/>
                  <a:pt x="294" y="509"/>
                  <a:pt x="294" y="509"/>
                </a:cubicBezTo>
                <a:cubicBezTo>
                  <a:pt x="299" y="504"/>
                  <a:pt x="299" y="504"/>
                  <a:pt x="299" y="504"/>
                </a:cubicBezTo>
                <a:cubicBezTo>
                  <a:pt x="304" y="502"/>
                  <a:pt x="304" y="502"/>
                  <a:pt x="304" y="502"/>
                </a:cubicBezTo>
                <a:cubicBezTo>
                  <a:pt x="309" y="502"/>
                  <a:pt x="309" y="502"/>
                  <a:pt x="309" y="502"/>
                </a:cubicBezTo>
                <a:cubicBezTo>
                  <a:pt x="311" y="502"/>
                  <a:pt x="311" y="502"/>
                  <a:pt x="311" y="502"/>
                </a:cubicBezTo>
                <a:cubicBezTo>
                  <a:pt x="314" y="500"/>
                  <a:pt x="314" y="500"/>
                  <a:pt x="314" y="500"/>
                </a:cubicBezTo>
                <a:cubicBezTo>
                  <a:pt x="316" y="495"/>
                  <a:pt x="316" y="495"/>
                  <a:pt x="316" y="495"/>
                </a:cubicBezTo>
                <a:cubicBezTo>
                  <a:pt x="316" y="493"/>
                  <a:pt x="316" y="493"/>
                  <a:pt x="316" y="493"/>
                </a:cubicBezTo>
                <a:cubicBezTo>
                  <a:pt x="312" y="490"/>
                  <a:pt x="312" y="490"/>
                  <a:pt x="312" y="490"/>
                </a:cubicBezTo>
                <a:cubicBezTo>
                  <a:pt x="312" y="484"/>
                  <a:pt x="312" y="484"/>
                  <a:pt x="312" y="484"/>
                </a:cubicBezTo>
                <a:cubicBezTo>
                  <a:pt x="312" y="484"/>
                  <a:pt x="311" y="480"/>
                  <a:pt x="310" y="480"/>
                </a:cubicBezTo>
                <a:cubicBezTo>
                  <a:pt x="308" y="480"/>
                  <a:pt x="303" y="476"/>
                  <a:pt x="303" y="476"/>
                </a:cubicBezTo>
                <a:cubicBezTo>
                  <a:pt x="299" y="472"/>
                  <a:pt x="299" y="472"/>
                  <a:pt x="299" y="472"/>
                </a:cubicBezTo>
                <a:cubicBezTo>
                  <a:pt x="307" y="469"/>
                  <a:pt x="307" y="469"/>
                  <a:pt x="307" y="469"/>
                </a:cubicBezTo>
                <a:cubicBezTo>
                  <a:pt x="309" y="472"/>
                  <a:pt x="322" y="474"/>
                  <a:pt x="326" y="473"/>
                </a:cubicBezTo>
                <a:cubicBezTo>
                  <a:pt x="333" y="473"/>
                  <a:pt x="337" y="482"/>
                  <a:pt x="337" y="486"/>
                </a:cubicBezTo>
                <a:cubicBezTo>
                  <a:pt x="336" y="490"/>
                  <a:pt x="342" y="496"/>
                  <a:pt x="342" y="496"/>
                </a:cubicBezTo>
                <a:cubicBezTo>
                  <a:pt x="342" y="496"/>
                  <a:pt x="342" y="503"/>
                  <a:pt x="342" y="519"/>
                </a:cubicBezTo>
                <a:cubicBezTo>
                  <a:pt x="342" y="523"/>
                  <a:pt x="342" y="525"/>
                  <a:pt x="342" y="525"/>
                </a:cubicBezTo>
                <a:close/>
                <a:moveTo>
                  <a:pt x="245" y="500"/>
                </a:moveTo>
                <a:cubicBezTo>
                  <a:pt x="246" y="496"/>
                  <a:pt x="241" y="486"/>
                  <a:pt x="239" y="484"/>
                </a:cubicBezTo>
                <a:cubicBezTo>
                  <a:pt x="238" y="483"/>
                  <a:pt x="232" y="477"/>
                  <a:pt x="230" y="471"/>
                </a:cubicBezTo>
                <a:cubicBezTo>
                  <a:pt x="229" y="465"/>
                  <a:pt x="226" y="458"/>
                  <a:pt x="221" y="460"/>
                </a:cubicBezTo>
                <a:cubicBezTo>
                  <a:pt x="216" y="462"/>
                  <a:pt x="214" y="456"/>
                  <a:pt x="214" y="456"/>
                </a:cubicBezTo>
                <a:cubicBezTo>
                  <a:pt x="214" y="456"/>
                  <a:pt x="209" y="442"/>
                  <a:pt x="209" y="440"/>
                </a:cubicBezTo>
                <a:cubicBezTo>
                  <a:pt x="209" y="438"/>
                  <a:pt x="200" y="430"/>
                  <a:pt x="197" y="428"/>
                </a:cubicBezTo>
                <a:cubicBezTo>
                  <a:pt x="195" y="426"/>
                  <a:pt x="179" y="421"/>
                  <a:pt x="179" y="421"/>
                </a:cubicBezTo>
                <a:cubicBezTo>
                  <a:pt x="179" y="421"/>
                  <a:pt x="165" y="424"/>
                  <a:pt x="156" y="424"/>
                </a:cubicBezTo>
                <a:cubicBezTo>
                  <a:pt x="148" y="424"/>
                  <a:pt x="149" y="427"/>
                  <a:pt x="149" y="427"/>
                </a:cubicBezTo>
                <a:cubicBezTo>
                  <a:pt x="149" y="433"/>
                  <a:pt x="149" y="433"/>
                  <a:pt x="149" y="433"/>
                </a:cubicBezTo>
                <a:cubicBezTo>
                  <a:pt x="155" y="444"/>
                  <a:pt x="155" y="444"/>
                  <a:pt x="155" y="444"/>
                </a:cubicBezTo>
                <a:cubicBezTo>
                  <a:pt x="164" y="460"/>
                  <a:pt x="164" y="460"/>
                  <a:pt x="164" y="460"/>
                </a:cubicBezTo>
                <a:cubicBezTo>
                  <a:pt x="164" y="460"/>
                  <a:pt x="164" y="460"/>
                  <a:pt x="166" y="463"/>
                </a:cubicBezTo>
                <a:cubicBezTo>
                  <a:pt x="169" y="466"/>
                  <a:pt x="167" y="448"/>
                  <a:pt x="165" y="444"/>
                </a:cubicBezTo>
                <a:cubicBezTo>
                  <a:pt x="163" y="440"/>
                  <a:pt x="164" y="437"/>
                  <a:pt x="166" y="434"/>
                </a:cubicBezTo>
                <a:cubicBezTo>
                  <a:pt x="169" y="432"/>
                  <a:pt x="181" y="430"/>
                  <a:pt x="187" y="431"/>
                </a:cubicBezTo>
                <a:cubicBezTo>
                  <a:pt x="193" y="432"/>
                  <a:pt x="200" y="450"/>
                  <a:pt x="200" y="450"/>
                </a:cubicBezTo>
                <a:cubicBezTo>
                  <a:pt x="200" y="450"/>
                  <a:pt x="210" y="471"/>
                  <a:pt x="213" y="474"/>
                </a:cubicBezTo>
                <a:cubicBezTo>
                  <a:pt x="215" y="478"/>
                  <a:pt x="218" y="498"/>
                  <a:pt x="219" y="495"/>
                </a:cubicBezTo>
                <a:cubicBezTo>
                  <a:pt x="219" y="493"/>
                  <a:pt x="222" y="476"/>
                  <a:pt x="224" y="480"/>
                </a:cubicBezTo>
                <a:cubicBezTo>
                  <a:pt x="226" y="483"/>
                  <a:pt x="231" y="496"/>
                  <a:pt x="230" y="510"/>
                </a:cubicBezTo>
                <a:cubicBezTo>
                  <a:pt x="229" y="524"/>
                  <a:pt x="236" y="515"/>
                  <a:pt x="236" y="514"/>
                </a:cubicBezTo>
                <a:cubicBezTo>
                  <a:pt x="236" y="514"/>
                  <a:pt x="235" y="506"/>
                  <a:pt x="240" y="510"/>
                </a:cubicBezTo>
                <a:cubicBezTo>
                  <a:pt x="245" y="516"/>
                  <a:pt x="244" y="505"/>
                  <a:pt x="245" y="500"/>
                </a:cubicBezTo>
                <a:close/>
              </a:path>
            </a:pathLst>
          </a:cu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76" name="Freeform 90">
            <a:extLst>
              <a:ext uri="{FF2B5EF4-FFF2-40B4-BE49-F238E27FC236}">
                <a16:creationId xmlns:a16="http://schemas.microsoft.com/office/drawing/2014/main" id="{D9D6F51A-A6C2-8A7D-BE90-062A4E2F675F}"/>
              </a:ext>
            </a:extLst>
          </p:cNvPr>
          <p:cNvSpPr>
            <a:spLocks/>
          </p:cNvSpPr>
          <p:nvPr/>
        </p:nvSpPr>
        <p:spPr bwMode="auto">
          <a:xfrm>
            <a:off x="706961" y="244538"/>
            <a:ext cx="626730" cy="609791"/>
          </a:xfrm>
          <a:custGeom>
            <a:avLst/>
            <a:gdLst>
              <a:gd name="T0" fmla="*/ 121 w 143"/>
              <a:gd name="T1" fmla="*/ 111 h 139"/>
              <a:gd name="T2" fmla="*/ 119 w 143"/>
              <a:gd name="T3" fmla="*/ 125 h 139"/>
              <a:gd name="T4" fmla="*/ 103 w 143"/>
              <a:gd name="T5" fmla="*/ 130 h 139"/>
              <a:gd name="T6" fmla="*/ 76 w 143"/>
              <a:gd name="T7" fmla="*/ 137 h 139"/>
              <a:gd name="T8" fmla="*/ 43 w 143"/>
              <a:gd name="T9" fmla="*/ 134 h 139"/>
              <a:gd name="T10" fmla="*/ 19 w 143"/>
              <a:gd name="T11" fmla="*/ 125 h 139"/>
              <a:gd name="T12" fmla="*/ 10 w 143"/>
              <a:gd name="T13" fmla="*/ 125 h 139"/>
              <a:gd name="T14" fmla="*/ 10 w 143"/>
              <a:gd name="T15" fmla="*/ 118 h 139"/>
              <a:gd name="T16" fmla="*/ 15 w 143"/>
              <a:gd name="T17" fmla="*/ 109 h 139"/>
              <a:gd name="T18" fmla="*/ 22 w 143"/>
              <a:gd name="T19" fmla="*/ 99 h 139"/>
              <a:gd name="T20" fmla="*/ 21 w 143"/>
              <a:gd name="T21" fmla="*/ 89 h 139"/>
              <a:gd name="T22" fmla="*/ 10 w 143"/>
              <a:gd name="T23" fmla="*/ 59 h 139"/>
              <a:gd name="T24" fmla="*/ 21 w 143"/>
              <a:gd name="T25" fmla="*/ 39 h 139"/>
              <a:gd name="T26" fmla="*/ 53 w 143"/>
              <a:gd name="T27" fmla="*/ 60 h 139"/>
              <a:gd name="T28" fmla="*/ 66 w 143"/>
              <a:gd name="T29" fmla="*/ 41 h 139"/>
              <a:gd name="T30" fmla="*/ 62 w 143"/>
              <a:gd name="T31" fmla="*/ 0 h 139"/>
              <a:gd name="T32" fmla="*/ 78 w 143"/>
              <a:gd name="T33" fmla="*/ 30 h 139"/>
              <a:gd name="T34" fmla="*/ 93 w 143"/>
              <a:gd name="T35" fmla="*/ 77 h 139"/>
              <a:gd name="T36" fmla="*/ 97 w 143"/>
              <a:gd name="T37" fmla="*/ 91 h 139"/>
              <a:gd name="T38" fmla="*/ 121 w 143"/>
              <a:gd name="T39" fmla="*/ 111 h 1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43" h="139">
                <a:moveTo>
                  <a:pt x="121" y="111"/>
                </a:moveTo>
                <a:cubicBezTo>
                  <a:pt x="143" y="113"/>
                  <a:pt x="143" y="123"/>
                  <a:pt x="119" y="125"/>
                </a:cubicBezTo>
                <a:cubicBezTo>
                  <a:pt x="94" y="129"/>
                  <a:pt x="110" y="129"/>
                  <a:pt x="103" y="130"/>
                </a:cubicBezTo>
                <a:cubicBezTo>
                  <a:pt x="96" y="131"/>
                  <a:pt x="85" y="137"/>
                  <a:pt x="76" y="137"/>
                </a:cubicBezTo>
                <a:cubicBezTo>
                  <a:pt x="68" y="137"/>
                  <a:pt x="52" y="139"/>
                  <a:pt x="43" y="134"/>
                </a:cubicBezTo>
                <a:cubicBezTo>
                  <a:pt x="34" y="129"/>
                  <a:pt x="24" y="126"/>
                  <a:pt x="19" y="125"/>
                </a:cubicBezTo>
                <a:cubicBezTo>
                  <a:pt x="17" y="125"/>
                  <a:pt x="14" y="125"/>
                  <a:pt x="10" y="125"/>
                </a:cubicBezTo>
                <a:cubicBezTo>
                  <a:pt x="10" y="125"/>
                  <a:pt x="11" y="123"/>
                  <a:pt x="10" y="118"/>
                </a:cubicBezTo>
                <a:cubicBezTo>
                  <a:pt x="10" y="113"/>
                  <a:pt x="12" y="113"/>
                  <a:pt x="15" y="109"/>
                </a:cubicBezTo>
                <a:cubicBezTo>
                  <a:pt x="17" y="105"/>
                  <a:pt x="24" y="103"/>
                  <a:pt x="22" y="99"/>
                </a:cubicBezTo>
                <a:cubicBezTo>
                  <a:pt x="20" y="95"/>
                  <a:pt x="18" y="93"/>
                  <a:pt x="21" y="89"/>
                </a:cubicBezTo>
                <a:cubicBezTo>
                  <a:pt x="24" y="83"/>
                  <a:pt x="20" y="81"/>
                  <a:pt x="10" y="59"/>
                </a:cubicBezTo>
                <a:cubicBezTo>
                  <a:pt x="0" y="37"/>
                  <a:pt x="8" y="43"/>
                  <a:pt x="21" y="39"/>
                </a:cubicBezTo>
                <a:cubicBezTo>
                  <a:pt x="34" y="37"/>
                  <a:pt x="30" y="43"/>
                  <a:pt x="53" y="60"/>
                </a:cubicBezTo>
                <a:cubicBezTo>
                  <a:pt x="75" y="77"/>
                  <a:pt x="73" y="61"/>
                  <a:pt x="66" y="41"/>
                </a:cubicBezTo>
                <a:cubicBezTo>
                  <a:pt x="59" y="21"/>
                  <a:pt x="62" y="0"/>
                  <a:pt x="62" y="0"/>
                </a:cubicBezTo>
                <a:cubicBezTo>
                  <a:pt x="76" y="13"/>
                  <a:pt x="76" y="22"/>
                  <a:pt x="78" y="30"/>
                </a:cubicBezTo>
                <a:cubicBezTo>
                  <a:pt x="80" y="39"/>
                  <a:pt x="89" y="73"/>
                  <a:pt x="93" y="77"/>
                </a:cubicBezTo>
                <a:cubicBezTo>
                  <a:pt x="97" y="81"/>
                  <a:pt x="97" y="91"/>
                  <a:pt x="97" y="91"/>
                </a:cubicBezTo>
                <a:cubicBezTo>
                  <a:pt x="97" y="91"/>
                  <a:pt x="100" y="109"/>
                  <a:pt x="121" y="111"/>
                </a:cubicBezTo>
                <a:close/>
              </a:path>
            </a:pathLst>
          </a:custGeom>
          <a:solidFill>
            <a:srgbClr val="F2F2F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77" name="Freeform 93">
            <a:extLst>
              <a:ext uri="{FF2B5EF4-FFF2-40B4-BE49-F238E27FC236}">
                <a16:creationId xmlns:a16="http://schemas.microsoft.com/office/drawing/2014/main" id="{3EC7D188-F61B-6D50-4369-E3F32EB170AD}"/>
              </a:ext>
            </a:extLst>
          </p:cNvPr>
          <p:cNvSpPr>
            <a:spLocks/>
          </p:cNvSpPr>
          <p:nvPr/>
        </p:nvSpPr>
        <p:spPr bwMode="auto">
          <a:xfrm>
            <a:off x="514476" y="2201719"/>
            <a:ext cx="375730" cy="481981"/>
          </a:xfrm>
          <a:custGeom>
            <a:avLst/>
            <a:gdLst>
              <a:gd name="T0" fmla="*/ 86 w 86"/>
              <a:gd name="T1" fmla="*/ 41 h 110"/>
              <a:gd name="T2" fmla="*/ 68 w 86"/>
              <a:gd name="T3" fmla="*/ 56 h 110"/>
              <a:gd name="T4" fmla="*/ 60 w 86"/>
              <a:gd name="T5" fmla="*/ 92 h 110"/>
              <a:gd name="T6" fmla="*/ 53 w 86"/>
              <a:gd name="T7" fmla="*/ 92 h 110"/>
              <a:gd name="T8" fmla="*/ 50 w 86"/>
              <a:gd name="T9" fmla="*/ 91 h 110"/>
              <a:gd name="T10" fmla="*/ 41 w 86"/>
              <a:gd name="T11" fmla="*/ 86 h 110"/>
              <a:gd name="T12" fmla="*/ 29 w 86"/>
              <a:gd name="T13" fmla="*/ 75 h 110"/>
              <a:gd name="T14" fmla="*/ 16 w 86"/>
              <a:gd name="T15" fmla="*/ 86 h 110"/>
              <a:gd name="T16" fmla="*/ 6 w 86"/>
              <a:gd name="T17" fmla="*/ 91 h 110"/>
              <a:gd name="T18" fmla="*/ 2 w 86"/>
              <a:gd name="T19" fmla="*/ 64 h 110"/>
              <a:gd name="T20" fmla="*/ 14 w 86"/>
              <a:gd name="T21" fmla="*/ 36 h 110"/>
              <a:gd name="T22" fmla="*/ 21 w 86"/>
              <a:gd name="T23" fmla="*/ 22 h 110"/>
              <a:gd name="T24" fmla="*/ 39 w 86"/>
              <a:gd name="T25" fmla="*/ 25 h 110"/>
              <a:gd name="T26" fmla="*/ 63 w 86"/>
              <a:gd name="T27" fmla="*/ 30 h 110"/>
              <a:gd name="T28" fmla="*/ 86 w 86"/>
              <a:gd name="T29" fmla="*/ 41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6" h="110">
                <a:moveTo>
                  <a:pt x="86" y="41"/>
                </a:moveTo>
                <a:cubicBezTo>
                  <a:pt x="86" y="41"/>
                  <a:pt x="79" y="47"/>
                  <a:pt x="68" y="56"/>
                </a:cubicBezTo>
                <a:cubicBezTo>
                  <a:pt x="62" y="62"/>
                  <a:pt x="58" y="78"/>
                  <a:pt x="60" y="92"/>
                </a:cubicBezTo>
                <a:cubicBezTo>
                  <a:pt x="53" y="92"/>
                  <a:pt x="53" y="92"/>
                  <a:pt x="53" y="92"/>
                </a:cubicBezTo>
                <a:cubicBezTo>
                  <a:pt x="53" y="91"/>
                  <a:pt x="50" y="91"/>
                  <a:pt x="50" y="91"/>
                </a:cubicBezTo>
                <a:cubicBezTo>
                  <a:pt x="50" y="91"/>
                  <a:pt x="47" y="90"/>
                  <a:pt x="41" y="86"/>
                </a:cubicBezTo>
                <a:cubicBezTo>
                  <a:pt x="34" y="82"/>
                  <a:pt x="27" y="89"/>
                  <a:pt x="29" y="75"/>
                </a:cubicBezTo>
                <a:cubicBezTo>
                  <a:pt x="30" y="61"/>
                  <a:pt x="24" y="62"/>
                  <a:pt x="16" y="86"/>
                </a:cubicBezTo>
                <a:cubicBezTo>
                  <a:pt x="9" y="110"/>
                  <a:pt x="4" y="98"/>
                  <a:pt x="6" y="91"/>
                </a:cubicBezTo>
                <a:cubicBezTo>
                  <a:pt x="7" y="84"/>
                  <a:pt x="4" y="72"/>
                  <a:pt x="2" y="64"/>
                </a:cubicBezTo>
                <a:cubicBezTo>
                  <a:pt x="0" y="56"/>
                  <a:pt x="14" y="36"/>
                  <a:pt x="14" y="36"/>
                </a:cubicBezTo>
                <a:cubicBezTo>
                  <a:pt x="14" y="36"/>
                  <a:pt x="14" y="44"/>
                  <a:pt x="21" y="22"/>
                </a:cubicBezTo>
                <a:cubicBezTo>
                  <a:pt x="28" y="0"/>
                  <a:pt x="34" y="20"/>
                  <a:pt x="39" y="25"/>
                </a:cubicBezTo>
                <a:cubicBezTo>
                  <a:pt x="44" y="30"/>
                  <a:pt x="50" y="30"/>
                  <a:pt x="63" y="30"/>
                </a:cubicBezTo>
                <a:cubicBezTo>
                  <a:pt x="74" y="31"/>
                  <a:pt x="67" y="28"/>
                  <a:pt x="86" y="41"/>
                </a:cubicBezTo>
                <a:close/>
              </a:path>
            </a:pathLst>
          </a:cu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78" name="Freeform 94">
            <a:extLst>
              <a:ext uri="{FF2B5EF4-FFF2-40B4-BE49-F238E27FC236}">
                <a16:creationId xmlns:a16="http://schemas.microsoft.com/office/drawing/2014/main" id="{E01A4ACB-B9DC-11BC-C3CB-87B99DB47B3F}"/>
              </a:ext>
            </a:extLst>
          </p:cNvPr>
          <p:cNvSpPr>
            <a:spLocks/>
          </p:cNvSpPr>
          <p:nvPr/>
        </p:nvSpPr>
        <p:spPr bwMode="auto">
          <a:xfrm>
            <a:off x="479059" y="963659"/>
            <a:ext cx="408067" cy="503540"/>
          </a:xfrm>
          <a:custGeom>
            <a:avLst/>
            <a:gdLst>
              <a:gd name="T0" fmla="*/ 84 w 93"/>
              <a:gd name="T1" fmla="*/ 99 h 115"/>
              <a:gd name="T2" fmla="*/ 60 w 93"/>
              <a:gd name="T3" fmla="*/ 112 h 115"/>
              <a:gd name="T4" fmla="*/ 32 w 93"/>
              <a:gd name="T5" fmla="*/ 109 h 115"/>
              <a:gd name="T6" fmla="*/ 17 w 93"/>
              <a:gd name="T7" fmla="*/ 109 h 115"/>
              <a:gd name="T8" fmla="*/ 13 w 93"/>
              <a:gd name="T9" fmla="*/ 91 h 115"/>
              <a:gd name="T10" fmla="*/ 16 w 93"/>
              <a:gd name="T11" fmla="*/ 69 h 115"/>
              <a:gd name="T12" fmla="*/ 30 w 93"/>
              <a:gd name="T13" fmla="*/ 23 h 115"/>
              <a:gd name="T14" fmla="*/ 43 w 93"/>
              <a:gd name="T15" fmla="*/ 0 h 115"/>
              <a:gd name="T16" fmla="*/ 46 w 93"/>
              <a:gd name="T17" fmla="*/ 13 h 115"/>
              <a:gd name="T18" fmla="*/ 51 w 93"/>
              <a:gd name="T19" fmla="*/ 35 h 115"/>
              <a:gd name="T20" fmla="*/ 43 w 93"/>
              <a:gd name="T21" fmla="*/ 77 h 115"/>
              <a:gd name="T22" fmla="*/ 51 w 93"/>
              <a:gd name="T23" fmla="*/ 96 h 115"/>
              <a:gd name="T24" fmla="*/ 82 w 93"/>
              <a:gd name="T25" fmla="*/ 96 h 115"/>
              <a:gd name="T26" fmla="*/ 84 w 93"/>
              <a:gd name="T27" fmla="*/ 99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93" h="115">
                <a:moveTo>
                  <a:pt x="84" y="99"/>
                </a:moveTo>
                <a:cubicBezTo>
                  <a:pt x="93" y="115"/>
                  <a:pt x="76" y="111"/>
                  <a:pt x="60" y="112"/>
                </a:cubicBezTo>
                <a:cubicBezTo>
                  <a:pt x="45" y="112"/>
                  <a:pt x="45" y="103"/>
                  <a:pt x="32" y="109"/>
                </a:cubicBezTo>
                <a:cubicBezTo>
                  <a:pt x="19" y="114"/>
                  <a:pt x="16" y="111"/>
                  <a:pt x="17" y="109"/>
                </a:cubicBezTo>
                <a:cubicBezTo>
                  <a:pt x="18" y="106"/>
                  <a:pt x="16" y="96"/>
                  <a:pt x="13" y="91"/>
                </a:cubicBezTo>
                <a:cubicBezTo>
                  <a:pt x="10" y="87"/>
                  <a:pt x="0" y="83"/>
                  <a:pt x="16" y="69"/>
                </a:cubicBezTo>
                <a:cubicBezTo>
                  <a:pt x="31" y="54"/>
                  <a:pt x="28" y="34"/>
                  <a:pt x="30" y="23"/>
                </a:cubicBezTo>
                <a:cubicBezTo>
                  <a:pt x="31" y="13"/>
                  <a:pt x="32" y="11"/>
                  <a:pt x="43" y="0"/>
                </a:cubicBezTo>
                <a:cubicBezTo>
                  <a:pt x="43" y="0"/>
                  <a:pt x="43" y="11"/>
                  <a:pt x="46" y="13"/>
                </a:cubicBezTo>
                <a:cubicBezTo>
                  <a:pt x="49" y="17"/>
                  <a:pt x="53" y="27"/>
                  <a:pt x="51" y="35"/>
                </a:cubicBezTo>
                <a:cubicBezTo>
                  <a:pt x="49" y="43"/>
                  <a:pt x="43" y="77"/>
                  <a:pt x="43" y="77"/>
                </a:cubicBezTo>
                <a:cubicBezTo>
                  <a:pt x="43" y="77"/>
                  <a:pt x="40" y="95"/>
                  <a:pt x="51" y="96"/>
                </a:cubicBezTo>
                <a:cubicBezTo>
                  <a:pt x="63" y="97"/>
                  <a:pt x="82" y="96"/>
                  <a:pt x="82" y="96"/>
                </a:cubicBezTo>
                <a:cubicBezTo>
                  <a:pt x="82" y="97"/>
                  <a:pt x="83" y="98"/>
                  <a:pt x="84" y="99"/>
                </a:cubicBezTo>
                <a:close/>
              </a:path>
            </a:pathLst>
          </a:custGeom>
          <a:solidFill>
            <a:srgbClr val="F2F2F3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79" name="Freeform 137">
            <a:extLst>
              <a:ext uri="{FF2B5EF4-FFF2-40B4-BE49-F238E27FC236}">
                <a16:creationId xmlns:a16="http://schemas.microsoft.com/office/drawing/2014/main" id="{1CB359D1-D630-C839-EAE0-61939B00C279}"/>
              </a:ext>
            </a:extLst>
          </p:cNvPr>
          <p:cNvSpPr>
            <a:spLocks/>
          </p:cNvSpPr>
          <p:nvPr/>
        </p:nvSpPr>
        <p:spPr bwMode="auto">
          <a:xfrm>
            <a:off x="479059" y="92090"/>
            <a:ext cx="854631" cy="1375109"/>
          </a:xfrm>
          <a:custGeom>
            <a:avLst/>
            <a:gdLst>
              <a:gd name="T0" fmla="*/ 93 w 195"/>
              <a:gd name="T1" fmla="*/ 0 h 314"/>
              <a:gd name="T2" fmla="*/ 89 w 195"/>
              <a:gd name="T3" fmla="*/ 8 h 314"/>
              <a:gd name="T4" fmla="*/ 106 w 195"/>
              <a:gd name="T5" fmla="*/ 30 h 314"/>
              <a:gd name="T6" fmla="*/ 114 w 195"/>
              <a:gd name="T7" fmla="*/ 35 h 314"/>
              <a:gd name="T8" fmla="*/ 130 w 195"/>
              <a:gd name="T9" fmla="*/ 65 h 314"/>
              <a:gd name="T10" fmla="*/ 145 w 195"/>
              <a:gd name="T11" fmla="*/ 112 h 314"/>
              <a:gd name="T12" fmla="*/ 149 w 195"/>
              <a:gd name="T13" fmla="*/ 126 h 314"/>
              <a:gd name="T14" fmla="*/ 173 w 195"/>
              <a:gd name="T15" fmla="*/ 146 h 314"/>
              <a:gd name="T16" fmla="*/ 171 w 195"/>
              <a:gd name="T17" fmla="*/ 160 h 314"/>
              <a:gd name="T18" fmla="*/ 155 w 195"/>
              <a:gd name="T19" fmla="*/ 165 h 314"/>
              <a:gd name="T20" fmla="*/ 128 w 195"/>
              <a:gd name="T21" fmla="*/ 172 h 314"/>
              <a:gd name="T22" fmla="*/ 95 w 195"/>
              <a:gd name="T23" fmla="*/ 169 h 314"/>
              <a:gd name="T24" fmla="*/ 71 w 195"/>
              <a:gd name="T25" fmla="*/ 160 h 314"/>
              <a:gd name="T26" fmla="*/ 62 w 195"/>
              <a:gd name="T27" fmla="*/ 160 h 314"/>
              <a:gd name="T28" fmla="*/ 30 w 195"/>
              <a:gd name="T29" fmla="*/ 164 h 314"/>
              <a:gd name="T30" fmla="*/ 28 w 195"/>
              <a:gd name="T31" fmla="*/ 173 h 314"/>
              <a:gd name="T32" fmla="*/ 29 w 195"/>
              <a:gd name="T33" fmla="*/ 182 h 314"/>
              <a:gd name="T34" fmla="*/ 48 w 195"/>
              <a:gd name="T35" fmla="*/ 194 h 314"/>
              <a:gd name="T36" fmla="*/ 43 w 195"/>
              <a:gd name="T37" fmla="*/ 199 h 314"/>
              <a:gd name="T38" fmla="*/ 30 w 195"/>
              <a:gd name="T39" fmla="*/ 222 h 314"/>
              <a:gd name="T40" fmla="*/ 16 w 195"/>
              <a:gd name="T41" fmla="*/ 268 h 314"/>
              <a:gd name="T42" fmla="*/ 13 w 195"/>
              <a:gd name="T43" fmla="*/ 290 h 314"/>
              <a:gd name="T44" fmla="*/ 17 w 195"/>
              <a:gd name="T45" fmla="*/ 308 h 314"/>
              <a:gd name="T46" fmla="*/ 32 w 195"/>
              <a:gd name="T47" fmla="*/ 308 h 314"/>
              <a:gd name="T48" fmla="*/ 60 w 195"/>
              <a:gd name="T49" fmla="*/ 311 h 314"/>
              <a:gd name="T50" fmla="*/ 84 w 195"/>
              <a:gd name="T51" fmla="*/ 298 h 314"/>
              <a:gd name="T52" fmla="*/ 82 w 195"/>
              <a:gd name="T53" fmla="*/ 295 h 314"/>
              <a:gd name="T54" fmla="*/ 83 w 195"/>
              <a:gd name="T55" fmla="*/ 270 h 314"/>
              <a:gd name="T56" fmla="*/ 85 w 195"/>
              <a:gd name="T57" fmla="*/ 245 h 314"/>
              <a:gd name="T58" fmla="*/ 102 w 195"/>
              <a:gd name="T59" fmla="*/ 248 h 314"/>
              <a:gd name="T60" fmla="*/ 109 w 195"/>
              <a:gd name="T61" fmla="*/ 254 h 314"/>
              <a:gd name="T62" fmla="*/ 123 w 195"/>
              <a:gd name="T63" fmla="*/ 269 h 314"/>
              <a:gd name="T64" fmla="*/ 129 w 195"/>
              <a:gd name="T65" fmla="*/ 285 h 314"/>
              <a:gd name="T66" fmla="*/ 129 w 195"/>
              <a:gd name="T67" fmla="*/ 285 h 3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95" h="314">
                <a:moveTo>
                  <a:pt x="93" y="0"/>
                </a:moveTo>
                <a:cubicBezTo>
                  <a:pt x="89" y="8"/>
                  <a:pt x="89" y="8"/>
                  <a:pt x="89" y="8"/>
                </a:cubicBezTo>
                <a:cubicBezTo>
                  <a:pt x="89" y="8"/>
                  <a:pt x="85" y="14"/>
                  <a:pt x="106" y="30"/>
                </a:cubicBezTo>
                <a:cubicBezTo>
                  <a:pt x="109" y="32"/>
                  <a:pt x="112" y="34"/>
                  <a:pt x="114" y="35"/>
                </a:cubicBezTo>
                <a:cubicBezTo>
                  <a:pt x="128" y="48"/>
                  <a:pt x="128" y="57"/>
                  <a:pt x="130" y="65"/>
                </a:cubicBezTo>
                <a:cubicBezTo>
                  <a:pt x="132" y="74"/>
                  <a:pt x="141" y="108"/>
                  <a:pt x="145" y="112"/>
                </a:cubicBezTo>
                <a:cubicBezTo>
                  <a:pt x="149" y="116"/>
                  <a:pt x="149" y="126"/>
                  <a:pt x="149" y="126"/>
                </a:cubicBezTo>
                <a:cubicBezTo>
                  <a:pt x="149" y="126"/>
                  <a:pt x="152" y="144"/>
                  <a:pt x="173" y="146"/>
                </a:cubicBezTo>
                <a:cubicBezTo>
                  <a:pt x="195" y="148"/>
                  <a:pt x="195" y="158"/>
                  <a:pt x="171" y="160"/>
                </a:cubicBezTo>
                <a:cubicBezTo>
                  <a:pt x="146" y="164"/>
                  <a:pt x="162" y="164"/>
                  <a:pt x="155" y="165"/>
                </a:cubicBezTo>
                <a:cubicBezTo>
                  <a:pt x="148" y="166"/>
                  <a:pt x="137" y="172"/>
                  <a:pt x="128" y="172"/>
                </a:cubicBezTo>
                <a:cubicBezTo>
                  <a:pt x="120" y="172"/>
                  <a:pt x="104" y="174"/>
                  <a:pt x="95" y="169"/>
                </a:cubicBezTo>
                <a:cubicBezTo>
                  <a:pt x="86" y="164"/>
                  <a:pt x="76" y="161"/>
                  <a:pt x="71" y="160"/>
                </a:cubicBezTo>
                <a:cubicBezTo>
                  <a:pt x="69" y="160"/>
                  <a:pt x="66" y="160"/>
                  <a:pt x="62" y="160"/>
                </a:cubicBezTo>
                <a:cubicBezTo>
                  <a:pt x="50" y="161"/>
                  <a:pt x="30" y="164"/>
                  <a:pt x="30" y="164"/>
                </a:cubicBezTo>
                <a:cubicBezTo>
                  <a:pt x="30" y="164"/>
                  <a:pt x="17" y="168"/>
                  <a:pt x="28" y="173"/>
                </a:cubicBezTo>
                <a:cubicBezTo>
                  <a:pt x="39" y="178"/>
                  <a:pt x="14" y="181"/>
                  <a:pt x="29" y="182"/>
                </a:cubicBezTo>
                <a:cubicBezTo>
                  <a:pt x="45" y="184"/>
                  <a:pt x="64" y="178"/>
                  <a:pt x="48" y="194"/>
                </a:cubicBezTo>
                <a:cubicBezTo>
                  <a:pt x="46" y="196"/>
                  <a:pt x="44" y="198"/>
                  <a:pt x="43" y="199"/>
                </a:cubicBezTo>
                <a:cubicBezTo>
                  <a:pt x="32" y="210"/>
                  <a:pt x="31" y="212"/>
                  <a:pt x="30" y="222"/>
                </a:cubicBezTo>
                <a:cubicBezTo>
                  <a:pt x="28" y="233"/>
                  <a:pt x="31" y="253"/>
                  <a:pt x="16" y="268"/>
                </a:cubicBezTo>
                <a:cubicBezTo>
                  <a:pt x="0" y="282"/>
                  <a:pt x="10" y="286"/>
                  <a:pt x="13" y="290"/>
                </a:cubicBezTo>
                <a:cubicBezTo>
                  <a:pt x="16" y="295"/>
                  <a:pt x="18" y="305"/>
                  <a:pt x="17" y="308"/>
                </a:cubicBezTo>
                <a:cubicBezTo>
                  <a:pt x="16" y="310"/>
                  <a:pt x="19" y="313"/>
                  <a:pt x="32" y="308"/>
                </a:cubicBezTo>
                <a:cubicBezTo>
                  <a:pt x="45" y="302"/>
                  <a:pt x="45" y="311"/>
                  <a:pt x="60" y="311"/>
                </a:cubicBezTo>
                <a:cubicBezTo>
                  <a:pt x="76" y="310"/>
                  <a:pt x="93" y="314"/>
                  <a:pt x="84" y="298"/>
                </a:cubicBezTo>
                <a:cubicBezTo>
                  <a:pt x="83" y="297"/>
                  <a:pt x="82" y="296"/>
                  <a:pt x="82" y="295"/>
                </a:cubicBezTo>
                <a:cubicBezTo>
                  <a:pt x="76" y="282"/>
                  <a:pt x="88" y="280"/>
                  <a:pt x="83" y="270"/>
                </a:cubicBezTo>
                <a:cubicBezTo>
                  <a:pt x="77" y="258"/>
                  <a:pt x="68" y="254"/>
                  <a:pt x="85" y="245"/>
                </a:cubicBezTo>
                <a:cubicBezTo>
                  <a:pt x="101" y="236"/>
                  <a:pt x="99" y="244"/>
                  <a:pt x="102" y="248"/>
                </a:cubicBezTo>
                <a:cubicBezTo>
                  <a:pt x="105" y="252"/>
                  <a:pt x="104" y="254"/>
                  <a:pt x="109" y="254"/>
                </a:cubicBezTo>
                <a:cubicBezTo>
                  <a:pt x="114" y="254"/>
                  <a:pt x="123" y="251"/>
                  <a:pt x="123" y="269"/>
                </a:cubicBezTo>
                <a:cubicBezTo>
                  <a:pt x="124" y="284"/>
                  <a:pt x="127" y="285"/>
                  <a:pt x="129" y="285"/>
                </a:cubicBezTo>
                <a:cubicBezTo>
                  <a:pt x="129" y="285"/>
                  <a:pt x="129" y="285"/>
                  <a:pt x="129" y="285"/>
                </a:cubicBezTo>
              </a:path>
            </a:pathLst>
          </a:custGeom>
          <a:noFill/>
          <a:ln w="7938" cap="rnd">
            <a:solidFill>
              <a:srgbClr val="23202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80" name="Freeform 138">
            <a:extLst>
              <a:ext uri="{FF2B5EF4-FFF2-40B4-BE49-F238E27FC236}">
                <a16:creationId xmlns:a16="http://schemas.microsoft.com/office/drawing/2014/main" id="{7E1D6B88-82E5-FAD5-DB56-B7FF35728B0E}"/>
              </a:ext>
            </a:extLst>
          </p:cNvPr>
          <p:cNvSpPr>
            <a:spLocks/>
          </p:cNvSpPr>
          <p:nvPr/>
        </p:nvSpPr>
        <p:spPr bwMode="auto">
          <a:xfrm>
            <a:off x="654605" y="963660"/>
            <a:ext cx="183246" cy="425006"/>
          </a:xfrm>
          <a:custGeom>
            <a:avLst/>
            <a:gdLst>
              <a:gd name="T0" fmla="*/ 3 w 42"/>
              <a:gd name="T1" fmla="*/ 0 h 97"/>
              <a:gd name="T2" fmla="*/ 6 w 42"/>
              <a:gd name="T3" fmla="*/ 13 h 97"/>
              <a:gd name="T4" fmla="*/ 11 w 42"/>
              <a:gd name="T5" fmla="*/ 35 h 97"/>
              <a:gd name="T6" fmla="*/ 3 w 42"/>
              <a:gd name="T7" fmla="*/ 77 h 97"/>
              <a:gd name="T8" fmla="*/ 11 w 42"/>
              <a:gd name="T9" fmla="*/ 96 h 97"/>
              <a:gd name="T10" fmla="*/ 42 w 42"/>
              <a:gd name="T11" fmla="*/ 96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2" h="97">
                <a:moveTo>
                  <a:pt x="3" y="0"/>
                </a:moveTo>
                <a:cubicBezTo>
                  <a:pt x="3" y="0"/>
                  <a:pt x="3" y="11"/>
                  <a:pt x="6" y="13"/>
                </a:cubicBezTo>
                <a:cubicBezTo>
                  <a:pt x="9" y="17"/>
                  <a:pt x="13" y="27"/>
                  <a:pt x="11" y="35"/>
                </a:cubicBezTo>
                <a:cubicBezTo>
                  <a:pt x="9" y="43"/>
                  <a:pt x="3" y="77"/>
                  <a:pt x="3" y="77"/>
                </a:cubicBezTo>
                <a:cubicBezTo>
                  <a:pt x="3" y="77"/>
                  <a:pt x="0" y="95"/>
                  <a:pt x="11" y="96"/>
                </a:cubicBezTo>
                <a:cubicBezTo>
                  <a:pt x="23" y="97"/>
                  <a:pt x="42" y="96"/>
                  <a:pt x="42" y="96"/>
                </a:cubicBezTo>
              </a:path>
            </a:pathLst>
          </a:custGeom>
          <a:noFill/>
          <a:ln w="7938" cap="rnd">
            <a:solidFill>
              <a:srgbClr val="23202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81" name="Freeform 139">
            <a:extLst>
              <a:ext uri="{FF2B5EF4-FFF2-40B4-BE49-F238E27FC236}">
                <a16:creationId xmlns:a16="http://schemas.microsoft.com/office/drawing/2014/main" id="{E2B2B35C-CD54-B523-50A6-85737219DCED}"/>
              </a:ext>
            </a:extLst>
          </p:cNvPr>
          <p:cNvSpPr>
            <a:spLocks/>
          </p:cNvSpPr>
          <p:nvPr/>
        </p:nvSpPr>
        <p:spPr bwMode="auto">
          <a:xfrm>
            <a:off x="706961" y="244538"/>
            <a:ext cx="327994" cy="548196"/>
          </a:xfrm>
          <a:custGeom>
            <a:avLst/>
            <a:gdLst>
              <a:gd name="T0" fmla="*/ 62 w 75"/>
              <a:gd name="T1" fmla="*/ 0 h 125"/>
              <a:gd name="T2" fmla="*/ 66 w 75"/>
              <a:gd name="T3" fmla="*/ 41 h 125"/>
              <a:gd name="T4" fmla="*/ 53 w 75"/>
              <a:gd name="T5" fmla="*/ 60 h 125"/>
              <a:gd name="T6" fmla="*/ 21 w 75"/>
              <a:gd name="T7" fmla="*/ 39 h 125"/>
              <a:gd name="T8" fmla="*/ 10 w 75"/>
              <a:gd name="T9" fmla="*/ 59 h 125"/>
              <a:gd name="T10" fmla="*/ 21 w 75"/>
              <a:gd name="T11" fmla="*/ 89 h 125"/>
              <a:gd name="T12" fmla="*/ 22 w 75"/>
              <a:gd name="T13" fmla="*/ 99 h 125"/>
              <a:gd name="T14" fmla="*/ 15 w 75"/>
              <a:gd name="T15" fmla="*/ 109 h 125"/>
              <a:gd name="T16" fmla="*/ 10 w 75"/>
              <a:gd name="T17" fmla="*/ 118 h 125"/>
              <a:gd name="T18" fmla="*/ 10 w 75"/>
              <a:gd name="T19" fmla="*/ 125 h 1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5" h="125">
                <a:moveTo>
                  <a:pt x="62" y="0"/>
                </a:moveTo>
                <a:cubicBezTo>
                  <a:pt x="62" y="0"/>
                  <a:pt x="59" y="21"/>
                  <a:pt x="66" y="41"/>
                </a:cubicBezTo>
                <a:cubicBezTo>
                  <a:pt x="73" y="61"/>
                  <a:pt x="75" y="77"/>
                  <a:pt x="53" y="60"/>
                </a:cubicBezTo>
                <a:cubicBezTo>
                  <a:pt x="30" y="43"/>
                  <a:pt x="34" y="37"/>
                  <a:pt x="21" y="39"/>
                </a:cubicBezTo>
                <a:cubicBezTo>
                  <a:pt x="8" y="43"/>
                  <a:pt x="0" y="37"/>
                  <a:pt x="10" y="59"/>
                </a:cubicBezTo>
                <a:cubicBezTo>
                  <a:pt x="20" y="81"/>
                  <a:pt x="24" y="83"/>
                  <a:pt x="21" y="89"/>
                </a:cubicBezTo>
                <a:cubicBezTo>
                  <a:pt x="18" y="93"/>
                  <a:pt x="20" y="95"/>
                  <a:pt x="22" y="99"/>
                </a:cubicBezTo>
                <a:cubicBezTo>
                  <a:pt x="24" y="103"/>
                  <a:pt x="17" y="105"/>
                  <a:pt x="15" y="109"/>
                </a:cubicBezTo>
                <a:cubicBezTo>
                  <a:pt x="12" y="113"/>
                  <a:pt x="10" y="113"/>
                  <a:pt x="10" y="118"/>
                </a:cubicBezTo>
                <a:cubicBezTo>
                  <a:pt x="11" y="123"/>
                  <a:pt x="10" y="125"/>
                  <a:pt x="10" y="125"/>
                </a:cubicBezTo>
              </a:path>
            </a:pathLst>
          </a:custGeom>
          <a:noFill/>
          <a:ln w="7938" cap="rnd">
            <a:solidFill>
              <a:srgbClr val="23202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grpSp>
        <p:nvGrpSpPr>
          <p:cNvPr id="82" name="Gruppieren 81">
            <a:extLst>
              <a:ext uri="{FF2B5EF4-FFF2-40B4-BE49-F238E27FC236}">
                <a16:creationId xmlns:a16="http://schemas.microsoft.com/office/drawing/2014/main" id="{3423D002-27DA-1558-C5FD-33F3396FA4AB}"/>
              </a:ext>
            </a:extLst>
          </p:cNvPr>
          <p:cNvGrpSpPr/>
          <p:nvPr/>
        </p:nvGrpSpPr>
        <p:grpSpPr>
          <a:xfrm>
            <a:off x="3816557" y="253587"/>
            <a:ext cx="2122710" cy="704910"/>
            <a:chOff x="1262101" y="808531"/>
            <a:chExt cx="2122710" cy="704910"/>
          </a:xfrm>
        </p:grpSpPr>
        <p:grpSp>
          <p:nvGrpSpPr>
            <p:cNvPr id="83" name="Gruppieren 82">
              <a:extLst>
                <a:ext uri="{FF2B5EF4-FFF2-40B4-BE49-F238E27FC236}">
                  <a16:creationId xmlns:a16="http://schemas.microsoft.com/office/drawing/2014/main" id="{AA4D427D-316F-C55B-E85D-A183F334E826}"/>
                </a:ext>
              </a:extLst>
            </p:cNvPr>
            <p:cNvGrpSpPr/>
            <p:nvPr/>
          </p:nvGrpSpPr>
          <p:grpSpPr>
            <a:xfrm>
              <a:off x="1262101" y="808531"/>
              <a:ext cx="2122710" cy="637835"/>
              <a:chOff x="3127853" y="6687062"/>
              <a:chExt cx="2019093" cy="657565"/>
            </a:xfrm>
          </p:grpSpPr>
          <p:sp>
            <p:nvSpPr>
              <p:cNvPr id="85" name="Line 292">
                <a:extLst>
                  <a:ext uri="{FF2B5EF4-FFF2-40B4-BE49-F238E27FC236}">
                    <a16:creationId xmlns:a16="http://schemas.microsoft.com/office/drawing/2014/main" id="{979B2407-FF67-DF72-8CD6-E7839507BB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2901" y="7176601"/>
                <a:ext cx="1781998" cy="0"/>
              </a:xfrm>
              <a:prstGeom prst="line">
                <a:avLst/>
              </a:prstGeom>
              <a:noFill/>
              <a:ln w="12700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" name="Line 293">
                <a:extLst>
                  <a:ext uri="{FF2B5EF4-FFF2-40B4-BE49-F238E27FC236}">
                    <a16:creationId xmlns:a16="http://schemas.microsoft.com/office/drawing/2014/main" id="{4FFED07D-A412-E5F6-10B7-EA228A61FA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7663" y="7175240"/>
                <a:ext cx="0" cy="169387"/>
              </a:xfrm>
              <a:prstGeom prst="line">
                <a:avLst/>
              </a:prstGeom>
              <a:noFill/>
              <a:ln w="12700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7" name="Line 294">
                <a:extLst>
                  <a:ext uri="{FF2B5EF4-FFF2-40B4-BE49-F238E27FC236}">
                    <a16:creationId xmlns:a16="http://schemas.microsoft.com/office/drawing/2014/main" id="{106A6343-8C56-4D4D-0AAB-B7E22D7397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42518" y="7172859"/>
                <a:ext cx="0" cy="169387"/>
              </a:xfrm>
              <a:prstGeom prst="line">
                <a:avLst/>
              </a:prstGeom>
              <a:noFill/>
              <a:ln w="12700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8" name="Rectangle 295">
                <a:extLst>
                  <a:ext uri="{FF2B5EF4-FFF2-40B4-BE49-F238E27FC236}">
                    <a16:creationId xmlns:a16="http://schemas.microsoft.com/office/drawing/2014/main" id="{591612A9-EAFE-D416-E797-712A8DCCAA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30165" y="6936797"/>
                <a:ext cx="416781" cy="2000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3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30 km</a:t>
                </a:r>
                <a:endParaRPr kumimoji="0" lang="de-DE" altLang="de-DE" sz="1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89" name="Rectangle 295">
                <a:extLst>
                  <a:ext uri="{FF2B5EF4-FFF2-40B4-BE49-F238E27FC236}">
                    <a16:creationId xmlns:a16="http://schemas.microsoft.com/office/drawing/2014/main" id="{31E6EB9D-A8C7-8299-51A5-1E5E77CD9B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7853" y="6939175"/>
                <a:ext cx="84960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3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0</a:t>
                </a:r>
                <a:endParaRPr kumimoji="0" lang="de-DE" altLang="de-DE" sz="1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0" name="Rectangle 295">
                <a:extLst>
                  <a:ext uri="{FF2B5EF4-FFF2-40B4-BE49-F238E27FC236}">
                    <a16:creationId xmlns:a16="http://schemas.microsoft.com/office/drawing/2014/main" id="{A6D9E661-316C-34BF-3386-AB08A649C0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5123" y="6687062"/>
                <a:ext cx="102159" cy="2062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300" i="0" u="none" strike="noStrike" cap="none" normalizeH="0" baseline="0" dirty="0">
                    <a:ln>
                      <a:noFill/>
                    </a:ln>
                    <a:solidFill>
                      <a:srgbClr val="232021"/>
                    </a:solidFill>
                    <a:effectLst/>
                    <a:latin typeface="+mn-lt"/>
                  </a:rPr>
                  <a:t>N</a:t>
                </a:r>
                <a:endParaRPr kumimoji="0" lang="de-DE" altLang="de-DE" sz="1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</p:grpSp>
        <p:cxnSp>
          <p:nvCxnSpPr>
            <p:cNvPr id="84" name="Gerade Verbindung mit Pfeil 83">
              <a:extLst>
                <a:ext uri="{FF2B5EF4-FFF2-40B4-BE49-F238E27FC236}">
                  <a16:creationId xmlns:a16="http://schemas.microsoft.com/office/drawing/2014/main" id="{6F9C83FB-9434-70C9-2E96-6A1E2B196186}"/>
                </a:ext>
              </a:extLst>
            </p:cNvPr>
            <p:cNvCxnSpPr/>
            <p:nvPr/>
          </p:nvCxnSpPr>
          <p:spPr>
            <a:xfrm rot="5340000" flipH="1" flipV="1">
              <a:off x="1981380" y="1279441"/>
              <a:ext cx="46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" name="Textfeld 23">
            <a:extLst>
              <a:ext uri="{FF2B5EF4-FFF2-40B4-BE49-F238E27FC236}">
                <a16:creationId xmlns:a16="http://schemas.microsoft.com/office/drawing/2014/main" id="{E56B81AA-9AFC-32F8-11DC-7446633A1DF2}"/>
              </a:ext>
            </a:extLst>
          </p:cNvPr>
          <p:cNvSpPr txBox="1">
            <a:spLocks noChangeArrowheads="1"/>
          </p:cNvSpPr>
          <p:nvPr/>
        </p:nvSpPr>
        <p:spPr bwMode="auto">
          <a:xfrm rot="17809089">
            <a:off x="3051667" y="4911547"/>
            <a:ext cx="985282" cy="25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200" i="1" dirty="0">
                <a:latin typeface="Calibri" pitchFamily="34" charset="0"/>
              </a:rPr>
              <a:t>South </a:t>
            </a:r>
            <a:r>
              <a:rPr lang="de-DE" sz="1200" i="1" dirty="0" err="1">
                <a:latin typeface="Calibri" pitchFamily="34" charset="0"/>
              </a:rPr>
              <a:t>Africa</a:t>
            </a:r>
            <a:endParaRPr lang="de-DE" sz="1200" i="1" dirty="0">
              <a:latin typeface="Calibri" pitchFamily="34" charset="0"/>
            </a:endParaRPr>
          </a:p>
        </p:txBody>
      </p:sp>
      <p:sp>
        <p:nvSpPr>
          <p:cNvPr id="92" name="Textfeld 40">
            <a:extLst>
              <a:ext uri="{FF2B5EF4-FFF2-40B4-BE49-F238E27FC236}">
                <a16:creationId xmlns:a16="http://schemas.microsoft.com/office/drawing/2014/main" id="{5F547600-5248-FBE3-FB92-86C9140F6C5C}"/>
              </a:ext>
            </a:extLst>
          </p:cNvPr>
          <p:cNvSpPr txBox="1">
            <a:spLocks noChangeArrowheads="1"/>
          </p:cNvSpPr>
          <p:nvPr/>
        </p:nvSpPr>
        <p:spPr bwMode="auto">
          <a:xfrm rot="21540000">
            <a:off x="2662692" y="2630191"/>
            <a:ext cx="830287" cy="2550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400" i="1" dirty="0" err="1">
                <a:latin typeface="Calibri" pitchFamily="34" charset="0"/>
              </a:rPr>
              <a:t>Barberton</a:t>
            </a:r>
            <a:endParaRPr lang="de-DE" sz="1400" i="1" dirty="0">
              <a:latin typeface="Calibri" pitchFamily="34" charset="0"/>
            </a:endParaRPr>
          </a:p>
        </p:txBody>
      </p:sp>
      <p:sp>
        <p:nvSpPr>
          <p:cNvPr id="93" name="Textfeld 56">
            <a:extLst>
              <a:ext uri="{FF2B5EF4-FFF2-40B4-BE49-F238E27FC236}">
                <a16:creationId xmlns:a16="http://schemas.microsoft.com/office/drawing/2014/main" id="{C92FFB99-53A3-3535-CBB2-549112286A27}"/>
              </a:ext>
            </a:extLst>
          </p:cNvPr>
          <p:cNvSpPr txBox="1">
            <a:spLocks noChangeArrowheads="1"/>
          </p:cNvSpPr>
          <p:nvPr/>
        </p:nvSpPr>
        <p:spPr bwMode="auto">
          <a:xfrm rot="20959028">
            <a:off x="1529119" y="3888410"/>
            <a:ext cx="5390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de-DE" sz="800" i="1" dirty="0" err="1">
                <a:latin typeface="Calibri" pitchFamily="34" charset="0"/>
              </a:rPr>
              <a:t>Inyoka</a:t>
            </a:r>
            <a:endParaRPr lang="de-DE" sz="800" i="1" dirty="0">
              <a:latin typeface="Calibri" pitchFamily="34" charset="0"/>
            </a:endParaRPr>
          </a:p>
        </p:txBody>
      </p:sp>
      <p:sp>
        <p:nvSpPr>
          <p:cNvPr id="94" name="Textfeld 56">
            <a:extLst>
              <a:ext uri="{FF2B5EF4-FFF2-40B4-BE49-F238E27FC236}">
                <a16:creationId xmlns:a16="http://schemas.microsoft.com/office/drawing/2014/main" id="{A1FEEA00-9828-48B4-AB50-A9A6881F7F0E}"/>
              </a:ext>
            </a:extLst>
          </p:cNvPr>
          <p:cNvSpPr txBox="1">
            <a:spLocks noChangeArrowheads="1"/>
          </p:cNvSpPr>
          <p:nvPr/>
        </p:nvSpPr>
        <p:spPr bwMode="auto">
          <a:xfrm rot="19618571">
            <a:off x="2475218" y="3654100"/>
            <a:ext cx="5390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de-DE" sz="800" i="1" dirty="0">
                <a:latin typeface="Calibri" pitchFamily="34" charset="0"/>
              </a:rPr>
              <a:t>Fault</a:t>
            </a:r>
          </a:p>
        </p:txBody>
      </p:sp>
      <p:sp>
        <p:nvSpPr>
          <p:cNvPr id="95" name="Ellipse 94">
            <a:extLst>
              <a:ext uri="{FF2B5EF4-FFF2-40B4-BE49-F238E27FC236}">
                <a16:creationId xmlns:a16="http://schemas.microsoft.com/office/drawing/2014/main" id="{428FC270-42A6-B4C0-A536-BFCBE15E96D3}"/>
              </a:ext>
            </a:extLst>
          </p:cNvPr>
          <p:cNvSpPr/>
          <p:nvPr/>
        </p:nvSpPr>
        <p:spPr>
          <a:xfrm rot="21540000">
            <a:off x="3530728" y="2795538"/>
            <a:ext cx="147791" cy="134084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/>
          </a:p>
        </p:txBody>
      </p:sp>
      <p:grpSp>
        <p:nvGrpSpPr>
          <p:cNvPr id="96" name="Gruppieren 95">
            <a:extLst>
              <a:ext uri="{FF2B5EF4-FFF2-40B4-BE49-F238E27FC236}">
                <a16:creationId xmlns:a16="http://schemas.microsoft.com/office/drawing/2014/main" id="{807BD7F6-8830-736A-2141-9650B1DBBA1B}"/>
              </a:ext>
            </a:extLst>
          </p:cNvPr>
          <p:cNvGrpSpPr/>
          <p:nvPr/>
        </p:nvGrpSpPr>
        <p:grpSpPr>
          <a:xfrm>
            <a:off x="141857" y="90900"/>
            <a:ext cx="1969501" cy="1559894"/>
            <a:chOff x="7883527" y="2439988"/>
            <a:chExt cx="2030413" cy="1608138"/>
          </a:xfrm>
        </p:grpSpPr>
        <p:sp>
          <p:nvSpPr>
            <p:cNvPr id="97" name="Freeform 267">
              <a:extLst>
                <a:ext uri="{FF2B5EF4-FFF2-40B4-BE49-F238E27FC236}">
                  <a16:creationId xmlns:a16="http://schemas.microsoft.com/office/drawing/2014/main" id="{FEAF8E5B-0692-2E77-8569-CA85CBCC0453}"/>
                </a:ext>
              </a:extLst>
            </p:cNvPr>
            <p:cNvSpPr>
              <a:spLocks/>
            </p:cNvSpPr>
            <p:nvPr/>
          </p:nvSpPr>
          <p:spPr bwMode="auto">
            <a:xfrm>
              <a:off x="7883527" y="2439988"/>
              <a:ext cx="2030413" cy="1603375"/>
            </a:xfrm>
            <a:custGeom>
              <a:avLst/>
              <a:gdLst>
                <a:gd name="T0" fmla="*/ 1279 w 1279"/>
                <a:gd name="T1" fmla="*/ 57 h 1010"/>
                <a:gd name="T2" fmla="*/ 1279 w 1279"/>
                <a:gd name="T3" fmla="*/ 1010 h 1010"/>
                <a:gd name="T4" fmla="*/ 366 w 1279"/>
                <a:gd name="T5" fmla="*/ 1010 h 1010"/>
                <a:gd name="T6" fmla="*/ 347 w 1279"/>
                <a:gd name="T7" fmla="*/ 1010 h 1010"/>
                <a:gd name="T8" fmla="*/ 0 w 1279"/>
                <a:gd name="T9" fmla="*/ 1010 h 1010"/>
                <a:gd name="T10" fmla="*/ 0 w 1279"/>
                <a:gd name="T11" fmla="*/ 137 h 1010"/>
                <a:gd name="T12" fmla="*/ 0 w 1279"/>
                <a:gd name="T13" fmla="*/ 80 h 1010"/>
                <a:gd name="T14" fmla="*/ 0 w 1279"/>
                <a:gd name="T15" fmla="*/ 0 h 1010"/>
                <a:gd name="T16" fmla="*/ 474 w 1279"/>
                <a:gd name="T17" fmla="*/ 0 h 1010"/>
                <a:gd name="T18" fmla="*/ 810 w 1279"/>
                <a:gd name="T19" fmla="*/ 0 h 1010"/>
                <a:gd name="T20" fmla="*/ 858 w 1279"/>
                <a:gd name="T21" fmla="*/ 0 h 1010"/>
                <a:gd name="T22" fmla="*/ 1279 w 1279"/>
                <a:gd name="T23" fmla="*/ 0 h 1010"/>
                <a:gd name="T24" fmla="*/ 1279 w 1279"/>
                <a:gd name="T25" fmla="*/ 57 h 10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1279" h="1010">
                  <a:moveTo>
                    <a:pt x="1279" y="57"/>
                  </a:moveTo>
                  <a:lnTo>
                    <a:pt x="1279" y="1010"/>
                  </a:lnTo>
                  <a:lnTo>
                    <a:pt x="366" y="1010"/>
                  </a:lnTo>
                  <a:lnTo>
                    <a:pt x="347" y="1010"/>
                  </a:lnTo>
                  <a:lnTo>
                    <a:pt x="0" y="1010"/>
                  </a:lnTo>
                  <a:lnTo>
                    <a:pt x="0" y="137"/>
                  </a:lnTo>
                  <a:lnTo>
                    <a:pt x="0" y="80"/>
                  </a:lnTo>
                  <a:lnTo>
                    <a:pt x="0" y="0"/>
                  </a:lnTo>
                  <a:lnTo>
                    <a:pt x="474" y="0"/>
                  </a:lnTo>
                  <a:lnTo>
                    <a:pt x="810" y="0"/>
                  </a:lnTo>
                  <a:lnTo>
                    <a:pt x="858" y="0"/>
                  </a:lnTo>
                  <a:lnTo>
                    <a:pt x="1279" y="0"/>
                  </a:lnTo>
                  <a:lnTo>
                    <a:pt x="1279" y="57"/>
                  </a:ln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8" name="Freeform 261">
              <a:extLst>
                <a:ext uri="{FF2B5EF4-FFF2-40B4-BE49-F238E27FC236}">
                  <a16:creationId xmlns:a16="http://schemas.microsoft.com/office/drawing/2014/main" id="{0BDAED47-88D2-7FEF-E628-D3C7023AADC0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9790" y="2525714"/>
              <a:ext cx="1449388" cy="1512888"/>
            </a:xfrm>
            <a:custGeom>
              <a:avLst/>
              <a:gdLst>
                <a:gd name="T0" fmla="*/ 321 w 321"/>
                <a:gd name="T1" fmla="*/ 0 h 335"/>
                <a:gd name="T2" fmla="*/ 321 w 321"/>
                <a:gd name="T3" fmla="*/ 335 h 335"/>
                <a:gd name="T4" fmla="*/ 0 w 321"/>
                <a:gd name="T5" fmla="*/ 335 h 335"/>
                <a:gd name="T6" fmla="*/ 3 w 321"/>
                <a:gd name="T7" fmla="*/ 330 h 335"/>
                <a:gd name="T8" fmla="*/ 14 w 321"/>
                <a:gd name="T9" fmla="*/ 327 h 335"/>
                <a:gd name="T10" fmla="*/ 26 w 321"/>
                <a:gd name="T11" fmla="*/ 327 h 335"/>
                <a:gd name="T12" fmla="*/ 29 w 321"/>
                <a:gd name="T13" fmla="*/ 324 h 335"/>
                <a:gd name="T14" fmla="*/ 38 w 321"/>
                <a:gd name="T15" fmla="*/ 320 h 335"/>
                <a:gd name="T16" fmla="*/ 56 w 321"/>
                <a:gd name="T17" fmla="*/ 320 h 335"/>
                <a:gd name="T18" fmla="*/ 71 w 321"/>
                <a:gd name="T19" fmla="*/ 322 h 335"/>
                <a:gd name="T20" fmla="*/ 82 w 321"/>
                <a:gd name="T21" fmla="*/ 320 h 335"/>
                <a:gd name="T22" fmla="*/ 96 w 321"/>
                <a:gd name="T23" fmla="*/ 315 h 335"/>
                <a:gd name="T24" fmla="*/ 116 w 321"/>
                <a:gd name="T25" fmla="*/ 305 h 335"/>
                <a:gd name="T26" fmla="*/ 146 w 321"/>
                <a:gd name="T27" fmla="*/ 280 h 335"/>
                <a:gd name="T28" fmla="*/ 172 w 321"/>
                <a:gd name="T29" fmla="*/ 247 h 335"/>
                <a:gd name="T30" fmla="*/ 183 w 321"/>
                <a:gd name="T31" fmla="*/ 229 h 335"/>
                <a:gd name="T32" fmla="*/ 193 w 321"/>
                <a:gd name="T33" fmla="*/ 223 h 335"/>
                <a:gd name="T34" fmla="*/ 200 w 321"/>
                <a:gd name="T35" fmla="*/ 207 h 335"/>
                <a:gd name="T36" fmla="*/ 206 w 321"/>
                <a:gd name="T37" fmla="*/ 191 h 335"/>
                <a:gd name="T38" fmla="*/ 207 w 321"/>
                <a:gd name="T39" fmla="*/ 190 h 335"/>
                <a:gd name="T40" fmla="*/ 206 w 321"/>
                <a:gd name="T41" fmla="*/ 177 h 335"/>
                <a:gd name="T42" fmla="*/ 208 w 321"/>
                <a:gd name="T43" fmla="*/ 165 h 335"/>
                <a:gd name="T44" fmla="*/ 228 w 321"/>
                <a:gd name="T45" fmla="*/ 152 h 335"/>
                <a:gd name="T46" fmla="*/ 250 w 321"/>
                <a:gd name="T47" fmla="*/ 135 h 335"/>
                <a:gd name="T48" fmla="*/ 250 w 321"/>
                <a:gd name="T49" fmla="*/ 120 h 335"/>
                <a:gd name="T50" fmla="*/ 250 w 321"/>
                <a:gd name="T51" fmla="*/ 102 h 335"/>
                <a:gd name="T52" fmla="*/ 245 w 321"/>
                <a:gd name="T53" fmla="*/ 80 h 335"/>
                <a:gd name="T54" fmla="*/ 241 w 321"/>
                <a:gd name="T55" fmla="*/ 70 h 335"/>
                <a:gd name="T56" fmla="*/ 248 w 321"/>
                <a:gd name="T57" fmla="*/ 54 h 335"/>
                <a:gd name="T58" fmla="*/ 268 w 321"/>
                <a:gd name="T59" fmla="*/ 37 h 335"/>
                <a:gd name="T60" fmla="*/ 290 w 321"/>
                <a:gd name="T61" fmla="*/ 15 h 335"/>
                <a:gd name="T62" fmla="*/ 303 w 321"/>
                <a:gd name="T63" fmla="*/ 7 h 335"/>
                <a:gd name="T64" fmla="*/ 321 w 321"/>
                <a:gd name="T65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321" h="335">
                  <a:moveTo>
                    <a:pt x="321" y="0"/>
                  </a:moveTo>
                  <a:cubicBezTo>
                    <a:pt x="321" y="335"/>
                    <a:pt x="321" y="335"/>
                    <a:pt x="321" y="335"/>
                  </a:cubicBezTo>
                  <a:cubicBezTo>
                    <a:pt x="0" y="335"/>
                    <a:pt x="0" y="335"/>
                    <a:pt x="0" y="335"/>
                  </a:cubicBezTo>
                  <a:cubicBezTo>
                    <a:pt x="0" y="335"/>
                    <a:pt x="1" y="331"/>
                    <a:pt x="3" y="330"/>
                  </a:cubicBezTo>
                  <a:cubicBezTo>
                    <a:pt x="6" y="328"/>
                    <a:pt x="10" y="327"/>
                    <a:pt x="14" y="327"/>
                  </a:cubicBezTo>
                  <a:cubicBezTo>
                    <a:pt x="18" y="327"/>
                    <a:pt x="26" y="327"/>
                    <a:pt x="26" y="327"/>
                  </a:cubicBezTo>
                  <a:cubicBezTo>
                    <a:pt x="26" y="327"/>
                    <a:pt x="29" y="325"/>
                    <a:pt x="29" y="324"/>
                  </a:cubicBezTo>
                  <a:cubicBezTo>
                    <a:pt x="29" y="322"/>
                    <a:pt x="33" y="321"/>
                    <a:pt x="38" y="320"/>
                  </a:cubicBezTo>
                  <a:cubicBezTo>
                    <a:pt x="42" y="319"/>
                    <a:pt x="53" y="321"/>
                    <a:pt x="56" y="320"/>
                  </a:cubicBezTo>
                  <a:cubicBezTo>
                    <a:pt x="59" y="319"/>
                    <a:pt x="69" y="322"/>
                    <a:pt x="71" y="322"/>
                  </a:cubicBezTo>
                  <a:cubicBezTo>
                    <a:pt x="72" y="323"/>
                    <a:pt x="80" y="322"/>
                    <a:pt x="82" y="320"/>
                  </a:cubicBezTo>
                  <a:cubicBezTo>
                    <a:pt x="85" y="318"/>
                    <a:pt x="93" y="315"/>
                    <a:pt x="96" y="315"/>
                  </a:cubicBezTo>
                  <a:cubicBezTo>
                    <a:pt x="99" y="315"/>
                    <a:pt x="105" y="316"/>
                    <a:pt x="116" y="305"/>
                  </a:cubicBezTo>
                  <a:cubicBezTo>
                    <a:pt x="128" y="295"/>
                    <a:pt x="146" y="280"/>
                    <a:pt x="146" y="280"/>
                  </a:cubicBezTo>
                  <a:cubicBezTo>
                    <a:pt x="172" y="247"/>
                    <a:pt x="172" y="247"/>
                    <a:pt x="172" y="247"/>
                  </a:cubicBezTo>
                  <a:cubicBezTo>
                    <a:pt x="183" y="229"/>
                    <a:pt x="183" y="229"/>
                    <a:pt x="183" y="229"/>
                  </a:cubicBezTo>
                  <a:cubicBezTo>
                    <a:pt x="183" y="229"/>
                    <a:pt x="192" y="223"/>
                    <a:pt x="193" y="223"/>
                  </a:cubicBezTo>
                  <a:cubicBezTo>
                    <a:pt x="195" y="223"/>
                    <a:pt x="198" y="219"/>
                    <a:pt x="200" y="207"/>
                  </a:cubicBezTo>
                  <a:cubicBezTo>
                    <a:pt x="202" y="195"/>
                    <a:pt x="203" y="194"/>
                    <a:pt x="206" y="191"/>
                  </a:cubicBezTo>
                  <a:cubicBezTo>
                    <a:pt x="207" y="191"/>
                    <a:pt x="207" y="190"/>
                    <a:pt x="207" y="190"/>
                  </a:cubicBezTo>
                  <a:cubicBezTo>
                    <a:pt x="208" y="186"/>
                    <a:pt x="206" y="179"/>
                    <a:pt x="206" y="177"/>
                  </a:cubicBezTo>
                  <a:cubicBezTo>
                    <a:pt x="206" y="176"/>
                    <a:pt x="197" y="175"/>
                    <a:pt x="208" y="165"/>
                  </a:cubicBezTo>
                  <a:cubicBezTo>
                    <a:pt x="218" y="155"/>
                    <a:pt x="224" y="152"/>
                    <a:pt x="228" y="152"/>
                  </a:cubicBezTo>
                  <a:cubicBezTo>
                    <a:pt x="232" y="151"/>
                    <a:pt x="249" y="145"/>
                    <a:pt x="250" y="135"/>
                  </a:cubicBezTo>
                  <a:cubicBezTo>
                    <a:pt x="250" y="125"/>
                    <a:pt x="246" y="124"/>
                    <a:pt x="250" y="120"/>
                  </a:cubicBezTo>
                  <a:cubicBezTo>
                    <a:pt x="253" y="115"/>
                    <a:pt x="251" y="109"/>
                    <a:pt x="250" y="102"/>
                  </a:cubicBezTo>
                  <a:cubicBezTo>
                    <a:pt x="248" y="95"/>
                    <a:pt x="245" y="80"/>
                    <a:pt x="245" y="80"/>
                  </a:cubicBezTo>
                  <a:cubicBezTo>
                    <a:pt x="245" y="80"/>
                    <a:pt x="246" y="75"/>
                    <a:pt x="241" y="70"/>
                  </a:cubicBezTo>
                  <a:cubicBezTo>
                    <a:pt x="235" y="65"/>
                    <a:pt x="245" y="59"/>
                    <a:pt x="248" y="54"/>
                  </a:cubicBezTo>
                  <a:cubicBezTo>
                    <a:pt x="252" y="50"/>
                    <a:pt x="268" y="37"/>
                    <a:pt x="268" y="37"/>
                  </a:cubicBezTo>
                  <a:cubicBezTo>
                    <a:pt x="290" y="15"/>
                    <a:pt x="290" y="15"/>
                    <a:pt x="290" y="15"/>
                  </a:cubicBezTo>
                  <a:cubicBezTo>
                    <a:pt x="290" y="15"/>
                    <a:pt x="298" y="8"/>
                    <a:pt x="303" y="7"/>
                  </a:cubicBezTo>
                  <a:cubicBezTo>
                    <a:pt x="308" y="5"/>
                    <a:pt x="321" y="0"/>
                    <a:pt x="321" y="0"/>
                  </a:cubicBezTo>
                  <a:close/>
                </a:path>
              </a:pathLst>
            </a:cu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9" name="Freeform 262">
              <a:extLst>
                <a:ext uri="{FF2B5EF4-FFF2-40B4-BE49-F238E27FC236}">
                  <a16:creationId xmlns:a16="http://schemas.microsoft.com/office/drawing/2014/main" id="{5E8FB9CD-48AD-614F-F72F-035222AE7FA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207377" y="2987676"/>
              <a:ext cx="1192213" cy="1055688"/>
            </a:xfrm>
            <a:custGeom>
              <a:avLst/>
              <a:gdLst>
                <a:gd name="T0" fmla="*/ 263 w 264"/>
                <a:gd name="T1" fmla="*/ 90 h 234"/>
                <a:gd name="T2" fmla="*/ 250 w 264"/>
                <a:gd name="T3" fmla="*/ 122 h 234"/>
                <a:gd name="T4" fmla="*/ 229 w 264"/>
                <a:gd name="T5" fmla="*/ 146 h 234"/>
                <a:gd name="T6" fmla="*/ 173 w 264"/>
                <a:gd name="T7" fmla="*/ 204 h 234"/>
                <a:gd name="T8" fmla="*/ 139 w 264"/>
                <a:gd name="T9" fmla="*/ 219 h 234"/>
                <a:gd name="T10" fmla="*/ 113 w 264"/>
                <a:gd name="T11" fmla="*/ 219 h 234"/>
                <a:gd name="T12" fmla="*/ 86 w 264"/>
                <a:gd name="T13" fmla="*/ 223 h 234"/>
                <a:gd name="T14" fmla="*/ 71 w 264"/>
                <a:gd name="T15" fmla="*/ 226 h 234"/>
                <a:gd name="T16" fmla="*/ 57 w 264"/>
                <a:gd name="T17" fmla="*/ 234 h 234"/>
                <a:gd name="T18" fmla="*/ 48 w 264"/>
                <a:gd name="T19" fmla="*/ 231 h 234"/>
                <a:gd name="T20" fmla="*/ 36 w 264"/>
                <a:gd name="T21" fmla="*/ 222 h 234"/>
                <a:gd name="T22" fmla="*/ 31 w 264"/>
                <a:gd name="T23" fmla="*/ 217 h 234"/>
                <a:gd name="T24" fmla="*/ 23 w 264"/>
                <a:gd name="T25" fmla="*/ 199 h 234"/>
                <a:gd name="T26" fmla="*/ 29 w 264"/>
                <a:gd name="T27" fmla="*/ 194 h 234"/>
                <a:gd name="T28" fmla="*/ 20 w 264"/>
                <a:gd name="T29" fmla="*/ 162 h 234"/>
                <a:gd name="T30" fmla="*/ 0 w 264"/>
                <a:gd name="T31" fmla="*/ 118 h 234"/>
                <a:gd name="T32" fmla="*/ 19 w 264"/>
                <a:gd name="T33" fmla="*/ 119 h 234"/>
                <a:gd name="T34" fmla="*/ 47 w 264"/>
                <a:gd name="T35" fmla="*/ 121 h 234"/>
                <a:gd name="T36" fmla="*/ 57 w 264"/>
                <a:gd name="T37" fmla="*/ 110 h 234"/>
                <a:gd name="T38" fmla="*/ 68 w 264"/>
                <a:gd name="T39" fmla="*/ 56 h 234"/>
                <a:gd name="T40" fmla="*/ 70 w 264"/>
                <a:gd name="T41" fmla="*/ 79 h 234"/>
                <a:gd name="T42" fmla="*/ 79 w 264"/>
                <a:gd name="T43" fmla="*/ 86 h 234"/>
                <a:gd name="T44" fmla="*/ 106 w 264"/>
                <a:gd name="T45" fmla="*/ 60 h 234"/>
                <a:gd name="T46" fmla="*/ 122 w 264"/>
                <a:gd name="T47" fmla="*/ 62 h 234"/>
                <a:gd name="T48" fmla="*/ 153 w 264"/>
                <a:gd name="T49" fmla="*/ 56 h 234"/>
                <a:gd name="T50" fmla="*/ 171 w 264"/>
                <a:gd name="T51" fmla="*/ 31 h 234"/>
                <a:gd name="T52" fmla="*/ 186 w 264"/>
                <a:gd name="T53" fmla="*/ 15 h 234"/>
                <a:gd name="T54" fmla="*/ 208 w 264"/>
                <a:gd name="T55" fmla="*/ 0 h 234"/>
                <a:gd name="T56" fmla="*/ 242 w 264"/>
                <a:gd name="T57" fmla="*/ 2 h 234"/>
                <a:gd name="T58" fmla="*/ 244 w 264"/>
                <a:gd name="T59" fmla="*/ 14 h 234"/>
                <a:gd name="T60" fmla="*/ 246 w 264"/>
                <a:gd name="T61" fmla="*/ 28 h 234"/>
                <a:gd name="T62" fmla="*/ 248 w 264"/>
                <a:gd name="T63" fmla="*/ 34 h 234"/>
                <a:gd name="T64" fmla="*/ 250 w 264"/>
                <a:gd name="T65" fmla="*/ 63 h 234"/>
                <a:gd name="T66" fmla="*/ 246 w 264"/>
                <a:gd name="T67" fmla="*/ 68 h 234"/>
                <a:gd name="T68" fmla="*/ 239 w 264"/>
                <a:gd name="T69" fmla="*/ 70 h 234"/>
                <a:gd name="T70" fmla="*/ 238 w 264"/>
                <a:gd name="T71" fmla="*/ 74 h 234"/>
                <a:gd name="T72" fmla="*/ 233 w 264"/>
                <a:gd name="T73" fmla="*/ 79 h 234"/>
                <a:gd name="T74" fmla="*/ 232 w 264"/>
                <a:gd name="T75" fmla="*/ 87 h 234"/>
                <a:gd name="T76" fmla="*/ 238 w 264"/>
                <a:gd name="T77" fmla="*/ 92 h 234"/>
                <a:gd name="T78" fmla="*/ 243 w 264"/>
                <a:gd name="T79" fmla="*/ 94 h 234"/>
                <a:gd name="T80" fmla="*/ 248 w 264"/>
                <a:gd name="T81" fmla="*/ 92 h 234"/>
                <a:gd name="T82" fmla="*/ 250 w 264"/>
                <a:gd name="T83" fmla="*/ 89 h 234"/>
                <a:gd name="T84" fmla="*/ 255 w 264"/>
                <a:gd name="T85" fmla="*/ 89 h 234"/>
                <a:gd name="T86" fmla="*/ 206 w 264"/>
                <a:gd name="T87" fmla="*/ 133 h 234"/>
                <a:gd name="T88" fmla="*/ 204 w 264"/>
                <a:gd name="T89" fmla="*/ 126 h 234"/>
                <a:gd name="T90" fmla="*/ 197 w 264"/>
                <a:gd name="T91" fmla="*/ 119 h 234"/>
                <a:gd name="T92" fmla="*/ 190 w 264"/>
                <a:gd name="T93" fmla="*/ 119 h 234"/>
                <a:gd name="T94" fmla="*/ 184 w 264"/>
                <a:gd name="T95" fmla="*/ 124 h 234"/>
                <a:gd name="T96" fmla="*/ 178 w 264"/>
                <a:gd name="T97" fmla="*/ 129 h 234"/>
                <a:gd name="T98" fmla="*/ 174 w 264"/>
                <a:gd name="T99" fmla="*/ 133 h 234"/>
                <a:gd name="T100" fmla="*/ 169 w 264"/>
                <a:gd name="T101" fmla="*/ 139 h 234"/>
                <a:gd name="T102" fmla="*/ 172 w 264"/>
                <a:gd name="T103" fmla="*/ 148 h 234"/>
                <a:gd name="T104" fmla="*/ 179 w 264"/>
                <a:gd name="T105" fmla="*/ 156 h 234"/>
                <a:gd name="T106" fmla="*/ 184 w 264"/>
                <a:gd name="T107" fmla="*/ 156 h 234"/>
                <a:gd name="T108" fmla="*/ 186 w 264"/>
                <a:gd name="T109" fmla="*/ 149 h 234"/>
                <a:gd name="T110" fmla="*/ 191 w 264"/>
                <a:gd name="T111" fmla="*/ 146 h 234"/>
                <a:gd name="T112" fmla="*/ 197 w 264"/>
                <a:gd name="T113" fmla="*/ 146 h 234"/>
                <a:gd name="T114" fmla="*/ 202 w 264"/>
                <a:gd name="T115" fmla="*/ 141 h 234"/>
                <a:gd name="T116" fmla="*/ 206 w 264"/>
                <a:gd name="T117" fmla="*/ 133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64" h="234">
                  <a:moveTo>
                    <a:pt x="264" y="89"/>
                  </a:moveTo>
                  <a:cubicBezTo>
                    <a:pt x="264" y="89"/>
                    <a:pt x="264" y="90"/>
                    <a:pt x="263" y="90"/>
                  </a:cubicBezTo>
                  <a:cubicBezTo>
                    <a:pt x="260" y="93"/>
                    <a:pt x="259" y="94"/>
                    <a:pt x="257" y="106"/>
                  </a:cubicBezTo>
                  <a:cubicBezTo>
                    <a:pt x="255" y="118"/>
                    <a:pt x="252" y="122"/>
                    <a:pt x="250" y="122"/>
                  </a:cubicBezTo>
                  <a:cubicBezTo>
                    <a:pt x="249" y="122"/>
                    <a:pt x="240" y="128"/>
                    <a:pt x="240" y="128"/>
                  </a:cubicBezTo>
                  <a:cubicBezTo>
                    <a:pt x="229" y="146"/>
                    <a:pt x="229" y="146"/>
                    <a:pt x="229" y="146"/>
                  </a:cubicBezTo>
                  <a:cubicBezTo>
                    <a:pt x="203" y="179"/>
                    <a:pt x="203" y="179"/>
                    <a:pt x="203" y="179"/>
                  </a:cubicBezTo>
                  <a:cubicBezTo>
                    <a:pt x="203" y="179"/>
                    <a:pt x="185" y="194"/>
                    <a:pt x="173" y="204"/>
                  </a:cubicBezTo>
                  <a:cubicBezTo>
                    <a:pt x="162" y="215"/>
                    <a:pt x="156" y="214"/>
                    <a:pt x="153" y="214"/>
                  </a:cubicBezTo>
                  <a:cubicBezTo>
                    <a:pt x="150" y="214"/>
                    <a:pt x="142" y="217"/>
                    <a:pt x="139" y="219"/>
                  </a:cubicBezTo>
                  <a:cubicBezTo>
                    <a:pt x="137" y="221"/>
                    <a:pt x="129" y="222"/>
                    <a:pt x="128" y="221"/>
                  </a:cubicBezTo>
                  <a:cubicBezTo>
                    <a:pt x="126" y="221"/>
                    <a:pt x="116" y="218"/>
                    <a:pt x="113" y="219"/>
                  </a:cubicBezTo>
                  <a:cubicBezTo>
                    <a:pt x="110" y="220"/>
                    <a:pt x="99" y="218"/>
                    <a:pt x="95" y="219"/>
                  </a:cubicBezTo>
                  <a:cubicBezTo>
                    <a:pt x="90" y="220"/>
                    <a:pt x="86" y="221"/>
                    <a:pt x="86" y="223"/>
                  </a:cubicBezTo>
                  <a:cubicBezTo>
                    <a:pt x="86" y="224"/>
                    <a:pt x="83" y="226"/>
                    <a:pt x="83" y="226"/>
                  </a:cubicBezTo>
                  <a:cubicBezTo>
                    <a:pt x="83" y="226"/>
                    <a:pt x="75" y="226"/>
                    <a:pt x="71" y="226"/>
                  </a:cubicBezTo>
                  <a:cubicBezTo>
                    <a:pt x="67" y="226"/>
                    <a:pt x="63" y="227"/>
                    <a:pt x="60" y="229"/>
                  </a:cubicBezTo>
                  <a:cubicBezTo>
                    <a:pt x="58" y="230"/>
                    <a:pt x="57" y="234"/>
                    <a:pt x="57" y="234"/>
                  </a:cubicBezTo>
                  <a:cubicBezTo>
                    <a:pt x="50" y="234"/>
                    <a:pt x="50" y="234"/>
                    <a:pt x="50" y="234"/>
                  </a:cubicBezTo>
                  <a:cubicBezTo>
                    <a:pt x="48" y="231"/>
                    <a:pt x="48" y="231"/>
                    <a:pt x="48" y="231"/>
                  </a:cubicBezTo>
                  <a:cubicBezTo>
                    <a:pt x="42" y="226"/>
                    <a:pt x="42" y="226"/>
                    <a:pt x="42" y="226"/>
                  </a:cubicBezTo>
                  <a:cubicBezTo>
                    <a:pt x="42" y="226"/>
                    <a:pt x="39" y="223"/>
                    <a:pt x="36" y="222"/>
                  </a:cubicBezTo>
                  <a:cubicBezTo>
                    <a:pt x="34" y="222"/>
                    <a:pt x="31" y="222"/>
                    <a:pt x="31" y="222"/>
                  </a:cubicBezTo>
                  <a:cubicBezTo>
                    <a:pt x="31" y="217"/>
                    <a:pt x="31" y="217"/>
                    <a:pt x="31" y="217"/>
                  </a:cubicBezTo>
                  <a:cubicBezTo>
                    <a:pt x="29" y="206"/>
                    <a:pt x="29" y="206"/>
                    <a:pt x="29" y="206"/>
                  </a:cubicBezTo>
                  <a:cubicBezTo>
                    <a:pt x="29" y="206"/>
                    <a:pt x="24" y="203"/>
                    <a:pt x="23" y="199"/>
                  </a:cubicBezTo>
                  <a:cubicBezTo>
                    <a:pt x="21" y="194"/>
                    <a:pt x="24" y="195"/>
                    <a:pt x="26" y="194"/>
                  </a:cubicBezTo>
                  <a:cubicBezTo>
                    <a:pt x="28" y="194"/>
                    <a:pt x="29" y="194"/>
                    <a:pt x="29" y="194"/>
                  </a:cubicBezTo>
                  <a:cubicBezTo>
                    <a:pt x="29" y="194"/>
                    <a:pt x="29" y="189"/>
                    <a:pt x="29" y="184"/>
                  </a:cubicBezTo>
                  <a:cubicBezTo>
                    <a:pt x="28" y="178"/>
                    <a:pt x="23" y="166"/>
                    <a:pt x="20" y="162"/>
                  </a:cubicBezTo>
                  <a:cubicBezTo>
                    <a:pt x="18" y="157"/>
                    <a:pt x="14" y="152"/>
                    <a:pt x="12" y="145"/>
                  </a:cubicBezTo>
                  <a:cubicBezTo>
                    <a:pt x="11" y="138"/>
                    <a:pt x="2" y="121"/>
                    <a:pt x="0" y="118"/>
                  </a:cubicBezTo>
                  <a:cubicBezTo>
                    <a:pt x="1" y="119"/>
                    <a:pt x="4" y="123"/>
                    <a:pt x="8" y="113"/>
                  </a:cubicBezTo>
                  <a:cubicBezTo>
                    <a:pt x="12" y="103"/>
                    <a:pt x="16" y="115"/>
                    <a:pt x="19" y="119"/>
                  </a:cubicBezTo>
                  <a:cubicBezTo>
                    <a:pt x="21" y="123"/>
                    <a:pt x="35" y="124"/>
                    <a:pt x="35" y="124"/>
                  </a:cubicBezTo>
                  <a:cubicBezTo>
                    <a:pt x="35" y="124"/>
                    <a:pt x="46" y="125"/>
                    <a:pt x="47" y="121"/>
                  </a:cubicBezTo>
                  <a:cubicBezTo>
                    <a:pt x="48" y="118"/>
                    <a:pt x="57" y="115"/>
                    <a:pt x="57" y="115"/>
                  </a:cubicBezTo>
                  <a:cubicBezTo>
                    <a:pt x="57" y="110"/>
                    <a:pt x="57" y="110"/>
                    <a:pt x="57" y="110"/>
                  </a:cubicBezTo>
                  <a:cubicBezTo>
                    <a:pt x="60" y="49"/>
                    <a:pt x="60" y="49"/>
                    <a:pt x="60" y="49"/>
                  </a:cubicBezTo>
                  <a:cubicBezTo>
                    <a:pt x="60" y="49"/>
                    <a:pt x="66" y="53"/>
                    <a:pt x="68" y="56"/>
                  </a:cubicBezTo>
                  <a:cubicBezTo>
                    <a:pt x="70" y="60"/>
                    <a:pt x="73" y="66"/>
                    <a:pt x="72" y="70"/>
                  </a:cubicBezTo>
                  <a:cubicBezTo>
                    <a:pt x="72" y="74"/>
                    <a:pt x="71" y="74"/>
                    <a:pt x="70" y="79"/>
                  </a:cubicBezTo>
                  <a:cubicBezTo>
                    <a:pt x="69" y="83"/>
                    <a:pt x="68" y="86"/>
                    <a:pt x="70" y="86"/>
                  </a:cubicBezTo>
                  <a:cubicBezTo>
                    <a:pt x="72" y="87"/>
                    <a:pt x="76" y="86"/>
                    <a:pt x="79" y="86"/>
                  </a:cubicBezTo>
                  <a:cubicBezTo>
                    <a:pt x="82" y="86"/>
                    <a:pt x="89" y="87"/>
                    <a:pt x="97" y="77"/>
                  </a:cubicBezTo>
                  <a:cubicBezTo>
                    <a:pt x="105" y="67"/>
                    <a:pt x="106" y="61"/>
                    <a:pt x="106" y="60"/>
                  </a:cubicBezTo>
                  <a:cubicBezTo>
                    <a:pt x="105" y="58"/>
                    <a:pt x="108" y="57"/>
                    <a:pt x="111" y="56"/>
                  </a:cubicBezTo>
                  <a:cubicBezTo>
                    <a:pt x="114" y="56"/>
                    <a:pt x="120" y="61"/>
                    <a:pt x="122" y="62"/>
                  </a:cubicBezTo>
                  <a:cubicBezTo>
                    <a:pt x="124" y="64"/>
                    <a:pt x="132" y="68"/>
                    <a:pt x="139" y="66"/>
                  </a:cubicBezTo>
                  <a:cubicBezTo>
                    <a:pt x="146" y="65"/>
                    <a:pt x="153" y="61"/>
                    <a:pt x="153" y="56"/>
                  </a:cubicBezTo>
                  <a:cubicBezTo>
                    <a:pt x="153" y="52"/>
                    <a:pt x="167" y="40"/>
                    <a:pt x="168" y="41"/>
                  </a:cubicBezTo>
                  <a:cubicBezTo>
                    <a:pt x="169" y="42"/>
                    <a:pt x="170" y="35"/>
                    <a:pt x="171" y="31"/>
                  </a:cubicBezTo>
                  <a:cubicBezTo>
                    <a:pt x="172" y="28"/>
                    <a:pt x="173" y="26"/>
                    <a:pt x="175" y="24"/>
                  </a:cubicBezTo>
                  <a:cubicBezTo>
                    <a:pt x="178" y="22"/>
                    <a:pt x="183" y="20"/>
                    <a:pt x="186" y="15"/>
                  </a:cubicBezTo>
                  <a:cubicBezTo>
                    <a:pt x="190" y="11"/>
                    <a:pt x="192" y="8"/>
                    <a:pt x="194" y="8"/>
                  </a:cubicBezTo>
                  <a:cubicBezTo>
                    <a:pt x="196" y="8"/>
                    <a:pt x="208" y="1"/>
                    <a:pt x="208" y="0"/>
                  </a:cubicBezTo>
                  <a:cubicBezTo>
                    <a:pt x="217" y="2"/>
                    <a:pt x="217" y="2"/>
                    <a:pt x="217" y="2"/>
                  </a:cubicBezTo>
                  <a:cubicBezTo>
                    <a:pt x="242" y="2"/>
                    <a:pt x="242" y="2"/>
                    <a:pt x="242" y="2"/>
                  </a:cubicBezTo>
                  <a:cubicBezTo>
                    <a:pt x="242" y="2"/>
                    <a:pt x="240" y="6"/>
                    <a:pt x="242" y="8"/>
                  </a:cubicBezTo>
                  <a:cubicBezTo>
                    <a:pt x="243" y="9"/>
                    <a:pt x="244" y="14"/>
                    <a:pt x="244" y="14"/>
                  </a:cubicBezTo>
                  <a:cubicBezTo>
                    <a:pt x="244" y="14"/>
                    <a:pt x="244" y="16"/>
                    <a:pt x="245" y="19"/>
                  </a:cubicBezTo>
                  <a:cubicBezTo>
                    <a:pt x="245" y="22"/>
                    <a:pt x="245" y="27"/>
                    <a:pt x="246" y="28"/>
                  </a:cubicBezTo>
                  <a:cubicBezTo>
                    <a:pt x="247" y="29"/>
                    <a:pt x="248" y="32"/>
                    <a:pt x="248" y="32"/>
                  </a:cubicBezTo>
                  <a:cubicBezTo>
                    <a:pt x="248" y="34"/>
                    <a:pt x="248" y="34"/>
                    <a:pt x="248" y="34"/>
                  </a:cubicBezTo>
                  <a:cubicBezTo>
                    <a:pt x="248" y="51"/>
                    <a:pt x="248" y="51"/>
                    <a:pt x="248" y="51"/>
                  </a:cubicBezTo>
                  <a:cubicBezTo>
                    <a:pt x="250" y="63"/>
                    <a:pt x="250" y="63"/>
                    <a:pt x="250" y="63"/>
                  </a:cubicBezTo>
                  <a:cubicBezTo>
                    <a:pt x="250" y="70"/>
                    <a:pt x="250" y="70"/>
                    <a:pt x="250" y="70"/>
                  </a:cubicBezTo>
                  <a:cubicBezTo>
                    <a:pt x="246" y="68"/>
                    <a:pt x="246" y="68"/>
                    <a:pt x="246" y="68"/>
                  </a:cubicBezTo>
                  <a:cubicBezTo>
                    <a:pt x="241" y="68"/>
                    <a:pt x="241" y="68"/>
                    <a:pt x="241" y="68"/>
                  </a:cubicBezTo>
                  <a:cubicBezTo>
                    <a:pt x="239" y="70"/>
                    <a:pt x="239" y="70"/>
                    <a:pt x="239" y="70"/>
                  </a:cubicBezTo>
                  <a:cubicBezTo>
                    <a:pt x="239" y="70"/>
                    <a:pt x="238" y="71"/>
                    <a:pt x="238" y="72"/>
                  </a:cubicBezTo>
                  <a:cubicBezTo>
                    <a:pt x="237" y="73"/>
                    <a:pt x="239" y="73"/>
                    <a:pt x="238" y="74"/>
                  </a:cubicBezTo>
                  <a:cubicBezTo>
                    <a:pt x="236" y="75"/>
                    <a:pt x="234" y="77"/>
                    <a:pt x="234" y="77"/>
                  </a:cubicBezTo>
                  <a:cubicBezTo>
                    <a:pt x="233" y="79"/>
                    <a:pt x="233" y="79"/>
                    <a:pt x="233" y="79"/>
                  </a:cubicBezTo>
                  <a:cubicBezTo>
                    <a:pt x="233" y="79"/>
                    <a:pt x="234" y="81"/>
                    <a:pt x="233" y="82"/>
                  </a:cubicBezTo>
                  <a:cubicBezTo>
                    <a:pt x="232" y="83"/>
                    <a:pt x="232" y="87"/>
                    <a:pt x="232" y="87"/>
                  </a:cubicBezTo>
                  <a:cubicBezTo>
                    <a:pt x="232" y="87"/>
                    <a:pt x="234" y="90"/>
                    <a:pt x="235" y="90"/>
                  </a:cubicBezTo>
                  <a:cubicBezTo>
                    <a:pt x="236" y="91"/>
                    <a:pt x="238" y="92"/>
                    <a:pt x="238" y="92"/>
                  </a:cubicBezTo>
                  <a:cubicBezTo>
                    <a:pt x="241" y="94"/>
                    <a:pt x="241" y="94"/>
                    <a:pt x="241" y="94"/>
                  </a:cubicBezTo>
                  <a:cubicBezTo>
                    <a:pt x="243" y="94"/>
                    <a:pt x="243" y="94"/>
                    <a:pt x="243" y="94"/>
                  </a:cubicBezTo>
                  <a:cubicBezTo>
                    <a:pt x="245" y="94"/>
                    <a:pt x="245" y="94"/>
                    <a:pt x="245" y="94"/>
                  </a:cubicBezTo>
                  <a:cubicBezTo>
                    <a:pt x="248" y="92"/>
                    <a:pt x="248" y="92"/>
                    <a:pt x="248" y="92"/>
                  </a:cubicBezTo>
                  <a:cubicBezTo>
                    <a:pt x="249" y="91"/>
                    <a:pt x="249" y="91"/>
                    <a:pt x="249" y="91"/>
                  </a:cubicBezTo>
                  <a:cubicBezTo>
                    <a:pt x="250" y="89"/>
                    <a:pt x="250" y="89"/>
                    <a:pt x="250" y="89"/>
                  </a:cubicBezTo>
                  <a:cubicBezTo>
                    <a:pt x="253" y="87"/>
                    <a:pt x="253" y="87"/>
                    <a:pt x="253" y="87"/>
                  </a:cubicBezTo>
                  <a:cubicBezTo>
                    <a:pt x="253" y="87"/>
                    <a:pt x="254" y="88"/>
                    <a:pt x="255" y="89"/>
                  </a:cubicBezTo>
                  <a:cubicBezTo>
                    <a:pt x="257" y="89"/>
                    <a:pt x="264" y="89"/>
                    <a:pt x="264" y="89"/>
                  </a:cubicBezTo>
                  <a:close/>
                  <a:moveTo>
                    <a:pt x="206" y="133"/>
                  </a:moveTo>
                  <a:cubicBezTo>
                    <a:pt x="206" y="130"/>
                    <a:pt x="206" y="130"/>
                    <a:pt x="206" y="130"/>
                  </a:cubicBezTo>
                  <a:cubicBezTo>
                    <a:pt x="204" y="126"/>
                    <a:pt x="204" y="126"/>
                    <a:pt x="204" y="126"/>
                  </a:cubicBezTo>
                  <a:cubicBezTo>
                    <a:pt x="200" y="123"/>
                    <a:pt x="200" y="123"/>
                    <a:pt x="200" y="123"/>
                  </a:cubicBezTo>
                  <a:cubicBezTo>
                    <a:pt x="197" y="119"/>
                    <a:pt x="197" y="119"/>
                    <a:pt x="197" y="119"/>
                  </a:cubicBezTo>
                  <a:cubicBezTo>
                    <a:pt x="195" y="119"/>
                    <a:pt x="195" y="119"/>
                    <a:pt x="195" y="119"/>
                  </a:cubicBezTo>
                  <a:cubicBezTo>
                    <a:pt x="190" y="119"/>
                    <a:pt x="190" y="119"/>
                    <a:pt x="190" y="119"/>
                  </a:cubicBezTo>
                  <a:cubicBezTo>
                    <a:pt x="188" y="122"/>
                    <a:pt x="188" y="122"/>
                    <a:pt x="188" y="122"/>
                  </a:cubicBezTo>
                  <a:cubicBezTo>
                    <a:pt x="188" y="122"/>
                    <a:pt x="185" y="123"/>
                    <a:pt x="184" y="124"/>
                  </a:cubicBezTo>
                  <a:cubicBezTo>
                    <a:pt x="184" y="126"/>
                    <a:pt x="181" y="127"/>
                    <a:pt x="181" y="127"/>
                  </a:cubicBezTo>
                  <a:cubicBezTo>
                    <a:pt x="178" y="129"/>
                    <a:pt x="178" y="129"/>
                    <a:pt x="178" y="129"/>
                  </a:cubicBezTo>
                  <a:cubicBezTo>
                    <a:pt x="176" y="131"/>
                    <a:pt x="176" y="131"/>
                    <a:pt x="176" y="131"/>
                  </a:cubicBezTo>
                  <a:cubicBezTo>
                    <a:pt x="174" y="133"/>
                    <a:pt x="174" y="133"/>
                    <a:pt x="174" y="133"/>
                  </a:cubicBezTo>
                  <a:cubicBezTo>
                    <a:pt x="169" y="136"/>
                    <a:pt x="169" y="136"/>
                    <a:pt x="169" y="136"/>
                  </a:cubicBezTo>
                  <a:cubicBezTo>
                    <a:pt x="169" y="139"/>
                    <a:pt x="169" y="139"/>
                    <a:pt x="169" y="139"/>
                  </a:cubicBezTo>
                  <a:cubicBezTo>
                    <a:pt x="169" y="144"/>
                    <a:pt x="169" y="144"/>
                    <a:pt x="169" y="144"/>
                  </a:cubicBezTo>
                  <a:cubicBezTo>
                    <a:pt x="172" y="148"/>
                    <a:pt x="172" y="148"/>
                    <a:pt x="172" y="148"/>
                  </a:cubicBezTo>
                  <a:cubicBezTo>
                    <a:pt x="176" y="152"/>
                    <a:pt x="176" y="152"/>
                    <a:pt x="176" y="152"/>
                  </a:cubicBezTo>
                  <a:cubicBezTo>
                    <a:pt x="179" y="156"/>
                    <a:pt x="179" y="156"/>
                    <a:pt x="179" y="156"/>
                  </a:cubicBezTo>
                  <a:cubicBezTo>
                    <a:pt x="182" y="158"/>
                    <a:pt x="182" y="158"/>
                    <a:pt x="182" y="158"/>
                  </a:cubicBezTo>
                  <a:cubicBezTo>
                    <a:pt x="184" y="156"/>
                    <a:pt x="184" y="156"/>
                    <a:pt x="184" y="156"/>
                  </a:cubicBezTo>
                  <a:cubicBezTo>
                    <a:pt x="184" y="156"/>
                    <a:pt x="186" y="155"/>
                    <a:pt x="186" y="154"/>
                  </a:cubicBezTo>
                  <a:cubicBezTo>
                    <a:pt x="187" y="153"/>
                    <a:pt x="186" y="149"/>
                    <a:pt x="186" y="149"/>
                  </a:cubicBezTo>
                  <a:cubicBezTo>
                    <a:pt x="189" y="148"/>
                    <a:pt x="189" y="148"/>
                    <a:pt x="189" y="148"/>
                  </a:cubicBezTo>
                  <a:cubicBezTo>
                    <a:pt x="191" y="146"/>
                    <a:pt x="191" y="146"/>
                    <a:pt x="191" y="146"/>
                  </a:cubicBezTo>
                  <a:cubicBezTo>
                    <a:pt x="194" y="146"/>
                    <a:pt x="194" y="146"/>
                    <a:pt x="194" y="146"/>
                  </a:cubicBezTo>
                  <a:cubicBezTo>
                    <a:pt x="197" y="146"/>
                    <a:pt x="197" y="146"/>
                    <a:pt x="197" y="146"/>
                  </a:cubicBezTo>
                  <a:cubicBezTo>
                    <a:pt x="200" y="144"/>
                    <a:pt x="200" y="144"/>
                    <a:pt x="200" y="144"/>
                  </a:cubicBezTo>
                  <a:cubicBezTo>
                    <a:pt x="202" y="141"/>
                    <a:pt x="202" y="141"/>
                    <a:pt x="202" y="141"/>
                  </a:cubicBezTo>
                  <a:cubicBezTo>
                    <a:pt x="204" y="137"/>
                    <a:pt x="204" y="137"/>
                    <a:pt x="204" y="137"/>
                  </a:cubicBezTo>
                  <a:lnTo>
                    <a:pt x="206" y="133"/>
                  </a:lnTo>
                  <a:close/>
                </a:path>
              </a:pathLst>
            </a:cu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0" name="Freeform 263">
              <a:extLst>
                <a:ext uri="{FF2B5EF4-FFF2-40B4-BE49-F238E27FC236}">
                  <a16:creationId xmlns:a16="http://schemas.microsoft.com/office/drawing/2014/main" id="{BC08DAB2-9EA6-0543-0440-8FF159D44948}"/>
                </a:ext>
              </a:extLst>
            </p:cNvPr>
            <p:cNvSpPr>
              <a:spLocks/>
            </p:cNvSpPr>
            <p:nvPr/>
          </p:nvSpPr>
          <p:spPr bwMode="auto">
            <a:xfrm>
              <a:off x="7883527" y="2439988"/>
              <a:ext cx="842963" cy="195263"/>
            </a:xfrm>
            <a:custGeom>
              <a:avLst/>
              <a:gdLst>
                <a:gd name="T0" fmla="*/ 176 w 187"/>
                <a:gd name="T1" fmla="*/ 24 h 43"/>
                <a:gd name="T2" fmla="*/ 187 w 187"/>
                <a:gd name="T3" fmla="*/ 37 h 43"/>
                <a:gd name="T4" fmla="*/ 169 w 187"/>
                <a:gd name="T5" fmla="*/ 41 h 43"/>
                <a:gd name="T6" fmla="*/ 122 w 187"/>
                <a:gd name="T7" fmla="*/ 41 h 43"/>
                <a:gd name="T8" fmla="*/ 110 w 187"/>
                <a:gd name="T9" fmla="*/ 34 h 43"/>
                <a:gd name="T10" fmla="*/ 97 w 187"/>
                <a:gd name="T11" fmla="*/ 32 h 43"/>
                <a:gd name="T12" fmla="*/ 82 w 187"/>
                <a:gd name="T13" fmla="*/ 32 h 43"/>
                <a:gd name="T14" fmla="*/ 42 w 187"/>
                <a:gd name="T15" fmla="*/ 34 h 43"/>
                <a:gd name="T16" fmla="*/ 28 w 187"/>
                <a:gd name="T17" fmla="*/ 25 h 43"/>
                <a:gd name="T18" fmla="*/ 20 w 187"/>
                <a:gd name="T19" fmla="*/ 25 h 43"/>
                <a:gd name="T20" fmla="*/ 12 w 187"/>
                <a:gd name="T21" fmla="*/ 28 h 43"/>
                <a:gd name="T22" fmla="*/ 0 w 187"/>
                <a:gd name="T23" fmla="*/ 28 h 43"/>
                <a:gd name="T24" fmla="*/ 0 w 187"/>
                <a:gd name="T25" fmla="*/ 0 h 43"/>
                <a:gd name="T26" fmla="*/ 167 w 187"/>
                <a:gd name="T27" fmla="*/ 0 h 43"/>
                <a:gd name="T28" fmla="*/ 167 w 187"/>
                <a:gd name="T29" fmla="*/ 13 h 43"/>
                <a:gd name="T30" fmla="*/ 176 w 187"/>
                <a:gd name="T31" fmla="*/ 24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87" h="43">
                  <a:moveTo>
                    <a:pt x="176" y="24"/>
                  </a:moveTo>
                  <a:cubicBezTo>
                    <a:pt x="187" y="37"/>
                    <a:pt x="187" y="37"/>
                    <a:pt x="187" y="37"/>
                  </a:cubicBezTo>
                  <a:cubicBezTo>
                    <a:pt x="169" y="41"/>
                    <a:pt x="169" y="41"/>
                    <a:pt x="169" y="41"/>
                  </a:cubicBezTo>
                  <a:cubicBezTo>
                    <a:pt x="169" y="41"/>
                    <a:pt x="136" y="43"/>
                    <a:pt x="122" y="41"/>
                  </a:cubicBezTo>
                  <a:cubicBezTo>
                    <a:pt x="109" y="39"/>
                    <a:pt x="113" y="36"/>
                    <a:pt x="110" y="34"/>
                  </a:cubicBezTo>
                  <a:cubicBezTo>
                    <a:pt x="106" y="32"/>
                    <a:pt x="97" y="32"/>
                    <a:pt x="97" y="32"/>
                  </a:cubicBezTo>
                  <a:cubicBezTo>
                    <a:pt x="82" y="32"/>
                    <a:pt x="82" y="32"/>
                    <a:pt x="82" y="32"/>
                  </a:cubicBezTo>
                  <a:cubicBezTo>
                    <a:pt x="82" y="32"/>
                    <a:pt x="45" y="32"/>
                    <a:pt x="42" y="34"/>
                  </a:cubicBezTo>
                  <a:cubicBezTo>
                    <a:pt x="38" y="35"/>
                    <a:pt x="31" y="26"/>
                    <a:pt x="28" y="25"/>
                  </a:cubicBezTo>
                  <a:cubicBezTo>
                    <a:pt x="25" y="24"/>
                    <a:pt x="21" y="22"/>
                    <a:pt x="20" y="25"/>
                  </a:cubicBezTo>
                  <a:cubicBezTo>
                    <a:pt x="19" y="27"/>
                    <a:pt x="12" y="28"/>
                    <a:pt x="12" y="28"/>
                  </a:cubicBezTo>
                  <a:cubicBezTo>
                    <a:pt x="0" y="28"/>
                    <a:pt x="0" y="28"/>
                    <a:pt x="0" y="28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7" y="0"/>
                    <a:pt x="167" y="0"/>
                    <a:pt x="167" y="0"/>
                  </a:cubicBezTo>
                  <a:cubicBezTo>
                    <a:pt x="167" y="13"/>
                    <a:pt x="167" y="13"/>
                    <a:pt x="167" y="13"/>
                  </a:cubicBezTo>
                  <a:lnTo>
                    <a:pt x="176" y="24"/>
                  </a:lnTo>
                  <a:close/>
                </a:path>
              </a:pathLst>
            </a:cu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1" name="Freeform 264">
              <a:extLst>
                <a:ext uri="{FF2B5EF4-FFF2-40B4-BE49-F238E27FC236}">
                  <a16:creationId xmlns:a16="http://schemas.microsoft.com/office/drawing/2014/main" id="{5BAFCB77-5C08-DFAE-1F81-6A81FA28AAF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90670" y="2652714"/>
              <a:ext cx="550863" cy="1385888"/>
            </a:xfrm>
            <a:custGeom>
              <a:avLst/>
              <a:gdLst>
                <a:gd name="T0" fmla="*/ 122 w 122"/>
                <a:gd name="T1" fmla="*/ 307 h 307"/>
                <a:gd name="T2" fmla="*/ 0 w 122"/>
                <a:gd name="T3" fmla="*/ 307 h 307"/>
                <a:gd name="T4" fmla="*/ 0 w 122"/>
                <a:gd name="T5" fmla="*/ 0 h 307"/>
                <a:gd name="T6" fmla="*/ 7 w 122"/>
                <a:gd name="T7" fmla="*/ 10 h 307"/>
                <a:gd name="T8" fmla="*/ 16 w 122"/>
                <a:gd name="T9" fmla="*/ 22 h 307"/>
                <a:gd name="T10" fmla="*/ 28 w 122"/>
                <a:gd name="T11" fmla="*/ 48 h 307"/>
                <a:gd name="T12" fmla="*/ 35 w 122"/>
                <a:gd name="T13" fmla="*/ 60 h 307"/>
                <a:gd name="T14" fmla="*/ 39 w 122"/>
                <a:gd name="T15" fmla="*/ 71 h 307"/>
                <a:gd name="T16" fmla="*/ 43 w 122"/>
                <a:gd name="T17" fmla="*/ 79 h 307"/>
                <a:gd name="T18" fmla="*/ 43 w 122"/>
                <a:gd name="T19" fmla="*/ 103 h 307"/>
                <a:gd name="T20" fmla="*/ 47 w 122"/>
                <a:gd name="T21" fmla="*/ 118 h 307"/>
                <a:gd name="T22" fmla="*/ 51 w 122"/>
                <a:gd name="T23" fmla="*/ 139 h 307"/>
                <a:gd name="T24" fmla="*/ 61 w 122"/>
                <a:gd name="T25" fmla="*/ 178 h 307"/>
                <a:gd name="T26" fmla="*/ 72 w 122"/>
                <a:gd name="T27" fmla="*/ 191 h 307"/>
                <a:gd name="T28" fmla="*/ 72 w 122"/>
                <a:gd name="T29" fmla="*/ 191 h 307"/>
                <a:gd name="T30" fmla="*/ 84 w 122"/>
                <a:gd name="T31" fmla="*/ 218 h 307"/>
                <a:gd name="T32" fmla="*/ 92 w 122"/>
                <a:gd name="T33" fmla="*/ 235 h 307"/>
                <a:gd name="T34" fmla="*/ 101 w 122"/>
                <a:gd name="T35" fmla="*/ 257 h 307"/>
                <a:gd name="T36" fmla="*/ 101 w 122"/>
                <a:gd name="T37" fmla="*/ 267 h 307"/>
                <a:gd name="T38" fmla="*/ 98 w 122"/>
                <a:gd name="T39" fmla="*/ 267 h 307"/>
                <a:gd name="T40" fmla="*/ 95 w 122"/>
                <a:gd name="T41" fmla="*/ 272 h 307"/>
                <a:gd name="T42" fmla="*/ 101 w 122"/>
                <a:gd name="T43" fmla="*/ 279 h 307"/>
                <a:gd name="T44" fmla="*/ 103 w 122"/>
                <a:gd name="T45" fmla="*/ 290 h 307"/>
                <a:gd name="T46" fmla="*/ 103 w 122"/>
                <a:gd name="T47" fmla="*/ 295 h 307"/>
                <a:gd name="T48" fmla="*/ 108 w 122"/>
                <a:gd name="T49" fmla="*/ 295 h 307"/>
                <a:gd name="T50" fmla="*/ 114 w 122"/>
                <a:gd name="T51" fmla="*/ 299 h 307"/>
                <a:gd name="T52" fmla="*/ 120 w 122"/>
                <a:gd name="T53" fmla="*/ 304 h 307"/>
                <a:gd name="T54" fmla="*/ 122 w 122"/>
                <a:gd name="T55" fmla="*/ 307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122" h="307">
                  <a:moveTo>
                    <a:pt x="122" y="307"/>
                  </a:moveTo>
                  <a:cubicBezTo>
                    <a:pt x="0" y="307"/>
                    <a:pt x="0" y="307"/>
                    <a:pt x="0" y="307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7" y="10"/>
                    <a:pt x="7" y="10"/>
                    <a:pt x="7" y="10"/>
                  </a:cubicBezTo>
                  <a:cubicBezTo>
                    <a:pt x="7" y="10"/>
                    <a:pt x="12" y="12"/>
                    <a:pt x="16" y="22"/>
                  </a:cubicBezTo>
                  <a:cubicBezTo>
                    <a:pt x="19" y="31"/>
                    <a:pt x="27" y="45"/>
                    <a:pt x="28" y="48"/>
                  </a:cubicBezTo>
                  <a:cubicBezTo>
                    <a:pt x="29" y="52"/>
                    <a:pt x="35" y="60"/>
                    <a:pt x="35" y="60"/>
                  </a:cubicBezTo>
                  <a:cubicBezTo>
                    <a:pt x="39" y="71"/>
                    <a:pt x="39" y="71"/>
                    <a:pt x="39" y="71"/>
                  </a:cubicBezTo>
                  <a:cubicBezTo>
                    <a:pt x="39" y="71"/>
                    <a:pt x="43" y="73"/>
                    <a:pt x="43" y="79"/>
                  </a:cubicBezTo>
                  <a:cubicBezTo>
                    <a:pt x="43" y="84"/>
                    <a:pt x="43" y="103"/>
                    <a:pt x="43" y="103"/>
                  </a:cubicBezTo>
                  <a:cubicBezTo>
                    <a:pt x="43" y="103"/>
                    <a:pt x="44" y="111"/>
                    <a:pt x="47" y="118"/>
                  </a:cubicBezTo>
                  <a:cubicBezTo>
                    <a:pt x="50" y="125"/>
                    <a:pt x="51" y="131"/>
                    <a:pt x="51" y="139"/>
                  </a:cubicBezTo>
                  <a:cubicBezTo>
                    <a:pt x="51" y="147"/>
                    <a:pt x="58" y="174"/>
                    <a:pt x="61" y="178"/>
                  </a:cubicBezTo>
                  <a:cubicBezTo>
                    <a:pt x="64" y="182"/>
                    <a:pt x="72" y="191"/>
                    <a:pt x="72" y="191"/>
                  </a:cubicBezTo>
                  <a:cubicBezTo>
                    <a:pt x="72" y="191"/>
                    <a:pt x="72" y="191"/>
                    <a:pt x="72" y="191"/>
                  </a:cubicBezTo>
                  <a:cubicBezTo>
                    <a:pt x="74" y="194"/>
                    <a:pt x="83" y="211"/>
                    <a:pt x="84" y="218"/>
                  </a:cubicBezTo>
                  <a:cubicBezTo>
                    <a:pt x="86" y="225"/>
                    <a:pt x="90" y="230"/>
                    <a:pt x="92" y="235"/>
                  </a:cubicBezTo>
                  <a:cubicBezTo>
                    <a:pt x="95" y="239"/>
                    <a:pt x="100" y="251"/>
                    <a:pt x="101" y="257"/>
                  </a:cubicBezTo>
                  <a:cubicBezTo>
                    <a:pt x="101" y="262"/>
                    <a:pt x="101" y="267"/>
                    <a:pt x="101" y="267"/>
                  </a:cubicBezTo>
                  <a:cubicBezTo>
                    <a:pt x="101" y="267"/>
                    <a:pt x="100" y="267"/>
                    <a:pt x="98" y="267"/>
                  </a:cubicBezTo>
                  <a:cubicBezTo>
                    <a:pt x="96" y="268"/>
                    <a:pt x="93" y="267"/>
                    <a:pt x="95" y="272"/>
                  </a:cubicBezTo>
                  <a:cubicBezTo>
                    <a:pt x="96" y="276"/>
                    <a:pt x="101" y="279"/>
                    <a:pt x="101" y="279"/>
                  </a:cubicBezTo>
                  <a:cubicBezTo>
                    <a:pt x="103" y="290"/>
                    <a:pt x="103" y="290"/>
                    <a:pt x="103" y="290"/>
                  </a:cubicBezTo>
                  <a:cubicBezTo>
                    <a:pt x="103" y="295"/>
                    <a:pt x="103" y="295"/>
                    <a:pt x="103" y="295"/>
                  </a:cubicBezTo>
                  <a:cubicBezTo>
                    <a:pt x="103" y="295"/>
                    <a:pt x="106" y="295"/>
                    <a:pt x="108" y="295"/>
                  </a:cubicBezTo>
                  <a:cubicBezTo>
                    <a:pt x="111" y="296"/>
                    <a:pt x="114" y="299"/>
                    <a:pt x="114" y="299"/>
                  </a:cubicBezTo>
                  <a:cubicBezTo>
                    <a:pt x="120" y="304"/>
                    <a:pt x="120" y="304"/>
                    <a:pt x="120" y="304"/>
                  </a:cubicBezTo>
                  <a:lnTo>
                    <a:pt x="122" y="307"/>
                  </a:lnTo>
                  <a:close/>
                </a:path>
              </a:pathLst>
            </a:cu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" name="Freeform 265">
              <a:extLst>
                <a:ext uri="{FF2B5EF4-FFF2-40B4-BE49-F238E27FC236}">
                  <a16:creationId xmlns:a16="http://schemas.microsoft.com/office/drawing/2014/main" id="{22190DD3-35E3-EC60-FC9C-DC2E90C825D1}"/>
                </a:ext>
              </a:extLst>
            </p:cNvPr>
            <p:cNvSpPr>
              <a:spLocks/>
            </p:cNvSpPr>
            <p:nvPr/>
          </p:nvSpPr>
          <p:spPr bwMode="auto">
            <a:xfrm>
              <a:off x="9291639" y="2995613"/>
              <a:ext cx="107950" cy="393700"/>
            </a:xfrm>
            <a:custGeom>
              <a:avLst/>
              <a:gdLst>
                <a:gd name="T0" fmla="*/ 2 w 24"/>
                <a:gd name="T1" fmla="*/ 0 h 87"/>
                <a:gd name="T2" fmla="*/ 2 w 24"/>
                <a:gd name="T3" fmla="*/ 6 h 87"/>
                <a:gd name="T4" fmla="*/ 4 w 24"/>
                <a:gd name="T5" fmla="*/ 12 h 87"/>
                <a:gd name="T6" fmla="*/ 5 w 24"/>
                <a:gd name="T7" fmla="*/ 17 h 87"/>
                <a:gd name="T8" fmla="*/ 6 w 24"/>
                <a:gd name="T9" fmla="*/ 26 h 87"/>
                <a:gd name="T10" fmla="*/ 8 w 24"/>
                <a:gd name="T11" fmla="*/ 30 h 87"/>
                <a:gd name="T12" fmla="*/ 8 w 24"/>
                <a:gd name="T13" fmla="*/ 32 h 87"/>
                <a:gd name="T14" fmla="*/ 8 w 24"/>
                <a:gd name="T15" fmla="*/ 49 h 87"/>
                <a:gd name="T16" fmla="*/ 10 w 24"/>
                <a:gd name="T17" fmla="*/ 61 h 87"/>
                <a:gd name="T18" fmla="*/ 10 w 24"/>
                <a:gd name="T19" fmla="*/ 68 h 87"/>
                <a:gd name="T20" fmla="*/ 10 w 24"/>
                <a:gd name="T21" fmla="*/ 69 h 87"/>
                <a:gd name="T22" fmla="*/ 12 w 24"/>
                <a:gd name="T23" fmla="*/ 73 h 87"/>
                <a:gd name="T24" fmla="*/ 13 w 24"/>
                <a:gd name="T25" fmla="*/ 85 h 87"/>
                <a:gd name="T26" fmla="*/ 15 w 24"/>
                <a:gd name="T27" fmla="*/ 87 h 87"/>
                <a:gd name="T28" fmla="*/ 24 w 24"/>
                <a:gd name="T29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24" h="87">
                  <a:moveTo>
                    <a:pt x="2" y="0"/>
                  </a:moveTo>
                  <a:cubicBezTo>
                    <a:pt x="2" y="0"/>
                    <a:pt x="0" y="4"/>
                    <a:pt x="2" y="6"/>
                  </a:cubicBezTo>
                  <a:cubicBezTo>
                    <a:pt x="3" y="7"/>
                    <a:pt x="4" y="12"/>
                    <a:pt x="4" y="12"/>
                  </a:cubicBezTo>
                  <a:cubicBezTo>
                    <a:pt x="4" y="12"/>
                    <a:pt x="4" y="14"/>
                    <a:pt x="5" y="17"/>
                  </a:cubicBezTo>
                  <a:cubicBezTo>
                    <a:pt x="5" y="20"/>
                    <a:pt x="5" y="25"/>
                    <a:pt x="6" y="26"/>
                  </a:cubicBezTo>
                  <a:cubicBezTo>
                    <a:pt x="7" y="27"/>
                    <a:pt x="8" y="30"/>
                    <a:pt x="8" y="30"/>
                  </a:cubicBezTo>
                  <a:cubicBezTo>
                    <a:pt x="8" y="32"/>
                    <a:pt x="8" y="32"/>
                    <a:pt x="8" y="32"/>
                  </a:cubicBezTo>
                  <a:cubicBezTo>
                    <a:pt x="8" y="49"/>
                    <a:pt x="8" y="49"/>
                    <a:pt x="8" y="49"/>
                  </a:cubicBezTo>
                  <a:cubicBezTo>
                    <a:pt x="10" y="61"/>
                    <a:pt x="10" y="61"/>
                    <a:pt x="10" y="61"/>
                  </a:cubicBezTo>
                  <a:cubicBezTo>
                    <a:pt x="10" y="68"/>
                    <a:pt x="10" y="68"/>
                    <a:pt x="10" y="68"/>
                  </a:cubicBezTo>
                  <a:cubicBezTo>
                    <a:pt x="10" y="69"/>
                    <a:pt x="10" y="69"/>
                    <a:pt x="10" y="69"/>
                  </a:cubicBezTo>
                  <a:cubicBezTo>
                    <a:pt x="10" y="69"/>
                    <a:pt x="11" y="70"/>
                    <a:pt x="12" y="73"/>
                  </a:cubicBezTo>
                  <a:cubicBezTo>
                    <a:pt x="13" y="76"/>
                    <a:pt x="14" y="84"/>
                    <a:pt x="13" y="85"/>
                  </a:cubicBezTo>
                  <a:cubicBezTo>
                    <a:pt x="13" y="85"/>
                    <a:pt x="14" y="86"/>
                    <a:pt x="15" y="87"/>
                  </a:cubicBezTo>
                  <a:cubicBezTo>
                    <a:pt x="17" y="87"/>
                    <a:pt x="24" y="87"/>
                    <a:pt x="24" y="87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" name="Freeform 266">
              <a:extLst>
                <a:ext uri="{FF2B5EF4-FFF2-40B4-BE49-F238E27FC236}">
                  <a16:creationId xmlns:a16="http://schemas.microsoft.com/office/drawing/2014/main" id="{471D74E1-7810-6E09-DF19-F71B3F6C421E}"/>
                </a:ext>
              </a:extLst>
            </p:cNvPr>
            <p:cNvSpPr>
              <a:spLocks/>
            </p:cNvSpPr>
            <p:nvPr/>
          </p:nvSpPr>
          <p:spPr bwMode="auto">
            <a:xfrm>
              <a:off x="9255127" y="3294063"/>
              <a:ext cx="95250" cy="117475"/>
            </a:xfrm>
            <a:custGeom>
              <a:avLst/>
              <a:gdLst>
                <a:gd name="T0" fmla="*/ 18 w 21"/>
                <a:gd name="T1" fmla="*/ 2 h 26"/>
                <a:gd name="T2" fmla="*/ 14 w 21"/>
                <a:gd name="T3" fmla="*/ 0 h 26"/>
                <a:gd name="T4" fmla="*/ 9 w 21"/>
                <a:gd name="T5" fmla="*/ 0 h 26"/>
                <a:gd name="T6" fmla="*/ 7 w 21"/>
                <a:gd name="T7" fmla="*/ 2 h 26"/>
                <a:gd name="T8" fmla="*/ 6 w 21"/>
                <a:gd name="T9" fmla="*/ 4 h 26"/>
                <a:gd name="T10" fmla="*/ 6 w 21"/>
                <a:gd name="T11" fmla="*/ 6 h 26"/>
                <a:gd name="T12" fmla="*/ 2 w 21"/>
                <a:gd name="T13" fmla="*/ 9 h 26"/>
                <a:gd name="T14" fmla="*/ 1 w 21"/>
                <a:gd name="T15" fmla="*/ 11 h 26"/>
                <a:gd name="T16" fmla="*/ 1 w 21"/>
                <a:gd name="T17" fmla="*/ 14 h 26"/>
                <a:gd name="T18" fmla="*/ 0 w 21"/>
                <a:gd name="T19" fmla="*/ 19 h 26"/>
                <a:gd name="T20" fmla="*/ 3 w 21"/>
                <a:gd name="T21" fmla="*/ 22 h 26"/>
                <a:gd name="T22" fmla="*/ 6 w 21"/>
                <a:gd name="T23" fmla="*/ 24 h 26"/>
                <a:gd name="T24" fmla="*/ 9 w 21"/>
                <a:gd name="T25" fmla="*/ 26 h 26"/>
                <a:gd name="T26" fmla="*/ 11 w 21"/>
                <a:gd name="T27" fmla="*/ 26 h 26"/>
                <a:gd name="T28" fmla="*/ 13 w 21"/>
                <a:gd name="T29" fmla="*/ 26 h 26"/>
                <a:gd name="T30" fmla="*/ 16 w 21"/>
                <a:gd name="T31" fmla="*/ 24 h 26"/>
                <a:gd name="T32" fmla="*/ 17 w 21"/>
                <a:gd name="T33" fmla="*/ 23 h 26"/>
                <a:gd name="T34" fmla="*/ 18 w 21"/>
                <a:gd name="T35" fmla="*/ 21 h 26"/>
                <a:gd name="T36" fmla="*/ 21 w 21"/>
                <a:gd name="T37" fmla="*/ 19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1" h="26">
                  <a:moveTo>
                    <a:pt x="18" y="2"/>
                  </a:moveTo>
                  <a:cubicBezTo>
                    <a:pt x="14" y="0"/>
                    <a:pt x="14" y="0"/>
                    <a:pt x="14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7" y="2"/>
                    <a:pt x="7" y="2"/>
                    <a:pt x="7" y="2"/>
                  </a:cubicBezTo>
                  <a:cubicBezTo>
                    <a:pt x="7" y="2"/>
                    <a:pt x="6" y="3"/>
                    <a:pt x="6" y="4"/>
                  </a:cubicBezTo>
                  <a:cubicBezTo>
                    <a:pt x="5" y="5"/>
                    <a:pt x="7" y="5"/>
                    <a:pt x="6" y="6"/>
                  </a:cubicBezTo>
                  <a:cubicBezTo>
                    <a:pt x="4" y="7"/>
                    <a:pt x="2" y="9"/>
                    <a:pt x="2" y="9"/>
                  </a:cubicBezTo>
                  <a:cubicBezTo>
                    <a:pt x="1" y="11"/>
                    <a:pt x="1" y="11"/>
                    <a:pt x="1" y="11"/>
                  </a:cubicBezTo>
                  <a:cubicBezTo>
                    <a:pt x="1" y="11"/>
                    <a:pt x="2" y="13"/>
                    <a:pt x="1" y="14"/>
                  </a:cubicBezTo>
                  <a:cubicBezTo>
                    <a:pt x="0" y="15"/>
                    <a:pt x="0" y="19"/>
                    <a:pt x="0" y="19"/>
                  </a:cubicBezTo>
                  <a:cubicBezTo>
                    <a:pt x="0" y="19"/>
                    <a:pt x="2" y="22"/>
                    <a:pt x="3" y="22"/>
                  </a:cubicBezTo>
                  <a:cubicBezTo>
                    <a:pt x="4" y="23"/>
                    <a:pt x="6" y="24"/>
                    <a:pt x="6" y="24"/>
                  </a:cubicBezTo>
                  <a:cubicBezTo>
                    <a:pt x="9" y="26"/>
                    <a:pt x="9" y="26"/>
                    <a:pt x="9" y="26"/>
                  </a:cubicBezTo>
                  <a:cubicBezTo>
                    <a:pt x="11" y="26"/>
                    <a:pt x="11" y="26"/>
                    <a:pt x="11" y="26"/>
                  </a:cubicBezTo>
                  <a:cubicBezTo>
                    <a:pt x="13" y="26"/>
                    <a:pt x="13" y="26"/>
                    <a:pt x="13" y="26"/>
                  </a:cubicBezTo>
                  <a:cubicBezTo>
                    <a:pt x="16" y="24"/>
                    <a:pt x="16" y="24"/>
                    <a:pt x="16" y="24"/>
                  </a:cubicBezTo>
                  <a:cubicBezTo>
                    <a:pt x="17" y="23"/>
                    <a:pt x="17" y="23"/>
                    <a:pt x="17" y="23"/>
                  </a:cubicBezTo>
                  <a:cubicBezTo>
                    <a:pt x="18" y="21"/>
                    <a:pt x="18" y="21"/>
                    <a:pt x="18" y="21"/>
                  </a:cubicBezTo>
                  <a:cubicBezTo>
                    <a:pt x="21" y="19"/>
                    <a:pt x="21" y="19"/>
                    <a:pt x="21" y="19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" name="Freeform 268">
              <a:extLst>
                <a:ext uri="{FF2B5EF4-FFF2-40B4-BE49-F238E27FC236}">
                  <a16:creationId xmlns:a16="http://schemas.microsoft.com/office/drawing/2014/main" id="{0D8C940A-2D25-8432-5F15-9165BFDFF2CB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7377" y="3519488"/>
              <a:ext cx="227013" cy="528638"/>
            </a:xfrm>
            <a:custGeom>
              <a:avLst/>
              <a:gdLst>
                <a:gd name="T0" fmla="*/ 0 w 50"/>
                <a:gd name="T1" fmla="*/ 0 h 117"/>
                <a:gd name="T2" fmla="*/ 12 w 50"/>
                <a:gd name="T3" fmla="*/ 27 h 117"/>
                <a:gd name="T4" fmla="*/ 20 w 50"/>
                <a:gd name="T5" fmla="*/ 44 h 117"/>
                <a:gd name="T6" fmla="*/ 29 w 50"/>
                <a:gd name="T7" fmla="*/ 66 h 117"/>
                <a:gd name="T8" fmla="*/ 29 w 50"/>
                <a:gd name="T9" fmla="*/ 76 h 117"/>
                <a:gd name="T10" fmla="*/ 26 w 50"/>
                <a:gd name="T11" fmla="*/ 76 h 117"/>
                <a:gd name="T12" fmla="*/ 23 w 50"/>
                <a:gd name="T13" fmla="*/ 81 h 117"/>
                <a:gd name="T14" fmla="*/ 29 w 50"/>
                <a:gd name="T15" fmla="*/ 88 h 117"/>
                <a:gd name="T16" fmla="*/ 31 w 50"/>
                <a:gd name="T17" fmla="*/ 99 h 117"/>
                <a:gd name="T18" fmla="*/ 31 w 50"/>
                <a:gd name="T19" fmla="*/ 104 h 117"/>
                <a:gd name="T20" fmla="*/ 36 w 50"/>
                <a:gd name="T21" fmla="*/ 104 h 117"/>
                <a:gd name="T22" fmla="*/ 42 w 50"/>
                <a:gd name="T23" fmla="*/ 108 h 117"/>
                <a:gd name="T24" fmla="*/ 48 w 50"/>
                <a:gd name="T25" fmla="*/ 113 h 117"/>
                <a:gd name="T26" fmla="*/ 50 w 50"/>
                <a:gd name="T27" fmla="*/ 116 h 117"/>
                <a:gd name="T28" fmla="*/ 50 w 50"/>
                <a:gd name="T29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50" h="117">
                  <a:moveTo>
                    <a:pt x="0" y="0"/>
                  </a:moveTo>
                  <a:cubicBezTo>
                    <a:pt x="2" y="3"/>
                    <a:pt x="11" y="20"/>
                    <a:pt x="12" y="27"/>
                  </a:cubicBezTo>
                  <a:cubicBezTo>
                    <a:pt x="14" y="34"/>
                    <a:pt x="18" y="39"/>
                    <a:pt x="20" y="44"/>
                  </a:cubicBezTo>
                  <a:cubicBezTo>
                    <a:pt x="23" y="48"/>
                    <a:pt x="28" y="60"/>
                    <a:pt x="29" y="66"/>
                  </a:cubicBezTo>
                  <a:cubicBezTo>
                    <a:pt x="29" y="71"/>
                    <a:pt x="29" y="76"/>
                    <a:pt x="29" y="76"/>
                  </a:cubicBezTo>
                  <a:cubicBezTo>
                    <a:pt x="29" y="76"/>
                    <a:pt x="28" y="76"/>
                    <a:pt x="26" y="76"/>
                  </a:cubicBezTo>
                  <a:cubicBezTo>
                    <a:pt x="24" y="77"/>
                    <a:pt x="21" y="76"/>
                    <a:pt x="23" y="81"/>
                  </a:cubicBezTo>
                  <a:cubicBezTo>
                    <a:pt x="24" y="85"/>
                    <a:pt x="29" y="88"/>
                    <a:pt x="29" y="88"/>
                  </a:cubicBezTo>
                  <a:cubicBezTo>
                    <a:pt x="31" y="99"/>
                    <a:pt x="31" y="99"/>
                    <a:pt x="31" y="99"/>
                  </a:cubicBezTo>
                  <a:cubicBezTo>
                    <a:pt x="31" y="104"/>
                    <a:pt x="31" y="104"/>
                    <a:pt x="31" y="104"/>
                  </a:cubicBezTo>
                  <a:cubicBezTo>
                    <a:pt x="31" y="104"/>
                    <a:pt x="34" y="104"/>
                    <a:pt x="36" y="104"/>
                  </a:cubicBezTo>
                  <a:cubicBezTo>
                    <a:pt x="39" y="105"/>
                    <a:pt x="42" y="108"/>
                    <a:pt x="42" y="108"/>
                  </a:cubicBezTo>
                  <a:cubicBezTo>
                    <a:pt x="48" y="113"/>
                    <a:pt x="48" y="113"/>
                    <a:pt x="48" y="113"/>
                  </a:cubicBezTo>
                  <a:cubicBezTo>
                    <a:pt x="50" y="116"/>
                    <a:pt x="50" y="116"/>
                    <a:pt x="50" y="116"/>
                  </a:cubicBezTo>
                  <a:cubicBezTo>
                    <a:pt x="50" y="117"/>
                    <a:pt x="50" y="117"/>
                    <a:pt x="50" y="117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" name="Freeform 269">
              <a:extLst>
                <a:ext uri="{FF2B5EF4-FFF2-40B4-BE49-F238E27FC236}">
                  <a16:creationId xmlns:a16="http://schemas.microsoft.com/office/drawing/2014/main" id="{BA210258-6CD5-6EED-8C14-DB9294178E0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83527" y="2657476"/>
              <a:ext cx="323850" cy="862013"/>
            </a:xfrm>
            <a:custGeom>
              <a:avLst/>
              <a:gdLst>
                <a:gd name="T0" fmla="*/ 0 w 72"/>
                <a:gd name="T1" fmla="*/ 0 h 191"/>
                <a:gd name="T2" fmla="*/ 7 w 72"/>
                <a:gd name="T3" fmla="*/ 10 h 191"/>
                <a:gd name="T4" fmla="*/ 16 w 72"/>
                <a:gd name="T5" fmla="*/ 22 h 191"/>
                <a:gd name="T6" fmla="*/ 28 w 72"/>
                <a:gd name="T7" fmla="*/ 48 h 191"/>
                <a:gd name="T8" fmla="*/ 35 w 72"/>
                <a:gd name="T9" fmla="*/ 60 h 191"/>
                <a:gd name="T10" fmla="*/ 39 w 72"/>
                <a:gd name="T11" fmla="*/ 71 h 191"/>
                <a:gd name="T12" fmla="*/ 43 w 72"/>
                <a:gd name="T13" fmla="*/ 79 h 191"/>
                <a:gd name="T14" fmla="*/ 43 w 72"/>
                <a:gd name="T15" fmla="*/ 103 h 191"/>
                <a:gd name="T16" fmla="*/ 47 w 72"/>
                <a:gd name="T17" fmla="*/ 118 h 191"/>
                <a:gd name="T18" fmla="*/ 51 w 72"/>
                <a:gd name="T19" fmla="*/ 139 h 191"/>
                <a:gd name="T20" fmla="*/ 61 w 72"/>
                <a:gd name="T21" fmla="*/ 178 h 191"/>
                <a:gd name="T22" fmla="*/ 72 w 72"/>
                <a:gd name="T23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72" h="191">
                  <a:moveTo>
                    <a:pt x="0" y="0"/>
                  </a:moveTo>
                  <a:cubicBezTo>
                    <a:pt x="7" y="10"/>
                    <a:pt x="7" y="10"/>
                    <a:pt x="7" y="10"/>
                  </a:cubicBezTo>
                  <a:cubicBezTo>
                    <a:pt x="7" y="10"/>
                    <a:pt x="12" y="12"/>
                    <a:pt x="16" y="22"/>
                  </a:cubicBezTo>
                  <a:cubicBezTo>
                    <a:pt x="19" y="31"/>
                    <a:pt x="27" y="45"/>
                    <a:pt x="28" y="48"/>
                  </a:cubicBezTo>
                  <a:cubicBezTo>
                    <a:pt x="29" y="52"/>
                    <a:pt x="35" y="60"/>
                    <a:pt x="35" y="60"/>
                  </a:cubicBezTo>
                  <a:cubicBezTo>
                    <a:pt x="39" y="71"/>
                    <a:pt x="39" y="71"/>
                    <a:pt x="39" y="71"/>
                  </a:cubicBezTo>
                  <a:cubicBezTo>
                    <a:pt x="39" y="71"/>
                    <a:pt x="43" y="73"/>
                    <a:pt x="43" y="79"/>
                  </a:cubicBezTo>
                  <a:cubicBezTo>
                    <a:pt x="43" y="84"/>
                    <a:pt x="43" y="103"/>
                    <a:pt x="43" y="103"/>
                  </a:cubicBezTo>
                  <a:cubicBezTo>
                    <a:pt x="43" y="103"/>
                    <a:pt x="44" y="111"/>
                    <a:pt x="47" y="118"/>
                  </a:cubicBezTo>
                  <a:cubicBezTo>
                    <a:pt x="50" y="125"/>
                    <a:pt x="51" y="131"/>
                    <a:pt x="51" y="139"/>
                  </a:cubicBezTo>
                  <a:cubicBezTo>
                    <a:pt x="51" y="147"/>
                    <a:pt x="58" y="174"/>
                    <a:pt x="61" y="178"/>
                  </a:cubicBezTo>
                  <a:cubicBezTo>
                    <a:pt x="64" y="182"/>
                    <a:pt x="72" y="191"/>
                    <a:pt x="72" y="191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" name="Freeform 270">
              <a:extLst>
                <a:ext uri="{FF2B5EF4-FFF2-40B4-BE49-F238E27FC236}">
                  <a16:creationId xmlns:a16="http://schemas.microsoft.com/office/drawing/2014/main" id="{029B7EC6-9978-7BD0-B566-CEE1700241C3}"/>
                </a:ext>
              </a:extLst>
            </p:cNvPr>
            <p:cNvSpPr>
              <a:spLocks/>
            </p:cNvSpPr>
            <p:nvPr/>
          </p:nvSpPr>
          <p:spPr bwMode="auto">
            <a:xfrm>
              <a:off x="8464552" y="2530476"/>
              <a:ext cx="1449388" cy="1512888"/>
            </a:xfrm>
            <a:custGeom>
              <a:avLst/>
              <a:gdLst>
                <a:gd name="T0" fmla="*/ 0 w 321"/>
                <a:gd name="T1" fmla="*/ 335 h 335"/>
                <a:gd name="T2" fmla="*/ 3 w 321"/>
                <a:gd name="T3" fmla="*/ 330 h 335"/>
                <a:gd name="T4" fmla="*/ 14 w 321"/>
                <a:gd name="T5" fmla="*/ 327 h 335"/>
                <a:gd name="T6" fmla="*/ 26 w 321"/>
                <a:gd name="T7" fmla="*/ 327 h 335"/>
                <a:gd name="T8" fmla="*/ 29 w 321"/>
                <a:gd name="T9" fmla="*/ 324 h 335"/>
                <a:gd name="T10" fmla="*/ 38 w 321"/>
                <a:gd name="T11" fmla="*/ 320 h 335"/>
                <a:gd name="T12" fmla="*/ 56 w 321"/>
                <a:gd name="T13" fmla="*/ 320 h 335"/>
                <a:gd name="T14" fmla="*/ 71 w 321"/>
                <a:gd name="T15" fmla="*/ 322 h 335"/>
                <a:gd name="T16" fmla="*/ 82 w 321"/>
                <a:gd name="T17" fmla="*/ 320 h 335"/>
                <a:gd name="T18" fmla="*/ 96 w 321"/>
                <a:gd name="T19" fmla="*/ 315 h 335"/>
                <a:gd name="T20" fmla="*/ 116 w 321"/>
                <a:gd name="T21" fmla="*/ 305 h 335"/>
                <a:gd name="T22" fmla="*/ 146 w 321"/>
                <a:gd name="T23" fmla="*/ 280 h 335"/>
                <a:gd name="T24" fmla="*/ 172 w 321"/>
                <a:gd name="T25" fmla="*/ 247 h 335"/>
                <a:gd name="T26" fmla="*/ 183 w 321"/>
                <a:gd name="T27" fmla="*/ 229 h 335"/>
                <a:gd name="T28" fmla="*/ 193 w 321"/>
                <a:gd name="T29" fmla="*/ 223 h 335"/>
                <a:gd name="T30" fmla="*/ 200 w 321"/>
                <a:gd name="T31" fmla="*/ 207 h 335"/>
                <a:gd name="T32" fmla="*/ 206 w 321"/>
                <a:gd name="T33" fmla="*/ 191 h 335"/>
                <a:gd name="T34" fmla="*/ 207 w 321"/>
                <a:gd name="T35" fmla="*/ 190 h 335"/>
                <a:gd name="T36" fmla="*/ 206 w 321"/>
                <a:gd name="T37" fmla="*/ 177 h 335"/>
                <a:gd name="T38" fmla="*/ 208 w 321"/>
                <a:gd name="T39" fmla="*/ 165 h 335"/>
                <a:gd name="T40" fmla="*/ 228 w 321"/>
                <a:gd name="T41" fmla="*/ 152 h 335"/>
                <a:gd name="T42" fmla="*/ 250 w 321"/>
                <a:gd name="T43" fmla="*/ 135 h 335"/>
                <a:gd name="T44" fmla="*/ 250 w 321"/>
                <a:gd name="T45" fmla="*/ 120 h 335"/>
                <a:gd name="T46" fmla="*/ 250 w 321"/>
                <a:gd name="T47" fmla="*/ 102 h 335"/>
                <a:gd name="T48" fmla="*/ 245 w 321"/>
                <a:gd name="T49" fmla="*/ 80 h 335"/>
                <a:gd name="T50" fmla="*/ 241 w 321"/>
                <a:gd name="T51" fmla="*/ 70 h 335"/>
                <a:gd name="T52" fmla="*/ 248 w 321"/>
                <a:gd name="T53" fmla="*/ 54 h 335"/>
                <a:gd name="T54" fmla="*/ 268 w 321"/>
                <a:gd name="T55" fmla="*/ 37 h 335"/>
                <a:gd name="T56" fmla="*/ 290 w 321"/>
                <a:gd name="T57" fmla="*/ 15 h 335"/>
                <a:gd name="T58" fmla="*/ 303 w 321"/>
                <a:gd name="T59" fmla="*/ 7 h 335"/>
                <a:gd name="T60" fmla="*/ 321 w 321"/>
                <a:gd name="T61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321" h="335">
                  <a:moveTo>
                    <a:pt x="0" y="335"/>
                  </a:moveTo>
                  <a:cubicBezTo>
                    <a:pt x="0" y="335"/>
                    <a:pt x="1" y="331"/>
                    <a:pt x="3" y="330"/>
                  </a:cubicBezTo>
                  <a:cubicBezTo>
                    <a:pt x="6" y="328"/>
                    <a:pt x="10" y="327"/>
                    <a:pt x="14" y="327"/>
                  </a:cubicBezTo>
                  <a:cubicBezTo>
                    <a:pt x="18" y="327"/>
                    <a:pt x="26" y="327"/>
                    <a:pt x="26" y="327"/>
                  </a:cubicBezTo>
                  <a:cubicBezTo>
                    <a:pt x="26" y="327"/>
                    <a:pt x="29" y="325"/>
                    <a:pt x="29" y="324"/>
                  </a:cubicBezTo>
                  <a:cubicBezTo>
                    <a:pt x="29" y="322"/>
                    <a:pt x="33" y="321"/>
                    <a:pt x="38" y="320"/>
                  </a:cubicBezTo>
                  <a:cubicBezTo>
                    <a:pt x="42" y="319"/>
                    <a:pt x="53" y="321"/>
                    <a:pt x="56" y="320"/>
                  </a:cubicBezTo>
                  <a:cubicBezTo>
                    <a:pt x="59" y="319"/>
                    <a:pt x="69" y="322"/>
                    <a:pt x="71" y="322"/>
                  </a:cubicBezTo>
                  <a:cubicBezTo>
                    <a:pt x="72" y="323"/>
                    <a:pt x="80" y="322"/>
                    <a:pt x="82" y="320"/>
                  </a:cubicBezTo>
                  <a:cubicBezTo>
                    <a:pt x="85" y="318"/>
                    <a:pt x="93" y="315"/>
                    <a:pt x="96" y="315"/>
                  </a:cubicBezTo>
                  <a:cubicBezTo>
                    <a:pt x="99" y="315"/>
                    <a:pt x="105" y="316"/>
                    <a:pt x="116" y="305"/>
                  </a:cubicBezTo>
                  <a:cubicBezTo>
                    <a:pt x="128" y="295"/>
                    <a:pt x="146" y="280"/>
                    <a:pt x="146" y="280"/>
                  </a:cubicBezTo>
                  <a:cubicBezTo>
                    <a:pt x="172" y="247"/>
                    <a:pt x="172" y="247"/>
                    <a:pt x="172" y="247"/>
                  </a:cubicBezTo>
                  <a:cubicBezTo>
                    <a:pt x="183" y="229"/>
                    <a:pt x="183" y="229"/>
                    <a:pt x="183" y="229"/>
                  </a:cubicBezTo>
                  <a:cubicBezTo>
                    <a:pt x="183" y="229"/>
                    <a:pt x="192" y="223"/>
                    <a:pt x="193" y="223"/>
                  </a:cubicBezTo>
                  <a:cubicBezTo>
                    <a:pt x="195" y="223"/>
                    <a:pt x="198" y="219"/>
                    <a:pt x="200" y="207"/>
                  </a:cubicBezTo>
                  <a:cubicBezTo>
                    <a:pt x="202" y="195"/>
                    <a:pt x="203" y="194"/>
                    <a:pt x="206" y="191"/>
                  </a:cubicBezTo>
                  <a:cubicBezTo>
                    <a:pt x="207" y="191"/>
                    <a:pt x="207" y="190"/>
                    <a:pt x="207" y="190"/>
                  </a:cubicBezTo>
                  <a:cubicBezTo>
                    <a:pt x="208" y="186"/>
                    <a:pt x="206" y="179"/>
                    <a:pt x="206" y="177"/>
                  </a:cubicBezTo>
                  <a:cubicBezTo>
                    <a:pt x="206" y="176"/>
                    <a:pt x="197" y="175"/>
                    <a:pt x="208" y="165"/>
                  </a:cubicBezTo>
                  <a:cubicBezTo>
                    <a:pt x="218" y="155"/>
                    <a:pt x="224" y="152"/>
                    <a:pt x="228" y="152"/>
                  </a:cubicBezTo>
                  <a:cubicBezTo>
                    <a:pt x="232" y="151"/>
                    <a:pt x="249" y="145"/>
                    <a:pt x="250" y="135"/>
                  </a:cubicBezTo>
                  <a:cubicBezTo>
                    <a:pt x="250" y="125"/>
                    <a:pt x="246" y="124"/>
                    <a:pt x="250" y="120"/>
                  </a:cubicBezTo>
                  <a:cubicBezTo>
                    <a:pt x="253" y="115"/>
                    <a:pt x="251" y="109"/>
                    <a:pt x="250" y="102"/>
                  </a:cubicBezTo>
                  <a:cubicBezTo>
                    <a:pt x="248" y="95"/>
                    <a:pt x="245" y="80"/>
                    <a:pt x="245" y="80"/>
                  </a:cubicBezTo>
                  <a:cubicBezTo>
                    <a:pt x="245" y="80"/>
                    <a:pt x="246" y="75"/>
                    <a:pt x="241" y="70"/>
                  </a:cubicBezTo>
                  <a:cubicBezTo>
                    <a:pt x="235" y="65"/>
                    <a:pt x="245" y="59"/>
                    <a:pt x="248" y="54"/>
                  </a:cubicBezTo>
                  <a:cubicBezTo>
                    <a:pt x="252" y="50"/>
                    <a:pt x="268" y="37"/>
                    <a:pt x="268" y="37"/>
                  </a:cubicBezTo>
                  <a:cubicBezTo>
                    <a:pt x="290" y="15"/>
                    <a:pt x="290" y="15"/>
                    <a:pt x="290" y="15"/>
                  </a:cubicBezTo>
                  <a:cubicBezTo>
                    <a:pt x="290" y="15"/>
                    <a:pt x="298" y="8"/>
                    <a:pt x="303" y="7"/>
                  </a:cubicBezTo>
                  <a:cubicBezTo>
                    <a:pt x="308" y="5"/>
                    <a:pt x="321" y="0"/>
                    <a:pt x="321" y="0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9" name="Freeform 271">
              <a:extLst>
                <a:ext uri="{FF2B5EF4-FFF2-40B4-BE49-F238E27FC236}">
                  <a16:creationId xmlns:a16="http://schemas.microsoft.com/office/drawing/2014/main" id="{546C6AB2-0962-30B2-5B57-ADD04487E786}"/>
                </a:ext>
              </a:extLst>
            </p:cNvPr>
            <p:cNvSpPr>
              <a:spLocks/>
            </p:cNvSpPr>
            <p:nvPr/>
          </p:nvSpPr>
          <p:spPr bwMode="auto">
            <a:xfrm>
              <a:off x="7883527" y="2439988"/>
              <a:ext cx="842963" cy="195263"/>
            </a:xfrm>
            <a:custGeom>
              <a:avLst/>
              <a:gdLst>
                <a:gd name="T0" fmla="*/ 0 w 187"/>
                <a:gd name="T1" fmla="*/ 28 h 43"/>
                <a:gd name="T2" fmla="*/ 12 w 187"/>
                <a:gd name="T3" fmla="*/ 28 h 43"/>
                <a:gd name="T4" fmla="*/ 20 w 187"/>
                <a:gd name="T5" fmla="*/ 25 h 43"/>
                <a:gd name="T6" fmla="*/ 28 w 187"/>
                <a:gd name="T7" fmla="*/ 25 h 43"/>
                <a:gd name="T8" fmla="*/ 42 w 187"/>
                <a:gd name="T9" fmla="*/ 34 h 43"/>
                <a:gd name="T10" fmla="*/ 82 w 187"/>
                <a:gd name="T11" fmla="*/ 32 h 43"/>
                <a:gd name="T12" fmla="*/ 97 w 187"/>
                <a:gd name="T13" fmla="*/ 32 h 43"/>
                <a:gd name="T14" fmla="*/ 110 w 187"/>
                <a:gd name="T15" fmla="*/ 34 h 43"/>
                <a:gd name="T16" fmla="*/ 122 w 187"/>
                <a:gd name="T17" fmla="*/ 41 h 43"/>
                <a:gd name="T18" fmla="*/ 169 w 187"/>
                <a:gd name="T19" fmla="*/ 41 h 43"/>
                <a:gd name="T20" fmla="*/ 187 w 187"/>
                <a:gd name="T21" fmla="*/ 37 h 43"/>
                <a:gd name="T22" fmla="*/ 176 w 187"/>
                <a:gd name="T23" fmla="*/ 24 h 43"/>
                <a:gd name="T24" fmla="*/ 167 w 187"/>
                <a:gd name="T25" fmla="*/ 13 h 43"/>
                <a:gd name="T26" fmla="*/ 167 w 187"/>
                <a:gd name="T2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87" h="43">
                  <a:moveTo>
                    <a:pt x="0" y="28"/>
                  </a:moveTo>
                  <a:cubicBezTo>
                    <a:pt x="12" y="28"/>
                    <a:pt x="12" y="28"/>
                    <a:pt x="12" y="28"/>
                  </a:cubicBezTo>
                  <a:cubicBezTo>
                    <a:pt x="12" y="28"/>
                    <a:pt x="19" y="27"/>
                    <a:pt x="20" y="25"/>
                  </a:cubicBezTo>
                  <a:cubicBezTo>
                    <a:pt x="21" y="22"/>
                    <a:pt x="25" y="24"/>
                    <a:pt x="28" y="25"/>
                  </a:cubicBezTo>
                  <a:cubicBezTo>
                    <a:pt x="31" y="26"/>
                    <a:pt x="38" y="35"/>
                    <a:pt x="42" y="34"/>
                  </a:cubicBezTo>
                  <a:cubicBezTo>
                    <a:pt x="45" y="32"/>
                    <a:pt x="82" y="32"/>
                    <a:pt x="82" y="32"/>
                  </a:cubicBezTo>
                  <a:cubicBezTo>
                    <a:pt x="97" y="32"/>
                    <a:pt x="97" y="32"/>
                    <a:pt x="97" y="32"/>
                  </a:cubicBezTo>
                  <a:cubicBezTo>
                    <a:pt x="97" y="32"/>
                    <a:pt x="106" y="32"/>
                    <a:pt x="110" y="34"/>
                  </a:cubicBezTo>
                  <a:cubicBezTo>
                    <a:pt x="113" y="36"/>
                    <a:pt x="109" y="39"/>
                    <a:pt x="122" y="41"/>
                  </a:cubicBezTo>
                  <a:cubicBezTo>
                    <a:pt x="136" y="43"/>
                    <a:pt x="169" y="41"/>
                    <a:pt x="169" y="41"/>
                  </a:cubicBezTo>
                  <a:cubicBezTo>
                    <a:pt x="187" y="37"/>
                    <a:pt x="187" y="37"/>
                    <a:pt x="187" y="37"/>
                  </a:cubicBezTo>
                  <a:cubicBezTo>
                    <a:pt x="176" y="24"/>
                    <a:pt x="176" y="24"/>
                    <a:pt x="176" y="24"/>
                  </a:cubicBezTo>
                  <a:cubicBezTo>
                    <a:pt x="167" y="13"/>
                    <a:pt x="167" y="13"/>
                    <a:pt x="167" y="13"/>
                  </a:cubicBezTo>
                  <a:cubicBezTo>
                    <a:pt x="167" y="0"/>
                    <a:pt x="167" y="0"/>
                    <a:pt x="167" y="0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0" name="Freeform 272">
              <a:extLst>
                <a:ext uri="{FF2B5EF4-FFF2-40B4-BE49-F238E27FC236}">
                  <a16:creationId xmlns:a16="http://schemas.microsoft.com/office/drawing/2014/main" id="{9E50B8D1-1985-306F-3FE2-BDCD98AA7A12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7377" y="2593976"/>
              <a:ext cx="655638" cy="957263"/>
            </a:xfrm>
            <a:custGeom>
              <a:avLst/>
              <a:gdLst>
                <a:gd name="T0" fmla="*/ 115 w 145"/>
                <a:gd name="T1" fmla="*/ 3 h 212"/>
                <a:gd name="T2" fmla="*/ 129 w 145"/>
                <a:gd name="T3" fmla="*/ 0 h 212"/>
                <a:gd name="T4" fmla="*/ 143 w 145"/>
                <a:gd name="T5" fmla="*/ 3 h 212"/>
                <a:gd name="T6" fmla="*/ 140 w 145"/>
                <a:gd name="T7" fmla="*/ 7 h 212"/>
                <a:gd name="T8" fmla="*/ 138 w 145"/>
                <a:gd name="T9" fmla="*/ 8 h 212"/>
                <a:gd name="T10" fmla="*/ 130 w 145"/>
                <a:gd name="T11" fmla="*/ 10 h 212"/>
                <a:gd name="T12" fmla="*/ 122 w 145"/>
                <a:gd name="T13" fmla="*/ 14 h 212"/>
                <a:gd name="T14" fmla="*/ 120 w 145"/>
                <a:gd name="T15" fmla="*/ 18 h 212"/>
                <a:gd name="T16" fmla="*/ 115 w 145"/>
                <a:gd name="T17" fmla="*/ 11 h 212"/>
                <a:gd name="T18" fmla="*/ 106 w 145"/>
                <a:gd name="T19" fmla="*/ 11 h 212"/>
                <a:gd name="T20" fmla="*/ 85 w 145"/>
                <a:gd name="T21" fmla="*/ 14 h 212"/>
                <a:gd name="T22" fmla="*/ 78 w 145"/>
                <a:gd name="T23" fmla="*/ 14 h 212"/>
                <a:gd name="T24" fmla="*/ 78 w 145"/>
                <a:gd name="T25" fmla="*/ 41 h 212"/>
                <a:gd name="T26" fmla="*/ 77 w 145"/>
                <a:gd name="T27" fmla="*/ 64 h 212"/>
                <a:gd name="T28" fmla="*/ 76 w 145"/>
                <a:gd name="T29" fmla="*/ 83 h 212"/>
                <a:gd name="T30" fmla="*/ 63 w 145"/>
                <a:gd name="T31" fmla="*/ 83 h 212"/>
                <a:gd name="T32" fmla="*/ 60 w 145"/>
                <a:gd name="T33" fmla="*/ 136 h 212"/>
                <a:gd name="T34" fmla="*/ 57 w 145"/>
                <a:gd name="T35" fmla="*/ 197 h 212"/>
                <a:gd name="T36" fmla="*/ 57 w 145"/>
                <a:gd name="T37" fmla="*/ 202 h 212"/>
                <a:gd name="T38" fmla="*/ 47 w 145"/>
                <a:gd name="T39" fmla="*/ 208 h 212"/>
                <a:gd name="T40" fmla="*/ 35 w 145"/>
                <a:gd name="T41" fmla="*/ 211 h 212"/>
                <a:gd name="T42" fmla="*/ 19 w 145"/>
                <a:gd name="T43" fmla="*/ 206 h 212"/>
                <a:gd name="T44" fmla="*/ 8 w 145"/>
                <a:gd name="T45" fmla="*/ 200 h 212"/>
                <a:gd name="T46" fmla="*/ 0 w 145"/>
                <a:gd name="T47" fmla="*/ 205 h 212"/>
                <a:gd name="T48" fmla="*/ 0 w 145"/>
                <a:gd name="T49" fmla="*/ 205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45" h="212">
                  <a:moveTo>
                    <a:pt x="115" y="3"/>
                  </a:moveTo>
                  <a:cubicBezTo>
                    <a:pt x="115" y="3"/>
                    <a:pt x="123" y="1"/>
                    <a:pt x="129" y="0"/>
                  </a:cubicBezTo>
                  <a:cubicBezTo>
                    <a:pt x="135" y="0"/>
                    <a:pt x="140" y="0"/>
                    <a:pt x="143" y="3"/>
                  </a:cubicBezTo>
                  <a:cubicBezTo>
                    <a:pt x="145" y="6"/>
                    <a:pt x="142" y="7"/>
                    <a:pt x="140" y="7"/>
                  </a:cubicBezTo>
                  <a:cubicBezTo>
                    <a:pt x="139" y="8"/>
                    <a:pt x="138" y="8"/>
                    <a:pt x="138" y="8"/>
                  </a:cubicBezTo>
                  <a:cubicBezTo>
                    <a:pt x="130" y="10"/>
                    <a:pt x="130" y="10"/>
                    <a:pt x="130" y="10"/>
                  </a:cubicBezTo>
                  <a:cubicBezTo>
                    <a:pt x="130" y="10"/>
                    <a:pt x="124" y="10"/>
                    <a:pt x="122" y="14"/>
                  </a:cubicBezTo>
                  <a:cubicBezTo>
                    <a:pt x="120" y="18"/>
                    <a:pt x="120" y="18"/>
                    <a:pt x="120" y="18"/>
                  </a:cubicBezTo>
                  <a:cubicBezTo>
                    <a:pt x="115" y="11"/>
                    <a:pt x="115" y="11"/>
                    <a:pt x="115" y="11"/>
                  </a:cubicBezTo>
                  <a:cubicBezTo>
                    <a:pt x="106" y="11"/>
                    <a:pt x="106" y="11"/>
                    <a:pt x="106" y="11"/>
                  </a:cubicBezTo>
                  <a:cubicBezTo>
                    <a:pt x="85" y="14"/>
                    <a:pt x="85" y="14"/>
                    <a:pt x="85" y="14"/>
                  </a:cubicBezTo>
                  <a:cubicBezTo>
                    <a:pt x="78" y="14"/>
                    <a:pt x="78" y="14"/>
                    <a:pt x="78" y="14"/>
                  </a:cubicBezTo>
                  <a:cubicBezTo>
                    <a:pt x="78" y="41"/>
                    <a:pt x="78" y="41"/>
                    <a:pt x="78" y="41"/>
                  </a:cubicBezTo>
                  <a:cubicBezTo>
                    <a:pt x="77" y="64"/>
                    <a:pt x="77" y="64"/>
                    <a:pt x="77" y="64"/>
                  </a:cubicBezTo>
                  <a:cubicBezTo>
                    <a:pt x="76" y="83"/>
                    <a:pt x="76" y="83"/>
                    <a:pt x="76" y="83"/>
                  </a:cubicBezTo>
                  <a:cubicBezTo>
                    <a:pt x="63" y="83"/>
                    <a:pt x="63" y="83"/>
                    <a:pt x="63" y="83"/>
                  </a:cubicBezTo>
                  <a:cubicBezTo>
                    <a:pt x="60" y="136"/>
                    <a:pt x="60" y="136"/>
                    <a:pt x="60" y="136"/>
                  </a:cubicBezTo>
                  <a:cubicBezTo>
                    <a:pt x="57" y="197"/>
                    <a:pt x="57" y="197"/>
                    <a:pt x="57" y="197"/>
                  </a:cubicBezTo>
                  <a:cubicBezTo>
                    <a:pt x="57" y="202"/>
                    <a:pt x="57" y="202"/>
                    <a:pt x="57" y="202"/>
                  </a:cubicBezTo>
                  <a:cubicBezTo>
                    <a:pt x="57" y="202"/>
                    <a:pt x="48" y="205"/>
                    <a:pt x="47" y="208"/>
                  </a:cubicBezTo>
                  <a:cubicBezTo>
                    <a:pt x="46" y="212"/>
                    <a:pt x="35" y="211"/>
                    <a:pt x="35" y="211"/>
                  </a:cubicBezTo>
                  <a:cubicBezTo>
                    <a:pt x="35" y="211"/>
                    <a:pt x="21" y="210"/>
                    <a:pt x="19" y="206"/>
                  </a:cubicBezTo>
                  <a:cubicBezTo>
                    <a:pt x="16" y="202"/>
                    <a:pt x="12" y="190"/>
                    <a:pt x="8" y="200"/>
                  </a:cubicBezTo>
                  <a:cubicBezTo>
                    <a:pt x="4" y="210"/>
                    <a:pt x="1" y="206"/>
                    <a:pt x="0" y="205"/>
                  </a:cubicBezTo>
                  <a:cubicBezTo>
                    <a:pt x="0" y="205"/>
                    <a:pt x="0" y="205"/>
                    <a:pt x="0" y="205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1" name="Freeform 273">
              <a:extLst>
                <a:ext uri="{FF2B5EF4-FFF2-40B4-BE49-F238E27FC236}">
                  <a16:creationId xmlns:a16="http://schemas.microsoft.com/office/drawing/2014/main" id="{D176328D-08B5-7961-A058-EE44E9A273CB}"/>
                </a:ext>
              </a:extLst>
            </p:cNvPr>
            <p:cNvSpPr>
              <a:spLocks/>
            </p:cNvSpPr>
            <p:nvPr/>
          </p:nvSpPr>
          <p:spPr bwMode="auto">
            <a:xfrm>
              <a:off x="8858252" y="2439988"/>
              <a:ext cx="585788" cy="555625"/>
            </a:xfrm>
            <a:custGeom>
              <a:avLst/>
              <a:gdLst>
                <a:gd name="T0" fmla="*/ 86 w 130"/>
                <a:gd name="T1" fmla="*/ 0 h 123"/>
                <a:gd name="T2" fmla="*/ 93 w 130"/>
                <a:gd name="T3" fmla="*/ 8 h 123"/>
                <a:gd name="T4" fmla="*/ 109 w 130"/>
                <a:gd name="T5" fmla="*/ 13 h 123"/>
                <a:gd name="T6" fmla="*/ 119 w 130"/>
                <a:gd name="T7" fmla="*/ 17 h 123"/>
                <a:gd name="T8" fmla="*/ 128 w 130"/>
                <a:gd name="T9" fmla="*/ 21 h 123"/>
                <a:gd name="T10" fmla="*/ 128 w 130"/>
                <a:gd name="T11" fmla="*/ 32 h 123"/>
                <a:gd name="T12" fmla="*/ 129 w 130"/>
                <a:gd name="T13" fmla="*/ 46 h 123"/>
                <a:gd name="T14" fmla="*/ 129 w 130"/>
                <a:gd name="T15" fmla="*/ 53 h 123"/>
                <a:gd name="T16" fmla="*/ 122 w 130"/>
                <a:gd name="T17" fmla="*/ 61 h 123"/>
                <a:gd name="T18" fmla="*/ 124 w 130"/>
                <a:gd name="T19" fmla="*/ 71 h 123"/>
                <a:gd name="T20" fmla="*/ 125 w 130"/>
                <a:gd name="T21" fmla="*/ 79 h 123"/>
                <a:gd name="T22" fmla="*/ 122 w 130"/>
                <a:gd name="T23" fmla="*/ 88 h 123"/>
                <a:gd name="T24" fmla="*/ 118 w 130"/>
                <a:gd name="T25" fmla="*/ 100 h 123"/>
                <a:gd name="T26" fmla="*/ 113 w 130"/>
                <a:gd name="T27" fmla="*/ 109 h 123"/>
                <a:gd name="T28" fmla="*/ 105 w 130"/>
                <a:gd name="T29" fmla="*/ 117 h 123"/>
                <a:gd name="T30" fmla="*/ 100 w 130"/>
                <a:gd name="T31" fmla="*/ 123 h 123"/>
                <a:gd name="T32" fmla="*/ 98 w 130"/>
                <a:gd name="T33" fmla="*/ 123 h 123"/>
                <a:gd name="T34" fmla="*/ 73 w 130"/>
                <a:gd name="T35" fmla="*/ 123 h 123"/>
                <a:gd name="T36" fmla="*/ 64 w 130"/>
                <a:gd name="T37" fmla="*/ 121 h 123"/>
                <a:gd name="T38" fmla="*/ 60 w 130"/>
                <a:gd name="T39" fmla="*/ 120 h 123"/>
                <a:gd name="T40" fmla="*/ 60 w 130"/>
                <a:gd name="T41" fmla="*/ 113 h 123"/>
                <a:gd name="T42" fmla="*/ 44 w 130"/>
                <a:gd name="T43" fmla="*/ 109 h 123"/>
                <a:gd name="T44" fmla="*/ 40 w 130"/>
                <a:gd name="T45" fmla="*/ 91 h 123"/>
                <a:gd name="T46" fmla="*/ 35 w 130"/>
                <a:gd name="T47" fmla="*/ 88 h 123"/>
                <a:gd name="T48" fmla="*/ 29 w 130"/>
                <a:gd name="T49" fmla="*/ 80 h 123"/>
                <a:gd name="T50" fmla="*/ 15 w 130"/>
                <a:gd name="T51" fmla="*/ 69 h 123"/>
                <a:gd name="T52" fmla="*/ 9 w 130"/>
                <a:gd name="T53" fmla="*/ 52 h 123"/>
                <a:gd name="T54" fmla="*/ 0 w 130"/>
                <a:gd name="T55" fmla="*/ 42 h 123"/>
                <a:gd name="T56" fmla="*/ 1 w 130"/>
                <a:gd name="T57" fmla="*/ 42 h 123"/>
                <a:gd name="T58" fmla="*/ 9 w 130"/>
                <a:gd name="T59" fmla="*/ 42 h 123"/>
                <a:gd name="T60" fmla="*/ 26 w 130"/>
                <a:gd name="T61" fmla="*/ 46 h 123"/>
                <a:gd name="T62" fmla="*/ 32 w 130"/>
                <a:gd name="T63" fmla="*/ 41 h 123"/>
                <a:gd name="T64" fmla="*/ 46 w 130"/>
                <a:gd name="T65" fmla="*/ 21 h 123"/>
                <a:gd name="T66" fmla="*/ 60 w 130"/>
                <a:gd name="T67" fmla="*/ 15 h 123"/>
                <a:gd name="T68" fmla="*/ 69 w 130"/>
                <a:gd name="T69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30" h="123">
                  <a:moveTo>
                    <a:pt x="86" y="0"/>
                  </a:moveTo>
                  <a:cubicBezTo>
                    <a:pt x="86" y="0"/>
                    <a:pt x="87" y="8"/>
                    <a:pt x="93" y="8"/>
                  </a:cubicBezTo>
                  <a:cubicBezTo>
                    <a:pt x="99" y="8"/>
                    <a:pt x="109" y="13"/>
                    <a:pt x="109" y="13"/>
                  </a:cubicBezTo>
                  <a:cubicBezTo>
                    <a:pt x="119" y="17"/>
                    <a:pt x="119" y="17"/>
                    <a:pt x="119" y="17"/>
                  </a:cubicBezTo>
                  <a:cubicBezTo>
                    <a:pt x="128" y="21"/>
                    <a:pt x="128" y="21"/>
                    <a:pt x="128" y="21"/>
                  </a:cubicBezTo>
                  <a:cubicBezTo>
                    <a:pt x="128" y="21"/>
                    <a:pt x="130" y="29"/>
                    <a:pt x="128" y="32"/>
                  </a:cubicBezTo>
                  <a:cubicBezTo>
                    <a:pt x="127" y="34"/>
                    <a:pt x="129" y="46"/>
                    <a:pt x="129" y="46"/>
                  </a:cubicBezTo>
                  <a:cubicBezTo>
                    <a:pt x="129" y="53"/>
                    <a:pt x="129" y="53"/>
                    <a:pt x="129" y="53"/>
                  </a:cubicBezTo>
                  <a:cubicBezTo>
                    <a:pt x="122" y="61"/>
                    <a:pt x="122" y="61"/>
                    <a:pt x="122" y="61"/>
                  </a:cubicBezTo>
                  <a:cubicBezTo>
                    <a:pt x="122" y="61"/>
                    <a:pt x="123" y="67"/>
                    <a:pt x="124" y="71"/>
                  </a:cubicBezTo>
                  <a:cubicBezTo>
                    <a:pt x="125" y="74"/>
                    <a:pt x="125" y="79"/>
                    <a:pt x="125" y="79"/>
                  </a:cubicBezTo>
                  <a:cubicBezTo>
                    <a:pt x="122" y="88"/>
                    <a:pt x="122" y="88"/>
                    <a:pt x="122" y="88"/>
                  </a:cubicBezTo>
                  <a:cubicBezTo>
                    <a:pt x="118" y="100"/>
                    <a:pt x="118" y="100"/>
                    <a:pt x="118" y="100"/>
                  </a:cubicBezTo>
                  <a:cubicBezTo>
                    <a:pt x="118" y="100"/>
                    <a:pt x="115" y="107"/>
                    <a:pt x="113" y="109"/>
                  </a:cubicBezTo>
                  <a:cubicBezTo>
                    <a:pt x="112" y="111"/>
                    <a:pt x="105" y="117"/>
                    <a:pt x="105" y="117"/>
                  </a:cubicBezTo>
                  <a:cubicBezTo>
                    <a:pt x="100" y="123"/>
                    <a:pt x="100" y="123"/>
                    <a:pt x="100" y="123"/>
                  </a:cubicBezTo>
                  <a:cubicBezTo>
                    <a:pt x="98" y="123"/>
                    <a:pt x="98" y="123"/>
                    <a:pt x="98" y="123"/>
                  </a:cubicBezTo>
                  <a:cubicBezTo>
                    <a:pt x="73" y="123"/>
                    <a:pt x="73" y="123"/>
                    <a:pt x="73" y="123"/>
                  </a:cubicBezTo>
                  <a:cubicBezTo>
                    <a:pt x="64" y="121"/>
                    <a:pt x="64" y="121"/>
                    <a:pt x="64" y="121"/>
                  </a:cubicBezTo>
                  <a:cubicBezTo>
                    <a:pt x="60" y="120"/>
                    <a:pt x="60" y="120"/>
                    <a:pt x="60" y="120"/>
                  </a:cubicBezTo>
                  <a:cubicBezTo>
                    <a:pt x="60" y="113"/>
                    <a:pt x="60" y="113"/>
                    <a:pt x="60" y="113"/>
                  </a:cubicBezTo>
                  <a:cubicBezTo>
                    <a:pt x="44" y="109"/>
                    <a:pt x="44" y="109"/>
                    <a:pt x="44" y="109"/>
                  </a:cubicBezTo>
                  <a:cubicBezTo>
                    <a:pt x="40" y="91"/>
                    <a:pt x="40" y="91"/>
                    <a:pt x="40" y="91"/>
                  </a:cubicBezTo>
                  <a:cubicBezTo>
                    <a:pt x="35" y="88"/>
                    <a:pt x="35" y="88"/>
                    <a:pt x="35" y="88"/>
                  </a:cubicBezTo>
                  <a:cubicBezTo>
                    <a:pt x="29" y="80"/>
                    <a:pt x="29" y="80"/>
                    <a:pt x="29" y="80"/>
                  </a:cubicBezTo>
                  <a:cubicBezTo>
                    <a:pt x="15" y="69"/>
                    <a:pt x="15" y="69"/>
                    <a:pt x="15" y="69"/>
                  </a:cubicBezTo>
                  <a:cubicBezTo>
                    <a:pt x="9" y="52"/>
                    <a:pt x="9" y="52"/>
                    <a:pt x="9" y="52"/>
                  </a:cubicBezTo>
                  <a:cubicBezTo>
                    <a:pt x="0" y="42"/>
                    <a:pt x="0" y="42"/>
                    <a:pt x="0" y="42"/>
                  </a:cubicBezTo>
                  <a:cubicBezTo>
                    <a:pt x="0" y="42"/>
                    <a:pt x="0" y="42"/>
                    <a:pt x="1" y="42"/>
                  </a:cubicBezTo>
                  <a:cubicBezTo>
                    <a:pt x="2" y="41"/>
                    <a:pt x="5" y="41"/>
                    <a:pt x="9" y="42"/>
                  </a:cubicBezTo>
                  <a:cubicBezTo>
                    <a:pt x="15" y="43"/>
                    <a:pt x="26" y="46"/>
                    <a:pt x="26" y="46"/>
                  </a:cubicBezTo>
                  <a:cubicBezTo>
                    <a:pt x="26" y="46"/>
                    <a:pt x="28" y="46"/>
                    <a:pt x="32" y="41"/>
                  </a:cubicBezTo>
                  <a:cubicBezTo>
                    <a:pt x="36" y="37"/>
                    <a:pt x="45" y="19"/>
                    <a:pt x="46" y="21"/>
                  </a:cubicBezTo>
                  <a:cubicBezTo>
                    <a:pt x="48" y="22"/>
                    <a:pt x="58" y="17"/>
                    <a:pt x="60" y="15"/>
                  </a:cubicBezTo>
                  <a:cubicBezTo>
                    <a:pt x="62" y="12"/>
                    <a:pt x="69" y="0"/>
                    <a:pt x="69" y="0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2" name="Freeform 274">
              <a:extLst>
                <a:ext uri="{FF2B5EF4-FFF2-40B4-BE49-F238E27FC236}">
                  <a16:creationId xmlns:a16="http://schemas.microsoft.com/office/drawing/2014/main" id="{0654DD3D-AEA2-A6CA-4FF2-E6CC2B6B2FA1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8839" y="2987676"/>
              <a:ext cx="668338" cy="392113"/>
            </a:xfrm>
            <a:custGeom>
              <a:avLst/>
              <a:gdLst>
                <a:gd name="T0" fmla="*/ 0 w 148"/>
                <a:gd name="T1" fmla="*/ 49 h 87"/>
                <a:gd name="T2" fmla="*/ 8 w 148"/>
                <a:gd name="T3" fmla="*/ 56 h 87"/>
                <a:gd name="T4" fmla="*/ 12 w 148"/>
                <a:gd name="T5" fmla="*/ 70 h 87"/>
                <a:gd name="T6" fmla="*/ 10 w 148"/>
                <a:gd name="T7" fmla="*/ 79 h 87"/>
                <a:gd name="T8" fmla="*/ 10 w 148"/>
                <a:gd name="T9" fmla="*/ 86 h 87"/>
                <a:gd name="T10" fmla="*/ 19 w 148"/>
                <a:gd name="T11" fmla="*/ 86 h 87"/>
                <a:gd name="T12" fmla="*/ 37 w 148"/>
                <a:gd name="T13" fmla="*/ 77 h 87"/>
                <a:gd name="T14" fmla="*/ 46 w 148"/>
                <a:gd name="T15" fmla="*/ 60 h 87"/>
                <a:gd name="T16" fmla="*/ 51 w 148"/>
                <a:gd name="T17" fmla="*/ 56 h 87"/>
                <a:gd name="T18" fmla="*/ 62 w 148"/>
                <a:gd name="T19" fmla="*/ 62 h 87"/>
                <a:gd name="T20" fmla="*/ 79 w 148"/>
                <a:gd name="T21" fmla="*/ 66 h 87"/>
                <a:gd name="T22" fmla="*/ 93 w 148"/>
                <a:gd name="T23" fmla="*/ 56 h 87"/>
                <a:gd name="T24" fmla="*/ 108 w 148"/>
                <a:gd name="T25" fmla="*/ 41 h 87"/>
                <a:gd name="T26" fmla="*/ 111 w 148"/>
                <a:gd name="T27" fmla="*/ 31 h 87"/>
                <a:gd name="T28" fmla="*/ 115 w 148"/>
                <a:gd name="T29" fmla="*/ 24 h 87"/>
                <a:gd name="T30" fmla="*/ 126 w 148"/>
                <a:gd name="T31" fmla="*/ 15 h 87"/>
                <a:gd name="T32" fmla="*/ 134 w 148"/>
                <a:gd name="T33" fmla="*/ 8 h 87"/>
                <a:gd name="T34" fmla="*/ 148 w 148"/>
                <a:gd name="T35" fmla="*/ 0 h 87"/>
                <a:gd name="T36" fmla="*/ 148 w 148"/>
                <a:gd name="T37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148" h="87">
                  <a:moveTo>
                    <a:pt x="0" y="49"/>
                  </a:moveTo>
                  <a:cubicBezTo>
                    <a:pt x="0" y="49"/>
                    <a:pt x="6" y="53"/>
                    <a:pt x="8" y="56"/>
                  </a:cubicBezTo>
                  <a:cubicBezTo>
                    <a:pt x="10" y="60"/>
                    <a:pt x="13" y="66"/>
                    <a:pt x="12" y="70"/>
                  </a:cubicBezTo>
                  <a:cubicBezTo>
                    <a:pt x="12" y="74"/>
                    <a:pt x="11" y="74"/>
                    <a:pt x="10" y="79"/>
                  </a:cubicBezTo>
                  <a:cubicBezTo>
                    <a:pt x="9" y="83"/>
                    <a:pt x="8" y="86"/>
                    <a:pt x="10" y="86"/>
                  </a:cubicBezTo>
                  <a:cubicBezTo>
                    <a:pt x="12" y="87"/>
                    <a:pt x="16" y="86"/>
                    <a:pt x="19" y="86"/>
                  </a:cubicBezTo>
                  <a:cubicBezTo>
                    <a:pt x="22" y="86"/>
                    <a:pt x="29" y="87"/>
                    <a:pt x="37" y="77"/>
                  </a:cubicBezTo>
                  <a:cubicBezTo>
                    <a:pt x="45" y="67"/>
                    <a:pt x="46" y="61"/>
                    <a:pt x="46" y="60"/>
                  </a:cubicBezTo>
                  <a:cubicBezTo>
                    <a:pt x="45" y="58"/>
                    <a:pt x="48" y="57"/>
                    <a:pt x="51" y="56"/>
                  </a:cubicBezTo>
                  <a:cubicBezTo>
                    <a:pt x="54" y="56"/>
                    <a:pt x="60" y="61"/>
                    <a:pt x="62" y="62"/>
                  </a:cubicBezTo>
                  <a:cubicBezTo>
                    <a:pt x="64" y="64"/>
                    <a:pt x="72" y="68"/>
                    <a:pt x="79" y="66"/>
                  </a:cubicBezTo>
                  <a:cubicBezTo>
                    <a:pt x="86" y="65"/>
                    <a:pt x="93" y="61"/>
                    <a:pt x="93" y="56"/>
                  </a:cubicBezTo>
                  <a:cubicBezTo>
                    <a:pt x="93" y="52"/>
                    <a:pt x="107" y="40"/>
                    <a:pt x="108" y="41"/>
                  </a:cubicBezTo>
                  <a:cubicBezTo>
                    <a:pt x="109" y="42"/>
                    <a:pt x="110" y="35"/>
                    <a:pt x="111" y="31"/>
                  </a:cubicBezTo>
                  <a:cubicBezTo>
                    <a:pt x="112" y="28"/>
                    <a:pt x="113" y="26"/>
                    <a:pt x="115" y="24"/>
                  </a:cubicBezTo>
                  <a:cubicBezTo>
                    <a:pt x="118" y="22"/>
                    <a:pt x="123" y="20"/>
                    <a:pt x="126" y="15"/>
                  </a:cubicBezTo>
                  <a:cubicBezTo>
                    <a:pt x="130" y="11"/>
                    <a:pt x="132" y="8"/>
                    <a:pt x="134" y="8"/>
                  </a:cubicBezTo>
                  <a:cubicBezTo>
                    <a:pt x="136" y="8"/>
                    <a:pt x="148" y="1"/>
                    <a:pt x="148" y="0"/>
                  </a:cubicBezTo>
                  <a:cubicBezTo>
                    <a:pt x="148" y="0"/>
                    <a:pt x="148" y="0"/>
                    <a:pt x="148" y="0"/>
                  </a:cubicBezTo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3" name="Freeform 275">
              <a:extLst>
                <a:ext uri="{FF2B5EF4-FFF2-40B4-BE49-F238E27FC236}">
                  <a16:creationId xmlns:a16="http://schemas.microsoft.com/office/drawing/2014/main" id="{7831CDFF-C6E4-C6D1-FB02-92F65ABBA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4" y="3524251"/>
              <a:ext cx="166688" cy="176213"/>
            </a:xfrm>
            <a:custGeom>
              <a:avLst/>
              <a:gdLst>
                <a:gd name="T0" fmla="*/ 5 w 37"/>
                <a:gd name="T1" fmla="*/ 14 h 39"/>
                <a:gd name="T2" fmla="*/ 0 w 37"/>
                <a:gd name="T3" fmla="*/ 17 h 39"/>
                <a:gd name="T4" fmla="*/ 0 w 37"/>
                <a:gd name="T5" fmla="*/ 20 h 39"/>
                <a:gd name="T6" fmla="*/ 0 w 37"/>
                <a:gd name="T7" fmla="*/ 25 h 39"/>
                <a:gd name="T8" fmla="*/ 3 w 37"/>
                <a:gd name="T9" fmla="*/ 29 h 39"/>
                <a:gd name="T10" fmla="*/ 7 w 37"/>
                <a:gd name="T11" fmla="*/ 33 h 39"/>
                <a:gd name="T12" fmla="*/ 10 w 37"/>
                <a:gd name="T13" fmla="*/ 37 h 39"/>
                <a:gd name="T14" fmla="*/ 13 w 37"/>
                <a:gd name="T15" fmla="*/ 39 h 39"/>
                <a:gd name="T16" fmla="*/ 15 w 37"/>
                <a:gd name="T17" fmla="*/ 37 h 39"/>
                <a:gd name="T18" fmla="*/ 17 w 37"/>
                <a:gd name="T19" fmla="*/ 35 h 39"/>
                <a:gd name="T20" fmla="*/ 17 w 37"/>
                <a:gd name="T21" fmla="*/ 30 h 39"/>
                <a:gd name="T22" fmla="*/ 20 w 37"/>
                <a:gd name="T23" fmla="*/ 29 h 39"/>
                <a:gd name="T24" fmla="*/ 22 w 37"/>
                <a:gd name="T25" fmla="*/ 27 h 39"/>
                <a:gd name="T26" fmla="*/ 25 w 37"/>
                <a:gd name="T27" fmla="*/ 27 h 39"/>
                <a:gd name="T28" fmla="*/ 28 w 37"/>
                <a:gd name="T29" fmla="*/ 27 h 39"/>
                <a:gd name="T30" fmla="*/ 31 w 37"/>
                <a:gd name="T31" fmla="*/ 25 h 39"/>
                <a:gd name="T32" fmla="*/ 33 w 37"/>
                <a:gd name="T33" fmla="*/ 22 h 39"/>
                <a:gd name="T34" fmla="*/ 35 w 37"/>
                <a:gd name="T35" fmla="*/ 18 h 39"/>
                <a:gd name="T36" fmla="*/ 37 w 37"/>
                <a:gd name="T37" fmla="*/ 14 h 39"/>
                <a:gd name="T38" fmla="*/ 37 w 37"/>
                <a:gd name="T39" fmla="*/ 11 h 39"/>
                <a:gd name="T40" fmla="*/ 35 w 37"/>
                <a:gd name="T41" fmla="*/ 7 h 39"/>
                <a:gd name="T42" fmla="*/ 31 w 37"/>
                <a:gd name="T43" fmla="*/ 4 h 39"/>
                <a:gd name="T44" fmla="*/ 28 w 37"/>
                <a:gd name="T45" fmla="*/ 0 h 39"/>
                <a:gd name="T46" fmla="*/ 26 w 37"/>
                <a:gd name="T47" fmla="*/ 0 h 39"/>
                <a:gd name="T48" fmla="*/ 21 w 37"/>
                <a:gd name="T49" fmla="*/ 0 h 39"/>
                <a:gd name="T50" fmla="*/ 19 w 37"/>
                <a:gd name="T51" fmla="*/ 3 h 39"/>
                <a:gd name="T52" fmla="*/ 15 w 37"/>
                <a:gd name="T53" fmla="*/ 5 h 39"/>
                <a:gd name="T54" fmla="*/ 12 w 37"/>
                <a:gd name="T55" fmla="*/ 8 h 39"/>
                <a:gd name="T56" fmla="*/ 9 w 37"/>
                <a:gd name="T57" fmla="*/ 10 h 39"/>
                <a:gd name="T58" fmla="*/ 7 w 37"/>
                <a:gd name="T59" fmla="*/ 12 h 39"/>
                <a:gd name="T60" fmla="*/ 5 w 37"/>
                <a:gd name="T61" fmla="*/ 14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37" h="39">
                  <a:moveTo>
                    <a:pt x="5" y="14"/>
                  </a:moveTo>
                  <a:cubicBezTo>
                    <a:pt x="0" y="17"/>
                    <a:pt x="0" y="17"/>
                    <a:pt x="0" y="17"/>
                  </a:cubicBezTo>
                  <a:cubicBezTo>
                    <a:pt x="0" y="20"/>
                    <a:pt x="0" y="20"/>
                    <a:pt x="0" y="20"/>
                  </a:cubicBezTo>
                  <a:cubicBezTo>
                    <a:pt x="0" y="25"/>
                    <a:pt x="0" y="25"/>
                    <a:pt x="0" y="25"/>
                  </a:cubicBezTo>
                  <a:cubicBezTo>
                    <a:pt x="3" y="29"/>
                    <a:pt x="3" y="29"/>
                    <a:pt x="3" y="29"/>
                  </a:cubicBezTo>
                  <a:cubicBezTo>
                    <a:pt x="7" y="33"/>
                    <a:pt x="7" y="33"/>
                    <a:pt x="7" y="33"/>
                  </a:cubicBezTo>
                  <a:cubicBezTo>
                    <a:pt x="10" y="37"/>
                    <a:pt x="10" y="37"/>
                    <a:pt x="10" y="37"/>
                  </a:cubicBezTo>
                  <a:cubicBezTo>
                    <a:pt x="13" y="39"/>
                    <a:pt x="13" y="39"/>
                    <a:pt x="13" y="39"/>
                  </a:cubicBezTo>
                  <a:cubicBezTo>
                    <a:pt x="15" y="37"/>
                    <a:pt x="15" y="37"/>
                    <a:pt x="15" y="37"/>
                  </a:cubicBezTo>
                  <a:cubicBezTo>
                    <a:pt x="15" y="37"/>
                    <a:pt x="17" y="36"/>
                    <a:pt x="17" y="35"/>
                  </a:cubicBezTo>
                  <a:cubicBezTo>
                    <a:pt x="18" y="34"/>
                    <a:pt x="17" y="30"/>
                    <a:pt x="17" y="30"/>
                  </a:cubicBezTo>
                  <a:cubicBezTo>
                    <a:pt x="20" y="29"/>
                    <a:pt x="20" y="29"/>
                    <a:pt x="20" y="29"/>
                  </a:cubicBezTo>
                  <a:cubicBezTo>
                    <a:pt x="22" y="27"/>
                    <a:pt x="22" y="27"/>
                    <a:pt x="22" y="27"/>
                  </a:cubicBezTo>
                  <a:cubicBezTo>
                    <a:pt x="25" y="27"/>
                    <a:pt x="25" y="27"/>
                    <a:pt x="25" y="27"/>
                  </a:cubicBezTo>
                  <a:cubicBezTo>
                    <a:pt x="28" y="27"/>
                    <a:pt x="28" y="27"/>
                    <a:pt x="28" y="27"/>
                  </a:cubicBezTo>
                  <a:cubicBezTo>
                    <a:pt x="31" y="25"/>
                    <a:pt x="31" y="25"/>
                    <a:pt x="31" y="25"/>
                  </a:cubicBezTo>
                  <a:cubicBezTo>
                    <a:pt x="33" y="22"/>
                    <a:pt x="33" y="22"/>
                    <a:pt x="33" y="22"/>
                  </a:cubicBezTo>
                  <a:cubicBezTo>
                    <a:pt x="35" y="18"/>
                    <a:pt x="35" y="18"/>
                    <a:pt x="35" y="18"/>
                  </a:cubicBezTo>
                  <a:cubicBezTo>
                    <a:pt x="37" y="14"/>
                    <a:pt x="37" y="14"/>
                    <a:pt x="37" y="14"/>
                  </a:cubicBezTo>
                  <a:cubicBezTo>
                    <a:pt x="37" y="11"/>
                    <a:pt x="37" y="11"/>
                    <a:pt x="37" y="11"/>
                  </a:cubicBezTo>
                  <a:cubicBezTo>
                    <a:pt x="35" y="7"/>
                    <a:pt x="35" y="7"/>
                    <a:pt x="35" y="7"/>
                  </a:cubicBezTo>
                  <a:cubicBezTo>
                    <a:pt x="31" y="4"/>
                    <a:pt x="31" y="4"/>
                    <a:pt x="31" y="4"/>
                  </a:cubicBezTo>
                  <a:cubicBezTo>
                    <a:pt x="28" y="0"/>
                    <a:pt x="28" y="0"/>
                    <a:pt x="28" y="0"/>
                  </a:cubicBezTo>
                  <a:cubicBezTo>
                    <a:pt x="26" y="0"/>
                    <a:pt x="26" y="0"/>
                    <a:pt x="26" y="0"/>
                  </a:cubicBezTo>
                  <a:cubicBezTo>
                    <a:pt x="21" y="0"/>
                    <a:pt x="21" y="0"/>
                    <a:pt x="21" y="0"/>
                  </a:cubicBezTo>
                  <a:cubicBezTo>
                    <a:pt x="19" y="3"/>
                    <a:pt x="19" y="3"/>
                    <a:pt x="19" y="3"/>
                  </a:cubicBezTo>
                  <a:cubicBezTo>
                    <a:pt x="19" y="3"/>
                    <a:pt x="16" y="4"/>
                    <a:pt x="15" y="5"/>
                  </a:cubicBezTo>
                  <a:cubicBezTo>
                    <a:pt x="15" y="7"/>
                    <a:pt x="12" y="8"/>
                    <a:pt x="12" y="8"/>
                  </a:cubicBezTo>
                  <a:cubicBezTo>
                    <a:pt x="9" y="10"/>
                    <a:pt x="9" y="10"/>
                    <a:pt x="9" y="10"/>
                  </a:cubicBezTo>
                  <a:cubicBezTo>
                    <a:pt x="7" y="12"/>
                    <a:pt x="7" y="12"/>
                    <a:pt x="7" y="12"/>
                  </a:cubicBezTo>
                  <a:lnTo>
                    <a:pt x="5" y="14"/>
                  </a:lnTo>
                  <a:close/>
                </a:path>
              </a:pathLst>
            </a:cu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4" name="Line 276">
              <a:extLst>
                <a:ext uri="{FF2B5EF4-FFF2-40B4-BE49-F238E27FC236}">
                  <a16:creationId xmlns:a16="http://schemas.microsoft.com/office/drawing/2014/main" id="{BF356B44-0F08-D2F5-CCFD-95C921BD9D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50277" y="2882901"/>
              <a:ext cx="4763" cy="31750"/>
            </a:xfrm>
            <a:prstGeom prst="line">
              <a:avLst/>
            </a:pr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5" name="Rectangle 282">
              <a:extLst>
                <a:ext uri="{FF2B5EF4-FFF2-40B4-BE49-F238E27FC236}">
                  <a16:creationId xmlns:a16="http://schemas.microsoft.com/office/drawing/2014/main" id="{75377023-CF8C-4C31-1365-FA8EADC97B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70658" y="3465956"/>
              <a:ext cx="2260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i="0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BGB</a:t>
              </a:r>
              <a:endParaRPr kumimoji="0" lang="de-DE" altLang="de-DE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6" name="Rectangle 283">
              <a:extLst>
                <a:ext uri="{FF2B5EF4-FFF2-40B4-BE49-F238E27FC236}">
                  <a16:creationId xmlns:a16="http://schemas.microsoft.com/office/drawing/2014/main" id="{86D5B0D2-BDF0-7D66-9DA9-9508348C3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78610" y="3656035"/>
              <a:ext cx="29815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i="0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South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i="0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 </a:t>
              </a:r>
              <a:r>
                <a:rPr kumimoji="0" lang="de-DE" altLang="de-DE" sz="9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Africa</a:t>
              </a:r>
              <a:endParaRPr kumimoji="0" lang="de-DE" altLang="de-DE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47" name="Freeform 277">
              <a:extLst>
                <a:ext uri="{FF2B5EF4-FFF2-40B4-BE49-F238E27FC236}">
                  <a16:creationId xmlns:a16="http://schemas.microsoft.com/office/drawing/2014/main" id="{991367CE-C3EB-F01C-BB69-DC5E47D8CAF9}"/>
                </a:ext>
              </a:extLst>
            </p:cNvPr>
            <p:cNvSpPr>
              <a:spLocks/>
            </p:cNvSpPr>
            <p:nvPr/>
          </p:nvSpPr>
          <p:spPr bwMode="auto">
            <a:xfrm>
              <a:off x="8522421" y="2910681"/>
              <a:ext cx="858838" cy="830263"/>
            </a:xfrm>
            <a:custGeom>
              <a:avLst/>
              <a:gdLst>
                <a:gd name="T0" fmla="*/ 1 w 190"/>
                <a:gd name="T1" fmla="*/ 0 h 184"/>
                <a:gd name="T2" fmla="*/ 47 w 190"/>
                <a:gd name="T3" fmla="*/ 0 h 184"/>
                <a:gd name="T4" fmla="*/ 86 w 190"/>
                <a:gd name="T5" fmla="*/ 10 h 184"/>
                <a:gd name="T6" fmla="*/ 127 w 190"/>
                <a:gd name="T7" fmla="*/ 10 h 184"/>
                <a:gd name="T8" fmla="*/ 162 w 190"/>
                <a:gd name="T9" fmla="*/ 8 h 184"/>
                <a:gd name="T10" fmla="*/ 166 w 190"/>
                <a:gd name="T11" fmla="*/ 10 h 184"/>
                <a:gd name="T12" fmla="*/ 169 w 190"/>
                <a:gd name="T13" fmla="*/ 16 h 184"/>
                <a:gd name="T14" fmla="*/ 174 w 190"/>
                <a:gd name="T15" fmla="*/ 31 h 184"/>
                <a:gd name="T16" fmla="*/ 181 w 190"/>
                <a:gd name="T17" fmla="*/ 57 h 184"/>
                <a:gd name="T18" fmla="*/ 181 w 190"/>
                <a:gd name="T19" fmla="*/ 75 h 184"/>
                <a:gd name="T20" fmla="*/ 181 w 190"/>
                <a:gd name="T21" fmla="*/ 91 h 184"/>
                <a:gd name="T22" fmla="*/ 188 w 190"/>
                <a:gd name="T23" fmla="*/ 100 h 184"/>
                <a:gd name="T24" fmla="*/ 190 w 190"/>
                <a:gd name="T25" fmla="*/ 107 h 184"/>
                <a:gd name="T26" fmla="*/ 188 w 190"/>
                <a:gd name="T27" fmla="*/ 114 h 184"/>
                <a:gd name="T28" fmla="*/ 177 w 190"/>
                <a:gd name="T29" fmla="*/ 122 h 184"/>
                <a:gd name="T30" fmla="*/ 159 w 190"/>
                <a:gd name="T31" fmla="*/ 137 h 184"/>
                <a:gd name="T32" fmla="*/ 134 w 190"/>
                <a:gd name="T33" fmla="*/ 152 h 184"/>
                <a:gd name="T34" fmla="*/ 123 w 190"/>
                <a:gd name="T35" fmla="*/ 159 h 184"/>
                <a:gd name="T36" fmla="*/ 109 w 190"/>
                <a:gd name="T37" fmla="*/ 166 h 184"/>
                <a:gd name="T38" fmla="*/ 87 w 190"/>
                <a:gd name="T39" fmla="*/ 176 h 184"/>
                <a:gd name="T40" fmla="*/ 74 w 190"/>
                <a:gd name="T41" fmla="*/ 181 h 184"/>
                <a:gd name="T42" fmla="*/ 51 w 190"/>
                <a:gd name="T43" fmla="*/ 178 h 184"/>
                <a:gd name="T44" fmla="*/ 15 w 190"/>
                <a:gd name="T45" fmla="*/ 152 h 184"/>
                <a:gd name="T46" fmla="*/ 12 w 190"/>
                <a:gd name="T47" fmla="*/ 123 h 184"/>
                <a:gd name="T48" fmla="*/ 14 w 190"/>
                <a:gd name="T49" fmla="*/ 57 h 184"/>
                <a:gd name="T50" fmla="*/ 14 w 190"/>
                <a:gd name="T51" fmla="*/ 28 h 184"/>
                <a:gd name="T52" fmla="*/ 0 w 190"/>
                <a:gd name="T53" fmla="*/ 7 h 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190" h="184">
                  <a:moveTo>
                    <a:pt x="1" y="0"/>
                  </a:moveTo>
                  <a:cubicBezTo>
                    <a:pt x="47" y="0"/>
                    <a:pt x="47" y="0"/>
                    <a:pt x="47" y="0"/>
                  </a:cubicBezTo>
                  <a:cubicBezTo>
                    <a:pt x="86" y="10"/>
                    <a:pt x="86" y="10"/>
                    <a:pt x="86" y="10"/>
                  </a:cubicBezTo>
                  <a:cubicBezTo>
                    <a:pt x="127" y="10"/>
                    <a:pt x="127" y="10"/>
                    <a:pt x="127" y="10"/>
                  </a:cubicBezTo>
                  <a:cubicBezTo>
                    <a:pt x="162" y="8"/>
                    <a:pt x="162" y="8"/>
                    <a:pt x="162" y="8"/>
                  </a:cubicBezTo>
                  <a:cubicBezTo>
                    <a:pt x="162" y="8"/>
                    <a:pt x="165" y="8"/>
                    <a:pt x="166" y="10"/>
                  </a:cubicBezTo>
                  <a:cubicBezTo>
                    <a:pt x="168" y="11"/>
                    <a:pt x="169" y="16"/>
                    <a:pt x="169" y="16"/>
                  </a:cubicBezTo>
                  <a:cubicBezTo>
                    <a:pt x="174" y="31"/>
                    <a:pt x="174" y="31"/>
                    <a:pt x="174" y="31"/>
                  </a:cubicBezTo>
                  <a:cubicBezTo>
                    <a:pt x="181" y="57"/>
                    <a:pt x="181" y="57"/>
                    <a:pt x="181" y="57"/>
                  </a:cubicBezTo>
                  <a:cubicBezTo>
                    <a:pt x="181" y="75"/>
                    <a:pt x="181" y="75"/>
                    <a:pt x="181" y="75"/>
                  </a:cubicBezTo>
                  <a:cubicBezTo>
                    <a:pt x="181" y="91"/>
                    <a:pt x="181" y="91"/>
                    <a:pt x="181" y="91"/>
                  </a:cubicBezTo>
                  <a:cubicBezTo>
                    <a:pt x="188" y="100"/>
                    <a:pt x="188" y="100"/>
                    <a:pt x="188" y="100"/>
                  </a:cubicBezTo>
                  <a:cubicBezTo>
                    <a:pt x="190" y="107"/>
                    <a:pt x="190" y="107"/>
                    <a:pt x="190" y="107"/>
                  </a:cubicBezTo>
                  <a:cubicBezTo>
                    <a:pt x="188" y="114"/>
                    <a:pt x="188" y="114"/>
                    <a:pt x="188" y="114"/>
                  </a:cubicBezTo>
                  <a:cubicBezTo>
                    <a:pt x="177" y="122"/>
                    <a:pt x="177" y="122"/>
                    <a:pt x="177" y="122"/>
                  </a:cubicBezTo>
                  <a:cubicBezTo>
                    <a:pt x="159" y="137"/>
                    <a:pt x="159" y="137"/>
                    <a:pt x="159" y="137"/>
                  </a:cubicBezTo>
                  <a:cubicBezTo>
                    <a:pt x="134" y="152"/>
                    <a:pt x="134" y="152"/>
                    <a:pt x="134" y="152"/>
                  </a:cubicBezTo>
                  <a:cubicBezTo>
                    <a:pt x="123" y="159"/>
                    <a:pt x="123" y="159"/>
                    <a:pt x="123" y="159"/>
                  </a:cubicBezTo>
                  <a:cubicBezTo>
                    <a:pt x="109" y="166"/>
                    <a:pt x="109" y="166"/>
                    <a:pt x="109" y="166"/>
                  </a:cubicBezTo>
                  <a:cubicBezTo>
                    <a:pt x="87" y="176"/>
                    <a:pt x="87" y="176"/>
                    <a:pt x="87" y="176"/>
                  </a:cubicBezTo>
                  <a:cubicBezTo>
                    <a:pt x="87" y="176"/>
                    <a:pt x="82" y="180"/>
                    <a:pt x="74" y="181"/>
                  </a:cubicBezTo>
                  <a:cubicBezTo>
                    <a:pt x="65" y="181"/>
                    <a:pt x="61" y="184"/>
                    <a:pt x="51" y="178"/>
                  </a:cubicBezTo>
                  <a:cubicBezTo>
                    <a:pt x="41" y="171"/>
                    <a:pt x="17" y="156"/>
                    <a:pt x="15" y="152"/>
                  </a:cubicBezTo>
                  <a:cubicBezTo>
                    <a:pt x="13" y="147"/>
                    <a:pt x="11" y="131"/>
                    <a:pt x="12" y="123"/>
                  </a:cubicBezTo>
                  <a:cubicBezTo>
                    <a:pt x="13" y="115"/>
                    <a:pt x="14" y="57"/>
                    <a:pt x="14" y="57"/>
                  </a:cubicBezTo>
                  <a:cubicBezTo>
                    <a:pt x="14" y="28"/>
                    <a:pt x="14" y="28"/>
                    <a:pt x="14" y="28"/>
                  </a:cubicBezTo>
                  <a:cubicBezTo>
                    <a:pt x="0" y="7"/>
                    <a:pt x="0" y="7"/>
                    <a:pt x="0" y="7"/>
                  </a:cubicBezTo>
                </a:path>
              </a:pathLst>
            </a:custGeom>
            <a:solidFill>
              <a:schemeClr val="accent2">
                <a:lumMod val="40000"/>
                <a:lumOff val="60000"/>
                <a:alpha val="75000"/>
              </a:schemeClr>
            </a:solidFill>
            <a:ln w="7938" cap="rnd">
              <a:solidFill>
                <a:schemeClr val="tx1"/>
              </a:solidFill>
              <a:prstDash val="dash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9" name="Freihandform 824">
              <a:extLst>
                <a:ext uri="{FF2B5EF4-FFF2-40B4-BE49-F238E27FC236}">
                  <a16:creationId xmlns:a16="http://schemas.microsoft.com/office/drawing/2014/main" id="{1930B378-A436-A159-58C3-1CA2C6F8CC0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202814" y="3269818"/>
              <a:ext cx="140818" cy="126242"/>
            </a:xfrm>
            <a:custGeom>
              <a:avLst/>
              <a:gdLst>
                <a:gd name="connsiteX0" fmla="*/ 2388865 w 7040906"/>
                <a:gd name="connsiteY0" fmla="*/ 2776008 h 6312049"/>
                <a:gd name="connsiteX1" fmla="*/ 2508608 w 7040906"/>
                <a:gd name="connsiteY1" fmla="*/ 2449437 h 6312049"/>
                <a:gd name="connsiteX2" fmla="*/ 2388865 w 7040906"/>
                <a:gd name="connsiteY2" fmla="*/ 2068437 h 6312049"/>
                <a:gd name="connsiteX3" fmla="*/ 2018751 w 7040906"/>
                <a:gd name="connsiteY3" fmla="*/ 1654780 h 6312049"/>
                <a:gd name="connsiteX4" fmla="*/ 1615980 w 7040906"/>
                <a:gd name="connsiteY4" fmla="*/ 1393522 h 6312049"/>
                <a:gd name="connsiteX5" fmla="*/ 1137008 w 7040906"/>
                <a:gd name="connsiteY5" fmla="*/ 1197580 h 6312049"/>
                <a:gd name="connsiteX6" fmla="*/ 777780 w 7040906"/>
                <a:gd name="connsiteY6" fmla="*/ 1360865 h 6312049"/>
                <a:gd name="connsiteX7" fmla="*/ 734237 w 7040906"/>
                <a:gd name="connsiteY7" fmla="*/ 1066951 h 6312049"/>
                <a:gd name="connsiteX8" fmla="*/ 1093465 w 7040906"/>
                <a:gd name="connsiteY8" fmla="*/ 1034294 h 6312049"/>
                <a:gd name="connsiteX9" fmla="*/ 1452694 w 7040906"/>
                <a:gd name="connsiteY9" fmla="*/ 1219351 h 6312049"/>
                <a:gd name="connsiteX10" fmla="*/ 1942551 w 7040906"/>
                <a:gd name="connsiteY10" fmla="*/ 1426180 h 6312049"/>
                <a:gd name="connsiteX11" fmla="*/ 2443294 w 7040906"/>
                <a:gd name="connsiteY11" fmla="*/ 1654780 h 6312049"/>
                <a:gd name="connsiteX12" fmla="*/ 3129094 w 7040906"/>
                <a:gd name="connsiteY12" fmla="*/ 1535037 h 6312049"/>
                <a:gd name="connsiteX13" fmla="*/ 2791637 w 7040906"/>
                <a:gd name="connsiteY13" fmla="*/ 1709208 h 6312049"/>
                <a:gd name="connsiteX14" fmla="*/ 3150865 w 7040906"/>
                <a:gd name="connsiteY14" fmla="*/ 1894265 h 6312049"/>
                <a:gd name="connsiteX15" fmla="*/ 3978180 w 7040906"/>
                <a:gd name="connsiteY15" fmla="*/ 1665665 h 6312049"/>
                <a:gd name="connsiteX16" fmla="*/ 4250322 w 7040906"/>
                <a:gd name="connsiteY16" fmla="*/ 1295551 h 6312049"/>
                <a:gd name="connsiteX17" fmla="*/ 3923751 w 7040906"/>
                <a:gd name="connsiteY17" fmla="*/ 1143151 h 6312049"/>
                <a:gd name="connsiteX18" fmla="*/ 4228551 w 7040906"/>
                <a:gd name="connsiteY18" fmla="*/ 1001637 h 6312049"/>
                <a:gd name="connsiteX19" fmla="*/ 4936122 w 7040906"/>
                <a:gd name="connsiteY19" fmla="*/ 718608 h 6312049"/>
                <a:gd name="connsiteX20" fmla="*/ 5371551 w 7040906"/>
                <a:gd name="connsiteY20" fmla="*/ 446465 h 6312049"/>
                <a:gd name="connsiteX21" fmla="*/ 5567494 w 7040906"/>
                <a:gd name="connsiteY21" fmla="*/ 446465 h 6312049"/>
                <a:gd name="connsiteX22" fmla="*/ 5698122 w 7040906"/>
                <a:gd name="connsiteY22" fmla="*/ 206980 h 6312049"/>
                <a:gd name="connsiteX23" fmla="*/ 5872294 w 7040906"/>
                <a:gd name="connsiteY23" fmla="*/ 392037 h 6312049"/>
                <a:gd name="connsiteX24" fmla="*/ 6242408 w 7040906"/>
                <a:gd name="connsiteY24" fmla="*/ 402922 h 6312049"/>
                <a:gd name="connsiteX25" fmla="*/ 6514551 w 7040906"/>
                <a:gd name="connsiteY25" fmla="*/ 315837 h 6312049"/>
                <a:gd name="connsiteX26" fmla="*/ 7026180 w 7040906"/>
                <a:gd name="connsiteY26" fmla="*/ 151 h 6312049"/>
                <a:gd name="connsiteX27" fmla="*/ 6906437 w 7040906"/>
                <a:gd name="connsiteY27" fmla="*/ 359380 h 6312049"/>
                <a:gd name="connsiteX28" fmla="*/ 6949980 w 7040906"/>
                <a:gd name="connsiteY28" fmla="*/ 468237 h 6312049"/>
                <a:gd name="connsiteX29" fmla="*/ 6830237 w 7040906"/>
                <a:gd name="connsiteY29" fmla="*/ 675065 h 6312049"/>
                <a:gd name="connsiteX30" fmla="*/ 6960865 w 7040906"/>
                <a:gd name="connsiteY30" fmla="*/ 1001637 h 6312049"/>
                <a:gd name="connsiteX31" fmla="*/ 6841122 w 7040906"/>
                <a:gd name="connsiteY31" fmla="*/ 1208465 h 6312049"/>
                <a:gd name="connsiteX32" fmla="*/ 6296837 w 7040906"/>
                <a:gd name="connsiteY32" fmla="*/ 1535037 h 6312049"/>
                <a:gd name="connsiteX33" fmla="*/ 6710494 w 7040906"/>
                <a:gd name="connsiteY33" fmla="*/ 1023408 h 6312049"/>
                <a:gd name="connsiteX34" fmla="*/ 6264180 w 7040906"/>
                <a:gd name="connsiteY34" fmla="*/ 1241122 h 6312049"/>
                <a:gd name="connsiteX35" fmla="*/ 6057351 w 7040906"/>
                <a:gd name="connsiteY35" fmla="*/ 1491494 h 6312049"/>
                <a:gd name="connsiteX36" fmla="*/ 5654580 w 7040906"/>
                <a:gd name="connsiteY36" fmla="*/ 1567694 h 6312049"/>
                <a:gd name="connsiteX37" fmla="*/ 5415094 w 7040906"/>
                <a:gd name="connsiteY37" fmla="*/ 1839837 h 6312049"/>
                <a:gd name="connsiteX38" fmla="*/ 4772837 w 7040906"/>
                <a:gd name="connsiteY38" fmla="*/ 2090208 h 6312049"/>
                <a:gd name="connsiteX39" fmla="*/ 4772837 w 7040906"/>
                <a:gd name="connsiteY39" fmla="*/ 2253494 h 6312049"/>
                <a:gd name="connsiteX40" fmla="*/ 4337408 w 7040906"/>
                <a:gd name="connsiteY40" fmla="*/ 2950180 h 6312049"/>
                <a:gd name="connsiteX41" fmla="*/ 4228551 w 7040906"/>
                <a:gd name="connsiteY41" fmla="*/ 2895751 h 6312049"/>
                <a:gd name="connsiteX42" fmla="*/ 4250322 w 7040906"/>
                <a:gd name="connsiteY42" fmla="*/ 2645380 h 6312049"/>
                <a:gd name="connsiteX43" fmla="*/ 3956408 w 7040906"/>
                <a:gd name="connsiteY43" fmla="*/ 3265865 h 6312049"/>
                <a:gd name="connsiteX44" fmla="*/ 3662494 w 7040906"/>
                <a:gd name="connsiteY44" fmla="*/ 3614208 h 6312049"/>
                <a:gd name="connsiteX45" fmla="*/ 3640722 w 7040906"/>
                <a:gd name="connsiteY45" fmla="*/ 3494465 h 6312049"/>
                <a:gd name="connsiteX46" fmla="*/ 3455665 w 7040906"/>
                <a:gd name="connsiteY46" fmla="*/ 4125837 h 6312049"/>
                <a:gd name="connsiteX47" fmla="*/ 2965808 w 7040906"/>
                <a:gd name="connsiteY47" fmla="*/ 4441522 h 6312049"/>
                <a:gd name="connsiteX48" fmla="*/ 2846065 w 7040906"/>
                <a:gd name="connsiteY48" fmla="*/ 4811637 h 6312049"/>
                <a:gd name="connsiteX49" fmla="*/ 2715437 w 7040906"/>
                <a:gd name="connsiteY49" fmla="*/ 5410351 h 6312049"/>
                <a:gd name="connsiteX50" fmla="*/ 2584808 w 7040906"/>
                <a:gd name="connsiteY50" fmla="*/ 5617180 h 6312049"/>
                <a:gd name="connsiteX51" fmla="*/ 2323551 w 7040906"/>
                <a:gd name="connsiteY51" fmla="*/ 5769580 h 6312049"/>
                <a:gd name="connsiteX52" fmla="*/ 2269122 w 7040906"/>
                <a:gd name="connsiteY52" fmla="*/ 5704265 h 6312049"/>
                <a:gd name="connsiteX53" fmla="*/ 2127608 w 7040906"/>
                <a:gd name="connsiteY53" fmla="*/ 6063494 h 6312049"/>
                <a:gd name="connsiteX54" fmla="*/ 2084065 w 7040906"/>
                <a:gd name="connsiteY54" fmla="*/ 6281208 h 6312049"/>
                <a:gd name="connsiteX55" fmla="*/ 1811922 w 7040906"/>
                <a:gd name="connsiteY55" fmla="*/ 6292094 h 6312049"/>
                <a:gd name="connsiteX56" fmla="*/ 1975208 w 7040906"/>
                <a:gd name="connsiteY56" fmla="*/ 6107037 h 6312049"/>
                <a:gd name="connsiteX57" fmla="*/ 2040522 w 7040906"/>
                <a:gd name="connsiteY57" fmla="*/ 5736922 h 6312049"/>
                <a:gd name="connsiteX58" fmla="*/ 2149380 w 7040906"/>
                <a:gd name="connsiteY58" fmla="*/ 5355922 h 6312049"/>
                <a:gd name="connsiteX59" fmla="*/ 2149380 w 7040906"/>
                <a:gd name="connsiteY59" fmla="*/ 5170865 h 6312049"/>
                <a:gd name="connsiteX60" fmla="*/ 1986094 w 7040906"/>
                <a:gd name="connsiteY60" fmla="*/ 5094665 h 6312049"/>
                <a:gd name="connsiteX61" fmla="*/ 1703065 w 7040906"/>
                <a:gd name="connsiteY61" fmla="*/ 5181751 h 6312049"/>
                <a:gd name="connsiteX62" fmla="*/ 1953437 w 7040906"/>
                <a:gd name="connsiteY62" fmla="*/ 4811637 h 6312049"/>
                <a:gd name="connsiteX63" fmla="*/ 1768380 w 7040906"/>
                <a:gd name="connsiteY63" fmla="*/ 4517722 h 6312049"/>
                <a:gd name="connsiteX64" fmla="*/ 1539780 w 7040906"/>
                <a:gd name="connsiteY64" fmla="*/ 4561265 h 6312049"/>
                <a:gd name="connsiteX65" fmla="*/ 1376494 w 7040906"/>
                <a:gd name="connsiteY65" fmla="*/ 4702780 h 6312049"/>
                <a:gd name="connsiteX66" fmla="*/ 1354722 w 7040906"/>
                <a:gd name="connsiteY66" fmla="*/ 4561265 h 6312049"/>
                <a:gd name="connsiteX67" fmla="*/ 1213208 w 7040906"/>
                <a:gd name="connsiteY67" fmla="*/ 4506837 h 6312049"/>
                <a:gd name="connsiteX68" fmla="*/ 1376494 w 7040906"/>
                <a:gd name="connsiteY68" fmla="*/ 4397980 h 6312049"/>
                <a:gd name="connsiteX69" fmla="*/ 1071694 w 7040906"/>
                <a:gd name="connsiteY69" fmla="*/ 4049637 h 6312049"/>
                <a:gd name="connsiteX70" fmla="*/ 875751 w 7040906"/>
                <a:gd name="connsiteY70" fmla="*/ 4038751 h 6312049"/>
                <a:gd name="connsiteX71" fmla="*/ 919294 w 7040906"/>
                <a:gd name="connsiteY71" fmla="*/ 4245580 h 6312049"/>
                <a:gd name="connsiteX72" fmla="*/ 1017265 w 7040906"/>
                <a:gd name="connsiteY72" fmla="*/ 4648351 h 6312049"/>
                <a:gd name="connsiteX73" fmla="*/ 886637 w 7040906"/>
                <a:gd name="connsiteY73" fmla="*/ 4278237 h 6312049"/>
                <a:gd name="connsiteX74" fmla="*/ 832208 w 7040906"/>
                <a:gd name="connsiteY74" fmla="*/ 4278237 h 6312049"/>
                <a:gd name="connsiteX75" fmla="*/ 756008 w 7040906"/>
                <a:gd name="connsiteY75" fmla="*/ 3886351 h 6312049"/>
                <a:gd name="connsiteX76" fmla="*/ 157294 w 7040906"/>
                <a:gd name="connsiteY76" fmla="*/ 3864580 h 6312049"/>
                <a:gd name="connsiteX77" fmla="*/ 37551 w 7040906"/>
                <a:gd name="connsiteY77" fmla="*/ 3919008 h 6312049"/>
                <a:gd name="connsiteX78" fmla="*/ 15780 w 7040906"/>
                <a:gd name="connsiteY78" fmla="*/ 3788380 h 6312049"/>
                <a:gd name="connsiteX79" fmla="*/ 255265 w 7040906"/>
                <a:gd name="connsiteY79" fmla="*/ 3723065 h 6312049"/>
                <a:gd name="connsiteX80" fmla="*/ 603608 w 7040906"/>
                <a:gd name="connsiteY80" fmla="*/ 3265865 h 6312049"/>
                <a:gd name="connsiteX81" fmla="*/ 723351 w 7040906"/>
                <a:gd name="connsiteY81" fmla="*/ 3363837 h 6312049"/>
                <a:gd name="connsiteX82" fmla="*/ 745122 w 7040906"/>
                <a:gd name="connsiteY82" fmla="*/ 3157008 h 6312049"/>
                <a:gd name="connsiteX83" fmla="*/ 570951 w 7040906"/>
                <a:gd name="connsiteY83" fmla="*/ 3037265 h 6312049"/>
                <a:gd name="connsiteX84" fmla="*/ 570951 w 7040906"/>
                <a:gd name="connsiteY84" fmla="*/ 2580065 h 6312049"/>
                <a:gd name="connsiteX85" fmla="*/ 396780 w 7040906"/>
                <a:gd name="connsiteY85" fmla="*/ 2373237 h 6312049"/>
                <a:gd name="connsiteX86" fmla="*/ 320580 w 7040906"/>
                <a:gd name="connsiteY86" fmla="*/ 2286151 h 6312049"/>
                <a:gd name="connsiteX87" fmla="*/ 233494 w 7040906"/>
                <a:gd name="connsiteY87" fmla="*/ 2384122 h 6312049"/>
                <a:gd name="connsiteX88" fmla="*/ 233494 w 7040906"/>
                <a:gd name="connsiteY88" fmla="*/ 2220837 h 6312049"/>
                <a:gd name="connsiteX89" fmla="*/ 320580 w 7040906"/>
                <a:gd name="connsiteY89" fmla="*/ 1992237 h 6312049"/>
                <a:gd name="connsiteX90" fmla="*/ 570951 w 7040906"/>
                <a:gd name="connsiteY90" fmla="*/ 2144637 h 6312049"/>
                <a:gd name="connsiteX91" fmla="*/ 462094 w 7040906"/>
                <a:gd name="connsiteY91" fmla="*/ 2297037 h 6312049"/>
                <a:gd name="connsiteX92" fmla="*/ 679808 w 7040906"/>
                <a:gd name="connsiteY92" fmla="*/ 2623608 h 6312049"/>
                <a:gd name="connsiteX93" fmla="*/ 788665 w 7040906"/>
                <a:gd name="connsiteY93" fmla="*/ 3015494 h 6312049"/>
                <a:gd name="connsiteX94" fmla="*/ 1256751 w 7040906"/>
                <a:gd name="connsiteY94" fmla="*/ 3189665 h 6312049"/>
                <a:gd name="connsiteX95" fmla="*/ 1234980 w 7040906"/>
                <a:gd name="connsiteY95" fmla="*/ 2950180 h 6312049"/>
                <a:gd name="connsiteX96" fmla="*/ 1801037 w 7040906"/>
                <a:gd name="connsiteY96" fmla="*/ 2884865 h 6312049"/>
                <a:gd name="connsiteX97" fmla="*/ 2094951 w 7040906"/>
                <a:gd name="connsiteY97" fmla="*/ 2939294 h 6312049"/>
                <a:gd name="connsiteX98" fmla="*/ 2388865 w 7040906"/>
                <a:gd name="connsiteY98" fmla="*/ 2776008 h 63120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</a:cxnLst>
              <a:rect l="l" t="t" r="r" b="b"/>
              <a:pathLst>
                <a:path w="7040906" h="6312049">
                  <a:moveTo>
                    <a:pt x="2388865" y="2776008"/>
                  </a:moveTo>
                  <a:cubicBezTo>
                    <a:pt x="2457808" y="2694365"/>
                    <a:pt x="2508608" y="2567365"/>
                    <a:pt x="2508608" y="2449437"/>
                  </a:cubicBezTo>
                  <a:cubicBezTo>
                    <a:pt x="2508608" y="2331509"/>
                    <a:pt x="2470508" y="2200880"/>
                    <a:pt x="2388865" y="2068437"/>
                  </a:cubicBezTo>
                  <a:cubicBezTo>
                    <a:pt x="2307222" y="1935994"/>
                    <a:pt x="2147565" y="1767266"/>
                    <a:pt x="2018751" y="1654780"/>
                  </a:cubicBezTo>
                  <a:cubicBezTo>
                    <a:pt x="1889937" y="1542294"/>
                    <a:pt x="1762937" y="1469722"/>
                    <a:pt x="1615980" y="1393522"/>
                  </a:cubicBezTo>
                  <a:cubicBezTo>
                    <a:pt x="1469023" y="1317322"/>
                    <a:pt x="1276708" y="1203023"/>
                    <a:pt x="1137008" y="1197580"/>
                  </a:cubicBezTo>
                  <a:cubicBezTo>
                    <a:pt x="997308" y="1192137"/>
                    <a:pt x="844908" y="1382636"/>
                    <a:pt x="777780" y="1360865"/>
                  </a:cubicBezTo>
                  <a:cubicBezTo>
                    <a:pt x="710652" y="1339094"/>
                    <a:pt x="681623" y="1121379"/>
                    <a:pt x="734237" y="1066951"/>
                  </a:cubicBezTo>
                  <a:cubicBezTo>
                    <a:pt x="786851" y="1012523"/>
                    <a:pt x="973722" y="1008894"/>
                    <a:pt x="1093465" y="1034294"/>
                  </a:cubicBezTo>
                  <a:cubicBezTo>
                    <a:pt x="1213208" y="1059694"/>
                    <a:pt x="1311180" y="1154037"/>
                    <a:pt x="1452694" y="1219351"/>
                  </a:cubicBezTo>
                  <a:cubicBezTo>
                    <a:pt x="1594208" y="1284665"/>
                    <a:pt x="1777451" y="1353608"/>
                    <a:pt x="1942551" y="1426180"/>
                  </a:cubicBezTo>
                  <a:cubicBezTo>
                    <a:pt x="2107651" y="1498751"/>
                    <a:pt x="2245537" y="1636637"/>
                    <a:pt x="2443294" y="1654780"/>
                  </a:cubicBezTo>
                  <a:cubicBezTo>
                    <a:pt x="2641051" y="1672923"/>
                    <a:pt x="3071037" y="1525966"/>
                    <a:pt x="3129094" y="1535037"/>
                  </a:cubicBezTo>
                  <a:cubicBezTo>
                    <a:pt x="3187151" y="1544108"/>
                    <a:pt x="2788009" y="1649337"/>
                    <a:pt x="2791637" y="1709208"/>
                  </a:cubicBezTo>
                  <a:cubicBezTo>
                    <a:pt x="2795265" y="1769079"/>
                    <a:pt x="2953108" y="1901522"/>
                    <a:pt x="3150865" y="1894265"/>
                  </a:cubicBezTo>
                  <a:cubicBezTo>
                    <a:pt x="3348622" y="1887008"/>
                    <a:pt x="3794937" y="1765451"/>
                    <a:pt x="3978180" y="1665665"/>
                  </a:cubicBezTo>
                  <a:cubicBezTo>
                    <a:pt x="4161423" y="1565879"/>
                    <a:pt x="4259393" y="1382637"/>
                    <a:pt x="4250322" y="1295551"/>
                  </a:cubicBezTo>
                  <a:cubicBezTo>
                    <a:pt x="4241251" y="1208465"/>
                    <a:pt x="3927380" y="1192137"/>
                    <a:pt x="3923751" y="1143151"/>
                  </a:cubicBezTo>
                  <a:cubicBezTo>
                    <a:pt x="3920123" y="1094165"/>
                    <a:pt x="4059823" y="1072394"/>
                    <a:pt x="4228551" y="1001637"/>
                  </a:cubicBezTo>
                  <a:cubicBezTo>
                    <a:pt x="4397279" y="930880"/>
                    <a:pt x="4745622" y="811137"/>
                    <a:pt x="4936122" y="718608"/>
                  </a:cubicBezTo>
                  <a:cubicBezTo>
                    <a:pt x="5126622" y="626079"/>
                    <a:pt x="5266322" y="491822"/>
                    <a:pt x="5371551" y="446465"/>
                  </a:cubicBezTo>
                  <a:cubicBezTo>
                    <a:pt x="5476780" y="401108"/>
                    <a:pt x="5513066" y="486379"/>
                    <a:pt x="5567494" y="446465"/>
                  </a:cubicBezTo>
                  <a:cubicBezTo>
                    <a:pt x="5621922" y="406551"/>
                    <a:pt x="5647322" y="216051"/>
                    <a:pt x="5698122" y="206980"/>
                  </a:cubicBezTo>
                  <a:cubicBezTo>
                    <a:pt x="5748922" y="197909"/>
                    <a:pt x="5781580" y="359380"/>
                    <a:pt x="5872294" y="392037"/>
                  </a:cubicBezTo>
                  <a:cubicBezTo>
                    <a:pt x="5963008" y="424694"/>
                    <a:pt x="6135365" y="415622"/>
                    <a:pt x="6242408" y="402922"/>
                  </a:cubicBezTo>
                  <a:cubicBezTo>
                    <a:pt x="6349451" y="390222"/>
                    <a:pt x="6383922" y="382965"/>
                    <a:pt x="6514551" y="315837"/>
                  </a:cubicBezTo>
                  <a:cubicBezTo>
                    <a:pt x="6645180" y="248709"/>
                    <a:pt x="6960866" y="-7106"/>
                    <a:pt x="7026180" y="151"/>
                  </a:cubicBezTo>
                  <a:cubicBezTo>
                    <a:pt x="7091494" y="7408"/>
                    <a:pt x="6919137" y="281366"/>
                    <a:pt x="6906437" y="359380"/>
                  </a:cubicBezTo>
                  <a:cubicBezTo>
                    <a:pt x="6893737" y="437394"/>
                    <a:pt x="6962680" y="415623"/>
                    <a:pt x="6949980" y="468237"/>
                  </a:cubicBezTo>
                  <a:cubicBezTo>
                    <a:pt x="6937280" y="520851"/>
                    <a:pt x="6828423" y="586165"/>
                    <a:pt x="6830237" y="675065"/>
                  </a:cubicBezTo>
                  <a:cubicBezTo>
                    <a:pt x="6832051" y="763965"/>
                    <a:pt x="6959051" y="912737"/>
                    <a:pt x="6960865" y="1001637"/>
                  </a:cubicBezTo>
                  <a:cubicBezTo>
                    <a:pt x="6962679" y="1090537"/>
                    <a:pt x="6951793" y="1119565"/>
                    <a:pt x="6841122" y="1208465"/>
                  </a:cubicBezTo>
                  <a:cubicBezTo>
                    <a:pt x="6730451" y="1297365"/>
                    <a:pt x="6318608" y="1565880"/>
                    <a:pt x="6296837" y="1535037"/>
                  </a:cubicBezTo>
                  <a:cubicBezTo>
                    <a:pt x="6275066" y="1504194"/>
                    <a:pt x="6715937" y="1072394"/>
                    <a:pt x="6710494" y="1023408"/>
                  </a:cubicBezTo>
                  <a:cubicBezTo>
                    <a:pt x="6705051" y="974422"/>
                    <a:pt x="6373037" y="1163108"/>
                    <a:pt x="6264180" y="1241122"/>
                  </a:cubicBezTo>
                  <a:cubicBezTo>
                    <a:pt x="6155323" y="1319136"/>
                    <a:pt x="6158951" y="1437065"/>
                    <a:pt x="6057351" y="1491494"/>
                  </a:cubicBezTo>
                  <a:cubicBezTo>
                    <a:pt x="5955751" y="1545923"/>
                    <a:pt x="5761623" y="1509637"/>
                    <a:pt x="5654580" y="1567694"/>
                  </a:cubicBezTo>
                  <a:cubicBezTo>
                    <a:pt x="5547537" y="1625751"/>
                    <a:pt x="5562051" y="1752751"/>
                    <a:pt x="5415094" y="1839837"/>
                  </a:cubicBezTo>
                  <a:cubicBezTo>
                    <a:pt x="5268137" y="1926923"/>
                    <a:pt x="4879880" y="2021265"/>
                    <a:pt x="4772837" y="2090208"/>
                  </a:cubicBezTo>
                  <a:cubicBezTo>
                    <a:pt x="4665794" y="2159151"/>
                    <a:pt x="4845408" y="2110165"/>
                    <a:pt x="4772837" y="2253494"/>
                  </a:cubicBezTo>
                  <a:cubicBezTo>
                    <a:pt x="4700266" y="2396823"/>
                    <a:pt x="4428122" y="2843137"/>
                    <a:pt x="4337408" y="2950180"/>
                  </a:cubicBezTo>
                  <a:cubicBezTo>
                    <a:pt x="4246694" y="3057223"/>
                    <a:pt x="4243065" y="2946551"/>
                    <a:pt x="4228551" y="2895751"/>
                  </a:cubicBezTo>
                  <a:cubicBezTo>
                    <a:pt x="4214037" y="2844951"/>
                    <a:pt x="4295679" y="2583694"/>
                    <a:pt x="4250322" y="2645380"/>
                  </a:cubicBezTo>
                  <a:cubicBezTo>
                    <a:pt x="4204965" y="2707066"/>
                    <a:pt x="4054379" y="3104394"/>
                    <a:pt x="3956408" y="3265865"/>
                  </a:cubicBezTo>
                  <a:cubicBezTo>
                    <a:pt x="3858437" y="3427336"/>
                    <a:pt x="3715108" y="3576108"/>
                    <a:pt x="3662494" y="3614208"/>
                  </a:cubicBezTo>
                  <a:cubicBezTo>
                    <a:pt x="3609880" y="3652308"/>
                    <a:pt x="3675194" y="3409194"/>
                    <a:pt x="3640722" y="3494465"/>
                  </a:cubicBezTo>
                  <a:cubicBezTo>
                    <a:pt x="3606251" y="3579737"/>
                    <a:pt x="3568151" y="3967994"/>
                    <a:pt x="3455665" y="4125837"/>
                  </a:cubicBezTo>
                  <a:cubicBezTo>
                    <a:pt x="3343179" y="4283680"/>
                    <a:pt x="3067408" y="4327222"/>
                    <a:pt x="2965808" y="4441522"/>
                  </a:cubicBezTo>
                  <a:cubicBezTo>
                    <a:pt x="2864208" y="4555822"/>
                    <a:pt x="2887793" y="4650166"/>
                    <a:pt x="2846065" y="4811637"/>
                  </a:cubicBezTo>
                  <a:cubicBezTo>
                    <a:pt x="2804337" y="4973108"/>
                    <a:pt x="2758980" y="5276094"/>
                    <a:pt x="2715437" y="5410351"/>
                  </a:cubicBezTo>
                  <a:cubicBezTo>
                    <a:pt x="2671894" y="5544608"/>
                    <a:pt x="2650122" y="5557309"/>
                    <a:pt x="2584808" y="5617180"/>
                  </a:cubicBezTo>
                  <a:cubicBezTo>
                    <a:pt x="2519494" y="5677051"/>
                    <a:pt x="2376165" y="5755066"/>
                    <a:pt x="2323551" y="5769580"/>
                  </a:cubicBezTo>
                  <a:cubicBezTo>
                    <a:pt x="2270937" y="5784094"/>
                    <a:pt x="2301779" y="5655279"/>
                    <a:pt x="2269122" y="5704265"/>
                  </a:cubicBezTo>
                  <a:cubicBezTo>
                    <a:pt x="2236465" y="5753251"/>
                    <a:pt x="2158451" y="5967337"/>
                    <a:pt x="2127608" y="6063494"/>
                  </a:cubicBezTo>
                  <a:cubicBezTo>
                    <a:pt x="2096765" y="6159651"/>
                    <a:pt x="2136679" y="6243108"/>
                    <a:pt x="2084065" y="6281208"/>
                  </a:cubicBezTo>
                  <a:cubicBezTo>
                    <a:pt x="2031451" y="6319308"/>
                    <a:pt x="1830065" y="6321122"/>
                    <a:pt x="1811922" y="6292094"/>
                  </a:cubicBezTo>
                  <a:cubicBezTo>
                    <a:pt x="1793779" y="6263066"/>
                    <a:pt x="1937108" y="6199566"/>
                    <a:pt x="1975208" y="6107037"/>
                  </a:cubicBezTo>
                  <a:cubicBezTo>
                    <a:pt x="2013308" y="6014508"/>
                    <a:pt x="2011493" y="5862108"/>
                    <a:pt x="2040522" y="5736922"/>
                  </a:cubicBezTo>
                  <a:cubicBezTo>
                    <a:pt x="2069551" y="5611736"/>
                    <a:pt x="2131237" y="5450265"/>
                    <a:pt x="2149380" y="5355922"/>
                  </a:cubicBezTo>
                  <a:cubicBezTo>
                    <a:pt x="2167523" y="5261579"/>
                    <a:pt x="2176594" y="5214408"/>
                    <a:pt x="2149380" y="5170865"/>
                  </a:cubicBezTo>
                  <a:cubicBezTo>
                    <a:pt x="2122166" y="5127322"/>
                    <a:pt x="2060480" y="5092851"/>
                    <a:pt x="1986094" y="5094665"/>
                  </a:cubicBezTo>
                  <a:cubicBezTo>
                    <a:pt x="1911708" y="5096479"/>
                    <a:pt x="1708508" y="5228922"/>
                    <a:pt x="1703065" y="5181751"/>
                  </a:cubicBezTo>
                  <a:cubicBezTo>
                    <a:pt x="1697622" y="5134580"/>
                    <a:pt x="1942551" y="4922309"/>
                    <a:pt x="1953437" y="4811637"/>
                  </a:cubicBezTo>
                  <a:cubicBezTo>
                    <a:pt x="1964323" y="4700966"/>
                    <a:pt x="1837323" y="4559451"/>
                    <a:pt x="1768380" y="4517722"/>
                  </a:cubicBezTo>
                  <a:cubicBezTo>
                    <a:pt x="1699437" y="4475993"/>
                    <a:pt x="1605094" y="4530422"/>
                    <a:pt x="1539780" y="4561265"/>
                  </a:cubicBezTo>
                  <a:cubicBezTo>
                    <a:pt x="1474466" y="4592108"/>
                    <a:pt x="1407337" y="4702780"/>
                    <a:pt x="1376494" y="4702780"/>
                  </a:cubicBezTo>
                  <a:cubicBezTo>
                    <a:pt x="1345651" y="4702780"/>
                    <a:pt x="1381936" y="4593922"/>
                    <a:pt x="1354722" y="4561265"/>
                  </a:cubicBezTo>
                  <a:cubicBezTo>
                    <a:pt x="1327508" y="4528608"/>
                    <a:pt x="1209579" y="4534051"/>
                    <a:pt x="1213208" y="4506837"/>
                  </a:cubicBezTo>
                  <a:cubicBezTo>
                    <a:pt x="1216837" y="4479623"/>
                    <a:pt x="1400080" y="4474180"/>
                    <a:pt x="1376494" y="4397980"/>
                  </a:cubicBezTo>
                  <a:cubicBezTo>
                    <a:pt x="1352908" y="4321780"/>
                    <a:pt x="1155151" y="4109509"/>
                    <a:pt x="1071694" y="4049637"/>
                  </a:cubicBezTo>
                  <a:cubicBezTo>
                    <a:pt x="988237" y="3989766"/>
                    <a:pt x="901151" y="4006094"/>
                    <a:pt x="875751" y="4038751"/>
                  </a:cubicBezTo>
                  <a:cubicBezTo>
                    <a:pt x="850351" y="4071408"/>
                    <a:pt x="895708" y="4143980"/>
                    <a:pt x="919294" y="4245580"/>
                  </a:cubicBezTo>
                  <a:cubicBezTo>
                    <a:pt x="942880" y="4347180"/>
                    <a:pt x="1022708" y="4642908"/>
                    <a:pt x="1017265" y="4648351"/>
                  </a:cubicBezTo>
                  <a:cubicBezTo>
                    <a:pt x="1011822" y="4653794"/>
                    <a:pt x="917480" y="4339923"/>
                    <a:pt x="886637" y="4278237"/>
                  </a:cubicBezTo>
                  <a:cubicBezTo>
                    <a:pt x="855794" y="4216551"/>
                    <a:pt x="853979" y="4343551"/>
                    <a:pt x="832208" y="4278237"/>
                  </a:cubicBezTo>
                  <a:cubicBezTo>
                    <a:pt x="810437" y="4212923"/>
                    <a:pt x="868494" y="3955294"/>
                    <a:pt x="756008" y="3886351"/>
                  </a:cubicBezTo>
                  <a:cubicBezTo>
                    <a:pt x="643522" y="3817408"/>
                    <a:pt x="277037" y="3859137"/>
                    <a:pt x="157294" y="3864580"/>
                  </a:cubicBezTo>
                  <a:cubicBezTo>
                    <a:pt x="37551" y="3870023"/>
                    <a:pt x="61137" y="3931708"/>
                    <a:pt x="37551" y="3919008"/>
                  </a:cubicBezTo>
                  <a:cubicBezTo>
                    <a:pt x="13965" y="3906308"/>
                    <a:pt x="-20506" y="3821037"/>
                    <a:pt x="15780" y="3788380"/>
                  </a:cubicBezTo>
                  <a:cubicBezTo>
                    <a:pt x="52066" y="3755723"/>
                    <a:pt x="157294" y="3810151"/>
                    <a:pt x="255265" y="3723065"/>
                  </a:cubicBezTo>
                  <a:cubicBezTo>
                    <a:pt x="353236" y="3635979"/>
                    <a:pt x="525594" y="3325736"/>
                    <a:pt x="603608" y="3265865"/>
                  </a:cubicBezTo>
                  <a:cubicBezTo>
                    <a:pt x="681622" y="3205994"/>
                    <a:pt x="699765" y="3381980"/>
                    <a:pt x="723351" y="3363837"/>
                  </a:cubicBezTo>
                  <a:cubicBezTo>
                    <a:pt x="746937" y="3345694"/>
                    <a:pt x="770522" y="3211437"/>
                    <a:pt x="745122" y="3157008"/>
                  </a:cubicBezTo>
                  <a:cubicBezTo>
                    <a:pt x="719722" y="3102579"/>
                    <a:pt x="599979" y="3133422"/>
                    <a:pt x="570951" y="3037265"/>
                  </a:cubicBezTo>
                  <a:cubicBezTo>
                    <a:pt x="541922" y="2941108"/>
                    <a:pt x="599979" y="2690736"/>
                    <a:pt x="570951" y="2580065"/>
                  </a:cubicBezTo>
                  <a:cubicBezTo>
                    <a:pt x="541922" y="2469394"/>
                    <a:pt x="438508" y="2422223"/>
                    <a:pt x="396780" y="2373237"/>
                  </a:cubicBezTo>
                  <a:cubicBezTo>
                    <a:pt x="355052" y="2324251"/>
                    <a:pt x="347794" y="2284337"/>
                    <a:pt x="320580" y="2286151"/>
                  </a:cubicBezTo>
                  <a:cubicBezTo>
                    <a:pt x="293366" y="2287965"/>
                    <a:pt x="248008" y="2395008"/>
                    <a:pt x="233494" y="2384122"/>
                  </a:cubicBezTo>
                  <a:cubicBezTo>
                    <a:pt x="218980" y="2373236"/>
                    <a:pt x="218980" y="2286151"/>
                    <a:pt x="233494" y="2220837"/>
                  </a:cubicBezTo>
                  <a:cubicBezTo>
                    <a:pt x="248008" y="2155523"/>
                    <a:pt x="264337" y="2004937"/>
                    <a:pt x="320580" y="1992237"/>
                  </a:cubicBezTo>
                  <a:cubicBezTo>
                    <a:pt x="376823" y="1979537"/>
                    <a:pt x="547365" y="2093837"/>
                    <a:pt x="570951" y="2144637"/>
                  </a:cubicBezTo>
                  <a:cubicBezTo>
                    <a:pt x="594537" y="2195437"/>
                    <a:pt x="443951" y="2217209"/>
                    <a:pt x="462094" y="2297037"/>
                  </a:cubicBezTo>
                  <a:cubicBezTo>
                    <a:pt x="480237" y="2376865"/>
                    <a:pt x="625380" y="2503865"/>
                    <a:pt x="679808" y="2623608"/>
                  </a:cubicBezTo>
                  <a:cubicBezTo>
                    <a:pt x="734236" y="2743351"/>
                    <a:pt x="692508" y="2921151"/>
                    <a:pt x="788665" y="3015494"/>
                  </a:cubicBezTo>
                  <a:cubicBezTo>
                    <a:pt x="884822" y="3109837"/>
                    <a:pt x="1182365" y="3200551"/>
                    <a:pt x="1256751" y="3189665"/>
                  </a:cubicBezTo>
                  <a:cubicBezTo>
                    <a:pt x="1331137" y="3178779"/>
                    <a:pt x="1144266" y="3000980"/>
                    <a:pt x="1234980" y="2950180"/>
                  </a:cubicBezTo>
                  <a:cubicBezTo>
                    <a:pt x="1325694" y="2899380"/>
                    <a:pt x="1657709" y="2886679"/>
                    <a:pt x="1801037" y="2884865"/>
                  </a:cubicBezTo>
                  <a:cubicBezTo>
                    <a:pt x="1944365" y="2883051"/>
                    <a:pt x="1996980" y="2962880"/>
                    <a:pt x="2094951" y="2939294"/>
                  </a:cubicBezTo>
                  <a:cubicBezTo>
                    <a:pt x="2192922" y="2915708"/>
                    <a:pt x="2319922" y="2857651"/>
                    <a:pt x="2388865" y="2776008"/>
                  </a:cubicBez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0" name="Line 281">
              <a:extLst>
                <a:ext uri="{FF2B5EF4-FFF2-40B4-BE49-F238E27FC236}">
                  <a16:creationId xmlns:a16="http://schemas.microsoft.com/office/drawing/2014/main" id="{6FD6AF9C-148B-2FBB-493E-A98C1C6B17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4339" y="3344066"/>
              <a:ext cx="149225" cy="113506"/>
            </a:xfrm>
            <a:prstGeom prst="line">
              <a:avLst/>
            </a:prstGeom>
            <a:noFill/>
            <a:ln w="7938" cap="rnd">
              <a:solidFill>
                <a:srgbClr val="23202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51" name="Rectangle 282">
              <a:extLst>
                <a:ext uri="{FF2B5EF4-FFF2-40B4-BE49-F238E27FC236}">
                  <a16:creationId xmlns:a16="http://schemas.microsoft.com/office/drawing/2014/main" id="{8FDB1F4B-DF7E-BFEC-5BE4-431A26EC58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2307" y="3079039"/>
              <a:ext cx="48250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i="1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Kaapvaal</a:t>
              </a:r>
              <a:endParaRPr kumimoji="0" lang="de-DE" altLang="de-DE" sz="1000" i="1" u="none" strike="noStrike" cap="none" normalizeH="0" baseline="0" dirty="0">
                <a:ln>
                  <a:noFill/>
                </a:ln>
                <a:solidFill>
                  <a:srgbClr val="232021"/>
                </a:solidFill>
                <a:effectLst/>
                <a:latin typeface="+mn-lt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1000" i="1" dirty="0" err="1">
                  <a:solidFill>
                    <a:srgbClr val="232021"/>
                  </a:solidFill>
                  <a:latin typeface="+mn-lt"/>
                </a:rPr>
                <a:t>Craton</a:t>
              </a:r>
              <a:endParaRPr kumimoji="0" lang="de-DE" altLang="de-DE" sz="18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sp>
        <p:nvSpPr>
          <p:cNvPr id="152" name="Textfeld 45">
            <a:extLst>
              <a:ext uri="{FF2B5EF4-FFF2-40B4-BE49-F238E27FC236}">
                <a16:creationId xmlns:a16="http://schemas.microsoft.com/office/drawing/2014/main" id="{E0A72EE8-6DBB-94E8-0A63-1A7E10EA58A7}"/>
              </a:ext>
            </a:extLst>
          </p:cNvPr>
          <p:cNvSpPr txBox="1">
            <a:spLocks noChangeArrowheads="1"/>
          </p:cNvSpPr>
          <p:nvPr/>
        </p:nvSpPr>
        <p:spPr bwMode="auto">
          <a:xfrm rot="19712759">
            <a:off x="2437936" y="4123563"/>
            <a:ext cx="104116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de-DE" sz="1000" i="1" dirty="0" err="1">
                <a:latin typeface="Calibri" pitchFamily="34" charset="0"/>
              </a:rPr>
              <a:t>Onverwacht</a:t>
            </a:r>
            <a:r>
              <a:rPr lang="de-DE" sz="1000" i="1" dirty="0">
                <a:latin typeface="Calibri" pitchFamily="34" charset="0"/>
              </a:rPr>
              <a:t> </a:t>
            </a:r>
            <a:r>
              <a:rPr lang="de-DE" sz="1000" i="1" dirty="0" err="1">
                <a:latin typeface="Calibri" pitchFamily="34" charset="0"/>
              </a:rPr>
              <a:t>Anticline</a:t>
            </a:r>
            <a:endParaRPr lang="de-DE" sz="1000" i="1" dirty="0">
              <a:latin typeface="Calibri" pitchFamily="34" charset="0"/>
            </a:endParaRPr>
          </a:p>
        </p:txBody>
      </p:sp>
      <p:sp>
        <p:nvSpPr>
          <p:cNvPr id="153" name="Textfeld 44">
            <a:extLst>
              <a:ext uri="{FF2B5EF4-FFF2-40B4-BE49-F238E27FC236}">
                <a16:creationId xmlns:a16="http://schemas.microsoft.com/office/drawing/2014/main" id="{0EAAF721-E12F-4D1B-66C2-A26FB33C92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3220" y="1557569"/>
            <a:ext cx="728788" cy="600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de-DE" sz="1100" i="1" dirty="0">
                <a:latin typeface="Calibri" pitchFamily="34" charset="0"/>
              </a:rPr>
              <a:t>Eureka </a:t>
            </a:r>
            <a:r>
              <a:rPr lang="de-DE" sz="1100" i="1" dirty="0" err="1">
                <a:latin typeface="Calibri" pitchFamily="34" charset="0"/>
              </a:rPr>
              <a:t>Syncline</a:t>
            </a:r>
            <a:endParaRPr lang="de-DE" sz="1100" i="1" dirty="0">
              <a:latin typeface="Calibri" pitchFamily="34" charset="0"/>
            </a:endParaRPr>
          </a:p>
          <a:p>
            <a:pPr eaLnBrk="1" hangingPunct="1"/>
            <a:r>
              <a:rPr lang="de-DE" sz="1100" i="1" dirty="0">
                <a:latin typeface="Calibri" pitchFamily="34" charset="0"/>
              </a:rPr>
              <a:t> </a:t>
            </a:r>
          </a:p>
        </p:txBody>
      </p:sp>
      <p:grpSp>
        <p:nvGrpSpPr>
          <p:cNvPr id="154" name="Gruppieren 153">
            <a:extLst>
              <a:ext uri="{FF2B5EF4-FFF2-40B4-BE49-F238E27FC236}">
                <a16:creationId xmlns:a16="http://schemas.microsoft.com/office/drawing/2014/main" id="{3058CF8F-F23C-D487-10A9-D19DC89EA984}"/>
              </a:ext>
            </a:extLst>
          </p:cNvPr>
          <p:cNvGrpSpPr/>
          <p:nvPr/>
        </p:nvGrpSpPr>
        <p:grpSpPr>
          <a:xfrm>
            <a:off x="4639680" y="4246509"/>
            <a:ext cx="1893185" cy="1879561"/>
            <a:chOff x="4640879" y="3931333"/>
            <a:chExt cx="1951737" cy="1937692"/>
          </a:xfrm>
        </p:grpSpPr>
        <p:cxnSp>
          <p:nvCxnSpPr>
            <p:cNvPr id="155" name="Gerader Verbinder 154">
              <a:extLst>
                <a:ext uri="{FF2B5EF4-FFF2-40B4-BE49-F238E27FC236}">
                  <a16:creationId xmlns:a16="http://schemas.microsoft.com/office/drawing/2014/main" id="{F1A8FA1F-5731-88CB-56CB-11CDDBB1569C}"/>
                </a:ext>
              </a:extLst>
            </p:cNvPr>
            <p:cNvCxnSpPr/>
            <p:nvPr/>
          </p:nvCxnSpPr>
          <p:spPr>
            <a:xfrm rot="5400000">
              <a:off x="5415917" y="4845174"/>
              <a:ext cx="12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feld 155">
              <a:extLst>
                <a:ext uri="{FF2B5EF4-FFF2-40B4-BE49-F238E27FC236}">
                  <a16:creationId xmlns:a16="http://schemas.microsoft.com/office/drawing/2014/main" id="{F8964911-0442-AB0C-A42C-9E666D9B0EED}"/>
                </a:ext>
              </a:extLst>
            </p:cNvPr>
            <p:cNvSpPr txBox="1"/>
            <p:nvPr/>
          </p:nvSpPr>
          <p:spPr>
            <a:xfrm>
              <a:off x="4700243" y="5622804"/>
              <a:ext cx="9252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Conglomerate</a:t>
              </a:r>
              <a:endParaRPr lang="de-DE" sz="1000" dirty="0"/>
            </a:p>
          </p:txBody>
        </p:sp>
        <p:sp>
          <p:nvSpPr>
            <p:cNvPr id="157" name="Textfeld 156">
              <a:extLst>
                <a:ext uri="{FF2B5EF4-FFF2-40B4-BE49-F238E27FC236}">
                  <a16:creationId xmlns:a16="http://schemas.microsoft.com/office/drawing/2014/main" id="{8B165160-6427-B412-6BD0-45A5FB99DF6F}"/>
                </a:ext>
              </a:extLst>
            </p:cNvPr>
            <p:cNvSpPr txBox="1"/>
            <p:nvPr/>
          </p:nvSpPr>
          <p:spPr>
            <a:xfrm>
              <a:off x="4795404" y="5442236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Gravelly</a:t>
              </a:r>
              <a:endParaRPr lang="de-DE" sz="1000" dirty="0"/>
            </a:p>
          </p:txBody>
        </p:sp>
        <p:sp>
          <p:nvSpPr>
            <p:cNvPr id="158" name="Textfeld 157">
              <a:extLst>
                <a:ext uri="{FF2B5EF4-FFF2-40B4-BE49-F238E27FC236}">
                  <a16:creationId xmlns:a16="http://schemas.microsoft.com/office/drawing/2014/main" id="{EF6A536D-1EC1-1AFC-9D82-B5E3DE6257F9}"/>
                </a:ext>
              </a:extLst>
            </p:cNvPr>
            <p:cNvSpPr txBox="1"/>
            <p:nvPr/>
          </p:nvSpPr>
          <p:spPr>
            <a:xfrm>
              <a:off x="4724235" y="5212458"/>
              <a:ext cx="5790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Coarse</a:t>
              </a:r>
              <a:r>
                <a:rPr lang="de-DE" sz="1000" dirty="0"/>
                <a:t>-</a:t>
              </a:r>
            </a:p>
          </p:txBody>
        </p:sp>
        <p:sp>
          <p:nvSpPr>
            <p:cNvPr id="159" name="Textfeld 158">
              <a:extLst>
                <a:ext uri="{FF2B5EF4-FFF2-40B4-BE49-F238E27FC236}">
                  <a16:creationId xmlns:a16="http://schemas.microsoft.com/office/drawing/2014/main" id="{6F92D77B-4E6D-A31D-799E-50D9935E536C}"/>
                </a:ext>
              </a:extLst>
            </p:cNvPr>
            <p:cNvSpPr txBox="1"/>
            <p:nvPr/>
          </p:nvSpPr>
          <p:spPr>
            <a:xfrm>
              <a:off x="4640879" y="4960248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/>
                <a:t>Medium-</a:t>
              </a:r>
              <a:endParaRPr lang="de-DE" sz="800" dirty="0"/>
            </a:p>
          </p:txBody>
        </p:sp>
        <p:sp>
          <p:nvSpPr>
            <p:cNvPr id="160" name="Textfeld 159">
              <a:extLst>
                <a:ext uri="{FF2B5EF4-FFF2-40B4-BE49-F238E27FC236}">
                  <a16:creationId xmlns:a16="http://schemas.microsoft.com/office/drawing/2014/main" id="{43D90CE7-C421-CEFD-B75C-5978826491D6}"/>
                </a:ext>
              </a:extLst>
            </p:cNvPr>
            <p:cNvSpPr txBox="1"/>
            <p:nvPr/>
          </p:nvSpPr>
          <p:spPr>
            <a:xfrm>
              <a:off x="4860491" y="4738375"/>
              <a:ext cx="4427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/>
                <a:t>Fine-</a:t>
              </a:r>
            </a:p>
          </p:txBody>
        </p:sp>
        <p:sp>
          <p:nvSpPr>
            <p:cNvPr id="161" name="Textfeld 160">
              <a:extLst>
                <a:ext uri="{FF2B5EF4-FFF2-40B4-BE49-F238E27FC236}">
                  <a16:creationId xmlns:a16="http://schemas.microsoft.com/office/drawing/2014/main" id="{ECADF9FB-FCA6-F966-B8C7-F7519FCFB6F2}"/>
                </a:ext>
              </a:extLst>
            </p:cNvPr>
            <p:cNvSpPr txBox="1"/>
            <p:nvPr/>
          </p:nvSpPr>
          <p:spPr>
            <a:xfrm>
              <a:off x="4988783" y="4527546"/>
              <a:ext cx="6367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Siltstone</a:t>
              </a:r>
              <a:endParaRPr lang="de-DE" sz="1000" dirty="0"/>
            </a:p>
          </p:txBody>
        </p:sp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471EAD1B-812E-D9E8-B931-6D98FAF2A891}"/>
                </a:ext>
              </a:extLst>
            </p:cNvPr>
            <p:cNvSpPr txBox="1"/>
            <p:nvPr/>
          </p:nvSpPr>
          <p:spPr>
            <a:xfrm>
              <a:off x="5930947" y="4422851"/>
              <a:ext cx="661669" cy="412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Air-fall Tuff</a:t>
              </a: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90082136-58AF-7E4A-99AF-C34EF5449973}"/>
                </a:ext>
              </a:extLst>
            </p:cNvPr>
            <p:cNvSpPr txBox="1"/>
            <p:nvPr/>
          </p:nvSpPr>
          <p:spPr>
            <a:xfrm>
              <a:off x="5933671" y="3931333"/>
              <a:ext cx="6123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BIF, </a:t>
              </a:r>
              <a:r>
                <a:rPr lang="de-DE" sz="1000" dirty="0" err="1"/>
                <a:t>Jaspilite</a:t>
              </a:r>
              <a:endParaRPr lang="de-DE" sz="1000" dirty="0"/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96430CB3-ECD2-1F13-6A3C-200A67D36CDA}"/>
                </a:ext>
              </a:extLst>
            </p:cNvPr>
            <p:cNvSpPr txBox="1"/>
            <p:nvPr/>
          </p:nvSpPr>
          <p:spPr>
            <a:xfrm>
              <a:off x="4780393" y="4099845"/>
              <a:ext cx="8451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Basaltic</a:t>
              </a:r>
              <a:r>
                <a:rPr lang="de-DE" sz="1000" dirty="0"/>
                <a:t> Lava</a:t>
              </a:r>
            </a:p>
          </p:txBody>
        </p:sp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F5EFAB51-1F9C-0F60-75F0-60DDBB26882E}"/>
                </a:ext>
              </a:extLst>
            </p:cNvPr>
            <p:cNvSpPr txBox="1"/>
            <p:nvPr/>
          </p:nvSpPr>
          <p:spPr>
            <a:xfrm rot="5400000">
              <a:off x="5078059" y="5001111"/>
              <a:ext cx="7312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/>
                <a:t>-</a:t>
              </a:r>
              <a:r>
                <a:rPr lang="de-DE" sz="1000" dirty="0" err="1"/>
                <a:t>grained</a:t>
              </a:r>
              <a:endParaRPr lang="de-DE" sz="1000" dirty="0"/>
            </a:p>
            <a:p>
              <a:pPr algn="ctr"/>
              <a:r>
                <a:rPr lang="de-DE" sz="1000" dirty="0" err="1"/>
                <a:t>Sandstone</a:t>
              </a:r>
              <a:endParaRPr lang="de-DE" sz="1000" dirty="0"/>
            </a:p>
          </p:txBody>
        </p:sp>
        <p:sp>
          <p:nvSpPr>
            <p:cNvPr id="166" name="Textfeld 165">
              <a:extLst>
                <a:ext uri="{FF2B5EF4-FFF2-40B4-BE49-F238E27FC236}">
                  <a16:creationId xmlns:a16="http://schemas.microsoft.com/office/drawing/2014/main" id="{9A2B78C9-9249-9695-91C1-99479C4603D7}"/>
                </a:ext>
              </a:extLst>
            </p:cNvPr>
            <p:cNvSpPr txBox="1"/>
            <p:nvPr/>
          </p:nvSpPr>
          <p:spPr>
            <a:xfrm>
              <a:off x="5160304" y="4289906"/>
              <a:ext cx="4651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 err="1"/>
                <a:t>Shale</a:t>
              </a:r>
              <a:endParaRPr lang="de-DE" sz="1000" dirty="0"/>
            </a:p>
          </p:txBody>
        </p:sp>
        <p:sp>
          <p:nvSpPr>
            <p:cNvPr id="167" name="Rechteck 166">
              <a:extLst>
                <a:ext uri="{FF2B5EF4-FFF2-40B4-BE49-F238E27FC236}">
                  <a16:creationId xmlns:a16="http://schemas.microsoft.com/office/drawing/2014/main" id="{1D41D5DB-C914-5719-99BA-C4B2699C79EF}"/>
                </a:ext>
              </a:extLst>
            </p:cNvPr>
            <p:cNvSpPr/>
            <p:nvPr/>
          </p:nvSpPr>
          <p:spPr>
            <a:xfrm>
              <a:off x="5627017" y="5224655"/>
              <a:ext cx="239364" cy="253535"/>
            </a:xfrm>
            <a:prstGeom prst="rect">
              <a:avLst/>
            </a:prstGeom>
            <a:solidFill>
              <a:srgbClr val="F4B183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8" name="Rechteck 167">
              <a:extLst>
                <a:ext uri="{FF2B5EF4-FFF2-40B4-BE49-F238E27FC236}">
                  <a16:creationId xmlns:a16="http://schemas.microsoft.com/office/drawing/2014/main" id="{D0CF8E1E-5ABA-2537-3A3F-080C28614C11}"/>
                </a:ext>
              </a:extLst>
            </p:cNvPr>
            <p:cNvSpPr/>
            <p:nvPr/>
          </p:nvSpPr>
          <p:spPr>
            <a:xfrm>
              <a:off x="5627017" y="4982961"/>
              <a:ext cx="211019" cy="233023"/>
            </a:xfrm>
            <a:prstGeom prst="rect">
              <a:avLst/>
            </a:prstGeom>
            <a:solidFill>
              <a:srgbClr val="FFD966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9" name="Rechteck 168">
              <a:extLst>
                <a:ext uri="{FF2B5EF4-FFF2-40B4-BE49-F238E27FC236}">
                  <a16:creationId xmlns:a16="http://schemas.microsoft.com/office/drawing/2014/main" id="{5519C9DC-E9E3-0570-6C3B-8FBFD2E44C58}"/>
                </a:ext>
              </a:extLst>
            </p:cNvPr>
            <p:cNvSpPr/>
            <p:nvPr/>
          </p:nvSpPr>
          <p:spPr>
            <a:xfrm>
              <a:off x="5627017" y="4755142"/>
              <a:ext cx="182671" cy="216763"/>
            </a:xfrm>
            <a:prstGeom prst="rect">
              <a:avLst/>
            </a:prstGeom>
            <a:solidFill>
              <a:srgbClr val="FFE69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0" name="Rechteck 169">
              <a:extLst>
                <a:ext uri="{FF2B5EF4-FFF2-40B4-BE49-F238E27FC236}">
                  <a16:creationId xmlns:a16="http://schemas.microsoft.com/office/drawing/2014/main" id="{4E6D497E-03FD-F869-E74F-F67BC05F9A39}"/>
                </a:ext>
              </a:extLst>
            </p:cNvPr>
            <p:cNvSpPr/>
            <p:nvPr/>
          </p:nvSpPr>
          <p:spPr>
            <a:xfrm>
              <a:off x="5627017" y="4566553"/>
              <a:ext cx="157474" cy="179917"/>
            </a:xfrm>
            <a:prstGeom prst="rect">
              <a:avLst/>
            </a:prstGeom>
            <a:solidFill>
              <a:srgbClr val="CAD48C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1" name="Rechteck 170">
              <a:extLst>
                <a:ext uri="{FF2B5EF4-FFF2-40B4-BE49-F238E27FC236}">
                  <a16:creationId xmlns:a16="http://schemas.microsoft.com/office/drawing/2014/main" id="{BE8EE711-525B-DAC3-EC79-2DF634198EEA}"/>
                </a:ext>
              </a:extLst>
            </p:cNvPr>
            <p:cNvSpPr/>
            <p:nvPr/>
          </p:nvSpPr>
          <p:spPr>
            <a:xfrm>
              <a:off x="5627017" y="4315162"/>
              <a:ext cx="125980" cy="229289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72" name="Gerader Verbinder 171">
              <a:extLst>
                <a:ext uri="{FF2B5EF4-FFF2-40B4-BE49-F238E27FC236}">
                  <a16:creationId xmlns:a16="http://schemas.microsoft.com/office/drawing/2014/main" id="{6C04CE61-B3AA-6E1E-CDBD-E8A5CEF156EC}"/>
                </a:ext>
              </a:extLst>
            </p:cNvPr>
            <p:cNvCxnSpPr/>
            <p:nvPr/>
          </p:nvCxnSpPr>
          <p:spPr>
            <a:xfrm>
              <a:off x="5627016" y="4171642"/>
              <a:ext cx="360000" cy="2088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Rechteck 172">
              <a:extLst>
                <a:ext uri="{FF2B5EF4-FFF2-40B4-BE49-F238E27FC236}">
                  <a16:creationId xmlns:a16="http://schemas.microsoft.com/office/drawing/2014/main" id="{96F3A786-2F90-C7D7-4C8A-0E02497003CC}"/>
                </a:ext>
              </a:extLst>
            </p:cNvPr>
            <p:cNvSpPr/>
            <p:nvPr/>
          </p:nvSpPr>
          <p:spPr>
            <a:xfrm>
              <a:off x="5627017" y="4179784"/>
              <a:ext cx="188970" cy="124329"/>
            </a:xfrm>
            <a:prstGeom prst="rect">
              <a:avLst/>
            </a:prstGeom>
            <a:solidFill>
              <a:srgbClr val="548235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4" name="Rechteck 173">
              <a:extLst>
                <a:ext uri="{FF2B5EF4-FFF2-40B4-BE49-F238E27FC236}">
                  <a16:creationId xmlns:a16="http://schemas.microsoft.com/office/drawing/2014/main" id="{643EF481-28C2-6696-30A8-6C32B3E9CFD9}"/>
                </a:ext>
              </a:extLst>
            </p:cNvPr>
            <p:cNvSpPr/>
            <p:nvPr/>
          </p:nvSpPr>
          <p:spPr>
            <a:xfrm>
              <a:off x="5627017" y="5489348"/>
              <a:ext cx="261411" cy="173928"/>
            </a:xfrm>
            <a:prstGeom prst="rect">
              <a:avLst/>
            </a:prstGeom>
            <a:solidFill>
              <a:srgbClr val="C55A1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75" name="Gerader Verbinder 174">
              <a:extLst>
                <a:ext uri="{FF2B5EF4-FFF2-40B4-BE49-F238E27FC236}">
                  <a16:creationId xmlns:a16="http://schemas.microsoft.com/office/drawing/2014/main" id="{DA5FCC26-BCEE-1D68-43B9-1E79E945303B}"/>
                </a:ext>
              </a:extLst>
            </p:cNvPr>
            <p:cNvCxnSpPr/>
            <p:nvPr/>
          </p:nvCxnSpPr>
          <p:spPr>
            <a:xfrm>
              <a:off x="5624255" y="4556474"/>
              <a:ext cx="360000" cy="1787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6" name="Gruppieren 175">
              <a:extLst>
                <a:ext uri="{FF2B5EF4-FFF2-40B4-BE49-F238E27FC236}">
                  <a16:creationId xmlns:a16="http://schemas.microsoft.com/office/drawing/2014/main" id="{C003E980-5605-1445-193A-FF164AF2BE1B}"/>
                </a:ext>
              </a:extLst>
            </p:cNvPr>
            <p:cNvGrpSpPr/>
            <p:nvPr/>
          </p:nvGrpSpPr>
          <p:grpSpPr>
            <a:xfrm>
              <a:off x="5627611" y="5673662"/>
              <a:ext cx="374039" cy="158417"/>
              <a:chOff x="4763961" y="6415088"/>
              <a:chExt cx="282798" cy="130968"/>
            </a:xfrm>
          </p:grpSpPr>
          <p:sp>
            <p:nvSpPr>
              <p:cNvPr id="178" name="Freihandform 858">
                <a:extLst>
                  <a:ext uri="{FF2B5EF4-FFF2-40B4-BE49-F238E27FC236}">
                    <a16:creationId xmlns:a16="http://schemas.microsoft.com/office/drawing/2014/main" id="{AF751FF4-BCC3-6C49-C19A-0BFC11378861}"/>
                  </a:ext>
                </a:extLst>
              </p:cNvPr>
              <p:cNvSpPr/>
              <p:nvPr/>
            </p:nvSpPr>
            <p:spPr>
              <a:xfrm>
                <a:off x="4763961" y="6415088"/>
                <a:ext cx="282798" cy="130968"/>
              </a:xfrm>
              <a:custGeom>
                <a:avLst/>
                <a:gdLst>
                  <a:gd name="connsiteX0" fmla="*/ 0 w 280988"/>
                  <a:gd name="connsiteY0" fmla="*/ 0 h 130968"/>
                  <a:gd name="connsiteX1" fmla="*/ 280988 w 280988"/>
                  <a:gd name="connsiteY1" fmla="*/ 0 h 130968"/>
                  <a:gd name="connsiteX2" fmla="*/ 271463 w 280988"/>
                  <a:gd name="connsiteY2" fmla="*/ 61912 h 130968"/>
                  <a:gd name="connsiteX3" fmla="*/ 278606 w 280988"/>
                  <a:gd name="connsiteY3" fmla="*/ 104775 h 130968"/>
                  <a:gd name="connsiteX4" fmla="*/ 204788 w 280988"/>
                  <a:gd name="connsiteY4" fmla="*/ 130968 h 130968"/>
                  <a:gd name="connsiteX5" fmla="*/ 133350 w 280988"/>
                  <a:gd name="connsiteY5" fmla="*/ 121443 h 130968"/>
                  <a:gd name="connsiteX6" fmla="*/ 61913 w 280988"/>
                  <a:gd name="connsiteY6" fmla="*/ 123825 h 130968"/>
                  <a:gd name="connsiteX7" fmla="*/ 2381 w 280988"/>
                  <a:gd name="connsiteY7" fmla="*/ 116681 h 130968"/>
                  <a:gd name="connsiteX8" fmla="*/ 0 w 280988"/>
                  <a:gd name="connsiteY8" fmla="*/ 0 h 130968"/>
                  <a:gd name="connsiteX0" fmla="*/ 0 w 298965"/>
                  <a:gd name="connsiteY0" fmla="*/ 0 h 130968"/>
                  <a:gd name="connsiteX1" fmla="*/ 280988 w 298965"/>
                  <a:gd name="connsiteY1" fmla="*/ 0 h 130968"/>
                  <a:gd name="connsiteX2" fmla="*/ 271463 w 298965"/>
                  <a:gd name="connsiteY2" fmla="*/ 61912 h 130968"/>
                  <a:gd name="connsiteX3" fmla="*/ 278606 w 298965"/>
                  <a:gd name="connsiteY3" fmla="*/ 104775 h 130968"/>
                  <a:gd name="connsiteX4" fmla="*/ 204788 w 298965"/>
                  <a:gd name="connsiteY4" fmla="*/ 130968 h 130968"/>
                  <a:gd name="connsiteX5" fmla="*/ 133350 w 298965"/>
                  <a:gd name="connsiteY5" fmla="*/ 121443 h 130968"/>
                  <a:gd name="connsiteX6" fmla="*/ 61913 w 298965"/>
                  <a:gd name="connsiteY6" fmla="*/ 123825 h 130968"/>
                  <a:gd name="connsiteX7" fmla="*/ 2381 w 298965"/>
                  <a:gd name="connsiteY7" fmla="*/ 116681 h 130968"/>
                  <a:gd name="connsiteX8" fmla="*/ 0 w 298965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3794"/>
                  <a:gd name="connsiteY0" fmla="*/ 0 h 130968"/>
                  <a:gd name="connsiteX1" fmla="*/ 280988 w 283794"/>
                  <a:gd name="connsiteY1" fmla="*/ 0 h 130968"/>
                  <a:gd name="connsiteX2" fmla="*/ 271463 w 283794"/>
                  <a:gd name="connsiteY2" fmla="*/ 61912 h 130968"/>
                  <a:gd name="connsiteX3" fmla="*/ 278606 w 283794"/>
                  <a:gd name="connsiteY3" fmla="*/ 104775 h 130968"/>
                  <a:gd name="connsiteX4" fmla="*/ 204788 w 283794"/>
                  <a:gd name="connsiteY4" fmla="*/ 130968 h 130968"/>
                  <a:gd name="connsiteX5" fmla="*/ 133350 w 283794"/>
                  <a:gd name="connsiteY5" fmla="*/ 121443 h 130968"/>
                  <a:gd name="connsiteX6" fmla="*/ 61913 w 283794"/>
                  <a:gd name="connsiteY6" fmla="*/ 123825 h 130968"/>
                  <a:gd name="connsiteX7" fmla="*/ 2381 w 283794"/>
                  <a:gd name="connsiteY7" fmla="*/ 116681 h 130968"/>
                  <a:gd name="connsiteX8" fmla="*/ 0 w 283794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04775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  <a:gd name="connsiteX0" fmla="*/ 0 w 282798"/>
                  <a:gd name="connsiteY0" fmla="*/ 0 h 130968"/>
                  <a:gd name="connsiteX1" fmla="*/ 280988 w 282798"/>
                  <a:gd name="connsiteY1" fmla="*/ 0 h 130968"/>
                  <a:gd name="connsiteX2" fmla="*/ 271463 w 282798"/>
                  <a:gd name="connsiteY2" fmla="*/ 61912 h 130968"/>
                  <a:gd name="connsiteX3" fmla="*/ 278606 w 282798"/>
                  <a:gd name="connsiteY3" fmla="*/ 116681 h 130968"/>
                  <a:gd name="connsiteX4" fmla="*/ 204788 w 282798"/>
                  <a:gd name="connsiteY4" fmla="*/ 130968 h 130968"/>
                  <a:gd name="connsiteX5" fmla="*/ 133350 w 282798"/>
                  <a:gd name="connsiteY5" fmla="*/ 121443 h 130968"/>
                  <a:gd name="connsiteX6" fmla="*/ 61913 w 282798"/>
                  <a:gd name="connsiteY6" fmla="*/ 123825 h 130968"/>
                  <a:gd name="connsiteX7" fmla="*/ 2381 w 282798"/>
                  <a:gd name="connsiteY7" fmla="*/ 116681 h 130968"/>
                  <a:gd name="connsiteX8" fmla="*/ 0 w 282798"/>
                  <a:gd name="connsiteY8" fmla="*/ 0 h 1309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82798" h="130968">
                    <a:moveTo>
                      <a:pt x="0" y="0"/>
                    </a:moveTo>
                    <a:lnTo>
                      <a:pt x="280988" y="0"/>
                    </a:lnTo>
                    <a:cubicBezTo>
                      <a:pt x="288132" y="24606"/>
                      <a:pt x="271860" y="42465"/>
                      <a:pt x="271463" y="61912"/>
                    </a:cubicBezTo>
                    <a:cubicBezTo>
                      <a:pt x="271066" y="81359"/>
                      <a:pt x="281778" y="104188"/>
                      <a:pt x="278606" y="116681"/>
                    </a:cubicBezTo>
                    <a:cubicBezTo>
                      <a:pt x="242933" y="124908"/>
                      <a:pt x="229394" y="122237"/>
                      <a:pt x="204788" y="130968"/>
                    </a:cubicBezTo>
                    <a:lnTo>
                      <a:pt x="133350" y="121443"/>
                    </a:lnTo>
                    <a:lnTo>
                      <a:pt x="61913" y="123825"/>
                    </a:lnTo>
                    <a:lnTo>
                      <a:pt x="2381" y="116681"/>
                    </a:lnTo>
                    <a:cubicBezTo>
                      <a:pt x="1587" y="77787"/>
                      <a:pt x="794" y="38894"/>
                      <a:pt x="0" y="0"/>
                    </a:cubicBezTo>
                    <a:close/>
                  </a:path>
                </a:pathLst>
              </a:custGeom>
              <a:solidFill>
                <a:schemeClr val="accent2">
                  <a:lumMod val="5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80" name="Ellipse 179">
                <a:extLst>
                  <a:ext uri="{FF2B5EF4-FFF2-40B4-BE49-F238E27FC236}">
                    <a16:creationId xmlns:a16="http://schemas.microsoft.com/office/drawing/2014/main" id="{62B652D8-12F0-3032-11EF-C43E1E6B1139}"/>
                  </a:ext>
                </a:extLst>
              </p:cNvPr>
              <p:cNvSpPr/>
              <p:nvPr/>
            </p:nvSpPr>
            <p:spPr>
              <a:xfrm>
                <a:off x="4800600" y="6443187"/>
                <a:ext cx="64294" cy="45719"/>
              </a:xfrm>
              <a:prstGeom prst="ellipse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81" name="Ellipse 180">
                <a:extLst>
                  <a:ext uri="{FF2B5EF4-FFF2-40B4-BE49-F238E27FC236}">
                    <a16:creationId xmlns:a16="http://schemas.microsoft.com/office/drawing/2014/main" id="{67C2D9CD-A62F-BCF0-0BC7-BFA59FF0C562}"/>
                  </a:ext>
                </a:extLst>
              </p:cNvPr>
              <p:cNvSpPr/>
              <p:nvPr/>
            </p:nvSpPr>
            <p:spPr>
              <a:xfrm rot="20361425">
                <a:off x="4866713" y="6471004"/>
                <a:ext cx="87016" cy="45719"/>
              </a:xfrm>
              <a:prstGeom prst="ellipse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82" name="Ellipse 181">
                <a:extLst>
                  <a:ext uri="{FF2B5EF4-FFF2-40B4-BE49-F238E27FC236}">
                    <a16:creationId xmlns:a16="http://schemas.microsoft.com/office/drawing/2014/main" id="{DE6E2628-1C39-F3F5-7268-F72BCFED6E57}"/>
                  </a:ext>
                </a:extLst>
              </p:cNvPr>
              <p:cNvSpPr/>
              <p:nvPr/>
            </p:nvSpPr>
            <p:spPr>
              <a:xfrm rot="20361425">
                <a:off x="4972644" y="6436936"/>
                <a:ext cx="45719" cy="45719"/>
              </a:xfrm>
              <a:prstGeom prst="ellipse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cxnSp>
          <p:nvCxnSpPr>
            <p:cNvPr id="177" name="Gerader Verbinder 176">
              <a:extLst>
                <a:ext uri="{FF2B5EF4-FFF2-40B4-BE49-F238E27FC236}">
                  <a16:creationId xmlns:a16="http://schemas.microsoft.com/office/drawing/2014/main" id="{C34D886F-5646-65C3-1606-140CA694C935}"/>
                </a:ext>
              </a:extLst>
            </p:cNvPr>
            <p:cNvCxnSpPr/>
            <p:nvPr/>
          </p:nvCxnSpPr>
          <p:spPr>
            <a:xfrm rot="5400000">
              <a:off x="5415911" y="5566693"/>
              <a:ext cx="12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3" name="Textfeld 40">
            <a:extLst>
              <a:ext uri="{FF2B5EF4-FFF2-40B4-BE49-F238E27FC236}">
                <a16:creationId xmlns:a16="http://schemas.microsoft.com/office/drawing/2014/main" id="{1629E530-7B4B-665C-39D2-46E309B544A8}"/>
              </a:ext>
            </a:extLst>
          </p:cNvPr>
          <p:cNvSpPr txBox="1">
            <a:spLocks noChangeArrowheads="1"/>
          </p:cNvSpPr>
          <p:nvPr/>
        </p:nvSpPr>
        <p:spPr bwMode="auto">
          <a:xfrm rot="21540000">
            <a:off x="5007763" y="3783058"/>
            <a:ext cx="102245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400" i="1" dirty="0" err="1">
                <a:latin typeface="Calibri" pitchFamily="34" charset="0"/>
              </a:rPr>
              <a:t>Piggs</a:t>
            </a:r>
            <a:r>
              <a:rPr lang="de-DE" sz="1400" i="1" dirty="0">
                <a:latin typeface="Calibri" pitchFamily="34" charset="0"/>
              </a:rPr>
              <a:t> Peak</a:t>
            </a:r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150C90AD-B026-01AE-EE0A-49BC38D459B4}"/>
              </a:ext>
            </a:extLst>
          </p:cNvPr>
          <p:cNvSpPr/>
          <p:nvPr/>
        </p:nvSpPr>
        <p:spPr>
          <a:xfrm rot="21540000">
            <a:off x="4886745" y="3995031"/>
            <a:ext cx="147791" cy="134084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/>
          </a:p>
        </p:txBody>
      </p:sp>
      <p:sp>
        <p:nvSpPr>
          <p:cNvPr id="185" name="Textfeld 24">
            <a:extLst>
              <a:ext uri="{FF2B5EF4-FFF2-40B4-BE49-F238E27FC236}">
                <a16:creationId xmlns:a16="http://schemas.microsoft.com/office/drawing/2014/main" id="{C305CD06-2CC6-6FA4-4866-2ED97762D7A3}"/>
              </a:ext>
            </a:extLst>
          </p:cNvPr>
          <p:cNvSpPr txBox="1">
            <a:spLocks noChangeArrowheads="1"/>
          </p:cNvSpPr>
          <p:nvPr/>
        </p:nvSpPr>
        <p:spPr bwMode="auto">
          <a:xfrm rot="17742259">
            <a:off x="3449309" y="4960403"/>
            <a:ext cx="7079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200" i="1" dirty="0">
                <a:latin typeface="Calibri" pitchFamily="34" charset="0"/>
              </a:rPr>
              <a:t>Eswatini</a:t>
            </a:r>
          </a:p>
        </p:txBody>
      </p:sp>
      <p:sp>
        <p:nvSpPr>
          <p:cNvPr id="186" name="Textfeld 56">
            <a:extLst>
              <a:ext uri="{FF2B5EF4-FFF2-40B4-BE49-F238E27FC236}">
                <a16:creationId xmlns:a16="http://schemas.microsoft.com/office/drawing/2014/main" id="{C4E1BC70-C942-7646-CFC6-4EAEB9A489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1259" y="3378363"/>
            <a:ext cx="5390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/>
            <a:r>
              <a:rPr lang="de-DE" sz="800" i="1" dirty="0">
                <a:latin typeface="Calibri" pitchFamily="34" charset="0"/>
              </a:rPr>
              <a:t>Zone</a:t>
            </a:r>
          </a:p>
        </p:txBody>
      </p:sp>
      <p:grpSp>
        <p:nvGrpSpPr>
          <p:cNvPr id="187" name="Gruppieren 186">
            <a:extLst>
              <a:ext uri="{FF2B5EF4-FFF2-40B4-BE49-F238E27FC236}">
                <a16:creationId xmlns:a16="http://schemas.microsoft.com/office/drawing/2014/main" id="{74CB8DDD-97F1-A5A2-0140-43BB6124381C}"/>
              </a:ext>
            </a:extLst>
          </p:cNvPr>
          <p:cNvGrpSpPr>
            <a:grpSpLocks noChangeAspect="1"/>
          </p:cNvGrpSpPr>
          <p:nvPr/>
        </p:nvGrpSpPr>
        <p:grpSpPr>
          <a:xfrm>
            <a:off x="6467558" y="1002253"/>
            <a:ext cx="2567108" cy="5361302"/>
            <a:chOff x="5297707" y="2054441"/>
            <a:chExt cx="2730966" cy="5703513"/>
          </a:xfrm>
        </p:grpSpPr>
        <p:sp>
          <p:nvSpPr>
            <p:cNvPr id="188" name="Rectangle 9" descr="70%">
              <a:extLst>
                <a:ext uri="{FF2B5EF4-FFF2-40B4-BE49-F238E27FC236}">
                  <a16:creationId xmlns:a16="http://schemas.microsoft.com/office/drawing/2014/main" id="{31F60456-73C7-6EFB-05EF-D4F0D94F0B17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 flipV="1">
              <a:off x="6662747" y="4824165"/>
              <a:ext cx="621784" cy="215730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189" name="Text Box 6">
              <a:extLst>
                <a:ext uri="{FF2B5EF4-FFF2-40B4-BE49-F238E27FC236}">
                  <a16:creationId xmlns:a16="http://schemas.microsoft.com/office/drawing/2014/main" id="{7DC8664F-1AD0-06A1-1F6A-9DF3E53547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97707" y="7468801"/>
              <a:ext cx="2084819" cy="273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dirty="0" err="1">
                  <a:latin typeface="+mn-lt"/>
                </a:rPr>
                <a:t>Schoongezicht</a:t>
              </a:r>
              <a:r>
                <a:rPr lang="de-DE" sz="1050" dirty="0">
                  <a:latin typeface="+mn-lt"/>
                </a:rPr>
                <a:t> Fm., Fig </a:t>
              </a:r>
              <a:r>
                <a:rPr lang="de-DE" sz="1050" dirty="0" err="1">
                  <a:latin typeface="+mn-lt"/>
                </a:rPr>
                <a:t>Tree</a:t>
              </a:r>
              <a:r>
                <a:rPr lang="de-DE" sz="1050" dirty="0">
                  <a:latin typeface="+mn-lt"/>
                </a:rPr>
                <a:t> </a:t>
              </a:r>
              <a:r>
                <a:rPr lang="de-DE" sz="1050" dirty="0" err="1">
                  <a:latin typeface="+mn-lt"/>
                </a:rPr>
                <a:t>Gp</a:t>
              </a:r>
              <a:r>
                <a:rPr lang="de-DE" sz="1050" dirty="0">
                  <a:latin typeface="+mn-lt"/>
                </a:rPr>
                <a:t>. </a:t>
              </a:r>
            </a:p>
          </p:txBody>
        </p:sp>
        <p:sp>
          <p:nvSpPr>
            <p:cNvPr id="190" name="Rectangle 9" descr="70%">
              <a:extLst>
                <a:ext uri="{FF2B5EF4-FFF2-40B4-BE49-F238E27FC236}">
                  <a16:creationId xmlns:a16="http://schemas.microsoft.com/office/drawing/2014/main" id="{E586CFC8-3EF6-15F9-04C1-CF67E10CD8D2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450216" y="7234636"/>
              <a:ext cx="833974" cy="202561"/>
            </a:xfrm>
            <a:prstGeom prst="rect">
              <a:avLst/>
            </a:prstGeom>
            <a:solidFill>
              <a:srgbClr val="C55A1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cxnSp>
          <p:nvCxnSpPr>
            <p:cNvPr id="191" name="Gerade Verbindung 596">
              <a:extLst>
                <a:ext uri="{FF2B5EF4-FFF2-40B4-BE49-F238E27FC236}">
                  <a16:creationId xmlns:a16="http://schemas.microsoft.com/office/drawing/2014/main" id="{35116C28-9703-22EC-8669-F31B1FFB6CA3}"/>
                </a:ext>
              </a:extLst>
            </p:cNvPr>
            <p:cNvCxnSpPr/>
            <p:nvPr/>
          </p:nvCxnSpPr>
          <p:spPr bwMode="auto">
            <a:xfrm flipH="1" flipV="1">
              <a:off x="6164983" y="7273892"/>
              <a:ext cx="1112597" cy="2732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Rectangle 9" descr="70%">
              <a:extLst>
                <a:ext uri="{FF2B5EF4-FFF2-40B4-BE49-F238E27FC236}">
                  <a16:creationId xmlns:a16="http://schemas.microsoft.com/office/drawing/2014/main" id="{647C02A3-8ED3-1B01-AEE7-49E830C3A7AC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669969" y="2894815"/>
              <a:ext cx="616872" cy="179906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193" name="Rectangle 9" descr="70%">
              <a:extLst>
                <a:ext uri="{FF2B5EF4-FFF2-40B4-BE49-F238E27FC236}">
                  <a16:creationId xmlns:a16="http://schemas.microsoft.com/office/drawing/2014/main" id="{CCD97BE7-3786-1B19-6A71-CBE12CAAA7BA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589796" y="3871792"/>
              <a:ext cx="695059" cy="421732"/>
            </a:xfrm>
            <a:prstGeom prst="rect">
              <a:avLst/>
            </a:prstGeom>
            <a:solidFill>
              <a:srgbClr val="FFD966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194" name="Rectangle 9" descr="70%">
              <a:extLst>
                <a:ext uri="{FF2B5EF4-FFF2-40B4-BE49-F238E27FC236}">
                  <a16:creationId xmlns:a16="http://schemas.microsoft.com/office/drawing/2014/main" id="{B7577A98-F8A8-7221-654F-FC96B5BCE56A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661749" y="3194611"/>
              <a:ext cx="625091" cy="86532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cxnSp>
          <p:nvCxnSpPr>
            <p:cNvPr id="195" name="Gerade Verbindung 347">
              <a:extLst>
                <a:ext uri="{FF2B5EF4-FFF2-40B4-BE49-F238E27FC236}">
                  <a16:creationId xmlns:a16="http://schemas.microsoft.com/office/drawing/2014/main" id="{22906277-0354-00D3-AA8A-9C41DA3EA97F}"/>
                </a:ext>
              </a:extLst>
            </p:cNvPr>
            <p:cNvCxnSpPr/>
            <p:nvPr/>
          </p:nvCxnSpPr>
          <p:spPr bwMode="auto">
            <a:xfrm rot="10800000" flipV="1">
              <a:off x="6723926" y="3126619"/>
              <a:ext cx="34132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Rectangle 9" descr="70%">
              <a:extLst>
                <a:ext uri="{FF2B5EF4-FFF2-40B4-BE49-F238E27FC236}">
                  <a16:creationId xmlns:a16="http://schemas.microsoft.com/office/drawing/2014/main" id="{18E7C5D5-0817-BBFB-9773-F6A85F6EF31B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661750" y="2715589"/>
              <a:ext cx="624430" cy="13417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197" name="Rectangle 9" descr="70%">
              <a:extLst>
                <a:ext uri="{FF2B5EF4-FFF2-40B4-BE49-F238E27FC236}">
                  <a16:creationId xmlns:a16="http://schemas.microsoft.com/office/drawing/2014/main" id="{DBD41617-ABEC-8EA6-27F8-8FC305ABECDF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859703" y="2241940"/>
              <a:ext cx="427137" cy="377524"/>
            </a:xfrm>
            <a:prstGeom prst="rect">
              <a:avLst/>
            </a:prstGeom>
            <a:solidFill>
              <a:srgbClr val="CAD48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198" name="Rectangle 9" descr="70%">
              <a:extLst>
                <a:ext uri="{FF2B5EF4-FFF2-40B4-BE49-F238E27FC236}">
                  <a16:creationId xmlns:a16="http://schemas.microsoft.com/office/drawing/2014/main" id="{61263B7F-D52C-C6D9-445E-42C8F4434247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757689" y="2621468"/>
              <a:ext cx="527167" cy="961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cxnSp>
          <p:nvCxnSpPr>
            <p:cNvPr id="199" name="Gerade Verbindung 357">
              <a:extLst>
                <a:ext uri="{FF2B5EF4-FFF2-40B4-BE49-F238E27FC236}">
                  <a16:creationId xmlns:a16="http://schemas.microsoft.com/office/drawing/2014/main" id="{D300AA20-ACAB-569A-E24E-F2EF3664EEDA}"/>
                </a:ext>
              </a:extLst>
            </p:cNvPr>
            <p:cNvCxnSpPr/>
            <p:nvPr/>
          </p:nvCxnSpPr>
          <p:spPr bwMode="auto">
            <a:xfrm rot="10800000" flipV="1">
              <a:off x="6878712" y="2583251"/>
              <a:ext cx="342643" cy="273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Gerade Verbindung 358">
              <a:extLst>
                <a:ext uri="{FF2B5EF4-FFF2-40B4-BE49-F238E27FC236}">
                  <a16:creationId xmlns:a16="http://schemas.microsoft.com/office/drawing/2014/main" id="{BE5DFA89-7518-88B2-F9DA-8C15606DC2F7}"/>
                </a:ext>
              </a:extLst>
            </p:cNvPr>
            <p:cNvCxnSpPr/>
            <p:nvPr/>
          </p:nvCxnSpPr>
          <p:spPr bwMode="auto">
            <a:xfrm rot="10800000" flipV="1">
              <a:off x="6816535" y="2555946"/>
              <a:ext cx="342643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Gerade Verbindung 359">
              <a:extLst>
                <a:ext uri="{FF2B5EF4-FFF2-40B4-BE49-F238E27FC236}">
                  <a16:creationId xmlns:a16="http://schemas.microsoft.com/office/drawing/2014/main" id="{42169E59-E26D-38F0-83FC-15E6C337CB4E}"/>
                </a:ext>
              </a:extLst>
            </p:cNvPr>
            <p:cNvCxnSpPr/>
            <p:nvPr/>
          </p:nvCxnSpPr>
          <p:spPr bwMode="auto">
            <a:xfrm rot="10800000" flipV="1">
              <a:off x="6731865" y="2332046"/>
              <a:ext cx="342643" cy="273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Gerade Verbindung 360">
              <a:extLst>
                <a:ext uri="{FF2B5EF4-FFF2-40B4-BE49-F238E27FC236}">
                  <a16:creationId xmlns:a16="http://schemas.microsoft.com/office/drawing/2014/main" id="{2088AC83-E914-DC16-6E60-1E87153CC858}"/>
                </a:ext>
              </a:extLst>
            </p:cNvPr>
            <p:cNvCxnSpPr/>
            <p:nvPr/>
          </p:nvCxnSpPr>
          <p:spPr bwMode="auto">
            <a:xfrm rot="10800000" flipV="1">
              <a:off x="6723926" y="2599634"/>
              <a:ext cx="34132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Line 15">
              <a:extLst>
                <a:ext uri="{FF2B5EF4-FFF2-40B4-BE49-F238E27FC236}">
                  <a16:creationId xmlns:a16="http://schemas.microsoft.com/office/drawing/2014/main" id="{A798BDA7-67CE-81F3-3460-6CBD177AA8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35979" y="2816724"/>
              <a:ext cx="38762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de-DE"/>
            </a:p>
          </p:txBody>
        </p:sp>
        <p:cxnSp>
          <p:nvCxnSpPr>
            <p:cNvPr id="204" name="Gerade Verbindung 363">
              <a:extLst>
                <a:ext uri="{FF2B5EF4-FFF2-40B4-BE49-F238E27FC236}">
                  <a16:creationId xmlns:a16="http://schemas.microsoft.com/office/drawing/2014/main" id="{2C2FD23D-E32E-0FF2-EF52-C7C707485E10}"/>
                </a:ext>
              </a:extLst>
            </p:cNvPr>
            <p:cNvCxnSpPr/>
            <p:nvPr/>
          </p:nvCxnSpPr>
          <p:spPr bwMode="auto">
            <a:xfrm rot="10800000" flipV="1">
              <a:off x="6795367" y="2368906"/>
              <a:ext cx="342643" cy="2730"/>
            </a:xfrm>
            <a:prstGeom prst="lin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Rectangle 9" descr="70%">
              <a:extLst>
                <a:ext uri="{FF2B5EF4-FFF2-40B4-BE49-F238E27FC236}">
                  <a16:creationId xmlns:a16="http://schemas.microsoft.com/office/drawing/2014/main" id="{F77D5C70-DD68-9E53-261D-E44A9E1CF6C1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591307" y="5044561"/>
              <a:ext cx="693224" cy="549720"/>
            </a:xfrm>
            <a:prstGeom prst="rect">
              <a:avLst/>
            </a:prstGeom>
            <a:solidFill>
              <a:srgbClr val="FFD966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06" name="Rectangle 9" descr="70%">
              <a:extLst>
                <a:ext uri="{FF2B5EF4-FFF2-40B4-BE49-F238E27FC236}">
                  <a16:creationId xmlns:a16="http://schemas.microsoft.com/office/drawing/2014/main" id="{80E03E42-42DC-83AD-D62E-BFDA2F61708E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314477" y="4372579"/>
              <a:ext cx="972365" cy="247109"/>
            </a:xfrm>
            <a:prstGeom prst="rect">
              <a:avLst/>
            </a:prstGeom>
            <a:solidFill>
              <a:srgbClr val="F4B183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07" name="Rectangle 9" descr="70%">
              <a:extLst>
                <a:ext uri="{FF2B5EF4-FFF2-40B4-BE49-F238E27FC236}">
                  <a16:creationId xmlns:a16="http://schemas.microsoft.com/office/drawing/2014/main" id="{503FB06D-32B4-E48E-C0FB-4CDFCBBC882B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 flipV="1">
              <a:off x="6311174" y="3563381"/>
              <a:ext cx="975663" cy="61636"/>
            </a:xfrm>
            <a:prstGeom prst="rect">
              <a:avLst/>
            </a:prstGeom>
            <a:solidFill>
              <a:srgbClr val="F4B183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08" name="Rectangle 9" descr="70%">
              <a:extLst>
                <a:ext uri="{FF2B5EF4-FFF2-40B4-BE49-F238E27FC236}">
                  <a16:creationId xmlns:a16="http://schemas.microsoft.com/office/drawing/2014/main" id="{9A6CA98D-0D40-FE39-F325-450233BBA506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447617" y="5799770"/>
              <a:ext cx="837422" cy="1434873"/>
            </a:xfrm>
            <a:prstGeom prst="rect">
              <a:avLst/>
            </a:prstGeom>
            <a:solidFill>
              <a:srgbClr val="C55A1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grpSp>
          <p:nvGrpSpPr>
            <p:cNvPr id="209" name="Group 10">
              <a:extLst>
                <a:ext uri="{FF2B5EF4-FFF2-40B4-BE49-F238E27FC236}">
                  <a16:creationId xmlns:a16="http://schemas.microsoft.com/office/drawing/2014/main" id="{448EEEDF-2FE5-855E-B07B-AEACA88016C8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454708" y="5919656"/>
              <a:ext cx="806998" cy="641201"/>
              <a:chOff x="3130" y="2921"/>
              <a:chExt cx="1754" cy="430"/>
            </a:xfrm>
            <a:noFill/>
          </p:grpSpPr>
          <p:sp>
            <p:nvSpPr>
              <p:cNvPr id="473" name="Line 11">
                <a:extLst>
                  <a:ext uri="{FF2B5EF4-FFF2-40B4-BE49-F238E27FC236}">
                    <a16:creationId xmlns:a16="http://schemas.microsoft.com/office/drawing/2014/main" id="{9A01F1CC-7E99-5EF4-5EF4-C4EFD90C14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0" y="3232"/>
                <a:ext cx="1233" cy="0"/>
              </a:xfrm>
              <a:prstGeom prst="lin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>
                  <a:defRPr/>
                </a:pPr>
                <a:endParaRPr lang="de-DE"/>
              </a:p>
            </p:txBody>
          </p:sp>
          <p:sp>
            <p:nvSpPr>
              <p:cNvPr id="474" name="Line 12">
                <a:extLst>
                  <a:ext uri="{FF2B5EF4-FFF2-40B4-BE49-F238E27FC236}">
                    <a16:creationId xmlns:a16="http://schemas.microsoft.com/office/drawing/2014/main" id="{38D063D1-0DDA-F003-A7FB-41DCE2EFA2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0" y="3351"/>
                <a:ext cx="1234" cy="0"/>
              </a:xfrm>
              <a:prstGeom prst="lin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>
                  <a:defRPr/>
                </a:pPr>
                <a:endParaRPr lang="de-DE"/>
              </a:p>
            </p:txBody>
          </p:sp>
          <p:sp>
            <p:nvSpPr>
              <p:cNvPr id="475" name="Line 13">
                <a:extLst>
                  <a:ext uri="{FF2B5EF4-FFF2-40B4-BE49-F238E27FC236}">
                    <a16:creationId xmlns:a16="http://schemas.microsoft.com/office/drawing/2014/main" id="{9C591121-2DC7-697D-66DF-AAD81D024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1" y="2921"/>
                <a:ext cx="1233" cy="0"/>
              </a:xfrm>
              <a:prstGeom prst="lin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>
                  <a:defRPr/>
                </a:pPr>
                <a:endParaRPr lang="de-DE"/>
              </a:p>
            </p:txBody>
          </p:sp>
        </p:grpSp>
        <p:sp>
          <p:nvSpPr>
            <p:cNvPr id="210" name="Line 22">
              <a:extLst>
                <a:ext uri="{FF2B5EF4-FFF2-40B4-BE49-F238E27FC236}">
                  <a16:creationId xmlns:a16="http://schemas.microsoft.com/office/drawing/2014/main" id="{FE89E42D-253B-DA8A-451F-9C2EC4429E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346227" y="4162841"/>
              <a:ext cx="56754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12" name="AutoShape 23" descr="20%">
              <a:extLst>
                <a:ext uri="{FF2B5EF4-FFF2-40B4-BE49-F238E27FC236}">
                  <a16:creationId xmlns:a16="http://schemas.microsoft.com/office/drawing/2014/main" id="{F5A0A2C8-F216-EEA1-0246-44E54780BA59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5876581" y="2527275"/>
              <a:ext cx="1410259" cy="241649"/>
            </a:xfrm>
            <a:prstGeom prst="rtTriangle">
              <a:avLst/>
            </a:prstGeom>
            <a:solidFill>
              <a:srgbClr val="843C0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13" name="AutoShape 24" descr="20%">
              <a:extLst>
                <a:ext uri="{FF2B5EF4-FFF2-40B4-BE49-F238E27FC236}">
                  <a16:creationId xmlns:a16="http://schemas.microsoft.com/office/drawing/2014/main" id="{CCE9AC57-3F7B-B3B7-EFEF-574F860E9158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5876581" y="2706123"/>
              <a:ext cx="1410259" cy="185673"/>
            </a:xfrm>
            <a:prstGeom prst="rtTriangle">
              <a:avLst/>
            </a:prstGeom>
            <a:solidFill>
              <a:srgbClr val="843C0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14" name="AutoShape 25" descr="20%">
              <a:extLst>
                <a:ext uri="{FF2B5EF4-FFF2-40B4-BE49-F238E27FC236}">
                  <a16:creationId xmlns:a16="http://schemas.microsoft.com/office/drawing/2014/main" id="{79BFEFC0-74BD-4AA6-4806-627ACC0C01D6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5875259" y="3003746"/>
              <a:ext cx="1411582" cy="182944"/>
            </a:xfrm>
            <a:prstGeom prst="rtTriangle">
              <a:avLst/>
            </a:prstGeom>
            <a:solidFill>
              <a:srgbClr val="843C0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15" name="AutoShape 26" descr="20%">
              <a:extLst>
                <a:ext uri="{FF2B5EF4-FFF2-40B4-BE49-F238E27FC236}">
                  <a16:creationId xmlns:a16="http://schemas.microsoft.com/office/drawing/2014/main" id="{BAA9F72E-6981-7F7A-FD3C-CD3F24C5E50E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5954156" y="6968420"/>
              <a:ext cx="1330883" cy="266224"/>
            </a:xfrm>
            <a:prstGeom prst="rtTriangle">
              <a:avLst/>
            </a:prstGeom>
            <a:solidFill>
              <a:srgbClr val="843C0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grpSp>
          <p:nvGrpSpPr>
            <p:cNvPr id="216" name="Group 27">
              <a:extLst>
                <a:ext uri="{FF2B5EF4-FFF2-40B4-BE49-F238E27FC236}">
                  <a16:creationId xmlns:a16="http://schemas.microsoft.com/office/drawing/2014/main" id="{6A13685D-880D-0E55-7661-D929D127EA90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766923" y="7010744"/>
              <a:ext cx="474938" cy="148811"/>
              <a:chOff x="2079" y="2350"/>
              <a:chExt cx="650" cy="190"/>
            </a:xfrm>
            <a:solidFill>
              <a:schemeClr val="bg1">
                <a:lumMod val="50000"/>
              </a:schemeClr>
            </a:solidFill>
          </p:grpSpPr>
          <p:sp>
            <p:nvSpPr>
              <p:cNvPr id="470" name="Oval 28">
                <a:extLst>
                  <a:ext uri="{FF2B5EF4-FFF2-40B4-BE49-F238E27FC236}">
                    <a16:creationId xmlns:a16="http://schemas.microsoft.com/office/drawing/2014/main" id="{A311FE5D-F1A6-9CC3-EE55-A15FAC0555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9" y="2421"/>
                <a:ext cx="279" cy="108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71" name="Oval 29">
                <a:extLst>
                  <a:ext uri="{FF2B5EF4-FFF2-40B4-BE49-F238E27FC236}">
                    <a16:creationId xmlns:a16="http://schemas.microsoft.com/office/drawing/2014/main" id="{E1B5EDD6-686F-36FB-3B0B-1402DD23B7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5" y="2350"/>
                <a:ext cx="162" cy="126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72" name="Oval 30">
                <a:extLst>
                  <a:ext uri="{FF2B5EF4-FFF2-40B4-BE49-F238E27FC236}">
                    <a16:creationId xmlns:a16="http://schemas.microsoft.com/office/drawing/2014/main" id="{C72BC7EC-0EDE-D92B-1709-93B1124AB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2432"/>
                <a:ext cx="108" cy="108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sp>
          <p:nvSpPr>
            <p:cNvPr id="217" name="Rectangle 39">
              <a:extLst>
                <a:ext uri="{FF2B5EF4-FFF2-40B4-BE49-F238E27FC236}">
                  <a16:creationId xmlns:a16="http://schemas.microsoft.com/office/drawing/2014/main" id="{6263CC7F-F93D-A929-7071-8B85DB76FD42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723227" y="4295869"/>
              <a:ext cx="560267" cy="74842"/>
            </a:xfrm>
            <a:prstGeom prst="rect">
              <a:avLst/>
            </a:prstGeom>
            <a:solidFill>
              <a:srgbClr val="548235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grpSp>
          <p:nvGrpSpPr>
            <p:cNvPr id="218" name="Group 57">
              <a:extLst>
                <a:ext uri="{FF2B5EF4-FFF2-40B4-BE49-F238E27FC236}">
                  <a16:creationId xmlns:a16="http://schemas.microsoft.com/office/drawing/2014/main" id="{8AFD4F26-DECB-EBB4-1048-E1F0534ABF35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743111" y="2579155"/>
              <a:ext cx="521239" cy="612994"/>
              <a:chOff x="2085" y="1876"/>
              <a:chExt cx="898" cy="613"/>
            </a:xfrm>
            <a:noFill/>
          </p:grpSpPr>
          <p:sp>
            <p:nvSpPr>
              <p:cNvPr id="464" name="Oval 58">
                <a:extLst>
                  <a:ext uri="{FF2B5EF4-FFF2-40B4-BE49-F238E27FC236}">
                    <a16:creationId xmlns:a16="http://schemas.microsoft.com/office/drawing/2014/main" id="{CC99B004-7F57-E28D-0C23-60C25FB1F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0" y="2425"/>
                <a:ext cx="153" cy="39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5" name="Oval 59">
                <a:extLst>
                  <a:ext uri="{FF2B5EF4-FFF2-40B4-BE49-F238E27FC236}">
                    <a16:creationId xmlns:a16="http://schemas.microsoft.com/office/drawing/2014/main" id="{D1A5E755-3C27-CD8C-AD76-DD39ED6677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13" y="2441"/>
                <a:ext cx="91" cy="4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6" name="Oval 60">
                <a:extLst>
                  <a:ext uri="{FF2B5EF4-FFF2-40B4-BE49-F238E27FC236}">
                    <a16:creationId xmlns:a16="http://schemas.microsoft.com/office/drawing/2014/main" id="{3E4FEF73-D88A-7CBA-AF82-C67FE941D7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47487">
                <a:off x="2549" y="2421"/>
                <a:ext cx="95" cy="68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7" name="Oval 59">
                <a:extLst>
                  <a:ext uri="{FF2B5EF4-FFF2-40B4-BE49-F238E27FC236}">
                    <a16:creationId xmlns:a16="http://schemas.microsoft.com/office/drawing/2014/main" id="{687789A4-7BD1-2651-393F-337E94507F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2" y="2412"/>
                <a:ext cx="91" cy="4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8" name="Oval 59">
                <a:extLst>
                  <a:ext uri="{FF2B5EF4-FFF2-40B4-BE49-F238E27FC236}">
                    <a16:creationId xmlns:a16="http://schemas.microsoft.com/office/drawing/2014/main" id="{7DBBA159-CE20-9B84-4C35-7427D46CA1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9" y="2103"/>
                <a:ext cx="91" cy="4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9" name="Oval 59">
                <a:extLst>
                  <a:ext uri="{FF2B5EF4-FFF2-40B4-BE49-F238E27FC236}">
                    <a16:creationId xmlns:a16="http://schemas.microsoft.com/office/drawing/2014/main" id="{CFD566F3-C8CB-3380-6201-2F510D9586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5" y="1876"/>
                <a:ext cx="91" cy="4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grpSp>
          <p:nvGrpSpPr>
            <p:cNvPr id="219" name="Group 61">
              <a:extLst>
                <a:ext uri="{FF2B5EF4-FFF2-40B4-BE49-F238E27FC236}">
                  <a16:creationId xmlns:a16="http://schemas.microsoft.com/office/drawing/2014/main" id="{91A61156-CD45-7020-C188-606EBF957DF8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806613" y="2808516"/>
              <a:ext cx="300309" cy="99662"/>
              <a:chOff x="2200" y="2440"/>
              <a:chExt cx="519" cy="100"/>
            </a:xfrm>
            <a:solidFill>
              <a:schemeClr val="bg1">
                <a:lumMod val="50000"/>
              </a:schemeClr>
            </a:solidFill>
          </p:grpSpPr>
          <p:sp>
            <p:nvSpPr>
              <p:cNvPr id="461" name="Oval 62">
                <a:extLst>
                  <a:ext uri="{FF2B5EF4-FFF2-40B4-BE49-F238E27FC236}">
                    <a16:creationId xmlns:a16="http://schemas.microsoft.com/office/drawing/2014/main" id="{FD7621E4-61E0-E206-816C-6DAC47E48E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0" y="2459"/>
                <a:ext cx="94" cy="40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2" name="Oval 63">
                <a:extLst>
                  <a:ext uri="{FF2B5EF4-FFF2-40B4-BE49-F238E27FC236}">
                    <a16:creationId xmlns:a16="http://schemas.microsoft.com/office/drawing/2014/main" id="{C0685C33-1AD2-74C4-81E3-2DC9E1BFE4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2" y="2440"/>
                <a:ext cx="139" cy="67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3" name="Oval 64">
                <a:extLst>
                  <a:ext uri="{FF2B5EF4-FFF2-40B4-BE49-F238E27FC236}">
                    <a16:creationId xmlns:a16="http://schemas.microsoft.com/office/drawing/2014/main" id="{3E43EA4D-6E40-D837-3603-510DC4EB00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2488"/>
                <a:ext cx="98" cy="52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grpSp>
          <p:nvGrpSpPr>
            <p:cNvPr id="220" name="Group 65">
              <a:extLst>
                <a:ext uri="{FF2B5EF4-FFF2-40B4-BE49-F238E27FC236}">
                  <a16:creationId xmlns:a16="http://schemas.microsoft.com/office/drawing/2014/main" id="{16E89ADD-4A4B-A8D3-C0AF-634105387A27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909801" y="2603848"/>
              <a:ext cx="297663" cy="152789"/>
              <a:chOff x="2211" y="2386"/>
              <a:chExt cx="512" cy="154"/>
            </a:xfrm>
            <a:solidFill>
              <a:schemeClr val="bg1">
                <a:lumMod val="50000"/>
              </a:schemeClr>
            </a:solidFill>
          </p:grpSpPr>
          <p:sp>
            <p:nvSpPr>
              <p:cNvPr id="458" name="Oval 66">
                <a:extLst>
                  <a:ext uri="{FF2B5EF4-FFF2-40B4-BE49-F238E27FC236}">
                    <a16:creationId xmlns:a16="http://schemas.microsoft.com/office/drawing/2014/main" id="{59D2321F-B73F-88FF-2B5B-51C37D56F4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1" y="2421"/>
                <a:ext cx="147" cy="81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59" name="Oval 67">
                <a:extLst>
                  <a:ext uri="{FF2B5EF4-FFF2-40B4-BE49-F238E27FC236}">
                    <a16:creationId xmlns:a16="http://schemas.microsoft.com/office/drawing/2014/main" id="{73CC6F43-775D-BE43-5D2C-897FB3A1E6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4459783">
                <a:off x="2425" y="2345"/>
                <a:ext cx="84" cy="166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60" name="Oval 68">
                <a:extLst>
                  <a:ext uri="{FF2B5EF4-FFF2-40B4-BE49-F238E27FC236}">
                    <a16:creationId xmlns:a16="http://schemas.microsoft.com/office/drawing/2014/main" id="{CB50E03B-7051-E26A-5D46-E564A30BDF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2478"/>
                <a:ext cx="102" cy="62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grpSp>
          <p:nvGrpSpPr>
            <p:cNvPr id="221" name="Group 75">
              <a:extLst>
                <a:ext uri="{FF2B5EF4-FFF2-40B4-BE49-F238E27FC236}">
                  <a16:creationId xmlns:a16="http://schemas.microsoft.com/office/drawing/2014/main" id="{8884CC4C-E5AC-BE79-E953-464C748997C3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023427" y="4060447"/>
              <a:ext cx="1263413" cy="135159"/>
              <a:chOff x="4764" y="1110"/>
              <a:chExt cx="891" cy="139"/>
            </a:xfrm>
            <a:solidFill>
              <a:schemeClr val="bg1">
                <a:lumMod val="75000"/>
              </a:schemeClr>
            </a:solidFill>
          </p:grpSpPr>
          <p:sp>
            <p:nvSpPr>
              <p:cNvPr id="453" name="AutoShape 70" descr="20%">
                <a:extLst>
                  <a:ext uri="{FF2B5EF4-FFF2-40B4-BE49-F238E27FC236}">
                    <a16:creationId xmlns:a16="http://schemas.microsoft.com/office/drawing/2014/main" id="{0BD31921-6D94-65A3-6D18-6B7F0C2BD2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4" y="1110"/>
                <a:ext cx="891" cy="126"/>
              </a:xfrm>
              <a:prstGeom prst="rtTriangle">
                <a:avLst/>
              </a:prstGeom>
              <a:solidFill>
                <a:srgbClr val="843C0C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grpSp>
            <p:nvGrpSpPr>
              <p:cNvPr id="454" name="Group 71">
                <a:extLst>
                  <a:ext uri="{FF2B5EF4-FFF2-40B4-BE49-F238E27FC236}">
                    <a16:creationId xmlns:a16="http://schemas.microsoft.com/office/drawing/2014/main" id="{4006E502-E318-C41E-3BD6-8ECEEA8990A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786" y="1148"/>
                <a:ext cx="291" cy="101"/>
                <a:chOff x="2079" y="2378"/>
                <a:chExt cx="496" cy="152"/>
              </a:xfrm>
              <a:grpFill/>
            </p:grpSpPr>
            <p:sp>
              <p:nvSpPr>
                <p:cNvPr id="455" name="Oval 72">
                  <a:extLst>
                    <a:ext uri="{FF2B5EF4-FFF2-40B4-BE49-F238E27FC236}">
                      <a16:creationId xmlns:a16="http://schemas.microsoft.com/office/drawing/2014/main" id="{FEBBD39C-24E4-CD4A-76F4-8372419B3D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79" y="2421"/>
                  <a:ext cx="138" cy="108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56" name="Oval 73">
                  <a:extLst>
                    <a:ext uri="{FF2B5EF4-FFF2-40B4-BE49-F238E27FC236}">
                      <a16:creationId xmlns:a16="http://schemas.microsoft.com/office/drawing/2014/main" id="{5E10FDA5-E1D6-E0F4-93A3-8BF2826766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95" y="2378"/>
                  <a:ext cx="90" cy="98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57" name="Oval 74">
                  <a:extLst>
                    <a:ext uri="{FF2B5EF4-FFF2-40B4-BE49-F238E27FC236}">
                      <a16:creationId xmlns:a16="http://schemas.microsoft.com/office/drawing/2014/main" id="{805015CA-A230-86BC-2081-7EF8ACE378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01" y="2418"/>
                  <a:ext cx="74" cy="112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</p:grpSp>
        </p:grpSp>
        <p:grpSp>
          <p:nvGrpSpPr>
            <p:cNvPr id="222" name="Gruppieren 232">
              <a:extLst>
                <a:ext uri="{FF2B5EF4-FFF2-40B4-BE49-F238E27FC236}">
                  <a16:creationId xmlns:a16="http://schemas.microsoft.com/office/drawing/2014/main" id="{AA7CA2A7-B566-D29A-6CD7-38B28C91E8D8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483292" y="4909491"/>
              <a:ext cx="801748" cy="890296"/>
              <a:chOff x="1015672" y="3821939"/>
              <a:chExt cx="1154328" cy="824244"/>
            </a:xfrm>
            <a:solidFill>
              <a:schemeClr val="bg1">
                <a:lumMod val="85000"/>
              </a:schemeClr>
            </a:solidFill>
          </p:grpSpPr>
          <p:sp>
            <p:nvSpPr>
              <p:cNvPr id="446" name="Rectangle 9" descr="70%">
                <a:extLst>
                  <a:ext uri="{FF2B5EF4-FFF2-40B4-BE49-F238E27FC236}">
                    <a16:creationId xmlns:a16="http://schemas.microsoft.com/office/drawing/2014/main" id="{6EC7C929-2669-C41D-D640-8E8FA439F3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5672" y="4454062"/>
                <a:ext cx="1144938" cy="192121"/>
              </a:xfrm>
              <a:prstGeom prst="rect">
                <a:avLst/>
              </a:prstGeom>
              <a:solidFill>
                <a:srgbClr val="F4B183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cxnSp>
            <p:nvCxnSpPr>
              <p:cNvPr id="447" name="Gerade Verbindung 522">
                <a:extLst>
                  <a:ext uri="{FF2B5EF4-FFF2-40B4-BE49-F238E27FC236}">
                    <a16:creationId xmlns:a16="http://schemas.microsoft.com/office/drawing/2014/main" id="{09B87961-5F31-F31B-8F8D-6A3C892B226E}"/>
                  </a:ext>
                </a:extLst>
              </p:cNvPr>
              <p:cNvCxnSpPr>
                <a:cxnSpLocks/>
                <a:stCxn id="446" idx="1"/>
              </p:cNvCxnSpPr>
              <p:nvPr/>
            </p:nvCxnSpPr>
            <p:spPr bwMode="auto">
              <a:xfrm>
                <a:off x="1015672" y="4550113"/>
                <a:ext cx="830450" cy="7595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8" name="Gerade Verbindung 523">
                <a:extLst>
                  <a:ext uri="{FF2B5EF4-FFF2-40B4-BE49-F238E27FC236}">
                    <a16:creationId xmlns:a16="http://schemas.microsoft.com/office/drawing/2014/main" id="{425E5218-321F-B21D-8FC8-512179D9217D}"/>
                  </a:ext>
                </a:extLst>
              </p:cNvPr>
              <p:cNvCxnSpPr/>
              <p:nvPr/>
            </p:nvCxnSpPr>
            <p:spPr bwMode="auto">
              <a:xfrm rot="10800000" flipH="1" flipV="1">
                <a:off x="1168312" y="4581722"/>
                <a:ext cx="830456" cy="2528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9" name="Gerade Verbindung 524">
                <a:extLst>
                  <a:ext uri="{FF2B5EF4-FFF2-40B4-BE49-F238E27FC236}">
                    <a16:creationId xmlns:a16="http://schemas.microsoft.com/office/drawing/2014/main" id="{E6167A82-FE38-FD5D-B6AC-ED0FB15C138D}"/>
                  </a:ext>
                </a:extLst>
              </p:cNvPr>
              <p:cNvCxnSpPr/>
              <p:nvPr/>
            </p:nvCxnSpPr>
            <p:spPr bwMode="auto">
              <a:xfrm rot="10800000" flipH="1" flipV="1">
                <a:off x="1185460" y="4275836"/>
                <a:ext cx="830456" cy="0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0" name="Gerade Verbindung 525">
                <a:extLst>
                  <a:ext uri="{FF2B5EF4-FFF2-40B4-BE49-F238E27FC236}">
                    <a16:creationId xmlns:a16="http://schemas.microsoft.com/office/drawing/2014/main" id="{ECAE1BFA-92A0-09C4-405D-87ACD2F22DCD}"/>
                  </a:ext>
                </a:extLst>
              </p:cNvPr>
              <p:cNvCxnSpPr/>
              <p:nvPr/>
            </p:nvCxnSpPr>
            <p:spPr bwMode="auto">
              <a:xfrm rot="10800000" flipH="1" flipV="1">
                <a:off x="1341449" y="4494800"/>
                <a:ext cx="828551" cy="1264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1" name="Gerade Verbindung 526">
                <a:extLst>
                  <a:ext uri="{FF2B5EF4-FFF2-40B4-BE49-F238E27FC236}">
                    <a16:creationId xmlns:a16="http://schemas.microsoft.com/office/drawing/2014/main" id="{76029CBE-D56E-5CEF-2C3D-49A4D687E53E}"/>
                  </a:ext>
                </a:extLst>
              </p:cNvPr>
              <p:cNvCxnSpPr/>
              <p:nvPr/>
            </p:nvCxnSpPr>
            <p:spPr bwMode="auto">
              <a:xfrm rot="10800000" flipH="1" flipV="1">
                <a:off x="1339543" y="4614585"/>
                <a:ext cx="830456" cy="1264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2" name="Gerade Verbindung 524">
                <a:extLst>
                  <a:ext uri="{FF2B5EF4-FFF2-40B4-BE49-F238E27FC236}">
                    <a16:creationId xmlns:a16="http://schemas.microsoft.com/office/drawing/2014/main" id="{5ADAEB0A-49BD-FF05-B750-C672616422DF}"/>
                  </a:ext>
                </a:extLst>
              </p:cNvPr>
              <p:cNvCxnSpPr/>
              <p:nvPr/>
            </p:nvCxnSpPr>
            <p:spPr bwMode="auto">
              <a:xfrm rot="10800000" flipH="1" flipV="1">
                <a:off x="1075245" y="3821939"/>
                <a:ext cx="830456" cy="0"/>
              </a:xfrm>
              <a:prstGeom prst="line">
                <a:avLst/>
              </a:prstGeom>
              <a:grpFill/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3" name="Group 27">
              <a:extLst>
                <a:ext uri="{FF2B5EF4-FFF2-40B4-BE49-F238E27FC236}">
                  <a16:creationId xmlns:a16="http://schemas.microsoft.com/office/drawing/2014/main" id="{A519354B-4500-7BCB-0264-0EA2FCBB58EC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7014315" y="6444166"/>
              <a:ext cx="235483" cy="75089"/>
              <a:chOff x="2079" y="2403"/>
              <a:chExt cx="650" cy="137"/>
            </a:xfrm>
            <a:solidFill>
              <a:schemeClr val="bg1">
                <a:lumMod val="50000"/>
              </a:schemeClr>
            </a:solidFill>
          </p:grpSpPr>
          <p:sp>
            <p:nvSpPr>
              <p:cNvPr id="443" name="Oval 28">
                <a:extLst>
                  <a:ext uri="{FF2B5EF4-FFF2-40B4-BE49-F238E27FC236}">
                    <a16:creationId xmlns:a16="http://schemas.microsoft.com/office/drawing/2014/main" id="{516000D1-7B68-3DFC-57FB-F3CE6DCF08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9" y="2421"/>
                <a:ext cx="279" cy="108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44" name="Oval 29">
                <a:extLst>
                  <a:ext uri="{FF2B5EF4-FFF2-40B4-BE49-F238E27FC236}">
                    <a16:creationId xmlns:a16="http://schemas.microsoft.com/office/drawing/2014/main" id="{68037392-F349-232A-AC9C-0A3B64ABA7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5" y="2403"/>
                <a:ext cx="162" cy="7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45" name="Oval 30">
                <a:extLst>
                  <a:ext uri="{FF2B5EF4-FFF2-40B4-BE49-F238E27FC236}">
                    <a16:creationId xmlns:a16="http://schemas.microsoft.com/office/drawing/2014/main" id="{8EBF89CD-48BC-66BA-7B4A-8BDF331D53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3" y="2468"/>
                <a:ext cx="106" cy="72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grpSp>
          <p:nvGrpSpPr>
            <p:cNvPr id="224" name="Group 27">
              <a:extLst>
                <a:ext uri="{FF2B5EF4-FFF2-40B4-BE49-F238E27FC236}">
                  <a16:creationId xmlns:a16="http://schemas.microsoft.com/office/drawing/2014/main" id="{D7337818-37F2-3AE7-51A2-A7DB60E2DD2A}"/>
                </a:ext>
              </a:extLst>
            </p:cNvPr>
            <p:cNvGrpSpPr>
              <a:grpSpLocks/>
            </p:cNvGrpSpPr>
            <p:nvPr/>
          </p:nvGrpSpPr>
          <p:grpSpPr bwMode="auto">
            <a:xfrm rot="18800903" flipH="1">
              <a:off x="7006882" y="5916413"/>
              <a:ext cx="181623" cy="185392"/>
              <a:chOff x="2079" y="2232"/>
              <a:chExt cx="573" cy="297"/>
            </a:xfrm>
            <a:solidFill>
              <a:schemeClr val="bg1">
                <a:lumMod val="50000"/>
              </a:schemeClr>
            </a:solidFill>
          </p:grpSpPr>
          <p:sp>
            <p:nvSpPr>
              <p:cNvPr id="440" name="Oval 28">
                <a:extLst>
                  <a:ext uri="{FF2B5EF4-FFF2-40B4-BE49-F238E27FC236}">
                    <a16:creationId xmlns:a16="http://schemas.microsoft.com/office/drawing/2014/main" id="{1EAD61F1-3803-FFED-5A82-61D3E6255F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062542">
                <a:off x="2079" y="2421"/>
                <a:ext cx="279" cy="108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41" name="Oval 29">
                <a:extLst>
                  <a:ext uri="{FF2B5EF4-FFF2-40B4-BE49-F238E27FC236}">
                    <a16:creationId xmlns:a16="http://schemas.microsoft.com/office/drawing/2014/main" id="{85F174B9-FC9D-1A56-AFDA-120242BC4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5" y="2350"/>
                <a:ext cx="162" cy="126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42" name="Oval 30">
                <a:extLst>
                  <a:ext uri="{FF2B5EF4-FFF2-40B4-BE49-F238E27FC236}">
                    <a16:creationId xmlns:a16="http://schemas.microsoft.com/office/drawing/2014/main" id="{AB85E120-3479-0CDD-A55F-BB948B64C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02" y="2232"/>
                <a:ext cx="150" cy="90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grpSp>
          <p:nvGrpSpPr>
            <p:cNvPr id="225" name="Group 27">
              <a:extLst>
                <a:ext uri="{FF2B5EF4-FFF2-40B4-BE49-F238E27FC236}">
                  <a16:creationId xmlns:a16="http://schemas.microsoft.com/office/drawing/2014/main" id="{081A2D92-191A-9C0F-40B0-18215F72B4E9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721804" y="6018897"/>
              <a:ext cx="235483" cy="73724"/>
              <a:chOff x="2079" y="2404"/>
              <a:chExt cx="647" cy="136"/>
            </a:xfrm>
            <a:solidFill>
              <a:schemeClr val="bg1">
                <a:lumMod val="50000"/>
              </a:schemeClr>
            </a:solidFill>
          </p:grpSpPr>
          <p:sp>
            <p:nvSpPr>
              <p:cNvPr id="437" name="Oval 28">
                <a:extLst>
                  <a:ext uri="{FF2B5EF4-FFF2-40B4-BE49-F238E27FC236}">
                    <a16:creationId xmlns:a16="http://schemas.microsoft.com/office/drawing/2014/main" id="{C9EB3B64-D138-79A2-701D-409A98CD7A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9" y="2421"/>
                <a:ext cx="279" cy="108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38" name="Oval 29">
                <a:extLst>
                  <a:ext uri="{FF2B5EF4-FFF2-40B4-BE49-F238E27FC236}">
                    <a16:creationId xmlns:a16="http://schemas.microsoft.com/office/drawing/2014/main" id="{8EAF0BB4-9AF9-A468-4F45-D771DD1235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5" y="2404"/>
                <a:ext cx="162" cy="72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sp>
            <p:nvSpPr>
              <p:cNvPr id="439" name="Oval 30">
                <a:extLst>
                  <a:ext uri="{FF2B5EF4-FFF2-40B4-BE49-F238E27FC236}">
                    <a16:creationId xmlns:a16="http://schemas.microsoft.com/office/drawing/2014/main" id="{0C9C61B2-E9B8-49DC-9B28-694EC6B1BD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2468"/>
                <a:ext cx="105" cy="72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</p:grpSp>
        <p:cxnSp>
          <p:nvCxnSpPr>
            <p:cNvPr id="226" name="Gerade Verbindung 552">
              <a:extLst>
                <a:ext uri="{FF2B5EF4-FFF2-40B4-BE49-F238E27FC236}">
                  <a16:creationId xmlns:a16="http://schemas.microsoft.com/office/drawing/2014/main" id="{B599E9CB-235A-1D5A-6741-7A507D0CB3DA}"/>
                </a:ext>
              </a:extLst>
            </p:cNvPr>
            <p:cNvCxnSpPr/>
            <p:nvPr/>
          </p:nvCxnSpPr>
          <p:spPr bwMode="auto">
            <a:xfrm flipH="1">
              <a:off x="6889957" y="4438620"/>
              <a:ext cx="181244" cy="750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Gerade Verbindung 554">
              <a:extLst>
                <a:ext uri="{FF2B5EF4-FFF2-40B4-BE49-F238E27FC236}">
                  <a16:creationId xmlns:a16="http://schemas.microsoft.com/office/drawing/2014/main" id="{1FBA47E8-D023-3A7B-8CA7-B2588DFE8E6A}"/>
                </a:ext>
              </a:extLst>
            </p:cNvPr>
            <p:cNvCxnSpPr/>
            <p:nvPr/>
          </p:nvCxnSpPr>
          <p:spPr bwMode="auto">
            <a:xfrm flipH="1">
              <a:off x="6702100" y="4438620"/>
              <a:ext cx="179921" cy="750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Gerade Verbindung 555">
              <a:extLst>
                <a:ext uri="{FF2B5EF4-FFF2-40B4-BE49-F238E27FC236}">
                  <a16:creationId xmlns:a16="http://schemas.microsoft.com/office/drawing/2014/main" id="{CE6EAD73-E88D-8C90-6D27-8024B9F0564A}"/>
                </a:ext>
              </a:extLst>
            </p:cNvPr>
            <p:cNvCxnSpPr/>
            <p:nvPr/>
          </p:nvCxnSpPr>
          <p:spPr bwMode="auto">
            <a:xfrm flipH="1">
              <a:off x="7032834" y="4509614"/>
              <a:ext cx="181244" cy="750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Gerade Verbindung 557">
              <a:extLst>
                <a:ext uri="{FF2B5EF4-FFF2-40B4-BE49-F238E27FC236}">
                  <a16:creationId xmlns:a16="http://schemas.microsoft.com/office/drawing/2014/main" id="{C049A5EF-C60F-AF2D-375C-A2CE784372AB}"/>
                </a:ext>
              </a:extLst>
            </p:cNvPr>
            <p:cNvCxnSpPr/>
            <p:nvPr/>
          </p:nvCxnSpPr>
          <p:spPr bwMode="auto">
            <a:xfrm flipH="1">
              <a:off x="6844976" y="4509614"/>
              <a:ext cx="179921" cy="750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0" name="Group 75">
              <a:extLst>
                <a:ext uri="{FF2B5EF4-FFF2-40B4-BE49-F238E27FC236}">
                  <a16:creationId xmlns:a16="http://schemas.microsoft.com/office/drawing/2014/main" id="{82B54ACE-8D19-6A68-8C5E-89ABF944519E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021626" y="7322020"/>
              <a:ext cx="1263413" cy="154272"/>
              <a:chOff x="4764" y="1110"/>
              <a:chExt cx="891" cy="126"/>
            </a:xfrm>
            <a:solidFill>
              <a:schemeClr val="bg1">
                <a:lumMod val="75000"/>
              </a:schemeClr>
            </a:solidFill>
          </p:grpSpPr>
          <p:sp>
            <p:nvSpPr>
              <p:cNvPr id="432" name="AutoShape 70" descr="20%">
                <a:extLst>
                  <a:ext uri="{FF2B5EF4-FFF2-40B4-BE49-F238E27FC236}">
                    <a16:creationId xmlns:a16="http://schemas.microsoft.com/office/drawing/2014/main" id="{72C6FAF4-FF78-8160-2670-F7259F8F6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4" y="1110"/>
                <a:ext cx="891" cy="126"/>
              </a:xfrm>
              <a:prstGeom prst="rtTriangle">
                <a:avLst/>
              </a:prstGeom>
              <a:solidFill>
                <a:srgbClr val="843C0C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grpSp>
            <p:nvGrpSpPr>
              <p:cNvPr id="433" name="Group 71">
                <a:extLst>
                  <a:ext uri="{FF2B5EF4-FFF2-40B4-BE49-F238E27FC236}">
                    <a16:creationId xmlns:a16="http://schemas.microsoft.com/office/drawing/2014/main" id="{8DBB19DA-9546-C29E-7244-B589DDB895E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786" y="1154"/>
                <a:ext cx="291" cy="82"/>
                <a:chOff x="2079" y="2418"/>
                <a:chExt cx="496" cy="125"/>
              </a:xfrm>
              <a:grpFill/>
            </p:grpSpPr>
            <p:sp>
              <p:nvSpPr>
                <p:cNvPr id="434" name="Oval 73">
                  <a:extLst>
                    <a:ext uri="{FF2B5EF4-FFF2-40B4-BE49-F238E27FC236}">
                      <a16:creationId xmlns:a16="http://schemas.microsoft.com/office/drawing/2014/main" id="{B2455144-1B1B-1291-5598-11F2A3BE50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54" y="2424"/>
                  <a:ext cx="90" cy="99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35" name="Oval 74">
                  <a:extLst>
                    <a:ext uri="{FF2B5EF4-FFF2-40B4-BE49-F238E27FC236}">
                      <a16:creationId xmlns:a16="http://schemas.microsoft.com/office/drawing/2014/main" id="{8F93A813-BFD3-8721-1D47-0F9E64638F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01" y="2418"/>
                  <a:ext cx="74" cy="100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36" name="Oval 72">
                  <a:extLst>
                    <a:ext uri="{FF2B5EF4-FFF2-40B4-BE49-F238E27FC236}">
                      <a16:creationId xmlns:a16="http://schemas.microsoft.com/office/drawing/2014/main" id="{3E166E79-E54C-0405-531F-4DF1A05ABC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79" y="2459"/>
                  <a:ext cx="100" cy="84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</p:grpSp>
        </p:grpSp>
        <p:grpSp>
          <p:nvGrpSpPr>
            <p:cNvPr id="231" name="Group 75">
              <a:extLst>
                <a:ext uri="{FF2B5EF4-FFF2-40B4-BE49-F238E27FC236}">
                  <a16:creationId xmlns:a16="http://schemas.microsoft.com/office/drawing/2014/main" id="{C3458960-40DA-A0DE-115B-3690073166AB}"/>
                </a:ext>
              </a:extLst>
            </p:cNvPr>
            <p:cNvGrpSpPr>
              <a:grpSpLocks/>
            </p:cNvGrpSpPr>
            <p:nvPr/>
          </p:nvGrpSpPr>
          <p:grpSpPr bwMode="auto">
            <a:xfrm flipH="1">
              <a:off x="6083806" y="7240104"/>
              <a:ext cx="1201233" cy="140620"/>
              <a:chOff x="4764" y="1110"/>
              <a:chExt cx="891" cy="145"/>
            </a:xfrm>
            <a:solidFill>
              <a:schemeClr val="bg1">
                <a:lumMod val="75000"/>
              </a:schemeClr>
            </a:solidFill>
          </p:grpSpPr>
          <p:sp>
            <p:nvSpPr>
              <p:cNvPr id="427" name="AutoShape 70" descr="20%">
                <a:extLst>
                  <a:ext uri="{FF2B5EF4-FFF2-40B4-BE49-F238E27FC236}">
                    <a16:creationId xmlns:a16="http://schemas.microsoft.com/office/drawing/2014/main" id="{21DA8347-FF49-6289-83AB-AA40DF46EA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4" y="1110"/>
                <a:ext cx="891" cy="126"/>
              </a:xfrm>
              <a:prstGeom prst="rtTriangle">
                <a:avLst/>
              </a:prstGeom>
              <a:solidFill>
                <a:srgbClr val="843C0C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de-DE">
                  <a:latin typeface="Calibri" pitchFamily="34" charset="0"/>
                </a:endParaRPr>
              </a:p>
            </p:txBody>
          </p:sp>
          <p:grpSp>
            <p:nvGrpSpPr>
              <p:cNvPr id="428" name="Group 71">
                <a:extLst>
                  <a:ext uri="{FF2B5EF4-FFF2-40B4-BE49-F238E27FC236}">
                    <a16:creationId xmlns:a16="http://schemas.microsoft.com/office/drawing/2014/main" id="{7071CE03-220D-15BB-D8D5-FFF04638E86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795" y="1169"/>
                <a:ext cx="332" cy="86"/>
                <a:chOff x="2079" y="2400"/>
                <a:chExt cx="562" cy="129"/>
              </a:xfrm>
              <a:grpFill/>
            </p:grpSpPr>
            <p:sp>
              <p:nvSpPr>
                <p:cNvPr id="429" name="Oval 72">
                  <a:extLst>
                    <a:ext uri="{FF2B5EF4-FFF2-40B4-BE49-F238E27FC236}">
                      <a16:creationId xmlns:a16="http://schemas.microsoft.com/office/drawing/2014/main" id="{958202BB-C7E8-F547-3D8A-ED8E89238D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79" y="2421"/>
                  <a:ext cx="138" cy="108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30" name="Oval 73">
                  <a:extLst>
                    <a:ext uri="{FF2B5EF4-FFF2-40B4-BE49-F238E27FC236}">
                      <a16:creationId xmlns:a16="http://schemas.microsoft.com/office/drawing/2014/main" id="{35646AD1-D813-52EB-AACE-09BD080345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17" y="2400"/>
                  <a:ext cx="64" cy="76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  <p:sp>
              <p:nvSpPr>
                <p:cNvPr id="431" name="Oval 74">
                  <a:extLst>
                    <a:ext uri="{FF2B5EF4-FFF2-40B4-BE49-F238E27FC236}">
                      <a16:creationId xmlns:a16="http://schemas.microsoft.com/office/drawing/2014/main" id="{D2981431-7400-664A-D2D6-EB07D37FD0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53" y="2408"/>
                  <a:ext cx="88" cy="112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>
                    <a:defRPr/>
                  </a:pPr>
                  <a:endParaRPr lang="de-DE">
                    <a:latin typeface="Calibri" pitchFamily="34" charset="0"/>
                  </a:endParaRPr>
                </a:p>
              </p:txBody>
            </p:sp>
          </p:grpSp>
        </p:grpSp>
        <p:cxnSp>
          <p:nvCxnSpPr>
            <p:cNvPr id="232" name="Gerade Verbindung 598">
              <a:extLst>
                <a:ext uri="{FF2B5EF4-FFF2-40B4-BE49-F238E27FC236}">
                  <a16:creationId xmlns:a16="http://schemas.microsoft.com/office/drawing/2014/main" id="{67E27EAC-9E0E-76EB-1927-9443D0D88456}"/>
                </a:ext>
              </a:extLst>
            </p:cNvPr>
            <p:cNvCxnSpPr/>
            <p:nvPr/>
          </p:nvCxnSpPr>
          <p:spPr bwMode="auto">
            <a:xfrm flipH="1" flipV="1">
              <a:off x="6161013" y="5313743"/>
              <a:ext cx="1113919" cy="2732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Gerade Verbindung 599">
              <a:extLst>
                <a:ext uri="{FF2B5EF4-FFF2-40B4-BE49-F238E27FC236}">
                  <a16:creationId xmlns:a16="http://schemas.microsoft.com/office/drawing/2014/main" id="{537F2660-6695-AE2A-CFA2-D621E09CD6A4}"/>
                </a:ext>
              </a:extLst>
            </p:cNvPr>
            <p:cNvCxnSpPr/>
            <p:nvPr/>
          </p:nvCxnSpPr>
          <p:spPr bwMode="auto">
            <a:xfrm flipH="1" flipV="1">
              <a:off x="6161013" y="4257043"/>
              <a:ext cx="1113919" cy="2732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Gerade Verbindung 601">
              <a:extLst>
                <a:ext uri="{FF2B5EF4-FFF2-40B4-BE49-F238E27FC236}">
                  <a16:creationId xmlns:a16="http://schemas.microsoft.com/office/drawing/2014/main" id="{F5FB18A4-6FC7-F0B4-DC54-7A2B33C0E4BB}"/>
                </a:ext>
              </a:extLst>
            </p:cNvPr>
            <p:cNvCxnSpPr/>
            <p:nvPr/>
          </p:nvCxnSpPr>
          <p:spPr bwMode="auto">
            <a:xfrm flipH="1" flipV="1">
              <a:off x="6395177" y="5158104"/>
              <a:ext cx="887696" cy="1365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Gerade Verbindung 602">
              <a:extLst>
                <a:ext uri="{FF2B5EF4-FFF2-40B4-BE49-F238E27FC236}">
                  <a16:creationId xmlns:a16="http://schemas.microsoft.com/office/drawing/2014/main" id="{FE839C13-C68F-317A-488A-8630203D435E}"/>
                </a:ext>
              </a:extLst>
            </p:cNvPr>
            <p:cNvCxnSpPr/>
            <p:nvPr/>
          </p:nvCxnSpPr>
          <p:spPr bwMode="auto">
            <a:xfrm flipH="1">
              <a:off x="6395177" y="4290408"/>
              <a:ext cx="887696" cy="2732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Gerade Verbindung 604">
              <a:extLst>
                <a:ext uri="{FF2B5EF4-FFF2-40B4-BE49-F238E27FC236}">
                  <a16:creationId xmlns:a16="http://schemas.microsoft.com/office/drawing/2014/main" id="{39B34491-AF16-5B91-C8A1-078B5774B3A3}"/>
                </a:ext>
              </a:extLst>
            </p:cNvPr>
            <p:cNvCxnSpPr/>
            <p:nvPr/>
          </p:nvCxnSpPr>
          <p:spPr bwMode="auto">
            <a:xfrm flipH="1" flipV="1">
              <a:off x="6401790" y="2495875"/>
              <a:ext cx="881083" cy="1365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Gerade Verbindung 604">
              <a:extLst>
                <a:ext uri="{FF2B5EF4-FFF2-40B4-BE49-F238E27FC236}">
                  <a16:creationId xmlns:a16="http://schemas.microsoft.com/office/drawing/2014/main" id="{56C136CE-7DFA-207C-6D6A-0D9D11CA1DA5}"/>
                </a:ext>
              </a:extLst>
            </p:cNvPr>
            <p:cNvCxnSpPr/>
            <p:nvPr/>
          </p:nvCxnSpPr>
          <p:spPr bwMode="auto">
            <a:xfrm flipH="1" flipV="1">
              <a:off x="6410212" y="2980869"/>
              <a:ext cx="881083" cy="1365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8" name="Gleichschenkliges Dreieck 7">
              <a:extLst>
                <a:ext uri="{FF2B5EF4-FFF2-40B4-BE49-F238E27FC236}">
                  <a16:creationId xmlns:a16="http://schemas.microsoft.com/office/drawing/2014/main" id="{4BECABA9-25FE-342F-9A73-DFAE46E7A4C3}"/>
                </a:ext>
              </a:extLst>
            </p:cNvPr>
            <p:cNvSpPr/>
            <p:nvPr/>
          </p:nvSpPr>
          <p:spPr>
            <a:xfrm rot="10399632" flipH="1">
              <a:off x="6932212" y="2237250"/>
              <a:ext cx="66653" cy="229005"/>
            </a:xfrm>
            <a:custGeom>
              <a:avLst/>
              <a:gdLst>
                <a:gd name="connsiteX0" fmla="*/ 0 w 131286"/>
                <a:gd name="connsiteY0" fmla="*/ 440236 h 440236"/>
                <a:gd name="connsiteX1" fmla="*/ 65643 w 131286"/>
                <a:gd name="connsiteY1" fmla="*/ 0 h 440236"/>
                <a:gd name="connsiteX2" fmla="*/ 131286 w 131286"/>
                <a:gd name="connsiteY2" fmla="*/ 440236 h 440236"/>
                <a:gd name="connsiteX3" fmla="*/ 0 w 131286"/>
                <a:gd name="connsiteY3" fmla="*/ 440236 h 440236"/>
                <a:gd name="connsiteX0" fmla="*/ 0 w 114156"/>
                <a:gd name="connsiteY0" fmla="*/ 440236 h 440236"/>
                <a:gd name="connsiteX1" fmla="*/ 65643 w 114156"/>
                <a:gd name="connsiteY1" fmla="*/ 0 h 440236"/>
                <a:gd name="connsiteX2" fmla="*/ 114156 w 114156"/>
                <a:gd name="connsiteY2" fmla="*/ 252840 h 440236"/>
                <a:gd name="connsiteX3" fmla="*/ 0 w 114156"/>
                <a:gd name="connsiteY3" fmla="*/ 440236 h 440236"/>
                <a:gd name="connsiteX0" fmla="*/ 0 w 80234"/>
                <a:gd name="connsiteY0" fmla="*/ 258854 h 258854"/>
                <a:gd name="connsiteX1" fmla="*/ 31721 w 80234"/>
                <a:gd name="connsiteY1" fmla="*/ 0 h 258854"/>
                <a:gd name="connsiteX2" fmla="*/ 80234 w 80234"/>
                <a:gd name="connsiteY2" fmla="*/ 252840 h 258854"/>
                <a:gd name="connsiteX3" fmla="*/ 0 w 80234"/>
                <a:gd name="connsiteY3" fmla="*/ 258854 h 258854"/>
                <a:gd name="connsiteX0" fmla="*/ 0 w 80234"/>
                <a:gd name="connsiteY0" fmla="*/ 220307 h 220307"/>
                <a:gd name="connsiteX1" fmla="*/ 50616 w 80234"/>
                <a:gd name="connsiteY1" fmla="*/ 0 h 220307"/>
                <a:gd name="connsiteX2" fmla="*/ 80234 w 80234"/>
                <a:gd name="connsiteY2" fmla="*/ 214293 h 220307"/>
                <a:gd name="connsiteX3" fmla="*/ 0 w 80234"/>
                <a:gd name="connsiteY3" fmla="*/ 220307 h 220307"/>
                <a:gd name="connsiteX0" fmla="*/ 0 w 50616"/>
                <a:gd name="connsiteY0" fmla="*/ 220307 h 220307"/>
                <a:gd name="connsiteX1" fmla="*/ 50616 w 50616"/>
                <a:gd name="connsiteY1" fmla="*/ 0 h 220307"/>
                <a:gd name="connsiteX2" fmla="*/ 48104 w 50616"/>
                <a:gd name="connsiteY2" fmla="*/ 206064 h 220307"/>
                <a:gd name="connsiteX3" fmla="*/ 0 w 50616"/>
                <a:gd name="connsiteY3" fmla="*/ 220307 h 220307"/>
                <a:gd name="connsiteX0" fmla="*/ 0 w 53223"/>
                <a:gd name="connsiteY0" fmla="*/ 220307 h 220307"/>
                <a:gd name="connsiteX1" fmla="*/ 50616 w 53223"/>
                <a:gd name="connsiteY1" fmla="*/ 0 h 220307"/>
                <a:gd name="connsiteX2" fmla="*/ 53112 w 53223"/>
                <a:gd name="connsiteY2" fmla="*/ 207877 h 220307"/>
                <a:gd name="connsiteX3" fmla="*/ 0 w 53223"/>
                <a:gd name="connsiteY3" fmla="*/ 220307 h 220307"/>
                <a:gd name="connsiteX0" fmla="*/ 0 w 56100"/>
                <a:gd name="connsiteY0" fmla="*/ 220307 h 220307"/>
                <a:gd name="connsiteX1" fmla="*/ 50616 w 56100"/>
                <a:gd name="connsiteY1" fmla="*/ 0 h 220307"/>
                <a:gd name="connsiteX2" fmla="*/ 56032 w 56100"/>
                <a:gd name="connsiteY2" fmla="*/ 212330 h 220307"/>
                <a:gd name="connsiteX3" fmla="*/ 0 w 56100"/>
                <a:gd name="connsiteY3" fmla="*/ 220307 h 22030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6100" h="220307">
                  <a:moveTo>
                    <a:pt x="0" y="220307"/>
                  </a:moveTo>
                  <a:lnTo>
                    <a:pt x="50616" y="0"/>
                  </a:lnTo>
                  <a:cubicBezTo>
                    <a:pt x="49779" y="68688"/>
                    <a:pt x="56869" y="143642"/>
                    <a:pt x="56032" y="212330"/>
                  </a:cubicBezTo>
                  <a:lnTo>
                    <a:pt x="0" y="220307"/>
                  </a:lnTo>
                  <a:close/>
                </a:path>
              </a:pathLst>
            </a:cu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9" name="Text Box 6">
              <a:extLst>
                <a:ext uri="{FF2B5EF4-FFF2-40B4-BE49-F238E27FC236}">
                  <a16:creationId xmlns:a16="http://schemas.microsoft.com/office/drawing/2014/main" id="{F28C860C-456B-CF6F-C208-956BFDF3DB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51404" y="2054441"/>
              <a:ext cx="595705" cy="341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900" i="1" dirty="0" err="1">
                  <a:latin typeface="+mn-lt"/>
                </a:rPr>
                <a:t>dike</a:t>
              </a:r>
              <a:endParaRPr lang="de-DE" sz="900" i="1" dirty="0">
                <a:latin typeface="+mn-lt"/>
              </a:endParaRPr>
            </a:p>
          </p:txBody>
        </p:sp>
        <p:sp>
          <p:nvSpPr>
            <p:cNvPr id="240" name="Rechteck 239">
              <a:extLst>
                <a:ext uri="{FF2B5EF4-FFF2-40B4-BE49-F238E27FC236}">
                  <a16:creationId xmlns:a16="http://schemas.microsoft.com/office/drawing/2014/main" id="{1E7B9A43-36EA-DA45-C41D-4EC3452F4C35}"/>
                </a:ext>
              </a:extLst>
            </p:cNvPr>
            <p:cNvSpPr/>
            <p:nvPr/>
          </p:nvSpPr>
          <p:spPr>
            <a:xfrm>
              <a:off x="6863318" y="4622890"/>
              <a:ext cx="419902" cy="201275"/>
            </a:xfrm>
            <a:prstGeom prst="rect">
              <a:avLst/>
            </a:prstGeom>
            <a:solidFill>
              <a:srgbClr val="CAD48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241" name="Gruppieren 240">
              <a:extLst>
                <a:ext uri="{FF2B5EF4-FFF2-40B4-BE49-F238E27FC236}">
                  <a16:creationId xmlns:a16="http://schemas.microsoft.com/office/drawing/2014/main" id="{A2DB36AD-5058-4E1F-93E3-695A2DA54BB4}"/>
                </a:ext>
              </a:extLst>
            </p:cNvPr>
            <p:cNvGrpSpPr/>
            <p:nvPr/>
          </p:nvGrpSpPr>
          <p:grpSpPr>
            <a:xfrm>
              <a:off x="5554956" y="4162458"/>
              <a:ext cx="387069" cy="2282149"/>
              <a:chOff x="5123491" y="5468921"/>
              <a:chExt cx="411297" cy="2264853"/>
            </a:xfrm>
          </p:grpSpPr>
          <p:sp>
            <p:nvSpPr>
              <p:cNvPr id="423" name="Text Box 6">
                <a:extLst>
                  <a:ext uri="{FF2B5EF4-FFF2-40B4-BE49-F238E27FC236}">
                    <a16:creationId xmlns:a16="http://schemas.microsoft.com/office/drawing/2014/main" id="{6209A2EB-1A69-FB5F-3A75-BE87A385512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23491" y="5841139"/>
                <a:ext cx="345039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1</a:t>
                </a:r>
              </a:p>
            </p:txBody>
          </p:sp>
          <p:sp>
            <p:nvSpPr>
              <p:cNvPr id="424" name="Text Box 6">
                <a:extLst>
                  <a:ext uri="{FF2B5EF4-FFF2-40B4-BE49-F238E27FC236}">
                    <a16:creationId xmlns:a16="http://schemas.microsoft.com/office/drawing/2014/main" id="{108F9A58-FAFF-EC67-D93A-02BAFA81C70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29792" y="7479858"/>
                <a:ext cx="345039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0</a:t>
                </a:r>
              </a:p>
            </p:txBody>
          </p:sp>
          <p:sp>
            <p:nvSpPr>
              <p:cNvPr id="425" name="Text Box 6">
                <a:extLst>
                  <a:ext uri="{FF2B5EF4-FFF2-40B4-BE49-F238E27FC236}">
                    <a16:creationId xmlns:a16="http://schemas.microsoft.com/office/drawing/2014/main" id="{B5D14148-62E7-4F4A-F896-6CB4149450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202024" y="5547769"/>
                <a:ext cx="411612" cy="25391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km</a:t>
                </a:r>
              </a:p>
            </p:txBody>
          </p:sp>
          <p:cxnSp>
            <p:nvCxnSpPr>
              <p:cNvPr id="426" name="Gerader Verbinder 425">
                <a:extLst>
                  <a:ext uri="{FF2B5EF4-FFF2-40B4-BE49-F238E27FC236}">
                    <a16:creationId xmlns:a16="http://schemas.microsoft.com/office/drawing/2014/main" id="{213EDED8-FB37-C488-418D-F4F76419B675}"/>
                  </a:ext>
                </a:extLst>
              </p:cNvPr>
              <p:cNvCxnSpPr/>
              <p:nvPr/>
            </p:nvCxnSpPr>
            <p:spPr>
              <a:xfrm flipV="1">
                <a:off x="5276911" y="6066489"/>
                <a:ext cx="0" cy="1440001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2" name="Rectangle 9" descr="70%">
              <a:extLst>
                <a:ext uri="{FF2B5EF4-FFF2-40B4-BE49-F238E27FC236}">
                  <a16:creationId xmlns:a16="http://schemas.microsoft.com/office/drawing/2014/main" id="{61416D4E-9F03-9EC9-B7DC-389A22CCCD55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 flipV="1">
              <a:off x="6664164" y="3656712"/>
              <a:ext cx="621784" cy="76383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cxnSp>
          <p:nvCxnSpPr>
            <p:cNvPr id="243" name="Gerade Verbindung 233">
              <a:extLst>
                <a:ext uri="{FF2B5EF4-FFF2-40B4-BE49-F238E27FC236}">
                  <a16:creationId xmlns:a16="http://schemas.microsoft.com/office/drawing/2014/main" id="{DA8C9A96-7DEF-53CB-F4F5-F5B8F2A5851F}"/>
                </a:ext>
              </a:extLst>
            </p:cNvPr>
            <p:cNvCxnSpPr/>
            <p:nvPr/>
          </p:nvCxnSpPr>
          <p:spPr>
            <a:xfrm>
              <a:off x="5365253" y="7483102"/>
              <a:ext cx="60366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4" name="Gruppieren 243">
              <a:extLst>
                <a:ext uri="{FF2B5EF4-FFF2-40B4-BE49-F238E27FC236}">
                  <a16:creationId xmlns:a16="http://schemas.microsoft.com/office/drawing/2014/main" id="{F6378D05-820E-6BEC-32C0-96EAEE5F8F1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193269" y="2207598"/>
              <a:ext cx="835404" cy="5550356"/>
              <a:chOff x="9561488" y="759269"/>
              <a:chExt cx="997744" cy="6628924"/>
            </a:xfrm>
          </p:grpSpPr>
          <p:sp>
            <p:nvSpPr>
              <p:cNvPr id="255" name="Text Box 6">
                <a:extLst>
                  <a:ext uri="{FF2B5EF4-FFF2-40B4-BE49-F238E27FC236}">
                    <a16:creationId xmlns:a16="http://schemas.microsoft.com/office/drawing/2014/main" id="{E40D5DA5-8268-EF59-0011-5612BBE4245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7" y="2233220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Q3</a:t>
                </a:r>
              </a:p>
            </p:txBody>
          </p:sp>
          <p:sp>
            <p:nvSpPr>
              <p:cNvPr id="256" name="Text Box 6">
                <a:extLst>
                  <a:ext uri="{FF2B5EF4-FFF2-40B4-BE49-F238E27FC236}">
                    <a16:creationId xmlns:a16="http://schemas.microsoft.com/office/drawing/2014/main" id="{55A70A80-E951-758F-1626-C6D1BABE56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8" y="969507"/>
                <a:ext cx="963614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I4</a:t>
                </a:r>
              </a:p>
            </p:txBody>
          </p:sp>
          <p:sp>
            <p:nvSpPr>
              <p:cNvPr id="257" name="Text Box 6">
                <a:extLst>
                  <a:ext uri="{FF2B5EF4-FFF2-40B4-BE49-F238E27FC236}">
                    <a16:creationId xmlns:a16="http://schemas.microsoft.com/office/drawing/2014/main" id="{43CDD1E2-AB85-1114-F1A0-DAF4B4125BC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0597" y="759269"/>
                <a:ext cx="963615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S4</a:t>
                </a:r>
              </a:p>
            </p:txBody>
          </p:sp>
          <p:sp>
            <p:nvSpPr>
              <p:cNvPr id="258" name="Text Box 6">
                <a:extLst>
                  <a:ext uri="{FF2B5EF4-FFF2-40B4-BE49-F238E27FC236}">
                    <a16:creationId xmlns:a16="http://schemas.microsoft.com/office/drawing/2014/main" id="{28E59D14-9034-E253-0680-A5DAB487D51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728126" y="3117977"/>
                <a:ext cx="664462" cy="3030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100" dirty="0">
                    <a:latin typeface="+mn-lt"/>
                  </a:rPr>
                  <a:t>MdL2</a:t>
                </a:r>
              </a:p>
            </p:txBody>
          </p:sp>
          <p:cxnSp>
            <p:nvCxnSpPr>
              <p:cNvPr id="390" name="Gerade Verbindung 301">
                <a:extLst>
                  <a:ext uri="{FF2B5EF4-FFF2-40B4-BE49-F238E27FC236}">
                    <a16:creationId xmlns:a16="http://schemas.microsoft.com/office/drawing/2014/main" id="{F3DD3E1C-8F2C-77FB-C36B-24AF6BC883BB}"/>
                  </a:ext>
                </a:extLst>
              </p:cNvPr>
              <p:cNvCxnSpPr/>
              <p:nvPr/>
            </p:nvCxnSpPr>
            <p:spPr>
              <a:xfrm flipH="1">
                <a:off x="9827871" y="2491183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" name="Gerade Verbindung 302">
                <a:extLst>
                  <a:ext uri="{FF2B5EF4-FFF2-40B4-BE49-F238E27FC236}">
                    <a16:creationId xmlns:a16="http://schemas.microsoft.com/office/drawing/2014/main" id="{551C2CA9-2D8B-D816-B521-C484F001E385}"/>
                  </a:ext>
                </a:extLst>
              </p:cNvPr>
              <p:cNvCxnSpPr/>
              <p:nvPr/>
            </p:nvCxnSpPr>
            <p:spPr>
              <a:xfrm flipH="1">
                <a:off x="9842315" y="7056719"/>
                <a:ext cx="544512" cy="0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1" name="Gerade Verbindung 303">
                <a:extLst>
                  <a:ext uri="{FF2B5EF4-FFF2-40B4-BE49-F238E27FC236}">
                    <a16:creationId xmlns:a16="http://schemas.microsoft.com/office/drawing/2014/main" id="{BF54C96F-C903-DD55-1061-F6329FE0F5A6}"/>
                  </a:ext>
                </a:extLst>
              </p:cNvPr>
              <p:cNvCxnSpPr/>
              <p:nvPr/>
            </p:nvCxnSpPr>
            <p:spPr>
              <a:xfrm flipH="1">
                <a:off x="9842315" y="6468412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Gerade Verbindung 304">
                <a:extLst>
                  <a:ext uri="{FF2B5EF4-FFF2-40B4-BE49-F238E27FC236}">
                    <a16:creationId xmlns:a16="http://schemas.microsoft.com/office/drawing/2014/main" id="{73E6D709-B3EF-9B37-BEA0-1877F86470F8}"/>
                  </a:ext>
                </a:extLst>
              </p:cNvPr>
              <p:cNvCxnSpPr/>
              <p:nvPr/>
            </p:nvCxnSpPr>
            <p:spPr>
              <a:xfrm flipH="1">
                <a:off x="9842315" y="5059167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Gerade Verbindung 305">
                <a:extLst>
                  <a:ext uri="{FF2B5EF4-FFF2-40B4-BE49-F238E27FC236}">
                    <a16:creationId xmlns:a16="http://schemas.microsoft.com/office/drawing/2014/main" id="{0B76696C-4571-B2DD-28FC-BE4FE9AD3013}"/>
                  </a:ext>
                </a:extLst>
              </p:cNvPr>
              <p:cNvCxnSpPr/>
              <p:nvPr/>
            </p:nvCxnSpPr>
            <p:spPr>
              <a:xfrm flipH="1">
                <a:off x="9811933" y="3361760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6" name="Gerade Verbindung 306">
                <a:extLst>
                  <a:ext uri="{FF2B5EF4-FFF2-40B4-BE49-F238E27FC236}">
                    <a16:creationId xmlns:a16="http://schemas.microsoft.com/office/drawing/2014/main" id="{DF1E0664-1840-3ADE-C2BB-228F5BF74288}"/>
                  </a:ext>
                </a:extLst>
              </p:cNvPr>
              <p:cNvCxnSpPr/>
              <p:nvPr/>
            </p:nvCxnSpPr>
            <p:spPr>
              <a:xfrm flipH="1">
                <a:off x="9842317" y="3648558"/>
                <a:ext cx="544513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7" name="Gerade Verbindung 307">
                <a:extLst>
                  <a:ext uri="{FF2B5EF4-FFF2-40B4-BE49-F238E27FC236}">
                    <a16:creationId xmlns:a16="http://schemas.microsoft.com/office/drawing/2014/main" id="{CC662064-8B74-4FE5-6164-4D36B4851539}"/>
                  </a:ext>
                </a:extLst>
              </p:cNvPr>
              <p:cNvCxnSpPr/>
              <p:nvPr/>
            </p:nvCxnSpPr>
            <p:spPr>
              <a:xfrm flipH="1">
                <a:off x="9811932" y="2296493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8" name="Text Box 6">
                <a:extLst>
                  <a:ext uri="{FF2B5EF4-FFF2-40B4-BE49-F238E27FC236}">
                    <a16:creationId xmlns:a16="http://schemas.microsoft.com/office/drawing/2014/main" id="{1689882F-4BA0-1F8F-4EF2-57234E5E60B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6" y="6777061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 err="1">
                    <a:latin typeface="+mn-lt"/>
                  </a:rPr>
                  <a:t>MdbC</a:t>
                </a:r>
                <a:endParaRPr lang="de-DE" sz="1050" dirty="0">
                  <a:latin typeface="+mn-lt"/>
                </a:endParaRPr>
              </a:p>
            </p:txBody>
          </p:sp>
          <p:sp>
            <p:nvSpPr>
              <p:cNvPr id="409" name="Text Box 6">
                <a:extLst>
                  <a:ext uri="{FF2B5EF4-FFF2-40B4-BE49-F238E27FC236}">
                    <a16:creationId xmlns:a16="http://schemas.microsoft.com/office/drawing/2014/main" id="{8D62DFDF-4CA6-D44B-6AFF-BD51C24B274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6" y="5654699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Q1</a:t>
                </a:r>
              </a:p>
            </p:txBody>
          </p:sp>
          <p:sp>
            <p:nvSpPr>
              <p:cNvPr id="411" name="Text Box 6">
                <a:extLst>
                  <a:ext uri="{FF2B5EF4-FFF2-40B4-BE49-F238E27FC236}">
                    <a16:creationId xmlns:a16="http://schemas.microsoft.com/office/drawing/2014/main" id="{2061EC8E-8EFA-51F7-E446-1D1E1126154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6" y="4152925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S1</a:t>
                </a:r>
              </a:p>
            </p:txBody>
          </p:sp>
          <p:sp>
            <p:nvSpPr>
              <p:cNvPr id="412" name="Text Box 6">
                <a:extLst>
                  <a:ext uri="{FF2B5EF4-FFF2-40B4-BE49-F238E27FC236}">
                    <a16:creationId xmlns:a16="http://schemas.microsoft.com/office/drawing/2014/main" id="{78F8B752-F622-5504-A178-3C4525596F4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4" y="3379746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Q2</a:t>
                </a:r>
              </a:p>
            </p:txBody>
          </p:sp>
          <p:sp>
            <p:nvSpPr>
              <p:cNvPr id="413" name="Text Box 6">
                <a:extLst>
                  <a:ext uri="{FF2B5EF4-FFF2-40B4-BE49-F238E27FC236}">
                    <a16:creationId xmlns:a16="http://schemas.microsoft.com/office/drawing/2014/main" id="{C5E757C1-C15F-D384-6700-AEAF7A74AD4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81396" y="2591171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S2</a:t>
                </a:r>
              </a:p>
            </p:txBody>
          </p:sp>
          <p:sp>
            <p:nvSpPr>
              <p:cNvPr id="414" name="Text Box 6">
                <a:extLst>
                  <a:ext uri="{FF2B5EF4-FFF2-40B4-BE49-F238E27FC236}">
                    <a16:creationId xmlns:a16="http://schemas.microsoft.com/office/drawing/2014/main" id="{92A1D13C-6435-20C2-126A-2E90F597D4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6" y="1633113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S3</a:t>
                </a:r>
              </a:p>
            </p:txBody>
          </p:sp>
          <p:sp>
            <p:nvSpPr>
              <p:cNvPr id="418" name="Text Box 6">
                <a:extLst>
                  <a:ext uri="{FF2B5EF4-FFF2-40B4-BE49-F238E27FC236}">
                    <a16:creationId xmlns:a16="http://schemas.microsoft.com/office/drawing/2014/main" id="{B771009B-7584-BD53-3CEC-3D13DACA7A3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5616" y="7094033"/>
                <a:ext cx="963612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FT Sch</a:t>
                </a:r>
              </a:p>
            </p:txBody>
          </p:sp>
          <p:cxnSp>
            <p:nvCxnSpPr>
              <p:cNvPr id="420" name="Gerade Verbindung 413">
                <a:extLst>
                  <a:ext uri="{FF2B5EF4-FFF2-40B4-BE49-F238E27FC236}">
                    <a16:creationId xmlns:a16="http://schemas.microsoft.com/office/drawing/2014/main" id="{B575E015-801A-9603-B322-2268054FC73D}"/>
                  </a:ext>
                </a:extLst>
              </p:cNvPr>
              <p:cNvCxnSpPr/>
              <p:nvPr/>
            </p:nvCxnSpPr>
            <p:spPr>
              <a:xfrm flipH="1">
                <a:off x="9842316" y="1233520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Gerade Verbindung 414">
                <a:extLst>
                  <a:ext uri="{FF2B5EF4-FFF2-40B4-BE49-F238E27FC236}">
                    <a16:creationId xmlns:a16="http://schemas.microsoft.com/office/drawing/2014/main" id="{EFF44254-C44F-BBEB-74B2-A33C18C36B3B}"/>
                  </a:ext>
                </a:extLst>
              </p:cNvPr>
              <p:cNvCxnSpPr/>
              <p:nvPr/>
            </p:nvCxnSpPr>
            <p:spPr>
              <a:xfrm flipH="1">
                <a:off x="9842316" y="814411"/>
                <a:ext cx="544512" cy="0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2" name="Text Box 6">
                <a:extLst>
                  <a:ext uri="{FF2B5EF4-FFF2-40B4-BE49-F238E27FC236}">
                    <a16:creationId xmlns:a16="http://schemas.microsoft.com/office/drawing/2014/main" id="{455DB14C-4A44-E727-0F20-0AC9C09D714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61488" y="2908114"/>
                <a:ext cx="963613" cy="29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de-DE" sz="1050" dirty="0">
                    <a:latin typeface="+mn-lt"/>
                  </a:rPr>
                  <a:t>MdI2</a:t>
                </a:r>
              </a:p>
            </p:txBody>
          </p:sp>
        </p:grpSp>
        <p:sp>
          <p:nvSpPr>
            <p:cNvPr id="245" name="Freihandform 691">
              <a:extLst>
                <a:ext uri="{FF2B5EF4-FFF2-40B4-BE49-F238E27FC236}">
                  <a16:creationId xmlns:a16="http://schemas.microsoft.com/office/drawing/2014/main" id="{490D435A-E401-9964-21E6-22C4B1B530BC}"/>
                </a:ext>
              </a:extLst>
            </p:cNvPr>
            <p:cNvSpPr/>
            <p:nvPr/>
          </p:nvSpPr>
          <p:spPr>
            <a:xfrm>
              <a:off x="7104709" y="4228035"/>
              <a:ext cx="758357" cy="83222"/>
            </a:xfrm>
            <a:custGeom>
              <a:avLst/>
              <a:gdLst>
                <a:gd name="connsiteX0" fmla="*/ 0 w 600075"/>
                <a:gd name="connsiteY0" fmla="*/ 157162 h 157162"/>
                <a:gd name="connsiteX1" fmla="*/ 271463 w 600075"/>
                <a:gd name="connsiteY1" fmla="*/ 157162 h 157162"/>
                <a:gd name="connsiteX2" fmla="*/ 385763 w 600075"/>
                <a:gd name="connsiteY2" fmla="*/ 4762 h 157162"/>
                <a:gd name="connsiteX3" fmla="*/ 600075 w 600075"/>
                <a:gd name="connsiteY3" fmla="*/ 0 h 157162"/>
                <a:gd name="connsiteX0" fmla="*/ 0 w 600075"/>
                <a:gd name="connsiteY0" fmla="*/ 157162 h 166984"/>
                <a:gd name="connsiteX1" fmla="*/ 111919 w 600075"/>
                <a:gd name="connsiteY1" fmla="*/ 166984 h 166984"/>
                <a:gd name="connsiteX2" fmla="*/ 385763 w 600075"/>
                <a:gd name="connsiteY2" fmla="*/ 4762 h 166984"/>
                <a:gd name="connsiteX3" fmla="*/ 600075 w 600075"/>
                <a:gd name="connsiteY3" fmla="*/ 0 h 166984"/>
                <a:gd name="connsiteX0" fmla="*/ 0 w 600075"/>
                <a:gd name="connsiteY0" fmla="*/ 157310 h 167132"/>
                <a:gd name="connsiteX1" fmla="*/ 111919 w 600075"/>
                <a:gd name="connsiteY1" fmla="*/ 167132 h 167132"/>
                <a:gd name="connsiteX2" fmla="*/ 145256 w 600075"/>
                <a:gd name="connsiteY2" fmla="*/ 0 h 167132"/>
                <a:gd name="connsiteX3" fmla="*/ 600075 w 600075"/>
                <a:gd name="connsiteY3" fmla="*/ 148 h 167132"/>
                <a:gd name="connsiteX0" fmla="*/ 0 w 600075"/>
                <a:gd name="connsiteY0" fmla="*/ 176956 h 176956"/>
                <a:gd name="connsiteX1" fmla="*/ 111919 w 600075"/>
                <a:gd name="connsiteY1" fmla="*/ 167132 h 176956"/>
                <a:gd name="connsiteX2" fmla="*/ 145256 w 600075"/>
                <a:gd name="connsiteY2" fmla="*/ 0 h 176956"/>
                <a:gd name="connsiteX3" fmla="*/ 600075 w 600075"/>
                <a:gd name="connsiteY3" fmla="*/ 148 h 176956"/>
                <a:gd name="connsiteX0" fmla="*/ 0 w 597694"/>
                <a:gd name="connsiteY0" fmla="*/ 167132 h 167132"/>
                <a:gd name="connsiteX1" fmla="*/ 109538 w 597694"/>
                <a:gd name="connsiteY1" fmla="*/ 167132 h 167132"/>
                <a:gd name="connsiteX2" fmla="*/ 142875 w 597694"/>
                <a:gd name="connsiteY2" fmla="*/ 0 h 167132"/>
                <a:gd name="connsiteX3" fmla="*/ 597694 w 597694"/>
                <a:gd name="connsiteY3" fmla="*/ 148 h 167132"/>
                <a:gd name="connsiteX0" fmla="*/ 0 w 597694"/>
                <a:gd name="connsiteY0" fmla="*/ 176954 h 176954"/>
                <a:gd name="connsiteX1" fmla="*/ 109538 w 597694"/>
                <a:gd name="connsiteY1" fmla="*/ 176954 h 176954"/>
                <a:gd name="connsiteX2" fmla="*/ 142875 w 597694"/>
                <a:gd name="connsiteY2" fmla="*/ 0 h 176954"/>
                <a:gd name="connsiteX3" fmla="*/ 597694 w 597694"/>
                <a:gd name="connsiteY3" fmla="*/ 9970 h 176954"/>
                <a:gd name="connsiteX0" fmla="*/ 0 w 781812"/>
                <a:gd name="connsiteY0" fmla="*/ 176954 h 176954"/>
                <a:gd name="connsiteX1" fmla="*/ 109538 w 781812"/>
                <a:gd name="connsiteY1" fmla="*/ 176954 h 176954"/>
                <a:gd name="connsiteX2" fmla="*/ 142875 w 781812"/>
                <a:gd name="connsiteY2" fmla="*/ 0 h 176954"/>
                <a:gd name="connsiteX3" fmla="*/ 781812 w 781812"/>
                <a:gd name="connsiteY3" fmla="*/ 9970 h 1769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81812" h="176954">
                  <a:moveTo>
                    <a:pt x="0" y="176954"/>
                  </a:moveTo>
                  <a:lnTo>
                    <a:pt x="109538" y="176954"/>
                  </a:lnTo>
                  <a:lnTo>
                    <a:pt x="142875" y="0"/>
                  </a:lnTo>
                  <a:lnTo>
                    <a:pt x="781812" y="9970"/>
                  </a:lnTo>
                </a:path>
              </a:pathLst>
            </a:custGeom>
            <a:noFill/>
            <a:ln w="317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46" name="Freihandform 692">
              <a:extLst>
                <a:ext uri="{FF2B5EF4-FFF2-40B4-BE49-F238E27FC236}">
                  <a16:creationId xmlns:a16="http://schemas.microsoft.com/office/drawing/2014/main" id="{C7E406C1-ADEF-5302-FB96-E6D3D3C7CFBD}"/>
                </a:ext>
              </a:extLst>
            </p:cNvPr>
            <p:cNvSpPr/>
            <p:nvPr/>
          </p:nvSpPr>
          <p:spPr>
            <a:xfrm>
              <a:off x="7100333" y="4049891"/>
              <a:ext cx="770191" cy="228862"/>
            </a:xfrm>
            <a:custGeom>
              <a:avLst/>
              <a:gdLst>
                <a:gd name="connsiteX0" fmla="*/ 0 w 600075"/>
                <a:gd name="connsiteY0" fmla="*/ 157162 h 157162"/>
                <a:gd name="connsiteX1" fmla="*/ 271463 w 600075"/>
                <a:gd name="connsiteY1" fmla="*/ 157162 h 157162"/>
                <a:gd name="connsiteX2" fmla="*/ 385763 w 600075"/>
                <a:gd name="connsiteY2" fmla="*/ 4762 h 157162"/>
                <a:gd name="connsiteX3" fmla="*/ 600075 w 600075"/>
                <a:gd name="connsiteY3" fmla="*/ 0 h 157162"/>
                <a:gd name="connsiteX0" fmla="*/ 0 w 600075"/>
                <a:gd name="connsiteY0" fmla="*/ 157162 h 158799"/>
                <a:gd name="connsiteX1" fmla="*/ 92870 w 600075"/>
                <a:gd name="connsiteY1" fmla="*/ 158799 h 158799"/>
                <a:gd name="connsiteX2" fmla="*/ 385763 w 600075"/>
                <a:gd name="connsiteY2" fmla="*/ 4762 h 158799"/>
                <a:gd name="connsiteX3" fmla="*/ 600075 w 600075"/>
                <a:gd name="connsiteY3" fmla="*/ 0 h 158799"/>
                <a:gd name="connsiteX0" fmla="*/ 0 w 600075"/>
                <a:gd name="connsiteY0" fmla="*/ 160587 h 162224"/>
                <a:gd name="connsiteX1" fmla="*/ 92870 w 600075"/>
                <a:gd name="connsiteY1" fmla="*/ 162224 h 162224"/>
                <a:gd name="connsiteX2" fmla="*/ 159544 w 600075"/>
                <a:gd name="connsiteY2" fmla="*/ 0 h 162224"/>
                <a:gd name="connsiteX3" fmla="*/ 600075 w 600075"/>
                <a:gd name="connsiteY3" fmla="*/ 3425 h 162224"/>
                <a:gd name="connsiteX0" fmla="*/ 0 w 794011"/>
                <a:gd name="connsiteY0" fmla="*/ 160587 h 162224"/>
                <a:gd name="connsiteX1" fmla="*/ 92870 w 794011"/>
                <a:gd name="connsiteY1" fmla="*/ 162224 h 162224"/>
                <a:gd name="connsiteX2" fmla="*/ 159544 w 794011"/>
                <a:gd name="connsiteY2" fmla="*/ 0 h 162224"/>
                <a:gd name="connsiteX3" fmla="*/ 794011 w 794011"/>
                <a:gd name="connsiteY3" fmla="*/ 5113 h 1622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94011" h="162224">
                  <a:moveTo>
                    <a:pt x="0" y="160587"/>
                  </a:moveTo>
                  <a:lnTo>
                    <a:pt x="92870" y="162224"/>
                  </a:lnTo>
                  <a:lnTo>
                    <a:pt x="159544" y="0"/>
                  </a:lnTo>
                  <a:lnTo>
                    <a:pt x="794011" y="5113"/>
                  </a:lnTo>
                </a:path>
              </a:pathLst>
            </a:custGeom>
            <a:noFill/>
            <a:ln w="317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47" name="Rechteck 246">
              <a:extLst>
                <a:ext uri="{FF2B5EF4-FFF2-40B4-BE49-F238E27FC236}">
                  <a16:creationId xmlns:a16="http://schemas.microsoft.com/office/drawing/2014/main" id="{BF7C28EC-1A43-6BCB-4E87-33D940DB547C}"/>
                </a:ext>
              </a:extLst>
            </p:cNvPr>
            <p:cNvSpPr/>
            <p:nvPr/>
          </p:nvSpPr>
          <p:spPr>
            <a:xfrm>
              <a:off x="6866935" y="3733574"/>
              <a:ext cx="419902" cy="52368"/>
            </a:xfrm>
            <a:prstGeom prst="rect">
              <a:avLst/>
            </a:prstGeom>
            <a:solidFill>
              <a:srgbClr val="CAD48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48" name="Rectangle 9" descr="70%">
              <a:extLst>
                <a:ext uri="{FF2B5EF4-FFF2-40B4-BE49-F238E27FC236}">
                  <a16:creationId xmlns:a16="http://schemas.microsoft.com/office/drawing/2014/main" id="{810CC14C-F5ED-4620-4735-5F25E9465EA0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 flipV="1">
              <a:off x="6664749" y="3785234"/>
              <a:ext cx="621784" cy="89561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49" name="Rectangle 9" descr="70%">
              <a:extLst>
                <a:ext uri="{FF2B5EF4-FFF2-40B4-BE49-F238E27FC236}">
                  <a16:creationId xmlns:a16="http://schemas.microsoft.com/office/drawing/2014/main" id="{3FB95DA4-48C3-FA6F-A3AC-7933E269B15A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661747" y="3330942"/>
              <a:ext cx="625091" cy="116154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50" name="Rechteck 249">
              <a:extLst>
                <a:ext uri="{FF2B5EF4-FFF2-40B4-BE49-F238E27FC236}">
                  <a16:creationId xmlns:a16="http://schemas.microsoft.com/office/drawing/2014/main" id="{9240C22E-DC91-8CF3-67D8-AC0401A3AFF1}"/>
                </a:ext>
              </a:extLst>
            </p:cNvPr>
            <p:cNvSpPr/>
            <p:nvPr/>
          </p:nvSpPr>
          <p:spPr>
            <a:xfrm>
              <a:off x="6863911" y="3280571"/>
              <a:ext cx="419902" cy="52368"/>
            </a:xfrm>
            <a:prstGeom prst="rect">
              <a:avLst/>
            </a:prstGeom>
            <a:solidFill>
              <a:srgbClr val="CAD48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1" name="Rechteck 250">
              <a:extLst>
                <a:ext uri="{FF2B5EF4-FFF2-40B4-BE49-F238E27FC236}">
                  <a16:creationId xmlns:a16="http://schemas.microsoft.com/office/drawing/2014/main" id="{D438750D-F398-B7E8-5591-37E5359D0EF5}"/>
                </a:ext>
              </a:extLst>
            </p:cNvPr>
            <p:cNvSpPr/>
            <p:nvPr/>
          </p:nvSpPr>
          <p:spPr>
            <a:xfrm>
              <a:off x="6867394" y="3448964"/>
              <a:ext cx="419902" cy="52368"/>
            </a:xfrm>
            <a:prstGeom prst="rect">
              <a:avLst/>
            </a:prstGeom>
            <a:solidFill>
              <a:srgbClr val="CAD48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252" name="Gerade Verbindung 599">
              <a:extLst>
                <a:ext uri="{FF2B5EF4-FFF2-40B4-BE49-F238E27FC236}">
                  <a16:creationId xmlns:a16="http://schemas.microsoft.com/office/drawing/2014/main" id="{8B6C06A0-8648-E634-593C-1B88294226C5}"/>
                </a:ext>
              </a:extLst>
            </p:cNvPr>
            <p:cNvCxnSpPr/>
            <p:nvPr/>
          </p:nvCxnSpPr>
          <p:spPr bwMode="auto">
            <a:xfrm flipH="1" flipV="1">
              <a:off x="6167137" y="3340471"/>
              <a:ext cx="1113919" cy="2732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AutoShape 24" descr="20%">
              <a:extLst>
                <a:ext uri="{FF2B5EF4-FFF2-40B4-BE49-F238E27FC236}">
                  <a16:creationId xmlns:a16="http://schemas.microsoft.com/office/drawing/2014/main" id="{14D1F438-C8BB-ADFA-43EE-9D542AF637F5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5876580" y="3550683"/>
              <a:ext cx="1410259" cy="103465"/>
            </a:xfrm>
            <a:prstGeom prst="rtTriangle">
              <a:avLst/>
            </a:prstGeom>
            <a:solidFill>
              <a:srgbClr val="843C0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  <p:sp>
          <p:nvSpPr>
            <p:cNvPr id="254" name="Rectangle 9" descr="70%">
              <a:extLst>
                <a:ext uri="{FF2B5EF4-FFF2-40B4-BE49-F238E27FC236}">
                  <a16:creationId xmlns:a16="http://schemas.microsoft.com/office/drawing/2014/main" id="{BBDB8569-31EA-5C4A-B8DA-F06CF7C57B76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 flipV="1">
              <a:off x="6665035" y="3504597"/>
              <a:ext cx="621784" cy="58057"/>
            </a:xfrm>
            <a:prstGeom prst="rect">
              <a:avLst/>
            </a:prstGeom>
            <a:solidFill>
              <a:srgbClr val="FFE6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>
                <a:defRPr/>
              </a:pPr>
              <a:endParaRPr lang="de-DE">
                <a:latin typeface="Calibri" pitchFamily="34" charset="0"/>
              </a:endParaRPr>
            </a:p>
          </p:txBody>
        </p:sp>
      </p:grpSp>
      <p:grpSp>
        <p:nvGrpSpPr>
          <p:cNvPr id="476" name="Gruppieren 475">
            <a:extLst>
              <a:ext uri="{FF2B5EF4-FFF2-40B4-BE49-F238E27FC236}">
                <a16:creationId xmlns:a16="http://schemas.microsoft.com/office/drawing/2014/main" id="{33D2CA1F-6887-3357-673D-4209E74C133A}"/>
              </a:ext>
            </a:extLst>
          </p:cNvPr>
          <p:cNvGrpSpPr/>
          <p:nvPr/>
        </p:nvGrpSpPr>
        <p:grpSpPr>
          <a:xfrm>
            <a:off x="160305" y="4393890"/>
            <a:ext cx="2258997" cy="2003989"/>
            <a:chOff x="-959193" y="5793329"/>
            <a:chExt cx="2258997" cy="2003989"/>
          </a:xfrm>
        </p:grpSpPr>
        <p:sp>
          <p:nvSpPr>
            <p:cNvPr id="477" name="Freeform 77">
              <a:extLst>
                <a:ext uri="{FF2B5EF4-FFF2-40B4-BE49-F238E27FC236}">
                  <a16:creationId xmlns:a16="http://schemas.microsoft.com/office/drawing/2014/main" id="{B90C069B-6A99-A7D6-9039-B73CAA4AF725}"/>
                </a:ext>
              </a:extLst>
            </p:cNvPr>
            <p:cNvSpPr>
              <a:spLocks/>
            </p:cNvSpPr>
            <p:nvPr/>
          </p:nvSpPr>
          <p:spPr bwMode="auto">
            <a:xfrm>
              <a:off x="-959193" y="6132713"/>
              <a:ext cx="2258997" cy="1664605"/>
            </a:xfrm>
            <a:custGeom>
              <a:avLst/>
              <a:gdLst>
                <a:gd name="T0" fmla="*/ 509 w 516"/>
                <a:gd name="T1" fmla="*/ 181 h 380"/>
                <a:gd name="T2" fmla="*/ 508 w 516"/>
                <a:gd name="T3" fmla="*/ 191 h 380"/>
                <a:gd name="T4" fmla="*/ 492 w 516"/>
                <a:gd name="T5" fmla="*/ 229 h 380"/>
                <a:gd name="T6" fmla="*/ 485 w 516"/>
                <a:gd name="T7" fmla="*/ 245 h 380"/>
                <a:gd name="T8" fmla="*/ 481 w 516"/>
                <a:gd name="T9" fmla="*/ 264 h 380"/>
                <a:gd name="T10" fmla="*/ 483 w 516"/>
                <a:gd name="T11" fmla="*/ 296 h 380"/>
                <a:gd name="T12" fmla="*/ 478 w 516"/>
                <a:gd name="T13" fmla="*/ 308 h 380"/>
                <a:gd name="T14" fmla="*/ 474 w 516"/>
                <a:gd name="T15" fmla="*/ 333 h 380"/>
                <a:gd name="T16" fmla="*/ 462 w 516"/>
                <a:gd name="T17" fmla="*/ 354 h 380"/>
                <a:gd name="T18" fmla="*/ 454 w 516"/>
                <a:gd name="T19" fmla="*/ 358 h 380"/>
                <a:gd name="T20" fmla="*/ 448 w 516"/>
                <a:gd name="T21" fmla="*/ 361 h 380"/>
                <a:gd name="T22" fmla="*/ 445 w 516"/>
                <a:gd name="T23" fmla="*/ 364 h 380"/>
                <a:gd name="T24" fmla="*/ 442 w 516"/>
                <a:gd name="T25" fmla="*/ 372 h 380"/>
                <a:gd name="T26" fmla="*/ 440 w 516"/>
                <a:gd name="T27" fmla="*/ 380 h 380"/>
                <a:gd name="T28" fmla="*/ 0 w 516"/>
                <a:gd name="T29" fmla="*/ 380 h 380"/>
                <a:gd name="T30" fmla="*/ 0 w 516"/>
                <a:gd name="T31" fmla="*/ 77 h 380"/>
                <a:gd name="T32" fmla="*/ 14 w 516"/>
                <a:gd name="T33" fmla="*/ 64 h 380"/>
                <a:gd name="T34" fmla="*/ 30 w 516"/>
                <a:gd name="T35" fmla="*/ 46 h 380"/>
                <a:gd name="T36" fmla="*/ 39 w 516"/>
                <a:gd name="T37" fmla="*/ 31 h 380"/>
                <a:gd name="T38" fmla="*/ 53 w 516"/>
                <a:gd name="T39" fmla="*/ 15 h 380"/>
                <a:gd name="T40" fmla="*/ 91 w 516"/>
                <a:gd name="T41" fmla="*/ 21 h 380"/>
                <a:gd name="T42" fmla="*/ 129 w 516"/>
                <a:gd name="T43" fmla="*/ 49 h 380"/>
                <a:gd name="T44" fmla="*/ 153 w 516"/>
                <a:gd name="T45" fmla="*/ 66 h 380"/>
                <a:gd name="T46" fmla="*/ 190 w 516"/>
                <a:gd name="T47" fmla="*/ 84 h 380"/>
                <a:gd name="T48" fmla="*/ 228 w 516"/>
                <a:gd name="T49" fmla="*/ 82 h 380"/>
                <a:gd name="T50" fmla="*/ 259 w 516"/>
                <a:gd name="T51" fmla="*/ 82 h 380"/>
                <a:gd name="T52" fmla="*/ 284 w 516"/>
                <a:gd name="T53" fmla="*/ 86 h 380"/>
                <a:gd name="T54" fmla="*/ 307 w 516"/>
                <a:gd name="T55" fmla="*/ 86 h 380"/>
                <a:gd name="T56" fmla="*/ 320 w 516"/>
                <a:gd name="T57" fmla="*/ 88 h 380"/>
                <a:gd name="T58" fmla="*/ 338 w 516"/>
                <a:gd name="T59" fmla="*/ 104 h 380"/>
                <a:gd name="T60" fmla="*/ 351 w 516"/>
                <a:gd name="T61" fmla="*/ 114 h 380"/>
                <a:gd name="T62" fmla="*/ 387 w 516"/>
                <a:gd name="T63" fmla="*/ 129 h 380"/>
                <a:gd name="T64" fmla="*/ 418 w 516"/>
                <a:gd name="T65" fmla="*/ 124 h 380"/>
                <a:gd name="T66" fmla="*/ 421 w 516"/>
                <a:gd name="T67" fmla="*/ 139 h 380"/>
                <a:gd name="T68" fmla="*/ 428 w 516"/>
                <a:gd name="T69" fmla="*/ 145 h 380"/>
                <a:gd name="T70" fmla="*/ 465 w 516"/>
                <a:gd name="T71" fmla="*/ 155 h 380"/>
                <a:gd name="T72" fmla="*/ 488 w 516"/>
                <a:gd name="T73" fmla="*/ 160 h 380"/>
                <a:gd name="T74" fmla="*/ 499 w 516"/>
                <a:gd name="T75" fmla="*/ 162 h 380"/>
                <a:gd name="T76" fmla="*/ 509 w 516"/>
                <a:gd name="T77" fmla="*/ 160 h 380"/>
                <a:gd name="T78" fmla="*/ 509 w 516"/>
                <a:gd name="T79" fmla="*/ 181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516" h="380">
                  <a:moveTo>
                    <a:pt x="509" y="181"/>
                  </a:moveTo>
                  <a:cubicBezTo>
                    <a:pt x="516" y="177"/>
                    <a:pt x="512" y="184"/>
                    <a:pt x="508" y="191"/>
                  </a:cubicBezTo>
                  <a:cubicBezTo>
                    <a:pt x="503" y="198"/>
                    <a:pt x="495" y="219"/>
                    <a:pt x="492" y="229"/>
                  </a:cubicBezTo>
                  <a:cubicBezTo>
                    <a:pt x="489" y="240"/>
                    <a:pt x="486" y="242"/>
                    <a:pt x="485" y="245"/>
                  </a:cubicBezTo>
                  <a:cubicBezTo>
                    <a:pt x="483" y="248"/>
                    <a:pt x="481" y="264"/>
                    <a:pt x="481" y="264"/>
                  </a:cubicBezTo>
                  <a:cubicBezTo>
                    <a:pt x="481" y="264"/>
                    <a:pt x="482" y="290"/>
                    <a:pt x="483" y="296"/>
                  </a:cubicBezTo>
                  <a:cubicBezTo>
                    <a:pt x="484" y="302"/>
                    <a:pt x="479" y="304"/>
                    <a:pt x="478" y="308"/>
                  </a:cubicBezTo>
                  <a:cubicBezTo>
                    <a:pt x="476" y="313"/>
                    <a:pt x="475" y="314"/>
                    <a:pt x="474" y="333"/>
                  </a:cubicBezTo>
                  <a:cubicBezTo>
                    <a:pt x="474" y="352"/>
                    <a:pt x="462" y="354"/>
                    <a:pt x="462" y="354"/>
                  </a:cubicBezTo>
                  <a:cubicBezTo>
                    <a:pt x="454" y="358"/>
                    <a:pt x="454" y="358"/>
                    <a:pt x="454" y="358"/>
                  </a:cubicBezTo>
                  <a:cubicBezTo>
                    <a:pt x="448" y="361"/>
                    <a:pt x="448" y="361"/>
                    <a:pt x="448" y="361"/>
                  </a:cubicBezTo>
                  <a:cubicBezTo>
                    <a:pt x="445" y="364"/>
                    <a:pt x="445" y="364"/>
                    <a:pt x="445" y="364"/>
                  </a:cubicBezTo>
                  <a:cubicBezTo>
                    <a:pt x="442" y="372"/>
                    <a:pt x="442" y="372"/>
                    <a:pt x="442" y="372"/>
                  </a:cubicBezTo>
                  <a:cubicBezTo>
                    <a:pt x="440" y="380"/>
                    <a:pt x="440" y="380"/>
                    <a:pt x="440" y="380"/>
                  </a:cubicBezTo>
                  <a:cubicBezTo>
                    <a:pt x="0" y="380"/>
                    <a:pt x="0" y="380"/>
                    <a:pt x="0" y="380"/>
                  </a:cubicBezTo>
                  <a:cubicBezTo>
                    <a:pt x="0" y="77"/>
                    <a:pt x="0" y="77"/>
                    <a:pt x="0" y="77"/>
                  </a:cubicBezTo>
                  <a:cubicBezTo>
                    <a:pt x="0" y="77"/>
                    <a:pt x="8" y="73"/>
                    <a:pt x="14" y="64"/>
                  </a:cubicBezTo>
                  <a:cubicBezTo>
                    <a:pt x="19" y="55"/>
                    <a:pt x="24" y="51"/>
                    <a:pt x="30" y="46"/>
                  </a:cubicBezTo>
                  <a:cubicBezTo>
                    <a:pt x="36" y="41"/>
                    <a:pt x="37" y="35"/>
                    <a:pt x="39" y="31"/>
                  </a:cubicBezTo>
                  <a:cubicBezTo>
                    <a:pt x="41" y="28"/>
                    <a:pt x="50" y="17"/>
                    <a:pt x="53" y="15"/>
                  </a:cubicBezTo>
                  <a:cubicBezTo>
                    <a:pt x="57" y="13"/>
                    <a:pt x="65" y="0"/>
                    <a:pt x="91" y="21"/>
                  </a:cubicBezTo>
                  <a:cubicBezTo>
                    <a:pt x="116" y="42"/>
                    <a:pt x="129" y="49"/>
                    <a:pt x="129" y="49"/>
                  </a:cubicBezTo>
                  <a:cubicBezTo>
                    <a:pt x="129" y="49"/>
                    <a:pt x="144" y="57"/>
                    <a:pt x="153" y="66"/>
                  </a:cubicBezTo>
                  <a:cubicBezTo>
                    <a:pt x="163" y="74"/>
                    <a:pt x="170" y="84"/>
                    <a:pt x="190" y="84"/>
                  </a:cubicBezTo>
                  <a:cubicBezTo>
                    <a:pt x="209" y="83"/>
                    <a:pt x="219" y="78"/>
                    <a:pt x="228" y="82"/>
                  </a:cubicBezTo>
                  <a:cubicBezTo>
                    <a:pt x="238" y="85"/>
                    <a:pt x="249" y="85"/>
                    <a:pt x="259" y="82"/>
                  </a:cubicBezTo>
                  <a:cubicBezTo>
                    <a:pt x="269" y="78"/>
                    <a:pt x="275" y="85"/>
                    <a:pt x="284" y="86"/>
                  </a:cubicBezTo>
                  <a:cubicBezTo>
                    <a:pt x="294" y="86"/>
                    <a:pt x="307" y="86"/>
                    <a:pt x="307" y="86"/>
                  </a:cubicBezTo>
                  <a:cubicBezTo>
                    <a:pt x="307" y="86"/>
                    <a:pt x="316" y="85"/>
                    <a:pt x="320" y="88"/>
                  </a:cubicBezTo>
                  <a:cubicBezTo>
                    <a:pt x="322" y="91"/>
                    <a:pt x="330" y="98"/>
                    <a:pt x="338" y="104"/>
                  </a:cubicBezTo>
                  <a:cubicBezTo>
                    <a:pt x="342" y="108"/>
                    <a:pt x="347" y="112"/>
                    <a:pt x="351" y="114"/>
                  </a:cubicBezTo>
                  <a:cubicBezTo>
                    <a:pt x="360" y="119"/>
                    <a:pt x="371" y="130"/>
                    <a:pt x="387" y="129"/>
                  </a:cubicBezTo>
                  <a:cubicBezTo>
                    <a:pt x="404" y="128"/>
                    <a:pt x="418" y="124"/>
                    <a:pt x="418" y="124"/>
                  </a:cubicBezTo>
                  <a:cubicBezTo>
                    <a:pt x="413" y="133"/>
                    <a:pt x="412" y="140"/>
                    <a:pt x="421" y="139"/>
                  </a:cubicBezTo>
                  <a:cubicBezTo>
                    <a:pt x="421" y="139"/>
                    <a:pt x="420" y="142"/>
                    <a:pt x="428" y="145"/>
                  </a:cubicBezTo>
                  <a:cubicBezTo>
                    <a:pt x="436" y="149"/>
                    <a:pt x="456" y="154"/>
                    <a:pt x="465" y="155"/>
                  </a:cubicBezTo>
                  <a:cubicBezTo>
                    <a:pt x="475" y="157"/>
                    <a:pt x="481" y="159"/>
                    <a:pt x="488" y="160"/>
                  </a:cubicBezTo>
                  <a:cubicBezTo>
                    <a:pt x="495" y="162"/>
                    <a:pt x="499" y="162"/>
                    <a:pt x="499" y="162"/>
                  </a:cubicBezTo>
                  <a:cubicBezTo>
                    <a:pt x="509" y="160"/>
                    <a:pt x="509" y="160"/>
                    <a:pt x="509" y="160"/>
                  </a:cubicBezTo>
                  <a:cubicBezTo>
                    <a:pt x="501" y="169"/>
                    <a:pt x="502" y="184"/>
                    <a:pt x="509" y="181"/>
                  </a:cubicBezTo>
                  <a:close/>
                </a:path>
              </a:pathLst>
            </a:cu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78" name="Freeform 89">
              <a:extLst>
                <a:ext uri="{FF2B5EF4-FFF2-40B4-BE49-F238E27FC236}">
                  <a16:creationId xmlns:a16="http://schemas.microsoft.com/office/drawing/2014/main" id="{3E7720C5-8675-8420-A501-EDB35A5F4D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928" y="5793329"/>
              <a:ext cx="161687" cy="161687"/>
            </a:xfrm>
            <a:custGeom>
              <a:avLst/>
              <a:gdLst>
                <a:gd name="T0" fmla="*/ 37 w 37"/>
                <a:gd name="T1" fmla="*/ 21 h 37"/>
                <a:gd name="T2" fmla="*/ 37 w 37"/>
                <a:gd name="T3" fmla="*/ 23 h 37"/>
                <a:gd name="T4" fmla="*/ 35 w 37"/>
                <a:gd name="T5" fmla="*/ 28 h 37"/>
                <a:gd name="T6" fmla="*/ 32 w 37"/>
                <a:gd name="T7" fmla="*/ 30 h 37"/>
                <a:gd name="T8" fmla="*/ 30 w 37"/>
                <a:gd name="T9" fmla="*/ 30 h 37"/>
                <a:gd name="T10" fmla="*/ 25 w 37"/>
                <a:gd name="T11" fmla="*/ 30 h 37"/>
                <a:gd name="T12" fmla="*/ 20 w 37"/>
                <a:gd name="T13" fmla="*/ 32 h 37"/>
                <a:gd name="T14" fmla="*/ 15 w 37"/>
                <a:gd name="T15" fmla="*/ 37 h 37"/>
                <a:gd name="T16" fmla="*/ 12 w 37"/>
                <a:gd name="T17" fmla="*/ 37 h 37"/>
                <a:gd name="T18" fmla="*/ 8 w 37"/>
                <a:gd name="T19" fmla="*/ 32 h 37"/>
                <a:gd name="T20" fmla="*/ 2 w 37"/>
                <a:gd name="T21" fmla="*/ 23 h 37"/>
                <a:gd name="T22" fmla="*/ 4 w 37"/>
                <a:gd name="T23" fmla="*/ 18 h 37"/>
                <a:gd name="T24" fmla="*/ 2 w 37"/>
                <a:gd name="T25" fmla="*/ 12 h 37"/>
                <a:gd name="T26" fmla="*/ 6 w 37"/>
                <a:gd name="T27" fmla="*/ 4 h 37"/>
                <a:gd name="T28" fmla="*/ 13 w 37"/>
                <a:gd name="T29" fmla="*/ 4 h 37"/>
                <a:gd name="T30" fmla="*/ 20 w 37"/>
                <a:gd name="T31" fmla="*/ 0 h 37"/>
                <a:gd name="T32" fmla="*/ 24 w 37"/>
                <a:gd name="T33" fmla="*/ 4 h 37"/>
                <a:gd name="T34" fmla="*/ 31 w 37"/>
                <a:gd name="T35" fmla="*/ 8 h 37"/>
                <a:gd name="T36" fmla="*/ 33 w 37"/>
                <a:gd name="T37" fmla="*/ 12 h 37"/>
                <a:gd name="T38" fmla="*/ 33 w 37"/>
                <a:gd name="T39" fmla="*/ 18 h 37"/>
                <a:gd name="T40" fmla="*/ 37 w 37"/>
                <a:gd name="T41" fmla="*/ 21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37" h="37">
                  <a:moveTo>
                    <a:pt x="37" y="21"/>
                  </a:moveTo>
                  <a:cubicBezTo>
                    <a:pt x="37" y="23"/>
                    <a:pt x="37" y="23"/>
                    <a:pt x="37" y="23"/>
                  </a:cubicBezTo>
                  <a:cubicBezTo>
                    <a:pt x="35" y="28"/>
                    <a:pt x="35" y="28"/>
                    <a:pt x="35" y="28"/>
                  </a:cubicBezTo>
                  <a:cubicBezTo>
                    <a:pt x="32" y="30"/>
                    <a:pt x="32" y="30"/>
                    <a:pt x="32" y="30"/>
                  </a:cubicBezTo>
                  <a:cubicBezTo>
                    <a:pt x="30" y="30"/>
                    <a:pt x="30" y="30"/>
                    <a:pt x="30" y="30"/>
                  </a:cubicBezTo>
                  <a:cubicBezTo>
                    <a:pt x="25" y="30"/>
                    <a:pt x="25" y="30"/>
                    <a:pt x="25" y="30"/>
                  </a:cubicBezTo>
                  <a:cubicBezTo>
                    <a:pt x="20" y="32"/>
                    <a:pt x="20" y="32"/>
                    <a:pt x="20" y="32"/>
                  </a:cubicBezTo>
                  <a:cubicBezTo>
                    <a:pt x="15" y="37"/>
                    <a:pt x="15" y="37"/>
                    <a:pt x="15" y="37"/>
                  </a:cubicBezTo>
                  <a:cubicBezTo>
                    <a:pt x="12" y="37"/>
                    <a:pt x="12" y="37"/>
                    <a:pt x="12" y="37"/>
                  </a:cubicBezTo>
                  <a:cubicBezTo>
                    <a:pt x="8" y="32"/>
                    <a:pt x="8" y="32"/>
                    <a:pt x="8" y="32"/>
                  </a:cubicBezTo>
                  <a:cubicBezTo>
                    <a:pt x="2" y="23"/>
                    <a:pt x="2" y="23"/>
                    <a:pt x="2" y="23"/>
                  </a:cubicBezTo>
                  <a:cubicBezTo>
                    <a:pt x="2" y="23"/>
                    <a:pt x="2" y="23"/>
                    <a:pt x="4" y="18"/>
                  </a:cubicBezTo>
                  <a:cubicBezTo>
                    <a:pt x="5" y="14"/>
                    <a:pt x="4" y="15"/>
                    <a:pt x="2" y="12"/>
                  </a:cubicBezTo>
                  <a:cubicBezTo>
                    <a:pt x="0" y="8"/>
                    <a:pt x="3" y="2"/>
                    <a:pt x="6" y="4"/>
                  </a:cubicBezTo>
                  <a:cubicBezTo>
                    <a:pt x="9" y="6"/>
                    <a:pt x="12" y="6"/>
                    <a:pt x="13" y="4"/>
                  </a:cubicBezTo>
                  <a:cubicBezTo>
                    <a:pt x="14" y="2"/>
                    <a:pt x="20" y="0"/>
                    <a:pt x="20" y="0"/>
                  </a:cubicBezTo>
                  <a:cubicBezTo>
                    <a:pt x="24" y="4"/>
                    <a:pt x="24" y="4"/>
                    <a:pt x="24" y="4"/>
                  </a:cubicBezTo>
                  <a:cubicBezTo>
                    <a:pt x="24" y="4"/>
                    <a:pt x="29" y="8"/>
                    <a:pt x="31" y="8"/>
                  </a:cubicBezTo>
                  <a:cubicBezTo>
                    <a:pt x="32" y="8"/>
                    <a:pt x="33" y="12"/>
                    <a:pt x="33" y="12"/>
                  </a:cubicBezTo>
                  <a:cubicBezTo>
                    <a:pt x="33" y="18"/>
                    <a:pt x="33" y="18"/>
                    <a:pt x="33" y="18"/>
                  </a:cubicBezTo>
                  <a:lnTo>
                    <a:pt x="37" y="21"/>
                  </a:lnTo>
                  <a:close/>
                </a:path>
              </a:pathLst>
            </a:custGeom>
            <a:solidFill>
              <a:srgbClr val="F2F2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79" name="Rectangle 240">
              <a:extLst>
                <a:ext uri="{FF2B5EF4-FFF2-40B4-BE49-F238E27FC236}">
                  <a16:creationId xmlns:a16="http://schemas.microsoft.com/office/drawing/2014/main" id="{01112CA0-11CE-CD73-D06F-87E76B59BE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08003" y="6769266"/>
              <a:ext cx="733981" cy="179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Onverwacht</a:t>
              </a:r>
              <a:endParaRPr kumimoji="0" lang="de-DE" altLang="de-D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0" name="Rectangle 256">
              <a:extLst>
                <a:ext uri="{FF2B5EF4-FFF2-40B4-BE49-F238E27FC236}">
                  <a16:creationId xmlns:a16="http://schemas.microsoft.com/office/drawing/2014/main" id="{9DBD50F7-BF6A-4CE3-9E2F-2D184784C8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13545" y="6163590"/>
              <a:ext cx="432705" cy="219156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7938" cap="flat">
              <a:solidFill>
                <a:srgbClr val="23202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81" name="Rectangle 256">
              <a:extLst>
                <a:ext uri="{FF2B5EF4-FFF2-40B4-BE49-F238E27FC236}">
                  <a16:creationId xmlns:a16="http://schemas.microsoft.com/office/drawing/2014/main" id="{DC689809-8EF2-E1F3-349A-E807DD4C1B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12580" y="6454133"/>
              <a:ext cx="432705" cy="222287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7938" cap="flat">
              <a:solidFill>
                <a:srgbClr val="23202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82" name="Rectangle 240">
              <a:extLst>
                <a:ext uri="{FF2B5EF4-FFF2-40B4-BE49-F238E27FC236}">
                  <a16:creationId xmlns:a16="http://schemas.microsoft.com/office/drawing/2014/main" id="{37EA22F9-634C-FE78-1C96-B1CFD6E488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13488" y="6480192"/>
              <a:ext cx="469210" cy="179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Fig</a:t>
              </a:r>
              <a:r>
                <a:rPr kumimoji="0" lang="de-DE" altLang="de-DE" sz="1200" i="0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 </a:t>
              </a:r>
              <a:r>
                <a:rPr lang="de-DE" altLang="de-DE" sz="1200" dirty="0" err="1">
                  <a:solidFill>
                    <a:srgbClr val="232021"/>
                  </a:solidFill>
                  <a:latin typeface="+mn-lt"/>
                </a:rPr>
                <a:t>T</a:t>
              </a:r>
              <a:r>
                <a:rPr kumimoji="0" lang="de-DE" altLang="de-DE" sz="12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ree</a:t>
              </a:r>
              <a:endParaRPr kumimoji="0" lang="de-DE" altLang="de-D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3" name="Rectangle 240">
              <a:extLst>
                <a:ext uri="{FF2B5EF4-FFF2-40B4-BE49-F238E27FC236}">
                  <a16:creationId xmlns:a16="http://schemas.microsoft.com/office/drawing/2014/main" id="{3FFC3BD1-9709-8F20-9A22-4410C510D6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26736" y="6180452"/>
              <a:ext cx="531780" cy="179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Moodies</a:t>
              </a:r>
              <a:endParaRPr kumimoji="0" lang="de-DE" altLang="de-D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84" name="Rectangle 256">
              <a:extLst>
                <a:ext uri="{FF2B5EF4-FFF2-40B4-BE49-F238E27FC236}">
                  <a16:creationId xmlns:a16="http://schemas.microsoft.com/office/drawing/2014/main" id="{FBA8D32E-AC8C-AF02-8DD8-CC5838AD7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12546" y="6748680"/>
              <a:ext cx="432705" cy="221393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7938" cap="flat">
              <a:solidFill>
                <a:srgbClr val="23202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85" name="Rectangle 240">
              <a:extLst>
                <a:ext uri="{FF2B5EF4-FFF2-40B4-BE49-F238E27FC236}">
                  <a16:creationId xmlns:a16="http://schemas.microsoft.com/office/drawing/2014/main" id="{DA2347AF-ED12-5105-68CF-95632CC9D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13523" y="7407796"/>
              <a:ext cx="1703003" cy="261675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1pPr>
              <a:lvl2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2pPr>
              <a:lvl3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3pPr>
              <a:lvl4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4pPr>
              <a:lvl5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5pPr>
              <a:lvl6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6pPr>
              <a:lvl7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7pPr>
              <a:lvl8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8pPr>
              <a:lvl9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9pPr>
            </a:lstStyle>
            <a:p>
              <a:pPr defTabSz="914378">
                <a:lnSpc>
                  <a:spcPts val="1000"/>
                </a:lnSpc>
                <a:defRPr/>
              </a:pPr>
              <a:r>
                <a:rPr lang="en-US" sz="1100" dirty="0">
                  <a:solidFill>
                    <a:srgbClr val="232021"/>
                  </a:solidFill>
                  <a:latin typeface="Calibri"/>
                </a:rPr>
                <a:t>Plutons and gneiss complexes adjacent to the BGB</a:t>
              </a:r>
              <a:endParaRPr lang="en-US" sz="1100" dirty="0">
                <a:latin typeface="Calibri"/>
              </a:endParaRPr>
            </a:p>
          </p:txBody>
        </p:sp>
        <p:grpSp>
          <p:nvGrpSpPr>
            <p:cNvPr id="486" name="Gruppieren 485">
              <a:extLst>
                <a:ext uri="{FF2B5EF4-FFF2-40B4-BE49-F238E27FC236}">
                  <a16:creationId xmlns:a16="http://schemas.microsoft.com/office/drawing/2014/main" id="{01047265-DB34-59DC-34B3-02557316485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-910631" y="7404548"/>
              <a:ext cx="428074" cy="218993"/>
              <a:chOff x="-1251521" y="6808209"/>
              <a:chExt cx="1117468" cy="714570"/>
            </a:xfrm>
          </p:grpSpPr>
          <p:sp>
            <p:nvSpPr>
              <p:cNvPr id="494" name="Rechteck 493">
                <a:extLst>
                  <a:ext uri="{FF2B5EF4-FFF2-40B4-BE49-F238E27FC236}">
                    <a16:creationId xmlns:a16="http://schemas.microsoft.com/office/drawing/2014/main" id="{9BA0B0CB-7B46-2416-4EFC-6B5DA19F0A6E}"/>
                  </a:ext>
                </a:extLst>
              </p:cNvPr>
              <p:cNvSpPr/>
              <p:nvPr/>
            </p:nvSpPr>
            <p:spPr>
              <a:xfrm>
                <a:off x="-1251521" y="6808209"/>
                <a:ext cx="1117467" cy="71456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495" name="Gruppieren 494">
                <a:extLst>
                  <a:ext uri="{FF2B5EF4-FFF2-40B4-BE49-F238E27FC236}">
                    <a16:creationId xmlns:a16="http://schemas.microsoft.com/office/drawing/2014/main" id="{9CAEC2E3-C4A2-66CF-5028-704DCD8EDE5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-1251520" y="6808210"/>
                <a:ext cx="1117467" cy="714569"/>
                <a:chOff x="-603129" y="6718362"/>
                <a:chExt cx="344705" cy="220423"/>
              </a:xfrm>
            </p:grpSpPr>
            <p:sp>
              <p:nvSpPr>
                <p:cNvPr id="496" name="Rectangle 256">
                  <a:extLst>
                    <a:ext uri="{FF2B5EF4-FFF2-40B4-BE49-F238E27FC236}">
                      <a16:creationId xmlns:a16="http://schemas.microsoft.com/office/drawing/2014/main" id="{808C781E-A8D1-0243-1DE9-5EF52BD5D1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603129" y="6718362"/>
                  <a:ext cx="344705" cy="220423"/>
                </a:xfrm>
                <a:prstGeom prst="rect">
                  <a:avLst/>
                </a:prstGeom>
                <a:solidFill>
                  <a:srgbClr val="828282"/>
                </a:solidFill>
                <a:ln w="7938" cap="flat">
                  <a:noFill/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>
                    <a:defRPr/>
                  </a:pPr>
                  <a:endParaRPr lang="de-DE"/>
                </a:p>
              </p:txBody>
            </p:sp>
            <p:sp>
              <p:nvSpPr>
                <p:cNvPr id="497" name="Rectangle 256">
                  <a:extLst>
                    <a:ext uri="{FF2B5EF4-FFF2-40B4-BE49-F238E27FC236}">
                      <a16:creationId xmlns:a16="http://schemas.microsoft.com/office/drawing/2014/main" id="{8909684F-B878-9FCB-5822-7E7F3577FC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29002" y="6718362"/>
                  <a:ext cx="90000" cy="220423"/>
                </a:xfrm>
                <a:prstGeom prst="rect">
                  <a:avLst/>
                </a:prstGeom>
                <a:solidFill>
                  <a:srgbClr val="B4B4B4"/>
                </a:solidFill>
                <a:ln w="7938" cap="flat">
                  <a:noFill/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>
                    <a:defRPr/>
                  </a:pPr>
                  <a:endParaRPr lang="de-DE"/>
                </a:p>
              </p:txBody>
            </p:sp>
            <p:sp>
              <p:nvSpPr>
                <p:cNvPr id="498" name="Rectangle 256">
                  <a:extLst>
                    <a:ext uri="{FF2B5EF4-FFF2-40B4-BE49-F238E27FC236}">
                      <a16:creationId xmlns:a16="http://schemas.microsoft.com/office/drawing/2014/main" id="{E6E1B968-1744-4CA9-A6E5-88447F7F3E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438713" y="6718362"/>
                  <a:ext cx="90000" cy="220423"/>
                </a:xfrm>
                <a:prstGeom prst="rect">
                  <a:avLst/>
                </a:prstGeom>
                <a:solidFill>
                  <a:srgbClr val="C1C1C1"/>
                </a:solidFill>
                <a:ln w="7938" cap="flat">
                  <a:noFill/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>
                    <a:defRPr/>
                  </a:pPr>
                  <a:endParaRPr lang="de-DE"/>
                </a:p>
              </p:txBody>
            </p:sp>
            <p:sp>
              <p:nvSpPr>
                <p:cNvPr id="499" name="Rectangle 256">
                  <a:extLst>
                    <a:ext uri="{FF2B5EF4-FFF2-40B4-BE49-F238E27FC236}">
                      <a16:creationId xmlns:a16="http://schemas.microsoft.com/office/drawing/2014/main" id="{6C3FFE2E-96C6-B4BC-6DA4-F84473713B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348424" y="6718362"/>
                  <a:ext cx="90000" cy="220423"/>
                </a:xfrm>
                <a:prstGeom prst="rect">
                  <a:avLst/>
                </a:prstGeom>
                <a:solidFill>
                  <a:srgbClr val="CECECE"/>
                </a:solidFill>
                <a:ln w="7938" cap="flat">
                  <a:noFill/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>
                    <a:defRPr/>
                  </a:pPr>
                  <a:endParaRPr lang="de-DE"/>
                </a:p>
              </p:txBody>
            </p:sp>
          </p:grpSp>
        </p:grpSp>
        <p:grpSp>
          <p:nvGrpSpPr>
            <p:cNvPr id="487" name="Gruppieren 486">
              <a:extLst>
                <a:ext uri="{FF2B5EF4-FFF2-40B4-BE49-F238E27FC236}">
                  <a16:creationId xmlns:a16="http://schemas.microsoft.com/office/drawing/2014/main" id="{D468562C-14A5-2228-B7DD-4BBD488FA844}"/>
                </a:ext>
              </a:extLst>
            </p:cNvPr>
            <p:cNvGrpSpPr/>
            <p:nvPr/>
          </p:nvGrpSpPr>
          <p:grpSpPr>
            <a:xfrm>
              <a:off x="-911029" y="5822693"/>
              <a:ext cx="1744209" cy="220423"/>
              <a:chOff x="238932" y="5057930"/>
              <a:chExt cx="1744209" cy="220423"/>
            </a:xfrm>
          </p:grpSpPr>
          <p:sp>
            <p:nvSpPr>
              <p:cNvPr id="492" name="Rectangle 256">
                <a:extLst>
                  <a:ext uri="{FF2B5EF4-FFF2-40B4-BE49-F238E27FC236}">
                    <a16:creationId xmlns:a16="http://schemas.microsoft.com/office/drawing/2014/main" id="{CC9F335B-6256-ACD2-B7D9-E2693067FF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8932" y="5057930"/>
                <a:ext cx="436997" cy="220423"/>
              </a:xfrm>
              <a:prstGeom prst="rect">
                <a:avLst/>
              </a:prstGeom>
              <a:solidFill>
                <a:srgbClr val="EBEBCF"/>
              </a:solidFill>
              <a:ln w="7938" cap="flat">
                <a:solidFill>
                  <a:srgbClr val="23202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>
                  <a:defRPr/>
                </a:pPr>
                <a:endParaRPr lang="de-DE"/>
              </a:p>
            </p:txBody>
          </p:sp>
          <p:sp>
            <p:nvSpPr>
              <p:cNvPr id="493" name="Rectangle 240">
                <a:extLst>
                  <a:ext uri="{FF2B5EF4-FFF2-40B4-BE49-F238E27FC236}">
                    <a16:creationId xmlns:a16="http://schemas.microsoft.com/office/drawing/2014/main" id="{9BCDAE24-D923-DB61-ABCF-ABE293305C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1475" y="5082172"/>
                <a:ext cx="1251666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1pPr>
                <a:lvl2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2pPr>
                <a:lvl3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3pPr>
                <a:lvl4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4pPr>
                <a:lvl5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5pPr>
                <a:lvl6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6pPr>
                <a:lvl7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7pPr>
                <a:lvl8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8pPr>
                <a:lvl9pPr>
                  <a:spcBef>
                    <a:spcPts val="0"/>
                  </a:spcBef>
                  <a:spcAft>
                    <a:spcPts val="0"/>
                  </a:spcAft>
                  <a:defRPr>
                    <a:solidFill>
                      <a:schemeClr val="tx1"/>
                    </a:solidFill>
                    <a:latin typeface="Arial"/>
                  </a:defRPr>
                </a:lvl9pPr>
              </a:lstStyle>
              <a:p>
                <a:pPr defTabSz="914378">
                  <a:defRPr/>
                </a:pPr>
                <a:r>
                  <a:rPr lang="en-US" sz="1200" dirty="0">
                    <a:solidFill>
                      <a:srgbClr val="232021"/>
                    </a:solidFill>
                    <a:latin typeface="Calibri"/>
                  </a:rPr>
                  <a:t>Younger cover</a:t>
                </a:r>
                <a:endParaRPr lang="en-US" sz="1200" dirty="0">
                  <a:latin typeface="Calibri"/>
                </a:endParaRPr>
              </a:p>
            </p:txBody>
          </p:sp>
        </p:grpSp>
        <p:sp>
          <p:nvSpPr>
            <p:cNvPr id="488" name="Rectangle 240">
              <a:extLst>
                <a:ext uri="{FF2B5EF4-FFF2-40B4-BE49-F238E27FC236}">
                  <a16:creationId xmlns:a16="http://schemas.microsoft.com/office/drawing/2014/main" id="{24F464FA-8DC3-2F11-7C9D-6654654C23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08009" y="6438376"/>
              <a:ext cx="390235" cy="184666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1pPr>
              <a:lvl2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2pPr>
              <a:lvl3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3pPr>
              <a:lvl4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4pPr>
              <a:lvl5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5pPr>
              <a:lvl6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6pPr>
              <a:lvl7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7pPr>
              <a:lvl8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8pPr>
              <a:lvl9pPr>
                <a:spcBef>
                  <a:spcPts val="0"/>
                </a:spcBef>
                <a:spcAft>
                  <a:spcPts val="0"/>
                </a:spcAft>
                <a:defRPr>
                  <a:solidFill>
                    <a:schemeClr val="tx1"/>
                  </a:solidFill>
                  <a:latin typeface="Arial"/>
                </a:defRPr>
              </a:lvl9pPr>
            </a:lstStyle>
            <a:p>
              <a:pPr defTabSz="914378">
                <a:defRPr/>
              </a:pPr>
              <a:r>
                <a:rPr lang="de-DE" sz="1200" dirty="0">
                  <a:solidFill>
                    <a:srgbClr val="232021"/>
                  </a:solidFill>
                  <a:latin typeface="Calibri"/>
                </a:rPr>
                <a:t>Group</a:t>
              </a:r>
              <a:endParaRPr lang="de-DE" sz="1200" dirty="0">
                <a:latin typeface="Calibri"/>
              </a:endParaRPr>
            </a:p>
          </p:txBody>
        </p:sp>
        <p:cxnSp>
          <p:nvCxnSpPr>
            <p:cNvPr id="489" name="Gerader Verbinder 488">
              <a:extLst>
                <a:ext uri="{FF2B5EF4-FFF2-40B4-BE49-F238E27FC236}">
                  <a16:creationId xmlns:a16="http://schemas.microsoft.com/office/drawing/2014/main" id="{C53B7A0F-5551-18B3-63B3-06C86E99474A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93135" y="6221963"/>
              <a:ext cx="0" cy="65539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0" name="Rectangle 240">
              <a:extLst>
                <a:ext uri="{FF2B5EF4-FFF2-40B4-BE49-F238E27FC236}">
                  <a16:creationId xmlns:a16="http://schemas.microsoft.com/office/drawing/2014/main" id="{697BF9DE-7F91-917E-1AA8-B584581985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08003" y="7083118"/>
              <a:ext cx="9909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i="0" u="none" strike="noStrike" cap="none" normalizeH="0" baseline="0" dirty="0" err="1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Lomati</a:t>
              </a:r>
              <a:r>
                <a:rPr kumimoji="0" lang="de-DE" altLang="de-DE" sz="1200" i="0" u="none" strike="noStrike" cap="none" normalizeH="0" baseline="0" dirty="0">
                  <a:ln>
                    <a:noFill/>
                  </a:ln>
                  <a:solidFill>
                    <a:srgbClr val="232021"/>
                  </a:solidFill>
                  <a:effectLst/>
                  <a:latin typeface="+mn-lt"/>
                </a:rPr>
                <a:t> River Sill</a:t>
              </a:r>
              <a:endParaRPr kumimoji="0" lang="de-DE" altLang="de-DE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491" name="Rectangle 256">
              <a:extLst>
                <a:ext uri="{FF2B5EF4-FFF2-40B4-BE49-F238E27FC236}">
                  <a16:creationId xmlns:a16="http://schemas.microsoft.com/office/drawing/2014/main" id="{ACABD6D7-4169-B036-1969-EC91F38E1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912546" y="7062532"/>
              <a:ext cx="432705" cy="221393"/>
            </a:xfrm>
            <a:prstGeom prst="rect">
              <a:avLst/>
            </a:prstGeom>
            <a:solidFill>
              <a:srgbClr val="EA0000"/>
            </a:solidFill>
            <a:ln w="7938" cap="flat">
              <a:solidFill>
                <a:srgbClr val="23202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sp>
        <p:nvSpPr>
          <p:cNvPr id="500" name="Freihandform: Form 499">
            <a:extLst>
              <a:ext uri="{FF2B5EF4-FFF2-40B4-BE49-F238E27FC236}">
                <a16:creationId xmlns:a16="http://schemas.microsoft.com/office/drawing/2014/main" id="{18F5120F-2D5D-8317-1734-ECBF7C5AD6BE}"/>
              </a:ext>
            </a:extLst>
          </p:cNvPr>
          <p:cNvSpPr/>
          <p:nvPr/>
        </p:nvSpPr>
        <p:spPr>
          <a:xfrm>
            <a:off x="3853173" y="2829661"/>
            <a:ext cx="200025" cy="173831"/>
          </a:xfrm>
          <a:custGeom>
            <a:avLst/>
            <a:gdLst>
              <a:gd name="connsiteX0" fmla="*/ 0 w 200025"/>
              <a:gd name="connsiteY0" fmla="*/ 173831 h 173831"/>
              <a:gd name="connsiteX1" fmla="*/ 78581 w 200025"/>
              <a:gd name="connsiteY1" fmla="*/ 114300 h 173831"/>
              <a:gd name="connsiteX2" fmla="*/ 154781 w 200025"/>
              <a:gd name="connsiteY2" fmla="*/ 50006 h 173831"/>
              <a:gd name="connsiteX3" fmla="*/ 200025 w 200025"/>
              <a:gd name="connsiteY3" fmla="*/ 0 h 1738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0025" h="173831">
                <a:moveTo>
                  <a:pt x="0" y="173831"/>
                </a:moveTo>
                <a:cubicBezTo>
                  <a:pt x="26392" y="154384"/>
                  <a:pt x="52784" y="134937"/>
                  <a:pt x="78581" y="114300"/>
                </a:cubicBezTo>
                <a:cubicBezTo>
                  <a:pt x="104378" y="93662"/>
                  <a:pt x="134540" y="69056"/>
                  <a:pt x="154781" y="50006"/>
                </a:cubicBezTo>
                <a:cubicBezTo>
                  <a:pt x="175022" y="30956"/>
                  <a:pt x="187523" y="15478"/>
                  <a:pt x="200025" y="0"/>
                </a:cubicBezTo>
              </a:path>
            </a:pathLst>
          </a:custGeom>
          <a:noFill/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01" name="Gerader Verbinder 500">
            <a:extLst>
              <a:ext uri="{FF2B5EF4-FFF2-40B4-BE49-F238E27FC236}">
                <a16:creationId xmlns:a16="http://schemas.microsoft.com/office/drawing/2014/main" id="{C7C01365-3F38-4F8E-F3B3-9255B266CA0E}"/>
              </a:ext>
            </a:extLst>
          </p:cNvPr>
          <p:cNvCxnSpPr>
            <a:cxnSpLocks/>
          </p:cNvCxnSpPr>
          <p:nvPr/>
        </p:nvCxnSpPr>
        <p:spPr>
          <a:xfrm flipH="1">
            <a:off x="4215766" y="1960718"/>
            <a:ext cx="124698" cy="2925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2" name="Gerade Verbindung mit Pfeil 501">
            <a:extLst>
              <a:ext uri="{FF2B5EF4-FFF2-40B4-BE49-F238E27FC236}">
                <a16:creationId xmlns:a16="http://schemas.microsoft.com/office/drawing/2014/main" id="{15FDBFDF-7C1B-B635-41A1-8914BE18DB7F}"/>
              </a:ext>
            </a:extLst>
          </p:cNvPr>
          <p:cNvCxnSpPr/>
          <p:nvPr/>
        </p:nvCxnSpPr>
        <p:spPr>
          <a:xfrm>
            <a:off x="7368180" y="2751052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3" name="Textfeld 44">
            <a:extLst>
              <a:ext uri="{FF2B5EF4-FFF2-40B4-BE49-F238E27FC236}">
                <a16:creationId xmlns:a16="http://schemas.microsoft.com/office/drawing/2014/main" id="{4969E700-EF32-637A-A857-C1A13402BB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9348" y="2517170"/>
            <a:ext cx="793020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100" i="1" dirty="0" err="1">
                <a:latin typeface="Calibri" pitchFamily="34" charset="0"/>
              </a:rPr>
              <a:t>sampled</a:t>
            </a:r>
            <a:endParaRPr lang="de-DE" sz="1100" i="1" dirty="0">
              <a:latin typeface="Calibri" pitchFamily="34" charset="0"/>
            </a:endParaRPr>
          </a:p>
          <a:p>
            <a:pPr eaLnBrk="1" hangingPunct="1"/>
            <a:r>
              <a:rPr lang="de-DE" sz="1100" i="1" dirty="0" err="1">
                <a:latin typeface="Calibri" pitchFamily="34" charset="0"/>
              </a:rPr>
              <a:t>interval</a:t>
            </a:r>
            <a:endParaRPr lang="de-DE" sz="1100" i="1" dirty="0">
              <a:latin typeface="Calibri" pitchFamily="34" charset="0"/>
            </a:endParaRPr>
          </a:p>
        </p:txBody>
      </p:sp>
      <p:sp>
        <p:nvSpPr>
          <p:cNvPr id="504" name="Rechteck 503">
            <a:extLst>
              <a:ext uri="{FF2B5EF4-FFF2-40B4-BE49-F238E27FC236}">
                <a16:creationId xmlns:a16="http://schemas.microsoft.com/office/drawing/2014/main" id="{96803721-0716-F388-5F97-09F6F236EFFA}"/>
              </a:ext>
            </a:extLst>
          </p:cNvPr>
          <p:cNvSpPr/>
          <p:nvPr/>
        </p:nvSpPr>
        <p:spPr>
          <a:xfrm>
            <a:off x="8341053" y="3992780"/>
            <a:ext cx="710723" cy="339211"/>
          </a:xfrm>
          <a:prstGeom prst="rect">
            <a:avLst/>
          </a:prstGeom>
          <a:solidFill>
            <a:srgbClr val="E9EBC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05" name="TextBox 449">
            <a:extLst>
              <a:ext uri="{FF2B5EF4-FFF2-40B4-BE49-F238E27FC236}">
                <a16:creationId xmlns:a16="http://schemas.microsoft.com/office/drawing/2014/main" id="{99F9D252-5757-CD47-2B28-D84B9818099E}"/>
              </a:ext>
            </a:extLst>
          </p:cNvPr>
          <p:cNvSpPr txBox="1"/>
          <p:nvPr/>
        </p:nvSpPr>
        <p:spPr>
          <a:xfrm>
            <a:off x="1209929" y="6580851"/>
            <a:ext cx="635135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1" dirty="0"/>
              <a:t>Figure 1. </a:t>
            </a:r>
            <a:r>
              <a:rPr lang="en-US" sz="1200" i="1" dirty="0"/>
              <a:t>Simplified geological map of the Barberton Greenstone Belt within the eastern </a:t>
            </a:r>
            <a:r>
              <a:rPr lang="en-US" sz="1200" i="1" dirty="0" err="1"/>
              <a:t>Kaapvaal</a:t>
            </a:r>
            <a:r>
              <a:rPr lang="en-US" sz="1200" i="1" dirty="0"/>
              <a:t> craton. The grey rectangle highlights the study area in the central BGB, shown in Fig. 2. The column to the right shows the generalized stratigraphy of the </a:t>
            </a:r>
            <a:r>
              <a:rPr lang="en-US" sz="1200" i="1" dirty="0" err="1"/>
              <a:t>Moodies</a:t>
            </a:r>
            <a:r>
              <a:rPr lang="en-US" sz="1200" i="1" dirty="0"/>
              <a:t> Group in the Saddleback Syncline, using the nomenclature of </a:t>
            </a:r>
            <a:r>
              <a:rPr lang="en-US" sz="1200" i="1" dirty="0" err="1"/>
              <a:t>Anhaeusser</a:t>
            </a:r>
            <a:r>
              <a:rPr lang="en-US" sz="1200" i="1" dirty="0"/>
              <a:t> (1976).  Microbial mats and associated features occur in upper MdQ1.</a:t>
            </a:r>
            <a:endParaRPr lang="en-GB" sz="1200" i="1" dirty="0"/>
          </a:p>
        </p:txBody>
      </p:sp>
      <p:cxnSp>
        <p:nvCxnSpPr>
          <p:cNvPr id="506" name="Gerader Verbinder 505">
            <a:extLst>
              <a:ext uri="{FF2B5EF4-FFF2-40B4-BE49-F238E27FC236}">
                <a16:creationId xmlns:a16="http://schemas.microsoft.com/office/drawing/2014/main" id="{CD7638DE-CA84-FD0D-7B77-105116056480}"/>
              </a:ext>
            </a:extLst>
          </p:cNvPr>
          <p:cNvCxnSpPr>
            <a:cxnSpLocks/>
          </p:cNvCxnSpPr>
          <p:nvPr/>
        </p:nvCxnSpPr>
        <p:spPr>
          <a:xfrm>
            <a:off x="379729" y="1654336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7" name="Gerader Verbinder 506">
            <a:extLst>
              <a:ext uri="{FF2B5EF4-FFF2-40B4-BE49-F238E27FC236}">
                <a16:creationId xmlns:a16="http://schemas.microsoft.com/office/drawing/2014/main" id="{5FDDB0B2-C088-088B-787A-25806495D234}"/>
              </a:ext>
            </a:extLst>
          </p:cNvPr>
          <p:cNvCxnSpPr>
            <a:cxnSpLocks/>
          </p:cNvCxnSpPr>
          <p:nvPr/>
        </p:nvCxnSpPr>
        <p:spPr>
          <a:xfrm>
            <a:off x="3458485" y="99856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8" name="Gerader Verbinder 507">
            <a:extLst>
              <a:ext uri="{FF2B5EF4-FFF2-40B4-BE49-F238E27FC236}">
                <a16:creationId xmlns:a16="http://schemas.microsoft.com/office/drawing/2014/main" id="{3821140B-A686-B3D7-364E-B4AFF80EAD0C}"/>
              </a:ext>
            </a:extLst>
          </p:cNvPr>
          <p:cNvCxnSpPr>
            <a:cxnSpLocks/>
          </p:cNvCxnSpPr>
          <p:nvPr/>
        </p:nvCxnSpPr>
        <p:spPr>
          <a:xfrm>
            <a:off x="6537241" y="84616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9" name="Gerader Verbinder 508">
            <a:extLst>
              <a:ext uri="{FF2B5EF4-FFF2-40B4-BE49-F238E27FC236}">
                <a16:creationId xmlns:a16="http://schemas.microsoft.com/office/drawing/2014/main" id="{4AE597DD-5900-2164-3604-4D3B0C73F1B6}"/>
              </a:ext>
            </a:extLst>
          </p:cNvPr>
          <p:cNvCxnSpPr>
            <a:cxnSpLocks/>
          </p:cNvCxnSpPr>
          <p:nvPr/>
        </p:nvCxnSpPr>
        <p:spPr>
          <a:xfrm flipH="1" flipV="1">
            <a:off x="2113870" y="1083803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0" name="Gerader Verbinder 509">
            <a:extLst>
              <a:ext uri="{FF2B5EF4-FFF2-40B4-BE49-F238E27FC236}">
                <a16:creationId xmlns:a16="http://schemas.microsoft.com/office/drawing/2014/main" id="{BDE2AC98-DF3B-5D1C-7480-529E4094BE4F}"/>
              </a:ext>
            </a:extLst>
          </p:cNvPr>
          <p:cNvCxnSpPr>
            <a:cxnSpLocks/>
          </p:cNvCxnSpPr>
          <p:nvPr/>
        </p:nvCxnSpPr>
        <p:spPr>
          <a:xfrm flipH="1" flipV="1">
            <a:off x="132670" y="431690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1" name="Textfeld 510">
            <a:extLst>
              <a:ext uri="{FF2B5EF4-FFF2-40B4-BE49-F238E27FC236}">
                <a16:creationId xmlns:a16="http://schemas.microsoft.com/office/drawing/2014/main" id="{C091CE0B-7D45-C1E1-9A97-DF2713BA9ABF}"/>
              </a:ext>
            </a:extLst>
          </p:cNvPr>
          <p:cNvSpPr txBox="1"/>
          <p:nvPr/>
        </p:nvSpPr>
        <p:spPr>
          <a:xfrm>
            <a:off x="114513" y="1821976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0°30‘</a:t>
            </a:r>
          </a:p>
        </p:txBody>
      </p:sp>
      <p:sp>
        <p:nvSpPr>
          <p:cNvPr id="512" name="Textfeld 511">
            <a:extLst>
              <a:ext uri="{FF2B5EF4-FFF2-40B4-BE49-F238E27FC236}">
                <a16:creationId xmlns:a16="http://schemas.microsoft.com/office/drawing/2014/main" id="{1C16DE2C-8DA6-57B0-5F43-EFF9066842F5}"/>
              </a:ext>
            </a:extLst>
          </p:cNvPr>
          <p:cNvSpPr txBox="1"/>
          <p:nvPr/>
        </p:nvSpPr>
        <p:spPr>
          <a:xfrm>
            <a:off x="3291236" y="278050"/>
            <a:ext cx="3593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1°</a:t>
            </a:r>
          </a:p>
        </p:txBody>
      </p:sp>
      <p:sp>
        <p:nvSpPr>
          <p:cNvPr id="513" name="Textfeld 512">
            <a:extLst>
              <a:ext uri="{FF2B5EF4-FFF2-40B4-BE49-F238E27FC236}">
                <a16:creationId xmlns:a16="http://schemas.microsoft.com/office/drawing/2014/main" id="{FE2922ED-0209-95AA-CDAA-982DEB3B3942}"/>
              </a:ext>
            </a:extLst>
          </p:cNvPr>
          <p:cNvSpPr txBox="1"/>
          <p:nvPr/>
        </p:nvSpPr>
        <p:spPr>
          <a:xfrm>
            <a:off x="2260718" y="958089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5°30‘</a:t>
            </a:r>
          </a:p>
        </p:txBody>
      </p:sp>
      <p:sp>
        <p:nvSpPr>
          <p:cNvPr id="514" name="Textfeld 513">
            <a:extLst>
              <a:ext uri="{FF2B5EF4-FFF2-40B4-BE49-F238E27FC236}">
                <a16:creationId xmlns:a16="http://schemas.microsoft.com/office/drawing/2014/main" id="{FF756C64-4894-B118-8AEB-BBC8879AAE9F}"/>
              </a:ext>
            </a:extLst>
          </p:cNvPr>
          <p:cNvSpPr txBox="1"/>
          <p:nvPr/>
        </p:nvSpPr>
        <p:spPr>
          <a:xfrm>
            <a:off x="359580" y="4193640"/>
            <a:ext cx="3593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6°</a:t>
            </a:r>
          </a:p>
        </p:txBody>
      </p:sp>
      <p:sp>
        <p:nvSpPr>
          <p:cNvPr id="515" name="Textfeld 514">
            <a:extLst>
              <a:ext uri="{FF2B5EF4-FFF2-40B4-BE49-F238E27FC236}">
                <a16:creationId xmlns:a16="http://schemas.microsoft.com/office/drawing/2014/main" id="{BBA621D1-BC06-5EC0-5F91-7F9E702E11E6}"/>
              </a:ext>
            </a:extLst>
          </p:cNvPr>
          <p:cNvSpPr txBox="1"/>
          <p:nvPr/>
        </p:nvSpPr>
        <p:spPr>
          <a:xfrm>
            <a:off x="6278357" y="257838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1°30‘</a:t>
            </a:r>
          </a:p>
        </p:txBody>
      </p:sp>
      <p:cxnSp>
        <p:nvCxnSpPr>
          <p:cNvPr id="516" name="Gerader Verbinder 515">
            <a:extLst>
              <a:ext uri="{FF2B5EF4-FFF2-40B4-BE49-F238E27FC236}">
                <a16:creationId xmlns:a16="http://schemas.microsoft.com/office/drawing/2014/main" id="{F7570B94-24BC-3ACD-0F55-D96898A5E970}"/>
              </a:ext>
            </a:extLst>
          </p:cNvPr>
          <p:cNvCxnSpPr>
            <a:cxnSpLocks/>
          </p:cNvCxnSpPr>
          <p:nvPr/>
        </p:nvCxnSpPr>
        <p:spPr>
          <a:xfrm rot="1440000">
            <a:off x="3540836" y="2474840"/>
            <a:ext cx="1885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45">
            <a:extLst>
              <a:ext uri="{FF2B5EF4-FFF2-40B4-BE49-F238E27FC236}">
                <a16:creationId xmlns:a16="http://schemas.microsoft.com/office/drawing/2014/main" id="{E64BBABA-1CDC-CB74-9F92-D2D99E8213A6}"/>
              </a:ext>
            </a:extLst>
          </p:cNvPr>
          <p:cNvSpPr txBox="1">
            <a:spLocks noChangeArrowheads="1"/>
          </p:cNvSpPr>
          <p:nvPr/>
        </p:nvSpPr>
        <p:spPr bwMode="auto">
          <a:xfrm rot="19395473">
            <a:off x="3219194" y="3127306"/>
            <a:ext cx="1041165" cy="2185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de-DE" sz="820" i="1" dirty="0" err="1">
                <a:latin typeface="Calibri" pitchFamily="34" charset="0"/>
              </a:rPr>
              <a:t>Saddleback</a:t>
            </a:r>
            <a:endParaRPr lang="de-DE" sz="820" i="1" dirty="0">
              <a:latin typeface="Calibri" pitchFamily="34" charset="0"/>
            </a:endParaRPr>
          </a:p>
        </p:txBody>
      </p:sp>
      <p:sp>
        <p:nvSpPr>
          <p:cNvPr id="7" name="Textfeld 45">
            <a:extLst>
              <a:ext uri="{FF2B5EF4-FFF2-40B4-BE49-F238E27FC236}">
                <a16:creationId xmlns:a16="http://schemas.microsoft.com/office/drawing/2014/main" id="{4C8CA184-AC70-FA54-864C-7F2A9F5EED07}"/>
              </a:ext>
            </a:extLst>
          </p:cNvPr>
          <p:cNvSpPr txBox="1">
            <a:spLocks noChangeArrowheads="1"/>
          </p:cNvSpPr>
          <p:nvPr/>
        </p:nvSpPr>
        <p:spPr bwMode="auto">
          <a:xfrm rot="19849322">
            <a:off x="3663829" y="2802920"/>
            <a:ext cx="1041165" cy="2185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de-DE" sz="820" i="1" dirty="0" err="1">
                <a:latin typeface="Calibri" pitchFamily="34" charset="0"/>
              </a:rPr>
              <a:t>Syncline</a:t>
            </a:r>
            <a:endParaRPr lang="de-DE" sz="820" i="1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8396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8DF2D5-E1AD-CC21-0B2D-C9E943E9DB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 descr="Ein Bild, das Karte, Text enthält.&#10;&#10;Automatisch generierte Beschreibung">
            <a:extLst>
              <a:ext uri="{FF2B5EF4-FFF2-40B4-BE49-F238E27FC236}">
                <a16:creationId xmlns:a16="http://schemas.microsoft.com/office/drawing/2014/main" id="{34DE03A1-5591-CC3E-5B20-77D3F22F8B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763" y="-10510"/>
            <a:ext cx="4850005" cy="6858000"/>
          </a:xfrm>
          <a:prstGeom prst="rect">
            <a:avLst/>
          </a:prstGeom>
        </p:spPr>
      </p:pic>
      <p:cxnSp>
        <p:nvCxnSpPr>
          <p:cNvPr id="2" name="Gerader Verbinder 1">
            <a:extLst>
              <a:ext uri="{FF2B5EF4-FFF2-40B4-BE49-F238E27FC236}">
                <a16:creationId xmlns:a16="http://schemas.microsoft.com/office/drawing/2014/main" id="{60155A43-0136-9B87-D726-00A8747B2C92}"/>
              </a:ext>
            </a:extLst>
          </p:cNvPr>
          <p:cNvCxnSpPr/>
          <p:nvPr/>
        </p:nvCxnSpPr>
        <p:spPr>
          <a:xfrm flipH="1" flipV="1">
            <a:off x="2104040" y="4476750"/>
            <a:ext cx="546100" cy="952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>
            <a:extLst>
              <a:ext uri="{FF2B5EF4-FFF2-40B4-BE49-F238E27FC236}">
                <a16:creationId xmlns:a16="http://schemas.microsoft.com/office/drawing/2014/main" id="{7485F09E-E24C-B1ED-2C67-B26E17B72828}"/>
              </a:ext>
            </a:extLst>
          </p:cNvPr>
          <p:cNvSpPr txBox="1"/>
          <p:nvPr/>
        </p:nvSpPr>
        <p:spPr>
          <a:xfrm>
            <a:off x="2839326" y="4339709"/>
            <a:ext cx="97911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/>
              <a:t>BASE-1A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F789910E-19A7-708F-76FC-F6A23A136053}"/>
              </a:ext>
            </a:extLst>
          </p:cNvPr>
          <p:cNvSpPr txBox="1"/>
          <p:nvPr/>
        </p:nvSpPr>
        <p:spPr>
          <a:xfrm>
            <a:off x="5517931" y="2511972"/>
            <a:ext cx="337382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. 2. Loc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borehole</a:t>
            </a:r>
            <a:r>
              <a:rPr lang="de-DE" dirty="0"/>
              <a:t> BASE-1A in </a:t>
            </a:r>
            <a:r>
              <a:rPr lang="de-DE" dirty="0" err="1"/>
              <a:t>the</a:t>
            </a:r>
            <a:r>
              <a:rPr lang="de-DE" dirty="0"/>
              <a:t> Eureka </a:t>
            </a:r>
            <a:r>
              <a:rPr lang="de-DE" dirty="0" err="1"/>
              <a:t>Syncline</a:t>
            </a:r>
            <a:r>
              <a:rPr lang="de-DE" dirty="0"/>
              <a:t>. BASE-1A </a:t>
            </a:r>
            <a:r>
              <a:rPr lang="de-DE" dirty="0" err="1"/>
              <a:t>drilled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eastern</a:t>
            </a:r>
            <a:r>
              <a:rPr lang="de-DE" dirty="0"/>
              <a:t>, </a:t>
            </a:r>
            <a:r>
              <a:rPr lang="de-DE" dirty="0" err="1"/>
              <a:t>overturned</a:t>
            </a:r>
            <a:r>
              <a:rPr lang="de-DE" dirty="0"/>
              <a:t> </a:t>
            </a:r>
            <a:r>
              <a:rPr lang="de-DE" dirty="0" err="1"/>
              <a:t>limb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Eureka </a:t>
            </a:r>
            <a:r>
              <a:rPr lang="de-DE" dirty="0" err="1"/>
              <a:t>Syncline</a:t>
            </a:r>
            <a:r>
              <a:rPr lang="de-DE" dirty="0"/>
              <a:t> </a:t>
            </a:r>
            <a:r>
              <a:rPr lang="de-DE" dirty="0" err="1"/>
              <a:t>about</a:t>
            </a:r>
            <a:r>
              <a:rPr lang="de-DE" dirty="0"/>
              <a:t> 1.5 km ESE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Fairview</a:t>
            </a:r>
            <a:r>
              <a:rPr lang="de-DE" dirty="0"/>
              <a:t> Mine.</a:t>
            </a:r>
          </a:p>
        </p:txBody>
      </p:sp>
      <p:sp>
        <p:nvSpPr>
          <p:cNvPr id="5" name="Freihandform: Form 4">
            <a:extLst>
              <a:ext uri="{FF2B5EF4-FFF2-40B4-BE49-F238E27FC236}">
                <a16:creationId xmlns:a16="http://schemas.microsoft.com/office/drawing/2014/main" id="{58AC6107-5421-BCB8-8002-71635BA4C55B}"/>
              </a:ext>
            </a:extLst>
          </p:cNvPr>
          <p:cNvSpPr/>
          <p:nvPr/>
        </p:nvSpPr>
        <p:spPr>
          <a:xfrm>
            <a:off x="893379" y="3752193"/>
            <a:ext cx="420414" cy="536028"/>
          </a:xfrm>
          <a:custGeom>
            <a:avLst/>
            <a:gdLst>
              <a:gd name="connsiteX0" fmla="*/ 0 w 420414"/>
              <a:gd name="connsiteY0" fmla="*/ 168166 h 536028"/>
              <a:gd name="connsiteX1" fmla="*/ 220718 w 420414"/>
              <a:gd name="connsiteY1" fmla="*/ 168166 h 536028"/>
              <a:gd name="connsiteX2" fmla="*/ 346842 w 420414"/>
              <a:gd name="connsiteY2" fmla="*/ 0 h 536028"/>
              <a:gd name="connsiteX3" fmla="*/ 420414 w 420414"/>
              <a:gd name="connsiteY3" fmla="*/ 178676 h 536028"/>
              <a:gd name="connsiteX4" fmla="*/ 304800 w 420414"/>
              <a:gd name="connsiteY4" fmla="*/ 294290 h 536028"/>
              <a:gd name="connsiteX5" fmla="*/ 346842 w 420414"/>
              <a:gd name="connsiteY5" fmla="*/ 483476 h 536028"/>
              <a:gd name="connsiteX6" fmla="*/ 84083 w 420414"/>
              <a:gd name="connsiteY6" fmla="*/ 536028 h 536028"/>
              <a:gd name="connsiteX7" fmla="*/ 0 w 420414"/>
              <a:gd name="connsiteY7" fmla="*/ 168166 h 536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20414" h="536028">
                <a:moveTo>
                  <a:pt x="0" y="168166"/>
                </a:moveTo>
                <a:lnTo>
                  <a:pt x="220718" y="168166"/>
                </a:lnTo>
                <a:lnTo>
                  <a:pt x="346842" y="0"/>
                </a:lnTo>
                <a:lnTo>
                  <a:pt x="420414" y="178676"/>
                </a:lnTo>
                <a:lnTo>
                  <a:pt x="304800" y="294290"/>
                </a:lnTo>
                <a:lnTo>
                  <a:pt x="346842" y="483476"/>
                </a:lnTo>
                <a:lnTo>
                  <a:pt x="84083" y="536028"/>
                </a:lnTo>
                <a:lnTo>
                  <a:pt x="0" y="168166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5B66856-B789-F292-99CC-F7CE3F71CEAD}"/>
              </a:ext>
            </a:extLst>
          </p:cNvPr>
          <p:cNvSpPr txBox="1"/>
          <p:nvPr/>
        </p:nvSpPr>
        <p:spPr>
          <a:xfrm rot="18204666">
            <a:off x="1346369" y="1986911"/>
            <a:ext cx="2050712" cy="512391"/>
          </a:xfrm>
          <a:prstGeom prst="rect">
            <a:avLst/>
          </a:prstGeom>
          <a:noFill/>
        </p:spPr>
        <p:txBody>
          <a:bodyPr wrap="square" rtlCol="0">
            <a:prstTxWarp prst="textArchUp">
              <a:avLst>
                <a:gd name="adj" fmla="val 10781071"/>
              </a:avLst>
            </a:prstTxWarp>
            <a:spAutoFit/>
            <a:scene3d>
              <a:camera prst="orthographicFront">
                <a:rot lat="0" lon="0" rev="0"/>
              </a:camera>
              <a:lightRig rig="threePt" dir="t"/>
            </a:scene3d>
            <a:sp3d z="12700">
              <a:bevelT w="19050"/>
            </a:sp3d>
          </a:bodyPr>
          <a:lstStyle/>
          <a:p>
            <a:pPr algn="ctr"/>
            <a:r>
              <a:rPr lang="de-DE" dirty="0"/>
              <a:t>Eureka </a:t>
            </a:r>
            <a:r>
              <a:rPr lang="de-DE" dirty="0" err="1"/>
              <a:t>Syncline</a:t>
            </a:r>
            <a:endParaRPr lang="de-DE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FE156638-7E3A-5E6A-00C5-5E8ABDE6EDE1}"/>
              </a:ext>
            </a:extLst>
          </p:cNvPr>
          <p:cNvSpPr txBox="1"/>
          <p:nvPr/>
        </p:nvSpPr>
        <p:spPr>
          <a:xfrm>
            <a:off x="231461" y="4288221"/>
            <a:ext cx="9664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airview</a:t>
            </a:r>
            <a:endParaRPr lang="de-DE" dirty="0"/>
          </a:p>
          <a:p>
            <a:r>
              <a:rPr lang="de-DE" dirty="0"/>
              <a:t>Mine</a:t>
            </a:r>
          </a:p>
          <a:p>
            <a:endParaRPr lang="de-DE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73250CA8-A7D6-0E98-55A6-D77E1CB61FED}"/>
              </a:ext>
            </a:extLst>
          </p:cNvPr>
          <p:cNvSpPr txBox="1"/>
          <p:nvPr/>
        </p:nvSpPr>
        <p:spPr>
          <a:xfrm rot="19114112">
            <a:off x="733737" y="777846"/>
            <a:ext cx="746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R38 </a:t>
            </a:r>
            <a:r>
              <a:rPr lang="de-DE" sz="1200" dirty="0" err="1"/>
              <a:t>road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4035161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28C03D-BA95-F383-5386-C611B2739A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1D3754FB-D3D9-5C0B-D2C3-3C5BD48378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4052" t="27132" r="26122" b="5951"/>
          <a:stretch/>
        </p:blipFill>
        <p:spPr>
          <a:xfrm rot="16200000">
            <a:off x="-314329" y="2022473"/>
            <a:ext cx="3543304" cy="3524247"/>
          </a:xfrm>
          <a:prstGeom prst="rect">
            <a:avLst/>
          </a:prstGeom>
        </p:spPr>
      </p:pic>
      <p:pic>
        <p:nvPicPr>
          <p:cNvPr id="3" name="Grafik 2" descr="Ein Bild, das Karte, Text enthält.&#10;&#10;Automatisch generierte Beschreibung">
            <a:extLst>
              <a:ext uri="{FF2B5EF4-FFF2-40B4-BE49-F238E27FC236}">
                <a16:creationId xmlns:a16="http://schemas.microsoft.com/office/drawing/2014/main" id="{192F2028-2610-7268-2BB3-064BFEF093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0510" y="0"/>
            <a:ext cx="4850005" cy="6858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F69117E3-E781-D813-2D35-72DAC7553333}"/>
              </a:ext>
            </a:extLst>
          </p:cNvPr>
          <p:cNvCxnSpPr>
            <a:cxnSpLocks/>
          </p:cNvCxnSpPr>
          <p:nvPr/>
        </p:nvCxnSpPr>
        <p:spPr>
          <a:xfrm flipH="1" flipV="1">
            <a:off x="2139950" y="4467225"/>
            <a:ext cx="463550" cy="9842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Pfeil: Fünfeck 13">
            <a:extLst>
              <a:ext uri="{FF2B5EF4-FFF2-40B4-BE49-F238E27FC236}">
                <a16:creationId xmlns:a16="http://schemas.microsoft.com/office/drawing/2014/main" id="{AACA76F9-3888-52FE-2771-EF3E328B4754}"/>
              </a:ext>
            </a:extLst>
          </p:cNvPr>
          <p:cNvSpPr/>
          <p:nvPr/>
        </p:nvSpPr>
        <p:spPr>
          <a:xfrm flipH="1">
            <a:off x="2717397" y="4281706"/>
            <a:ext cx="1620048" cy="567887"/>
          </a:xfrm>
          <a:prstGeom prst="homePlat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BASE-1A</a:t>
            </a:r>
          </a:p>
        </p:txBody>
      </p:sp>
      <p:sp>
        <p:nvSpPr>
          <p:cNvPr id="15" name="Freihandform: Form 14">
            <a:extLst>
              <a:ext uri="{FF2B5EF4-FFF2-40B4-BE49-F238E27FC236}">
                <a16:creationId xmlns:a16="http://schemas.microsoft.com/office/drawing/2014/main" id="{9FEC126B-29CC-8ECE-86C6-904CCF04A7DB}"/>
              </a:ext>
            </a:extLst>
          </p:cNvPr>
          <p:cNvSpPr/>
          <p:nvPr/>
        </p:nvSpPr>
        <p:spPr>
          <a:xfrm>
            <a:off x="893379" y="3752193"/>
            <a:ext cx="420414" cy="536028"/>
          </a:xfrm>
          <a:custGeom>
            <a:avLst/>
            <a:gdLst>
              <a:gd name="connsiteX0" fmla="*/ 0 w 420414"/>
              <a:gd name="connsiteY0" fmla="*/ 168166 h 536028"/>
              <a:gd name="connsiteX1" fmla="*/ 220718 w 420414"/>
              <a:gd name="connsiteY1" fmla="*/ 168166 h 536028"/>
              <a:gd name="connsiteX2" fmla="*/ 346842 w 420414"/>
              <a:gd name="connsiteY2" fmla="*/ 0 h 536028"/>
              <a:gd name="connsiteX3" fmla="*/ 420414 w 420414"/>
              <a:gd name="connsiteY3" fmla="*/ 178676 h 536028"/>
              <a:gd name="connsiteX4" fmla="*/ 304800 w 420414"/>
              <a:gd name="connsiteY4" fmla="*/ 294290 h 536028"/>
              <a:gd name="connsiteX5" fmla="*/ 346842 w 420414"/>
              <a:gd name="connsiteY5" fmla="*/ 483476 h 536028"/>
              <a:gd name="connsiteX6" fmla="*/ 84083 w 420414"/>
              <a:gd name="connsiteY6" fmla="*/ 536028 h 536028"/>
              <a:gd name="connsiteX7" fmla="*/ 0 w 420414"/>
              <a:gd name="connsiteY7" fmla="*/ 168166 h 536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20414" h="536028">
                <a:moveTo>
                  <a:pt x="0" y="168166"/>
                </a:moveTo>
                <a:lnTo>
                  <a:pt x="220718" y="168166"/>
                </a:lnTo>
                <a:lnTo>
                  <a:pt x="346842" y="0"/>
                </a:lnTo>
                <a:lnTo>
                  <a:pt x="420414" y="178676"/>
                </a:lnTo>
                <a:lnTo>
                  <a:pt x="304800" y="294290"/>
                </a:lnTo>
                <a:lnTo>
                  <a:pt x="346842" y="483476"/>
                </a:lnTo>
                <a:lnTo>
                  <a:pt x="84083" y="536028"/>
                </a:lnTo>
                <a:lnTo>
                  <a:pt x="0" y="168166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ABA3E879-5614-08FD-16E0-F5F623449A98}"/>
              </a:ext>
            </a:extLst>
          </p:cNvPr>
          <p:cNvSpPr txBox="1"/>
          <p:nvPr/>
        </p:nvSpPr>
        <p:spPr>
          <a:xfrm rot="18204666">
            <a:off x="1346369" y="1986911"/>
            <a:ext cx="2050712" cy="512391"/>
          </a:xfrm>
          <a:prstGeom prst="rect">
            <a:avLst/>
          </a:prstGeom>
          <a:noFill/>
        </p:spPr>
        <p:txBody>
          <a:bodyPr wrap="square" rtlCol="0">
            <a:prstTxWarp prst="textArchUp">
              <a:avLst>
                <a:gd name="adj" fmla="val 10781071"/>
              </a:avLst>
            </a:prstTxWarp>
            <a:spAutoFit/>
            <a:scene3d>
              <a:camera prst="orthographicFront">
                <a:rot lat="0" lon="0" rev="0"/>
              </a:camera>
              <a:lightRig rig="threePt" dir="t"/>
            </a:scene3d>
            <a:sp3d z="12700">
              <a:bevelT w="19050"/>
            </a:sp3d>
          </a:bodyPr>
          <a:lstStyle/>
          <a:p>
            <a:pPr algn="ctr"/>
            <a:r>
              <a:rPr lang="de-DE" dirty="0"/>
              <a:t>Eureka </a:t>
            </a:r>
            <a:r>
              <a:rPr lang="de-DE" dirty="0" err="1"/>
              <a:t>Syncline</a:t>
            </a:r>
            <a:endParaRPr lang="de-DE" dirty="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E2910BA-5F3E-C46E-1987-A5E82C27F0CE}"/>
              </a:ext>
            </a:extLst>
          </p:cNvPr>
          <p:cNvSpPr txBox="1"/>
          <p:nvPr/>
        </p:nvSpPr>
        <p:spPr>
          <a:xfrm>
            <a:off x="231461" y="4288221"/>
            <a:ext cx="9664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airview</a:t>
            </a:r>
            <a:endParaRPr lang="de-DE" dirty="0"/>
          </a:p>
          <a:p>
            <a:r>
              <a:rPr lang="de-DE" dirty="0"/>
              <a:t>Mine</a:t>
            </a:r>
          </a:p>
          <a:p>
            <a:endParaRPr lang="de-DE" dirty="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72D576A-BF56-5F23-16DF-0716217722C1}"/>
              </a:ext>
            </a:extLst>
          </p:cNvPr>
          <p:cNvSpPr txBox="1"/>
          <p:nvPr/>
        </p:nvSpPr>
        <p:spPr>
          <a:xfrm rot="19114112">
            <a:off x="733737" y="777846"/>
            <a:ext cx="746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R38 </a:t>
            </a:r>
            <a:r>
              <a:rPr lang="de-DE" sz="1200" dirty="0" err="1"/>
              <a:t>road</a:t>
            </a:r>
            <a:endParaRPr lang="de-DE" sz="1200" dirty="0"/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A7605924-8C8C-0133-253B-7F80C16C87AA}"/>
              </a:ext>
            </a:extLst>
          </p:cNvPr>
          <p:cNvSpPr/>
          <p:nvPr/>
        </p:nvSpPr>
        <p:spPr>
          <a:xfrm>
            <a:off x="5097517" y="4372311"/>
            <a:ext cx="378373" cy="210207"/>
          </a:xfrm>
          <a:prstGeom prst="rect">
            <a:avLst/>
          </a:prstGeom>
          <a:solidFill>
            <a:srgbClr val="E64C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6E790539-8020-1635-B2DB-7611F1CEA194}"/>
              </a:ext>
            </a:extLst>
          </p:cNvPr>
          <p:cNvSpPr/>
          <p:nvPr/>
        </p:nvSpPr>
        <p:spPr>
          <a:xfrm>
            <a:off x="5091745" y="3661771"/>
            <a:ext cx="378373" cy="210207"/>
          </a:xfrm>
          <a:prstGeom prst="rect">
            <a:avLst/>
          </a:prstGeom>
          <a:solidFill>
            <a:srgbClr val="A8D18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Rechteck 21">
            <a:extLst>
              <a:ext uri="{FF2B5EF4-FFF2-40B4-BE49-F238E27FC236}">
                <a16:creationId xmlns:a16="http://schemas.microsoft.com/office/drawing/2014/main" id="{82A651F3-C969-DE01-B314-E6C64975CC53}"/>
              </a:ext>
            </a:extLst>
          </p:cNvPr>
          <p:cNvSpPr/>
          <p:nvPr/>
        </p:nvSpPr>
        <p:spPr>
          <a:xfrm>
            <a:off x="5085973" y="3361130"/>
            <a:ext cx="378373" cy="210207"/>
          </a:xfrm>
          <a:prstGeom prst="rect">
            <a:avLst/>
          </a:prstGeom>
          <a:solidFill>
            <a:srgbClr val="4E4E4E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0F2A5CC3-D083-85B2-6296-8300DC59861C}"/>
              </a:ext>
            </a:extLst>
          </p:cNvPr>
          <p:cNvSpPr/>
          <p:nvPr/>
        </p:nvSpPr>
        <p:spPr>
          <a:xfrm>
            <a:off x="5080201" y="2629569"/>
            <a:ext cx="378373" cy="210207"/>
          </a:xfrm>
          <a:prstGeom prst="rect">
            <a:avLst/>
          </a:prstGeom>
          <a:solidFill>
            <a:srgbClr val="F4B18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>
            <a:extLst>
              <a:ext uri="{FF2B5EF4-FFF2-40B4-BE49-F238E27FC236}">
                <a16:creationId xmlns:a16="http://schemas.microsoft.com/office/drawing/2014/main" id="{D54FFB8A-BEBA-059D-8D4B-7419D3E120D5}"/>
              </a:ext>
            </a:extLst>
          </p:cNvPr>
          <p:cNvSpPr/>
          <p:nvPr/>
        </p:nvSpPr>
        <p:spPr>
          <a:xfrm>
            <a:off x="5074429" y="2328928"/>
            <a:ext cx="378373" cy="210207"/>
          </a:xfrm>
          <a:prstGeom prst="rect">
            <a:avLst/>
          </a:prstGeom>
          <a:solidFill>
            <a:srgbClr val="9C9C9C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FA24613E-B9BA-CBAC-21C1-3D82DEB65E07}"/>
              </a:ext>
            </a:extLst>
          </p:cNvPr>
          <p:cNvSpPr/>
          <p:nvPr/>
        </p:nvSpPr>
        <p:spPr>
          <a:xfrm>
            <a:off x="5068657" y="1639402"/>
            <a:ext cx="378373" cy="210207"/>
          </a:xfrm>
          <a:prstGeom prst="rect">
            <a:avLst/>
          </a:prstGeom>
          <a:solidFill>
            <a:srgbClr val="FFEBA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Rechteck 25">
            <a:extLst>
              <a:ext uri="{FF2B5EF4-FFF2-40B4-BE49-F238E27FC236}">
                <a16:creationId xmlns:a16="http://schemas.microsoft.com/office/drawing/2014/main" id="{76EA8795-FD78-464B-623A-61AF0195145E}"/>
              </a:ext>
            </a:extLst>
          </p:cNvPr>
          <p:cNvSpPr/>
          <p:nvPr/>
        </p:nvSpPr>
        <p:spPr>
          <a:xfrm>
            <a:off x="5062885" y="1338761"/>
            <a:ext cx="378373" cy="210207"/>
          </a:xfrm>
          <a:prstGeom prst="rect">
            <a:avLst/>
          </a:prstGeom>
          <a:solidFill>
            <a:srgbClr val="E594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7509A89E-114B-A551-6CD8-73045CB49B44}"/>
              </a:ext>
            </a:extLst>
          </p:cNvPr>
          <p:cNvSpPr/>
          <p:nvPr/>
        </p:nvSpPr>
        <p:spPr>
          <a:xfrm>
            <a:off x="5057113" y="1038120"/>
            <a:ext cx="378373" cy="210207"/>
          </a:xfrm>
          <a:prstGeom prst="rect">
            <a:avLst/>
          </a:prstGeom>
          <a:solidFill>
            <a:srgbClr val="F57778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E883EF92-8A5C-C2D0-E08C-1D08DB514493}"/>
              </a:ext>
            </a:extLst>
          </p:cNvPr>
          <p:cNvSpPr/>
          <p:nvPr/>
        </p:nvSpPr>
        <p:spPr>
          <a:xfrm>
            <a:off x="5051341" y="737479"/>
            <a:ext cx="378373" cy="210207"/>
          </a:xfrm>
          <a:prstGeom prst="rect">
            <a:avLst/>
          </a:prstGeom>
          <a:solidFill>
            <a:srgbClr val="C4B56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D1C1288B-FB84-8293-4388-7116137C9C5F}"/>
              </a:ext>
            </a:extLst>
          </p:cNvPr>
          <p:cNvSpPr txBox="1"/>
          <p:nvPr/>
        </p:nvSpPr>
        <p:spPr>
          <a:xfrm>
            <a:off x="5607218" y="4339990"/>
            <a:ext cx="16354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Kaap</a:t>
            </a:r>
            <a:r>
              <a:rPr lang="de-DE" sz="1400" dirty="0"/>
              <a:t> Valley </a:t>
            </a:r>
            <a:r>
              <a:rPr lang="de-DE" sz="1400" dirty="0" err="1"/>
              <a:t>Tonalite</a:t>
            </a:r>
            <a:endParaRPr lang="de-DE" sz="1400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D55661EE-D6BC-D27B-81F9-8C03F552A175}"/>
              </a:ext>
            </a:extLst>
          </p:cNvPr>
          <p:cNvSpPr txBox="1"/>
          <p:nvPr/>
        </p:nvSpPr>
        <p:spPr>
          <a:xfrm>
            <a:off x="5444360" y="3630548"/>
            <a:ext cx="21391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(ultra-)</a:t>
            </a:r>
            <a:r>
              <a:rPr lang="de-DE" sz="1400" dirty="0" err="1"/>
              <a:t>mafic</a:t>
            </a:r>
            <a:r>
              <a:rPr lang="de-DE" sz="1400" dirty="0"/>
              <a:t> </a:t>
            </a:r>
            <a:r>
              <a:rPr lang="de-DE" sz="1400" dirty="0" err="1"/>
              <a:t>volcanic</a:t>
            </a:r>
            <a:r>
              <a:rPr lang="de-DE" sz="1400" dirty="0"/>
              <a:t> </a:t>
            </a:r>
            <a:r>
              <a:rPr lang="de-DE" sz="1400" dirty="0" err="1"/>
              <a:t>rocks</a:t>
            </a:r>
            <a:endParaRPr lang="de-DE" sz="1400" dirty="0"/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DD9A06F7-011D-8333-906E-38B427FD8C29}"/>
              </a:ext>
            </a:extLst>
          </p:cNvPr>
          <p:cNvSpPr txBox="1"/>
          <p:nvPr/>
        </p:nvSpPr>
        <p:spPr>
          <a:xfrm>
            <a:off x="5444360" y="3320495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Chert</a:t>
            </a:r>
            <a:endParaRPr lang="de-DE" sz="1400" dirty="0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5D065A3A-2A29-2F2E-B51A-804B276B1E04}"/>
              </a:ext>
            </a:extLst>
          </p:cNvPr>
          <p:cNvSpPr txBox="1"/>
          <p:nvPr/>
        </p:nvSpPr>
        <p:spPr>
          <a:xfrm>
            <a:off x="5444360" y="2579522"/>
            <a:ext cx="2595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Ferruginous</a:t>
            </a:r>
            <a:r>
              <a:rPr lang="de-DE" sz="1400" dirty="0"/>
              <a:t> </a:t>
            </a:r>
            <a:r>
              <a:rPr lang="de-DE" sz="1400" dirty="0" err="1"/>
              <a:t>shales</a:t>
            </a:r>
            <a:r>
              <a:rPr lang="de-DE" sz="1400" dirty="0"/>
              <a:t> and </a:t>
            </a:r>
            <a:r>
              <a:rPr lang="de-DE" sz="1400" dirty="0" err="1"/>
              <a:t>siltstones</a:t>
            </a:r>
            <a:endParaRPr lang="de-DE" sz="1400" dirty="0"/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1C01159E-9826-6AA9-1AFE-6C7BAFB65EB5}"/>
              </a:ext>
            </a:extLst>
          </p:cNvPr>
          <p:cNvSpPr txBox="1"/>
          <p:nvPr/>
        </p:nvSpPr>
        <p:spPr>
          <a:xfrm>
            <a:off x="5444360" y="2279979"/>
            <a:ext cx="1367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Lithic</a:t>
            </a:r>
            <a:r>
              <a:rPr lang="de-DE" sz="1400" dirty="0"/>
              <a:t> </a:t>
            </a:r>
            <a:r>
              <a:rPr lang="de-DE" sz="1400" dirty="0" err="1"/>
              <a:t>sandstone</a:t>
            </a:r>
            <a:endParaRPr lang="de-DE" sz="1400" dirty="0"/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F3B61F09-BAAB-55DD-3F87-3CBE1D59B92C}"/>
              </a:ext>
            </a:extLst>
          </p:cNvPr>
          <p:cNvSpPr txBox="1"/>
          <p:nvPr/>
        </p:nvSpPr>
        <p:spPr>
          <a:xfrm>
            <a:off x="5444360" y="1591551"/>
            <a:ext cx="2062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Siltstone</a:t>
            </a:r>
            <a:r>
              <a:rPr lang="de-DE" sz="1400" dirty="0"/>
              <a:t> and </a:t>
            </a:r>
            <a:r>
              <a:rPr lang="de-DE" sz="1400" dirty="0" err="1"/>
              <a:t>shale</a:t>
            </a:r>
            <a:r>
              <a:rPr lang="de-DE" sz="1400" dirty="0"/>
              <a:t>, MdS2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5B104355-B96C-67B0-73B6-FE6F8FCD7E5C}"/>
              </a:ext>
            </a:extLst>
          </p:cNvPr>
          <p:cNvSpPr txBox="1"/>
          <p:nvPr/>
        </p:nvSpPr>
        <p:spPr>
          <a:xfrm>
            <a:off x="5444360" y="1292008"/>
            <a:ext cx="172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Quartzose</a:t>
            </a:r>
            <a:r>
              <a:rPr lang="de-DE" sz="1400" dirty="0"/>
              <a:t> </a:t>
            </a:r>
            <a:r>
              <a:rPr lang="de-DE" sz="1400" dirty="0" err="1"/>
              <a:t>sandstone</a:t>
            </a:r>
            <a:endParaRPr lang="de-DE" sz="1400" dirty="0"/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CB9AC476-093B-002E-3AB5-911BEEF07958}"/>
              </a:ext>
            </a:extLst>
          </p:cNvPr>
          <p:cNvSpPr txBox="1"/>
          <p:nvPr/>
        </p:nvSpPr>
        <p:spPr>
          <a:xfrm>
            <a:off x="5444360" y="992465"/>
            <a:ext cx="1077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Jaspilite</a:t>
            </a:r>
            <a:r>
              <a:rPr lang="de-DE" sz="1400" dirty="0"/>
              <a:t>, BIF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46CCA459-764F-58BC-6896-AF94349ACEDF}"/>
              </a:ext>
            </a:extLst>
          </p:cNvPr>
          <p:cNvSpPr txBox="1"/>
          <p:nvPr/>
        </p:nvSpPr>
        <p:spPr>
          <a:xfrm>
            <a:off x="5444360" y="692922"/>
            <a:ext cx="2074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Siltstone</a:t>
            </a:r>
            <a:r>
              <a:rPr lang="de-DE" sz="1400" dirty="0"/>
              <a:t> and </a:t>
            </a:r>
            <a:r>
              <a:rPr lang="de-DE" sz="1400" dirty="0" err="1"/>
              <a:t>Shale</a:t>
            </a:r>
            <a:r>
              <a:rPr lang="de-DE" sz="1400" dirty="0"/>
              <a:t>, MdS3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3FF1CAF9-47AC-C56B-6308-F7A35AA2F0B0}"/>
              </a:ext>
            </a:extLst>
          </p:cNvPr>
          <p:cNvSpPr txBox="1"/>
          <p:nvPr/>
        </p:nvSpPr>
        <p:spPr>
          <a:xfrm>
            <a:off x="4940967" y="2001636"/>
            <a:ext cx="1398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Fig </a:t>
            </a:r>
            <a:r>
              <a:rPr lang="de-DE" sz="1600" dirty="0" err="1"/>
              <a:t>Tree</a:t>
            </a:r>
            <a:r>
              <a:rPr lang="de-DE" sz="1600" dirty="0"/>
              <a:t> Group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C374E5F6-8837-F313-CFC2-CDA4BE08D41F}"/>
              </a:ext>
            </a:extLst>
          </p:cNvPr>
          <p:cNvSpPr txBox="1"/>
          <p:nvPr/>
        </p:nvSpPr>
        <p:spPr>
          <a:xfrm>
            <a:off x="4984348" y="3013916"/>
            <a:ext cx="17645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/>
              <a:t>Onverwacht</a:t>
            </a:r>
            <a:r>
              <a:rPr lang="de-DE" sz="1600" dirty="0"/>
              <a:t> Group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43E2A3CD-EAAB-9486-4E8B-143255A42D16}"/>
              </a:ext>
            </a:extLst>
          </p:cNvPr>
          <p:cNvSpPr txBox="1"/>
          <p:nvPr/>
        </p:nvSpPr>
        <p:spPr>
          <a:xfrm>
            <a:off x="4954346" y="410187"/>
            <a:ext cx="14829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Moodies Group</a:t>
            </a:r>
          </a:p>
        </p:txBody>
      </p:sp>
      <p:sp>
        <p:nvSpPr>
          <p:cNvPr id="41" name="Freihandform: Form 40">
            <a:extLst>
              <a:ext uri="{FF2B5EF4-FFF2-40B4-BE49-F238E27FC236}">
                <a16:creationId xmlns:a16="http://schemas.microsoft.com/office/drawing/2014/main" id="{ACC0C254-A6ED-6146-F288-78FE70CB7799}"/>
              </a:ext>
            </a:extLst>
          </p:cNvPr>
          <p:cNvSpPr/>
          <p:nvPr/>
        </p:nvSpPr>
        <p:spPr>
          <a:xfrm>
            <a:off x="5118538" y="4645587"/>
            <a:ext cx="451945" cy="241737"/>
          </a:xfrm>
          <a:custGeom>
            <a:avLst/>
            <a:gdLst>
              <a:gd name="connsiteX0" fmla="*/ 451945 w 451945"/>
              <a:gd name="connsiteY0" fmla="*/ 241737 h 241737"/>
              <a:gd name="connsiteX1" fmla="*/ 168165 w 451945"/>
              <a:gd name="connsiteY1" fmla="*/ 126124 h 241737"/>
              <a:gd name="connsiteX2" fmla="*/ 84083 w 451945"/>
              <a:gd name="connsiteY2" fmla="*/ 31531 h 241737"/>
              <a:gd name="connsiteX3" fmla="*/ 0 w 451945"/>
              <a:gd name="connsiteY3" fmla="*/ 0 h 2417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51945" h="241737">
                <a:moveTo>
                  <a:pt x="451945" y="241737"/>
                </a:moveTo>
                <a:cubicBezTo>
                  <a:pt x="340710" y="201447"/>
                  <a:pt x="229475" y="161158"/>
                  <a:pt x="168165" y="126124"/>
                </a:cubicBezTo>
                <a:cubicBezTo>
                  <a:pt x="106855" y="91090"/>
                  <a:pt x="112110" y="52552"/>
                  <a:pt x="84083" y="31531"/>
                </a:cubicBezTo>
                <a:cubicBezTo>
                  <a:pt x="56055" y="10510"/>
                  <a:pt x="28027" y="5255"/>
                  <a:pt x="0" y="0"/>
                </a:cubicBezTo>
              </a:path>
            </a:pathLst>
          </a:cu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07966C3-87D4-E68B-3B01-8CB668621E34}"/>
              </a:ext>
            </a:extLst>
          </p:cNvPr>
          <p:cNvSpPr txBox="1"/>
          <p:nvPr/>
        </p:nvSpPr>
        <p:spPr>
          <a:xfrm>
            <a:off x="5607218" y="4695753"/>
            <a:ext cx="2124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dolerite</a:t>
            </a:r>
            <a:r>
              <a:rPr lang="de-DE" sz="1400" dirty="0"/>
              <a:t> </a:t>
            </a:r>
            <a:r>
              <a:rPr lang="de-DE" sz="1400" dirty="0" err="1"/>
              <a:t>dikes</a:t>
            </a:r>
            <a:r>
              <a:rPr lang="de-DE" sz="1400" dirty="0"/>
              <a:t> (ca. 2.97 Ga)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FEECFBBC-2D88-8208-A8C0-9E036D0AB4DE}"/>
              </a:ext>
            </a:extLst>
          </p:cNvPr>
          <p:cNvSpPr txBox="1"/>
          <p:nvPr/>
        </p:nvSpPr>
        <p:spPr>
          <a:xfrm>
            <a:off x="4933326" y="80235"/>
            <a:ext cx="864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egend</a:t>
            </a:r>
          </a:p>
        </p:txBody>
      </p:sp>
      <p:sp>
        <p:nvSpPr>
          <p:cNvPr id="44" name="Freihandform: Form 43">
            <a:extLst>
              <a:ext uri="{FF2B5EF4-FFF2-40B4-BE49-F238E27FC236}">
                <a16:creationId xmlns:a16="http://schemas.microsoft.com/office/drawing/2014/main" id="{202831E5-474C-30CF-1135-6D04ADF3AF9A}"/>
              </a:ext>
            </a:extLst>
          </p:cNvPr>
          <p:cNvSpPr/>
          <p:nvPr/>
        </p:nvSpPr>
        <p:spPr>
          <a:xfrm>
            <a:off x="5139559" y="5087017"/>
            <a:ext cx="483475" cy="55098"/>
          </a:xfrm>
          <a:custGeom>
            <a:avLst/>
            <a:gdLst>
              <a:gd name="connsiteX0" fmla="*/ 0 w 483475"/>
              <a:gd name="connsiteY0" fmla="*/ 0 h 55098"/>
              <a:gd name="connsiteX1" fmla="*/ 294289 w 483475"/>
              <a:gd name="connsiteY1" fmla="*/ 52552 h 55098"/>
              <a:gd name="connsiteX2" fmla="*/ 483475 w 483475"/>
              <a:gd name="connsiteY2" fmla="*/ 42041 h 550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83475" h="55098">
                <a:moveTo>
                  <a:pt x="0" y="0"/>
                </a:moveTo>
                <a:cubicBezTo>
                  <a:pt x="106855" y="22772"/>
                  <a:pt x="213710" y="45545"/>
                  <a:pt x="294289" y="52552"/>
                </a:cubicBezTo>
                <a:cubicBezTo>
                  <a:pt x="374868" y="59559"/>
                  <a:pt x="429171" y="50800"/>
                  <a:pt x="483475" y="42041"/>
                </a:cubicBezTo>
              </a:path>
            </a:pathLst>
          </a:cu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Gleichschenkliges Dreieck 44">
            <a:extLst>
              <a:ext uri="{FF2B5EF4-FFF2-40B4-BE49-F238E27FC236}">
                <a16:creationId xmlns:a16="http://schemas.microsoft.com/office/drawing/2014/main" id="{82BFDEBD-C453-6375-E928-750B3E24F5ED}"/>
              </a:ext>
            </a:extLst>
          </p:cNvPr>
          <p:cNvSpPr/>
          <p:nvPr/>
        </p:nvSpPr>
        <p:spPr>
          <a:xfrm rot="620900">
            <a:off x="5329238" y="5236705"/>
            <a:ext cx="45719" cy="45719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Gleichschenkliges Dreieck 45">
            <a:extLst>
              <a:ext uri="{FF2B5EF4-FFF2-40B4-BE49-F238E27FC236}">
                <a16:creationId xmlns:a16="http://schemas.microsoft.com/office/drawing/2014/main" id="{44BC7EB2-C063-B0FF-2683-2AE6D59C1E59}"/>
              </a:ext>
            </a:extLst>
          </p:cNvPr>
          <p:cNvSpPr/>
          <p:nvPr/>
        </p:nvSpPr>
        <p:spPr>
          <a:xfrm rot="11427116">
            <a:off x="5348278" y="5065079"/>
            <a:ext cx="45719" cy="45719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F5F2200B-1F0F-AAEE-5AC8-F822D9549C43}"/>
              </a:ext>
            </a:extLst>
          </p:cNvPr>
          <p:cNvSpPr txBox="1"/>
          <p:nvPr/>
        </p:nvSpPr>
        <p:spPr>
          <a:xfrm>
            <a:off x="5607218" y="4974273"/>
            <a:ext cx="1447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synclinal</a:t>
            </a:r>
            <a:r>
              <a:rPr lang="de-DE" sz="1400" dirty="0"/>
              <a:t> </a:t>
            </a:r>
            <a:r>
              <a:rPr lang="de-DE" sz="1400" dirty="0" err="1"/>
              <a:t>fold</a:t>
            </a:r>
            <a:r>
              <a:rPr lang="de-DE" sz="1400" dirty="0"/>
              <a:t> </a:t>
            </a:r>
            <a:r>
              <a:rPr lang="de-DE" sz="1400" dirty="0" err="1"/>
              <a:t>axis</a:t>
            </a:r>
            <a:endParaRPr lang="de-DE" sz="1400" dirty="0"/>
          </a:p>
        </p:txBody>
      </p:sp>
      <p:sp>
        <p:nvSpPr>
          <p:cNvPr id="48" name="Freihandform: Form 47">
            <a:extLst>
              <a:ext uri="{FF2B5EF4-FFF2-40B4-BE49-F238E27FC236}">
                <a16:creationId xmlns:a16="http://schemas.microsoft.com/office/drawing/2014/main" id="{6EEC851A-6FE8-4287-7FE9-F0C37278B6E5}"/>
              </a:ext>
            </a:extLst>
          </p:cNvPr>
          <p:cNvSpPr/>
          <p:nvPr/>
        </p:nvSpPr>
        <p:spPr>
          <a:xfrm>
            <a:off x="5202621" y="5328742"/>
            <a:ext cx="325820" cy="92172"/>
          </a:xfrm>
          <a:custGeom>
            <a:avLst/>
            <a:gdLst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25820" h="92172">
                <a:moveTo>
                  <a:pt x="0" y="0"/>
                </a:moveTo>
                <a:cubicBezTo>
                  <a:pt x="128642" y="109"/>
                  <a:pt x="187435" y="70068"/>
                  <a:pt x="241738" y="84082"/>
                </a:cubicBezTo>
                <a:cubicBezTo>
                  <a:pt x="296041" y="98096"/>
                  <a:pt x="310930" y="91089"/>
                  <a:pt x="325820" y="84082"/>
                </a:cubicBezTo>
              </a:path>
            </a:pathLst>
          </a:custGeom>
          <a:noFill/>
          <a:ln>
            <a:solidFill>
              <a:srgbClr val="74A797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9" name="Freihandform: Form 48">
            <a:extLst>
              <a:ext uri="{FF2B5EF4-FFF2-40B4-BE49-F238E27FC236}">
                <a16:creationId xmlns:a16="http://schemas.microsoft.com/office/drawing/2014/main" id="{ADBCB830-CAFD-2FBE-5C7E-B501D134E64F}"/>
              </a:ext>
            </a:extLst>
          </p:cNvPr>
          <p:cNvSpPr/>
          <p:nvPr/>
        </p:nvSpPr>
        <p:spPr>
          <a:xfrm rot="9187984">
            <a:off x="5202425" y="5618051"/>
            <a:ext cx="325820" cy="92172"/>
          </a:xfrm>
          <a:custGeom>
            <a:avLst/>
            <a:gdLst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25820" h="92172">
                <a:moveTo>
                  <a:pt x="0" y="0"/>
                </a:moveTo>
                <a:cubicBezTo>
                  <a:pt x="93717" y="35034"/>
                  <a:pt x="187435" y="70068"/>
                  <a:pt x="241738" y="84082"/>
                </a:cubicBezTo>
                <a:cubicBezTo>
                  <a:pt x="296041" y="98096"/>
                  <a:pt x="310930" y="91089"/>
                  <a:pt x="325820" y="84082"/>
                </a:cubicBezTo>
              </a:path>
            </a:pathLst>
          </a:custGeom>
          <a:noFill/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0" name="Freihandform: Form 49">
            <a:extLst>
              <a:ext uri="{FF2B5EF4-FFF2-40B4-BE49-F238E27FC236}">
                <a16:creationId xmlns:a16="http://schemas.microsoft.com/office/drawing/2014/main" id="{046CC748-F328-3AA5-0E36-6964D099A917}"/>
              </a:ext>
            </a:extLst>
          </p:cNvPr>
          <p:cNvSpPr/>
          <p:nvPr/>
        </p:nvSpPr>
        <p:spPr>
          <a:xfrm rot="9187984">
            <a:off x="5215783" y="5641441"/>
            <a:ext cx="325820" cy="92172"/>
          </a:xfrm>
          <a:custGeom>
            <a:avLst/>
            <a:gdLst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25820" h="92172">
                <a:moveTo>
                  <a:pt x="0" y="0"/>
                </a:moveTo>
                <a:cubicBezTo>
                  <a:pt x="93717" y="35034"/>
                  <a:pt x="187435" y="70068"/>
                  <a:pt x="241738" y="84082"/>
                </a:cubicBezTo>
                <a:cubicBezTo>
                  <a:pt x="296041" y="98096"/>
                  <a:pt x="310930" y="91089"/>
                  <a:pt x="325820" y="84082"/>
                </a:cubicBezTo>
              </a:path>
            </a:pathLst>
          </a:custGeom>
          <a:noFill/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Freihandform: Form 50">
            <a:extLst>
              <a:ext uri="{FF2B5EF4-FFF2-40B4-BE49-F238E27FC236}">
                <a16:creationId xmlns:a16="http://schemas.microsoft.com/office/drawing/2014/main" id="{671C8B7F-8A72-68C7-414F-7C6784FB0880}"/>
              </a:ext>
            </a:extLst>
          </p:cNvPr>
          <p:cNvSpPr/>
          <p:nvPr/>
        </p:nvSpPr>
        <p:spPr>
          <a:xfrm rot="18020177">
            <a:off x="5386872" y="5306247"/>
            <a:ext cx="109325" cy="92172"/>
          </a:xfrm>
          <a:custGeom>
            <a:avLst/>
            <a:gdLst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  <a:gd name="connsiteX0" fmla="*/ 0 w 325820"/>
              <a:gd name="connsiteY0" fmla="*/ 0 h 92172"/>
              <a:gd name="connsiteX1" fmla="*/ 241738 w 325820"/>
              <a:gd name="connsiteY1" fmla="*/ 84082 h 92172"/>
              <a:gd name="connsiteX2" fmla="*/ 325820 w 325820"/>
              <a:gd name="connsiteY2" fmla="*/ 84082 h 921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25820" h="92172">
                <a:moveTo>
                  <a:pt x="0" y="0"/>
                </a:moveTo>
                <a:cubicBezTo>
                  <a:pt x="128642" y="109"/>
                  <a:pt x="187435" y="70068"/>
                  <a:pt x="241738" y="84082"/>
                </a:cubicBezTo>
                <a:cubicBezTo>
                  <a:pt x="296041" y="98096"/>
                  <a:pt x="310930" y="91089"/>
                  <a:pt x="325820" y="84082"/>
                </a:cubicBezTo>
              </a:path>
            </a:pathLst>
          </a:custGeom>
          <a:noFill/>
          <a:ln>
            <a:solidFill>
              <a:srgbClr val="74A797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239FB5D7-CBF7-5DBC-49D4-CB620B218C80}"/>
              </a:ext>
            </a:extLst>
          </p:cNvPr>
          <p:cNvSpPr txBox="1"/>
          <p:nvPr/>
        </p:nvSpPr>
        <p:spPr>
          <a:xfrm>
            <a:off x="5607218" y="5252435"/>
            <a:ext cx="820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drainage</a:t>
            </a:r>
            <a:endParaRPr lang="de-DE" sz="1400" dirty="0"/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371B170E-F54C-2B62-3776-27D57C5CC59A}"/>
              </a:ext>
            </a:extLst>
          </p:cNvPr>
          <p:cNvSpPr txBox="1"/>
          <p:nvPr/>
        </p:nvSpPr>
        <p:spPr>
          <a:xfrm>
            <a:off x="5607218" y="5530597"/>
            <a:ext cx="5200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road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9310372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Freihandform 10">
            <a:extLst>
              <a:ext uri="{FF2B5EF4-FFF2-40B4-BE49-F238E27FC236}">
                <a16:creationId xmlns:a16="http://schemas.microsoft.com/office/drawing/2014/main" id="{A4618276-C33D-2709-265B-E8C46EAEA55C}"/>
              </a:ext>
            </a:extLst>
          </p:cNvPr>
          <p:cNvSpPr/>
          <p:nvPr/>
        </p:nvSpPr>
        <p:spPr>
          <a:xfrm>
            <a:off x="6727277" y="1745924"/>
            <a:ext cx="946561" cy="2153841"/>
          </a:xfrm>
          <a:custGeom>
            <a:avLst/>
            <a:gdLst>
              <a:gd name="connsiteX0" fmla="*/ 0 w 1347787"/>
              <a:gd name="connsiteY0" fmla="*/ 0 h 1519237"/>
              <a:gd name="connsiteX1" fmla="*/ 966787 w 1347787"/>
              <a:gd name="connsiteY1" fmla="*/ 0 h 1519237"/>
              <a:gd name="connsiteX2" fmla="*/ 1347787 w 1347787"/>
              <a:gd name="connsiteY2" fmla="*/ 1042987 h 1519237"/>
              <a:gd name="connsiteX3" fmla="*/ 552450 w 1347787"/>
              <a:gd name="connsiteY3" fmla="*/ 1519237 h 1519237"/>
              <a:gd name="connsiteX4" fmla="*/ 0 w 1347787"/>
              <a:gd name="connsiteY4" fmla="*/ 0 h 1519237"/>
              <a:gd name="connsiteX0" fmla="*/ 0 w 1347787"/>
              <a:gd name="connsiteY0" fmla="*/ 461962 h 1981199"/>
              <a:gd name="connsiteX1" fmla="*/ 802481 w 1347787"/>
              <a:gd name="connsiteY1" fmla="*/ 0 h 1981199"/>
              <a:gd name="connsiteX2" fmla="*/ 1347787 w 1347787"/>
              <a:gd name="connsiteY2" fmla="*/ 1504949 h 1981199"/>
              <a:gd name="connsiteX3" fmla="*/ 552450 w 1347787"/>
              <a:gd name="connsiteY3" fmla="*/ 1981199 h 1981199"/>
              <a:gd name="connsiteX4" fmla="*/ 0 w 1347787"/>
              <a:gd name="connsiteY4" fmla="*/ 461962 h 1981199"/>
              <a:gd name="connsiteX0" fmla="*/ 0 w 1347787"/>
              <a:gd name="connsiteY0" fmla="*/ 461962 h 1981199"/>
              <a:gd name="connsiteX1" fmla="*/ 802481 w 1347787"/>
              <a:gd name="connsiteY1" fmla="*/ 0 h 1981199"/>
              <a:gd name="connsiteX2" fmla="*/ 1347787 w 1347787"/>
              <a:gd name="connsiteY2" fmla="*/ 1504949 h 1981199"/>
              <a:gd name="connsiteX3" fmla="*/ 552450 w 1347787"/>
              <a:gd name="connsiteY3" fmla="*/ 1981199 h 1981199"/>
              <a:gd name="connsiteX4" fmla="*/ 0 w 1347787"/>
              <a:gd name="connsiteY4" fmla="*/ 461962 h 1981199"/>
              <a:gd name="connsiteX0" fmla="*/ 0 w 1347787"/>
              <a:gd name="connsiteY0" fmla="*/ 461962 h 1981199"/>
              <a:gd name="connsiteX1" fmla="*/ 802481 w 1347787"/>
              <a:gd name="connsiteY1" fmla="*/ 0 h 1981199"/>
              <a:gd name="connsiteX2" fmla="*/ 1347787 w 1347787"/>
              <a:gd name="connsiteY2" fmla="*/ 1504949 h 1981199"/>
              <a:gd name="connsiteX3" fmla="*/ 552450 w 1347787"/>
              <a:gd name="connsiteY3" fmla="*/ 1981199 h 1981199"/>
              <a:gd name="connsiteX4" fmla="*/ 0 w 1347787"/>
              <a:gd name="connsiteY4" fmla="*/ 461962 h 1981199"/>
              <a:gd name="connsiteX0" fmla="*/ 0 w 1347787"/>
              <a:gd name="connsiteY0" fmla="*/ 549053 h 2068290"/>
              <a:gd name="connsiteX1" fmla="*/ 604837 w 1347787"/>
              <a:gd name="connsiteY1" fmla="*/ 220428 h 2068290"/>
              <a:gd name="connsiteX2" fmla="*/ 802481 w 1347787"/>
              <a:gd name="connsiteY2" fmla="*/ 87091 h 2068290"/>
              <a:gd name="connsiteX3" fmla="*/ 1347787 w 1347787"/>
              <a:gd name="connsiteY3" fmla="*/ 1592040 h 2068290"/>
              <a:gd name="connsiteX4" fmla="*/ 552450 w 1347787"/>
              <a:gd name="connsiteY4" fmla="*/ 2068290 h 2068290"/>
              <a:gd name="connsiteX5" fmla="*/ 0 w 1347787"/>
              <a:gd name="connsiteY5" fmla="*/ 549053 h 2068290"/>
              <a:gd name="connsiteX0" fmla="*/ 0 w 1345406"/>
              <a:gd name="connsiteY0" fmla="*/ 565722 h 2068290"/>
              <a:gd name="connsiteX1" fmla="*/ 602456 w 1345406"/>
              <a:gd name="connsiteY1" fmla="*/ 220428 h 2068290"/>
              <a:gd name="connsiteX2" fmla="*/ 800100 w 1345406"/>
              <a:gd name="connsiteY2" fmla="*/ 87091 h 2068290"/>
              <a:gd name="connsiteX3" fmla="*/ 1345406 w 1345406"/>
              <a:gd name="connsiteY3" fmla="*/ 1592040 h 2068290"/>
              <a:gd name="connsiteX4" fmla="*/ 550069 w 1345406"/>
              <a:gd name="connsiteY4" fmla="*/ 2068290 h 2068290"/>
              <a:gd name="connsiteX5" fmla="*/ 0 w 1345406"/>
              <a:gd name="connsiteY5" fmla="*/ 565722 h 2068290"/>
              <a:gd name="connsiteX0" fmla="*/ 0 w 1345406"/>
              <a:gd name="connsiteY0" fmla="*/ 565722 h 2068290"/>
              <a:gd name="connsiteX1" fmla="*/ 602456 w 1345406"/>
              <a:gd name="connsiteY1" fmla="*/ 220428 h 2068290"/>
              <a:gd name="connsiteX2" fmla="*/ 800100 w 1345406"/>
              <a:gd name="connsiteY2" fmla="*/ 87091 h 2068290"/>
              <a:gd name="connsiteX3" fmla="*/ 1345406 w 1345406"/>
              <a:gd name="connsiteY3" fmla="*/ 1592040 h 2068290"/>
              <a:gd name="connsiteX4" fmla="*/ 550069 w 1345406"/>
              <a:gd name="connsiteY4" fmla="*/ 2068290 h 2068290"/>
              <a:gd name="connsiteX5" fmla="*/ 0 w 1345406"/>
              <a:gd name="connsiteY5" fmla="*/ 565722 h 2068290"/>
              <a:gd name="connsiteX0" fmla="*/ 0 w 1345406"/>
              <a:gd name="connsiteY0" fmla="*/ 576661 h 2079229"/>
              <a:gd name="connsiteX1" fmla="*/ 631031 w 1345406"/>
              <a:gd name="connsiteY1" fmla="*/ 178980 h 2079229"/>
              <a:gd name="connsiteX2" fmla="*/ 800100 w 1345406"/>
              <a:gd name="connsiteY2" fmla="*/ 98030 h 2079229"/>
              <a:gd name="connsiteX3" fmla="*/ 1345406 w 1345406"/>
              <a:gd name="connsiteY3" fmla="*/ 1602979 h 2079229"/>
              <a:gd name="connsiteX4" fmla="*/ 550069 w 1345406"/>
              <a:gd name="connsiteY4" fmla="*/ 2079229 h 2079229"/>
              <a:gd name="connsiteX5" fmla="*/ 0 w 1345406"/>
              <a:gd name="connsiteY5" fmla="*/ 576661 h 2079229"/>
              <a:gd name="connsiteX0" fmla="*/ 0 w 1345406"/>
              <a:gd name="connsiteY0" fmla="*/ 576661 h 2079229"/>
              <a:gd name="connsiteX1" fmla="*/ 631031 w 1345406"/>
              <a:gd name="connsiteY1" fmla="*/ 178980 h 2079229"/>
              <a:gd name="connsiteX2" fmla="*/ 800100 w 1345406"/>
              <a:gd name="connsiteY2" fmla="*/ 98030 h 2079229"/>
              <a:gd name="connsiteX3" fmla="*/ 1345406 w 1345406"/>
              <a:gd name="connsiteY3" fmla="*/ 1602979 h 2079229"/>
              <a:gd name="connsiteX4" fmla="*/ 550069 w 1345406"/>
              <a:gd name="connsiteY4" fmla="*/ 2079229 h 2079229"/>
              <a:gd name="connsiteX5" fmla="*/ 0 w 1345406"/>
              <a:gd name="connsiteY5" fmla="*/ 576661 h 2079229"/>
              <a:gd name="connsiteX0" fmla="*/ 0 w 1345406"/>
              <a:gd name="connsiteY0" fmla="*/ 562162 h 2064730"/>
              <a:gd name="connsiteX1" fmla="*/ 631031 w 1345406"/>
              <a:gd name="connsiteY1" fmla="*/ 164481 h 2064730"/>
              <a:gd name="connsiteX2" fmla="*/ 800100 w 1345406"/>
              <a:gd name="connsiteY2" fmla="*/ 83531 h 2064730"/>
              <a:gd name="connsiteX3" fmla="*/ 1345406 w 1345406"/>
              <a:gd name="connsiteY3" fmla="*/ 1588480 h 2064730"/>
              <a:gd name="connsiteX4" fmla="*/ 550069 w 1345406"/>
              <a:gd name="connsiteY4" fmla="*/ 2064730 h 2064730"/>
              <a:gd name="connsiteX5" fmla="*/ 0 w 1345406"/>
              <a:gd name="connsiteY5" fmla="*/ 562162 h 2064730"/>
              <a:gd name="connsiteX0" fmla="*/ 0 w 1345406"/>
              <a:gd name="connsiteY0" fmla="*/ 478631 h 1981199"/>
              <a:gd name="connsiteX1" fmla="*/ 631031 w 1345406"/>
              <a:gd name="connsiteY1" fmla="*/ 80950 h 1981199"/>
              <a:gd name="connsiteX2" fmla="*/ 800100 w 1345406"/>
              <a:gd name="connsiteY2" fmla="*/ 0 h 1981199"/>
              <a:gd name="connsiteX3" fmla="*/ 1345406 w 1345406"/>
              <a:gd name="connsiteY3" fmla="*/ 1504949 h 1981199"/>
              <a:gd name="connsiteX4" fmla="*/ 550069 w 1345406"/>
              <a:gd name="connsiteY4" fmla="*/ 1981199 h 1981199"/>
              <a:gd name="connsiteX5" fmla="*/ 0 w 1345406"/>
              <a:gd name="connsiteY5" fmla="*/ 478631 h 1981199"/>
              <a:gd name="connsiteX0" fmla="*/ 0 w 1345406"/>
              <a:gd name="connsiteY0" fmla="*/ 569407 h 2071975"/>
              <a:gd name="connsiteX1" fmla="*/ 631031 w 1345406"/>
              <a:gd name="connsiteY1" fmla="*/ 171726 h 2071975"/>
              <a:gd name="connsiteX2" fmla="*/ 669130 w 1345406"/>
              <a:gd name="connsiteY2" fmla="*/ 169344 h 2071975"/>
              <a:gd name="connsiteX3" fmla="*/ 800100 w 1345406"/>
              <a:gd name="connsiteY3" fmla="*/ 90776 h 2071975"/>
              <a:gd name="connsiteX4" fmla="*/ 1345406 w 1345406"/>
              <a:gd name="connsiteY4" fmla="*/ 1595725 h 2071975"/>
              <a:gd name="connsiteX5" fmla="*/ 550069 w 1345406"/>
              <a:gd name="connsiteY5" fmla="*/ 2071975 h 2071975"/>
              <a:gd name="connsiteX6" fmla="*/ 0 w 1345406"/>
              <a:gd name="connsiteY6" fmla="*/ 569407 h 2071975"/>
              <a:gd name="connsiteX0" fmla="*/ 0 w 1345406"/>
              <a:gd name="connsiteY0" fmla="*/ 569407 h 2071975"/>
              <a:gd name="connsiteX1" fmla="*/ 631031 w 1345406"/>
              <a:gd name="connsiteY1" fmla="*/ 171726 h 2071975"/>
              <a:gd name="connsiteX2" fmla="*/ 711992 w 1345406"/>
              <a:gd name="connsiteY2" fmla="*/ 169344 h 2071975"/>
              <a:gd name="connsiteX3" fmla="*/ 800100 w 1345406"/>
              <a:gd name="connsiteY3" fmla="*/ 90776 h 2071975"/>
              <a:gd name="connsiteX4" fmla="*/ 1345406 w 1345406"/>
              <a:gd name="connsiteY4" fmla="*/ 1595725 h 2071975"/>
              <a:gd name="connsiteX5" fmla="*/ 550069 w 1345406"/>
              <a:gd name="connsiteY5" fmla="*/ 2071975 h 2071975"/>
              <a:gd name="connsiteX6" fmla="*/ 0 w 1345406"/>
              <a:gd name="connsiteY6" fmla="*/ 569407 h 2071975"/>
              <a:gd name="connsiteX0" fmla="*/ 0 w 1345406"/>
              <a:gd name="connsiteY0" fmla="*/ 478631 h 1981199"/>
              <a:gd name="connsiteX1" fmla="*/ 631031 w 1345406"/>
              <a:gd name="connsiteY1" fmla="*/ 80950 h 1981199"/>
              <a:gd name="connsiteX2" fmla="*/ 711992 w 1345406"/>
              <a:gd name="connsiteY2" fmla="*/ 78568 h 1981199"/>
              <a:gd name="connsiteX3" fmla="*/ 800100 w 1345406"/>
              <a:gd name="connsiteY3" fmla="*/ 0 h 1981199"/>
              <a:gd name="connsiteX4" fmla="*/ 1345406 w 1345406"/>
              <a:gd name="connsiteY4" fmla="*/ 1504949 h 1981199"/>
              <a:gd name="connsiteX5" fmla="*/ 550069 w 1345406"/>
              <a:gd name="connsiteY5" fmla="*/ 1981199 h 1981199"/>
              <a:gd name="connsiteX6" fmla="*/ 0 w 1345406"/>
              <a:gd name="connsiteY6" fmla="*/ 478631 h 1981199"/>
              <a:gd name="connsiteX0" fmla="*/ 0 w 1345406"/>
              <a:gd name="connsiteY0" fmla="*/ 478631 h 1981199"/>
              <a:gd name="connsiteX1" fmla="*/ 631031 w 1345406"/>
              <a:gd name="connsiteY1" fmla="*/ 80950 h 1981199"/>
              <a:gd name="connsiteX2" fmla="*/ 711992 w 1345406"/>
              <a:gd name="connsiteY2" fmla="*/ 78568 h 1981199"/>
              <a:gd name="connsiteX3" fmla="*/ 800100 w 1345406"/>
              <a:gd name="connsiteY3" fmla="*/ 0 h 1981199"/>
              <a:gd name="connsiteX4" fmla="*/ 1345406 w 1345406"/>
              <a:gd name="connsiteY4" fmla="*/ 1504949 h 1981199"/>
              <a:gd name="connsiteX5" fmla="*/ 550069 w 1345406"/>
              <a:gd name="connsiteY5" fmla="*/ 1981199 h 1981199"/>
              <a:gd name="connsiteX6" fmla="*/ 0 w 1345406"/>
              <a:gd name="connsiteY6" fmla="*/ 478631 h 1981199"/>
              <a:gd name="connsiteX0" fmla="*/ 0 w 1345406"/>
              <a:gd name="connsiteY0" fmla="*/ 478631 h 2138362"/>
              <a:gd name="connsiteX1" fmla="*/ 631031 w 1345406"/>
              <a:gd name="connsiteY1" fmla="*/ 80950 h 2138362"/>
              <a:gd name="connsiteX2" fmla="*/ 711992 w 1345406"/>
              <a:gd name="connsiteY2" fmla="*/ 78568 h 2138362"/>
              <a:gd name="connsiteX3" fmla="*/ 800100 w 1345406"/>
              <a:gd name="connsiteY3" fmla="*/ 0 h 2138362"/>
              <a:gd name="connsiteX4" fmla="*/ 1345406 w 1345406"/>
              <a:gd name="connsiteY4" fmla="*/ 1504949 h 2138362"/>
              <a:gd name="connsiteX5" fmla="*/ 602457 w 1345406"/>
              <a:gd name="connsiteY5" fmla="*/ 2138362 h 2138362"/>
              <a:gd name="connsiteX6" fmla="*/ 0 w 1345406"/>
              <a:gd name="connsiteY6" fmla="*/ 478631 h 2138362"/>
              <a:gd name="connsiteX0" fmla="*/ 0 w 1490338"/>
              <a:gd name="connsiteY0" fmla="*/ 547577 h 2138362"/>
              <a:gd name="connsiteX1" fmla="*/ 775963 w 1490338"/>
              <a:gd name="connsiteY1" fmla="*/ 80950 h 2138362"/>
              <a:gd name="connsiteX2" fmla="*/ 856924 w 1490338"/>
              <a:gd name="connsiteY2" fmla="*/ 78568 h 2138362"/>
              <a:gd name="connsiteX3" fmla="*/ 945032 w 1490338"/>
              <a:gd name="connsiteY3" fmla="*/ 0 h 2138362"/>
              <a:gd name="connsiteX4" fmla="*/ 1490338 w 1490338"/>
              <a:gd name="connsiteY4" fmla="*/ 1504949 h 2138362"/>
              <a:gd name="connsiteX5" fmla="*/ 747389 w 1490338"/>
              <a:gd name="connsiteY5" fmla="*/ 2138362 h 2138362"/>
              <a:gd name="connsiteX6" fmla="*/ 0 w 1490338"/>
              <a:gd name="connsiteY6" fmla="*/ 547577 h 2138362"/>
              <a:gd name="connsiteX0" fmla="*/ 0 w 1490338"/>
              <a:gd name="connsiteY0" fmla="*/ 547577 h 2310725"/>
              <a:gd name="connsiteX1" fmla="*/ 775963 w 1490338"/>
              <a:gd name="connsiteY1" fmla="*/ 80950 h 2310725"/>
              <a:gd name="connsiteX2" fmla="*/ 856924 w 1490338"/>
              <a:gd name="connsiteY2" fmla="*/ 78568 h 2310725"/>
              <a:gd name="connsiteX3" fmla="*/ 945032 w 1490338"/>
              <a:gd name="connsiteY3" fmla="*/ 0 h 2310725"/>
              <a:gd name="connsiteX4" fmla="*/ 1490338 w 1490338"/>
              <a:gd name="connsiteY4" fmla="*/ 1504949 h 2310725"/>
              <a:gd name="connsiteX5" fmla="*/ 554148 w 1490338"/>
              <a:gd name="connsiteY5" fmla="*/ 2310725 h 2310725"/>
              <a:gd name="connsiteX6" fmla="*/ 0 w 1490338"/>
              <a:gd name="connsiteY6" fmla="*/ 547577 h 2310725"/>
              <a:gd name="connsiteX0" fmla="*/ 0 w 1490338"/>
              <a:gd name="connsiteY0" fmla="*/ 547577 h 2241780"/>
              <a:gd name="connsiteX1" fmla="*/ 775963 w 1490338"/>
              <a:gd name="connsiteY1" fmla="*/ 80950 h 2241780"/>
              <a:gd name="connsiteX2" fmla="*/ 856924 w 1490338"/>
              <a:gd name="connsiteY2" fmla="*/ 78568 h 2241780"/>
              <a:gd name="connsiteX3" fmla="*/ 945032 w 1490338"/>
              <a:gd name="connsiteY3" fmla="*/ 0 h 2241780"/>
              <a:gd name="connsiteX4" fmla="*/ 1490338 w 1490338"/>
              <a:gd name="connsiteY4" fmla="*/ 1504949 h 2241780"/>
              <a:gd name="connsiteX5" fmla="*/ 623162 w 1490338"/>
              <a:gd name="connsiteY5" fmla="*/ 2241780 h 2241780"/>
              <a:gd name="connsiteX6" fmla="*/ 0 w 1490338"/>
              <a:gd name="connsiteY6" fmla="*/ 547577 h 2241780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94905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94905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94905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86488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86488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86488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81973 w 1490338"/>
              <a:gd name="connsiteY5" fmla="*/ 2569705 h 2569705"/>
              <a:gd name="connsiteX6" fmla="*/ 0 w 1490338"/>
              <a:gd name="connsiteY6" fmla="*/ 547577 h 2569705"/>
              <a:gd name="connsiteX0" fmla="*/ 0 w 1490338"/>
              <a:gd name="connsiteY0" fmla="*/ 547577 h 2569705"/>
              <a:gd name="connsiteX1" fmla="*/ 775963 w 1490338"/>
              <a:gd name="connsiteY1" fmla="*/ 80950 h 2569705"/>
              <a:gd name="connsiteX2" fmla="*/ 856924 w 1490338"/>
              <a:gd name="connsiteY2" fmla="*/ 78568 h 2569705"/>
              <a:gd name="connsiteX3" fmla="*/ 945032 w 1490338"/>
              <a:gd name="connsiteY3" fmla="*/ 0 h 2569705"/>
              <a:gd name="connsiteX4" fmla="*/ 1490338 w 1490338"/>
              <a:gd name="connsiteY4" fmla="*/ 1504949 h 2569705"/>
              <a:gd name="connsiteX5" fmla="*/ 281973 w 1490338"/>
              <a:gd name="connsiteY5" fmla="*/ 2569705 h 2569705"/>
              <a:gd name="connsiteX6" fmla="*/ 0 w 1490338"/>
              <a:gd name="connsiteY6" fmla="*/ 547577 h 2569705"/>
              <a:gd name="connsiteX0" fmla="*/ 0 w 1494853"/>
              <a:gd name="connsiteY0" fmla="*/ 547577 h 2569705"/>
              <a:gd name="connsiteX1" fmla="*/ 780478 w 1494853"/>
              <a:gd name="connsiteY1" fmla="*/ 80950 h 2569705"/>
              <a:gd name="connsiteX2" fmla="*/ 861439 w 1494853"/>
              <a:gd name="connsiteY2" fmla="*/ 78568 h 2569705"/>
              <a:gd name="connsiteX3" fmla="*/ 949547 w 1494853"/>
              <a:gd name="connsiteY3" fmla="*/ 0 h 2569705"/>
              <a:gd name="connsiteX4" fmla="*/ 1494853 w 1494853"/>
              <a:gd name="connsiteY4" fmla="*/ 1504949 h 2569705"/>
              <a:gd name="connsiteX5" fmla="*/ 286488 w 1494853"/>
              <a:gd name="connsiteY5" fmla="*/ 2569705 h 2569705"/>
              <a:gd name="connsiteX6" fmla="*/ 0 w 1494853"/>
              <a:gd name="connsiteY6" fmla="*/ 547577 h 2569705"/>
              <a:gd name="connsiteX0" fmla="*/ 0 w 1492596"/>
              <a:gd name="connsiteY0" fmla="*/ 556599 h 2569705"/>
              <a:gd name="connsiteX1" fmla="*/ 778221 w 1492596"/>
              <a:gd name="connsiteY1" fmla="*/ 80950 h 2569705"/>
              <a:gd name="connsiteX2" fmla="*/ 859182 w 1492596"/>
              <a:gd name="connsiteY2" fmla="*/ 78568 h 2569705"/>
              <a:gd name="connsiteX3" fmla="*/ 947290 w 1492596"/>
              <a:gd name="connsiteY3" fmla="*/ 0 h 2569705"/>
              <a:gd name="connsiteX4" fmla="*/ 1492596 w 1492596"/>
              <a:gd name="connsiteY4" fmla="*/ 1504949 h 2569705"/>
              <a:gd name="connsiteX5" fmla="*/ 284231 w 1492596"/>
              <a:gd name="connsiteY5" fmla="*/ 2569705 h 2569705"/>
              <a:gd name="connsiteX6" fmla="*/ 0 w 1492596"/>
              <a:gd name="connsiteY6" fmla="*/ 556599 h 2569705"/>
              <a:gd name="connsiteX0" fmla="*/ 0 w 1492596"/>
              <a:gd name="connsiteY0" fmla="*/ 556599 h 2569705"/>
              <a:gd name="connsiteX1" fmla="*/ 778221 w 1492596"/>
              <a:gd name="connsiteY1" fmla="*/ 80950 h 2569705"/>
              <a:gd name="connsiteX2" fmla="*/ 859182 w 1492596"/>
              <a:gd name="connsiteY2" fmla="*/ 78568 h 2569705"/>
              <a:gd name="connsiteX3" fmla="*/ 947290 w 1492596"/>
              <a:gd name="connsiteY3" fmla="*/ 0 h 2569705"/>
              <a:gd name="connsiteX4" fmla="*/ 1492596 w 1492596"/>
              <a:gd name="connsiteY4" fmla="*/ 1504949 h 2569705"/>
              <a:gd name="connsiteX5" fmla="*/ 284231 w 1492596"/>
              <a:gd name="connsiteY5" fmla="*/ 2569705 h 2569705"/>
              <a:gd name="connsiteX6" fmla="*/ 0 w 1492596"/>
              <a:gd name="connsiteY6" fmla="*/ 556599 h 2569705"/>
              <a:gd name="connsiteX0" fmla="*/ 0 w 1492596"/>
              <a:gd name="connsiteY0" fmla="*/ 556599 h 2569705"/>
              <a:gd name="connsiteX1" fmla="*/ 502789 w 1492596"/>
              <a:gd name="connsiteY1" fmla="*/ 360615 h 2569705"/>
              <a:gd name="connsiteX2" fmla="*/ 859182 w 1492596"/>
              <a:gd name="connsiteY2" fmla="*/ 78568 h 2569705"/>
              <a:gd name="connsiteX3" fmla="*/ 947290 w 1492596"/>
              <a:gd name="connsiteY3" fmla="*/ 0 h 2569705"/>
              <a:gd name="connsiteX4" fmla="*/ 1492596 w 1492596"/>
              <a:gd name="connsiteY4" fmla="*/ 1504949 h 2569705"/>
              <a:gd name="connsiteX5" fmla="*/ 284231 w 1492596"/>
              <a:gd name="connsiteY5" fmla="*/ 2569705 h 2569705"/>
              <a:gd name="connsiteX6" fmla="*/ 0 w 1492596"/>
              <a:gd name="connsiteY6" fmla="*/ 556599 h 2569705"/>
              <a:gd name="connsiteX0" fmla="*/ 0 w 1492596"/>
              <a:gd name="connsiteY0" fmla="*/ 556599 h 2569705"/>
              <a:gd name="connsiteX1" fmla="*/ 502789 w 1492596"/>
              <a:gd name="connsiteY1" fmla="*/ 360615 h 2569705"/>
              <a:gd name="connsiteX2" fmla="*/ 549884 w 1492596"/>
              <a:gd name="connsiteY2" fmla="*/ 358233 h 2569705"/>
              <a:gd name="connsiteX3" fmla="*/ 947290 w 1492596"/>
              <a:gd name="connsiteY3" fmla="*/ 0 h 2569705"/>
              <a:gd name="connsiteX4" fmla="*/ 1492596 w 1492596"/>
              <a:gd name="connsiteY4" fmla="*/ 1504949 h 2569705"/>
              <a:gd name="connsiteX5" fmla="*/ 284231 w 1492596"/>
              <a:gd name="connsiteY5" fmla="*/ 2569705 h 2569705"/>
              <a:gd name="connsiteX6" fmla="*/ 0 w 1492596"/>
              <a:gd name="connsiteY6" fmla="*/ 556599 h 2569705"/>
              <a:gd name="connsiteX0" fmla="*/ 0 w 1492596"/>
              <a:gd name="connsiteY0" fmla="*/ 315275 h 2328381"/>
              <a:gd name="connsiteX1" fmla="*/ 502789 w 1492596"/>
              <a:gd name="connsiteY1" fmla="*/ 119291 h 2328381"/>
              <a:gd name="connsiteX2" fmla="*/ 549884 w 1492596"/>
              <a:gd name="connsiteY2" fmla="*/ 116909 h 2328381"/>
              <a:gd name="connsiteX3" fmla="*/ 843438 w 1492596"/>
              <a:gd name="connsiteY3" fmla="*/ 0 h 2328381"/>
              <a:gd name="connsiteX4" fmla="*/ 1492596 w 1492596"/>
              <a:gd name="connsiteY4" fmla="*/ 1263625 h 2328381"/>
              <a:gd name="connsiteX5" fmla="*/ 284231 w 1492596"/>
              <a:gd name="connsiteY5" fmla="*/ 2328381 h 2328381"/>
              <a:gd name="connsiteX6" fmla="*/ 0 w 1492596"/>
              <a:gd name="connsiteY6" fmla="*/ 315275 h 2328381"/>
              <a:gd name="connsiteX0" fmla="*/ 0 w 867228"/>
              <a:gd name="connsiteY0" fmla="*/ 315275 h 2328381"/>
              <a:gd name="connsiteX1" fmla="*/ 502789 w 867228"/>
              <a:gd name="connsiteY1" fmla="*/ 119291 h 2328381"/>
              <a:gd name="connsiteX2" fmla="*/ 549884 w 867228"/>
              <a:gd name="connsiteY2" fmla="*/ 116909 h 2328381"/>
              <a:gd name="connsiteX3" fmla="*/ 843438 w 867228"/>
              <a:gd name="connsiteY3" fmla="*/ 0 h 2328381"/>
              <a:gd name="connsiteX4" fmla="*/ 867228 w 867228"/>
              <a:gd name="connsiteY4" fmla="*/ 1455331 h 2328381"/>
              <a:gd name="connsiteX5" fmla="*/ 284231 w 867228"/>
              <a:gd name="connsiteY5" fmla="*/ 2328381 h 2328381"/>
              <a:gd name="connsiteX6" fmla="*/ 0 w 867228"/>
              <a:gd name="connsiteY6" fmla="*/ 315275 h 232838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867228"/>
              <a:gd name="connsiteY0" fmla="*/ 315275 h 1559301"/>
              <a:gd name="connsiteX1" fmla="*/ 502789 w 867228"/>
              <a:gd name="connsiteY1" fmla="*/ 119291 h 1559301"/>
              <a:gd name="connsiteX2" fmla="*/ 549884 w 867228"/>
              <a:gd name="connsiteY2" fmla="*/ 116909 h 1559301"/>
              <a:gd name="connsiteX3" fmla="*/ 843438 w 867228"/>
              <a:gd name="connsiteY3" fmla="*/ 0 h 1559301"/>
              <a:gd name="connsiteX4" fmla="*/ 867228 w 867228"/>
              <a:gd name="connsiteY4" fmla="*/ 1455331 h 1559301"/>
              <a:gd name="connsiteX5" fmla="*/ 401628 w 867228"/>
              <a:gd name="connsiteY5" fmla="*/ 1559301 h 1559301"/>
              <a:gd name="connsiteX6" fmla="*/ 0 w 867228"/>
              <a:gd name="connsiteY6" fmla="*/ 315275 h 1559301"/>
              <a:gd name="connsiteX0" fmla="*/ 0 w 679844"/>
              <a:gd name="connsiteY0" fmla="*/ 256635 h 1559301"/>
              <a:gd name="connsiteX1" fmla="*/ 315405 w 679844"/>
              <a:gd name="connsiteY1" fmla="*/ 119291 h 1559301"/>
              <a:gd name="connsiteX2" fmla="*/ 362500 w 679844"/>
              <a:gd name="connsiteY2" fmla="*/ 116909 h 1559301"/>
              <a:gd name="connsiteX3" fmla="*/ 656054 w 679844"/>
              <a:gd name="connsiteY3" fmla="*/ 0 h 1559301"/>
              <a:gd name="connsiteX4" fmla="*/ 679844 w 679844"/>
              <a:gd name="connsiteY4" fmla="*/ 1455331 h 1559301"/>
              <a:gd name="connsiteX5" fmla="*/ 214244 w 679844"/>
              <a:gd name="connsiteY5" fmla="*/ 1559301 h 1559301"/>
              <a:gd name="connsiteX6" fmla="*/ 0 w 679844"/>
              <a:gd name="connsiteY6" fmla="*/ 256635 h 1559301"/>
              <a:gd name="connsiteX0" fmla="*/ 0 w 679844"/>
              <a:gd name="connsiteY0" fmla="*/ 256635 h 1529982"/>
              <a:gd name="connsiteX1" fmla="*/ 315405 w 679844"/>
              <a:gd name="connsiteY1" fmla="*/ 119291 h 1529982"/>
              <a:gd name="connsiteX2" fmla="*/ 362500 w 679844"/>
              <a:gd name="connsiteY2" fmla="*/ 116909 h 1529982"/>
              <a:gd name="connsiteX3" fmla="*/ 656054 w 679844"/>
              <a:gd name="connsiteY3" fmla="*/ 0 h 1529982"/>
              <a:gd name="connsiteX4" fmla="*/ 679844 w 679844"/>
              <a:gd name="connsiteY4" fmla="*/ 1455331 h 1529982"/>
              <a:gd name="connsiteX5" fmla="*/ 245852 w 679844"/>
              <a:gd name="connsiteY5" fmla="*/ 1529982 h 1529982"/>
              <a:gd name="connsiteX6" fmla="*/ 0 w 679844"/>
              <a:gd name="connsiteY6" fmla="*/ 256635 h 1529982"/>
              <a:gd name="connsiteX0" fmla="*/ 0 w 679844"/>
              <a:gd name="connsiteY0" fmla="*/ 256635 h 1529982"/>
              <a:gd name="connsiteX1" fmla="*/ 315405 w 679844"/>
              <a:gd name="connsiteY1" fmla="*/ 119291 h 1529982"/>
              <a:gd name="connsiteX2" fmla="*/ 362500 w 679844"/>
              <a:gd name="connsiteY2" fmla="*/ 116909 h 1529982"/>
              <a:gd name="connsiteX3" fmla="*/ 656054 w 679844"/>
              <a:gd name="connsiteY3" fmla="*/ 0 h 1529982"/>
              <a:gd name="connsiteX4" fmla="*/ 679844 w 679844"/>
              <a:gd name="connsiteY4" fmla="*/ 1455331 h 1529982"/>
              <a:gd name="connsiteX5" fmla="*/ 245852 w 679844"/>
              <a:gd name="connsiteY5" fmla="*/ 1529982 h 1529982"/>
              <a:gd name="connsiteX6" fmla="*/ 0 w 679844"/>
              <a:gd name="connsiteY6" fmla="*/ 256635 h 1529982"/>
              <a:gd name="connsiteX0" fmla="*/ 0 w 679844"/>
              <a:gd name="connsiteY0" fmla="*/ 256635 h 1529982"/>
              <a:gd name="connsiteX1" fmla="*/ 315405 w 679844"/>
              <a:gd name="connsiteY1" fmla="*/ 119291 h 1529982"/>
              <a:gd name="connsiteX2" fmla="*/ 362500 w 679844"/>
              <a:gd name="connsiteY2" fmla="*/ 116909 h 1529982"/>
              <a:gd name="connsiteX3" fmla="*/ 656054 w 679844"/>
              <a:gd name="connsiteY3" fmla="*/ 0 h 1529982"/>
              <a:gd name="connsiteX4" fmla="*/ 679844 w 679844"/>
              <a:gd name="connsiteY4" fmla="*/ 1455331 h 1529982"/>
              <a:gd name="connsiteX5" fmla="*/ 245852 w 679844"/>
              <a:gd name="connsiteY5" fmla="*/ 1529982 h 1529982"/>
              <a:gd name="connsiteX6" fmla="*/ 0 w 679844"/>
              <a:gd name="connsiteY6" fmla="*/ 256635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0 w 673071"/>
              <a:gd name="connsiteY6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0 w 673071"/>
              <a:gd name="connsiteY6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0 w 673071"/>
              <a:gd name="connsiteY6" fmla="*/ 258891 h 1529982"/>
              <a:gd name="connsiteX0" fmla="*/ 11303 w 684374"/>
              <a:gd name="connsiteY0" fmla="*/ 258891 h 1529982"/>
              <a:gd name="connsiteX1" fmla="*/ 319935 w 684374"/>
              <a:gd name="connsiteY1" fmla="*/ 119291 h 1529982"/>
              <a:gd name="connsiteX2" fmla="*/ 367030 w 684374"/>
              <a:gd name="connsiteY2" fmla="*/ 116909 h 1529982"/>
              <a:gd name="connsiteX3" fmla="*/ 660584 w 684374"/>
              <a:gd name="connsiteY3" fmla="*/ 0 h 1529982"/>
              <a:gd name="connsiteX4" fmla="*/ 684374 w 684374"/>
              <a:gd name="connsiteY4" fmla="*/ 1455331 h 1529982"/>
              <a:gd name="connsiteX5" fmla="*/ 250382 w 684374"/>
              <a:gd name="connsiteY5" fmla="*/ 1529982 h 1529982"/>
              <a:gd name="connsiteX6" fmla="*/ 84371 w 684374"/>
              <a:gd name="connsiteY6" fmla="*/ 633208 h 1529982"/>
              <a:gd name="connsiteX7" fmla="*/ 11303 w 684374"/>
              <a:gd name="connsiteY7" fmla="*/ 258891 h 1529982"/>
              <a:gd name="connsiteX0" fmla="*/ 12343 w 685414"/>
              <a:gd name="connsiteY0" fmla="*/ 258891 h 1529982"/>
              <a:gd name="connsiteX1" fmla="*/ 320975 w 685414"/>
              <a:gd name="connsiteY1" fmla="*/ 119291 h 1529982"/>
              <a:gd name="connsiteX2" fmla="*/ 368070 w 685414"/>
              <a:gd name="connsiteY2" fmla="*/ 116909 h 1529982"/>
              <a:gd name="connsiteX3" fmla="*/ 661624 w 685414"/>
              <a:gd name="connsiteY3" fmla="*/ 0 h 1529982"/>
              <a:gd name="connsiteX4" fmla="*/ 685414 w 685414"/>
              <a:gd name="connsiteY4" fmla="*/ 1455331 h 1529982"/>
              <a:gd name="connsiteX5" fmla="*/ 251422 w 685414"/>
              <a:gd name="connsiteY5" fmla="*/ 1529982 h 1529982"/>
              <a:gd name="connsiteX6" fmla="*/ 76380 w 685414"/>
              <a:gd name="connsiteY6" fmla="*/ 642230 h 1529982"/>
              <a:gd name="connsiteX7" fmla="*/ 12343 w 685414"/>
              <a:gd name="connsiteY7" fmla="*/ 258891 h 1529982"/>
              <a:gd name="connsiteX0" fmla="*/ 12343 w 685414"/>
              <a:gd name="connsiteY0" fmla="*/ 258891 h 1529982"/>
              <a:gd name="connsiteX1" fmla="*/ 320975 w 685414"/>
              <a:gd name="connsiteY1" fmla="*/ 119291 h 1529982"/>
              <a:gd name="connsiteX2" fmla="*/ 368070 w 685414"/>
              <a:gd name="connsiteY2" fmla="*/ 116909 h 1529982"/>
              <a:gd name="connsiteX3" fmla="*/ 661624 w 685414"/>
              <a:gd name="connsiteY3" fmla="*/ 0 h 1529982"/>
              <a:gd name="connsiteX4" fmla="*/ 685414 w 685414"/>
              <a:gd name="connsiteY4" fmla="*/ 1455331 h 1529982"/>
              <a:gd name="connsiteX5" fmla="*/ 251422 w 685414"/>
              <a:gd name="connsiteY5" fmla="*/ 1529982 h 1529982"/>
              <a:gd name="connsiteX6" fmla="*/ 76380 w 685414"/>
              <a:gd name="connsiteY6" fmla="*/ 642230 h 1529982"/>
              <a:gd name="connsiteX7" fmla="*/ 12343 w 685414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4037 w 673071"/>
              <a:gd name="connsiteY6" fmla="*/ 642230 h 1529982"/>
              <a:gd name="connsiteX7" fmla="*/ 0 w 673071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4037 w 673071"/>
              <a:gd name="connsiteY6" fmla="*/ 642230 h 1529982"/>
              <a:gd name="connsiteX7" fmla="*/ 0 w 673071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4037 w 673071"/>
              <a:gd name="connsiteY6" fmla="*/ 642230 h 1529982"/>
              <a:gd name="connsiteX7" fmla="*/ 0 w 673071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4037 w 673071"/>
              <a:gd name="connsiteY6" fmla="*/ 642230 h 1529982"/>
              <a:gd name="connsiteX7" fmla="*/ 0 w 673071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1780 w 673071"/>
              <a:gd name="connsiteY6" fmla="*/ 628698 h 1529982"/>
              <a:gd name="connsiteX7" fmla="*/ 0 w 673071"/>
              <a:gd name="connsiteY7" fmla="*/ 258891 h 1529982"/>
              <a:gd name="connsiteX0" fmla="*/ 0 w 673071"/>
              <a:gd name="connsiteY0" fmla="*/ 258891 h 1529982"/>
              <a:gd name="connsiteX1" fmla="*/ 308632 w 673071"/>
              <a:gd name="connsiteY1" fmla="*/ 119291 h 1529982"/>
              <a:gd name="connsiteX2" fmla="*/ 355727 w 673071"/>
              <a:gd name="connsiteY2" fmla="*/ 116909 h 1529982"/>
              <a:gd name="connsiteX3" fmla="*/ 649281 w 673071"/>
              <a:gd name="connsiteY3" fmla="*/ 0 h 1529982"/>
              <a:gd name="connsiteX4" fmla="*/ 673071 w 673071"/>
              <a:gd name="connsiteY4" fmla="*/ 1455331 h 1529982"/>
              <a:gd name="connsiteX5" fmla="*/ 239079 w 673071"/>
              <a:gd name="connsiteY5" fmla="*/ 1529982 h 1529982"/>
              <a:gd name="connsiteX6" fmla="*/ 61780 w 673071"/>
              <a:gd name="connsiteY6" fmla="*/ 628698 h 1529982"/>
              <a:gd name="connsiteX7" fmla="*/ 0 w 673071"/>
              <a:gd name="connsiteY7" fmla="*/ 258891 h 15299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73071" h="1529982">
                <a:moveTo>
                  <a:pt x="0" y="258891"/>
                </a:moveTo>
                <a:cubicBezTo>
                  <a:pt x="187416" y="185651"/>
                  <a:pt x="196934" y="188396"/>
                  <a:pt x="308632" y="119291"/>
                </a:cubicBezTo>
                <a:lnTo>
                  <a:pt x="355727" y="116909"/>
                </a:lnTo>
                <a:cubicBezTo>
                  <a:pt x="389689" y="91133"/>
                  <a:pt x="584193" y="36113"/>
                  <a:pt x="649281" y="0"/>
                </a:cubicBezTo>
                <a:lnTo>
                  <a:pt x="673071" y="1455331"/>
                </a:lnTo>
                <a:lnTo>
                  <a:pt x="239079" y="1529982"/>
                </a:lnTo>
                <a:cubicBezTo>
                  <a:pt x="211323" y="1219298"/>
                  <a:pt x="124202" y="840546"/>
                  <a:pt x="61780" y="628698"/>
                </a:cubicBezTo>
                <a:cubicBezTo>
                  <a:pt x="17418" y="419105"/>
                  <a:pt x="17180" y="351310"/>
                  <a:pt x="0" y="258891"/>
                </a:cubicBezTo>
                <a:close/>
              </a:path>
            </a:pathLst>
          </a:custGeom>
          <a:solidFill>
            <a:schemeClr val="accent6">
              <a:lumMod val="50000"/>
              <a:alpha val="69000"/>
            </a:schemeClr>
          </a:soli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223" name="Freihandform: Form 222">
            <a:extLst>
              <a:ext uri="{FF2B5EF4-FFF2-40B4-BE49-F238E27FC236}">
                <a16:creationId xmlns:a16="http://schemas.microsoft.com/office/drawing/2014/main" id="{901C53C3-F58E-1915-0BF5-57AD6218FA7C}"/>
              </a:ext>
            </a:extLst>
          </p:cNvPr>
          <p:cNvSpPr/>
          <p:nvPr/>
        </p:nvSpPr>
        <p:spPr>
          <a:xfrm>
            <a:off x="6488964" y="2110383"/>
            <a:ext cx="583844" cy="1911349"/>
          </a:xfrm>
          <a:custGeom>
            <a:avLst/>
            <a:gdLst>
              <a:gd name="connsiteX0" fmla="*/ 0 w 474090"/>
              <a:gd name="connsiteY0" fmla="*/ 66931 h 2278904"/>
              <a:gd name="connsiteX1" fmla="*/ 180975 w 474090"/>
              <a:gd name="connsiteY1" fmla="*/ 19306 h 2278904"/>
              <a:gd name="connsiteX2" fmla="*/ 228600 w 474090"/>
              <a:gd name="connsiteY2" fmla="*/ 347918 h 2278904"/>
              <a:gd name="connsiteX3" fmla="*/ 366712 w 474090"/>
              <a:gd name="connsiteY3" fmla="*/ 890843 h 2278904"/>
              <a:gd name="connsiteX4" fmla="*/ 438150 w 474090"/>
              <a:gd name="connsiteY4" fmla="*/ 1486156 h 2278904"/>
              <a:gd name="connsiteX5" fmla="*/ 471487 w 474090"/>
              <a:gd name="connsiteY5" fmla="*/ 2157668 h 2278904"/>
              <a:gd name="connsiteX6" fmla="*/ 371475 w 474090"/>
              <a:gd name="connsiteY6" fmla="*/ 2233868 h 2278904"/>
              <a:gd name="connsiteX7" fmla="*/ 361950 w 474090"/>
              <a:gd name="connsiteY7" fmla="*/ 1662368 h 2278904"/>
              <a:gd name="connsiteX8" fmla="*/ 261937 w 474090"/>
              <a:gd name="connsiteY8" fmla="*/ 1100393 h 2278904"/>
              <a:gd name="connsiteX9" fmla="*/ 204787 w 474090"/>
              <a:gd name="connsiteY9" fmla="*/ 524131 h 2278904"/>
              <a:gd name="connsiteX10" fmla="*/ 66675 w 474090"/>
              <a:gd name="connsiteY10" fmla="*/ 214568 h 2278904"/>
              <a:gd name="connsiteX11" fmla="*/ 0 w 474090"/>
              <a:gd name="connsiteY11" fmla="*/ 66931 h 2278904"/>
              <a:gd name="connsiteX0" fmla="*/ 0 w 474090"/>
              <a:gd name="connsiteY0" fmla="*/ 47625 h 2259598"/>
              <a:gd name="connsiteX1" fmla="*/ 180975 w 474090"/>
              <a:gd name="connsiteY1" fmla="*/ 0 h 2259598"/>
              <a:gd name="connsiteX2" fmla="*/ 228600 w 474090"/>
              <a:gd name="connsiteY2" fmla="*/ 328612 h 2259598"/>
              <a:gd name="connsiteX3" fmla="*/ 366712 w 474090"/>
              <a:gd name="connsiteY3" fmla="*/ 871537 h 2259598"/>
              <a:gd name="connsiteX4" fmla="*/ 438150 w 474090"/>
              <a:gd name="connsiteY4" fmla="*/ 1466850 h 2259598"/>
              <a:gd name="connsiteX5" fmla="*/ 471487 w 474090"/>
              <a:gd name="connsiteY5" fmla="*/ 2138362 h 2259598"/>
              <a:gd name="connsiteX6" fmla="*/ 371475 w 474090"/>
              <a:gd name="connsiteY6" fmla="*/ 2214562 h 2259598"/>
              <a:gd name="connsiteX7" fmla="*/ 361950 w 474090"/>
              <a:gd name="connsiteY7" fmla="*/ 1643062 h 2259598"/>
              <a:gd name="connsiteX8" fmla="*/ 261937 w 474090"/>
              <a:gd name="connsiteY8" fmla="*/ 1081087 h 2259598"/>
              <a:gd name="connsiteX9" fmla="*/ 204787 w 474090"/>
              <a:gd name="connsiteY9" fmla="*/ 504825 h 2259598"/>
              <a:gd name="connsiteX10" fmla="*/ 66675 w 474090"/>
              <a:gd name="connsiteY10" fmla="*/ 195262 h 2259598"/>
              <a:gd name="connsiteX11" fmla="*/ 0 w 474090"/>
              <a:gd name="connsiteY11" fmla="*/ 47625 h 2259598"/>
              <a:gd name="connsiteX0" fmla="*/ 0 w 474090"/>
              <a:gd name="connsiteY0" fmla="*/ 47625 h 2214562"/>
              <a:gd name="connsiteX1" fmla="*/ 180975 w 474090"/>
              <a:gd name="connsiteY1" fmla="*/ 0 h 2214562"/>
              <a:gd name="connsiteX2" fmla="*/ 228600 w 474090"/>
              <a:gd name="connsiteY2" fmla="*/ 328612 h 2214562"/>
              <a:gd name="connsiteX3" fmla="*/ 366712 w 474090"/>
              <a:gd name="connsiteY3" fmla="*/ 871537 h 2214562"/>
              <a:gd name="connsiteX4" fmla="*/ 438150 w 474090"/>
              <a:gd name="connsiteY4" fmla="*/ 1466850 h 2214562"/>
              <a:gd name="connsiteX5" fmla="*/ 471487 w 474090"/>
              <a:gd name="connsiteY5" fmla="*/ 2138362 h 2214562"/>
              <a:gd name="connsiteX6" fmla="*/ 371475 w 474090"/>
              <a:gd name="connsiteY6" fmla="*/ 2214562 h 2214562"/>
              <a:gd name="connsiteX7" fmla="*/ 361950 w 474090"/>
              <a:gd name="connsiteY7" fmla="*/ 1643062 h 2214562"/>
              <a:gd name="connsiteX8" fmla="*/ 261937 w 474090"/>
              <a:gd name="connsiteY8" fmla="*/ 1081087 h 2214562"/>
              <a:gd name="connsiteX9" fmla="*/ 204787 w 474090"/>
              <a:gd name="connsiteY9" fmla="*/ 504825 h 2214562"/>
              <a:gd name="connsiteX10" fmla="*/ 66675 w 474090"/>
              <a:gd name="connsiteY10" fmla="*/ 195262 h 2214562"/>
              <a:gd name="connsiteX11" fmla="*/ 0 w 474090"/>
              <a:gd name="connsiteY11" fmla="*/ 47625 h 2214562"/>
              <a:gd name="connsiteX0" fmla="*/ 0 w 474090"/>
              <a:gd name="connsiteY0" fmla="*/ 47625 h 2214562"/>
              <a:gd name="connsiteX1" fmla="*/ 180975 w 474090"/>
              <a:gd name="connsiteY1" fmla="*/ 0 h 2214562"/>
              <a:gd name="connsiteX2" fmla="*/ 228600 w 474090"/>
              <a:gd name="connsiteY2" fmla="*/ 328612 h 2214562"/>
              <a:gd name="connsiteX3" fmla="*/ 366712 w 474090"/>
              <a:gd name="connsiteY3" fmla="*/ 871537 h 2214562"/>
              <a:gd name="connsiteX4" fmla="*/ 438150 w 474090"/>
              <a:gd name="connsiteY4" fmla="*/ 1466850 h 2214562"/>
              <a:gd name="connsiteX5" fmla="*/ 471487 w 474090"/>
              <a:gd name="connsiteY5" fmla="*/ 2138362 h 2214562"/>
              <a:gd name="connsiteX6" fmla="*/ 371475 w 474090"/>
              <a:gd name="connsiteY6" fmla="*/ 2214562 h 2214562"/>
              <a:gd name="connsiteX7" fmla="*/ 361950 w 474090"/>
              <a:gd name="connsiteY7" fmla="*/ 1643062 h 2214562"/>
              <a:gd name="connsiteX8" fmla="*/ 261937 w 474090"/>
              <a:gd name="connsiteY8" fmla="*/ 1081087 h 2214562"/>
              <a:gd name="connsiteX9" fmla="*/ 204787 w 474090"/>
              <a:gd name="connsiteY9" fmla="*/ 504825 h 2214562"/>
              <a:gd name="connsiteX10" fmla="*/ 66675 w 474090"/>
              <a:gd name="connsiteY10" fmla="*/ 195262 h 2214562"/>
              <a:gd name="connsiteX11" fmla="*/ 0 w 474090"/>
              <a:gd name="connsiteY11" fmla="*/ 47625 h 2214562"/>
              <a:gd name="connsiteX0" fmla="*/ 0 w 474090"/>
              <a:gd name="connsiteY0" fmla="*/ 47625 h 2138362"/>
              <a:gd name="connsiteX1" fmla="*/ 180975 w 474090"/>
              <a:gd name="connsiteY1" fmla="*/ 0 h 2138362"/>
              <a:gd name="connsiteX2" fmla="*/ 228600 w 474090"/>
              <a:gd name="connsiteY2" fmla="*/ 328612 h 2138362"/>
              <a:gd name="connsiteX3" fmla="*/ 366712 w 474090"/>
              <a:gd name="connsiteY3" fmla="*/ 871537 h 2138362"/>
              <a:gd name="connsiteX4" fmla="*/ 438150 w 474090"/>
              <a:gd name="connsiteY4" fmla="*/ 1466850 h 2138362"/>
              <a:gd name="connsiteX5" fmla="*/ 471487 w 474090"/>
              <a:gd name="connsiteY5" fmla="*/ 2138362 h 2138362"/>
              <a:gd name="connsiteX6" fmla="*/ 361950 w 474090"/>
              <a:gd name="connsiteY6" fmla="*/ 1643062 h 2138362"/>
              <a:gd name="connsiteX7" fmla="*/ 261937 w 474090"/>
              <a:gd name="connsiteY7" fmla="*/ 1081087 h 2138362"/>
              <a:gd name="connsiteX8" fmla="*/ 204787 w 474090"/>
              <a:gd name="connsiteY8" fmla="*/ 504825 h 2138362"/>
              <a:gd name="connsiteX9" fmla="*/ 66675 w 474090"/>
              <a:gd name="connsiteY9" fmla="*/ 195262 h 2138362"/>
              <a:gd name="connsiteX10" fmla="*/ 0 w 474090"/>
              <a:gd name="connsiteY10" fmla="*/ 47625 h 2138362"/>
              <a:gd name="connsiteX0" fmla="*/ 0 w 438162"/>
              <a:gd name="connsiteY0" fmla="*/ 47625 h 1661769"/>
              <a:gd name="connsiteX1" fmla="*/ 180975 w 438162"/>
              <a:gd name="connsiteY1" fmla="*/ 0 h 1661769"/>
              <a:gd name="connsiteX2" fmla="*/ 228600 w 438162"/>
              <a:gd name="connsiteY2" fmla="*/ 328612 h 1661769"/>
              <a:gd name="connsiteX3" fmla="*/ 366712 w 438162"/>
              <a:gd name="connsiteY3" fmla="*/ 871537 h 1661769"/>
              <a:gd name="connsiteX4" fmla="*/ 438150 w 438162"/>
              <a:gd name="connsiteY4" fmla="*/ 1466850 h 1661769"/>
              <a:gd name="connsiteX5" fmla="*/ 361950 w 438162"/>
              <a:gd name="connsiteY5" fmla="*/ 1643062 h 1661769"/>
              <a:gd name="connsiteX6" fmla="*/ 261937 w 438162"/>
              <a:gd name="connsiteY6" fmla="*/ 1081087 h 1661769"/>
              <a:gd name="connsiteX7" fmla="*/ 204787 w 438162"/>
              <a:gd name="connsiteY7" fmla="*/ 504825 h 1661769"/>
              <a:gd name="connsiteX8" fmla="*/ 66675 w 438162"/>
              <a:gd name="connsiteY8" fmla="*/ 195262 h 1661769"/>
              <a:gd name="connsiteX9" fmla="*/ 0 w 438162"/>
              <a:gd name="connsiteY9" fmla="*/ 47625 h 1661769"/>
              <a:gd name="connsiteX0" fmla="*/ 0 w 441539"/>
              <a:gd name="connsiteY0" fmla="*/ 47625 h 1470035"/>
              <a:gd name="connsiteX1" fmla="*/ 180975 w 441539"/>
              <a:gd name="connsiteY1" fmla="*/ 0 h 1470035"/>
              <a:gd name="connsiteX2" fmla="*/ 228600 w 441539"/>
              <a:gd name="connsiteY2" fmla="*/ 328612 h 1470035"/>
              <a:gd name="connsiteX3" fmla="*/ 366712 w 441539"/>
              <a:gd name="connsiteY3" fmla="*/ 871537 h 1470035"/>
              <a:gd name="connsiteX4" fmla="*/ 438150 w 441539"/>
              <a:gd name="connsiteY4" fmla="*/ 1466850 h 1470035"/>
              <a:gd name="connsiteX5" fmla="*/ 261937 w 441539"/>
              <a:gd name="connsiteY5" fmla="*/ 1081087 h 1470035"/>
              <a:gd name="connsiteX6" fmla="*/ 204787 w 441539"/>
              <a:gd name="connsiteY6" fmla="*/ 504825 h 1470035"/>
              <a:gd name="connsiteX7" fmla="*/ 66675 w 441539"/>
              <a:gd name="connsiteY7" fmla="*/ 195262 h 1470035"/>
              <a:gd name="connsiteX8" fmla="*/ 0 w 441539"/>
              <a:gd name="connsiteY8" fmla="*/ 47625 h 1470035"/>
              <a:gd name="connsiteX0" fmla="*/ 0 w 418249"/>
              <a:gd name="connsiteY0" fmla="*/ 47625 h 1348209"/>
              <a:gd name="connsiteX1" fmla="*/ 180975 w 418249"/>
              <a:gd name="connsiteY1" fmla="*/ 0 h 1348209"/>
              <a:gd name="connsiteX2" fmla="*/ 228600 w 418249"/>
              <a:gd name="connsiteY2" fmla="*/ 328612 h 1348209"/>
              <a:gd name="connsiteX3" fmla="*/ 366712 w 418249"/>
              <a:gd name="connsiteY3" fmla="*/ 871537 h 1348209"/>
              <a:gd name="connsiteX4" fmla="*/ 413436 w 418249"/>
              <a:gd name="connsiteY4" fmla="*/ 1343282 h 1348209"/>
              <a:gd name="connsiteX5" fmla="*/ 261937 w 418249"/>
              <a:gd name="connsiteY5" fmla="*/ 1081087 h 1348209"/>
              <a:gd name="connsiteX6" fmla="*/ 204787 w 418249"/>
              <a:gd name="connsiteY6" fmla="*/ 504825 h 1348209"/>
              <a:gd name="connsiteX7" fmla="*/ 66675 w 418249"/>
              <a:gd name="connsiteY7" fmla="*/ 195262 h 1348209"/>
              <a:gd name="connsiteX8" fmla="*/ 0 w 418249"/>
              <a:gd name="connsiteY8" fmla="*/ 47625 h 1348209"/>
              <a:gd name="connsiteX0" fmla="*/ 0 w 440675"/>
              <a:gd name="connsiteY0" fmla="*/ 47625 h 1341225"/>
              <a:gd name="connsiteX1" fmla="*/ 180975 w 440675"/>
              <a:gd name="connsiteY1" fmla="*/ 0 h 1341225"/>
              <a:gd name="connsiteX2" fmla="*/ 228600 w 440675"/>
              <a:gd name="connsiteY2" fmla="*/ 328612 h 1341225"/>
              <a:gd name="connsiteX3" fmla="*/ 366712 w 440675"/>
              <a:gd name="connsiteY3" fmla="*/ 871537 h 1341225"/>
              <a:gd name="connsiteX4" fmla="*/ 437248 w 440675"/>
              <a:gd name="connsiteY4" fmla="*/ 1336139 h 1341225"/>
              <a:gd name="connsiteX5" fmla="*/ 261937 w 440675"/>
              <a:gd name="connsiteY5" fmla="*/ 1081087 h 1341225"/>
              <a:gd name="connsiteX6" fmla="*/ 204787 w 440675"/>
              <a:gd name="connsiteY6" fmla="*/ 504825 h 1341225"/>
              <a:gd name="connsiteX7" fmla="*/ 66675 w 440675"/>
              <a:gd name="connsiteY7" fmla="*/ 195262 h 1341225"/>
              <a:gd name="connsiteX8" fmla="*/ 0 w 440675"/>
              <a:gd name="connsiteY8" fmla="*/ 47625 h 1341225"/>
              <a:gd name="connsiteX0" fmla="*/ 0 w 437888"/>
              <a:gd name="connsiteY0" fmla="*/ 47625 h 1487408"/>
              <a:gd name="connsiteX1" fmla="*/ 180975 w 437888"/>
              <a:gd name="connsiteY1" fmla="*/ 0 h 1487408"/>
              <a:gd name="connsiteX2" fmla="*/ 228600 w 437888"/>
              <a:gd name="connsiteY2" fmla="*/ 328612 h 1487408"/>
              <a:gd name="connsiteX3" fmla="*/ 366712 w 437888"/>
              <a:gd name="connsiteY3" fmla="*/ 871537 h 1487408"/>
              <a:gd name="connsiteX4" fmla="*/ 437248 w 437888"/>
              <a:gd name="connsiteY4" fmla="*/ 1336139 h 1487408"/>
              <a:gd name="connsiteX5" fmla="*/ 328612 w 437888"/>
              <a:gd name="connsiteY5" fmla="*/ 1428750 h 1487408"/>
              <a:gd name="connsiteX6" fmla="*/ 204787 w 437888"/>
              <a:gd name="connsiteY6" fmla="*/ 504825 h 1487408"/>
              <a:gd name="connsiteX7" fmla="*/ 66675 w 437888"/>
              <a:gd name="connsiteY7" fmla="*/ 195262 h 1487408"/>
              <a:gd name="connsiteX8" fmla="*/ 0 w 437888"/>
              <a:gd name="connsiteY8" fmla="*/ 47625 h 1487408"/>
              <a:gd name="connsiteX0" fmla="*/ 0 w 437888"/>
              <a:gd name="connsiteY0" fmla="*/ 47625 h 1428750"/>
              <a:gd name="connsiteX1" fmla="*/ 180975 w 437888"/>
              <a:gd name="connsiteY1" fmla="*/ 0 h 1428750"/>
              <a:gd name="connsiteX2" fmla="*/ 228600 w 437888"/>
              <a:gd name="connsiteY2" fmla="*/ 328612 h 1428750"/>
              <a:gd name="connsiteX3" fmla="*/ 366712 w 437888"/>
              <a:gd name="connsiteY3" fmla="*/ 871537 h 1428750"/>
              <a:gd name="connsiteX4" fmla="*/ 437248 w 437888"/>
              <a:gd name="connsiteY4" fmla="*/ 1336139 h 1428750"/>
              <a:gd name="connsiteX5" fmla="*/ 328612 w 437888"/>
              <a:gd name="connsiteY5" fmla="*/ 1428750 h 1428750"/>
              <a:gd name="connsiteX6" fmla="*/ 204787 w 437888"/>
              <a:gd name="connsiteY6" fmla="*/ 504825 h 1428750"/>
              <a:gd name="connsiteX7" fmla="*/ 66675 w 437888"/>
              <a:gd name="connsiteY7" fmla="*/ 195262 h 1428750"/>
              <a:gd name="connsiteX8" fmla="*/ 0 w 437888"/>
              <a:gd name="connsiteY8" fmla="*/ 47625 h 1428750"/>
              <a:gd name="connsiteX0" fmla="*/ 0 w 437888"/>
              <a:gd name="connsiteY0" fmla="*/ 47625 h 1510827"/>
              <a:gd name="connsiteX1" fmla="*/ 180975 w 437888"/>
              <a:gd name="connsiteY1" fmla="*/ 0 h 1510827"/>
              <a:gd name="connsiteX2" fmla="*/ 228600 w 437888"/>
              <a:gd name="connsiteY2" fmla="*/ 328612 h 1510827"/>
              <a:gd name="connsiteX3" fmla="*/ 366712 w 437888"/>
              <a:gd name="connsiteY3" fmla="*/ 871537 h 1510827"/>
              <a:gd name="connsiteX4" fmla="*/ 437248 w 437888"/>
              <a:gd name="connsiteY4" fmla="*/ 1336139 h 1510827"/>
              <a:gd name="connsiteX5" fmla="*/ 328612 w 437888"/>
              <a:gd name="connsiteY5" fmla="*/ 1428750 h 1510827"/>
              <a:gd name="connsiteX6" fmla="*/ 204787 w 437888"/>
              <a:gd name="connsiteY6" fmla="*/ 504825 h 1510827"/>
              <a:gd name="connsiteX7" fmla="*/ 66675 w 437888"/>
              <a:gd name="connsiteY7" fmla="*/ 195262 h 1510827"/>
              <a:gd name="connsiteX8" fmla="*/ 0 w 437888"/>
              <a:gd name="connsiteY8" fmla="*/ 47625 h 1510827"/>
              <a:gd name="connsiteX0" fmla="*/ 0 w 437888"/>
              <a:gd name="connsiteY0" fmla="*/ 47625 h 1510827"/>
              <a:gd name="connsiteX1" fmla="*/ 180975 w 437888"/>
              <a:gd name="connsiteY1" fmla="*/ 0 h 1510827"/>
              <a:gd name="connsiteX2" fmla="*/ 228600 w 437888"/>
              <a:gd name="connsiteY2" fmla="*/ 328612 h 1510827"/>
              <a:gd name="connsiteX3" fmla="*/ 366712 w 437888"/>
              <a:gd name="connsiteY3" fmla="*/ 871537 h 1510827"/>
              <a:gd name="connsiteX4" fmla="*/ 437248 w 437888"/>
              <a:gd name="connsiteY4" fmla="*/ 1336139 h 1510827"/>
              <a:gd name="connsiteX5" fmla="*/ 328612 w 437888"/>
              <a:gd name="connsiteY5" fmla="*/ 1428750 h 1510827"/>
              <a:gd name="connsiteX6" fmla="*/ 204787 w 437888"/>
              <a:gd name="connsiteY6" fmla="*/ 504825 h 1510827"/>
              <a:gd name="connsiteX7" fmla="*/ 66675 w 437888"/>
              <a:gd name="connsiteY7" fmla="*/ 195262 h 1510827"/>
              <a:gd name="connsiteX8" fmla="*/ 0 w 437888"/>
              <a:gd name="connsiteY8" fmla="*/ 47625 h 1510827"/>
              <a:gd name="connsiteX0" fmla="*/ 0 w 437888"/>
              <a:gd name="connsiteY0" fmla="*/ 47625 h 1510827"/>
              <a:gd name="connsiteX1" fmla="*/ 180975 w 437888"/>
              <a:gd name="connsiteY1" fmla="*/ 0 h 1510827"/>
              <a:gd name="connsiteX2" fmla="*/ 228600 w 437888"/>
              <a:gd name="connsiteY2" fmla="*/ 328612 h 1510827"/>
              <a:gd name="connsiteX3" fmla="*/ 366712 w 437888"/>
              <a:gd name="connsiteY3" fmla="*/ 871537 h 1510827"/>
              <a:gd name="connsiteX4" fmla="*/ 437248 w 437888"/>
              <a:gd name="connsiteY4" fmla="*/ 1336139 h 1510827"/>
              <a:gd name="connsiteX5" fmla="*/ 328612 w 437888"/>
              <a:gd name="connsiteY5" fmla="*/ 1428750 h 1510827"/>
              <a:gd name="connsiteX6" fmla="*/ 204787 w 437888"/>
              <a:gd name="connsiteY6" fmla="*/ 504825 h 1510827"/>
              <a:gd name="connsiteX7" fmla="*/ 66675 w 437888"/>
              <a:gd name="connsiteY7" fmla="*/ 195262 h 1510827"/>
              <a:gd name="connsiteX8" fmla="*/ 0 w 437888"/>
              <a:gd name="connsiteY8" fmla="*/ 47625 h 1510827"/>
              <a:gd name="connsiteX0" fmla="*/ 0 w 437888"/>
              <a:gd name="connsiteY0" fmla="*/ 47625 h 1428750"/>
              <a:gd name="connsiteX1" fmla="*/ 180975 w 437888"/>
              <a:gd name="connsiteY1" fmla="*/ 0 h 1428750"/>
              <a:gd name="connsiteX2" fmla="*/ 228600 w 437888"/>
              <a:gd name="connsiteY2" fmla="*/ 328612 h 1428750"/>
              <a:gd name="connsiteX3" fmla="*/ 366712 w 437888"/>
              <a:gd name="connsiteY3" fmla="*/ 871537 h 1428750"/>
              <a:gd name="connsiteX4" fmla="*/ 437248 w 437888"/>
              <a:gd name="connsiteY4" fmla="*/ 1336139 h 1428750"/>
              <a:gd name="connsiteX5" fmla="*/ 328612 w 437888"/>
              <a:gd name="connsiteY5" fmla="*/ 1428750 h 1428750"/>
              <a:gd name="connsiteX6" fmla="*/ 204787 w 437888"/>
              <a:gd name="connsiteY6" fmla="*/ 504825 h 1428750"/>
              <a:gd name="connsiteX7" fmla="*/ 66675 w 437888"/>
              <a:gd name="connsiteY7" fmla="*/ 195262 h 1428750"/>
              <a:gd name="connsiteX8" fmla="*/ 0 w 437888"/>
              <a:gd name="connsiteY8" fmla="*/ 47625 h 1428750"/>
              <a:gd name="connsiteX0" fmla="*/ 0 w 437888"/>
              <a:gd name="connsiteY0" fmla="*/ 47625 h 1428750"/>
              <a:gd name="connsiteX1" fmla="*/ 180975 w 437888"/>
              <a:gd name="connsiteY1" fmla="*/ 0 h 1428750"/>
              <a:gd name="connsiteX2" fmla="*/ 228600 w 437888"/>
              <a:gd name="connsiteY2" fmla="*/ 328612 h 1428750"/>
              <a:gd name="connsiteX3" fmla="*/ 366712 w 437888"/>
              <a:gd name="connsiteY3" fmla="*/ 871537 h 1428750"/>
              <a:gd name="connsiteX4" fmla="*/ 437248 w 437888"/>
              <a:gd name="connsiteY4" fmla="*/ 1336139 h 1428750"/>
              <a:gd name="connsiteX5" fmla="*/ 328612 w 437888"/>
              <a:gd name="connsiteY5" fmla="*/ 1428750 h 1428750"/>
              <a:gd name="connsiteX6" fmla="*/ 204787 w 437888"/>
              <a:gd name="connsiteY6" fmla="*/ 504825 h 1428750"/>
              <a:gd name="connsiteX7" fmla="*/ 66675 w 437888"/>
              <a:gd name="connsiteY7" fmla="*/ 195262 h 1428750"/>
              <a:gd name="connsiteX8" fmla="*/ 0 w 437888"/>
              <a:gd name="connsiteY8" fmla="*/ 47625 h 1428750"/>
              <a:gd name="connsiteX0" fmla="*/ 0 w 437888"/>
              <a:gd name="connsiteY0" fmla="*/ 47625 h 1428750"/>
              <a:gd name="connsiteX1" fmla="*/ 180975 w 437888"/>
              <a:gd name="connsiteY1" fmla="*/ 0 h 1428750"/>
              <a:gd name="connsiteX2" fmla="*/ 228600 w 437888"/>
              <a:gd name="connsiteY2" fmla="*/ 328612 h 1428750"/>
              <a:gd name="connsiteX3" fmla="*/ 366712 w 437888"/>
              <a:gd name="connsiteY3" fmla="*/ 871537 h 1428750"/>
              <a:gd name="connsiteX4" fmla="*/ 437248 w 437888"/>
              <a:gd name="connsiteY4" fmla="*/ 1336139 h 1428750"/>
              <a:gd name="connsiteX5" fmla="*/ 328612 w 437888"/>
              <a:gd name="connsiteY5" fmla="*/ 1428750 h 1428750"/>
              <a:gd name="connsiteX6" fmla="*/ 204787 w 437888"/>
              <a:gd name="connsiteY6" fmla="*/ 504825 h 1428750"/>
              <a:gd name="connsiteX7" fmla="*/ 66675 w 437888"/>
              <a:gd name="connsiteY7" fmla="*/ 195262 h 1428750"/>
              <a:gd name="connsiteX8" fmla="*/ 0 w 437888"/>
              <a:gd name="connsiteY8" fmla="*/ 47625 h 1428750"/>
              <a:gd name="connsiteX0" fmla="*/ 0 w 437888"/>
              <a:gd name="connsiteY0" fmla="*/ 47625 h 1428750"/>
              <a:gd name="connsiteX1" fmla="*/ 180975 w 437888"/>
              <a:gd name="connsiteY1" fmla="*/ 0 h 1428750"/>
              <a:gd name="connsiteX2" fmla="*/ 228600 w 437888"/>
              <a:gd name="connsiteY2" fmla="*/ 328612 h 1428750"/>
              <a:gd name="connsiteX3" fmla="*/ 366712 w 437888"/>
              <a:gd name="connsiteY3" fmla="*/ 871537 h 1428750"/>
              <a:gd name="connsiteX4" fmla="*/ 437248 w 437888"/>
              <a:gd name="connsiteY4" fmla="*/ 1336139 h 1428750"/>
              <a:gd name="connsiteX5" fmla="*/ 328612 w 437888"/>
              <a:gd name="connsiteY5" fmla="*/ 1428750 h 1428750"/>
              <a:gd name="connsiteX6" fmla="*/ 204787 w 437888"/>
              <a:gd name="connsiteY6" fmla="*/ 504825 h 1428750"/>
              <a:gd name="connsiteX7" fmla="*/ 66675 w 437888"/>
              <a:gd name="connsiteY7" fmla="*/ 195262 h 1428750"/>
              <a:gd name="connsiteX8" fmla="*/ 0 w 437888"/>
              <a:gd name="connsiteY8" fmla="*/ 47625 h 1428750"/>
              <a:gd name="connsiteX0" fmla="*/ 0 w 437883"/>
              <a:gd name="connsiteY0" fmla="*/ 47625 h 1428750"/>
              <a:gd name="connsiteX1" fmla="*/ 180975 w 437883"/>
              <a:gd name="connsiteY1" fmla="*/ 0 h 1428750"/>
              <a:gd name="connsiteX2" fmla="*/ 230981 w 437883"/>
              <a:gd name="connsiteY2" fmla="*/ 328612 h 1428750"/>
              <a:gd name="connsiteX3" fmla="*/ 366712 w 437883"/>
              <a:gd name="connsiteY3" fmla="*/ 871537 h 1428750"/>
              <a:gd name="connsiteX4" fmla="*/ 437248 w 437883"/>
              <a:gd name="connsiteY4" fmla="*/ 1336139 h 1428750"/>
              <a:gd name="connsiteX5" fmla="*/ 328612 w 437883"/>
              <a:gd name="connsiteY5" fmla="*/ 1428750 h 1428750"/>
              <a:gd name="connsiteX6" fmla="*/ 204787 w 437883"/>
              <a:gd name="connsiteY6" fmla="*/ 504825 h 1428750"/>
              <a:gd name="connsiteX7" fmla="*/ 66675 w 437883"/>
              <a:gd name="connsiteY7" fmla="*/ 195262 h 1428750"/>
              <a:gd name="connsiteX8" fmla="*/ 0 w 437883"/>
              <a:gd name="connsiteY8" fmla="*/ 47625 h 1428750"/>
              <a:gd name="connsiteX0" fmla="*/ 0 w 437883"/>
              <a:gd name="connsiteY0" fmla="*/ 47625 h 1428750"/>
              <a:gd name="connsiteX1" fmla="*/ 180975 w 437883"/>
              <a:gd name="connsiteY1" fmla="*/ 0 h 1428750"/>
              <a:gd name="connsiteX2" fmla="*/ 230981 w 437883"/>
              <a:gd name="connsiteY2" fmla="*/ 328612 h 1428750"/>
              <a:gd name="connsiteX3" fmla="*/ 366712 w 437883"/>
              <a:gd name="connsiteY3" fmla="*/ 871537 h 1428750"/>
              <a:gd name="connsiteX4" fmla="*/ 437248 w 437883"/>
              <a:gd name="connsiteY4" fmla="*/ 1336139 h 1428750"/>
              <a:gd name="connsiteX5" fmla="*/ 328612 w 437883"/>
              <a:gd name="connsiteY5" fmla="*/ 1428750 h 1428750"/>
              <a:gd name="connsiteX6" fmla="*/ 204787 w 437883"/>
              <a:gd name="connsiteY6" fmla="*/ 504825 h 1428750"/>
              <a:gd name="connsiteX7" fmla="*/ 0 w 437883"/>
              <a:gd name="connsiteY7" fmla="*/ 47625 h 1428750"/>
              <a:gd name="connsiteX0" fmla="*/ 0 w 437883"/>
              <a:gd name="connsiteY0" fmla="*/ 47625 h 1428750"/>
              <a:gd name="connsiteX1" fmla="*/ 180975 w 437883"/>
              <a:gd name="connsiteY1" fmla="*/ 0 h 1428750"/>
              <a:gd name="connsiteX2" fmla="*/ 230981 w 437883"/>
              <a:gd name="connsiteY2" fmla="*/ 328612 h 1428750"/>
              <a:gd name="connsiteX3" fmla="*/ 366712 w 437883"/>
              <a:gd name="connsiteY3" fmla="*/ 871537 h 1428750"/>
              <a:gd name="connsiteX4" fmla="*/ 437248 w 437883"/>
              <a:gd name="connsiteY4" fmla="*/ 1336139 h 1428750"/>
              <a:gd name="connsiteX5" fmla="*/ 328612 w 437883"/>
              <a:gd name="connsiteY5" fmla="*/ 1428750 h 1428750"/>
              <a:gd name="connsiteX6" fmla="*/ 204787 w 437883"/>
              <a:gd name="connsiteY6" fmla="*/ 504825 h 1428750"/>
              <a:gd name="connsiteX7" fmla="*/ 0 w 437883"/>
              <a:gd name="connsiteY7" fmla="*/ 47625 h 1428750"/>
              <a:gd name="connsiteX0" fmla="*/ 0 w 437883"/>
              <a:gd name="connsiteY0" fmla="*/ 52387 h 1433512"/>
              <a:gd name="connsiteX1" fmla="*/ 178594 w 437883"/>
              <a:gd name="connsiteY1" fmla="*/ 0 h 1433512"/>
              <a:gd name="connsiteX2" fmla="*/ 230981 w 437883"/>
              <a:gd name="connsiteY2" fmla="*/ 333374 h 1433512"/>
              <a:gd name="connsiteX3" fmla="*/ 366712 w 437883"/>
              <a:gd name="connsiteY3" fmla="*/ 876299 h 1433512"/>
              <a:gd name="connsiteX4" fmla="*/ 437248 w 437883"/>
              <a:gd name="connsiteY4" fmla="*/ 1340901 h 1433512"/>
              <a:gd name="connsiteX5" fmla="*/ 328612 w 437883"/>
              <a:gd name="connsiteY5" fmla="*/ 1433512 h 1433512"/>
              <a:gd name="connsiteX6" fmla="*/ 204787 w 437883"/>
              <a:gd name="connsiteY6" fmla="*/ 509587 h 1433512"/>
              <a:gd name="connsiteX7" fmla="*/ 0 w 437883"/>
              <a:gd name="connsiteY7" fmla="*/ 52387 h 14335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37883" h="1433512">
                <a:moveTo>
                  <a:pt x="0" y="52387"/>
                </a:moveTo>
                <a:cubicBezTo>
                  <a:pt x="112713" y="31749"/>
                  <a:pt x="118269" y="15875"/>
                  <a:pt x="178594" y="0"/>
                </a:cubicBezTo>
                <a:cubicBezTo>
                  <a:pt x="188118" y="70644"/>
                  <a:pt x="207168" y="169068"/>
                  <a:pt x="230981" y="333374"/>
                </a:cubicBezTo>
                <a:cubicBezTo>
                  <a:pt x="276225" y="507205"/>
                  <a:pt x="332334" y="708378"/>
                  <a:pt x="366712" y="876299"/>
                </a:cubicBezTo>
                <a:cubicBezTo>
                  <a:pt x="401090" y="1044220"/>
                  <a:pt x="443598" y="1248032"/>
                  <a:pt x="437248" y="1340901"/>
                </a:cubicBezTo>
                <a:lnTo>
                  <a:pt x="328612" y="1433512"/>
                </a:lnTo>
                <a:cubicBezTo>
                  <a:pt x="237480" y="1033022"/>
                  <a:pt x="237331" y="657224"/>
                  <a:pt x="204787" y="509587"/>
                </a:cubicBezTo>
                <a:cubicBezTo>
                  <a:pt x="150018" y="279400"/>
                  <a:pt x="3969" y="136525"/>
                  <a:pt x="0" y="52387"/>
                </a:cubicBezTo>
                <a:close/>
              </a:path>
            </a:pathLst>
          </a:custGeom>
          <a:solidFill>
            <a:srgbClr val="C00000">
              <a:alpha val="7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2400"/>
          </a:p>
        </p:txBody>
      </p:sp>
      <p:sp>
        <p:nvSpPr>
          <p:cNvPr id="174" name="Freihandform: Form 173">
            <a:extLst>
              <a:ext uri="{FF2B5EF4-FFF2-40B4-BE49-F238E27FC236}">
                <a16:creationId xmlns:a16="http://schemas.microsoft.com/office/drawing/2014/main" id="{2E532FA4-426B-C8DB-9494-4EDFD8C21454}"/>
              </a:ext>
            </a:extLst>
          </p:cNvPr>
          <p:cNvSpPr/>
          <p:nvPr/>
        </p:nvSpPr>
        <p:spPr>
          <a:xfrm>
            <a:off x="4795034" y="2178563"/>
            <a:ext cx="2129978" cy="2545492"/>
          </a:xfrm>
          <a:custGeom>
            <a:avLst/>
            <a:gdLst>
              <a:gd name="connsiteX0" fmla="*/ 0 w 1663700"/>
              <a:gd name="connsiteY0" fmla="*/ 152400 h 2209800"/>
              <a:gd name="connsiteX1" fmla="*/ 749300 w 1663700"/>
              <a:gd name="connsiteY1" fmla="*/ 127000 h 2209800"/>
              <a:gd name="connsiteX2" fmla="*/ 1092200 w 1663700"/>
              <a:gd name="connsiteY2" fmla="*/ 0 h 2209800"/>
              <a:gd name="connsiteX3" fmla="*/ 1663700 w 1663700"/>
              <a:gd name="connsiteY3" fmla="*/ 1524000 h 2209800"/>
              <a:gd name="connsiteX4" fmla="*/ 1498600 w 1663700"/>
              <a:gd name="connsiteY4" fmla="*/ 1828800 h 2209800"/>
              <a:gd name="connsiteX5" fmla="*/ 723900 w 1663700"/>
              <a:gd name="connsiteY5" fmla="*/ 2209800 h 2209800"/>
              <a:gd name="connsiteX6" fmla="*/ 0 w 1663700"/>
              <a:gd name="connsiteY6" fmla="*/ 152400 h 2209800"/>
              <a:gd name="connsiteX0" fmla="*/ 0 w 1663700"/>
              <a:gd name="connsiteY0" fmla="*/ 130968 h 2209800"/>
              <a:gd name="connsiteX1" fmla="*/ 749300 w 1663700"/>
              <a:gd name="connsiteY1" fmla="*/ 127000 h 2209800"/>
              <a:gd name="connsiteX2" fmla="*/ 1092200 w 1663700"/>
              <a:gd name="connsiteY2" fmla="*/ 0 h 2209800"/>
              <a:gd name="connsiteX3" fmla="*/ 1663700 w 1663700"/>
              <a:gd name="connsiteY3" fmla="*/ 1524000 h 2209800"/>
              <a:gd name="connsiteX4" fmla="*/ 1498600 w 1663700"/>
              <a:gd name="connsiteY4" fmla="*/ 1828800 h 2209800"/>
              <a:gd name="connsiteX5" fmla="*/ 723900 w 1663700"/>
              <a:gd name="connsiteY5" fmla="*/ 2209800 h 2209800"/>
              <a:gd name="connsiteX6" fmla="*/ 0 w 1663700"/>
              <a:gd name="connsiteY6" fmla="*/ 130968 h 2209800"/>
              <a:gd name="connsiteX0" fmla="*/ 0 w 1663700"/>
              <a:gd name="connsiteY0" fmla="*/ 130968 h 2209800"/>
              <a:gd name="connsiteX1" fmla="*/ 713581 w 1663700"/>
              <a:gd name="connsiteY1" fmla="*/ 136525 h 2209800"/>
              <a:gd name="connsiteX2" fmla="*/ 1092200 w 1663700"/>
              <a:gd name="connsiteY2" fmla="*/ 0 h 2209800"/>
              <a:gd name="connsiteX3" fmla="*/ 1663700 w 1663700"/>
              <a:gd name="connsiteY3" fmla="*/ 1524000 h 2209800"/>
              <a:gd name="connsiteX4" fmla="*/ 1498600 w 1663700"/>
              <a:gd name="connsiteY4" fmla="*/ 1828800 h 2209800"/>
              <a:gd name="connsiteX5" fmla="*/ 723900 w 1663700"/>
              <a:gd name="connsiteY5" fmla="*/ 2209800 h 2209800"/>
              <a:gd name="connsiteX6" fmla="*/ 0 w 1663700"/>
              <a:gd name="connsiteY6" fmla="*/ 130968 h 2209800"/>
              <a:gd name="connsiteX0" fmla="*/ 0 w 1663700"/>
              <a:gd name="connsiteY0" fmla="*/ 140493 h 2219325"/>
              <a:gd name="connsiteX1" fmla="*/ 713581 w 1663700"/>
              <a:gd name="connsiteY1" fmla="*/ 146050 h 2219325"/>
              <a:gd name="connsiteX2" fmla="*/ 1094581 w 1663700"/>
              <a:gd name="connsiteY2" fmla="*/ 0 h 2219325"/>
              <a:gd name="connsiteX3" fmla="*/ 1663700 w 1663700"/>
              <a:gd name="connsiteY3" fmla="*/ 1533525 h 2219325"/>
              <a:gd name="connsiteX4" fmla="*/ 1498600 w 1663700"/>
              <a:gd name="connsiteY4" fmla="*/ 1838325 h 2219325"/>
              <a:gd name="connsiteX5" fmla="*/ 723900 w 1663700"/>
              <a:gd name="connsiteY5" fmla="*/ 2219325 h 2219325"/>
              <a:gd name="connsiteX6" fmla="*/ 0 w 1663700"/>
              <a:gd name="connsiteY6" fmla="*/ 140493 h 2219325"/>
              <a:gd name="connsiteX0" fmla="*/ 0 w 1651794"/>
              <a:gd name="connsiteY0" fmla="*/ 140493 h 2219325"/>
              <a:gd name="connsiteX1" fmla="*/ 713581 w 1651794"/>
              <a:gd name="connsiteY1" fmla="*/ 146050 h 2219325"/>
              <a:gd name="connsiteX2" fmla="*/ 1094581 w 1651794"/>
              <a:gd name="connsiteY2" fmla="*/ 0 h 2219325"/>
              <a:gd name="connsiteX3" fmla="*/ 1651794 w 1651794"/>
              <a:gd name="connsiteY3" fmla="*/ 1524000 h 2219325"/>
              <a:gd name="connsiteX4" fmla="*/ 1498600 w 1651794"/>
              <a:gd name="connsiteY4" fmla="*/ 1838325 h 2219325"/>
              <a:gd name="connsiteX5" fmla="*/ 723900 w 1651794"/>
              <a:gd name="connsiteY5" fmla="*/ 2219325 h 2219325"/>
              <a:gd name="connsiteX6" fmla="*/ 0 w 1651794"/>
              <a:gd name="connsiteY6" fmla="*/ 140493 h 2219325"/>
              <a:gd name="connsiteX0" fmla="*/ 0 w 1651794"/>
              <a:gd name="connsiteY0" fmla="*/ 140493 h 2219325"/>
              <a:gd name="connsiteX1" fmla="*/ 713581 w 1651794"/>
              <a:gd name="connsiteY1" fmla="*/ 146050 h 2219325"/>
              <a:gd name="connsiteX2" fmla="*/ 1094581 w 1651794"/>
              <a:gd name="connsiteY2" fmla="*/ 0 h 2219325"/>
              <a:gd name="connsiteX3" fmla="*/ 1651794 w 1651794"/>
              <a:gd name="connsiteY3" fmla="*/ 1524000 h 2219325"/>
              <a:gd name="connsiteX4" fmla="*/ 1493838 w 1651794"/>
              <a:gd name="connsiteY4" fmla="*/ 1835944 h 2219325"/>
              <a:gd name="connsiteX5" fmla="*/ 723900 w 1651794"/>
              <a:gd name="connsiteY5" fmla="*/ 2219325 h 2219325"/>
              <a:gd name="connsiteX6" fmla="*/ 0 w 1651794"/>
              <a:gd name="connsiteY6" fmla="*/ 140493 h 2219325"/>
              <a:gd name="connsiteX0" fmla="*/ 0 w 1651794"/>
              <a:gd name="connsiteY0" fmla="*/ 140493 h 2224087"/>
              <a:gd name="connsiteX1" fmla="*/ 713581 w 1651794"/>
              <a:gd name="connsiteY1" fmla="*/ 146050 h 2224087"/>
              <a:gd name="connsiteX2" fmla="*/ 1094581 w 1651794"/>
              <a:gd name="connsiteY2" fmla="*/ 0 h 2224087"/>
              <a:gd name="connsiteX3" fmla="*/ 1651794 w 1651794"/>
              <a:gd name="connsiteY3" fmla="*/ 1524000 h 2224087"/>
              <a:gd name="connsiteX4" fmla="*/ 1493838 w 1651794"/>
              <a:gd name="connsiteY4" fmla="*/ 1835944 h 2224087"/>
              <a:gd name="connsiteX5" fmla="*/ 714375 w 1651794"/>
              <a:gd name="connsiteY5" fmla="*/ 2224087 h 2224087"/>
              <a:gd name="connsiteX6" fmla="*/ 0 w 1651794"/>
              <a:gd name="connsiteY6" fmla="*/ 140493 h 2224087"/>
              <a:gd name="connsiteX0" fmla="*/ 0 w 1651794"/>
              <a:gd name="connsiteY0" fmla="*/ 121443 h 2205037"/>
              <a:gd name="connsiteX1" fmla="*/ 713581 w 1651794"/>
              <a:gd name="connsiteY1" fmla="*/ 127000 h 2205037"/>
              <a:gd name="connsiteX2" fmla="*/ 1096962 w 1651794"/>
              <a:gd name="connsiteY2" fmla="*/ 0 h 2205037"/>
              <a:gd name="connsiteX3" fmla="*/ 1651794 w 1651794"/>
              <a:gd name="connsiteY3" fmla="*/ 1504950 h 2205037"/>
              <a:gd name="connsiteX4" fmla="*/ 1493838 w 1651794"/>
              <a:gd name="connsiteY4" fmla="*/ 1816894 h 2205037"/>
              <a:gd name="connsiteX5" fmla="*/ 714375 w 1651794"/>
              <a:gd name="connsiteY5" fmla="*/ 2205037 h 2205037"/>
              <a:gd name="connsiteX6" fmla="*/ 0 w 1651794"/>
              <a:gd name="connsiteY6" fmla="*/ 121443 h 2205037"/>
              <a:gd name="connsiteX0" fmla="*/ 0 w 1651794"/>
              <a:gd name="connsiteY0" fmla="*/ 121443 h 2205037"/>
              <a:gd name="connsiteX1" fmla="*/ 713581 w 1651794"/>
              <a:gd name="connsiteY1" fmla="*/ 127000 h 2205037"/>
              <a:gd name="connsiteX2" fmla="*/ 1096962 w 1651794"/>
              <a:gd name="connsiteY2" fmla="*/ 0 h 2205037"/>
              <a:gd name="connsiteX3" fmla="*/ 1651794 w 1651794"/>
              <a:gd name="connsiteY3" fmla="*/ 1504950 h 2205037"/>
              <a:gd name="connsiteX4" fmla="*/ 1493838 w 1651794"/>
              <a:gd name="connsiteY4" fmla="*/ 1816894 h 2205037"/>
              <a:gd name="connsiteX5" fmla="*/ 714375 w 1651794"/>
              <a:gd name="connsiteY5" fmla="*/ 2205037 h 2205037"/>
              <a:gd name="connsiteX6" fmla="*/ 0 w 1651794"/>
              <a:gd name="connsiteY6" fmla="*/ 121443 h 2205037"/>
              <a:gd name="connsiteX0" fmla="*/ 0 w 1651794"/>
              <a:gd name="connsiteY0" fmla="*/ 121443 h 2390774"/>
              <a:gd name="connsiteX1" fmla="*/ 713581 w 1651794"/>
              <a:gd name="connsiteY1" fmla="*/ 127000 h 2390774"/>
              <a:gd name="connsiteX2" fmla="*/ 1096962 w 1651794"/>
              <a:gd name="connsiteY2" fmla="*/ 0 h 2390774"/>
              <a:gd name="connsiteX3" fmla="*/ 1651794 w 1651794"/>
              <a:gd name="connsiteY3" fmla="*/ 1504950 h 2390774"/>
              <a:gd name="connsiteX4" fmla="*/ 1493838 w 1651794"/>
              <a:gd name="connsiteY4" fmla="*/ 1816894 h 2390774"/>
              <a:gd name="connsiteX5" fmla="*/ 781050 w 1651794"/>
              <a:gd name="connsiteY5" fmla="*/ 2390774 h 2390774"/>
              <a:gd name="connsiteX6" fmla="*/ 0 w 1651794"/>
              <a:gd name="connsiteY6" fmla="*/ 121443 h 2390774"/>
              <a:gd name="connsiteX0" fmla="*/ 0 w 1704181"/>
              <a:gd name="connsiteY0" fmla="*/ 121443 h 2390774"/>
              <a:gd name="connsiteX1" fmla="*/ 713581 w 1704181"/>
              <a:gd name="connsiteY1" fmla="*/ 127000 h 2390774"/>
              <a:gd name="connsiteX2" fmla="*/ 1096962 w 1704181"/>
              <a:gd name="connsiteY2" fmla="*/ 0 h 2390774"/>
              <a:gd name="connsiteX3" fmla="*/ 1704181 w 1704181"/>
              <a:gd name="connsiteY3" fmla="*/ 1662113 h 2390774"/>
              <a:gd name="connsiteX4" fmla="*/ 1493838 w 1704181"/>
              <a:gd name="connsiteY4" fmla="*/ 1816894 h 2390774"/>
              <a:gd name="connsiteX5" fmla="*/ 781050 w 1704181"/>
              <a:gd name="connsiteY5" fmla="*/ 2390774 h 2390774"/>
              <a:gd name="connsiteX6" fmla="*/ 0 w 1704181"/>
              <a:gd name="connsiteY6" fmla="*/ 121443 h 2390774"/>
              <a:gd name="connsiteX0" fmla="*/ 0 w 1704181"/>
              <a:gd name="connsiteY0" fmla="*/ 121443 h 2390774"/>
              <a:gd name="connsiteX1" fmla="*/ 713581 w 1704181"/>
              <a:gd name="connsiteY1" fmla="*/ 127000 h 2390774"/>
              <a:gd name="connsiteX2" fmla="*/ 1096962 w 1704181"/>
              <a:gd name="connsiteY2" fmla="*/ 0 h 2390774"/>
              <a:gd name="connsiteX3" fmla="*/ 1704181 w 1704181"/>
              <a:gd name="connsiteY3" fmla="*/ 1662113 h 2390774"/>
              <a:gd name="connsiteX4" fmla="*/ 781050 w 1704181"/>
              <a:gd name="connsiteY4" fmla="*/ 2390774 h 2390774"/>
              <a:gd name="connsiteX5" fmla="*/ 0 w 1704181"/>
              <a:gd name="connsiteY5" fmla="*/ 121443 h 2390774"/>
              <a:gd name="connsiteX0" fmla="*/ 0 w 1704181"/>
              <a:gd name="connsiteY0" fmla="*/ 121443 h 2694132"/>
              <a:gd name="connsiteX1" fmla="*/ 713581 w 1704181"/>
              <a:gd name="connsiteY1" fmla="*/ 127000 h 2694132"/>
              <a:gd name="connsiteX2" fmla="*/ 1096962 w 1704181"/>
              <a:gd name="connsiteY2" fmla="*/ 0 h 2694132"/>
              <a:gd name="connsiteX3" fmla="*/ 1704181 w 1704181"/>
              <a:gd name="connsiteY3" fmla="*/ 1662113 h 2694132"/>
              <a:gd name="connsiteX4" fmla="*/ 422174 w 1704181"/>
              <a:gd name="connsiteY4" fmla="*/ 2694132 h 2694132"/>
              <a:gd name="connsiteX5" fmla="*/ 0 w 1704181"/>
              <a:gd name="connsiteY5" fmla="*/ 121443 h 2694132"/>
              <a:gd name="connsiteX0" fmla="*/ 0 w 2083762"/>
              <a:gd name="connsiteY0" fmla="*/ 107654 h 2694132"/>
              <a:gd name="connsiteX1" fmla="*/ 1093162 w 2083762"/>
              <a:gd name="connsiteY1" fmla="*/ 127000 h 2694132"/>
              <a:gd name="connsiteX2" fmla="*/ 1476543 w 2083762"/>
              <a:gd name="connsiteY2" fmla="*/ 0 h 2694132"/>
              <a:gd name="connsiteX3" fmla="*/ 2083762 w 2083762"/>
              <a:gd name="connsiteY3" fmla="*/ 1662113 h 2694132"/>
              <a:gd name="connsiteX4" fmla="*/ 801755 w 2083762"/>
              <a:gd name="connsiteY4" fmla="*/ 2694132 h 2694132"/>
              <a:gd name="connsiteX5" fmla="*/ 0 w 2083762"/>
              <a:gd name="connsiteY5" fmla="*/ 107654 h 2694132"/>
              <a:gd name="connsiteX0" fmla="*/ 0 w 2083762"/>
              <a:gd name="connsiteY0" fmla="*/ 52498 h 2638976"/>
              <a:gd name="connsiteX1" fmla="*/ 1093162 w 2083762"/>
              <a:gd name="connsiteY1" fmla="*/ 71844 h 2638976"/>
              <a:gd name="connsiteX2" fmla="*/ 1331611 w 2083762"/>
              <a:gd name="connsiteY2" fmla="*/ 0 h 2638976"/>
              <a:gd name="connsiteX3" fmla="*/ 2083762 w 2083762"/>
              <a:gd name="connsiteY3" fmla="*/ 1606957 h 2638976"/>
              <a:gd name="connsiteX4" fmla="*/ 801755 w 2083762"/>
              <a:gd name="connsiteY4" fmla="*/ 2638976 h 2638976"/>
              <a:gd name="connsiteX5" fmla="*/ 0 w 2083762"/>
              <a:gd name="connsiteY5" fmla="*/ 52498 h 2638976"/>
              <a:gd name="connsiteX0" fmla="*/ 0 w 1918126"/>
              <a:gd name="connsiteY0" fmla="*/ 52498 h 2638976"/>
              <a:gd name="connsiteX1" fmla="*/ 1093162 w 1918126"/>
              <a:gd name="connsiteY1" fmla="*/ 71844 h 2638976"/>
              <a:gd name="connsiteX2" fmla="*/ 1331611 w 1918126"/>
              <a:gd name="connsiteY2" fmla="*/ 0 h 2638976"/>
              <a:gd name="connsiteX3" fmla="*/ 1918126 w 1918126"/>
              <a:gd name="connsiteY3" fmla="*/ 1744847 h 2638976"/>
              <a:gd name="connsiteX4" fmla="*/ 801755 w 1918126"/>
              <a:gd name="connsiteY4" fmla="*/ 2638976 h 2638976"/>
              <a:gd name="connsiteX5" fmla="*/ 0 w 1918126"/>
              <a:gd name="connsiteY5" fmla="*/ 52498 h 2638976"/>
              <a:gd name="connsiteX0" fmla="*/ 0 w 2007846"/>
              <a:gd name="connsiteY0" fmla="*/ 73181 h 2638976"/>
              <a:gd name="connsiteX1" fmla="*/ 1182882 w 2007846"/>
              <a:gd name="connsiteY1" fmla="*/ 71844 h 2638976"/>
              <a:gd name="connsiteX2" fmla="*/ 1421331 w 2007846"/>
              <a:gd name="connsiteY2" fmla="*/ 0 h 2638976"/>
              <a:gd name="connsiteX3" fmla="*/ 2007846 w 2007846"/>
              <a:gd name="connsiteY3" fmla="*/ 1744847 h 2638976"/>
              <a:gd name="connsiteX4" fmla="*/ 891475 w 2007846"/>
              <a:gd name="connsiteY4" fmla="*/ 2638976 h 2638976"/>
              <a:gd name="connsiteX5" fmla="*/ 0 w 2007846"/>
              <a:gd name="connsiteY5" fmla="*/ 73181 h 2638976"/>
              <a:gd name="connsiteX0" fmla="*/ 0 w 2007846"/>
              <a:gd name="connsiteY0" fmla="*/ 73181 h 2776866"/>
              <a:gd name="connsiteX1" fmla="*/ 1182882 w 2007846"/>
              <a:gd name="connsiteY1" fmla="*/ 71844 h 2776866"/>
              <a:gd name="connsiteX2" fmla="*/ 1421331 w 2007846"/>
              <a:gd name="connsiteY2" fmla="*/ 0 h 2776866"/>
              <a:gd name="connsiteX3" fmla="*/ 2007846 w 2007846"/>
              <a:gd name="connsiteY3" fmla="*/ 1744847 h 2776866"/>
              <a:gd name="connsiteX4" fmla="*/ 753446 w 2007846"/>
              <a:gd name="connsiteY4" fmla="*/ 2776866 h 2776866"/>
              <a:gd name="connsiteX5" fmla="*/ 0 w 2007846"/>
              <a:gd name="connsiteY5" fmla="*/ 73181 h 2776866"/>
              <a:gd name="connsiteX0" fmla="*/ 0 w 2007846"/>
              <a:gd name="connsiteY0" fmla="*/ 73181 h 2694132"/>
              <a:gd name="connsiteX1" fmla="*/ 1182882 w 2007846"/>
              <a:gd name="connsiteY1" fmla="*/ 71844 h 2694132"/>
              <a:gd name="connsiteX2" fmla="*/ 1421331 w 2007846"/>
              <a:gd name="connsiteY2" fmla="*/ 0 h 2694132"/>
              <a:gd name="connsiteX3" fmla="*/ 2007846 w 2007846"/>
              <a:gd name="connsiteY3" fmla="*/ 1744847 h 2694132"/>
              <a:gd name="connsiteX4" fmla="*/ 850067 w 2007846"/>
              <a:gd name="connsiteY4" fmla="*/ 2694132 h 2694132"/>
              <a:gd name="connsiteX5" fmla="*/ 0 w 2007846"/>
              <a:gd name="connsiteY5" fmla="*/ 73181 h 2694132"/>
              <a:gd name="connsiteX0" fmla="*/ 0 w 2049255"/>
              <a:gd name="connsiteY0" fmla="*/ 73181 h 2694132"/>
              <a:gd name="connsiteX1" fmla="*/ 1182882 w 2049255"/>
              <a:gd name="connsiteY1" fmla="*/ 71844 h 2694132"/>
              <a:gd name="connsiteX2" fmla="*/ 1421331 w 2049255"/>
              <a:gd name="connsiteY2" fmla="*/ 0 h 2694132"/>
              <a:gd name="connsiteX3" fmla="*/ 2049255 w 2049255"/>
              <a:gd name="connsiteY3" fmla="*/ 1703480 h 2694132"/>
              <a:gd name="connsiteX4" fmla="*/ 850067 w 2049255"/>
              <a:gd name="connsiteY4" fmla="*/ 2694132 h 2694132"/>
              <a:gd name="connsiteX5" fmla="*/ 0 w 2049255"/>
              <a:gd name="connsiteY5" fmla="*/ 73181 h 2694132"/>
              <a:gd name="connsiteX0" fmla="*/ 0 w 2049255"/>
              <a:gd name="connsiteY0" fmla="*/ 73181 h 2638976"/>
              <a:gd name="connsiteX1" fmla="*/ 1182882 w 2049255"/>
              <a:gd name="connsiteY1" fmla="*/ 71844 h 2638976"/>
              <a:gd name="connsiteX2" fmla="*/ 1421331 w 2049255"/>
              <a:gd name="connsiteY2" fmla="*/ 0 h 2638976"/>
              <a:gd name="connsiteX3" fmla="*/ 2049255 w 2049255"/>
              <a:gd name="connsiteY3" fmla="*/ 1703480 h 2638976"/>
              <a:gd name="connsiteX4" fmla="*/ 919082 w 2049255"/>
              <a:gd name="connsiteY4" fmla="*/ 2638976 h 2638976"/>
              <a:gd name="connsiteX5" fmla="*/ 0 w 2049255"/>
              <a:gd name="connsiteY5" fmla="*/ 73181 h 2638976"/>
              <a:gd name="connsiteX0" fmla="*/ 0 w 2049255"/>
              <a:gd name="connsiteY0" fmla="*/ 73181 h 2604504"/>
              <a:gd name="connsiteX1" fmla="*/ 1182882 w 2049255"/>
              <a:gd name="connsiteY1" fmla="*/ 71844 h 2604504"/>
              <a:gd name="connsiteX2" fmla="*/ 1421331 w 2049255"/>
              <a:gd name="connsiteY2" fmla="*/ 0 h 2604504"/>
              <a:gd name="connsiteX3" fmla="*/ 2049255 w 2049255"/>
              <a:gd name="connsiteY3" fmla="*/ 1703480 h 2604504"/>
              <a:gd name="connsiteX4" fmla="*/ 967393 w 2049255"/>
              <a:gd name="connsiteY4" fmla="*/ 2604504 h 2604504"/>
              <a:gd name="connsiteX5" fmla="*/ 0 w 2049255"/>
              <a:gd name="connsiteY5" fmla="*/ 73181 h 2604504"/>
              <a:gd name="connsiteX0" fmla="*/ 0 w 2049255"/>
              <a:gd name="connsiteY0" fmla="*/ 73181 h 2701027"/>
              <a:gd name="connsiteX1" fmla="*/ 1182882 w 2049255"/>
              <a:gd name="connsiteY1" fmla="*/ 71844 h 2701027"/>
              <a:gd name="connsiteX2" fmla="*/ 1421331 w 2049255"/>
              <a:gd name="connsiteY2" fmla="*/ 0 h 2701027"/>
              <a:gd name="connsiteX3" fmla="*/ 2049255 w 2049255"/>
              <a:gd name="connsiteY3" fmla="*/ 1703480 h 2701027"/>
              <a:gd name="connsiteX4" fmla="*/ 877673 w 2049255"/>
              <a:gd name="connsiteY4" fmla="*/ 2701027 h 2701027"/>
              <a:gd name="connsiteX5" fmla="*/ 0 w 2049255"/>
              <a:gd name="connsiteY5" fmla="*/ 73181 h 2701027"/>
              <a:gd name="connsiteX0" fmla="*/ 0 w 2049255"/>
              <a:gd name="connsiteY0" fmla="*/ 73181 h 2701027"/>
              <a:gd name="connsiteX1" fmla="*/ 1182882 w 2049255"/>
              <a:gd name="connsiteY1" fmla="*/ 71844 h 2701027"/>
              <a:gd name="connsiteX2" fmla="*/ 1421331 w 2049255"/>
              <a:gd name="connsiteY2" fmla="*/ 0 h 2701027"/>
              <a:gd name="connsiteX3" fmla="*/ 2049255 w 2049255"/>
              <a:gd name="connsiteY3" fmla="*/ 1703480 h 2701027"/>
              <a:gd name="connsiteX4" fmla="*/ 877673 w 2049255"/>
              <a:gd name="connsiteY4" fmla="*/ 2701027 h 2701027"/>
              <a:gd name="connsiteX5" fmla="*/ 0 w 2049255"/>
              <a:gd name="connsiteY5" fmla="*/ 73181 h 2701027"/>
              <a:gd name="connsiteX0" fmla="*/ 0 w 2118270"/>
              <a:gd name="connsiteY0" fmla="*/ 73181 h 2701027"/>
              <a:gd name="connsiteX1" fmla="*/ 1251897 w 2118270"/>
              <a:gd name="connsiteY1" fmla="*/ 71844 h 2701027"/>
              <a:gd name="connsiteX2" fmla="*/ 1490346 w 2118270"/>
              <a:gd name="connsiteY2" fmla="*/ 0 h 2701027"/>
              <a:gd name="connsiteX3" fmla="*/ 2118270 w 2118270"/>
              <a:gd name="connsiteY3" fmla="*/ 1703480 h 2701027"/>
              <a:gd name="connsiteX4" fmla="*/ 946688 w 2118270"/>
              <a:gd name="connsiteY4" fmla="*/ 2701027 h 2701027"/>
              <a:gd name="connsiteX5" fmla="*/ 0 w 2118270"/>
              <a:gd name="connsiteY5" fmla="*/ 73181 h 2701027"/>
              <a:gd name="connsiteX0" fmla="*/ 0 w 2118270"/>
              <a:gd name="connsiteY0" fmla="*/ 73181 h 2725158"/>
              <a:gd name="connsiteX1" fmla="*/ 1251897 w 2118270"/>
              <a:gd name="connsiteY1" fmla="*/ 71844 h 2725158"/>
              <a:gd name="connsiteX2" fmla="*/ 1490346 w 2118270"/>
              <a:gd name="connsiteY2" fmla="*/ 0 h 2725158"/>
              <a:gd name="connsiteX3" fmla="*/ 2118270 w 2118270"/>
              <a:gd name="connsiteY3" fmla="*/ 1703480 h 2725158"/>
              <a:gd name="connsiteX4" fmla="*/ 925984 w 2118270"/>
              <a:gd name="connsiteY4" fmla="*/ 2725158 h 2725158"/>
              <a:gd name="connsiteX5" fmla="*/ 0 w 2118270"/>
              <a:gd name="connsiteY5" fmla="*/ 73181 h 2725158"/>
              <a:gd name="connsiteX0" fmla="*/ 0 w 2111368"/>
              <a:gd name="connsiteY0" fmla="*/ 69733 h 2725158"/>
              <a:gd name="connsiteX1" fmla="*/ 1244995 w 2111368"/>
              <a:gd name="connsiteY1" fmla="*/ 71844 h 2725158"/>
              <a:gd name="connsiteX2" fmla="*/ 1483444 w 2111368"/>
              <a:gd name="connsiteY2" fmla="*/ 0 h 2725158"/>
              <a:gd name="connsiteX3" fmla="*/ 2111368 w 2111368"/>
              <a:gd name="connsiteY3" fmla="*/ 1703480 h 2725158"/>
              <a:gd name="connsiteX4" fmla="*/ 919082 w 2111368"/>
              <a:gd name="connsiteY4" fmla="*/ 2725158 h 2725158"/>
              <a:gd name="connsiteX5" fmla="*/ 0 w 2111368"/>
              <a:gd name="connsiteY5" fmla="*/ 69733 h 2725158"/>
              <a:gd name="connsiteX0" fmla="*/ 0 w 2111368"/>
              <a:gd name="connsiteY0" fmla="*/ 69733 h 2635529"/>
              <a:gd name="connsiteX1" fmla="*/ 1244995 w 2111368"/>
              <a:gd name="connsiteY1" fmla="*/ 71844 h 2635529"/>
              <a:gd name="connsiteX2" fmla="*/ 1483444 w 2111368"/>
              <a:gd name="connsiteY2" fmla="*/ 0 h 2635529"/>
              <a:gd name="connsiteX3" fmla="*/ 2111368 w 2111368"/>
              <a:gd name="connsiteY3" fmla="*/ 1703480 h 2635529"/>
              <a:gd name="connsiteX4" fmla="*/ 1084717 w 2111368"/>
              <a:gd name="connsiteY4" fmla="*/ 2635529 h 2635529"/>
              <a:gd name="connsiteX5" fmla="*/ 0 w 2111368"/>
              <a:gd name="connsiteY5" fmla="*/ 69733 h 2635529"/>
              <a:gd name="connsiteX0" fmla="*/ 0 w 1724885"/>
              <a:gd name="connsiteY0" fmla="*/ 55944 h 2635529"/>
              <a:gd name="connsiteX1" fmla="*/ 858512 w 1724885"/>
              <a:gd name="connsiteY1" fmla="*/ 71844 h 2635529"/>
              <a:gd name="connsiteX2" fmla="*/ 1096961 w 1724885"/>
              <a:gd name="connsiteY2" fmla="*/ 0 h 2635529"/>
              <a:gd name="connsiteX3" fmla="*/ 1724885 w 1724885"/>
              <a:gd name="connsiteY3" fmla="*/ 1703480 h 2635529"/>
              <a:gd name="connsiteX4" fmla="*/ 698234 w 1724885"/>
              <a:gd name="connsiteY4" fmla="*/ 2635529 h 2635529"/>
              <a:gd name="connsiteX5" fmla="*/ 0 w 1724885"/>
              <a:gd name="connsiteY5" fmla="*/ 55944 h 2635529"/>
              <a:gd name="connsiteX0" fmla="*/ 0 w 1717983"/>
              <a:gd name="connsiteY0" fmla="*/ 55944 h 2635529"/>
              <a:gd name="connsiteX1" fmla="*/ 858512 w 1717983"/>
              <a:gd name="connsiteY1" fmla="*/ 71844 h 2635529"/>
              <a:gd name="connsiteX2" fmla="*/ 1096961 w 1717983"/>
              <a:gd name="connsiteY2" fmla="*/ 0 h 2635529"/>
              <a:gd name="connsiteX3" fmla="*/ 1717983 w 1717983"/>
              <a:gd name="connsiteY3" fmla="*/ 1910315 h 2635529"/>
              <a:gd name="connsiteX4" fmla="*/ 698234 w 1717983"/>
              <a:gd name="connsiteY4" fmla="*/ 2635529 h 2635529"/>
              <a:gd name="connsiteX5" fmla="*/ 0 w 1717983"/>
              <a:gd name="connsiteY5" fmla="*/ 55944 h 2635529"/>
              <a:gd name="connsiteX0" fmla="*/ 0 w 2421934"/>
              <a:gd name="connsiteY0" fmla="*/ 62837 h 2635529"/>
              <a:gd name="connsiteX1" fmla="*/ 1562463 w 2421934"/>
              <a:gd name="connsiteY1" fmla="*/ 71844 h 2635529"/>
              <a:gd name="connsiteX2" fmla="*/ 1800912 w 2421934"/>
              <a:gd name="connsiteY2" fmla="*/ 0 h 2635529"/>
              <a:gd name="connsiteX3" fmla="*/ 2421934 w 2421934"/>
              <a:gd name="connsiteY3" fmla="*/ 1910315 h 2635529"/>
              <a:gd name="connsiteX4" fmla="*/ 1402185 w 2421934"/>
              <a:gd name="connsiteY4" fmla="*/ 2635529 h 2635529"/>
              <a:gd name="connsiteX5" fmla="*/ 0 w 2421934"/>
              <a:gd name="connsiteY5" fmla="*/ 62837 h 2635529"/>
              <a:gd name="connsiteX0" fmla="*/ 0 w 2421934"/>
              <a:gd name="connsiteY0" fmla="*/ 62837 h 3007832"/>
              <a:gd name="connsiteX1" fmla="*/ 1562463 w 2421934"/>
              <a:gd name="connsiteY1" fmla="*/ 71844 h 3007832"/>
              <a:gd name="connsiteX2" fmla="*/ 1800912 w 2421934"/>
              <a:gd name="connsiteY2" fmla="*/ 0 h 3007832"/>
              <a:gd name="connsiteX3" fmla="*/ 2421934 w 2421934"/>
              <a:gd name="connsiteY3" fmla="*/ 1910315 h 3007832"/>
              <a:gd name="connsiteX4" fmla="*/ 925983 w 2421934"/>
              <a:gd name="connsiteY4" fmla="*/ 3007832 h 3007832"/>
              <a:gd name="connsiteX5" fmla="*/ 0 w 2421934"/>
              <a:gd name="connsiteY5" fmla="*/ 62837 h 3007832"/>
              <a:gd name="connsiteX0" fmla="*/ 0 w 2421934"/>
              <a:gd name="connsiteY0" fmla="*/ 62837 h 2959570"/>
              <a:gd name="connsiteX1" fmla="*/ 1562463 w 2421934"/>
              <a:gd name="connsiteY1" fmla="*/ 71844 h 2959570"/>
              <a:gd name="connsiteX2" fmla="*/ 1800912 w 2421934"/>
              <a:gd name="connsiteY2" fmla="*/ 0 h 2959570"/>
              <a:gd name="connsiteX3" fmla="*/ 2421934 w 2421934"/>
              <a:gd name="connsiteY3" fmla="*/ 1910315 h 2959570"/>
              <a:gd name="connsiteX4" fmla="*/ 1022603 w 2421934"/>
              <a:gd name="connsiteY4" fmla="*/ 2959570 h 2959570"/>
              <a:gd name="connsiteX5" fmla="*/ 0 w 2421934"/>
              <a:gd name="connsiteY5" fmla="*/ 62837 h 2959570"/>
              <a:gd name="connsiteX0" fmla="*/ 0 w 2421934"/>
              <a:gd name="connsiteY0" fmla="*/ 62837 h 2959570"/>
              <a:gd name="connsiteX1" fmla="*/ 1562463 w 2421934"/>
              <a:gd name="connsiteY1" fmla="*/ 71844 h 2959570"/>
              <a:gd name="connsiteX2" fmla="*/ 1800912 w 2421934"/>
              <a:gd name="connsiteY2" fmla="*/ 0 h 2959570"/>
              <a:gd name="connsiteX3" fmla="*/ 2018492 w 2421934"/>
              <a:gd name="connsiteY3" fmla="*/ 691147 h 2959570"/>
              <a:gd name="connsiteX4" fmla="*/ 2421934 w 2421934"/>
              <a:gd name="connsiteY4" fmla="*/ 1910315 h 2959570"/>
              <a:gd name="connsiteX5" fmla="*/ 1022603 w 2421934"/>
              <a:gd name="connsiteY5" fmla="*/ 2959570 h 2959570"/>
              <a:gd name="connsiteX6" fmla="*/ 0 w 2421934"/>
              <a:gd name="connsiteY6" fmla="*/ 62837 h 2959570"/>
              <a:gd name="connsiteX0" fmla="*/ 0 w 2421934"/>
              <a:gd name="connsiteY0" fmla="*/ 62837 h 2959570"/>
              <a:gd name="connsiteX1" fmla="*/ 1562463 w 2421934"/>
              <a:gd name="connsiteY1" fmla="*/ 71844 h 2959570"/>
              <a:gd name="connsiteX2" fmla="*/ 1800912 w 2421934"/>
              <a:gd name="connsiteY2" fmla="*/ 0 h 2959570"/>
              <a:gd name="connsiteX3" fmla="*/ 2128916 w 2421934"/>
              <a:gd name="connsiteY3" fmla="*/ 608413 h 2959570"/>
              <a:gd name="connsiteX4" fmla="*/ 2421934 w 2421934"/>
              <a:gd name="connsiteY4" fmla="*/ 1910315 h 2959570"/>
              <a:gd name="connsiteX5" fmla="*/ 1022603 w 2421934"/>
              <a:gd name="connsiteY5" fmla="*/ 2959570 h 2959570"/>
              <a:gd name="connsiteX6" fmla="*/ 0 w 2421934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00912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00912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00912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00912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38871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38871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959570"/>
              <a:gd name="connsiteX1" fmla="*/ 1562463 w 2314961"/>
              <a:gd name="connsiteY1" fmla="*/ 71844 h 2959570"/>
              <a:gd name="connsiteX2" fmla="*/ 1838871 w 2314961"/>
              <a:gd name="connsiteY2" fmla="*/ 0 h 2959570"/>
              <a:gd name="connsiteX3" fmla="*/ 2128916 w 2314961"/>
              <a:gd name="connsiteY3" fmla="*/ 608413 h 2959570"/>
              <a:gd name="connsiteX4" fmla="*/ 2314961 w 2314961"/>
              <a:gd name="connsiteY4" fmla="*/ 1996496 h 2959570"/>
              <a:gd name="connsiteX5" fmla="*/ 1022603 w 2314961"/>
              <a:gd name="connsiteY5" fmla="*/ 2959570 h 2959570"/>
              <a:gd name="connsiteX6" fmla="*/ 0 w 2314961"/>
              <a:gd name="connsiteY6" fmla="*/ 62837 h 2959570"/>
              <a:gd name="connsiteX0" fmla="*/ 0 w 2314961"/>
              <a:gd name="connsiteY0" fmla="*/ 62837 h 2863047"/>
              <a:gd name="connsiteX1" fmla="*/ 1562463 w 2314961"/>
              <a:gd name="connsiteY1" fmla="*/ 71844 h 2863047"/>
              <a:gd name="connsiteX2" fmla="*/ 1838871 w 2314961"/>
              <a:gd name="connsiteY2" fmla="*/ 0 h 2863047"/>
              <a:gd name="connsiteX3" fmla="*/ 2128916 w 2314961"/>
              <a:gd name="connsiteY3" fmla="*/ 608413 h 2863047"/>
              <a:gd name="connsiteX4" fmla="*/ 2314961 w 2314961"/>
              <a:gd name="connsiteY4" fmla="*/ 1996496 h 2863047"/>
              <a:gd name="connsiteX5" fmla="*/ 1160633 w 2314961"/>
              <a:gd name="connsiteY5" fmla="*/ 2863047 h 2863047"/>
              <a:gd name="connsiteX6" fmla="*/ 0 w 2314961"/>
              <a:gd name="connsiteY6" fmla="*/ 62837 h 2863047"/>
              <a:gd name="connsiteX0" fmla="*/ 0 w 2314961"/>
              <a:gd name="connsiteY0" fmla="*/ 62837 h 2863047"/>
              <a:gd name="connsiteX1" fmla="*/ 1562463 w 2314961"/>
              <a:gd name="connsiteY1" fmla="*/ 71844 h 2863047"/>
              <a:gd name="connsiteX2" fmla="*/ 1838871 w 2314961"/>
              <a:gd name="connsiteY2" fmla="*/ 0 h 2863047"/>
              <a:gd name="connsiteX3" fmla="*/ 2128916 w 2314961"/>
              <a:gd name="connsiteY3" fmla="*/ 608413 h 2863047"/>
              <a:gd name="connsiteX4" fmla="*/ 2314961 w 2314961"/>
              <a:gd name="connsiteY4" fmla="*/ 1996496 h 2863047"/>
              <a:gd name="connsiteX5" fmla="*/ 1160633 w 2314961"/>
              <a:gd name="connsiteY5" fmla="*/ 2863047 h 2863047"/>
              <a:gd name="connsiteX6" fmla="*/ 0 w 2314961"/>
              <a:gd name="connsiteY6" fmla="*/ 62837 h 2863047"/>
              <a:gd name="connsiteX0" fmla="*/ 0 w 2314961"/>
              <a:gd name="connsiteY0" fmla="*/ 62837 h 2863047"/>
              <a:gd name="connsiteX1" fmla="*/ 1562463 w 2314961"/>
              <a:gd name="connsiteY1" fmla="*/ 71844 h 2863047"/>
              <a:gd name="connsiteX2" fmla="*/ 1838871 w 2314961"/>
              <a:gd name="connsiteY2" fmla="*/ 0 h 2863047"/>
              <a:gd name="connsiteX3" fmla="*/ 2128916 w 2314961"/>
              <a:gd name="connsiteY3" fmla="*/ 608413 h 2863047"/>
              <a:gd name="connsiteX4" fmla="*/ 2314961 w 2314961"/>
              <a:gd name="connsiteY4" fmla="*/ 1996496 h 2863047"/>
              <a:gd name="connsiteX5" fmla="*/ 1160633 w 2314961"/>
              <a:gd name="connsiteY5" fmla="*/ 2863047 h 2863047"/>
              <a:gd name="connsiteX6" fmla="*/ 0 w 2314961"/>
              <a:gd name="connsiteY6" fmla="*/ 62837 h 2863047"/>
              <a:gd name="connsiteX0" fmla="*/ 0 w 2314961"/>
              <a:gd name="connsiteY0" fmla="*/ 62837 h 2763766"/>
              <a:gd name="connsiteX1" fmla="*/ 1562463 w 2314961"/>
              <a:gd name="connsiteY1" fmla="*/ 71844 h 2763766"/>
              <a:gd name="connsiteX2" fmla="*/ 1838871 w 2314961"/>
              <a:gd name="connsiteY2" fmla="*/ 0 h 2763766"/>
              <a:gd name="connsiteX3" fmla="*/ 2128916 w 2314961"/>
              <a:gd name="connsiteY3" fmla="*/ 608413 h 2763766"/>
              <a:gd name="connsiteX4" fmla="*/ 2314961 w 2314961"/>
              <a:gd name="connsiteY4" fmla="*/ 1996496 h 2763766"/>
              <a:gd name="connsiteX5" fmla="*/ 1293142 w 2314961"/>
              <a:gd name="connsiteY5" fmla="*/ 2763766 h 2763766"/>
              <a:gd name="connsiteX6" fmla="*/ 0 w 2314961"/>
              <a:gd name="connsiteY6" fmla="*/ 62837 h 2763766"/>
              <a:gd name="connsiteX0" fmla="*/ 0 w 2314961"/>
              <a:gd name="connsiteY0" fmla="*/ 62837 h 2763766"/>
              <a:gd name="connsiteX1" fmla="*/ 1562463 w 2314961"/>
              <a:gd name="connsiteY1" fmla="*/ 71844 h 2763766"/>
              <a:gd name="connsiteX2" fmla="*/ 1838871 w 2314961"/>
              <a:gd name="connsiteY2" fmla="*/ 0 h 2763766"/>
              <a:gd name="connsiteX3" fmla="*/ 2128916 w 2314961"/>
              <a:gd name="connsiteY3" fmla="*/ 608413 h 2763766"/>
              <a:gd name="connsiteX4" fmla="*/ 2314961 w 2314961"/>
              <a:gd name="connsiteY4" fmla="*/ 1996496 h 2763766"/>
              <a:gd name="connsiteX5" fmla="*/ 1293142 w 2314961"/>
              <a:gd name="connsiteY5" fmla="*/ 2763766 h 2763766"/>
              <a:gd name="connsiteX6" fmla="*/ 0 w 2314961"/>
              <a:gd name="connsiteY6" fmla="*/ 62837 h 2763766"/>
              <a:gd name="connsiteX0" fmla="*/ 0 w 2314961"/>
              <a:gd name="connsiteY0" fmla="*/ 62837 h 2763766"/>
              <a:gd name="connsiteX1" fmla="*/ 1562463 w 2314961"/>
              <a:gd name="connsiteY1" fmla="*/ 71844 h 2763766"/>
              <a:gd name="connsiteX2" fmla="*/ 1838871 w 2314961"/>
              <a:gd name="connsiteY2" fmla="*/ 0 h 2763766"/>
              <a:gd name="connsiteX3" fmla="*/ 2128916 w 2314961"/>
              <a:gd name="connsiteY3" fmla="*/ 608413 h 2763766"/>
              <a:gd name="connsiteX4" fmla="*/ 2314961 w 2314961"/>
              <a:gd name="connsiteY4" fmla="*/ 1996496 h 2763766"/>
              <a:gd name="connsiteX5" fmla="*/ 1293142 w 2314961"/>
              <a:gd name="connsiteY5" fmla="*/ 2763766 h 2763766"/>
              <a:gd name="connsiteX6" fmla="*/ 0 w 2314961"/>
              <a:gd name="connsiteY6" fmla="*/ 62837 h 27637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314961" h="2763766">
                <a:moveTo>
                  <a:pt x="0" y="62837"/>
                </a:moveTo>
                <a:lnTo>
                  <a:pt x="1562463" y="71844"/>
                </a:lnTo>
                <a:cubicBezTo>
                  <a:pt x="1690257" y="29511"/>
                  <a:pt x="1718221" y="44397"/>
                  <a:pt x="1838871" y="0"/>
                </a:cubicBezTo>
                <a:cubicBezTo>
                  <a:pt x="1973511" y="202803"/>
                  <a:pt x="2032234" y="405609"/>
                  <a:pt x="2128916" y="608413"/>
                </a:cubicBezTo>
                <a:cubicBezTo>
                  <a:pt x="2204734" y="943560"/>
                  <a:pt x="2152874" y="1295942"/>
                  <a:pt x="2314961" y="1996496"/>
                </a:cubicBezTo>
                <a:lnTo>
                  <a:pt x="1293142" y="2763766"/>
                </a:lnTo>
                <a:cubicBezTo>
                  <a:pt x="946292" y="1889655"/>
                  <a:pt x="313722" y="1018302"/>
                  <a:pt x="0" y="62837"/>
                </a:cubicBezTo>
                <a:close/>
              </a:path>
            </a:pathLst>
          </a:custGeom>
          <a:solidFill>
            <a:schemeClr val="accent6">
              <a:lumMod val="50000"/>
              <a:alpha val="27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176" name="Freihandform 9">
            <a:extLst>
              <a:ext uri="{FF2B5EF4-FFF2-40B4-BE49-F238E27FC236}">
                <a16:creationId xmlns:a16="http://schemas.microsoft.com/office/drawing/2014/main" id="{C63764BA-760A-B1AD-0FB0-D5E8A6B75588}"/>
              </a:ext>
            </a:extLst>
          </p:cNvPr>
          <p:cNvSpPr/>
          <p:nvPr/>
        </p:nvSpPr>
        <p:spPr>
          <a:xfrm>
            <a:off x="4140274" y="2205193"/>
            <a:ext cx="1841107" cy="2893208"/>
          </a:xfrm>
          <a:custGeom>
            <a:avLst/>
            <a:gdLst>
              <a:gd name="connsiteX0" fmla="*/ 0 w 2200275"/>
              <a:gd name="connsiteY0" fmla="*/ 0 h 2638425"/>
              <a:gd name="connsiteX1" fmla="*/ 1485900 w 2200275"/>
              <a:gd name="connsiteY1" fmla="*/ 4762 h 2638425"/>
              <a:gd name="connsiteX2" fmla="*/ 2200275 w 2200275"/>
              <a:gd name="connsiteY2" fmla="*/ 2071687 h 2638425"/>
              <a:gd name="connsiteX3" fmla="*/ 1004888 w 2200275"/>
              <a:gd name="connsiteY3" fmla="*/ 2638425 h 2638425"/>
              <a:gd name="connsiteX4" fmla="*/ 0 w 2200275"/>
              <a:gd name="connsiteY4" fmla="*/ 0 h 2638425"/>
              <a:gd name="connsiteX0" fmla="*/ 0 w 2200275"/>
              <a:gd name="connsiteY0" fmla="*/ 0 h 2638425"/>
              <a:gd name="connsiteX1" fmla="*/ 395288 w 2200275"/>
              <a:gd name="connsiteY1" fmla="*/ 1746 h 2638425"/>
              <a:gd name="connsiteX2" fmla="*/ 1485900 w 2200275"/>
              <a:gd name="connsiteY2" fmla="*/ 4762 h 2638425"/>
              <a:gd name="connsiteX3" fmla="*/ 2200275 w 2200275"/>
              <a:gd name="connsiteY3" fmla="*/ 2071687 h 2638425"/>
              <a:gd name="connsiteX4" fmla="*/ 1004888 w 2200275"/>
              <a:gd name="connsiteY4" fmla="*/ 2638425 h 2638425"/>
              <a:gd name="connsiteX5" fmla="*/ 0 w 2200275"/>
              <a:gd name="connsiteY5" fmla="*/ 0 h 2638425"/>
              <a:gd name="connsiteX0" fmla="*/ 0 w 2200275"/>
              <a:gd name="connsiteY0" fmla="*/ 0 h 2638425"/>
              <a:gd name="connsiteX1" fmla="*/ 361951 w 2200275"/>
              <a:gd name="connsiteY1" fmla="*/ 101758 h 2638425"/>
              <a:gd name="connsiteX2" fmla="*/ 1485900 w 2200275"/>
              <a:gd name="connsiteY2" fmla="*/ 4762 h 2638425"/>
              <a:gd name="connsiteX3" fmla="*/ 2200275 w 2200275"/>
              <a:gd name="connsiteY3" fmla="*/ 2071687 h 2638425"/>
              <a:gd name="connsiteX4" fmla="*/ 1004888 w 2200275"/>
              <a:gd name="connsiteY4" fmla="*/ 2638425 h 2638425"/>
              <a:gd name="connsiteX5" fmla="*/ 0 w 2200275"/>
              <a:gd name="connsiteY5" fmla="*/ 0 h 2638425"/>
              <a:gd name="connsiteX0" fmla="*/ 0 w 2200275"/>
              <a:gd name="connsiteY0" fmla="*/ 0 h 2638425"/>
              <a:gd name="connsiteX1" fmla="*/ 361951 w 2200275"/>
              <a:gd name="connsiteY1" fmla="*/ 101758 h 2638425"/>
              <a:gd name="connsiteX2" fmla="*/ 1485900 w 2200275"/>
              <a:gd name="connsiteY2" fmla="*/ 4762 h 2638425"/>
              <a:gd name="connsiteX3" fmla="*/ 2200275 w 2200275"/>
              <a:gd name="connsiteY3" fmla="*/ 2071687 h 2638425"/>
              <a:gd name="connsiteX4" fmla="*/ 1004888 w 2200275"/>
              <a:gd name="connsiteY4" fmla="*/ 2638425 h 2638425"/>
              <a:gd name="connsiteX5" fmla="*/ 0 w 2200275"/>
              <a:gd name="connsiteY5" fmla="*/ 0 h 2638425"/>
              <a:gd name="connsiteX0" fmla="*/ 0 w 2200275"/>
              <a:gd name="connsiteY0" fmla="*/ 9477 h 2647902"/>
              <a:gd name="connsiteX1" fmla="*/ 361951 w 2200275"/>
              <a:gd name="connsiteY1" fmla="*/ 111235 h 2647902"/>
              <a:gd name="connsiteX2" fmla="*/ 1485900 w 2200275"/>
              <a:gd name="connsiteY2" fmla="*/ 14239 h 2647902"/>
              <a:gd name="connsiteX3" fmla="*/ 2200275 w 2200275"/>
              <a:gd name="connsiteY3" fmla="*/ 2081164 h 2647902"/>
              <a:gd name="connsiteX4" fmla="*/ 1004888 w 2200275"/>
              <a:gd name="connsiteY4" fmla="*/ 2647902 h 2647902"/>
              <a:gd name="connsiteX5" fmla="*/ 0 w 2200275"/>
              <a:gd name="connsiteY5" fmla="*/ 9477 h 2647902"/>
              <a:gd name="connsiteX0" fmla="*/ 0 w 2200275"/>
              <a:gd name="connsiteY0" fmla="*/ 4665 h 2643090"/>
              <a:gd name="connsiteX1" fmla="*/ 361951 w 2200275"/>
              <a:gd name="connsiteY1" fmla="*/ 106423 h 2643090"/>
              <a:gd name="connsiteX2" fmla="*/ 1485900 w 2200275"/>
              <a:gd name="connsiteY2" fmla="*/ 9427 h 2643090"/>
              <a:gd name="connsiteX3" fmla="*/ 2200275 w 2200275"/>
              <a:gd name="connsiteY3" fmla="*/ 2076352 h 2643090"/>
              <a:gd name="connsiteX4" fmla="*/ 1004888 w 2200275"/>
              <a:gd name="connsiteY4" fmla="*/ 2643090 h 2643090"/>
              <a:gd name="connsiteX5" fmla="*/ 0 w 2200275"/>
              <a:gd name="connsiteY5" fmla="*/ 4665 h 2643090"/>
              <a:gd name="connsiteX0" fmla="*/ 0 w 2200275"/>
              <a:gd name="connsiteY0" fmla="*/ 4665 h 2643090"/>
              <a:gd name="connsiteX1" fmla="*/ 361951 w 2200275"/>
              <a:gd name="connsiteY1" fmla="*/ 106423 h 2643090"/>
              <a:gd name="connsiteX2" fmla="*/ 1485900 w 2200275"/>
              <a:gd name="connsiteY2" fmla="*/ 9427 h 2643090"/>
              <a:gd name="connsiteX3" fmla="*/ 2200275 w 2200275"/>
              <a:gd name="connsiteY3" fmla="*/ 2076352 h 2643090"/>
              <a:gd name="connsiteX4" fmla="*/ 1004888 w 2200275"/>
              <a:gd name="connsiteY4" fmla="*/ 2643090 h 2643090"/>
              <a:gd name="connsiteX5" fmla="*/ 0 w 2200275"/>
              <a:gd name="connsiteY5" fmla="*/ 4665 h 2643090"/>
              <a:gd name="connsiteX0" fmla="*/ 0 w 2205038"/>
              <a:gd name="connsiteY0" fmla="*/ 0 h 2652713"/>
              <a:gd name="connsiteX1" fmla="*/ 366714 w 2205038"/>
              <a:gd name="connsiteY1" fmla="*/ 116046 h 2652713"/>
              <a:gd name="connsiteX2" fmla="*/ 1490663 w 2205038"/>
              <a:gd name="connsiteY2" fmla="*/ 19050 h 2652713"/>
              <a:gd name="connsiteX3" fmla="*/ 2205038 w 2205038"/>
              <a:gd name="connsiteY3" fmla="*/ 2085975 h 2652713"/>
              <a:gd name="connsiteX4" fmla="*/ 1009651 w 2205038"/>
              <a:gd name="connsiteY4" fmla="*/ 2652713 h 2652713"/>
              <a:gd name="connsiteX5" fmla="*/ 0 w 2205038"/>
              <a:gd name="connsiteY5" fmla="*/ 0 h 2652713"/>
              <a:gd name="connsiteX0" fmla="*/ 0 w 2205038"/>
              <a:gd name="connsiteY0" fmla="*/ 0 h 2652713"/>
              <a:gd name="connsiteX1" fmla="*/ 366714 w 2205038"/>
              <a:gd name="connsiteY1" fmla="*/ 116046 h 2652713"/>
              <a:gd name="connsiteX2" fmla="*/ 1490663 w 2205038"/>
              <a:gd name="connsiteY2" fmla="*/ 19050 h 2652713"/>
              <a:gd name="connsiteX3" fmla="*/ 2205038 w 2205038"/>
              <a:gd name="connsiteY3" fmla="*/ 2085975 h 2652713"/>
              <a:gd name="connsiteX4" fmla="*/ 1009651 w 2205038"/>
              <a:gd name="connsiteY4" fmla="*/ 2652713 h 2652713"/>
              <a:gd name="connsiteX5" fmla="*/ 0 w 2205038"/>
              <a:gd name="connsiteY5" fmla="*/ 0 h 2652713"/>
              <a:gd name="connsiteX0" fmla="*/ 0 w 2197894"/>
              <a:gd name="connsiteY0" fmla="*/ 0 h 2652713"/>
              <a:gd name="connsiteX1" fmla="*/ 366714 w 2197894"/>
              <a:gd name="connsiteY1" fmla="*/ 116046 h 2652713"/>
              <a:gd name="connsiteX2" fmla="*/ 1490663 w 2197894"/>
              <a:gd name="connsiteY2" fmla="*/ 19050 h 2652713"/>
              <a:gd name="connsiteX3" fmla="*/ 2197894 w 2197894"/>
              <a:gd name="connsiteY3" fmla="*/ 2088356 h 2652713"/>
              <a:gd name="connsiteX4" fmla="*/ 1009651 w 2197894"/>
              <a:gd name="connsiteY4" fmla="*/ 2652713 h 2652713"/>
              <a:gd name="connsiteX5" fmla="*/ 0 w 2197894"/>
              <a:gd name="connsiteY5" fmla="*/ 0 h 2652713"/>
              <a:gd name="connsiteX0" fmla="*/ 0 w 2197894"/>
              <a:gd name="connsiteY0" fmla="*/ 0 h 2652713"/>
              <a:gd name="connsiteX1" fmla="*/ 366714 w 2197894"/>
              <a:gd name="connsiteY1" fmla="*/ 116046 h 2652713"/>
              <a:gd name="connsiteX2" fmla="*/ 1483519 w 2197894"/>
              <a:gd name="connsiteY2" fmla="*/ 14287 h 2652713"/>
              <a:gd name="connsiteX3" fmla="*/ 2197894 w 2197894"/>
              <a:gd name="connsiteY3" fmla="*/ 2088356 h 2652713"/>
              <a:gd name="connsiteX4" fmla="*/ 1009651 w 2197894"/>
              <a:gd name="connsiteY4" fmla="*/ 2652713 h 2652713"/>
              <a:gd name="connsiteX5" fmla="*/ 0 w 2197894"/>
              <a:gd name="connsiteY5" fmla="*/ 0 h 2652713"/>
              <a:gd name="connsiteX0" fmla="*/ 0 w 2197894"/>
              <a:gd name="connsiteY0" fmla="*/ 0 h 2652713"/>
              <a:gd name="connsiteX1" fmla="*/ 366714 w 2197894"/>
              <a:gd name="connsiteY1" fmla="*/ 116046 h 2652713"/>
              <a:gd name="connsiteX2" fmla="*/ 1483519 w 2197894"/>
              <a:gd name="connsiteY2" fmla="*/ 14287 h 2652713"/>
              <a:gd name="connsiteX3" fmla="*/ 2197894 w 2197894"/>
              <a:gd name="connsiteY3" fmla="*/ 2088356 h 2652713"/>
              <a:gd name="connsiteX4" fmla="*/ 1009651 w 2197894"/>
              <a:gd name="connsiteY4" fmla="*/ 2652713 h 2652713"/>
              <a:gd name="connsiteX5" fmla="*/ 0 w 2197894"/>
              <a:gd name="connsiteY5" fmla="*/ 0 h 2652713"/>
              <a:gd name="connsiteX0" fmla="*/ 0 w 2197894"/>
              <a:gd name="connsiteY0" fmla="*/ 0 h 3186113"/>
              <a:gd name="connsiteX1" fmla="*/ 366714 w 2197894"/>
              <a:gd name="connsiteY1" fmla="*/ 116046 h 3186113"/>
              <a:gd name="connsiteX2" fmla="*/ 1483519 w 2197894"/>
              <a:gd name="connsiteY2" fmla="*/ 14287 h 3186113"/>
              <a:gd name="connsiteX3" fmla="*/ 2197894 w 2197894"/>
              <a:gd name="connsiteY3" fmla="*/ 2088356 h 3186113"/>
              <a:gd name="connsiteX4" fmla="*/ 1228726 w 2197894"/>
              <a:gd name="connsiteY4" fmla="*/ 3186113 h 3186113"/>
              <a:gd name="connsiteX5" fmla="*/ 0 w 2197894"/>
              <a:gd name="connsiteY5" fmla="*/ 0 h 3186113"/>
              <a:gd name="connsiteX0" fmla="*/ 0 w 2259807"/>
              <a:gd name="connsiteY0" fmla="*/ 0 h 3186113"/>
              <a:gd name="connsiteX1" fmla="*/ 366714 w 2259807"/>
              <a:gd name="connsiteY1" fmla="*/ 116046 h 3186113"/>
              <a:gd name="connsiteX2" fmla="*/ 1483519 w 2259807"/>
              <a:gd name="connsiteY2" fmla="*/ 14287 h 3186113"/>
              <a:gd name="connsiteX3" fmla="*/ 2259807 w 2259807"/>
              <a:gd name="connsiteY3" fmla="*/ 2278856 h 3186113"/>
              <a:gd name="connsiteX4" fmla="*/ 1228726 w 2259807"/>
              <a:gd name="connsiteY4" fmla="*/ 3186113 h 3186113"/>
              <a:gd name="connsiteX5" fmla="*/ 0 w 2259807"/>
              <a:gd name="connsiteY5" fmla="*/ 0 h 3186113"/>
              <a:gd name="connsiteX0" fmla="*/ 0 w 2259807"/>
              <a:gd name="connsiteY0" fmla="*/ 3644 h 3189757"/>
              <a:gd name="connsiteX1" fmla="*/ 366714 w 2259807"/>
              <a:gd name="connsiteY1" fmla="*/ 119690 h 3189757"/>
              <a:gd name="connsiteX2" fmla="*/ 1097037 w 2259807"/>
              <a:gd name="connsiteY2" fmla="*/ 4142 h 3189757"/>
              <a:gd name="connsiteX3" fmla="*/ 2259807 w 2259807"/>
              <a:gd name="connsiteY3" fmla="*/ 2282500 h 3189757"/>
              <a:gd name="connsiteX4" fmla="*/ 1228726 w 2259807"/>
              <a:gd name="connsiteY4" fmla="*/ 3189757 h 3189757"/>
              <a:gd name="connsiteX5" fmla="*/ 0 w 2259807"/>
              <a:gd name="connsiteY5" fmla="*/ 3644 h 3189757"/>
              <a:gd name="connsiteX0" fmla="*/ 0 w 1907832"/>
              <a:gd name="connsiteY0" fmla="*/ 3644 h 3189757"/>
              <a:gd name="connsiteX1" fmla="*/ 366714 w 1907832"/>
              <a:gd name="connsiteY1" fmla="*/ 119690 h 3189757"/>
              <a:gd name="connsiteX2" fmla="*/ 1097037 w 1907832"/>
              <a:gd name="connsiteY2" fmla="*/ 4142 h 3189757"/>
              <a:gd name="connsiteX3" fmla="*/ 1907832 w 1907832"/>
              <a:gd name="connsiteY3" fmla="*/ 2599648 h 3189757"/>
              <a:gd name="connsiteX4" fmla="*/ 1228726 w 1907832"/>
              <a:gd name="connsiteY4" fmla="*/ 3189757 h 3189757"/>
              <a:gd name="connsiteX5" fmla="*/ 0 w 1907832"/>
              <a:gd name="connsiteY5" fmla="*/ 3644 h 3189757"/>
              <a:gd name="connsiteX0" fmla="*/ 0 w 1907832"/>
              <a:gd name="connsiteY0" fmla="*/ 3644 h 3189757"/>
              <a:gd name="connsiteX1" fmla="*/ 366714 w 1907832"/>
              <a:gd name="connsiteY1" fmla="*/ 119690 h 3189757"/>
              <a:gd name="connsiteX2" fmla="*/ 1014219 w 1907832"/>
              <a:gd name="connsiteY2" fmla="*/ 4142 h 3189757"/>
              <a:gd name="connsiteX3" fmla="*/ 1907832 w 1907832"/>
              <a:gd name="connsiteY3" fmla="*/ 2599648 h 3189757"/>
              <a:gd name="connsiteX4" fmla="*/ 1228726 w 1907832"/>
              <a:gd name="connsiteY4" fmla="*/ 3189757 h 3189757"/>
              <a:gd name="connsiteX5" fmla="*/ 0 w 1907832"/>
              <a:gd name="connsiteY5" fmla="*/ 3644 h 3189757"/>
              <a:gd name="connsiteX0" fmla="*/ 0 w 1769802"/>
              <a:gd name="connsiteY0" fmla="*/ 3644 h 3189757"/>
              <a:gd name="connsiteX1" fmla="*/ 366714 w 1769802"/>
              <a:gd name="connsiteY1" fmla="*/ 119690 h 3189757"/>
              <a:gd name="connsiteX2" fmla="*/ 1014219 w 1769802"/>
              <a:gd name="connsiteY2" fmla="*/ 4142 h 3189757"/>
              <a:gd name="connsiteX3" fmla="*/ 1769802 w 1769802"/>
              <a:gd name="connsiteY3" fmla="*/ 2709960 h 3189757"/>
              <a:gd name="connsiteX4" fmla="*/ 1228726 w 1769802"/>
              <a:gd name="connsiteY4" fmla="*/ 3189757 h 3189757"/>
              <a:gd name="connsiteX5" fmla="*/ 0 w 1769802"/>
              <a:gd name="connsiteY5" fmla="*/ 3644 h 3189757"/>
              <a:gd name="connsiteX0" fmla="*/ 0 w 1852620"/>
              <a:gd name="connsiteY0" fmla="*/ 3644 h 3189757"/>
              <a:gd name="connsiteX1" fmla="*/ 366714 w 1852620"/>
              <a:gd name="connsiteY1" fmla="*/ 119690 h 3189757"/>
              <a:gd name="connsiteX2" fmla="*/ 1014219 w 1852620"/>
              <a:gd name="connsiteY2" fmla="*/ 4142 h 3189757"/>
              <a:gd name="connsiteX3" fmla="*/ 1852620 w 1852620"/>
              <a:gd name="connsiteY3" fmla="*/ 2641015 h 3189757"/>
              <a:gd name="connsiteX4" fmla="*/ 1228726 w 1852620"/>
              <a:gd name="connsiteY4" fmla="*/ 3189757 h 3189757"/>
              <a:gd name="connsiteX5" fmla="*/ 0 w 1852620"/>
              <a:gd name="connsiteY5" fmla="*/ 3644 h 3189757"/>
              <a:gd name="connsiteX0" fmla="*/ 0 w 1928536"/>
              <a:gd name="connsiteY0" fmla="*/ 3644 h 3189757"/>
              <a:gd name="connsiteX1" fmla="*/ 366714 w 1928536"/>
              <a:gd name="connsiteY1" fmla="*/ 119690 h 3189757"/>
              <a:gd name="connsiteX2" fmla="*/ 1014219 w 1928536"/>
              <a:gd name="connsiteY2" fmla="*/ 4142 h 3189757"/>
              <a:gd name="connsiteX3" fmla="*/ 1928536 w 1928536"/>
              <a:gd name="connsiteY3" fmla="*/ 2599648 h 3189757"/>
              <a:gd name="connsiteX4" fmla="*/ 1228726 w 1928536"/>
              <a:gd name="connsiteY4" fmla="*/ 3189757 h 3189757"/>
              <a:gd name="connsiteX5" fmla="*/ 0 w 1928536"/>
              <a:gd name="connsiteY5" fmla="*/ 3644 h 3189757"/>
              <a:gd name="connsiteX0" fmla="*/ 0 w 1990649"/>
              <a:gd name="connsiteY0" fmla="*/ 3644 h 3189757"/>
              <a:gd name="connsiteX1" fmla="*/ 366714 w 1990649"/>
              <a:gd name="connsiteY1" fmla="*/ 119690 h 3189757"/>
              <a:gd name="connsiteX2" fmla="*/ 1014219 w 1990649"/>
              <a:gd name="connsiteY2" fmla="*/ 4142 h 3189757"/>
              <a:gd name="connsiteX3" fmla="*/ 1990649 w 1990649"/>
              <a:gd name="connsiteY3" fmla="*/ 2551387 h 3189757"/>
              <a:gd name="connsiteX4" fmla="*/ 1228726 w 1990649"/>
              <a:gd name="connsiteY4" fmla="*/ 3189757 h 3189757"/>
              <a:gd name="connsiteX5" fmla="*/ 0 w 1990649"/>
              <a:gd name="connsiteY5" fmla="*/ 3644 h 3189757"/>
              <a:gd name="connsiteX0" fmla="*/ 0 w 1990649"/>
              <a:gd name="connsiteY0" fmla="*/ 3644 h 3306963"/>
              <a:gd name="connsiteX1" fmla="*/ 366714 w 1990649"/>
              <a:gd name="connsiteY1" fmla="*/ 119690 h 3306963"/>
              <a:gd name="connsiteX2" fmla="*/ 1014219 w 1990649"/>
              <a:gd name="connsiteY2" fmla="*/ 4142 h 3306963"/>
              <a:gd name="connsiteX3" fmla="*/ 1990649 w 1990649"/>
              <a:gd name="connsiteY3" fmla="*/ 2551387 h 3306963"/>
              <a:gd name="connsiteX4" fmla="*/ 1125205 w 1990649"/>
              <a:gd name="connsiteY4" fmla="*/ 3306963 h 3306963"/>
              <a:gd name="connsiteX5" fmla="*/ 0 w 1990649"/>
              <a:gd name="connsiteY5" fmla="*/ 3644 h 3306963"/>
              <a:gd name="connsiteX0" fmla="*/ 0 w 2025157"/>
              <a:gd name="connsiteY0" fmla="*/ 0 h 3310214"/>
              <a:gd name="connsiteX1" fmla="*/ 401222 w 2025157"/>
              <a:gd name="connsiteY1" fmla="*/ 122941 h 3310214"/>
              <a:gd name="connsiteX2" fmla="*/ 1048727 w 2025157"/>
              <a:gd name="connsiteY2" fmla="*/ 7393 h 3310214"/>
              <a:gd name="connsiteX3" fmla="*/ 2025157 w 2025157"/>
              <a:gd name="connsiteY3" fmla="*/ 2554638 h 3310214"/>
              <a:gd name="connsiteX4" fmla="*/ 1159713 w 2025157"/>
              <a:gd name="connsiteY4" fmla="*/ 3310214 h 3310214"/>
              <a:gd name="connsiteX5" fmla="*/ 0 w 2025157"/>
              <a:gd name="connsiteY5" fmla="*/ 0 h 3310214"/>
              <a:gd name="connsiteX0" fmla="*/ 0 w 2025157"/>
              <a:gd name="connsiteY0" fmla="*/ 0 h 3310214"/>
              <a:gd name="connsiteX1" fmla="*/ 401222 w 2025157"/>
              <a:gd name="connsiteY1" fmla="*/ 122941 h 3310214"/>
              <a:gd name="connsiteX2" fmla="*/ 1048727 w 2025157"/>
              <a:gd name="connsiteY2" fmla="*/ 7393 h 3310214"/>
              <a:gd name="connsiteX3" fmla="*/ 2025157 w 2025157"/>
              <a:gd name="connsiteY3" fmla="*/ 2554638 h 3310214"/>
              <a:gd name="connsiteX4" fmla="*/ 1159713 w 2025157"/>
              <a:gd name="connsiteY4" fmla="*/ 3310214 h 3310214"/>
              <a:gd name="connsiteX5" fmla="*/ 0 w 2025157"/>
              <a:gd name="connsiteY5" fmla="*/ 0 h 3310214"/>
              <a:gd name="connsiteX0" fmla="*/ 0 w 2025157"/>
              <a:gd name="connsiteY0" fmla="*/ 0 h 3310214"/>
              <a:gd name="connsiteX1" fmla="*/ 401222 w 2025157"/>
              <a:gd name="connsiteY1" fmla="*/ 122941 h 3310214"/>
              <a:gd name="connsiteX2" fmla="*/ 1048727 w 2025157"/>
              <a:gd name="connsiteY2" fmla="*/ 7393 h 3310214"/>
              <a:gd name="connsiteX3" fmla="*/ 2025157 w 2025157"/>
              <a:gd name="connsiteY3" fmla="*/ 2554638 h 3310214"/>
              <a:gd name="connsiteX4" fmla="*/ 1159713 w 2025157"/>
              <a:gd name="connsiteY4" fmla="*/ 3310214 h 3310214"/>
              <a:gd name="connsiteX5" fmla="*/ 0 w 2025157"/>
              <a:gd name="connsiteY5" fmla="*/ 0 h 3310214"/>
              <a:gd name="connsiteX0" fmla="*/ 0 w 2025157"/>
              <a:gd name="connsiteY0" fmla="*/ 0 h 3310214"/>
              <a:gd name="connsiteX1" fmla="*/ 401222 w 2025157"/>
              <a:gd name="connsiteY1" fmla="*/ 122941 h 3310214"/>
              <a:gd name="connsiteX2" fmla="*/ 1048727 w 2025157"/>
              <a:gd name="connsiteY2" fmla="*/ 7393 h 3310214"/>
              <a:gd name="connsiteX3" fmla="*/ 2025157 w 2025157"/>
              <a:gd name="connsiteY3" fmla="*/ 2554638 h 3310214"/>
              <a:gd name="connsiteX4" fmla="*/ 1159713 w 2025157"/>
              <a:gd name="connsiteY4" fmla="*/ 3310214 h 3310214"/>
              <a:gd name="connsiteX5" fmla="*/ 0 w 2025157"/>
              <a:gd name="connsiteY5" fmla="*/ 0 h 3310214"/>
              <a:gd name="connsiteX0" fmla="*/ 0 w 2063116"/>
              <a:gd name="connsiteY0" fmla="*/ 0 h 3334345"/>
              <a:gd name="connsiteX1" fmla="*/ 439181 w 2063116"/>
              <a:gd name="connsiteY1" fmla="*/ 147072 h 3334345"/>
              <a:gd name="connsiteX2" fmla="*/ 1086686 w 2063116"/>
              <a:gd name="connsiteY2" fmla="*/ 31524 h 3334345"/>
              <a:gd name="connsiteX3" fmla="*/ 2063116 w 2063116"/>
              <a:gd name="connsiteY3" fmla="*/ 2578769 h 3334345"/>
              <a:gd name="connsiteX4" fmla="*/ 1197672 w 2063116"/>
              <a:gd name="connsiteY4" fmla="*/ 3334345 h 3334345"/>
              <a:gd name="connsiteX5" fmla="*/ 0 w 2063116"/>
              <a:gd name="connsiteY5" fmla="*/ 0 h 3334345"/>
              <a:gd name="connsiteX0" fmla="*/ 0 w 1956144"/>
              <a:gd name="connsiteY0" fmla="*/ 0 h 3334345"/>
              <a:gd name="connsiteX1" fmla="*/ 439181 w 1956144"/>
              <a:gd name="connsiteY1" fmla="*/ 147072 h 3334345"/>
              <a:gd name="connsiteX2" fmla="*/ 1086686 w 1956144"/>
              <a:gd name="connsiteY2" fmla="*/ 31524 h 3334345"/>
              <a:gd name="connsiteX3" fmla="*/ 1956144 w 1956144"/>
              <a:gd name="connsiteY3" fmla="*/ 2675292 h 3334345"/>
              <a:gd name="connsiteX4" fmla="*/ 1197672 w 1956144"/>
              <a:gd name="connsiteY4" fmla="*/ 3334345 h 3334345"/>
              <a:gd name="connsiteX5" fmla="*/ 0 w 1956144"/>
              <a:gd name="connsiteY5" fmla="*/ 0 h 3334345"/>
              <a:gd name="connsiteX0" fmla="*/ 0 w 1956144"/>
              <a:gd name="connsiteY0" fmla="*/ 0 h 3334345"/>
              <a:gd name="connsiteX1" fmla="*/ 439181 w 1956144"/>
              <a:gd name="connsiteY1" fmla="*/ 147072 h 3334345"/>
              <a:gd name="connsiteX2" fmla="*/ 1021121 w 1956144"/>
              <a:gd name="connsiteY2" fmla="*/ 34973 h 3334345"/>
              <a:gd name="connsiteX3" fmla="*/ 1956144 w 1956144"/>
              <a:gd name="connsiteY3" fmla="*/ 2675292 h 3334345"/>
              <a:gd name="connsiteX4" fmla="*/ 1197672 w 1956144"/>
              <a:gd name="connsiteY4" fmla="*/ 3334345 h 3334345"/>
              <a:gd name="connsiteX5" fmla="*/ 0 w 1956144"/>
              <a:gd name="connsiteY5" fmla="*/ 0 h 3334345"/>
              <a:gd name="connsiteX0" fmla="*/ 0 w 1963045"/>
              <a:gd name="connsiteY0" fmla="*/ 0 h 3334345"/>
              <a:gd name="connsiteX1" fmla="*/ 439181 w 1963045"/>
              <a:gd name="connsiteY1" fmla="*/ 147072 h 3334345"/>
              <a:gd name="connsiteX2" fmla="*/ 1021121 w 1963045"/>
              <a:gd name="connsiteY2" fmla="*/ 34973 h 3334345"/>
              <a:gd name="connsiteX3" fmla="*/ 1963045 w 1963045"/>
              <a:gd name="connsiteY3" fmla="*/ 2675292 h 3334345"/>
              <a:gd name="connsiteX4" fmla="*/ 1197672 w 1963045"/>
              <a:gd name="connsiteY4" fmla="*/ 3334345 h 3334345"/>
              <a:gd name="connsiteX5" fmla="*/ 0 w 1963045"/>
              <a:gd name="connsiteY5" fmla="*/ 0 h 3334345"/>
              <a:gd name="connsiteX0" fmla="*/ 0 w 1963045"/>
              <a:gd name="connsiteY0" fmla="*/ 0 h 3327450"/>
              <a:gd name="connsiteX1" fmla="*/ 439181 w 1963045"/>
              <a:gd name="connsiteY1" fmla="*/ 147072 h 3327450"/>
              <a:gd name="connsiteX2" fmla="*/ 1021121 w 1963045"/>
              <a:gd name="connsiteY2" fmla="*/ 34973 h 3327450"/>
              <a:gd name="connsiteX3" fmla="*/ 1963045 w 1963045"/>
              <a:gd name="connsiteY3" fmla="*/ 2675292 h 3327450"/>
              <a:gd name="connsiteX4" fmla="*/ 1194222 w 1963045"/>
              <a:gd name="connsiteY4" fmla="*/ 3327450 h 3327450"/>
              <a:gd name="connsiteX5" fmla="*/ 0 w 1963045"/>
              <a:gd name="connsiteY5" fmla="*/ 0 h 3327450"/>
              <a:gd name="connsiteX0" fmla="*/ 0 w 1938889"/>
              <a:gd name="connsiteY0" fmla="*/ 0 h 3327450"/>
              <a:gd name="connsiteX1" fmla="*/ 439181 w 1938889"/>
              <a:gd name="connsiteY1" fmla="*/ 147072 h 3327450"/>
              <a:gd name="connsiteX2" fmla="*/ 1021121 w 1938889"/>
              <a:gd name="connsiteY2" fmla="*/ 34973 h 3327450"/>
              <a:gd name="connsiteX3" fmla="*/ 1938889 w 1938889"/>
              <a:gd name="connsiteY3" fmla="*/ 2702870 h 3327450"/>
              <a:gd name="connsiteX4" fmla="*/ 1194222 w 1938889"/>
              <a:gd name="connsiteY4" fmla="*/ 3327450 h 3327450"/>
              <a:gd name="connsiteX5" fmla="*/ 0 w 1938889"/>
              <a:gd name="connsiteY5" fmla="*/ 0 h 3327450"/>
              <a:gd name="connsiteX0" fmla="*/ 0 w 1938889"/>
              <a:gd name="connsiteY0" fmla="*/ 0 h 3327450"/>
              <a:gd name="connsiteX1" fmla="*/ 397772 w 1938889"/>
              <a:gd name="connsiteY1" fmla="*/ 98810 h 3327450"/>
              <a:gd name="connsiteX2" fmla="*/ 1021121 w 1938889"/>
              <a:gd name="connsiteY2" fmla="*/ 34973 h 3327450"/>
              <a:gd name="connsiteX3" fmla="*/ 1938889 w 1938889"/>
              <a:gd name="connsiteY3" fmla="*/ 2702870 h 3327450"/>
              <a:gd name="connsiteX4" fmla="*/ 1194222 w 1938889"/>
              <a:gd name="connsiteY4" fmla="*/ 3327450 h 3327450"/>
              <a:gd name="connsiteX5" fmla="*/ 0 w 1938889"/>
              <a:gd name="connsiteY5" fmla="*/ 0 h 3327450"/>
              <a:gd name="connsiteX0" fmla="*/ 0 w 1938889"/>
              <a:gd name="connsiteY0" fmla="*/ 0 h 3327450"/>
              <a:gd name="connsiteX1" fmla="*/ 397772 w 1938889"/>
              <a:gd name="connsiteY1" fmla="*/ 98810 h 3327450"/>
              <a:gd name="connsiteX2" fmla="*/ 1021121 w 1938889"/>
              <a:gd name="connsiteY2" fmla="*/ 34973 h 3327450"/>
              <a:gd name="connsiteX3" fmla="*/ 1938889 w 1938889"/>
              <a:gd name="connsiteY3" fmla="*/ 2702870 h 3327450"/>
              <a:gd name="connsiteX4" fmla="*/ 1194222 w 1938889"/>
              <a:gd name="connsiteY4" fmla="*/ 3327450 h 3327450"/>
              <a:gd name="connsiteX5" fmla="*/ 0 w 1938889"/>
              <a:gd name="connsiteY5" fmla="*/ 0 h 3327450"/>
              <a:gd name="connsiteX0" fmla="*/ 0 w 1938889"/>
              <a:gd name="connsiteY0" fmla="*/ 0 h 3327450"/>
              <a:gd name="connsiteX1" fmla="*/ 397772 w 1938889"/>
              <a:gd name="connsiteY1" fmla="*/ 98810 h 3327450"/>
              <a:gd name="connsiteX2" fmla="*/ 1407604 w 1938889"/>
              <a:gd name="connsiteY2" fmla="*/ 34973 h 3327450"/>
              <a:gd name="connsiteX3" fmla="*/ 1938889 w 1938889"/>
              <a:gd name="connsiteY3" fmla="*/ 2702870 h 3327450"/>
              <a:gd name="connsiteX4" fmla="*/ 1194222 w 1938889"/>
              <a:gd name="connsiteY4" fmla="*/ 3327450 h 3327450"/>
              <a:gd name="connsiteX5" fmla="*/ 0 w 1938889"/>
              <a:gd name="connsiteY5" fmla="*/ 0 h 3327450"/>
              <a:gd name="connsiteX0" fmla="*/ 0 w 2097624"/>
              <a:gd name="connsiteY0" fmla="*/ 0 h 3327450"/>
              <a:gd name="connsiteX1" fmla="*/ 397772 w 2097624"/>
              <a:gd name="connsiteY1" fmla="*/ 98810 h 3327450"/>
              <a:gd name="connsiteX2" fmla="*/ 1407604 w 2097624"/>
              <a:gd name="connsiteY2" fmla="*/ 34973 h 3327450"/>
              <a:gd name="connsiteX3" fmla="*/ 2097624 w 2097624"/>
              <a:gd name="connsiteY3" fmla="*/ 2592558 h 3327450"/>
              <a:gd name="connsiteX4" fmla="*/ 1194222 w 2097624"/>
              <a:gd name="connsiteY4" fmla="*/ 3327450 h 3327450"/>
              <a:gd name="connsiteX5" fmla="*/ 0 w 2097624"/>
              <a:gd name="connsiteY5" fmla="*/ 0 h 3327450"/>
              <a:gd name="connsiteX0" fmla="*/ 0 w 2097624"/>
              <a:gd name="connsiteY0" fmla="*/ 0 h 3327450"/>
              <a:gd name="connsiteX1" fmla="*/ 397772 w 2097624"/>
              <a:gd name="connsiteY1" fmla="*/ 98810 h 3327450"/>
              <a:gd name="connsiteX2" fmla="*/ 710555 w 2097624"/>
              <a:gd name="connsiteY2" fmla="*/ 41868 h 3327450"/>
              <a:gd name="connsiteX3" fmla="*/ 2097624 w 2097624"/>
              <a:gd name="connsiteY3" fmla="*/ 2592558 h 3327450"/>
              <a:gd name="connsiteX4" fmla="*/ 1194222 w 2097624"/>
              <a:gd name="connsiteY4" fmla="*/ 3327450 h 3327450"/>
              <a:gd name="connsiteX5" fmla="*/ 0 w 2097624"/>
              <a:gd name="connsiteY5" fmla="*/ 0 h 3327450"/>
              <a:gd name="connsiteX0" fmla="*/ 0 w 1628323"/>
              <a:gd name="connsiteY0" fmla="*/ 0 h 3327450"/>
              <a:gd name="connsiteX1" fmla="*/ 397772 w 1628323"/>
              <a:gd name="connsiteY1" fmla="*/ 98810 h 3327450"/>
              <a:gd name="connsiteX2" fmla="*/ 710555 w 1628323"/>
              <a:gd name="connsiteY2" fmla="*/ 41868 h 3327450"/>
              <a:gd name="connsiteX3" fmla="*/ 1628323 w 1628323"/>
              <a:gd name="connsiteY3" fmla="*/ 2978651 h 3327450"/>
              <a:gd name="connsiteX4" fmla="*/ 1194222 w 1628323"/>
              <a:gd name="connsiteY4" fmla="*/ 3327450 h 3327450"/>
              <a:gd name="connsiteX5" fmla="*/ 0 w 1628323"/>
              <a:gd name="connsiteY5" fmla="*/ 0 h 3327450"/>
              <a:gd name="connsiteX0" fmla="*/ 0 w 1635225"/>
              <a:gd name="connsiteY0" fmla="*/ 0 h 3327450"/>
              <a:gd name="connsiteX1" fmla="*/ 404674 w 1635225"/>
              <a:gd name="connsiteY1" fmla="*/ 98810 h 3327450"/>
              <a:gd name="connsiteX2" fmla="*/ 717457 w 1635225"/>
              <a:gd name="connsiteY2" fmla="*/ 41868 h 3327450"/>
              <a:gd name="connsiteX3" fmla="*/ 1635225 w 1635225"/>
              <a:gd name="connsiteY3" fmla="*/ 2978651 h 3327450"/>
              <a:gd name="connsiteX4" fmla="*/ 1201124 w 1635225"/>
              <a:gd name="connsiteY4" fmla="*/ 3327450 h 3327450"/>
              <a:gd name="connsiteX5" fmla="*/ 0 w 1635225"/>
              <a:gd name="connsiteY5" fmla="*/ 0 h 3327450"/>
              <a:gd name="connsiteX0" fmla="*/ 0 w 1724944"/>
              <a:gd name="connsiteY0" fmla="*/ 0 h 3327450"/>
              <a:gd name="connsiteX1" fmla="*/ 404674 w 1724944"/>
              <a:gd name="connsiteY1" fmla="*/ 98810 h 3327450"/>
              <a:gd name="connsiteX2" fmla="*/ 717457 w 1724944"/>
              <a:gd name="connsiteY2" fmla="*/ 41868 h 3327450"/>
              <a:gd name="connsiteX3" fmla="*/ 1724944 w 1724944"/>
              <a:gd name="connsiteY3" fmla="*/ 2916601 h 3327450"/>
              <a:gd name="connsiteX4" fmla="*/ 1201124 w 1724944"/>
              <a:gd name="connsiteY4" fmla="*/ 3327450 h 3327450"/>
              <a:gd name="connsiteX5" fmla="*/ 0 w 1724944"/>
              <a:gd name="connsiteY5" fmla="*/ 0 h 3327450"/>
              <a:gd name="connsiteX0" fmla="*/ 0 w 1862974"/>
              <a:gd name="connsiteY0" fmla="*/ 0 h 3327450"/>
              <a:gd name="connsiteX1" fmla="*/ 404674 w 1862974"/>
              <a:gd name="connsiteY1" fmla="*/ 98810 h 3327450"/>
              <a:gd name="connsiteX2" fmla="*/ 717457 w 1862974"/>
              <a:gd name="connsiteY2" fmla="*/ 41868 h 3327450"/>
              <a:gd name="connsiteX3" fmla="*/ 1862974 w 1862974"/>
              <a:gd name="connsiteY3" fmla="*/ 2826972 h 3327450"/>
              <a:gd name="connsiteX4" fmla="*/ 1201124 w 1862974"/>
              <a:gd name="connsiteY4" fmla="*/ 3327450 h 3327450"/>
              <a:gd name="connsiteX5" fmla="*/ 0 w 1862974"/>
              <a:gd name="connsiteY5" fmla="*/ 0 h 3327450"/>
              <a:gd name="connsiteX0" fmla="*/ 0 w 1862974"/>
              <a:gd name="connsiteY0" fmla="*/ 0 h 3327450"/>
              <a:gd name="connsiteX1" fmla="*/ 404674 w 1862974"/>
              <a:gd name="connsiteY1" fmla="*/ 98810 h 3327450"/>
              <a:gd name="connsiteX2" fmla="*/ 717457 w 1862974"/>
              <a:gd name="connsiteY2" fmla="*/ 41868 h 3327450"/>
              <a:gd name="connsiteX3" fmla="*/ 1862974 w 1862974"/>
              <a:gd name="connsiteY3" fmla="*/ 2826972 h 3327450"/>
              <a:gd name="connsiteX4" fmla="*/ 1201124 w 1862974"/>
              <a:gd name="connsiteY4" fmla="*/ 3327450 h 3327450"/>
              <a:gd name="connsiteX5" fmla="*/ 0 w 1862974"/>
              <a:gd name="connsiteY5" fmla="*/ 0 h 3327450"/>
              <a:gd name="connsiteX0" fmla="*/ 0 w 1862974"/>
              <a:gd name="connsiteY0" fmla="*/ 0 h 3327450"/>
              <a:gd name="connsiteX1" fmla="*/ 404674 w 1862974"/>
              <a:gd name="connsiteY1" fmla="*/ 98810 h 3327450"/>
              <a:gd name="connsiteX2" fmla="*/ 717457 w 1862974"/>
              <a:gd name="connsiteY2" fmla="*/ 41868 h 3327450"/>
              <a:gd name="connsiteX3" fmla="*/ 1862974 w 1862974"/>
              <a:gd name="connsiteY3" fmla="*/ 2826972 h 3327450"/>
              <a:gd name="connsiteX4" fmla="*/ 1201124 w 1862974"/>
              <a:gd name="connsiteY4" fmla="*/ 3327450 h 3327450"/>
              <a:gd name="connsiteX5" fmla="*/ 0 w 1862974"/>
              <a:gd name="connsiteY5" fmla="*/ 0 h 3327450"/>
              <a:gd name="connsiteX0" fmla="*/ 0 w 1862974"/>
              <a:gd name="connsiteY0" fmla="*/ 0 h 3327450"/>
              <a:gd name="connsiteX1" fmla="*/ 404674 w 1862974"/>
              <a:gd name="connsiteY1" fmla="*/ 98810 h 3327450"/>
              <a:gd name="connsiteX2" fmla="*/ 717457 w 1862974"/>
              <a:gd name="connsiteY2" fmla="*/ 41868 h 3327450"/>
              <a:gd name="connsiteX3" fmla="*/ 1862974 w 1862974"/>
              <a:gd name="connsiteY3" fmla="*/ 2826972 h 3327450"/>
              <a:gd name="connsiteX4" fmla="*/ 1201124 w 1862974"/>
              <a:gd name="connsiteY4" fmla="*/ 3327450 h 3327450"/>
              <a:gd name="connsiteX5" fmla="*/ 0 w 1862974"/>
              <a:gd name="connsiteY5" fmla="*/ 0 h 3327450"/>
              <a:gd name="connsiteX0" fmla="*/ 0 w 1862974"/>
              <a:gd name="connsiteY0" fmla="*/ 0 h 3168877"/>
              <a:gd name="connsiteX1" fmla="*/ 404674 w 1862974"/>
              <a:gd name="connsiteY1" fmla="*/ 98810 h 3168877"/>
              <a:gd name="connsiteX2" fmla="*/ 717457 w 1862974"/>
              <a:gd name="connsiteY2" fmla="*/ 41868 h 3168877"/>
              <a:gd name="connsiteX3" fmla="*/ 1862974 w 1862974"/>
              <a:gd name="connsiteY3" fmla="*/ 2826972 h 3168877"/>
              <a:gd name="connsiteX4" fmla="*/ 1401268 w 1862974"/>
              <a:gd name="connsiteY4" fmla="*/ 3168877 h 3168877"/>
              <a:gd name="connsiteX5" fmla="*/ 0 w 1862974"/>
              <a:gd name="connsiteY5" fmla="*/ 0 h 3168877"/>
              <a:gd name="connsiteX0" fmla="*/ 0 w 1862974"/>
              <a:gd name="connsiteY0" fmla="*/ 0 h 3141299"/>
              <a:gd name="connsiteX1" fmla="*/ 404674 w 1862974"/>
              <a:gd name="connsiteY1" fmla="*/ 98810 h 3141299"/>
              <a:gd name="connsiteX2" fmla="*/ 717457 w 1862974"/>
              <a:gd name="connsiteY2" fmla="*/ 41868 h 3141299"/>
              <a:gd name="connsiteX3" fmla="*/ 1862974 w 1862974"/>
              <a:gd name="connsiteY3" fmla="*/ 2826972 h 3141299"/>
              <a:gd name="connsiteX4" fmla="*/ 1442677 w 1862974"/>
              <a:gd name="connsiteY4" fmla="*/ 3141299 h 3141299"/>
              <a:gd name="connsiteX5" fmla="*/ 0 w 1862974"/>
              <a:gd name="connsiteY5" fmla="*/ 0 h 3141299"/>
              <a:gd name="connsiteX0" fmla="*/ 0 w 1862974"/>
              <a:gd name="connsiteY0" fmla="*/ 0 h 3141299"/>
              <a:gd name="connsiteX1" fmla="*/ 404674 w 1862974"/>
              <a:gd name="connsiteY1" fmla="*/ 98810 h 3141299"/>
              <a:gd name="connsiteX2" fmla="*/ 717457 w 1862974"/>
              <a:gd name="connsiteY2" fmla="*/ 41868 h 3141299"/>
              <a:gd name="connsiteX3" fmla="*/ 1862974 w 1862974"/>
              <a:gd name="connsiteY3" fmla="*/ 2826972 h 3141299"/>
              <a:gd name="connsiteX4" fmla="*/ 1442677 w 1862974"/>
              <a:gd name="connsiteY4" fmla="*/ 3141299 h 3141299"/>
              <a:gd name="connsiteX5" fmla="*/ 0 w 1862974"/>
              <a:gd name="connsiteY5" fmla="*/ 0 h 3141299"/>
              <a:gd name="connsiteX0" fmla="*/ 0 w 1934749"/>
              <a:gd name="connsiteY0" fmla="*/ 0 h 3141299"/>
              <a:gd name="connsiteX1" fmla="*/ 404674 w 1934749"/>
              <a:gd name="connsiteY1" fmla="*/ 98810 h 3141299"/>
              <a:gd name="connsiteX2" fmla="*/ 717457 w 1934749"/>
              <a:gd name="connsiteY2" fmla="*/ 41868 h 3141299"/>
              <a:gd name="connsiteX3" fmla="*/ 1934749 w 1934749"/>
              <a:gd name="connsiteY3" fmla="*/ 2788362 h 3141299"/>
              <a:gd name="connsiteX4" fmla="*/ 1442677 w 1934749"/>
              <a:gd name="connsiteY4" fmla="*/ 3141299 h 3141299"/>
              <a:gd name="connsiteX5" fmla="*/ 0 w 1934749"/>
              <a:gd name="connsiteY5" fmla="*/ 0 h 3141299"/>
              <a:gd name="connsiteX0" fmla="*/ 0 w 2001003"/>
              <a:gd name="connsiteY0" fmla="*/ 0 h 3141299"/>
              <a:gd name="connsiteX1" fmla="*/ 404674 w 2001003"/>
              <a:gd name="connsiteY1" fmla="*/ 98810 h 3141299"/>
              <a:gd name="connsiteX2" fmla="*/ 717457 w 2001003"/>
              <a:gd name="connsiteY2" fmla="*/ 41868 h 3141299"/>
              <a:gd name="connsiteX3" fmla="*/ 2001003 w 2001003"/>
              <a:gd name="connsiteY3" fmla="*/ 2727691 h 3141299"/>
              <a:gd name="connsiteX4" fmla="*/ 1442677 w 2001003"/>
              <a:gd name="connsiteY4" fmla="*/ 3141299 h 3141299"/>
              <a:gd name="connsiteX5" fmla="*/ 0 w 2001003"/>
              <a:gd name="connsiteY5" fmla="*/ 0 h 3141299"/>
              <a:gd name="connsiteX0" fmla="*/ 0 w 2001003"/>
              <a:gd name="connsiteY0" fmla="*/ 0 h 3141299"/>
              <a:gd name="connsiteX1" fmla="*/ 404674 w 2001003"/>
              <a:gd name="connsiteY1" fmla="*/ 98810 h 3141299"/>
              <a:gd name="connsiteX2" fmla="*/ 717457 w 2001003"/>
              <a:gd name="connsiteY2" fmla="*/ 41868 h 3141299"/>
              <a:gd name="connsiteX3" fmla="*/ 2001003 w 2001003"/>
              <a:gd name="connsiteY3" fmla="*/ 2727691 h 3141299"/>
              <a:gd name="connsiteX4" fmla="*/ 1442677 w 2001003"/>
              <a:gd name="connsiteY4" fmla="*/ 3141299 h 3141299"/>
              <a:gd name="connsiteX5" fmla="*/ 0 w 2001003"/>
              <a:gd name="connsiteY5" fmla="*/ 0 h 3141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001003" h="3141299">
                <a:moveTo>
                  <a:pt x="0" y="0"/>
                </a:moveTo>
                <a:cubicBezTo>
                  <a:pt x="106363" y="48206"/>
                  <a:pt x="269736" y="83941"/>
                  <a:pt x="404674" y="98810"/>
                </a:cubicBezTo>
                <a:cubicBezTo>
                  <a:pt x="686699" y="25388"/>
                  <a:pt x="342564" y="77715"/>
                  <a:pt x="717457" y="41868"/>
                </a:cubicBezTo>
                <a:cubicBezTo>
                  <a:pt x="1009578" y="990919"/>
                  <a:pt x="1660573" y="1826901"/>
                  <a:pt x="2001003" y="2727691"/>
                </a:cubicBezTo>
                <a:lnTo>
                  <a:pt x="1442677" y="3141299"/>
                </a:lnTo>
                <a:cubicBezTo>
                  <a:pt x="1016408" y="2298429"/>
                  <a:pt x="336550" y="969731"/>
                  <a:pt x="0" y="0"/>
                </a:cubicBezTo>
                <a:close/>
              </a:path>
            </a:pathLst>
          </a:custGeom>
          <a:solidFill>
            <a:srgbClr val="E9DB47">
              <a:alpha val="61000"/>
            </a:srgbClr>
          </a:soli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173" name="Freihandform 7">
            <a:extLst>
              <a:ext uri="{FF2B5EF4-FFF2-40B4-BE49-F238E27FC236}">
                <a16:creationId xmlns:a16="http://schemas.microsoft.com/office/drawing/2014/main" id="{59BBD722-950E-4BB4-D145-1B754461E076}"/>
              </a:ext>
            </a:extLst>
          </p:cNvPr>
          <p:cNvSpPr/>
          <p:nvPr/>
        </p:nvSpPr>
        <p:spPr>
          <a:xfrm>
            <a:off x="3983158" y="2184611"/>
            <a:ext cx="1488893" cy="2966181"/>
          </a:xfrm>
          <a:custGeom>
            <a:avLst/>
            <a:gdLst>
              <a:gd name="connsiteX0" fmla="*/ 0 w 1243012"/>
              <a:gd name="connsiteY0" fmla="*/ 0 h 2719387"/>
              <a:gd name="connsiteX1" fmla="*/ 228600 w 1243012"/>
              <a:gd name="connsiteY1" fmla="*/ 0 h 2719387"/>
              <a:gd name="connsiteX2" fmla="*/ 1243012 w 1243012"/>
              <a:gd name="connsiteY2" fmla="*/ 2647950 h 2719387"/>
              <a:gd name="connsiteX3" fmla="*/ 1047750 w 1243012"/>
              <a:gd name="connsiteY3" fmla="*/ 2719387 h 2719387"/>
              <a:gd name="connsiteX4" fmla="*/ 0 w 1243012"/>
              <a:gd name="connsiteY4" fmla="*/ 0 h 2719387"/>
              <a:gd name="connsiteX0" fmla="*/ 0 w 1238249"/>
              <a:gd name="connsiteY0" fmla="*/ 0 h 2719387"/>
              <a:gd name="connsiteX1" fmla="*/ 228600 w 1238249"/>
              <a:gd name="connsiteY1" fmla="*/ 0 h 2719387"/>
              <a:gd name="connsiteX2" fmla="*/ 1238249 w 1238249"/>
              <a:gd name="connsiteY2" fmla="*/ 2633662 h 2719387"/>
              <a:gd name="connsiteX3" fmla="*/ 1047750 w 1238249"/>
              <a:gd name="connsiteY3" fmla="*/ 2719387 h 2719387"/>
              <a:gd name="connsiteX4" fmla="*/ 0 w 1238249"/>
              <a:gd name="connsiteY4" fmla="*/ 0 h 2719387"/>
              <a:gd name="connsiteX0" fmla="*/ 0 w 1262062"/>
              <a:gd name="connsiteY0" fmla="*/ 0 h 2790824"/>
              <a:gd name="connsiteX1" fmla="*/ 252413 w 1262062"/>
              <a:gd name="connsiteY1" fmla="*/ 71437 h 2790824"/>
              <a:gd name="connsiteX2" fmla="*/ 1262062 w 1262062"/>
              <a:gd name="connsiteY2" fmla="*/ 2705099 h 2790824"/>
              <a:gd name="connsiteX3" fmla="*/ 1071563 w 1262062"/>
              <a:gd name="connsiteY3" fmla="*/ 2790824 h 2790824"/>
              <a:gd name="connsiteX4" fmla="*/ 0 w 1262062"/>
              <a:gd name="connsiteY4" fmla="*/ 0 h 2790824"/>
              <a:gd name="connsiteX0" fmla="*/ 0 w 1228725"/>
              <a:gd name="connsiteY0" fmla="*/ 0 h 2795586"/>
              <a:gd name="connsiteX1" fmla="*/ 219076 w 1228725"/>
              <a:gd name="connsiteY1" fmla="*/ 76199 h 2795586"/>
              <a:gd name="connsiteX2" fmla="*/ 1228725 w 1228725"/>
              <a:gd name="connsiteY2" fmla="*/ 2709861 h 2795586"/>
              <a:gd name="connsiteX3" fmla="*/ 1038226 w 1228725"/>
              <a:gd name="connsiteY3" fmla="*/ 2795586 h 2795586"/>
              <a:gd name="connsiteX4" fmla="*/ 0 w 1228725"/>
              <a:gd name="connsiteY4" fmla="*/ 0 h 2795586"/>
              <a:gd name="connsiteX0" fmla="*/ 0 w 1233487"/>
              <a:gd name="connsiteY0" fmla="*/ 0 h 2795586"/>
              <a:gd name="connsiteX1" fmla="*/ 219076 w 1233487"/>
              <a:gd name="connsiteY1" fmla="*/ 76199 h 2795586"/>
              <a:gd name="connsiteX2" fmla="*/ 1233487 w 1233487"/>
              <a:gd name="connsiteY2" fmla="*/ 2728911 h 2795586"/>
              <a:gd name="connsiteX3" fmla="*/ 1038226 w 1233487"/>
              <a:gd name="connsiteY3" fmla="*/ 2795586 h 2795586"/>
              <a:gd name="connsiteX4" fmla="*/ 0 w 1233487"/>
              <a:gd name="connsiteY4" fmla="*/ 0 h 2795586"/>
              <a:gd name="connsiteX0" fmla="*/ 0 w 1238250"/>
              <a:gd name="connsiteY0" fmla="*/ 0 h 2795586"/>
              <a:gd name="connsiteX1" fmla="*/ 219076 w 1238250"/>
              <a:gd name="connsiteY1" fmla="*/ 76199 h 2795586"/>
              <a:gd name="connsiteX2" fmla="*/ 1238250 w 1238250"/>
              <a:gd name="connsiteY2" fmla="*/ 2733673 h 2795586"/>
              <a:gd name="connsiteX3" fmla="*/ 1038226 w 1238250"/>
              <a:gd name="connsiteY3" fmla="*/ 2795586 h 2795586"/>
              <a:gd name="connsiteX4" fmla="*/ 0 w 1238250"/>
              <a:gd name="connsiteY4" fmla="*/ 0 h 2795586"/>
              <a:gd name="connsiteX0" fmla="*/ 0 w 1290638"/>
              <a:gd name="connsiteY0" fmla="*/ 0 h 3448048"/>
              <a:gd name="connsiteX1" fmla="*/ 219076 w 1290638"/>
              <a:gd name="connsiteY1" fmla="*/ 76199 h 3448048"/>
              <a:gd name="connsiteX2" fmla="*/ 1238250 w 1290638"/>
              <a:gd name="connsiteY2" fmla="*/ 2733673 h 3448048"/>
              <a:gd name="connsiteX3" fmla="*/ 1290638 w 1290638"/>
              <a:gd name="connsiteY3" fmla="*/ 3448048 h 3448048"/>
              <a:gd name="connsiteX4" fmla="*/ 0 w 1290638"/>
              <a:gd name="connsiteY4" fmla="*/ 0 h 3448048"/>
              <a:gd name="connsiteX0" fmla="*/ 0 w 1452563"/>
              <a:gd name="connsiteY0" fmla="*/ 0 h 3448048"/>
              <a:gd name="connsiteX1" fmla="*/ 219076 w 1452563"/>
              <a:gd name="connsiteY1" fmla="*/ 76199 h 3448048"/>
              <a:gd name="connsiteX2" fmla="*/ 1452563 w 1452563"/>
              <a:gd name="connsiteY2" fmla="*/ 3281360 h 3448048"/>
              <a:gd name="connsiteX3" fmla="*/ 1290638 w 1452563"/>
              <a:gd name="connsiteY3" fmla="*/ 3448048 h 3448048"/>
              <a:gd name="connsiteX4" fmla="*/ 0 w 1452563"/>
              <a:gd name="connsiteY4" fmla="*/ 0 h 3448048"/>
              <a:gd name="connsiteX0" fmla="*/ 0 w 1507775"/>
              <a:gd name="connsiteY0" fmla="*/ 0 h 3448048"/>
              <a:gd name="connsiteX1" fmla="*/ 274288 w 1507775"/>
              <a:gd name="connsiteY1" fmla="*/ 76199 h 3448048"/>
              <a:gd name="connsiteX2" fmla="*/ 1507775 w 1507775"/>
              <a:gd name="connsiteY2" fmla="*/ 3281360 h 3448048"/>
              <a:gd name="connsiteX3" fmla="*/ 1345850 w 1507775"/>
              <a:gd name="connsiteY3" fmla="*/ 3448048 h 3448048"/>
              <a:gd name="connsiteX4" fmla="*/ 0 w 1507775"/>
              <a:gd name="connsiteY4" fmla="*/ 0 h 3448048"/>
              <a:gd name="connsiteX0" fmla="*/ 0 w 1507775"/>
              <a:gd name="connsiteY0" fmla="*/ 0 h 3448048"/>
              <a:gd name="connsiteX1" fmla="*/ 225979 w 1507775"/>
              <a:gd name="connsiteY1" fmla="*/ 48621 h 3448048"/>
              <a:gd name="connsiteX2" fmla="*/ 1507775 w 1507775"/>
              <a:gd name="connsiteY2" fmla="*/ 3281360 h 3448048"/>
              <a:gd name="connsiteX3" fmla="*/ 1345850 w 1507775"/>
              <a:gd name="connsiteY3" fmla="*/ 3448048 h 3448048"/>
              <a:gd name="connsiteX4" fmla="*/ 0 w 1507775"/>
              <a:gd name="connsiteY4" fmla="*/ 0 h 3448048"/>
              <a:gd name="connsiteX0" fmla="*/ 0 w 1507775"/>
              <a:gd name="connsiteY0" fmla="*/ 0 h 3523888"/>
              <a:gd name="connsiteX1" fmla="*/ 225979 w 1507775"/>
              <a:gd name="connsiteY1" fmla="*/ 48621 h 3523888"/>
              <a:gd name="connsiteX2" fmla="*/ 1507775 w 1507775"/>
              <a:gd name="connsiteY2" fmla="*/ 3281360 h 3523888"/>
              <a:gd name="connsiteX3" fmla="*/ 1207821 w 1507775"/>
              <a:gd name="connsiteY3" fmla="*/ 3523888 h 3523888"/>
              <a:gd name="connsiteX4" fmla="*/ 0 w 1507775"/>
              <a:gd name="connsiteY4" fmla="*/ 0 h 3523888"/>
              <a:gd name="connsiteX0" fmla="*/ 0 w 1376648"/>
              <a:gd name="connsiteY0" fmla="*/ 0 h 3523888"/>
              <a:gd name="connsiteX1" fmla="*/ 225979 w 1376648"/>
              <a:gd name="connsiteY1" fmla="*/ 48621 h 3523888"/>
              <a:gd name="connsiteX2" fmla="*/ 1376648 w 1376648"/>
              <a:gd name="connsiteY2" fmla="*/ 3405462 h 3523888"/>
              <a:gd name="connsiteX3" fmla="*/ 1207821 w 1376648"/>
              <a:gd name="connsiteY3" fmla="*/ 3523888 h 3523888"/>
              <a:gd name="connsiteX4" fmla="*/ 0 w 1376648"/>
              <a:gd name="connsiteY4" fmla="*/ 0 h 3523888"/>
              <a:gd name="connsiteX0" fmla="*/ 0 w 1397353"/>
              <a:gd name="connsiteY0" fmla="*/ 0 h 3523888"/>
              <a:gd name="connsiteX1" fmla="*/ 225979 w 1397353"/>
              <a:gd name="connsiteY1" fmla="*/ 48621 h 3523888"/>
              <a:gd name="connsiteX2" fmla="*/ 1397353 w 1397353"/>
              <a:gd name="connsiteY2" fmla="*/ 3384779 h 3523888"/>
              <a:gd name="connsiteX3" fmla="*/ 1207821 w 1397353"/>
              <a:gd name="connsiteY3" fmla="*/ 3523888 h 3523888"/>
              <a:gd name="connsiteX4" fmla="*/ 0 w 1397353"/>
              <a:gd name="connsiteY4" fmla="*/ 0 h 3523888"/>
              <a:gd name="connsiteX0" fmla="*/ 0 w 1397353"/>
              <a:gd name="connsiteY0" fmla="*/ 0 h 3523888"/>
              <a:gd name="connsiteX1" fmla="*/ 198373 w 1397353"/>
              <a:gd name="connsiteY1" fmla="*/ 34832 h 3523888"/>
              <a:gd name="connsiteX2" fmla="*/ 1397353 w 1397353"/>
              <a:gd name="connsiteY2" fmla="*/ 3384779 h 3523888"/>
              <a:gd name="connsiteX3" fmla="*/ 1207821 w 1397353"/>
              <a:gd name="connsiteY3" fmla="*/ 3523888 h 3523888"/>
              <a:gd name="connsiteX4" fmla="*/ 0 w 1397353"/>
              <a:gd name="connsiteY4" fmla="*/ 0 h 3523888"/>
              <a:gd name="connsiteX0" fmla="*/ 0 w 1414606"/>
              <a:gd name="connsiteY0" fmla="*/ 0 h 3534230"/>
              <a:gd name="connsiteX1" fmla="*/ 215626 w 1414606"/>
              <a:gd name="connsiteY1" fmla="*/ 45174 h 3534230"/>
              <a:gd name="connsiteX2" fmla="*/ 1414606 w 1414606"/>
              <a:gd name="connsiteY2" fmla="*/ 3395121 h 3534230"/>
              <a:gd name="connsiteX3" fmla="*/ 1225074 w 1414606"/>
              <a:gd name="connsiteY3" fmla="*/ 3534230 h 3534230"/>
              <a:gd name="connsiteX4" fmla="*/ 0 w 1414606"/>
              <a:gd name="connsiteY4" fmla="*/ 0 h 3534230"/>
              <a:gd name="connsiteX0" fmla="*/ 0 w 1414606"/>
              <a:gd name="connsiteY0" fmla="*/ 0 h 3534230"/>
              <a:gd name="connsiteX1" fmla="*/ 215626 w 1414606"/>
              <a:gd name="connsiteY1" fmla="*/ 62410 h 3534230"/>
              <a:gd name="connsiteX2" fmla="*/ 1414606 w 1414606"/>
              <a:gd name="connsiteY2" fmla="*/ 3395121 h 3534230"/>
              <a:gd name="connsiteX3" fmla="*/ 1225074 w 1414606"/>
              <a:gd name="connsiteY3" fmla="*/ 3534230 h 3534230"/>
              <a:gd name="connsiteX4" fmla="*/ 0 w 1414606"/>
              <a:gd name="connsiteY4" fmla="*/ 0 h 3534230"/>
              <a:gd name="connsiteX0" fmla="*/ 0 w 1414606"/>
              <a:gd name="connsiteY0" fmla="*/ 0 h 3534230"/>
              <a:gd name="connsiteX1" fmla="*/ 222528 w 1414606"/>
              <a:gd name="connsiteY1" fmla="*/ 62410 h 3534230"/>
              <a:gd name="connsiteX2" fmla="*/ 1414606 w 1414606"/>
              <a:gd name="connsiteY2" fmla="*/ 3395121 h 3534230"/>
              <a:gd name="connsiteX3" fmla="*/ 1225074 w 1414606"/>
              <a:gd name="connsiteY3" fmla="*/ 3534230 h 3534230"/>
              <a:gd name="connsiteX4" fmla="*/ 0 w 1414606"/>
              <a:gd name="connsiteY4" fmla="*/ 0 h 3534230"/>
              <a:gd name="connsiteX0" fmla="*/ 0 w 1414606"/>
              <a:gd name="connsiteY0" fmla="*/ 0 h 3565255"/>
              <a:gd name="connsiteX1" fmla="*/ 222528 w 1414606"/>
              <a:gd name="connsiteY1" fmla="*/ 62410 h 3565255"/>
              <a:gd name="connsiteX2" fmla="*/ 1414606 w 1414606"/>
              <a:gd name="connsiteY2" fmla="*/ 3395121 h 3565255"/>
              <a:gd name="connsiteX3" fmla="*/ 1231976 w 1414606"/>
              <a:gd name="connsiteY3" fmla="*/ 3565255 h 3565255"/>
              <a:gd name="connsiteX4" fmla="*/ 0 w 1414606"/>
              <a:gd name="connsiteY4" fmla="*/ 0 h 3565255"/>
              <a:gd name="connsiteX0" fmla="*/ 0 w 1414606"/>
              <a:gd name="connsiteY0" fmla="*/ 0 h 3579044"/>
              <a:gd name="connsiteX1" fmla="*/ 222528 w 1414606"/>
              <a:gd name="connsiteY1" fmla="*/ 62410 h 3579044"/>
              <a:gd name="connsiteX2" fmla="*/ 1414606 w 1414606"/>
              <a:gd name="connsiteY2" fmla="*/ 3395121 h 3579044"/>
              <a:gd name="connsiteX3" fmla="*/ 1190568 w 1414606"/>
              <a:gd name="connsiteY3" fmla="*/ 3579044 h 3579044"/>
              <a:gd name="connsiteX4" fmla="*/ 0 w 1414606"/>
              <a:gd name="connsiteY4" fmla="*/ 0 h 3579044"/>
              <a:gd name="connsiteX0" fmla="*/ 0 w 1352492"/>
              <a:gd name="connsiteY0" fmla="*/ 0 h 3544572"/>
              <a:gd name="connsiteX1" fmla="*/ 160414 w 1352492"/>
              <a:gd name="connsiteY1" fmla="*/ 27938 h 3544572"/>
              <a:gd name="connsiteX2" fmla="*/ 1352492 w 1352492"/>
              <a:gd name="connsiteY2" fmla="*/ 3360649 h 3544572"/>
              <a:gd name="connsiteX3" fmla="*/ 1128454 w 1352492"/>
              <a:gd name="connsiteY3" fmla="*/ 3544572 h 3544572"/>
              <a:gd name="connsiteX4" fmla="*/ 0 w 1352492"/>
              <a:gd name="connsiteY4" fmla="*/ 0 h 3544572"/>
              <a:gd name="connsiteX0" fmla="*/ 0 w 1352492"/>
              <a:gd name="connsiteY0" fmla="*/ 0 h 3468732"/>
              <a:gd name="connsiteX1" fmla="*/ 160414 w 1352492"/>
              <a:gd name="connsiteY1" fmla="*/ 27938 h 3468732"/>
              <a:gd name="connsiteX2" fmla="*/ 1352492 w 1352492"/>
              <a:gd name="connsiteY2" fmla="*/ 3360649 h 3468732"/>
              <a:gd name="connsiteX3" fmla="*/ 1204371 w 1352492"/>
              <a:gd name="connsiteY3" fmla="*/ 3468732 h 3468732"/>
              <a:gd name="connsiteX4" fmla="*/ 0 w 1352492"/>
              <a:gd name="connsiteY4" fmla="*/ 0 h 3468732"/>
              <a:gd name="connsiteX0" fmla="*/ 0 w 1373197"/>
              <a:gd name="connsiteY0" fmla="*/ 0 h 3485968"/>
              <a:gd name="connsiteX1" fmla="*/ 181119 w 1373197"/>
              <a:gd name="connsiteY1" fmla="*/ 45174 h 3485968"/>
              <a:gd name="connsiteX2" fmla="*/ 1373197 w 1373197"/>
              <a:gd name="connsiteY2" fmla="*/ 3377885 h 3485968"/>
              <a:gd name="connsiteX3" fmla="*/ 1225076 w 1373197"/>
              <a:gd name="connsiteY3" fmla="*/ 3485968 h 3485968"/>
              <a:gd name="connsiteX4" fmla="*/ 0 w 1373197"/>
              <a:gd name="connsiteY4" fmla="*/ 0 h 3485968"/>
              <a:gd name="connsiteX0" fmla="*/ 0 w 1369747"/>
              <a:gd name="connsiteY0" fmla="*/ 0 h 3485968"/>
              <a:gd name="connsiteX1" fmla="*/ 181119 w 1369747"/>
              <a:gd name="connsiteY1" fmla="*/ 45174 h 3485968"/>
              <a:gd name="connsiteX2" fmla="*/ 1369747 w 1369747"/>
              <a:gd name="connsiteY2" fmla="*/ 3357202 h 3485968"/>
              <a:gd name="connsiteX3" fmla="*/ 1225076 w 1369747"/>
              <a:gd name="connsiteY3" fmla="*/ 3485968 h 3485968"/>
              <a:gd name="connsiteX4" fmla="*/ 0 w 1369747"/>
              <a:gd name="connsiteY4" fmla="*/ 0 h 3485968"/>
              <a:gd name="connsiteX0" fmla="*/ 0 w 1369747"/>
              <a:gd name="connsiteY0" fmla="*/ 0 h 3485968"/>
              <a:gd name="connsiteX1" fmla="*/ 181119 w 1369747"/>
              <a:gd name="connsiteY1" fmla="*/ 45174 h 3485968"/>
              <a:gd name="connsiteX2" fmla="*/ 1369747 w 1369747"/>
              <a:gd name="connsiteY2" fmla="*/ 3357202 h 3485968"/>
              <a:gd name="connsiteX3" fmla="*/ 1225076 w 1369747"/>
              <a:gd name="connsiteY3" fmla="*/ 3485968 h 3485968"/>
              <a:gd name="connsiteX4" fmla="*/ 0 w 1369747"/>
              <a:gd name="connsiteY4" fmla="*/ 0 h 3485968"/>
              <a:gd name="connsiteX0" fmla="*/ 0 w 1369747"/>
              <a:gd name="connsiteY0" fmla="*/ 0 h 3485968"/>
              <a:gd name="connsiteX1" fmla="*/ 181119 w 1369747"/>
              <a:gd name="connsiteY1" fmla="*/ 45174 h 3485968"/>
              <a:gd name="connsiteX2" fmla="*/ 1369747 w 1369747"/>
              <a:gd name="connsiteY2" fmla="*/ 3357202 h 3485968"/>
              <a:gd name="connsiteX3" fmla="*/ 1225076 w 1369747"/>
              <a:gd name="connsiteY3" fmla="*/ 3485968 h 3485968"/>
              <a:gd name="connsiteX4" fmla="*/ 0 w 1369747"/>
              <a:gd name="connsiteY4" fmla="*/ 0 h 3485968"/>
              <a:gd name="connsiteX0" fmla="*/ 0 w 1569889"/>
              <a:gd name="connsiteY0" fmla="*/ 0 h 3485968"/>
              <a:gd name="connsiteX1" fmla="*/ 181119 w 1569889"/>
              <a:gd name="connsiteY1" fmla="*/ 45174 h 3485968"/>
              <a:gd name="connsiteX2" fmla="*/ 1569889 w 1569889"/>
              <a:gd name="connsiteY2" fmla="*/ 3198629 h 3485968"/>
              <a:gd name="connsiteX3" fmla="*/ 1225076 w 1569889"/>
              <a:gd name="connsiteY3" fmla="*/ 3485968 h 3485968"/>
              <a:gd name="connsiteX4" fmla="*/ 0 w 1569889"/>
              <a:gd name="connsiteY4" fmla="*/ 0 h 3485968"/>
              <a:gd name="connsiteX0" fmla="*/ 0 w 1569889"/>
              <a:gd name="connsiteY0" fmla="*/ 0 h 3251555"/>
              <a:gd name="connsiteX1" fmla="*/ 181119 w 1569889"/>
              <a:gd name="connsiteY1" fmla="*/ 45174 h 3251555"/>
              <a:gd name="connsiteX2" fmla="*/ 1569889 w 1569889"/>
              <a:gd name="connsiteY2" fmla="*/ 3198629 h 3251555"/>
              <a:gd name="connsiteX3" fmla="*/ 1542544 w 1569889"/>
              <a:gd name="connsiteY3" fmla="*/ 3251555 h 3251555"/>
              <a:gd name="connsiteX4" fmla="*/ 0 w 1569889"/>
              <a:gd name="connsiteY4" fmla="*/ 0 h 3251555"/>
              <a:gd name="connsiteX0" fmla="*/ 0 w 1618200"/>
              <a:gd name="connsiteY0" fmla="*/ 0 h 3251555"/>
              <a:gd name="connsiteX1" fmla="*/ 181119 w 1618200"/>
              <a:gd name="connsiteY1" fmla="*/ 45174 h 3251555"/>
              <a:gd name="connsiteX2" fmla="*/ 1618200 w 1618200"/>
              <a:gd name="connsiteY2" fmla="*/ 3171052 h 3251555"/>
              <a:gd name="connsiteX3" fmla="*/ 1542544 w 1618200"/>
              <a:gd name="connsiteY3" fmla="*/ 3251555 h 3251555"/>
              <a:gd name="connsiteX4" fmla="*/ 0 w 1618200"/>
              <a:gd name="connsiteY4" fmla="*/ 0 h 3251555"/>
              <a:gd name="connsiteX0" fmla="*/ 0 w 1618200"/>
              <a:gd name="connsiteY0" fmla="*/ 0 h 3237766"/>
              <a:gd name="connsiteX1" fmla="*/ 181119 w 1618200"/>
              <a:gd name="connsiteY1" fmla="*/ 45174 h 3237766"/>
              <a:gd name="connsiteX2" fmla="*/ 1618200 w 1618200"/>
              <a:gd name="connsiteY2" fmla="*/ 3171052 h 3237766"/>
              <a:gd name="connsiteX3" fmla="*/ 1535643 w 1618200"/>
              <a:gd name="connsiteY3" fmla="*/ 3237766 h 3237766"/>
              <a:gd name="connsiteX4" fmla="*/ 0 w 1618200"/>
              <a:gd name="connsiteY4" fmla="*/ 0 h 3237766"/>
              <a:gd name="connsiteX0" fmla="*/ 0 w 1618200"/>
              <a:gd name="connsiteY0" fmla="*/ 0 h 3220530"/>
              <a:gd name="connsiteX1" fmla="*/ 181119 w 1618200"/>
              <a:gd name="connsiteY1" fmla="*/ 45174 h 3220530"/>
              <a:gd name="connsiteX2" fmla="*/ 1618200 w 1618200"/>
              <a:gd name="connsiteY2" fmla="*/ 3171052 h 3220530"/>
              <a:gd name="connsiteX3" fmla="*/ 1525290 w 1618200"/>
              <a:gd name="connsiteY3" fmla="*/ 3220530 h 3220530"/>
              <a:gd name="connsiteX4" fmla="*/ 0 w 1618200"/>
              <a:gd name="connsiteY4" fmla="*/ 0 h 3220530"/>
              <a:gd name="connsiteX0" fmla="*/ 0 w 1618200"/>
              <a:gd name="connsiteY0" fmla="*/ 0 h 3220530"/>
              <a:gd name="connsiteX1" fmla="*/ 181119 w 1618200"/>
              <a:gd name="connsiteY1" fmla="*/ 45174 h 3220530"/>
              <a:gd name="connsiteX2" fmla="*/ 1618200 w 1618200"/>
              <a:gd name="connsiteY2" fmla="*/ 3171052 h 3220530"/>
              <a:gd name="connsiteX3" fmla="*/ 1525290 w 1618200"/>
              <a:gd name="connsiteY3" fmla="*/ 3220530 h 3220530"/>
              <a:gd name="connsiteX4" fmla="*/ 1023676 w 1618200"/>
              <a:gd name="connsiteY4" fmla="*/ 2256531 h 3220530"/>
              <a:gd name="connsiteX5" fmla="*/ 0 w 1618200"/>
              <a:gd name="connsiteY5" fmla="*/ 0 h 3220530"/>
              <a:gd name="connsiteX0" fmla="*/ 0 w 1618200"/>
              <a:gd name="connsiteY0" fmla="*/ 0 h 3220530"/>
              <a:gd name="connsiteX1" fmla="*/ 181119 w 1618200"/>
              <a:gd name="connsiteY1" fmla="*/ 45174 h 3220530"/>
              <a:gd name="connsiteX2" fmla="*/ 1618200 w 1618200"/>
              <a:gd name="connsiteY2" fmla="*/ 3171052 h 3220530"/>
              <a:gd name="connsiteX3" fmla="*/ 1525290 w 1618200"/>
              <a:gd name="connsiteY3" fmla="*/ 3220530 h 3220530"/>
              <a:gd name="connsiteX4" fmla="*/ 1023676 w 1618200"/>
              <a:gd name="connsiteY4" fmla="*/ 2132429 h 3220530"/>
              <a:gd name="connsiteX5" fmla="*/ 0 w 1618200"/>
              <a:gd name="connsiteY5" fmla="*/ 0 h 3220530"/>
              <a:gd name="connsiteX0" fmla="*/ 0 w 1618200"/>
              <a:gd name="connsiteY0" fmla="*/ 0 h 3220530"/>
              <a:gd name="connsiteX1" fmla="*/ 181119 w 1618200"/>
              <a:gd name="connsiteY1" fmla="*/ 45174 h 3220530"/>
              <a:gd name="connsiteX2" fmla="*/ 1618200 w 1618200"/>
              <a:gd name="connsiteY2" fmla="*/ 3171052 h 3220530"/>
              <a:gd name="connsiteX3" fmla="*/ 1525290 w 1618200"/>
              <a:gd name="connsiteY3" fmla="*/ 3220530 h 3220530"/>
              <a:gd name="connsiteX4" fmla="*/ 1023676 w 1618200"/>
              <a:gd name="connsiteY4" fmla="*/ 2132429 h 3220530"/>
              <a:gd name="connsiteX5" fmla="*/ 0 w 1618200"/>
              <a:gd name="connsiteY5" fmla="*/ 0 h 3220530"/>
              <a:gd name="connsiteX0" fmla="*/ 0 w 1618200"/>
              <a:gd name="connsiteY0" fmla="*/ 0 h 3220530"/>
              <a:gd name="connsiteX1" fmla="*/ 181119 w 1618200"/>
              <a:gd name="connsiteY1" fmla="*/ 45174 h 3220530"/>
              <a:gd name="connsiteX2" fmla="*/ 1618200 w 1618200"/>
              <a:gd name="connsiteY2" fmla="*/ 3171052 h 3220530"/>
              <a:gd name="connsiteX3" fmla="*/ 1525290 w 1618200"/>
              <a:gd name="connsiteY3" fmla="*/ 3220530 h 3220530"/>
              <a:gd name="connsiteX4" fmla="*/ 1023676 w 1618200"/>
              <a:gd name="connsiteY4" fmla="*/ 2132429 h 3220530"/>
              <a:gd name="connsiteX5" fmla="*/ 0 w 1618200"/>
              <a:gd name="connsiteY5" fmla="*/ 0 h 32205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618200" h="3220530">
                <a:moveTo>
                  <a:pt x="0" y="0"/>
                </a:moveTo>
                <a:lnTo>
                  <a:pt x="181119" y="45174"/>
                </a:lnTo>
                <a:cubicBezTo>
                  <a:pt x="577328" y="1149183"/>
                  <a:pt x="1100524" y="2126338"/>
                  <a:pt x="1618200" y="3171052"/>
                </a:cubicBezTo>
                <a:lnTo>
                  <a:pt x="1525290" y="3220530"/>
                </a:lnTo>
                <a:cubicBezTo>
                  <a:pt x="1426203" y="3068110"/>
                  <a:pt x="1277891" y="2669184"/>
                  <a:pt x="1023676" y="2132429"/>
                </a:cubicBezTo>
                <a:cubicBezTo>
                  <a:pt x="769461" y="1595674"/>
                  <a:pt x="140426" y="368559"/>
                  <a:pt x="0" y="0"/>
                </a:cubicBezTo>
                <a:close/>
              </a:path>
            </a:pathLst>
          </a:custGeom>
          <a:solidFill>
            <a:schemeClr val="accent6">
              <a:lumMod val="75000"/>
              <a:alpha val="5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212" name="Freihandform 5">
            <a:extLst>
              <a:ext uri="{FF2B5EF4-FFF2-40B4-BE49-F238E27FC236}">
                <a16:creationId xmlns:a16="http://schemas.microsoft.com/office/drawing/2014/main" id="{358D8FFA-FE8C-84BB-45E3-248E474B17DF}"/>
              </a:ext>
            </a:extLst>
          </p:cNvPr>
          <p:cNvSpPr/>
          <p:nvPr/>
        </p:nvSpPr>
        <p:spPr>
          <a:xfrm>
            <a:off x="3752058" y="2131192"/>
            <a:ext cx="1434273" cy="3170885"/>
          </a:xfrm>
          <a:custGeom>
            <a:avLst/>
            <a:gdLst>
              <a:gd name="connsiteX0" fmla="*/ 0 w 1076325"/>
              <a:gd name="connsiteY0" fmla="*/ 0 h 3009900"/>
              <a:gd name="connsiteX1" fmla="*/ 104775 w 1076325"/>
              <a:gd name="connsiteY1" fmla="*/ 4762 h 3009900"/>
              <a:gd name="connsiteX2" fmla="*/ 1076325 w 1076325"/>
              <a:gd name="connsiteY2" fmla="*/ 2838450 h 3009900"/>
              <a:gd name="connsiteX3" fmla="*/ 1038225 w 1076325"/>
              <a:gd name="connsiteY3" fmla="*/ 3009900 h 3009900"/>
              <a:gd name="connsiteX4" fmla="*/ 0 w 1076325"/>
              <a:gd name="connsiteY4" fmla="*/ 0 h 3009900"/>
              <a:gd name="connsiteX0" fmla="*/ 0 w 1076325"/>
              <a:gd name="connsiteY0" fmla="*/ 0 h 2928937"/>
              <a:gd name="connsiteX1" fmla="*/ 104775 w 1076325"/>
              <a:gd name="connsiteY1" fmla="*/ 4762 h 2928937"/>
              <a:gd name="connsiteX2" fmla="*/ 1076325 w 1076325"/>
              <a:gd name="connsiteY2" fmla="*/ 2838450 h 2928937"/>
              <a:gd name="connsiteX3" fmla="*/ 1009650 w 1076325"/>
              <a:gd name="connsiteY3" fmla="*/ 2928937 h 2928937"/>
              <a:gd name="connsiteX4" fmla="*/ 0 w 1076325"/>
              <a:gd name="connsiteY4" fmla="*/ 0 h 2928937"/>
              <a:gd name="connsiteX0" fmla="*/ 0 w 1081087"/>
              <a:gd name="connsiteY0" fmla="*/ 0 h 2971800"/>
              <a:gd name="connsiteX1" fmla="*/ 109537 w 1081087"/>
              <a:gd name="connsiteY1" fmla="*/ 47625 h 2971800"/>
              <a:gd name="connsiteX2" fmla="*/ 1081087 w 1081087"/>
              <a:gd name="connsiteY2" fmla="*/ 2881313 h 2971800"/>
              <a:gd name="connsiteX3" fmla="*/ 1014412 w 1081087"/>
              <a:gd name="connsiteY3" fmla="*/ 2971800 h 2971800"/>
              <a:gd name="connsiteX4" fmla="*/ 0 w 1081087"/>
              <a:gd name="connsiteY4" fmla="*/ 0 h 2971800"/>
              <a:gd name="connsiteX0" fmla="*/ 0 w 1081087"/>
              <a:gd name="connsiteY0" fmla="*/ 0 h 2971800"/>
              <a:gd name="connsiteX1" fmla="*/ 109537 w 1081087"/>
              <a:gd name="connsiteY1" fmla="*/ 47625 h 2971800"/>
              <a:gd name="connsiteX2" fmla="*/ 1081087 w 1081087"/>
              <a:gd name="connsiteY2" fmla="*/ 2881313 h 2971800"/>
              <a:gd name="connsiteX3" fmla="*/ 1014412 w 1081087"/>
              <a:gd name="connsiteY3" fmla="*/ 2971800 h 2971800"/>
              <a:gd name="connsiteX4" fmla="*/ 0 w 1081087"/>
              <a:gd name="connsiteY4" fmla="*/ 0 h 2971800"/>
              <a:gd name="connsiteX0" fmla="*/ 0 w 1095375"/>
              <a:gd name="connsiteY0" fmla="*/ 0 h 2971800"/>
              <a:gd name="connsiteX1" fmla="*/ 109537 w 1095375"/>
              <a:gd name="connsiteY1" fmla="*/ 47625 h 2971800"/>
              <a:gd name="connsiteX2" fmla="*/ 1095375 w 1095375"/>
              <a:gd name="connsiteY2" fmla="*/ 2914650 h 2971800"/>
              <a:gd name="connsiteX3" fmla="*/ 1014412 w 1095375"/>
              <a:gd name="connsiteY3" fmla="*/ 2971800 h 2971800"/>
              <a:gd name="connsiteX4" fmla="*/ 0 w 1095375"/>
              <a:gd name="connsiteY4" fmla="*/ 0 h 2971800"/>
              <a:gd name="connsiteX0" fmla="*/ 0 w 1095375"/>
              <a:gd name="connsiteY0" fmla="*/ 0 h 2962275"/>
              <a:gd name="connsiteX1" fmla="*/ 109537 w 1095375"/>
              <a:gd name="connsiteY1" fmla="*/ 47625 h 2962275"/>
              <a:gd name="connsiteX2" fmla="*/ 1095375 w 1095375"/>
              <a:gd name="connsiteY2" fmla="*/ 2914650 h 2962275"/>
              <a:gd name="connsiteX3" fmla="*/ 1009650 w 1095375"/>
              <a:gd name="connsiteY3" fmla="*/ 2962275 h 2962275"/>
              <a:gd name="connsiteX4" fmla="*/ 0 w 1095375"/>
              <a:gd name="connsiteY4" fmla="*/ 0 h 2962275"/>
              <a:gd name="connsiteX0" fmla="*/ 0 w 1276350"/>
              <a:gd name="connsiteY0" fmla="*/ 0 h 3738563"/>
              <a:gd name="connsiteX1" fmla="*/ 109537 w 1276350"/>
              <a:gd name="connsiteY1" fmla="*/ 47625 h 3738563"/>
              <a:gd name="connsiteX2" fmla="*/ 1095375 w 1276350"/>
              <a:gd name="connsiteY2" fmla="*/ 2914650 h 3738563"/>
              <a:gd name="connsiteX3" fmla="*/ 1276350 w 1276350"/>
              <a:gd name="connsiteY3" fmla="*/ 3738563 h 3738563"/>
              <a:gd name="connsiteX4" fmla="*/ 0 w 1276350"/>
              <a:gd name="connsiteY4" fmla="*/ 0 h 3738563"/>
              <a:gd name="connsiteX0" fmla="*/ 0 w 1357312"/>
              <a:gd name="connsiteY0" fmla="*/ 0 h 3738563"/>
              <a:gd name="connsiteX1" fmla="*/ 109537 w 1357312"/>
              <a:gd name="connsiteY1" fmla="*/ 47625 h 3738563"/>
              <a:gd name="connsiteX2" fmla="*/ 1357312 w 1357312"/>
              <a:gd name="connsiteY2" fmla="*/ 3624262 h 3738563"/>
              <a:gd name="connsiteX3" fmla="*/ 1276350 w 1357312"/>
              <a:gd name="connsiteY3" fmla="*/ 3738563 h 3738563"/>
              <a:gd name="connsiteX4" fmla="*/ 0 w 1357312"/>
              <a:gd name="connsiteY4" fmla="*/ 0 h 3738563"/>
              <a:gd name="connsiteX0" fmla="*/ 0 w 1378016"/>
              <a:gd name="connsiteY0" fmla="*/ 0 h 3738563"/>
              <a:gd name="connsiteX1" fmla="*/ 109537 w 1378016"/>
              <a:gd name="connsiteY1" fmla="*/ 47625 h 3738563"/>
              <a:gd name="connsiteX2" fmla="*/ 1378016 w 1378016"/>
              <a:gd name="connsiteY2" fmla="*/ 3724233 h 3738563"/>
              <a:gd name="connsiteX3" fmla="*/ 1276350 w 1378016"/>
              <a:gd name="connsiteY3" fmla="*/ 3738563 h 3738563"/>
              <a:gd name="connsiteX4" fmla="*/ 0 w 1378016"/>
              <a:gd name="connsiteY4" fmla="*/ 0 h 3738563"/>
              <a:gd name="connsiteX0" fmla="*/ 0 w 1378016"/>
              <a:gd name="connsiteY0" fmla="*/ 0 h 3797166"/>
              <a:gd name="connsiteX1" fmla="*/ 109537 w 1378016"/>
              <a:gd name="connsiteY1" fmla="*/ 47625 h 3797166"/>
              <a:gd name="connsiteX2" fmla="*/ 1378016 w 1378016"/>
              <a:gd name="connsiteY2" fmla="*/ 3724233 h 3797166"/>
              <a:gd name="connsiteX3" fmla="*/ 1310856 w 1378016"/>
              <a:gd name="connsiteY3" fmla="*/ 3797166 h 3797166"/>
              <a:gd name="connsiteX4" fmla="*/ 0 w 1378016"/>
              <a:gd name="connsiteY4" fmla="*/ 0 h 3797166"/>
              <a:gd name="connsiteX0" fmla="*/ 0 w 1405622"/>
              <a:gd name="connsiteY0" fmla="*/ 0 h 3813860"/>
              <a:gd name="connsiteX1" fmla="*/ 109537 w 1405622"/>
              <a:gd name="connsiteY1" fmla="*/ 47625 h 3813860"/>
              <a:gd name="connsiteX2" fmla="*/ 1405622 w 1405622"/>
              <a:gd name="connsiteY2" fmla="*/ 3813860 h 3813860"/>
              <a:gd name="connsiteX3" fmla="*/ 1310856 w 1405622"/>
              <a:gd name="connsiteY3" fmla="*/ 3797166 h 3813860"/>
              <a:gd name="connsiteX4" fmla="*/ 0 w 1405622"/>
              <a:gd name="connsiteY4" fmla="*/ 0 h 3813860"/>
              <a:gd name="connsiteX0" fmla="*/ 0 w 1405622"/>
              <a:gd name="connsiteY0" fmla="*/ 0 h 3879900"/>
              <a:gd name="connsiteX1" fmla="*/ 109537 w 1405622"/>
              <a:gd name="connsiteY1" fmla="*/ 47625 h 3879900"/>
              <a:gd name="connsiteX2" fmla="*/ 1405622 w 1405622"/>
              <a:gd name="connsiteY2" fmla="*/ 3813860 h 3879900"/>
              <a:gd name="connsiteX3" fmla="*/ 1359167 w 1405622"/>
              <a:gd name="connsiteY3" fmla="*/ 3879900 h 3879900"/>
              <a:gd name="connsiteX4" fmla="*/ 0 w 1405622"/>
              <a:gd name="connsiteY4" fmla="*/ 0 h 3879900"/>
              <a:gd name="connsiteX0" fmla="*/ 0 w 1405622"/>
              <a:gd name="connsiteY0" fmla="*/ 0 h 3813860"/>
              <a:gd name="connsiteX1" fmla="*/ 109537 w 1405622"/>
              <a:gd name="connsiteY1" fmla="*/ 47625 h 3813860"/>
              <a:gd name="connsiteX2" fmla="*/ 1405622 w 1405622"/>
              <a:gd name="connsiteY2" fmla="*/ 3813860 h 3813860"/>
              <a:gd name="connsiteX3" fmla="*/ 1276349 w 1405622"/>
              <a:gd name="connsiteY3" fmla="*/ 3631698 h 3813860"/>
              <a:gd name="connsiteX4" fmla="*/ 0 w 1405622"/>
              <a:gd name="connsiteY4" fmla="*/ 0 h 3813860"/>
              <a:gd name="connsiteX0" fmla="*/ 0 w 1405622"/>
              <a:gd name="connsiteY0" fmla="*/ 238497 h 4052357"/>
              <a:gd name="connsiteX1" fmla="*/ 109537 w 1405622"/>
              <a:gd name="connsiteY1" fmla="*/ 0 h 4052357"/>
              <a:gd name="connsiteX2" fmla="*/ 1405622 w 1405622"/>
              <a:gd name="connsiteY2" fmla="*/ 4052357 h 4052357"/>
              <a:gd name="connsiteX3" fmla="*/ 1276349 w 1405622"/>
              <a:gd name="connsiteY3" fmla="*/ 3870195 h 4052357"/>
              <a:gd name="connsiteX4" fmla="*/ 0 w 1405622"/>
              <a:gd name="connsiteY4" fmla="*/ 238497 h 4052357"/>
              <a:gd name="connsiteX0" fmla="*/ 0 w 1374566"/>
              <a:gd name="connsiteY0" fmla="*/ 0 h 4075851"/>
              <a:gd name="connsiteX1" fmla="*/ 78481 w 1374566"/>
              <a:gd name="connsiteY1" fmla="*/ 23494 h 4075851"/>
              <a:gd name="connsiteX2" fmla="*/ 1374566 w 1374566"/>
              <a:gd name="connsiteY2" fmla="*/ 4075851 h 4075851"/>
              <a:gd name="connsiteX3" fmla="*/ 1245293 w 1374566"/>
              <a:gd name="connsiteY3" fmla="*/ 3893689 h 4075851"/>
              <a:gd name="connsiteX4" fmla="*/ 0 w 1374566"/>
              <a:gd name="connsiteY4" fmla="*/ 0 h 4075851"/>
              <a:gd name="connsiteX0" fmla="*/ 0 w 1381468"/>
              <a:gd name="connsiteY0" fmla="*/ 0 h 3893688"/>
              <a:gd name="connsiteX1" fmla="*/ 78481 w 1381468"/>
              <a:gd name="connsiteY1" fmla="*/ 23494 h 3893688"/>
              <a:gd name="connsiteX2" fmla="*/ 1381468 w 1381468"/>
              <a:gd name="connsiteY2" fmla="*/ 3738021 h 3893688"/>
              <a:gd name="connsiteX3" fmla="*/ 1245293 w 1381468"/>
              <a:gd name="connsiteY3" fmla="*/ 3893689 h 3893688"/>
              <a:gd name="connsiteX4" fmla="*/ 0 w 1381468"/>
              <a:gd name="connsiteY4" fmla="*/ 0 h 3893688"/>
              <a:gd name="connsiteX0" fmla="*/ 0 w 1381468"/>
              <a:gd name="connsiteY0" fmla="*/ 0 h 3828191"/>
              <a:gd name="connsiteX1" fmla="*/ 78481 w 1381468"/>
              <a:gd name="connsiteY1" fmla="*/ 23494 h 3828191"/>
              <a:gd name="connsiteX2" fmla="*/ 1381468 w 1381468"/>
              <a:gd name="connsiteY2" fmla="*/ 3738021 h 3828191"/>
              <a:gd name="connsiteX3" fmla="*/ 1328111 w 1381468"/>
              <a:gd name="connsiteY3" fmla="*/ 3828191 h 3828191"/>
              <a:gd name="connsiteX4" fmla="*/ 0 w 1381468"/>
              <a:gd name="connsiteY4" fmla="*/ 0 h 3828191"/>
              <a:gd name="connsiteX0" fmla="*/ 0 w 1381468"/>
              <a:gd name="connsiteY0" fmla="*/ 0 h 3814402"/>
              <a:gd name="connsiteX1" fmla="*/ 78481 w 1381468"/>
              <a:gd name="connsiteY1" fmla="*/ 23494 h 3814402"/>
              <a:gd name="connsiteX2" fmla="*/ 1381468 w 1381468"/>
              <a:gd name="connsiteY2" fmla="*/ 3738021 h 3814402"/>
              <a:gd name="connsiteX3" fmla="*/ 1335013 w 1381468"/>
              <a:gd name="connsiteY3" fmla="*/ 3814402 h 3814402"/>
              <a:gd name="connsiteX4" fmla="*/ 0 w 1381468"/>
              <a:gd name="connsiteY4" fmla="*/ 0 h 3814402"/>
              <a:gd name="connsiteX0" fmla="*/ 0 w 1381468"/>
              <a:gd name="connsiteY0" fmla="*/ 0 h 3752351"/>
              <a:gd name="connsiteX1" fmla="*/ 78481 w 1381468"/>
              <a:gd name="connsiteY1" fmla="*/ 23494 h 3752351"/>
              <a:gd name="connsiteX2" fmla="*/ 1381468 w 1381468"/>
              <a:gd name="connsiteY2" fmla="*/ 3738021 h 3752351"/>
              <a:gd name="connsiteX3" fmla="*/ 1317760 w 1381468"/>
              <a:gd name="connsiteY3" fmla="*/ 3752351 h 3752351"/>
              <a:gd name="connsiteX4" fmla="*/ 0 w 1381468"/>
              <a:gd name="connsiteY4" fmla="*/ 0 h 3752351"/>
              <a:gd name="connsiteX0" fmla="*/ 0 w 1357314"/>
              <a:gd name="connsiteY0" fmla="*/ 0 h 3752351"/>
              <a:gd name="connsiteX1" fmla="*/ 78481 w 1357314"/>
              <a:gd name="connsiteY1" fmla="*/ 23494 h 3752351"/>
              <a:gd name="connsiteX2" fmla="*/ 1357314 w 1357314"/>
              <a:gd name="connsiteY2" fmla="*/ 3686311 h 3752351"/>
              <a:gd name="connsiteX3" fmla="*/ 1317760 w 1357314"/>
              <a:gd name="connsiteY3" fmla="*/ 3752351 h 3752351"/>
              <a:gd name="connsiteX4" fmla="*/ 0 w 1357314"/>
              <a:gd name="connsiteY4" fmla="*/ 0 h 3752351"/>
              <a:gd name="connsiteX0" fmla="*/ 0 w 1357314"/>
              <a:gd name="connsiteY0" fmla="*/ 0 h 3752351"/>
              <a:gd name="connsiteX1" fmla="*/ 78481 w 1357314"/>
              <a:gd name="connsiteY1" fmla="*/ 23494 h 3752351"/>
              <a:gd name="connsiteX2" fmla="*/ 1357314 w 1357314"/>
              <a:gd name="connsiteY2" fmla="*/ 3686311 h 3752351"/>
              <a:gd name="connsiteX3" fmla="*/ 1317760 w 1357314"/>
              <a:gd name="connsiteY3" fmla="*/ 3752351 h 3752351"/>
              <a:gd name="connsiteX4" fmla="*/ 0 w 1357314"/>
              <a:gd name="connsiteY4" fmla="*/ 0 h 3752351"/>
              <a:gd name="connsiteX0" fmla="*/ 0 w 1357314"/>
              <a:gd name="connsiteY0" fmla="*/ 0 h 3752351"/>
              <a:gd name="connsiteX1" fmla="*/ 78481 w 1357314"/>
              <a:gd name="connsiteY1" fmla="*/ 23494 h 3752351"/>
              <a:gd name="connsiteX2" fmla="*/ 1357314 w 1357314"/>
              <a:gd name="connsiteY2" fmla="*/ 3686311 h 3752351"/>
              <a:gd name="connsiteX3" fmla="*/ 1317760 w 1357314"/>
              <a:gd name="connsiteY3" fmla="*/ 3752351 h 3752351"/>
              <a:gd name="connsiteX4" fmla="*/ 0 w 1357314"/>
              <a:gd name="connsiteY4" fmla="*/ 0 h 3752351"/>
              <a:gd name="connsiteX0" fmla="*/ 0 w 1357314"/>
              <a:gd name="connsiteY0" fmla="*/ 0 h 3689034"/>
              <a:gd name="connsiteX1" fmla="*/ 78481 w 1357314"/>
              <a:gd name="connsiteY1" fmla="*/ 23494 h 3689034"/>
              <a:gd name="connsiteX2" fmla="*/ 1357314 w 1357314"/>
              <a:gd name="connsiteY2" fmla="*/ 3686311 h 3689034"/>
              <a:gd name="connsiteX3" fmla="*/ 1259098 w 1357314"/>
              <a:gd name="connsiteY3" fmla="*/ 3611013 h 3689034"/>
              <a:gd name="connsiteX4" fmla="*/ 0 w 1357314"/>
              <a:gd name="connsiteY4" fmla="*/ 0 h 3689034"/>
              <a:gd name="connsiteX0" fmla="*/ 0 w 1315905"/>
              <a:gd name="connsiteY0" fmla="*/ 0 h 3611014"/>
              <a:gd name="connsiteX1" fmla="*/ 78481 w 1315905"/>
              <a:gd name="connsiteY1" fmla="*/ 23494 h 3611014"/>
              <a:gd name="connsiteX2" fmla="*/ 1315905 w 1315905"/>
              <a:gd name="connsiteY2" fmla="*/ 3600129 h 3611014"/>
              <a:gd name="connsiteX3" fmla="*/ 1259098 w 1315905"/>
              <a:gd name="connsiteY3" fmla="*/ 3611013 h 3611014"/>
              <a:gd name="connsiteX4" fmla="*/ 0 w 1315905"/>
              <a:gd name="connsiteY4" fmla="*/ 0 h 3611014"/>
              <a:gd name="connsiteX0" fmla="*/ 0 w 1315905"/>
              <a:gd name="connsiteY0" fmla="*/ 0 h 3631697"/>
              <a:gd name="connsiteX1" fmla="*/ 78481 w 1315905"/>
              <a:gd name="connsiteY1" fmla="*/ 23494 h 3631697"/>
              <a:gd name="connsiteX2" fmla="*/ 1315905 w 1315905"/>
              <a:gd name="connsiteY2" fmla="*/ 3600129 h 3631697"/>
              <a:gd name="connsiteX3" fmla="*/ 1269450 w 1315905"/>
              <a:gd name="connsiteY3" fmla="*/ 3631697 h 3631697"/>
              <a:gd name="connsiteX4" fmla="*/ 0 w 1315905"/>
              <a:gd name="connsiteY4" fmla="*/ 0 h 3631697"/>
              <a:gd name="connsiteX0" fmla="*/ 0 w 1591964"/>
              <a:gd name="connsiteY0" fmla="*/ 0 h 3631697"/>
              <a:gd name="connsiteX1" fmla="*/ 78481 w 1591964"/>
              <a:gd name="connsiteY1" fmla="*/ 23494 h 3631697"/>
              <a:gd name="connsiteX2" fmla="*/ 1591964 w 1591964"/>
              <a:gd name="connsiteY2" fmla="*/ 3379505 h 3631697"/>
              <a:gd name="connsiteX3" fmla="*/ 1269450 w 1591964"/>
              <a:gd name="connsiteY3" fmla="*/ 3631697 h 3631697"/>
              <a:gd name="connsiteX4" fmla="*/ 0 w 1591964"/>
              <a:gd name="connsiteY4" fmla="*/ 0 h 3631697"/>
              <a:gd name="connsiteX0" fmla="*/ 0 w 1591964"/>
              <a:gd name="connsiteY0" fmla="*/ 0 h 3431756"/>
              <a:gd name="connsiteX1" fmla="*/ 78481 w 1591964"/>
              <a:gd name="connsiteY1" fmla="*/ 23494 h 3431756"/>
              <a:gd name="connsiteX2" fmla="*/ 1591964 w 1591964"/>
              <a:gd name="connsiteY2" fmla="*/ 3379505 h 3431756"/>
              <a:gd name="connsiteX3" fmla="*/ 1531706 w 1591964"/>
              <a:gd name="connsiteY3" fmla="*/ 3431756 h 3431756"/>
              <a:gd name="connsiteX4" fmla="*/ 0 w 1591964"/>
              <a:gd name="connsiteY4" fmla="*/ 0 h 3431756"/>
              <a:gd name="connsiteX0" fmla="*/ 0 w 1591964"/>
              <a:gd name="connsiteY0" fmla="*/ 0 h 3417967"/>
              <a:gd name="connsiteX1" fmla="*/ 78481 w 1591964"/>
              <a:gd name="connsiteY1" fmla="*/ 23494 h 3417967"/>
              <a:gd name="connsiteX2" fmla="*/ 1591964 w 1591964"/>
              <a:gd name="connsiteY2" fmla="*/ 3379505 h 3417967"/>
              <a:gd name="connsiteX3" fmla="*/ 1559312 w 1591964"/>
              <a:gd name="connsiteY3" fmla="*/ 3417967 h 3417967"/>
              <a:gd name="connsiteX4" fmla="*/ 0 w 1591964"/>
              <a:gd name="connsiteY4" fmla="*/ 0 h 3417967"/>
              <a:gd name="connsiteX0" fmla="*/ 0 w 1633373"/>
              <a:gd name="connsiteY0" fmla="*/ 0 h 3417967"/>
              <a:gd name="connsiteX1" fmla="*/ 78481 w 1633373"/>
              <a:gd name="connsiteY1" fmla="*/ 23494 h 3417967"/>
              <a:gd name="connsiteX2" fmla="*/ 1633373 w 1633373"/>
              <a:gd name="connsiteY2" fmla="*/ 3362268 h 3417967"/>
              <a:gd name="connsiteX3" fmla="*/ 1559312 w 1633373"/>
              <a:gd name="connsiteY3" fmla="*/ 3417967 h 3417967"/>
              <a:gd name="connsiteX4" fmla="*/ 0 w 1633373"/>
              <a:gd name="connsiteY4" fmla="*/ 0 h 3417967"/>
              <a:gd name="connsiteX0" fmla="*/ 0 w 1633373"/>
              <a:gd name="connsiteY0" fmla="*/ 0 h 3390389"/>
              <a:gd name="connsiteX1" fmla="*/ 78481 w 1633373"/>
              <a:gd name="connsiteY1" fmla="*/ 23494 h 3390389"/>
              <a:gd name="connsiteX2" fmla="*/ 1633373 w 1633373"/>
              <a:gd name="connsiteY2" fmla="*/ 3362268 h 3390389"/>
              <a:gd name="connsiteX3" fmla="*/ 1590369 w 1633373"/>
              <a:gd name="connsiteY3" fmla="*/ 3390389 h 3390389"/>
              <a:gd name="connsiteX4" fmla="*/ 0 w 1633373"/>
              <a:gd name="connsiteY4" fmla="*/ 0 h 3390389"/>
              <a:gd name="connsiteX0" fmla="*/ 0 w 1633373"/>
              <a:gd name="connsiteY0" fmla="*/ 0 h 3428998"/>
              <a:gd name="connsiteX1" fmla="*/ 78481 w 1633373"/>
              <a:gd name="connsiteY1" fmla="*/ 23494 h 3428998"/>
              <a:gd name="connsiteX2" fmla="*/ 1633373 w 1633373"/>
              <a:gd name="connsiteY2" fmla="*/ 3362268 h 3428998"/>
              <a:gd name="connsiteX3" fmla="*/ 1529636 w 1633373"/>
              <a:gd name="connsiteY3" fmla="*/ 3428998 h 3428998"/>
              <a:gd name="connsiteX4" fmla="*/ 0 w 1633373"/>
              <a:gd name="connsiteY4" fmla="*/ 0 h 3428998"/>
              <a:gd name="connsiteX0" fmla="*/ 0 w 1605767"/>
              <a:gd name="connsiteY0" fmla="*/ 0 h 3428998"/>
              <a:gd name="connsiteX1" fmla="*/ 78481 w 1605767"/>
              <a:gd name="connsiteY1" fmla="*/ 23494 h 3428998"/>
              <a:gd name="connsiteX2" fmla="*/ 1605767 w 1605767"/>
              <a:gd name="connsiteY2" fmla="*/ 3378815 h 3428998"/>
              <a:gd name="connsiteX3" fmla="*/ 1529636 w 1605767"/>
              <a:gd name="connsiteY3" fmla="*/ 3428998 h 3428998"/>
              <a:gd name="connsiteX4" fmla="*/ 0 w 1605767"/>
              <a:gd name="connsiteY4" fmla="*/ 0 h 3428998"/>
              <a:gd name="connsiteX0" fmla="*/ 0 w 1605767"/>
              <a:gd name="connsiteY0" fmla="*/ 0 h 3462092"/>
              <a:gd name="connsiteX1" fmla="*/ 78481 w 1605767"/>
              <a:gd name="connsiteY1" fmla="*/ 23494 h 3462092"/>
              <a:gd name="connsiteX2" fmla="*/ 1605767 w 1605767"/>
              <a:gd name="connsiteY2" fmla="*/ 3378815 h 3462092"/>
              <a:gd name="connsiteX3" fmla="*/ 1513072 w 1605767"/>
              <a:gd name="connsiteY3" fmla="*/ 3462092 h 3462092"/>
              <a:gd name="connsiteX4" fmla="*/ 0 w 1605767"/>
              <a:gd name="connsiteY4" fmla="*/ 0 h 3462092"/>
              <a:gd name="connsiteX0" fmla="*/ 0 w 1567119"/>
              <a:gd name="connsiteY0" fmla="*/ 0 h 3462092"/>
              <a:gd name="connsiteX1" fmla="*/ 78481 w 1567119"/>
              <a:gd name="connsiteY1" fmla="*/ 23494 h 3462092"/>
              <a:gd name="connsiteX2" fmla="*/ 1567119 w 1567119"/>
              <a:gd name="connsiteY2" fmla="*/ 3439487 h 3462092"/>
              <a:gd name="connsiteX3" fmla="*/ 1513072 w 1567119"/>
              <a:gd name="connsiteY3" fmla="*/ 3462092 h 3462092"/>
              <a:gd name="connsiteX4" fmla="*/ 0 w 1567119"/>
              <a:gd name="connsiteY4" fmla="*/ 0 h 3462092"/>
              <a:gd name="connsiteX0" fmla="*/ 0 w 1558837"/>
              <a:gd name="connsiteY0" fmla="*/ 0 h 3462092"/>
              <a:gd name="connsiteX1" fmla="*/ 78481 w 1558837"/>
              <a:gd name="connsiteY1" fmla="*/ 23494 h 3462092"/>
              <a:gd name="connsiteX2" fmla="*/ 1558837 w 1558837"/>
              <a:gd name="connsiteY2" fmla="*/ 3406393 h 3462092"/>
              <a:gd name="connsiteX3" fmla="*/ 1513072 w 1558837"/>
              <a:gd name="connsiteY3" fmla="*/ 3462092 h 3462092"/>
              <a:gd name="connsiteX4" fmla="*/ 0 w 1558837"/>
              <a:gd name="connsiteY4" fmla="*/ 0 h 3462092"/>
              <a:gd name="connsiteX0" fmla="*/ 0 w 1558837"/>
              <a:gd name="connsiteY0" fmla="*/ 0 h 3442787"/>
              <a:gd name="connsiteX1" fmla="*/ 78481 w 1558837"/>
              <a:gd name="connsiteY1" fmla="*/ 23494 h 3442787"/>
              <a:gd name="connsiteX2" fmla="*/ 1558837 w 1558837"/>
              <a:gd name="connsiteY2" fmla="*/ 3406393 h 3442787"/>
              <a:gd name="connsiteX3" fmla="*/ 1507551 w 1558837"/>
              <a:gd name="connsiteY3" fmla="*/ 3442787 h 3442787"/>
              <a:gd name="connsiteX4" fmla="*/ 0 w 1558837"/>
              <a:gd name="connsiteY4" fmla="*/ 0 h 34427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58837" h="3442787">
                <a:moveTo>
                  <a:pt x="0" y="0"/>
                </a:moveTo>
                <a:lnTo>
                  <a:pt x="78481" y="23494"/>
                </a:lnTo>
                <a:cubicBezTo>
                  <a:pt x="504759" y="1244433"/>
                  <a:pt x="1008332" y="2268188"/>
                  <a:pt x="1558837" y="3406393"/>
                </a:cubicBezTo>
                <a:cubicBezTo>
                  <a:pt x="1545652" y="3428406"/>
                  <a:pt x="1520736" y="3420774"/>
                  <a:pt x="1507551" y="3442787"/>
                </a:cubicBezTo>
                <a:cubicBezTo>
                  <a:pt x="930268" y="2260947"/>
                  <a:pt x="439253" y="1250784"/>
                  <a:pt x="0" y="0"/>
                </a:cubicBezTo>
                <a:close/>
              </a:path>
            </a:pathLst>
          </a:custGeom>
          <a:solidFill>
            <a:srgbClr val="CC0066">
              <a:alpha val="5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 dirty="0"/>
          </a:p>
        </p:txBody>
      </p:sp>
      <p:sp>
        <p:nvSpPr>
          <p:cNvPr id="172" name="Freihandform: Form 171">
            <a:extLst>
              <a:ext uri="{FF2B5EF4-FFF2-40B4-BE49-F238E27FC236}">
                <a16:creationId xmlns:a16="http://schemas.microsoft.com/office/drawing/2014/main" id="{61E6D897-9554-262A-5731-F0AE2F6B4C7F}"/>
              </a:ext>
            </a:extLst>
          </p:cNvPr>
          <p:cNvSpPr/>
          <p:nvPr/>
        </p:nvSpPr>
        <p:spPr>
          <a:xfrm>
            <a:off x="1249651" y="1537963"/>
            <a:ext cx="4137166" cy="4118565"/>
          </a:xfrm>
          <a:custGeom>
            <a:avLst/>
            <a:gdLst>
              <a:gd name="connsiteX0" fmla="*/ 32065 w 4162300"/>
              <a:gd name="connsiteY0" fmla="*/ 434513 h 5885793"/>
              <a:gd name="connsiteX1" fmla="*/ 501965 w 4162300"/>
              <a:gd name="connsiteY1" fmla="*/ 294813 h 5885793"/>
              <a:gd name="connsiteX2" fmla="*/ 1035365 w 4162300"/>
              <a:gd name="connsiteY2" fmla="*/ 447213 h 5885793"/>
              <a:gd name="connsiteX3" fmla="*/ 1302065 w 4162300"/>
              <a:gd name="connsiteY3" fmla="*/ 548813 h 5885793"/>
              <a:gd name="connsiteX4" fmla="*/ 1886265 w 4162300"/>
              <a:gd name="connsiteY4" fmla="*/ 942513 h 5885793"/>
              <a:gd name="connsiteX5" fmla="*/ 3003865 w 4162300"/>
              <a:gd name="connsiteY5" fmla="*/ 1348913 h 5885793"/>
              <a:gd name="connsiteX6" fmla="*/ 4083365 w 4162300"/>
              <a:gd name="connsiteY6" fmla="*/ 4193713 h 5885793"/>
              <a:gd name="connsiteX7" fmla="*/ 3854765 w 4162300"/>
              <a:gd name="connsiteY7" fmla="*/ 4244513 h 5885793"/>
              <a:gd name="connsiteX8" fmla="*/ 2064065 w 4162300"/>
              <a:gd name="connsiteY8" fmla="*/ 5044613 h 5885793"/>
              <a:gd name="connsiteX9" fmla="*/ 1441765 w 4162300"/>
              <a:gd name="connsiteY9" fmla="*/ 5616113 h 5885793"/>
              <a:gd name="connsiteX10" fmla="*/ 32065 w 4162300"/>
              <a:gd name="connsiteY10" fmla="*/ 434513 h 5885793"/>
              <a:gd name="connsiteX0" fmla="*/ 32854 w 4146420"/>
              <a:gd name="connsiteY0" fmla="*/ 435157 h 5881206"/>
              <a:gd name="connsiteX1" fmla="*/ 486085 w 4146420"/>
              <a:gd name="connsiteY1" fmla="*/ 293076 h 5881206"/>
              <a:gd name="connsiteX2" fmla="*/ 1019485 w 4146420"/>
              <a:gd name="connsiteY2" fmla="*/ 445476 h 5881206"/>
              <a:gd name="connsiteX3" fmla="*/ 1286185 w 4146420"/>
              <a:gd name="connsiteY3" fmla="*/ 547076 h 5881206"/>
              <a:gd name="connsiteX4" fmla="*/ 1870385 w 4146420"/>
              <a:gd name="connsiteY4" fmla="*/ 940776 h 5881206"/>
              <a:gd name="connsiteX5" fmla="*/ 2987985 w 4146420"/>
              <a:gd name="connsiteY5" fmla="*/ 1347176 h 5881206"/>
              <a:gd name="connsiteX6" fmla="*/ 4067485 w 4146420"/>
              <a:gd name="connsiteY6" fmla="*/ 4191976 h 5881206"/>
              <a:gd name="connsiteX7" fmla="*/ 3838885 w 4146420"/>
              <a:gd name="connsiteY7" fmla="*/ 4242776 h 5881206"/>
              <a:gd name="connsiteX8" fmla="*/ 2048185 w 4146420"/>
              <a:gd name="connsiteY8" fmla="*/ 5042876 h 5881206"/>
              <a:gd name="connsiteX9" fmla="*/ 1425885 w 4146420"/>
              <a:gd name="connsiteY9" fmla="*/ 5614376 h 5881206"/>
              <a:gd name="connsiteX10" fmla="*/ 32854 w 4146420"/>
              <a:gd name="connsiteY10" fmla="*/ 435157 h 5881206"/>
              <a:gd name="connsiteX0" fmla="*/ 32854 w 4146420"/>
              <a:gd name="connsiteY0" fmla="*/ 435157 h 5881206"/>
              <a:gd name="connsiteX1" fmla="*/ 486085 w 4146420"/>
              <a:gd name="connsiteY1" fmla="*/ 293076 h 5881206"/>
              <a:gd name="connsiteX2" fmla="*/ 1019485 w 4146420"/>
              <a:gd name="connsiteY2" fmla="*/ 445476 h 5881206"/>
              <a:gd name="connsiteX3" fmla="*/ 1286185 w 4146420"/>
              <a:gd name="connsiteY3" fmla="*/ 547076 h 5881206"/>
              <a:gd name="connsiteX4" fmla="*/ 1870385 w 4146420"/>
              <a:gd name="connsiteY4" fmla="*/ 940776 h 5881206"/>
              <a:gd name="connsiteX5" fmla="*/ 2987985 w 4146420"/>
              <a:gd name="connsiteY5" fmla="*/ 1347176 h 5881206"/>
              <a:gd name="connsiteX6" fmla="*/ 4067485 w 4146420"/>
              <a:gd name="connsiteY6" fmla="*/ 4191976 h 5881206"/>
              <a:gd name="connsiteX7" fmla="*/ 3838885 w 4146420"/>
              <a:gd name="connsiteY7" fmla="*/ 4242776 h 5881206"/>
              <a:gd name="connsiteX8" fmla="*/ 2048185 w 4146420"/>
              <a:gd name="connsiteY8" fmla="*/ 5042876 h 5881206"/>
              <a:gd name="connsiteX9" fmla="*/ 1425885 w 4146420"/>
              <a:gd name="connsiteY9" fmla="*/ 5614376 h 5881206"/>
              <a:gd name="connsiteX10" fmla="*/ 32854 w 4146420"/>
              <a:gd name="connsiteY10" fmla="*/ 435157 h 5881206"/>
              <a:gd name="connsiteX0" fmla="*/ 0 w 4113566"/>
              <a:gd name="connsiteY0" fmla="*/ 142096 h 5588145"/>
              <a:gd name="connsiteX1" fmla="*/ 453231 w 4113566"/>
              <a:gd name="connsiteY1" fmla="*/ 15 h 5588145"/>
              <a:gd name="connsiteX2" fmla="*/ 986631 w 4113566"/>
              <a:gd name="connsiteY2" fmla="*/ 152415 h 5588145"/>
              <a:gd name="connsiteX3" fmla="*/ 1253331 w 4113566"/>
              <a:gd name="connsiteY3" fmla="*/ 254015 h 5588145"/>
              <a:gd name="connsiteX4" fmla="*/ 1837531 w 4113566"/>
              <a:gd name="connsiteY4" fmla="*/ 647715 h 5588145"/>
              <a:gd name="connsiteX5" fmla="*/ 2955131 w 4113566"/>
              <a:gd name="connsiteY5" fmla="*/ 1054115 h 5588145"/>
              <a:gd name="connsiteX6" fmla="*/ 4034631 w 4113566"/>
              <a:gd name="connsiteY6" fmla="*/ 3898915 h 5588145"/>
              <a:gd name="connsiteX7" fmla="*/ 3806031 w 4113566"/>
              <a:gd name="connsiteY7" fmla="*/ 3949715 h 5588145"/>
              <a:gd name="connsiteX8" fmla="*/ 2015331 w 4113566"/>
              <a:gd name="connsiteY8" fmla="*/ 4749815 h 5588145"/>
              <a:gd name="connsiteX9" fmla="*/ 1393031 w 4113566"/>
              <a:gd name="connsiteY9" fmla="*/ 5321315 h 5588145"/>
              <a:gd name="connsiteX10" fmla="*/ 0 w 4113566"/>
              <a:gd name="connsiteY10" fmla="*/ 142096 h 5588145"/>
              <a:gd name="connsiteX0" fmla="*/ 0 w 4113566"/>
              <a:gd name="connsiteY0" fmla="*/ 142096 h 5588145"/>
              <a:gd name="connsiteX1" fmla="*/ 453231 w 4113566"/>
              <a:gd name="connsiteY1" fmla="*/ 15 h 5588145"/>
              <a:gd name="connsiteX2" fmla="*/ 986631 w 4113566"/>
              <a:gd name="connsiteY2" fmla="*/ 152415 h 5588145"/>
              <a:gd name="connsiteX3" fmla="*/ 1253331 w 4113566"/>
              <a:gd name="connsiteY3" fmla="*/ 254015 h 5588145"/>
              <a:gd name="connsiteX4" fmla="*/ 1837531 w 4113566"/>
              <a:gd name="connsiteY4" fmla="*/ 647715 h 5588145"/>
              <a:gd name="connsiteX5" fmla="*/ 2955131 w 4113566"/>
              <a:gd name="connsiteY5" fmla="*/ 1054115 h 5588145"/>
              <a:gd name="connsiteX6" fmla="*/ 4034631 w 4113566"/>
              <a:gd name="connsiteY6" fmla="*/ 3898915 h 5588145"/>
              <a:gd name="connsiteX7" fmla="*/ 3806031 w 4113566"/>
              <a:gd name="connsiteY7" fmla="*/ 3949715 h 5588145"/>
              <a:gd name="connsiteX8" fmla="*/ 2015331 w 4113566"/>
              <a:gd name="connsiteY8" fmla="*/ 4749815 h 5588145"/>
              <a:gd name="connsiteX9" fmla="*/ 1393031 w 4113566"/>
              <a:gd name="connsiteY9" fmla="*/ 5321315 h 5588145"/>
              <a:gd name="connsiteX10" fmla="*/ 0 w 4113566"/>
              <a:gd name="connsiteY10" fmla="*/ 142096 h 5588145"/>
              <a:gd name="connsiteX0" fmla="*/ 0 w 4113566"/>
              <a:gd name="connsiteY0" fmla="*/ 144476 h 5590525"/>
              <a:gd name="connsiteX1" fmla="*/ 427038 w 4113566"/>
              <a:gd name="connsiteY1" fmla="*/ 13 h 5590525"/>
              <a:gd name="connsiteX2" fmla="*/ 986631 w 4113566"/>
              <a:gd name="connsiteY2" fmla="*/ 154795 h 5590525"/>
              <a:gd name="connsiteX3" fmla="*/ 1253331 w 4113566"/>
              <a:gd name="connsiteY3" fmla="*/ 256395 h 5590525"/>
              <a:gd name="connsiteX4" fmla="*/ 1837531 w 4113566"/>
              <a:gd name="connsiteY4" fmla="*/ 650095 h 5590525"/>
              <a:gd name="connsiteX5" fmla="*/ 2955131 w 4113566"/>
              <a:gd name="connsiteY5" fmla="*/ 1056495 h 5590525"/>
              <a:gd name="connsiteX6" fmla="*/ 4034631 w 4113566"/>
              <a:gd name="connsiteY6" fmla="*/ 3901295 h 5590525"/>
              <a:gd name="connsiteX7" fmla="*/ 3806031 w 4113566"/>
              <a:gd name="connsiteY7" fmla="*/ 3952095 h 5590525"/>
              <a:gd name="connsiteX8" fmla="*/ 2015331 w 4113566"/>
              <a:gd name="connsiteY8" fmla="*/ 4752195 h 5590525"/>
              <a:gd name="connsiteX9" fmla="*/ 1393031 w 4113566"/>
              <a:gd name="connsiteY9" fmla="*/ 5323695 h 5590525"/>
              <a:gd name="connsiteX10" fmla="*/ 0 w 4113566"/>
              <a:gd name="connsiteY10" fmla="*/ 144476 h 5590525"/>
              <a:gd name="connsiteX0" fmla="*/ 0 w 4113566"/>
              <a:gd name="connsiteY0" fmla="*/ 144696 h 5590745"/>
              <a:gd name="connsiteX1" fmla="*/ 427038 w 4113566"/>
              <a:gd name="connsiteY1" fmla="*/ 233 h 5590745"/>
              <a:gd name="connsiteX2" fmla="*/ 1050925 w 4113566"/>
              <a:gd name="connsiteY2" fmla="*/ 188353 h 5590745"/>
              <a:gd name="connsiteX3" fmla="*/ 1253331 w 4113566"/>
              <a:gd name="connsiteY3" fmla="*/ 256615 h 5590745"/>
              <a:gd name="connsiteX4" fmla="*/ 1837531 w 4113566"/>
              <a:gd name="connsiteY4" fmla="*/ 650315 h 5590745"/>
              <a:gd name="connsiteX5" fmla="*/ 2955131 w 4113566"/>
              <a:gd name="connsiteY5" fmla="*/ 1056715 h 5590745"/>
              <a:gd name="connsiteX6" fmla="*/ 4034631 w 4113566"/>
              <a:gd name="connsiteY6" fmla="*/ 3901515 h 5590745"/>
              <a:gd name="connsiteX7" fmla="*/ 3806031 w 4113566"/>
              <a:gd name="connsiteY7" fmla="*/ 3952315 h 5590745"/>
              <a:gd name="connsiteX8" fmla="*/ 2015331 w 4113566"/>
              <a:gd name="connsiteY8" fmla="*/ 4752415 h 5590745"/>
              <a:gd name="connsiteX9" fmla="*/ 1393031 w 4113566"/>
              <a:gd name="connsiteY9" fmla="*/ 5323915 h 5590745"/>
              <a:gd name="connsiteX10" fmla="*/ 0 w 4113566"/>
              <a:gd name="connsiteY10" fmla="*/ 144696 h 5590745"/>
              <a:gd name="connsiteX0" fmla="*/ 0 w 4113566"/>
              <a:gd name="connsiteY0" fmla="*/ 144696 h 5590745"/>
              <a:gd name="connsiteX1" fmla="*/ 427038 w 4113566"/>
              <a:gd name="connsiteY1" fmla="*/ 233 h 5590745"/>
              <a:gd name="connsiteX2" fmla="*/ 1050925 w 4113566"/>
              <a:gd name="connsiteY2" fmla="*/ 188353 h 5590745"/>
              <a:gd name="connsiteX3" fmla="*/ 1253331 w 4113566"/>
              <a:gd name="connsiteY3" fmla="*/ 256615 h 5590745"/>
              <a:gd name="connsiteX4" fmla="*/ 1837531 w 4113566"/>
              <a:gd name="connsiteY4" fmla="*/ 650315 h 5590745"/>
              <a:gd name="connsiteX5" fmla="*/ 2955131 w 4113566"/>
              <a:gd name="connsiteY5" fmla="*/ 1056715 h 5590745"/>
              <a:gd name="connsiteX6" fmla="*/ 4034631 w 4113566"/>
              <a:gd name="connsiteY6" fmla="*/ 3901515 h 5590745"/>
              <a:gd name="connsiteX7" fmla="*/ 3806031 w 4113566"/>
              <a:gd name="connsiteY7" fmla="*/ 3952315 h 5590745"/>
              <a:gd name="connsiteX8" fmla="*/ 2015331 w 4113566"/>
              <a:gd name="connsiteY8" fmla="*/ 4752415 h 5590745"/>
              <a:gd name="connsiteX9" fmla="*/ 1393031 w 4113566"/>
              <a:gd name="connsiteY9" fmla="*/ 5323915 h 5590745"/>
              <a:gd name="connsiteX10" fmla="*/ 0 w 4113566"/>
              <a:gd name="connsiteY10" fmla="*/ 144696 h 5590745"/>
              <a:gd name="connsiteX0" fmla="*/ 0 w 4113566"/>
              <a:gd name="connsiteY0" fmla="*/ 144696 h 5590745"/>
              <a:gd name="connsiteX1" fmla="*/ 427038 w 4113566"/>
              <a:gd name="connsiteY1" fmla="*/ 233 h 5590745"/>
              <a:gd name="connsiteX2" fmla="*/ 1050925 w 4113566"/>
              <a:gd name="connsiteY2" fmla="*/ 188353 h 5590745"/>
              <a:gd name="connsiteX3" fmla="*/ 1253331 w 4113566"/>
              <a:gd name="connsiteY3" fmla="*/ 256615 h 5590745"/>
              <a:gd name="connsiteX4" fmla="*/ 1837531 w 4113566"/>
              <a:gd name="connsiteY4" fmla="*/ 650315 h 5590745"/>
              <a:gd name="connsiteX5" fmla="*/ 2955131 w 4113566"/>
              <a:gd name="connsiteY5" fmla="*/ 1056715 h 5590745"/>
              <a:gd name="connsiteX6" fmla="*/ 4034631 w 4113566"/>
              <a:gd name="connsiteY6" fmla="*/ 3901515 h 5590745"/>
              <a:gd name="connsiteX7" fmla="*/ 3806031 w 4113566"/>
              <a:gd name="connsiteY7" fmla="*/ 3952315 h 5590745"/>
              <a:gd name="connsiteX8" fmla="*/ 2015331 w 4113566"/>
              <a:gd name="connsiteY8" fmla="*/ 4752415 h 5590745"/>
              <a:gd name="connsiteX9" fmla="*/ 1393031 w 4113566"/>
              <a:gd name="connsiteY9" fmla="*/ 5323915 h 5590745"/>
              <a:gd name="connsiteX10" fmla="*/ 0 w 4113566"/>
              <a:gd name="connsiteY10" fmla="*/ 144696 h 5590745"/>
              <a:gd name="connsiteX0" fmla="*/ 0 w 4113566"/>
              <a:gd name="connsiteY0" fmla="*/ 144696 h 5590745"/>
              <a:gd name="connsiteX1" fmla="*/ 427038 w 4113566"/>
              <a:gd name="connsiteY1" fmla="*/ 233 h 5590745"/>
              <a:gd name="connsiteX2" fmla="*/ 1050925 w 4113566"/>
              <a:gd name="connsiteY2" fmla="*/ 188353 h 5590745"/>
              <a:gd name="connsiteX3" fmla="*/ 1253331 w 4113566"/>
              <a:gd name="connsiteY3" fmla="*/ 256615 h 5590745"/>
              <a:gd name="connsiteX4" fmla="*/ 1837531 w 4113566"/>
              <a:gd name="connsiteY4" fmla="*/ 650315 h 5590745"/>
              <a:gd name="connsiteX5" fmla="*/ 2955131 w 4113566"/>
              <a:gd name="connsiteY5" fmla="*/ 1056715 h 5590745"/>
              <a:gd name="connsiteX6" fmla="*/ 4034631 w 4113566"/>
              <a:gd name="connsiteY6" fmla="*/ 3901515 h 5590745"/>
              <a:gd name="connsiteX7" fmla="*/ 3806031 w 4113566"/>
              <a:gd name="connsiteY7" fmla="*/ 3952315 h 5590745"/>
              <a:gd name="connsiteX8" fmla="*/ 2015331 w 4113566"/>
              <a:gd name="connsiteY8" fmla="*/ 4752415 h 5590745"/>
              <a:gd name="connsiteX9" fmla="*/ 1393031 w 4113566"/>
              <a:gd name="connsiteY9" fmla="*/ 5323915 h 5590745"/>
              <a:gd name="connsiteX10" fmla="*/ 0 w 4113566"/>
              <a:gd name="connsiteY10" fmla="*/ 144696 h 5590745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53331 w 4113566"/>
              <a:gd name="connsiteY3" fmla="*/ 256410 h 5590540"/>
              <a:gd name="connsiteX4" fmla="*/ 1837531 w 4113566"/>
              <a:gd name="connsiteY4" fmla="*/ 650110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837531 w 4113566"/>
              <a:gd name="connsiteY4" fmla="*/ 650110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837531 w 4113566"/>
              <a:gd name="connsiteY4" fmla="*/ 650110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837531 w 4113566"/>
              <a:gd name="connsiteY4" fmla="*/ 650110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837531 w 4113566"/>
              <a:gd name="connsiteY4" fmla="*/ 650110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928019 w 4113566"/>
              <a:gd name="connsiteY4" fmla="*/ 673922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928019 w 4113566"/>
              <a:gd name="connsiteY4" fmla="*/ 673922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3566"/>
              <a:gd name="connsiteY0" fmla="*/ 144491 h 5590540"/>
              <a:gd name="connsiteX1" fmla="*/ 427038 w 4113566"/>
              <a:gd name="connsiteY1" fmla="*/ 28 h 5590540"/>
              <a:gd name="connsiteX2" fmla="*/ 1050925 w 4113566"/>
              <a:gd name="connsiteY2" fmla="*/ 188148 h 5590540"/>
              <a:gd name="connsiteX3" fmla="*/ 1219994 w 4113566"/>
              <a:gd name="connsiteY3" fmla="*/ 227835 h 5590540"/>
              <a:gd name="connsiteX4" fmla="*/ 1928019 w 4113566"/>
              <a:gd name="connsiteY4" fmla="*/ 673922 h 5590540"/>
              <a:gd name="connsiteX5" fmla="*/ 2955131 w 4113566"/>
              <a:gd name="connsiteY5" fmla="*/ 1056510 h 5590540"/>
              <a:gd name="connsiteX6" fmla="*/ 4034631 w 4113566"/>
              <a:gd name="connsiteY6" fmla="*/ 3901310 h 5590540"/>
              <a:gd name="connsiteX7" fmla="*/ 3806031 w 4113566"/>
              <a:gd name="connsiteY7" fmla="*/ 3952110 h 5590540"/>
              <a:gd name="connsiteX8" fmla="*/ 2015331 w 4113566"/>
              <a:gd name="connsiteY8" fmla="*/ 4752210 h 5590540"/>
              <a:gd name="connsiteX9" fmla="*/ 1393031 w 4113566"/>
              <a:gd name="connsiteY9" fmla="*/ 5323710 h 5590540"/>
              <a:gd name="connsiteX10" fmla="*/ 0 w 4113566"/>
              <a:gd name="connsiteY10" fmla="*/ 144491 h 5590540"/>
              <a:gd name="connsiteX0" fmla="*/ 0 w 4110052"/>
              <a:gd name="connsiteY0" fmla="*/ 144491 h 5590540"/>
              <a:gd name="connsiteX1" fmla="*/ 427038 w 4110052"/>
              <a:gd name="connsiteY1" fmla="*/ 28 h 5590540"/>
              <a:gd name="connsiteX2" fmla="*/ 1050925 w 4110052"/>
              <a:gd name="connsiteY2" fmla="*/ 188148 h 5590540"/>
              <a:gd name="connsiteX3" fmla="*/ 1219994 w 4110052"/>
              <a:gd name="connsiteY3" fmla="*/ 227835 h 5590540"/>
              <a:gd name="connsiteX4" fmla="*/ 1928019 w 4110052"/>
              <a:gd name="connsiteY4" fmla="*/ 673922 h 5590540"/>
              <a:gd name="connsiteX5" fmla="*/ 3002756 w 4110052"/>
              <a:gd name="connsiteY5" fmla="*/ 1096991 h 5590540"/>
              <a:gd name="connsiteX6" fmla="*/ 4034631 w 4110052"/>
              <a:gd name="connsiteY6" fmla="*/ 3901310 h 5590540"/>
              <a:gd name="connsiteX7" fmla="*/ 3806031 w 4110052"/>
              <a:gd name="connsiteY7" fmla="*/ 3952110 h 5590540"/>
              <a:gd name="connsiteX8" fmla="*/ 2015331 w 4110052"/>
              <a:gd name="connsiteY8" fmla="*/ 4752210 h 5590540"/>
              <a:gd name="connsiteX9" fmla="*/ 1393031 w 4110052"/>
              <a:gd name="connsiteY9" fmla="*/ 5323710 h 5590540"/>
              <a:gd name="connsiteX10" fmla="*/ 0 w 4110052"/>
              <a:gd name="connsiteY10" fmla="*/ 144491 h 5590540"/>
              <a:gd name="connsiteX0" fmla="*/ 0 w 4110052"/>
              <a:gd name="connsiteY0" fmla="*/ 144491 h 5590540"/>
              <a:gd name="connsiteX1" fmla="*/ 427038 w 4110052"/>
              <a:gd name="connsiteY1" fmla="*/ 28 h 5590540"/>
              <a:gd name="connsiteX2" fmla="*/ 1050925 w 4110052"/>
              <a:gd name="connsiteY2" fmla="*/ 188148 h 5590540"/>
              <a:gd name="connsiteX3" fmla="*/ 1219994 w 4110052"/>
              <a:gd name="connsiteY3" fmla="*/ 227835 h 5590540"/>
              <a:gd name="connsiteX4" fmla="*/ 1928019 w 4110052"/>
              <a:gd name="connsiteY4" fmla="*/ 673922 h 5590540"/>
              <a:gd name="connsiteX5" fmla="*/ 3002756 w 4110052"/>
              <a:gd name="connsiteY5" fmla="*/ 1096991 h 5590540"/>
              <a:gd name="connsiteX6" fmla="*/ 4034631 w 4110052"/>
              <a:gd name="connsiteY6" fmla="*/ 3901310 h 5590540"/>
              <a:gd name="connsiteX7" fmla="*/ 3806031 w 4110052"/>
              <a:gd name="connsiteY7" fmla="*/ 3952110 h 5590540"/>
              <a:gd name="connsiteX8" fmla="*/ 2015331 w 4110052"/>
              <a:gd name="connsiteY8" fmla="*/ 4752210 h 5590540"/>
              <a:gd name="connsiteX9" fmla="*/ 1393031 w 4110052"/>
              <a:gd name="connsiteY9" fmla="*/ 5323710 h 5590540"/>
              <a:gd name="connsiteX10" fmla="*/ 0 w 4110052"/>
              <a:gd name="connsiteY10" fmla="*/ 144491 h 5590540"/>
              <a:gd name="connsiteX0" fmla="*/ 0 w 4110052"/>
              <a:gd name="connsiteY0" fmla="*/ 144491 h 5590540"/>
              <a:gd name="connsiteX1" fmla="*/ 427038 w 4110052"/>
              <a:gd name="connsiteY1" fmla="*/ 28 h 5590540"/>
              <a:gd name="connsiteX2" fmla="*/ 1050925 w 4110052"/>
              <a:gd name="connsiteY2" fmla="*/ 188148 h 5590540"/>
              <a:gd name="connsiteX3" fmla="*/ 1219994 w 4110052"/>
              <a:gd name="connsiteY3" fmla="*/ 227835 h 5590540"/>
              <a:gd name="connsiteX4" fmla="*/ 1928019 w 4110052"/>
              <a:gd name="connsiteY4" fmla="*/ 673922 h 5590540"/>
              <a:gd name="connsiteX5" fmla="*/ 3002756 w 4110052"/>
              <a:gd name="connsiteY5" fmla="*/ 1096991 h 5590540"/>
              <a:gd name="connsiteX6" fmla="*/ 4034631 w 4110052"/>
              <a:gd name="connsiteY6" fmla="*/ 3901310 h 5590540"/>
              <a:gd name="connsiteX7" fmla="*/ 3806031 w 4110052"/>
              <a:gd name="connsiteY7" fmla="*/ 3952110 h 5590540"/>
              <a:gd name="connsiteX8" fmla="*/ 2015331 w 4110052"/>
              <a:gd name="connsiteY8" fmla="*/ 4752210 h 5590540"/>
              <a:gd name="connsiteX9" fmla="*/ 1393031 w 4110052"/>
              <a:gd name="connsiteY9" fmla="*/ 5323710 h 5590540"/>
              <a:gd name="connsiteX10" fmla="*/ 0 w 4110052"/>
              <a:gd name="connsiteY10" fmla="*/ 144491 h 5590540"/>
              <a:gd name="connsiteX0" fmla="*/ 0 w 4110052"/>
              <a:gd name="connsiteY0" fmla="*/ 144491 h 5590540"/>
              <a:gd name="connsiteX1" fmla="*/ 427038 w 4110052"/>
              <a:gd name="connsiteY1" fmla="*/ 28 h 5590540"/>
              <a:gd name="connsiteX2" fmla="*/ 1050925 w 4110052"/>
              <a:gd name="connsiteY2" fmla="*/ 188148 h 5590540"/>
              <a:gd name="connsiteX3" fmla="*/ 1219994 w 4110052"/>
              <a:gd name="connsiteY3" fmla="*/ 227835 h 5590540"/>
              <a:gd name="connsiteX4" fmla="*/ 1928019 w 4110052"/>
              <a:gd name="connsiteY4" fmla="*/ 673922 h 5590540"/>
              <a:gd name="connsiteX5" fmla="*/ 3002756 w 4110052"/>
              <a:gd name="connsiteY5" fmla="*/ 1096991 h 5590540"/>
              <a:gd name="connsiteX6" fmla="*/ 4034631 w 4110052"/>
              <a:gd name="connsiteY6" fmla="*/ 3901310 h 5590540"/>
              <a:gd name="connsiteX7" fmla="*/ 3806031 w 4110052"/>
              <a:gd name="connsiteY7" fmla="*/ 3952110 h 5590540"/>
              <a:gd name="connsiteX8" fmla="*/ 2015331 w 4110052"/>
              <a:gd name="connsiteY8" fmla="*/ 4752210 h 5590540"/>
              <a:gd name="connsiteX9" fmla="*/ 1393031 w 4110052"/>
              <a:gd name="connsiteY9" fmla="*/ 5323710 h 5590540"/>
              <a:gd name="connsiteX10" fmla="*/ 0 w 4110052"/>
              <a:gd name="connsiteY10" fmla="*/ 144491 h 5590540"/>
              <a:gd name="connsiteX0" fmla="*/ 0 w 4110755"/>
              <a:gd name="connsiteY0" fmla="*/ 144491 h 5590540"/>
              <a:gd name="connsiteX1" fmla="*/ 427038 w 4110755"/>
              <a:gd name="connsiteY1" fmla="*/ 28 h 5590540"/>
              <a:gd name="connsiteX2" fmla="*/ 1050925 w 4110755"/>
              <a:gd name="connsiteY2" fmla="*/ 188148 h 5590540"/>
              <a:gd name="connsiteX3" fmla="*/ 1219994 w 4110755"/>
              <a:gd name="connsiteY3" fmla="*/ 227835 h 5590540"/>
              <a:gd name="connsiteX4" fmla="*/ 1928019 w 4110755"/>
              <a:gd name="connsiteY4" fmla="*/ 673922 h 5590540"/>
              <a:gd name="connsiteX5" fmla="*/ 2993231 w 4110755"/>
              <a:gd name="connsiteY5" fmla="*/ 918397 h 5590540"/>
              <a:gd name="connsiteX6" fmla="*/ 4034631 w 4110755"/>
              <a:gd name="connsiteY6" fmla="*/ 3901310 h 5590540"/>
              <a:gd name="connsiteX7" fmla="*/ 3806031 w 4110755"/>
              <a:gd name="connsiteY7" fmla="*/ 3952110 h 5590540"/>
              <a:gd name="connsiteX8" fmla="*/ 2015331 w 4110755"/>
              <a:gd name="connsiteY8" fmla="*/ 4752210 h 5590540"/>
              <a:gd name="connsiteX9" fmla="*/ 1393031 w 4110755"/>
              <a:gd name="connsiteY9" fmla="*/ 5323710 h 5590540"/>
              <a:gd name="connsiteX10" fmla="*/ 0 w 4110755"/>
              <a:gd name="connsiteY10" fmla="*/ 144491 h 5590540"/>
              <a:gd name="connsiteX0" fmla="*/ 0 w 4111106"/>
              <a:gd name="connsiteY0" fmla="*/ 144491 h 5590540"/>
              <a:gd name="connsiteX1" fmla="*/ 427038 w 4111106"/>
              <a:gd name="connsiteY1" fmla="*/ 28 h 5590540"/>
              <a:gd name="connsiteX2" fmla="*/ 1050925 w 4111106"/>
              <a:gd name="connsiteY2" fmla="*/ 188148 h 5590540"/>
              <a:gd name="connsiteX3" fmla="*/ 1219994 w 4111106"/>
              <a:gd name="connsiteY3" fmla="*/ 227835 h 5590540"/>
              <a:gd name="connsiteX4" fmla="*/ 1928019 w 4111106"/>
              <a:gd name="connsiteY4" fmla="*/ 673922 h 5590540"/>
              <a:gd name="connsiteX5" fmla="*/ 2988469 w 4111106"/>
              <a:gd name="connsiteY5" fmla="*/ 1092229 h 5590540"/>
              <a:gd name="connsiteX6" fmla="*/ 4034631 w 4111106"/>
              <a:gd name="connsiteY6" fmla="*/ 3901310 h 5590540"/>
              <a:gd name="connsiteX7" fmla="*/ 3806031 w 4111106"/>
              <a:gd name="connsiteY7" fmla="*/ 3952110 h 5590540"/>
              <a:gd name="connsiteX8" fmla="*/ 2015331 w 4111106"/>
              <a:gd name="connsiteY8" fmla="*/ 4752210 h 5590540"/>
              <a:gd name="connsiteX9" fmla="*/ 1393031 w 4111106"/>
              <a:gd name="connsiteY9" fmla="*/ 5323710 h 5590540"/>
              <a:gd name="connsiteX10" fmla="*/ 0 w 4111106"/>
              <a:gd name="connsiteY10" fmla="*/ 144491 h 5590540"/>
              <a:gd name="connsiteX0" fmla="*/ 0 w 4107554"/>
              <a:gd name="connsiteY0" fmla="*/ 144491 h 5590540"/>
              <a:gd name="connsiteX1" fmla="*/ 427038 w 4107554"/>
              <a:gd name="connsiteY1" fmla="*/ 28 h 5590540"/>
              <a:gd name="connsiteX2" fmla="*/ 1050925 w 4107554"/>
              <a:gd name="connsiteY2" fmla="*/ 188148 h 5590540"/>
              <a:gd name="connsiteX3" fmla="*/ 1219994 w 4107554"/>
              <a:gd name="connsiteY3" fmla="*/ 227835 h 5590540"/>
              <a:gd name="connsiteX4" fmla="*/ 1928019 w 4107554"/>
              <a:gd name="connsiteY4" fmla="*/ 673922 h 5590540"/>
              <a:gd name="connsiteX5" fmla="*/ 2988469 w 4107554"/>
              <a:gd name="connsiteY5" fmla="*/ 1092229 h 5590540"/>
              <a:gd name="connsiteX6" fmla="*/ 4029868 w 4107554"/>
              <a:gd name="connsiteY6" fmla="*/ 3884642 h 5590540"/>
              <a:gd name="connsiteX7" fmla="*/ 3806031 w 4107554"/>
              <a:gd name="connsiteY7" fmla="*/ 3952110 h 5590540"/>
              <a:gd name="connsiteX8" fmla="*/ 2015331 w 4107554"/>
              <a:gd name="connsiteY8" fmla="*/ 4752210 h 5590540"/>
              <a:gd name="connsiteX9" fmla="*/ 1393031 w 4107554"/>
              <a:gd name="connsiteY9" fmla="*/ 5323710 h 5590540"/>
              <a:gd name="connsiteX10" fmla="*/ 0 w 4107554"/>
              <a:gd name="connsiteY10" fmla="*/ 144491 h 5590540"/>
              <a:gd name="connsiteX0" fmla="*/ 0 w 4029868"/>
              <a:gd name="connsiteY0" fmla="*/ 144491 h 5590540"/>
              <a:gd name="connsiteX1" fmla="*/ 427038 w 4029868"/>
              <a:gd name="connsiteY1" fmla="*/ 28 h 5590540"/>
              <a:gd name="connsiteX2" fmla="*/ 1050925 w 4029868"/>
              <a:gd name="connsiteY2" fmla="*/ 188148 h 5590540"/>
              <a:gd name="connsiteX3" fmla="*/ 1219994 w 4029868"/>
              <a:gd name="connsiteY3" fmla="*/ 227835 h 5590540"/>
              <a:gd name="connsiteX4" fmla="*/ 1928019 w 4029868"/>
              <a:gd name="connsiteY4" fmla="*/ 673922 h 5590540"/>
              <a:gd name="connsiteX5" fmla="*/ 2988469 w 4029868"/>
              <a:gd name="connsiteY5" fmla="*/ 1092229 h 5590540"/>
              <a:gd name="connsiteX6" fmla="*/ 4029868 w 4029868"/>
              <a:gd name="connsiteY6" fmla="*/ 3884642 h 5590540"/>
              <a:gd name="connsiteX7" fmla="*/ 3806031 w 4029868"/>
              <a:gd name="connsiteY7" fmla="*/ 3952110 h 5590540"/>
              <a:gd name="connsiteX8" fmla="*/ 2015331 w 4029868"/>
              <a:gd name="connsiteY8" fmla="*/ 4752210 h 5590540"/>
              <a:gd name="connsiteX9" fmla="*/ 1393031 w 4029868"/>
              <a:gd name="connsiteY9" fmla="*/ 5323710 h 5590540"/>
              <a:gd name="connsiteX10" fmla="*/ 0 w 4029868"/>
              <a:gd name="connsiteY10" fmla="*/ 144491 h 5590540"/>
              <a:gd name="connsiteX0" fmla="*/ 0 w 4065607"/>
              <a:gd name="connsiteY0" fmla="*/ 144491 h 5590540"/>
              <a:gd name="connsiteX1" fmla="*/ 427038 w 4065607"/>
              <a:gd name="connsiteY1" fmla="*/ 28 h 5590540"/>
              <a:gd name="connsiteX2" fmla="*/ 1050925 w 4065607"/>
              <a:gd name="connsiteY2" fmla="*/ 188148 h 5590540"/>
              <a:gd name="connsiteX3" fmla="*/ 1219994 w 4065607"/>
              <a:gd name="connsiteY3" fmla="*/ 227835 h 5590540"/>
              <a:gd name="connsiteX4" fmla="*/ 1928019 w 4065607"/>
              <a:gd name="connsiteY4" fmla="*/ 673922 h 5590540"/>
              <a:gd name="connsiteX5" fmla="*/ 2988469 w 4065607"/>
              <a:gd name="connsiteY5" fmla="*/ 1092229 h 5590540"/>
              <a:gd name="connsiteX6" fmla="*/ 4029868 w 4065607"/>
              <a:gd name="connsiteY6" fmla="*/ 3884642 h 5590540"/>
              <a:gd name="connsiteX7" fmla="*/ 3801269 w 4065607"/>
              <a:gd name="connsiteY7" fmla="*/ 3975923 h 5590540"/>
              <a:gd name="connsiteX8" fmla="*/ 2015331 w 4065607"/>
              <a:gd name="connsiteY8" fmla="*/ 4752210 h 5590540"/>
              <a:gd name="connsiteX9" fmla="*/ 1393031 w 4065607"/>
              <a:gd name="connsiteY9" fmla="*/ 5323710 h 5590540"/>
              <a:gd name="connsiteX10" fmla="*/ 0 w 4065607"/>
              <a:gd name="connsiteY10" fmla="*/ 144491 h 5590540"/>
              <a:gd name="connsiteX0" fmla="*/ 0 w 4029868"/>
              <a:gd name="connsiteY0" fmla="*/ 144491 h 5590540"/>
              <a:gd name="connsiteX1" fmla="*/ 427038 w 4029868"/>
              <a:gd name="connsiteY1" fmla="*/ 28 h 5590540"/>
              <a:gd name="connsiteX2" fmla="*/ 1050925 w 4029868"/>
              <a:gd name="connsiteY2" fmla="*/ 188148 h 5590540"/>
              <a:gd name="connsiteX3" fmla="*/ 1219994 w 4029868"/>
              <a:gd name="connsiteY3" fmla="*/ 227835 h 5590540"/>
              <a:gd name="connsiteX4" fmla="*/ 1928019 w 4029868"/>
              <a:gd name="connsiteY4" fmla="*/ 673922 h 5590540"/>
              <a:gd name="connsiteX5" fmla="*/ 2988469 w 4029868"/>
              <a:gd name="connsiteY5" fmla="*/ 1092229 h 5590540"/>
              <a:gd name="connsiteX6" fmla="*/ 4029868 w 4029868"/>
              <a:gd name="connsiteY6" fmla="*/ 3884642 h 5590540"/>
              <a:gd name="connsiteX7" fmla="*/ 3801269 w 4029868"/>
              <a:gd name="connsiteY7" fmla="*/ 3975923 h 5590540"/>
              <a:gd name="connsiteX8" fmla="*/ 2015331 w 4029868"/>
              <a:gd name="connsiteY8" fmla="*/ 4752210 h 5590540"/>
              <a:gd name="connsiteX9" fmla="*/ 1393031 w 4029868"/>
              <a:gd name="connsiteY9" fmla="*/ 5323710 h 5590540"/>
              <a:gd name="connsiteX10" fmla="*/ 0 w 4029868"/>
              <a:gd name="connsiteY10" fmla="*/ 144491 h 5590540"/>
              <a:gd name="connsiteX0" fmla="*/ 0 w 4029868"/>
              <a:gd name="connsiteY0" fmla="*/ 144491 h 5323710"/>
              <a:gd name="connsiteX1" fmla="*/ 427038 w 4029868"/>
              <a:gd name="connsiteY1" fmla="*/ 28 h 5323710"/>
              <a:gd name="connsiteX2" fmla="*/ 1050925 w 4029868"/>
              <a:gd name="connsiteY2" fmla="*/ 188148 h 5323710"/>
              <a:gd name="connsiteX3" fmla="*/ 1219994 w 4029868"/>
              <a:gd name="connsiteY3" fmla="*/ 227835 h 5323710"/>
              <a:gd name="connsiteX4" fmla="*/ 1928019 w 4029868"/>
              <a:gd name="connsiteY4" fmla="*/ 673922 h 5323710"/>
              <a:gd name="connsiteX5" fmla="*/ 2988469 w 4029868"/>
              <a:gd name="connsiteY5" fmla="*/ 1092229 h 5323710"/>
              <a:gd name="connsiteX6" fmla="*/ 4029868 w 4029868"/>
              <a:gd name="connsiteY6" fmla="*/ 3884642 h 5323710"/>
              <a:gd name="connsiteX7" fmla="*/ 3801269 w 4029868"/>
              <a:gd name="connsiteY7" fmla="*/ 3975923 h 5323710"/>
              <a:gd name="connsiteX8" fmla="*/ 2015331 w 4029868"/>
              <a:gd name="connsiteY8" fmla="*/ 4752210 h 5323710"/>
              <a:gd name="connsiteX9" fmla="*/ 1393031 w 4029868"/>
              <a:gd name="connsiteY9" fmla="*/ 5323710 h 5323710"/>
              <a:gd name="connsiteX10" fmla="*/ 0 w 4029868"/>
              <a:gd name="connsiteY10" fmla="*/ 144491 h 5323710"/>
              <a:gd name="connsiteX0" fmla="*/ 0 w 4029868"/>
              <a:gd name="connsiteY0" fmla="*/ 144491 h 5309423"/>
              <a:gd name="connsiteX1" fmla="*/ 427038 w 4029868"/>
              <a:gd name="connsiteY1" fmla="*/ 28 h 5309423"/>
              <a:gd name="connsiteX2" fmla="*/ 1050925 w 4029868"/>
              <a:gd name="connsiteY2" fmla="*/ 188148 h 5309423"/>
              <a:gd name="connsiteX3" fmla="*/ 1219994 w 4029868"/>
              <a:gd name="connsiteY3" fmla="*/ 227835 h 5309423"/>
              <a:gd name="connsiteX4" fmla="*/ 1928019 w 4029868"/>
              <a:gd name="connsiteY4" fmla="*/ 673922 h 5309423"/>
              <a:gd name="connsiteX5" fmla="*/ 2988469 w 4029868"/>
              <a:gd name="connsiteY5" fmla="*/ 1092229 h 5309423"/>
              <a:gd name="connsiteX6" fmla="*/ 4029868 w 4029868"/>
              <a:gd name="connsiteY6" fmla="*/ 3884642 h 5309423"/>
              <a:gd name="connsiteX7" fmla="*/ 3801269 w 4029868"/>
              <a:gd name="connsiteY7" fmla="*/ 3975923 h 5309423"/>
              <a:gd name="connsiteX8" fmla="*/ 2015331 w 4029868"/>
              <a:gd name="connsiteY8" fmla="*/ 4752210 h 5309423"/>
              <a:gd name="connsiteX9" fmla="*/ 1431131 w 4029868"/>
              <a:gd name="connsiteY9" fmla="*/ 5309423 h 5309423"/>
              <a:gd name="connsiteX10" fmla="*/ 0 w 4029868"/>
              <a:gd name="connsiteY10" fmla="*/ 144491 h 5309423"/>
              <a:gd name="connsiteX0" fmla="*/ 0 w 4029868"/>
              <a:gd name="connsiteY0" fmla="*/ 144491 h 5309423"/>
              <a:gd name="connsiteX1" fmla="*/ 427038 w 4029868"/>
              <a:gd name="connsiteY1" fmla="*/ 28 h 5309423"/>
              <a:gd name="connsiteX2" fmla="*/ 1050925 w 4029868"/>
              <a:gd name="connsiteY2" fmla="*/ 188148 h 5309423"/>
              <a:gd name="connsiteX3" fmla="*/ 1219994 w 4029868"/>
              <a:gd name="connsiteY3" fmla="*/ 227835 h 5309423"/>
              <a:gd name="connsiteX4" fmla="*/ 1928019 w 4029868"/>
              <a:gd name="connsiteY4" fmla="*/ 673922 h 5309423"/>
              <a:gd name="connsiteX5" fmla="*/ 2988469 w 4029868"/>
              <a:gd name="connsiteY5" fmla="*/ 1092229 h 5309423"/>
              <a:gd name="connsiteX6" fmla="*/ 4029868 w 4029868"/>
              <a:gd name="connsiteY6" fmla="*/ 3884642 h 5309423"/>
              <a:gd name="connsiteX7" fmla="*/ 3801269 w 4029868"/>
              <a:gd name="connsiteY7" fmla="*/ 3975923 h 5309423"/>
              <a:gd name="connsiteX8" fmla="*/ 2015331 w 4029868"/>
              <a:gd name="connsiteY8" fmla="*/ 4752210 h 5309423"/>
              <a:gd name="connsiteX9" fmla="*/ 1431131 w 4029868"/>
              <a:gd name="connsiteY9" fmla="*/ 5309423 h 5309423"/>
              <a:gd name="connsiteX10" fmla="*/ 0 w 4029868"/>
              <a:gd name="connsiteY10" fmla="*/ 144491 h 5309423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2015331 w 4029868"/>
              <a:gd name="connsiteY8" fmla="*/ 4752210 h 5333235"/>
              <a:gd name="connsiteX9" fmla="*/ 1385887 w 4029868"/>
              <a:gd name="connsiteY9" fmla="*/ 5333235 h 5333235"/>
              <a:gd name="connsiteX10" fmla="*/ 0 w 4029868"/>
              <a:gd name="connsiteY10" fmla="*/ 144491 h 5333235"/>
              <a:gd name="connsiteX0" fmla="*/ 0 w 4029868"/>
              <a:gd name="connsiteY0" fmla="*/ 144491 h 5603513"/>
              <a:gd name="connsiteX1" fmla="*/ 427038 w 4029868"/>
              <a:gd name="connsiteY1" fmla="*/ 28 h 5603513"/>
              <a:gd name="connsiteX2" fmla="*/ 1050925 w 4029868"/>
              <a:gd name="connsiteY2" fmla="*/ 188148 h 5603513"/>
              <a:gd name="connsiteX3" fmla="*/ 1219994 w 4029868"/>
              <a:gd name="connsiteY3" fmla="*/ 227835 h 5603513"/>
              <a:gd name="connsiteX4" fmla="*/ 1928019 w 4029868"/>
              <a:gd name="connsiteY4" fmla="*/ 673922 h 5603513"/>
              <a:gd name="connsiteX5" fmla="*/ 2988469 w 4029868"/>
              <a:gd name="connsiteY5" fmla="*/ 1092229 h 5603513"/>
              <a:gd name="connsiteX6" fmla="*/ 4029868 w 4029868"/>
              <a:gd name="connsiteY6" fmla="*/ 3884642 h 5603513"/>
              <a:gd name="connsiteX7" fmla="*/ 3801269 w 4029868"/>
              <a:gd name="connsiteY7" fmla="*/ 3975923 h 5603513"/>
              <a:gd name="connsiteX8" fmla="*/ 1920081 w 4029868"/>
              <a:gd name="connsiteY8" fmla="*/ 4806979 h 5603513"/>
              <a:gd name="connsiteX9" fmla="*/ 1385887 w 4029868"/>
              <a:gd name="connsiteY9" fmla="*/ 5333235 h 5603513"/>
              <a:gd name="connsiteX10" fmla="*/ 0 w 4029868"/>
              <a:gd name="connsiteY10" fmla="*/ 144491 h 5603513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0 w 4029868"/>
              <a:gd name="connsiteY10" fmla="*/ 144491 h 5333235"/>
              <a:gd name="connsiteX0" fmla="*/ 0 w 4069521"/>
              <a:gd name="connsiteY0" fmla="*/ 144491 h 5333235"/>
              <a:gd name="connsiteX1" fmla="*/ 427038 w 4069521"/>
              <a:gd name="connsiteY1" fmla="*/ 28 h 5333235"/>
              <a:gd name="connsiteX2" fmla="*/ 1050925 w 4069521"/>
              <a:gd name="connsiteY2" fmla="*/ 188148 h 5333235"/>
              <a:gd name="connsiteX3" fmla="*/ 1219994 w 4069521"/>
              <a:gd name="connsiteY3" fmla="*/ 227835 h 5333235"/>
              <a:gd name="connsiteX4" fmla="*/ 1928019 w 4069521"/>
              <a:gd name="connsiteY4" fmla="*/ 673922 h 5333235"/>
              <a:gd name="connsiteX5" fmla="*/ 2988469 w 4069521"/>
              <a:gd name="connsiteY5" fmla="*/ 1092229 h 5333235"/>
              <a:gd name="connsiteX6" fmla="*/ 3959224 w 4069521"/>
              <a:gd name="connsiteY6" fmla="*/ 3644928 h 5333235"/>
              <a:gd name="connsiteX7" fmla="*/ 4029868 w 4069521"/>
              <a:gd name="connsiteY7" fmla="*/ 3884642 h 5333235"/>
              <a:gd name="connsiteX8" fmla="*/ 3801269 w 4069521"/>
              <a:gd name="connsiteY8" fmla="*/ 3975923 h 5333235"/>
              <a:gd name="connsiteX9" fmla="*/ 1920081 w 4069521"/>
              <a:gd name="connsiteY9" fmla="*/ 4806979 h 5333235"/>
              <a:gd name="connsiteX10" fmla="*/ 1385887 w 4069521"/>
              <a:gd name="connsiteY10" fmla="*/ 5333235 h 5333235"/>
              <a:gd name="connsiteX11" fmla="*/ 0 w 4069521"/>
              <a:gd name="connsiteY11" fmla="*/ 144491 h 5333235"/>
              <a:gd name="connsiteX0" fmla="*/ 0 w 4069521"/>
              <a:gd name="connsiteY0" fmla="*/ 144491 h 5333235"/>
              <a:gd name="connsiteX1" fmla="*/ 427038 w 4069521"/>
              <a:gd name="connsiteY1" fmla="*/ 28 h 5333235"/>
              <a:gd name="connsiteX2" fmla="*/ 1050925 w 4069521"/>
              <a:gd name="connsiteY2" fmla="*/ 188148 h 5333235"/>
              <a:gd name="connsiteX3" fmla="*/ 1219994 w 4069521"/>
              <a:gd name="connsiteY3" fmla="*/ 227835 h 5333235"/>
              <a:gd name="connsiteX4" fmla="*/ 1928019 w 4069521"/>
              <a:gd name="connsiteY4" fmla="*/ 673922 h 5333235"/>
              <a:gd name="connsiteX5" fmla="*/ 2988469 w 4069521"/>
              <a:gd name="connsiteY5" fmla="*/ 1092229 h 5333235"/>
              <a:gd name="connsiteX6" fmla="*/ 3959224 w 4069521"/>
              <a:gd name="connsiteY6" fmla="*/ 3644928 h 5333235"/>
              <a:gd name="connsiteX7" fmla="*/ 4029868 w 4069521"/>
              <a:gd name="connsiteY7" fmla="*/ 3884642 h 5333235"/>
              <a:gd name="connsiteX8" fmla="*/ 3801269 w 4069521"/>
              <a:gd name="connsiteY8" fmla="*/ 3975923 h 5333235"/>
              <a:gd name="connsiteX9" fmla="*/ 1920081 w 4069521"/>
              <a:gd name="connsiteY9" fmla="*/ 4806979 h 5333235"/>
              <a:gd name="connsiteX10" fmla="*/ 1385887 w 4069521"/>
              <a:gd name="connsiteY10" fmla="*/ 5333235 h 5333235"/>
              <a:gd name="connsiteX11" fmla="*/ 0 w 4069521"/>
              <a:gd name="connsiteY11" fmla="*/ 144491 h 5333235"/>
              <a:gd name="connsiteX0" fmla="*/ 0 w 4048918"/>
              <a:gd name="connsiteY0" fmla="*/ 144491 h 5333235"/>
              <a:gd name="connsiteX1" fmla="*/ 427038 w 4048918"/>
              <a:gd name="connsiteY1" fmla="*/ 28 h 5333235"/>
              <a:gd name="connsiteX2" fmla="*/ 1050925 w 4048918"/>
              <a:gd name="connsiteY2" fmla="*/ 188148 h 5333235"/>
              <a:gd name="connsiteX3" fmla="*/ 1219994 w 4048918"/>
              <a:gd name="connsiteY3" fmla="*/ 227835 h 5333235"/>
              <a:gd name="connsiteX4" fmla="*/ 1928019 w 4048918"/>
              <a:gd name="connsiteY4" fmla="*/ 673922 h 5333235"/>
              <a:gd name="connsiteX5" fmla="*/ 2988469 w 4048918"/>
              <a:gd name="connsiteY5" fmla="*/ 1092229 h 5333235"/>
              <a:gd name="connsiteX6" fmla="*/ 3959224 w 4048918"/>
              <a:gd name="connsiteY6" fmla="*/ 3644928 h 5333235"/>
              <a:gd name="connsiteX7" fmla="*/ 4029868 w 4048918"/>
              <a:gd name="connsiteY7" fmla="*/ 3884642 h 5333235"/>
              <a:gd name="connsiteX8" fmla="*/ 3801269 w 4048918"/>
              <a:gd name="connsiteY8" fmla="*/ 3975923 h 5333235"/>
              <a:gd name="connsiteX9" fmla="*/ 1920081 w 4048918"/>
              <a:gd name="connsiteY9" fmla="*/ 4806979 h 5333235"/>
              <a:gd name="connsiteX10" fmla="*/ 1385887 w 4048918"/>
              <a:gd name="connsiteY10" fmla="*/ 5333235 h 5333235"/>
              <a:gd name="connsiteX11" fmla="*/ 0 w 4048918"/>
              <a:gd name="connsiteY11" fmla="*/ 144491 h 5333235"/>
              <a:gd name="connsiteX0" fmla="*/ 0 w 4039559"/>
              <a:gd name="connsiteY0" fmla="*/ 144491 h 5333235"/>
              <a:gd name="connsiteX1" fmla="*/ 427038 w 4039559"/>
              <a:gd name="connsiteY1" fmla="*/ 28 h 5333235"/>
              <a:gd name="connsiteX2" fmla="*/ 1050925 w 4039559"/>
              <a:gd name="connsiteY2" fmla="*/ 188148 h 5333235"/>
              <a:gd name="connsiteX3" fmla="*/ 1219994 w 4039559"/>
              <a:gd name="connsiteY3" fmla="*/ 227835 h 5333235"/>
              <a:gd name="connsiteX4" fmla="*/ 1928019 w 4039559"/>
              <a:gd name="connsiteY4" fmla="*/ 673922 h 5333235"/>
              <a:gd name="connsiteX5" fmla="*/ 2988469 w 4039559"/>
              <a:gd name="connsiteY5" fmla="*/ 1092229 h 5333235"/>
              <a:gd name="connsiteX6" fmla="*/ 4029868 w 4039559"/>
              <a:gd name="connsiteY6" fmla="*/ 3884642 h 5333235"/>
              <a:gd name="connsiteX7" fmla="*/ 3801269 w 4039559"/>
              <a:gd name="connsiteY7" fmla="*/ 3975923 h 5333235"/>
              <a:gd name="connsiteX8" fmla="*/ 1920081 w 4039559"/>
              <a:gd name="connsiteY8" fmla="*/ 4806979 h 5333235"/>
              <a:gd name="connsiteX9" fmla="*/ 1385887 w 4039559"/>
              <a:gd name="connsiteY9" fmla="*/ 5333235 h 5333235"/>
              <a:gd name="connsiteX10" fmla="*/ 0 w 4039559"/>
              <a:gd name="connsiteY10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0 w 4029868"/>
              <a:gd name="connsiteY10" fmla="*/ 144491 h 5333235"/>
              <a:gd name="connsiteX0" fmla="*/ 0 w 4029868"/>
              <a:gd name="connsiteY0" fmla="*/ 144491 h 5421904"/>
              <a:gd name="connsiteX1" fmla="*/ 427038 w 4029868"/>
              <a:gd name="connsiteY1" fmla="*/ 28 h 5421904"/>
              <a:gd name="connsiteX2" fmla="*/ 1050925 w 4029868"/>
              <a:gd name="connsiteY2" fmla="*/ 188148 h 5421904"/>
              <a:gd name="connsiteX3" fmla="*/ 1219994 w 4029868"/>
              <a:gd name="connsiteY3" fmla="*/ 227835 h 5421904"/>
              <a:gd name="connsiteX4" fmla="*/ 1928019 w 4029868"/>
              <a:gd name="connsiteY4" fmla="*/ 673922 h 5421904"/>
              <a:gd name="connsiteX5" fmla="*/ 2988469 w 4029868"/>
              <a:gd name="connsiteY5" fmla="*/ 1092229 h 5421904"/>
              <a:gd name="connsiteX6" fmla="*/ 4029868 w 4029868"/>
              <a:gd name="connsiteY6" fmla="*/ 3884642 h 5421904"/>
              <a:gd name="connsiteX7" fmla="*/ 3801269 w 4029868"/>
              <a:gd name="connsiteY7" fmla="*/ 3975923 h 5421904"/>
              <a:gd name="connsiteX8" fmla="*/ 1920081 w 4029868"/>
              <a:gd name="connsiteY8" fmla="*/ 4806979 h 5421904"/>
              <a:gd name="connsiteX9" fmla="*/ 1385887 w 4029868"/>
              <a:gd name="connsiteY9" fmla="*/ 5333235 h 5421904"/>
              <a:gd name="connsiteX10" fmla="*/ 1215231 w 4029868"/>
              <a:gd name="connsiteY10" fmla="*/ 4853809 h 5421904"/>
              <a:gd name="connsiteX11" fmla="*/ 0 w 4029868"/>
              <a:gd name="connsiteY11" fmla="*/ 144491 h 5421904"/>
              <a:gd name="connsiteX0" fmla="*/ 0 w 4029868"/>
              <a:gd name="connsiteY0" fmla="*/ 144491 h 5333414"/>
              <a:gd name="connsiteX1" fmla="*/ 427038 w 4029868"/>
              <a:gd name="connsiteY1" fmla="*/ 28 h 5333414"/>
              <a:gd name="connsiteX2" fmla="*/ 1050925 w 4029868"/>
              <a:gd name="connsiteY2" fmla="*/ 188148 h 5333414"/>
              <a:gd name="connsiteX3" fmla="*/ 1219994 w 4029868"/>
              <a:gd name="connsiteY3" fmla="*/ 227835 h 5333414"/>
              <a:gd name="connsiteX4" fmla="*/ 1928019 w 4029868"/>
              <a:gd name="connsiteY4" fmla="*/ 673922 h 5333414"/>
              <a:gd name="connsiteX5" fmla="*/ 2988469 w 4029868"/>
              <a:gd name="connsiteY5" fmla="*/ 1092229 h 5333414"/>
              <a:gd name="connsiteX6" fmla="*/ 4029868 w 4029868"/>
              <a:gd name="connsiteY6" fmla="*/ 3884642 h 5333414"/>
              <a:gd name="connsiteX7" fmla="*/ 3801269 w 4029868"/>
              <a:gd name="connsiteY7" fmla="*/ 3975923 h 5333414"/>
              <a:gd name="connsiteX8" fmla="*/ 1920081 w 4029868"/>
              <a:gd name="connsiteY8" fmla="*/ 4806979 h 5333414"/>
              <a:gd name="connsiteX9" fmla="*/ 1385887 w 4029868"/>
              <a:gd name="connsiteY9" fmla="*/ 5333235 h 5333414"/>
              <a:gd name="connsiteX10" fmla="*/ 1215231 w 4029868"/>
              <a:gd name="connsiteY10" fmla="*/ 4853809 h 5333414"/>
              <a:gd name="connsiteX11" fmla="*/ 0 w 4029868"/>
              <a:gd name="connsiteY11" fmla="*/ 144491 h 5333414"/>
              <a:gd name="connsiteX0" fmla="*/ 0 w 4029868"/>
              <a:gd name="connsiteY0" fmla="*/ 144491 h 5355913"/>
              <a:gd name="connsiteX1" fmla="*/ 427038 w 4029868"/>
              <a:gd name="connsiteY1" fmla="*/ 28 h 5355913"/>
              <a:gd name="connsiteX2" fmla="*/ 1050925 w 4029868"/>
              <a:gd name="connsiteY2" fmla="*/ 188148 h 5355913"/>
              <a:gd name="connsiteX3" fmla="*/ 1219994 w 4029868"/>
              <a:gd name="connsiteY3" fmla="*/ 227835 h 5355913"/>
              <a:gd name="connsiteX4" fmla="*/ 1928019 w 4029868"/>
              <a:gd name="connsiteY4" fmla="*/ 673922 h 5355913"/>
              <a:gd name="connsiteX5" fmla="*/ 2988469 w 4029868"/>
              <a:gd name="connsiteY5" fmla="*/ 1092229 h 5355913"/>
              <a:gd name="connsiteX6" fmla="*/ 4029868 w 4029868"/>
              <a:gd name="connsiteY6" fmla="*/ 3884642 h 5355913"/>
              <a:gd name="connsiteX7" fmla="*/ 3801269 w 4029868"/>
              <a:gd name="connsiteY7" fmla="*/ 3975923 h 5355913"/>
              <a:gd name="connsiteX8" fmla="*/ 1920081 w 4029868"/>
              <a:gd name="connsiteY8" fmla="*/ 4806979 h 5355913"/>
              <a:gd name="connsiteX9" fmla="*/ 1385887 w 4029868"/>
              <a:gd name="connsiteY9" fmla="*/ 5333235 h 5355913"/>
              <a:gd name="connsiteX10" fmla="*/ 123031 w 4029868"/>
              <a:gd name="connsiteY10" fmla="*/ 5120509 h 5355913"/>
              <a:gd name="connsiteX11" fmla="*/ 0 w 4029868"/>
              <a:gd name="connsiteY11" fmla="*/ 144491 h 5355913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123031 w 4029868"/>
              <a:gd name="connsiteY10" fmla="*/ 5120509 h 5333235"/>
              <a:gd name="connsiteX11" fmla="*/ 0 w 4029868"/>
              <a:gd name="connsiteY11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123031 w 4029868"/>
              <a:gd name="connsiteY10" fmla="*/ 5120509 h 5333235"/>
              <a:gd name="connsiteX11" fmla="*/ 0 w 4029868"/>
              <a:gd name="connsiteY11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123031 w 4029868"/>
              <a:gd name="connsiteY10" fmla="*/ 5120509 h 5333235"/>
              <a:gd name="connsiteX11" fmla="*/ 0 w 4029868"/>
              <a:gd name="connsiteY11" fmla="*/ 144491 h 5333235"/>
              <a:gd name="connsiteX0" fmla="*/ 0 w 4029868"/>
              <a:gd name="connsiteY0" fmla="*/ 144491 h 5353530"/>
              <a:gd name="connsiteX1" fmla="*/ 427038 w 4029868"/>
              <a:gd name="connsiteY1" fmla="*/ 28 h 5353530"/>
              <a:gd name="connsiteX2" fmla="*/ 1050925 w 4029868"/>
              <a:gd name="connsiteY2" fmla="*/ 188148 h 5353530"/>
              <a:gd name="connsiteX3" fmla="*/ 1219994 w 4029868"/>
              <a:gd name="connsiteY3" fmla="*/ 227835 h 5353530"/>
              <a:gd name="connsiteX4" fmla="*/ 1928019 w 4029868"/>
              <a:gd name="connsiteY4" fmla="*/ 673922 h 5353530"/>
              <a:gd name="connsiteX5" fmla="*/ 2988469 w 4029868"/>
              <a:gd name="connsiteY5" fmla="*/ 1092229 h 5353530"/>
              <a:gd name="connsiteX6" fmla="*/ 4029868 w 4029868"/>
              <a:gd name="connsiteY6" fmla="*/ 3884642 h 5353530"/>
              <a:gd name="connsiteX7" fmla="*/ 3801269 w 4029868"/>
              <a:gd name="connsiteY7" fmla="*/ 3975923 h 5353530"/>
              <a:gd name="connsiteX8" fmla="*/ 1920081 w 4029868"/>
              <a:gd name="connsiteY8" fmla="*/ 4806979 h 5353530"/>
              <a:gd name="connsiteX9" fmla="*/ 1385887 w 4029868"/>
              <a:gd name="connsiteY9" fmla="*/ 5333235 h 5353530"/>
              <a:gd name="connsiteX10" fmla="*/ 34131 w 4029868"/>
              <a:gd name="connsiteY10" fmla="*/ 5234809 h 5353530"/>
              <a:gd name="connsiteX11" fmla="*/ 0 w 4029868"/>
              <a:gd name="connsiteY11" fmla="*/ 144491 h 5353530"/>
              <a:gd name="connsiteX0" fmla="*/ 0 w 4029868"/>
              <a:gd name="connsiteY0" fmla="*/ 144491 h 5361213"/>
              <a:gd name="connsiteX1" fmla="*/ 427038 w 4029868"/>
              <a:gd name="connsiteY1" fmla="*/ 28 h 5361213"/>
              <a:gd name="connsiteX2" fmla="*/ 1050925 w 4029868"/>
              <a:gd name="connsiteY2" fmla="*/ 188148 h 5361213"/>
              <a:gd name="connsiteX3" fmla="*/ 1219994 w 4029868"/>
              <a:gd name="connsiteY3" fmla="*/ 227835 h 5361213"/>
              <a:gd name="connsiteX4" fmla="*/ 1928019 w 4029868"/>
              <a:gd name="connsiteY4" fmla="*/ 673922 h 5361213"/>
              <a:gd name="connsiteX5" fmla="*/ 2988469 w 4029868"/>
              <a:gd name="connsiteY5" fmla="*/ 1092229 h 5361213"/>
              <a:gd name="connsiteX6" fmla="*/ 4029868 w 4029868"/>
              <a:gd name="connsiteY6" fmla="*/ 3884642 h 5361213"/>
              <a:gd name="connsiteX7" fmla="*/ 3801269 w 4029868"/>
              <a:gd name="connsiteY7" fmla="*/ 3975923 h 5361213"/>
              <a:gd name="connsiteX8" fmla="*/ 1920081 w 4029868"/>
              <a:gd name="connsiteY8" fmla="*/ 4806979 h 5361213"/>
              <a:gd name="connsiteX9" fmla="*/ 1385887 w 4029868"/>
              <a:gd name="connsiteY9" fmla="*/ 5333235 h 5361213"/>
              <a:gd name="connsiteX10" fmla="*/ 21431 w 4029868"/>
              <a:gd name="connsiteY10" fmla="*/ 5272909 h 5361213"/>
              <a:gd name="connsiteX11" fmla="*/ 0 w 4029868"/>
              <a:gd name="connsiteY11" fmla="*/ 144491 h 5361213"/>
              <a:gd name="connsiteX0" fmla="*/ 0 w 4029868"/>
              <a:gd name="connsiteY0" fmla="*/ 144491 h 5372108"/>
              <a:gd name="connsiteX1" fmla="*/ 427038 w 4029868"/>
              <a:gd name="connsiteY1" fmla="*/ 28 h 5372108"/>
              <a:gd name="connsiteX2" fmla="*/ 1050925 w 4029868"/>
              <a:gd name="connsiteY2" fmla="*/ 188148 h 5372108"/>
              <a:gd name="connsiteX3" fmla="*/ 1219994 w 4029868"/>
              <a:gd name="connsiteY3" fmla="*/ 227835 h 5372108"/>
              <a:gd name="connsiteX4" fmla="*/ 1928019 w 4029868"/>
              <a:gd name="connsiteY4" fmla="*/ 673922 h 5372108"/>
              <a:gd name="connsiteX5" fmla="*/ 2988469 w 4029868"/>
              <a:gd name="connsiteY5" fmla="*/ 1092229 h 5372108"/>
              <a:gd name="connsiteX6" fmla="*/ 4029868 w 4029868"/>
              <a:gd name="connsiteY6" fmla="*/ 3884642 h 5372108"/>
              <a:gd name="connsiteX7" fmla="*/ 3801269 w 4029868"/>
              <a:gd name="connsiteY7" fmla="*/ 3975923 h 5372108"/>
              <a:gd name="connsiteX8" fmla="*/ 1920081 w 4029868"/>
              <a:gd name="connsiteY8" fmla="*/ 4806979 h 5372108"/>
              <a:gd name="connsiteX9" fmla="*/ 1385887 w 4029868"/>
              <a:gd name="connsiteY9" fmla="*/ 5333235 h 5372108"/>
              <a:gd name="connsiteX10" fmla="*/ 8731 w 4029868"/>
              <a:gd name="connsiteY10" fmla="*/ 5311009 h 5372108"/>
              <a:gd name="connsiteX11" fmla="*/ 0 w 4029868"/>
              <a:gd name="connsiteY11" fmla="*/ 144491 h 5372108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8731 w 4029868"/>
              <a:gd name="connsiteY10" fmla="*/ 5311009 h 5333235"/>
              <a:gd name="connsiteX11" fmla="*/ 0 w 4029868"/>
              <a:gd name="connsiteY11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920081 w 4029868"/>
              <a:gd name="connsiteY8" fmla="*/ 4806979 h 5333235"/>
              <a:gd name="connsiteX9" fmla="*/ 1385887 w 4029868"/>
              <a:gd name="connsiteY9" fmla="*/ 5333235 h 5333235"/>
              <a:gd name="connsiteX10" fmla="*/ 8731 w 4029868"/>
              <a:gd name="connsiteY10" fmla="*/ 5311009 h 5333235"/>
              <a:gd name="connsiteX11" fmla="*/ 0 w 4029868"/>
              <a:gd name="connsiteY11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385887 w 4029868"/>
              <a:gd name="connsiteY8" fmla="*/ 5333235 h 5333235"/>
              <a:gd name="connsiteX9" fmla="*/ 8731 w 4029868"/>
              <a:gd name="connsiteY9" fmla="*/ 5311009 h 5333235"/>
              <a:gd name="connsiteX10" fmla="*/ 0 w 4029868"/>
              <a:gd name="connsiteY10" fmla="*/ 144491 h 5333235"/>
              <a:gd name="connsiteX0" fmla="*/ 0 w 4029868"/>
              <a:gd name="connsiteY0" fmla="*/ 144491 h 5333235"/>
              <a:gd name="connsiteX1" fmla="*/ 427038 w 4029868"/>
              <a:gd name="connsiteY1" fmla="*/ 28 h 5333235"/>
              <a:gd name="connsiteX2" fmla="*/ 1050925 w 4029868"/>
              <a:gd name="connsiteY2" fmla="*/ 188148 h 5333235"/>
              <a:gd name="connsiteX3" fmla="*/ 1219994 w 4029868"/>
              <a:gd name="connsiteY3" fmla="*/ 227835 h 5333235"/>
              <a:gd name="connsiteX4" fmla="*/ 1928019 w 4029868"/>
              <a:gd name="connsiteY4" fmla="*/ 673922 h 5333235"/>
              <a:gd name="connsiteX5" fmla="*/ 2988469 w 4029868"/>
              <a:gd name="connsiteY5" fmla="*/ 1092229 h 5333235"/>
              <a:gd name="connsiteX6" fmla="*/ 4029868 w 4029868"/>
              <a:gd name="connsiteY6" fmla="*/ 3884642 h 5333235"/>
              <a:gd name="connsiteX7" fmla="*/ 3801269 w 4029868"/>
              <a:gd name="connsiteY7" fmla="*/ 3975923 h 5333235"/>
              <a:gd name="connsiteX8" fmla="*/ 1385887 w 4029868"/>
              <a:gd name="connsiteY8" fmla="*/ 5333235 h 5333235"/>
              <a:gd name="connsiteX9" fmla="*/ 8731 w 4029868"/>
              <a:gd name="connsiteY9" fmla="*/ 5311009 h 5333235"/>
              <a:gd name="connsiteX10" fmla="*/ 0 w 4029868"/>
              <a:gd name="connsiteY10" fmla="*/ 144491 h 5333235"/>
              <a:gd name="connsiteX0" fmla="*/ 0 w 4037011"/>
              <a:gd name="connsiteY0" fmla="*/ 144696 h 5333440"/>
              <a:gd name="connsiteX1" fmla="*/ 434181 w 4037011"/>
              <a:gd name="connsiteY1" fmla="*/ 233 h 5333440"/>
              <a:gd name="connsiteX2" fmla="*/ 1058068 w 4037011"/>
              <a:gd name="connsiteY2" fmla="*/ 188353 h 5333440"/>
              <a:gd name="connsiteX3" fmla="*/ 1227137 w 4037011"/>
              <a:gd name="connsiteY3" fmla="*/ 228040 h 5333440"/>
              <a:gd name="connsiteX4" fmla="*/ 1935162 w 4037011"/>
              <a:gd name="connsiteY4" fmla="*/ 674127 h 5333440"/>
              <a:gd name="connsiteX5" fmla="*/ 2995612 w 4037011"/>
              <a:gd name="connsiteY5" fmla="*/ 1092434 h 5333440"/>
              <a:gd name="connsiteX6" fmla="*/ 4037011 w 4037011"/>
              <a:gd name="connsiteY6" fmla="*/ 3884847 h 5333440"/>
              <a:gd name="connsiteX7" fmla="*/ 3808412 w 4037011"/>
              <a:gd name="connsiteY7" fmla="*/ 3976128 h 5333440"/>
              <a:gd name="connsiteX8" fmla="*/ 1393030 w 4037011"/>
              <a:gd name="connsiteY8" fmla="*/ 5333440 h 5333440"/>
              <a:gd name="connsiteX9" fmla="*/ 15874 w 4037011"/>
              <a:gd name="connsiteY9" fmla="*/ 5311214 h 5333440"/>
              <a:gd name="connsiteX10" fmla="*/ 0 w 4037011"/>
              <a:gd name="connsiteY10" fmla="*/ 144696 h 5333440"/>
              <a:gd name="connsiteX0" fmla="*/ 0 w 4037011"/>
              <a:gd name="connsiteY0" fmla="*/ 144696 h 5333440"/>
              <a:gd name="connsiteX1" fmla="*/ 434181 w 4037011"/>
              <a:gd name="connsiteY1" fmla="*/ 233 h 5333440"/>
              <a:gd name="connsiteX2" fmla="*/ 1058068 w 4037011"/>
              <a:gd name="connsiteY2" fmla="*/ 188353 h 5333440"/>
              <a:gd name="connsiteX3" fmla="*/ 1227137 w 4037011"/>
              <a:gd name="connsiteY3" fmla="*/ 228040 h 5333440"/>
              <a:gd name="connsiteX4" fmla="*/ 1935162 w 4037011"/>
              <a:gd name="connsiteY4" fmla="*/ 674127 h 5333440"/>
              <a:gd name="connsiteX5" fmla="*/ 3002756 w 4037011"/>
              <a:gd name="connsiteY5" fmla="*/ 1092434 h 5333440"/>
              <a:gd name="connsiteX6" fmla="*/ 4037011 w 4037011"/>
              <a:gd name="connsiteY6" fmla="*/ 3884847 h 5333440"/>
              <a:gd name="connsiteX7" fmla="*/ 3808412 w 4037011"/>
              <a:gd name="connsiteY7" fmla="*/ 3976128 h 5333440"/>
              <a:gd name="connsiteX8" fmla="*/ 1393030 w 4037011"/>
              <a:gd name="connsiteY8" fmla="*/ 5333440 h 5333440"/>
              <a:gd name="connsiteX9" fmla="*/ 15874 w 4037011"/>
              <a:gd name="connsiteY9" fmla="*/ 5311214 h 5333440"/>
              <a:gd name="connsiteX10" fmla="*/ 0 w 4037011"/>
              <a:gd name="connsiteY10" fmla="*/ 144696 h 5333440"/>
              <a:gd name="connsiteX0" fmla="*/ 0 w 4037011"/>
              <a:gd name="connsiteY0" fmla="*/ 144696 h 5333440"/>
              <a:gd name="connsiteX1" fmla="*/ 434181 w 4037011"/>
              <a:gd name="connsiteY1" fmla="*/ 233 h 5333440"/>
              <a:gd name="connsiteX2" fmla="*/ 1058068 w 4037011"/>
              <a:gd name="connsiteY2" fmla="*/ 188353 h 5333440"/>
              <a:gd name="connsiteX3" fmla="*/ 1227137 w 4037011"/>
              <a:gd name="connsiteY3" fmla="*/ 228040 h 5333440"/>
              <a:gd name="connsiteX4" fmla="*/ 1935162 w 4037011"/>
              <a:gd name="connsiteY4" fmla="*/ 674127 h 5333440"/>
              <a:gd name="connsiteX5" fmla="*/ 3002756 w 4037011"/>
              <a:gd name="connsiteY5" fmla="*/ 1092434 h 5333440"/>
              <a:gd name="connsiteX6" fmla="*/ 4037011 w 4037011"/>
              <a:gd name="connsiteY6" fmla="*/ 3884847 h 5333440"/>
              <a:gd name="connsiteX7" fmla="*/ 3527424 w 4037011"/>
              <a:gd name="connsiteY7" fmla="*/ 5314391 h 5333440"/>
              <a:gd name="connsiteX8" fmla="*/ 1393030 w 4037011"/>
              <a:gd name="connsiteY8" fmla="*/ 5333440 h 5333440"/>
              <a:gd name="connsiteX9" fmla="*/ 15874 w 4037011"/>
              <a:gd name="connsiteY9" fmla="*/ 5311214 h 5333440"/>
              <a:gd name="connsiteX10" fmla="*/ 0 w 4037011"/>
              <a:gd name="connsiteY10" fmla="*/ 144696 h 5333440"/>
              <a:gd name="connsiteX0" fmla="*/ 0 w 4037011"/>
              <a:gd name="connsiteY0" fmla="*/ 144696 h 5314391"/>
              <a:gd name="connsiteX1" fmla="*/ 434181 w 4037011"/>
              <a:gd name="connsiteY1" fmla="*/ 233 h 5314391"/>
              <a:gd name="connsiteX2" fmla="*/ 1058068 w 4037011"/>
              <a:gd name="connsiteY2" fmla="*/ 188353 h 5314391"/>
              <a:gd name="connsiteX3" fmla="*/ 1227137 w 4037011"/>
              <a:gd name="connsiteY3" fmla="*/ 228040 h 5314391"/>
              <a:gd name="connsiteX4" fmla="*/ 1935162 w 4037011"/>
              <a:gd name="connsiteY4" fmla="*/ 674127 h 5314391"/>
              <a:gd name="connsiteX5" fmla="*/ 3002756 w 4037011"/>
              <a:gd name="connsiteY5" fmla="*/ 1092434 h 5314391"/>
              <a:gd name="connsiteX6" fmla="*/ 4037011 w 4037011"/>
              <a:gd name="connsiteY6" fmla="*/ 3884847 h 5314391"/>
              <a:gd name="connsiteX7" fmla="*/ 3527424 w 4037011"/>
              <a:gd name="connsiteY7" fmla="*/ 5314391 h 5314391"/>
              <a:gd name="connsiteX8" fmla="*/ 15874 w 4037011"/>
              <a:gd name="connsiteY8" fmla="*/ 5311214 h 5314391"/>
              <a:gd name="connsiteX9" fmla="*/ 0 w 4037011"/>
              <a:gd name="connsiteY9" fmla="*/ 144696 h 5314391"/>
              <a:gd name="connsiteX0" fmla="*/ 0 w 4289423"/>
              <a:gd name="connsiteY0" fmla="*/ 144696 h 5314391"/>
              <a:gd name="connsiteX1" fmla="*/ 434181 w 4289423"/>
              <a:gd name="connsiteY1" fmla="*/ 233 h 5314391"/>
              <a:gd name="connsiteX2" fmla="*/ 1058068 w 4289423"/>
              <a:gd name="connsiteY2" fmla="*/ 188353 h 5314391"/>
              <a:gd name="connsiteX3" fmla="*/ 1227137 w 4289423"/>
              <a:gd name="connsiteY3" fmla="*/ 228040 h 5314391"/>
              <a:gd name="connsiteX4" fmla="*/ 1935162 w 4289423"/>
              <a:gd name="connsiteY4" fmla="*/ 674127 h 5314391"/>
              <a:gd name="connsiteX5" fmla="*/ 3002756 w 4289423"/>
              <a:gd name="connsiteY5" fmla="*/ 1092434 h 5314391"/>
              <a:gd name="connsiteX6" fmla="*/ 4289423 w 4289423"/>
              <a:gd name="connsiteY6" fmla="*/ 4532547 h 5314391"/>
              <a:gd name="connsiteX7" fmla="*/ 3527424 w 4289423"/>
              <a:gd name="connsiteY7" fmla="*/ 5314391 h 5314391"/>
              <a:gd name="connsiteX8" fmla="*/ 15874 w 4289423"/>
              <a:gd name="connsiteY8" fmla="*/ 5311214 h 5314391"/>
              <a:gd name="connsiteX9" fmla="*/ 0 w 4289423"/>
              <a:gd name="connsiteY9" fmla="*/ 144696 h 5314391"/>
              <a:gd name="connsiteX0" fmla="*/ 0 w 4289423"/>
              <a:gd name="connsiteY0" fmla="*/ 144696 h 5314391"/>
              <a:gd name="connsiteX1" fmla="*/ 434181 w 4289423"/>
              <a:gd name="connsiteY1" fmla="*/ 233 h 5314391"/>
              <a:gd name="connsiteX2" fmla="*/ 1058068 w 4289423"/>
              <a:gd name="connsiteY2" fmla="*/ 188353 h 5314391"/>
              <a:gd name="connsiteX3" fmla="*/ 1227137 w 4289423"/>
              <a:gd name="connsiteY3" fmla="*/ 228040 h 5314391"/>
              <a:gd name="connsiteX4" fmla="*/ 1935162 w 4289423"/>
              <a:gd name="connsiteY4" fmla="*/ 674127 h 5314391"/>
              <a:gd name="connsiteX5" fmla="*/ 2926840 w 4289423"/>
              <a:gd name="connsiteY5" fmla="*/ 1064855 h 5314391"/>
              <a:gd name="connsiteX6" fmla="*/ 4289423 w 4289423"/>
              <a:gd name="connsiteY6" fmla="*/ 4532547 h 5314391"/>
              <a:gd name="connsiteX7" fmla="*/ 3527424 w 4289423"/>
              <a:gd name="connsiteY7" fmla="*/ 5314391 h 5314391"/>
              <a:gd name="connsiteX8" fmla="*/ 15874 w 4289423"/>
              <a:gd name="connsiteY8" fmla="*/ 5311214 h 5314391"/>
              <a:gd name="connsiteX9" fmla="*/ 0 w 4289423"/>
              <a:gd name="connsiteY9" fmla="*/ 144696 h 5314391"/>
              <a:gd name="connsiteX0" fmla="*/ 0 w 4165196"/>
              <a:gd name="connsiteY0" fmla="*/ 144696 h 5314391"/>
              <a:gd name="connsiteX1" fmla="*/ 434181 w 4165196"/>
              <a:gd name="connsiteY1" fmla="*/ 233 h 5314391"/>
              <a:gd name="connsiteX2" fmla="*/ 1058068 w 4165196"/>
              <a:gd name="connsiteY2" fmla="*/ 188353 h 5314391"/>
              <a:gd name="connsiteX3" fmla="*/ 1227137 w 4165196"/>
              <a:gd name="connsiteY3" fmla="*/ 228040 h 5314391"/>
              <a:gd name="connsiteX4" fmla="*/ 1935162 w 4165196"/>
              <a:gd name="connsiteY4" fmla="*/ 674127 h 5314391"/>
              <a:gd name="connsiteX5" fmla="*/ 2926840 w 4165196"/>
              <a:gd name="connsiteY5" fmla="*/ 1064855 h 5314391"/>
              <a:gd name="connsiteX6" fmla="*/ 4165196 w 4165196"/>
              <a:gd name="connsiteY6" fmla="*/ 4642859 h 5314391"/>
              <a:gd name="connsiteX7" fmla="*/ 3527424 w 4165196"/>
              <a:gd name="connsiteY7" fmla="*/ 5314391 h 5314391"/>
              <a:gd name="connsiteX8" fmla="*/ 15874 w 4165196"/>
              <a:gd name="connsiteY8" fmla="*/ 5311214 h 5314391"/>
              <a:gd name="connsiteX9" fmla="*/ 0 w 4165196"/>
              <a:gd name="connsiteY9" fmla="*/ 144696 h 5314391"/>
              <a:gd name="connsiteX0" fmla="*/ 0 w 4165196"/>
              <a:gd name="connsiteY0" fmla="*/ 144696 h 5314391"/>
              <a:gd name="connsiteX1" fmla="*/ 434181 w 4165196"/>
              <a:gd name="connsiteY1" fmla="*/ 233 h 5314391"/>
              <a:gd name="connsiteX2" fmla="*/ 1058068 w 4165196"/>
              <a:gd name="connsiteY2" fmla="*/ 188353 h 5314391"/>
              <a:gd name="connsiteX3" fmla="*/ 1227137 w 4165196"/>
              <a:gd name="connsiteY3" fmla="*/ 228040 h 5314391"/>
              <a:gd name="connsiteX4" fmla="*/ 1935162 w 4165196"/>
              <a:gd name="connsiteY4" fmla="*/ 674127 h 5314391"/>
              <a:gd name="connsiteX5" fmla="*/ 2926841 w 4165196"/>
              <a:gd name="connsiteY5" fmla="*/ 913176 h 5314391"/>
              <a:gd name="connsiteX6" fmla="*/ 4165196 w 4165196"/>
              <a:gd name="connsiteY6" fmla="*/ 4642859 h 5314391"/>
              <a:gd name="connsiteX7" fmla="*/ 3527424 w 4165196"/>
              <a:gd name="connsiteY7" fmla="*/ 5314391 h 5314391"/>
              <a:gd name="connsiteX8" fmla="*/ 15874 w 4165196"/>
              <a:gd name="connsiteY8" fmla="*/ 5311214 h 5314391"/>
              <a:gd name="connsiteX9" fmla="*/ 0 w 4165196"/>
              <a:gd name="connsiteY9" fmla="*/ 144696 h 5314391"/>
              <a:gd name="connsiteX0" fmla="*/ 0 w 4165196"/>
              <a:gd name="connsiteY0" fmla="*/ 144696 h 5314391"/>
              <a:gd name="connsiteX1" fmla="*/ 434181 w 4165196"/>
              <a:gd name="connsiteY1" fmla="*/ 233 h 5314391"/>
              <a:gd name="connsiteX2" fmla="*/ 1058068 w 4165196"/>
              <a:gd name="connsiteY2" fmla="*/ 188353 h 5314391"/>
              <a:gd name="connsiteX3" fmla="*/ 1192631 w 4165196"/>
              <a:gd name="connsiteY3" fmla="*/ 379720 h 5314391"/>
              <a:gd name="connsiteX4" fmla="*/ 1935162 w 4165196"/>
              <a:gd name="connsiteY4" fmla="*/ 674127 h 5314391"/>
              <a:gd name="connsiteX5" fmla="*/ 2926841 w 4165196"/>
              <a:gd name="connsiteY5" fmla="*/ 913176 h 5314391"/>
              <a:gd name="connsiteX6" fmla="*/ 4165196 w 4165196"/>
              <a:gd name="connsiteY6" fmla="*/ 4642859 h 5314391"/>
              <a:gd name="connsiteX7" fmla="*/ 3527424 w 4165196"/>
              <a:gd name="connsiteY7" fmla="*/ 5314391 h 5314391"/>
              <a:gd name="connsiteX8" fmla="*/ 15874 w 4165196"/>
              <a:gd name="connsiteY8" fmla="*/ 5311214 h 5314391"/>
              <a:gd name="connsiteX9" fmla="*/ 0 w 4165196"/>
              <a:gd name="connsiteY9" fmla="*/ 144696 h 5314391"/>
              <a:gd name="connsiteX0" fmla="*/ 0 w 4165196"/>
              <a:gd name="connsiteY0" fmla="*/ 147548 h 5317243"/>
              <a:gd name="connsiteX1" fmla="*/ 434181 w 4165196"/>
              <a:gd name="connsiteY1" fmla="*/ 3085 h 5317243"/>
              <a:gd name="connsiteX2" fmla="*/ 940742 w 4165196"/>
              <a:gd name="connsiteY2" fmla="*/ 322201 h 5317243"/>
              <a:gd name="connsiteX3" fmla="*/ 1192631 w 4165196"/>
              <a:gd name="connsiteY3" fmla="*/ 382572 h 5317243"/>
              <a:gd name="connsiteX4" fmla="*/ 1935162 w 4165196"/>
              <a:gd name="connsiteY4" fmla="*/ 676979 h 5317243"/>
              <a:gd name="connsiteX5" fmla="*/ 2926841 w 4165196"/>
              <a:gd name="connsiteY5" fmla="*/ 916028 h 5317243"/>
              <a:gd name="connsiteX6" fmla="*/ 4165196 w 4165196"/>
              <a:gd name="connsiteY6" fmla="*/ 4645711 h 5317243"/>
              <a:gd name="connsiteX7" fmla="*/ 3527424 w 4165196"/>
              <a:gd name="connsiteY7" fmla="*/ 5317243 h 5317243"/>
              <a:gd name="connsiteX8" fmla="*/ 15874 w 4165196"/>
              <a:gd name="connsiteY8" fmla="*/ 5314066 h 5317243"/>
              <a:gd name="connsiteX9" fmla="*/ 0 w 4165196"/>
              <a:gd name="connsiteY9" fmla="*/ 147548 h 5317243"/>
              <a:gd name="connsiteX0" fmla="*/ 0 w 4165196"/>
              <a:gd name="connsiteY0" fmla="*/ 0 h 5169695"/>
              <a:gd name="connsiteX1" fmla="*/ 399674 w 4165196"/>
              <a:gd name="connsiteY1" fmla="*/ 55478 h 5169695"/>
              <a:gd name="connsiteX2" fmla="*/ 940742 w 4165196"/>
              <a:gd name="connsiteY2" fmla="*/ 174653 h 5169695"/>
              <a:gd name="connsiteX3" fmla="*/ 1192631 w 4165196"/>
              <a:gd name="connsiteY3" fmla="*/ 235024 h 5169695"/>
              <a:gd name="connsiteX4" fmla="*/ 1935162 w 4165196"/>
              <a:gd name="connsiteY4" fmla="*/ 529431 h 5169695"/>
              <a:gd name="connsiteX5" fmla="*/ 2926841 w 4165196"/>
              <a:gd name="connsiteY5" fmla="*/ 768480 h 5169695"/>
              <a:gd name="connsiteX6" fmla="*/ 4165196 w 4165196"/>
              <a:gd name="connsiteY6" fmla="*/ 4498163 h 5169695"/>
              <a:gd name="connsiteX7" fmla="*/ 3527424 w 4165196"/>
              <a:gd name="connsiteY7" fmla="*/ 5169695 h 5169695"/>
              <a:gd name="connsiteX8" fmla="*/ 15874 w 4165196"/>
              <a:gd name="connsiteY8" fmla="*/ 5166518 h 5169695"/>
              <a:gd name="connsiteX9" fmla="*/ 0 w 4165196"/>
              <a:gd name="connsiteY9" fmla="*/ 0 h 5169695"/>
              <a:gd name="connsiteX0" fmla="*/ 0 w 4165196"/>
              <a:gd name="connsiteY0" fmla="*/ 82679 h 5114484"/>
              <a:gd name="connsiteX1" fmla="*/ 399674 w 4165196"/>
              <a:gd name="connsiteY1" fmla="*/ 267 h 5114484"/>
              <a:gd name="connsiteX2" fmla="*/ 940742 w 4165196"/>
              <a:gd name="connsiteY2" fmla="*/ 119442 h 5114484"/>
              <a:gd name="connsiteX3" fmla="*/ 1192631 w 4165196"/>
              <a:gd name="connsiteY3" fmla="*/ 179813 h 5114484"/>
              <a:gd name="connsiteX4" fmla="*/ 1935162 w 4165196"/>
              <a:gd name="connsiteY4" fmla="*/ 474220 h 5114484"/>
              <a:gd name="connsiteX5" fmla="*/ 2926841 w 4165196"/>
              <a:gd name="connsiteY5" fmla="*/ 713269 h 5114484"/>
              <a:gd name="connsiteX6" fmla="*/ 4165196 w 4165196"/>
              <a:gd name="connsiteY6" fmla="*/ 4442952 h 5114484"/>
              <a:gd name="connsiteX7" fmla="*/ 3527424 w 4165196"/>
              <a:gd name="connsiteY7" fmla="*/ 5114484 h 5114484"/>
              <a:gd name="connsiteX8" fmla="*/ 15874 w 4165196"/>
              <a:gd name="connsiteY8" fmla="*/ 5111307 h 5114484"/>
              <a:gd name="connsiteX9" fmla="*/ 0 w 4165196"/>
              <a:gd name="connsiteY9" fmla="*/ 82679 h 5114484"/>
              <a:gd name="connsiteX0" fmla="*/ 0 w 4165196"/>
              <a:gd name="connsiteY0" fmla="*/ 82679 h 5114484"/>
              <a:gd name="connsiteX1" fmla="*/ 399674 w 4165196"/>
              <a:gd name="connsiteY1" fmla="*/ 267 h 5114484"/>
              <a:gd name="connsiteX2" fmla="*/ 940742 w 4165196"/>
              <a:gd name="connsiteY2" fmla="*/ 119442 h 5114484"/>
              <a:gd name="connsiteX3" fmla="*/ 1192631 w 4165196"/>
              <a:gd name="connsiteY3" fmla="*/ 179813 h 5114484"/>
              <a:gd name="connsiteX4" fmla="*/ 1935162 w 4165196"/>
              <a:gd name="connsiteY4" fmla="*/ 474220 h 5114484"/>
              <a:gd name="connsiteX5" fmla="*/ 2926841 w 4165196"/>
              <a:gd name="connsiteY5" fmla="*/ 713269 h 5114484"/>
              <a:gd name="connsiteX6" fmla="*/ 4165196 w 4165196"/>
              <a:gd name="connsiteY6" fmla="*/ 4442952 h 5114484"/>
              <a:gd name="connsiteX7" fmla="*/ 3527424 w 4165196"/>
              <a:gd name="connsiteY7" fmla="*/ 5114484 h 5114484"/>
              <a:gd name="connsiteX8" fmla="*/ 15874 w 4165196"/>
              <a:gd name="connsiteY8" fmla="*/ 5111307 h 5114484"/>
              <a:gd name="connsiteX9" fmla="*/ 0 w 4165196"/>
              <a:gd name="connsiteY9" fmla="*/ 82679 h 5114484"/>
              <a:gd name="connsiteX0" fmla="*/ 0 w 4165196"/>
              <a:gd name="connsiteY0" fmla="*/ 82679 h 5114484"/>
              <a:gd name="connsiteX1" fmla="*/ 399674 w 4165196"/>
              <a:gd name="connsiteY1" fmla="*/ 267 h 5114484"/>
              <a:gd name="connsiteX2" fmla="*/ 940742 w 4165196"/>
              <a:gd name="connsiteY2" fmla="*/ 119442 h 5114484"/>
              <a:gd name="connsiteX3" fmla="*/ 1192631 w 4165196"/>
              <a:gd name="connsiteY3" fmla="*/ 179813 h 5114484"/>
              <a:gd name="connsiteX4" fmla="*/ 1935162 w 4165196"/>
              <a:gd name="connsiteY4" fmla="*/ 474220 h 5114484"/>
              <a:gd name="connsiteX5" fmla="*/ 2926841 w 4165196"/>
              <a:gd name="connsiteY5" fmla="*/ 713269 h 5114484"/>
              <a:gd name="connsiteX6" fmla="*/ 4165196 w 4165196"/>
              <a:gd name="connsiteY6" fmla="*/ 4442952 h 5114484"/>
              <a:gd name="connsiteX7" fmla="*/ 3527424 w 4165196"/>
              <a:gd name="connsiteY7" fmla="*/ 5114484 h 5114484"/>
              <a:gd name="connsiteX8" fmla="*/ 15874 w 4165196"/>
              <a:gd name="connsiteY8" fmla="*/ 5111307 h 5114484"/>
              <a:gd name="connsiteX9" fmla="*/ 0 w 4165196"/>
              <a:gd name="connsiteY9" fmla="*/ 82679 h 5114484"/>
              <a:gd name="connsiteX0" fmla="*/ 0 w 4165196"/>
              <a:gd name="connsiteY0" fmla="*/ 82679 h 5114484"/>
              <a:gd name="connsiteX1" fmla="*/ 399674 w 4165196"/>
              <a:gd name="connsiteY1" fmla="*/ 267 h 5114484"/>
              <a:gd name="connsiteX2" fmla="*/ 940742 w 4165196"/>
              <a:gd name="connsiteY2" fmla="*/ 119442 h 5114484"/>
              <a:gd name="connsiteX3" fmla="*/ 1192631 w 4165196"/>
              <a:gd name="connsiteY3" fmla="*/ 179813 h 5114484"/>
              <a:gd name="connsiteX4" fmla="*/ 1935162 w 4165196"/>
              <a:gd name="connsiteY4" fmla="*/ 474220 h 5114484"/>
              <a:gd name="connsiteX5" fmla="*/ 2926841 w 4165196"/>
              <a:gd name="connsiteY5" fmla="*/ 713269 h 5114484"/>
              <a:gd name="connsiteX6" fmla="*/ 4165196 w 4165196"/>
              <a:gd name="connsiteY6" fmla="*/ 4442952 h 5114484"/>
              <a:gd name="connsiteX7" fmla="*/ 3527424 w 4165196"/>
              <a:gd name="connsiteY7" fmla="*/ 5114484 h 5114484"/>
              <a:gd name="connsiteX8" fmla="*/ 15874 w 4165196"/>
              <a:gd name="connsiteY8" fmla="*/ 5111307 h 5114484"/>
              <a:gd name="connsiteX9" fmla="*/ 0 w 4165196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92631 w 4192802"/>
              <a:gd name="connsiteY3" fmla="*/ 179813 h 5114484"/>
              <a:gd name="connsiteX4" fmla="*/ 1935162 w 4192802"/>
              <a:gd name="connsiteY4" fmla="*/ 474220 h 5114484"/>
              <a:gd name="connsiteX5" fmla="*/ 2926841 w 4192802"/>
              <a:gd name="connsiteY5" fmla="*/ 713269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92631 w 4192802"/>
              <a:gd name="connsiteY3" fmla="*/ 179813 h 5114484"/>
              <a:gd name="connsiteX4" fmla="*/ 1935162 w 4192802"/>
              <a:gd name="connsiteY4" fmla="*/ 474220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92631 w 4192802"/>
              <a:gd name="connsiteY3" fmla="*/ 179813 h 5114484"/>
              <a:gd name="connsiteX4" fmla="*/ 1935162 w 4192802"/>
              <a:gd name="connsiteY4" fmla="*/ 474220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92631 w 4192802"/>
              <a:gd name="connsiteY3" fmla="*/ 179813 h 5114484"/>
              <a:gd name="connsiteX4" fmla="*/ 1935162 w 4192802"/>
              <a:gd name="connsiteY4" fmla="*/ 463879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92631 w 4192802"/>
              <a:gd name="connsiteY3" fmla="*/ 179813 h 5114484"/>
              <a:gd name="connsiteX4" fmla="*/ 1935162 w 4192802"/>
              <a:gd name="connsiteY4" fmla="*/ 463879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85729 w 4192802"/>
              <a:gd name="connsiteY3" fmla="*/ 155683 h 5114484"/>
              <a:gd name="connsiteX4" fmla="*/ 1935162 w 4192802"/>
              <a:gd name="connsiteY4" fmla="*/ 463879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679 h 5114484"/>
              <a:gd name="connsiteX1" fmla="*/ 399674 w 4192802"/>
              <a:gd name="connsiteY1" fmla="*/ 267 h 5114484"/>
              <a:gd name="connsiteX2" fmla="*/ 940742 w 4192802"/>
              <a:gd name="connsiteY2" fmla="*/ 119442 h 5114484"/>
              <a:gd name="connsiteX3" fmla="*/ 1185729 w 4192802"/>
              <a:gd name="connsiteY3" fmla="*/ 155683 h 5114484"/>
              <a:gd name="connsiteX4" fmla="*/ 1935162 w 4192802"/>
              <a:gd name="connsiteY4" fmla="*/ 463879 h 5114484"/>
              <a:gd name="connsiteX5" fmla="*/ 2971700 w 4192802"/>
              <a:gd name="connsiteY5" fmla="*/ 716716 h 5114484"/>
              <a:gd name="connsiteX6" fmla="*/ 4192802 w 4192802"/>
              <a:gd name="connsiteY6" fmla="*/ 4194750 h 5114484"/>
              <a:gd name="connsiteX7" fmla="*/ 3527424 w 4192802"/>
              <a:gd name="connsiteY7" fmla="*/ 5114484 h 5114484"/>
              <a:gd name="connsiteX8" fmla="*/ 15874 w 4192802"/>
              <a:gd name="connsiteY8" fmla="*/ 5111307 h 5114484"/>
              <a:gd name="connsiteX9" fmla="*/ 0 w 4192802"/>
              <a:gd name="connsiteY9" fmla="*/ 82679 h 5114484"/>
              <a:gd name="connsiteX0" fmla="*/ 0 w 4192802"/>
              <a:gd name="connsiteY0" fmla="*/ 82591 h 5114396"/>
              <a:gd name="connsiteX1" fmla="*/ 399674 w 4192802"/>
              <a:gd name="connsiteY1" fmla="*/ 179 h 5114396"/>
              <a:gd name="connsiteX2" fmla="*/ 947644 w 4192802"/>
              <a:gd name="connsiteY2" fmla="*/ 112461 h 5114396"/>
              <a:gd name="connsiteX3" fmla="*/ 1185729 w 4192802"/>
              <a:gd name="connsiteY3" fmla="*/ 155595 h 5114396"/>
              <a:gd name="connsiteX4" fmla="*/ 1935162 w 4192802"/>
              <a:gd name="connsiteY4" fmla="*/ 463791 h 5114396"/>
              <a:gd name="connsiteX5" fmla="*/ 2971700 w 4192802"/>
              <a:gd name="connsiteY5" fmla="*/ 716628 h 5114396"/>
              <a:gd name="connsiteX6" fmla="*/ 4192802 w 4192802"/>
              <a:gd name="connsiteY6" fmla="*/ 4194662 h 5114396"/>
              <a:gd name="connsiteX7" fmla="*/ 3527424 w 4192802"/>
              <a:gd name="connsiteY7" fmla="*/ 5114396 h 5114396"/>
              <a:gd name="connsiteX8" fmla="*/ 15874 w 4192802"/>
              <a:gd name="connsiteY8" fmla="*/ 5111219 h 5114396"/>
              <a:gd name="connsiteX9" fmla="*/ 0 w 4192802"/>
              <a:gd name="connsiteY9" fmla="*/ 82591 h 5114396"/>
              <a:gd name="connsiteX0" fmla="*/ 0 w 4192802"/>
              <a:gd name="connsiteY0" fmla="*/ 82591 h 5114396"/>
              <a:gd name="connsiteX1" fmla="*/ 399674 w 4192802"/>
              <a:gd name="connsiteY1" fmla="*/ 179 h 5114396"/>
              <a:gd name="connsiteX2" fmla="*/ 947644 w 4192802"/>
              <a:gd name="connsiteY2" fmla="*/ 112461 h 5114396"/>
              <a:gd name="connsiteX3" fmla="*/ 1185729 w 4192802"/>
              <a:gd name="connsiteY3" fmla="*/ 155595 h 5114396"/>
              <a:gd name="connsiteX4" fmla="*/ 1935162 w 4192802"/>
              <a:gd name="connsiteY4" fmla="*/ 463791 h 5114396"/>
              <a:gd name="connsiteX5" fmla="*/ 2971700 w 4192802"/>
              <a:gd name="connsiteY5" fmla="*/ 716628 h 5114396"/>
              <a:gd name="connsiteX6" fmla="*/ 4192802 w 4192802"/>
              <a:gd name="connsiteY6" fmla="*/ 4194662 h 5114396"/>
              <a:gd name="connsiteX7" fmla="*/ 3527424 w 4192802"/>
              <a:gd name="connsiteY7" fmla="*/ 5114396 h 5114396"/>
              <a:gd name="connsiteX8" fmla="*/ 15874 w 4192802"/>
              <a:gd name="connsiteY8" fmla="*/ 5111219 h 5114396"/>
              <a:gd name="connsiteX9" fmla="*/ 0 w 4192802"/>
              <a:gd name="connsiteY9" fmla="*/ 82591 h 5114396"/>
              <a:gd name="connsiteX0" fmla="*/ 0 w 4192802"/>
              <a:gd name="connsiteY0" fmla="*/ 82591 h 5111220"/>
              <a:gd name="connsiteX1" fmla="*/ 399674 w 4192802"/>
              <a:gd name="connsiteY1" fmla="*/ 179 h 5111220"/>
              <a:gd name="connsiteX2" fmla="*/ 947644 w 4192802"/>
              <a:gd name="connsiteY2" fmla="*/ 112461 h 5111220"/>
              <a:gd name="connsiteX3" fmla="*/ 1185729 w 4192802"/>
              <a:gd name="connsiteY3" fmla="*/ 155595 h 5111220"/>
              <a:gd name="connsiteX4" fmla="*/ 1935162 w 4192802"/>
              <a:gd name="connsiteY4" fmla="*/ 463791 h 5111220"/>
              <a:gd name="connsiteX5" fmla="*/ 2971700 w 4192802"/>
              <a:gd name="connsiteY5" fmla="*/ 716628 h 5111220"/>
              <a:gd name="connsiteX6" fmla="*/ 4192802 w 4192802"/>
              <a:gd name="connsiteY6" fmla="*/ 4194662 h 5111220"/>
              <a:gd name="connsiteX7" fmla="*/ 3527424 w 4192802"/>
              <a:gd name="connsiteY7" fmla="*/ 4471434 h 5111220"/>
              <a:gd name="connsiteX8" fmla="*/ 15874 w 4192802"/>
              <a:gd name="connsiteY8" fmla="*/ 5111219 h 5111220"/>
              <a:gd name="connsiteX9" fmla="*/ 0 w 4192802"/>
              <a:gd name="connsiteY9" fmla="*/ 82591 h 5111220"/>
              <a:gd name="connsiteX0" fmla="*/ 0 w 4192802"/>
              <a:gd name="connsiteY0" fmla="*/ 82591 h 4471434"/>
              <a:gd name="connsiteX1" fmla="*/ 399674 w 4192802"/>
              <a:gd name="connsiteY1" fmla="*/ 179 h 4471434"/>
              <a:gd name="connsiteX2" fmla="*/ 947644 w 4192802"/>
              <a:gd name="connsiteY2" fmla="*/ 112461 h 4471434"/>
              <a:gd name="connsiteX3" fmla="*/ 1185729 w 4192802"/>
              <a:gd name="connsiteY3" fmla="*/ 155595 h 4471434"/>
              <a:gd name="connsiteX4" fmla="*/ 1935162 w 4192802"/>
              <a:gd name="connsiteY4" fmla="*/ 463791 h 4471434"/>
              <a:gd name="connsiteX5" fmla="*/ 2971700 w 4192802"/>
              <a:gd name="connsiteY5" fmla="*/ 716628 h 4471434"/>
              <a:gd name="connsiteX6" fmla="*/ 4192802 w 4192802"/>
              <a:gd name="connsiteY6" fmla="*/ 4194662 h 4471434"/>
              <a:gd name="connsiteX7" fmla="*/ 3527424 w 4192802"/>
              <a:gd name="connsiteY7" fmla="*/ 4471434 h 4471434"/>
              <a:gd name="connsiteX8" fmla="*/ 3255 w 4192802"/>
              <a:gd name="connsiteY8" fmla="*/ 4468255 h 4471434"/>
              <a:gd name="connsiteX9" fmla="*/ 0 w 4192802"/>
              <a:gd name="connsiteY9" fmla="*/ 82591 h 4471434"/>
              <a:gd name="connsiteX0" fmla="*/ 0 w 4496467"/>
              <a:gd name="connsiteY0" fmla="*/ 82591 h 4471434"/>
              <a:gd name="connsiteX1" fmla="*/ 399674 w 4496467"/>
              <a:gd name="connsiteY1" fmla="*/ 179 h 4471434"/>
              <a:gd name="connsiteX2" fmla="*/ 947644 w 4496467"/>
              <a:gd name="connsiteY2" fmla="*/ 112461 h 4471434"/>
              <a:gd name="connsiteX3" fmla="*/ 1185729 w 4496467"/>
              <a:gd name="connsiteY3" fmla="*/ 155595 h 4471434"/>
              <a:gd name="connsiteX4" fmla="*/ 1935162 w 4496467"/>
              <a:gd name="connsiteY4" fmla="*/ 463791 h 4471434"/>
              <a:gd name="connsiteX5" fmla="*/ 2971700 w 4496467"/>
              <a:gd name="connsiteY5" fmla="*/ 716628 h 4471434"/>
              <a:gd name="connsiteX6" fmla="*/ 4496467 w 4496467"/>
              <a:gd name="connsiteY6" fmla="*/ 3939566 h 4471434"/>
              <a:gd name="connsiteX7" fmla="*/ 3527424 w 4496467"/>
              <a:gd name="connsiteY7" fmla="*/ 4471434 h 4471434"/>
              <a:gd name="connsiteX8" fmla="*/ 3255 w 4496467"/>
              <a:gd name="connsiteY8" fmla="*/ 4468255 h 4471434"/>
              <a:gd name="connsiteX9" fmla="*/ 0 w 4496467"/>
              <a:gd name="connsiteY9" fmla="*/ 82591 h 4471434"/>
              <a:gd name="connsiteX0" fmla="*/ 0 w 4502190"/>
              <a:gd name="connsiteY0" fmla="*/ 82591 h 4471434"/>
              <a:gd name="connsiteX1" fmla="*/ 399674 w 4502190"/>
              <a:gd name="connsiteY1" fmla="*/ 179 h 4471434"/>
              <a:gd name="connsiteX2" fmla="*/ 947644 w 4502190"/>
              <a:gd name="connsiteY2" fmla="*/ 112461 h 4471434"/>
              <a:gd name="connsiteX3" fmla="*/ 1185729 w 4502190"/>
              <a:gd name="connsiteY3" fmla="*/ 155595 h 4471434"/>
              <a:gd name="connsiteX4" fmla="*/ 1935162 w 4502190"/>
              <a:gd name="connsiteY4" fmla="*/ 463791 h 4471434"/>
              <a:gd name="connsiteX5" fmla="*/ 2971700 w 4502190"/>
              <a:gd name="connsiteY5" fmla="*/ 716628 h 4471434"/>
              <a:gd name="connsiteX6" fmla="*/ 3884156 w 4502190"/>
              <a:gd name="connsiteY6" fmla="*/ 2758110 h 4471434"/>
              <a:gd name="connsiteX7" fmla="*/ 4496467 w 4502190"/>
              <a:gd name="connsiteY7" fmla="*/ 3939566 h 4471434"/>
              <a:gd name="connsiteX8" fmla="*/ 3527424 w 4502190"/>
              <a:gd name="connsiteY8" fmla="*/ 4471434 h 4471434"/>
              <a:gd name="connsiteX9" fmla="*/ 3255 w 4502190"/>
              <a:gd name="connsiteY9" fmla="*/ 4468255 h 4471434"/>
              <a:gd name="connsiteX10" fmla="*/ 0 w 4502190"/>
              <a:gd name="connsiteY10" fmla="*/ 82591 h 4471434"/>
              <a:gd name="connsiteX0" fmla="*/ 0 w 4503868"/>
              <a:gd name="connsiteY0" fmla="*/ 82591 h 4471434"/>
              <a:gd name="connsiteX1" fmla="*/ 399674 w 4503868"/>
              <a:gd name="connsiteY1" fmla="*/ 179 h 4471434"/>
              <a:gd name="connsiteX2" fmla="*/ 947644 w 4503868"/>
              <a:gd name="connsiteY2" fmla="*/ 112461 h 4471434"/>
              <a:gd name="connsiteX3" fmla="*/ 1185729 w 4503868"/>
              <a:gd name="connsiteY3" fmla="*/ 155595 h 4471434"/>
              <a:gd name="connsiteX4" fmla="*/ 1935162 w 4503868"/>
              <a:gd name="connsiteY4" fmla="*/ 463791 h 4471434"/>
              <a:gd name="connsiteX5" fmla="*/ 2971700 w 4503868"/>
              <a:gd name="connsiteY5" fmla="*/ 716628 h 4471434"/>
              <a:gd name="connsiteX6" fmla="*/ 3991130 w 4503868"/>
              <a:gd name="connsiteY6" fmla="*/ 2837395 h 4471434"/>
              <a:gd name="connsiteX7" fmla="*/ 4496467 w 4503868"/>
              <a:gd name="connsiteY7" fmla="*/ 3939566 h 4471434"/>
              <a:gd name="connsiteX8" fmla="*/ 3527424 w 4503868"/>
              <a:gd name="connsiteY8" fmla="*/ 4471434 h 4471434"/>
              <a:gd name="connsiteX9" fmla="*/ 3255 w 4503868"/>
              <a:gd name="connsiteY9" fmla="*/ 4468255 h 4471434"/>
              <a:gd name="connsiteX10" fmla="*/ 0 w 4503868"/>
              <a:gd name="connsiteY10" fmla="*/ 82591 h 4471434"/>
              <a:gd name="connsiteX0" fmla="*/ 0 w 4503868"/>
              <a:gd name="connsiteY0" fmla="*/ 82591 h 4471434"/>
              <a:gd name="connsiteX1" fmla="*/ 399674 w 4503868"/>
              <a:gd name="connsiteY1" fmla="*/ 179 h 4471434"/>
              <a:gd name="connsiteX2" fmla="*/ 947644 w 4503868"/>
              <a:gd name="connsiteY2" fmla="*/ 112461 h 4471434"/>
              <a:gd name="connsiteX3" fmla="*/ 1185729 w 4503868"/>
              <a:gd name="connsiteY3" fmla="*/ 155595 h 4471434"/>
              <a:gd name="connsiteX4" fmla="*/ 1935162 w 4503868"/>
              <a:gd name="connsiteY4" fmla="*/ 463791 h 4471434"/>
              <a:gd name="connsiteX5" fmla="*/ 2971700 w 4503868"/>
              <a:gd name="connsiteY5" fmla="*/ 716628 h 4471434"/>
              <a:gd name="connsiteX6" fmla="*/ 3991130 w 4503868"/>
              <a:gd name="connsiteY6" fmla="*/ 2837395 h 4471434"/>
              <a:gd name="connsiteX7" fmla="*/ 4496467 w 4503868"/>
              <a:gd name="connsiteY7" fmla="*/ 3939566 h 4471434"/>
              <a:gd name="connsiteX8" fmla="*/ 3527424 w 4503868"/>
              <a:gd name="connsiteY8" fmla="*/ 4471434 h 4471434"/>
              <a:gd name="connsiteX9" fmla="*/ 3255 w 4503868"/>
              <a:gd name="connsiteY9" fmla="*/ 4468255 h 4471434"/>
              <a:gd name="connsiteX10" fmla="*/ 0 w 4503868"/>
              <a:gd name="connsiteY10" fmla="*/ 82591 h 4471434"/>
              <a:gd name="connsiteX0" fmla="*/ 0 w 4496467"/>
              <a:gd name="connsiteY0" fmla="*/ 82591 h 4471434"/>
              <a:gd name="connsiteX1" fmla="*/ 399674 w 4496467"/>
              <a:gd name="connsiteY1" fmla="*/ 179 h 4471434"/>
              <a:gd name="connsiteX2" fmla="*/ 947644 w 4496467"/>
              <a:gd name="connsiteY2" fmla="*/ 112461 h 4471434"/>
              <a:gd name="connsiteX3" fmla="*/ 1185729 w 4496467"/>
              <a:gd name="connsiteY3" fmla="*/ 155595 h 4471434"/>
              <a:gd name="connsiteX4" fmla="*/ 1935162 w 4496467"/>
              <a:gd name="connsiteY4" fmla="*/ 463791 h 4471434"/>
              <a:gd name="connsiteX5" fmla="*/ 2971700 w 4496467"/>
              <a:gd name="connsiteY5" fmla="*/ 716628 h 4471434"/>
              <a:gd name="connsiteX6" fmla="*/ 3991130 w 4496467"/>
              <a:gd name="connsiteY6" fmla="*/ 2837395 h 4471434"/>
              <a:gd name="connsiteX7" fmla="*/ 4496467 w 4496467"/>
              <a:gd name="connsiteY7" fmla="*/ 3939566 h 4471434"/>
              <a:gd name="connsiteX8" fmla="*/ 3527424 w 4496467"/>
              <a:gd name="connsiteY8" fmla="*/ 4471434 h 4471434"/>
              <a:gd name="connsiteX9" fmla="*/ 3255 w 4496467"/>
              <a:gd name="connsiteY9" fmla="*/ 4468255 h 4471434"/>
              <a:gd name="connsiteX10" fmla="*/ 0 w 4496467"/>
              <a:gd name="connsiteY10" fmla="*/ 82591 h 4471434"/>
              <a:gd name="connsiteX0" fmla="*/ 0 w 4496467"/>
              <a:gd name="connsiteY0" fmla="*/ 82591 h 4471434"/>
              <a:gd name="connsiteX1" fmla="*/ 399674 w 4496467"/>
              <a:gd name="connsiteY1" fmla="*/ 179 h 4471434"/>
              <a:gd name="connsiteX2" fmla="*/ 947644 w 4496467"/>
              <a:gd name="connsiteY2" fmla="*/ 112461 h 4471434"/>
              <a:gd name="connsiteX3" fmla="*/ 1185729 w 4496467"/>
              <a:gd name="connsiteY3" fmla="*/ 155595 h 4471434"/>
              <a:gd name="connsiteX4" fmla="*/ 1935162 w 4496467"/>
              <a:gd name="connsiteY4" fmla="*/ 463791 h 4471434"/>
              <a:gd name="connsiteX5" fmla="*/ 2971700 w 4496467"/>
              <a:gd name="connsiteY5" fmla="*/ 716628 h 4471434"/>
              <a:gd name="connsiteX6" fmla="*/ 3991130 w 4496467"/>
              <a:gd name="connsiteY6" fmla="*/ 2837395 h 4471434"/>
              <a:gd name="connsiteX7" fmla="*/ 4496467 w 4496467"/>
              <a:gd name="connsiteY7" fmla="*/ 3939566 h 4471434"/>
              <a:gd name="connsiteX8" fmla="*/ 3527424 w 4496467"/>
              <a:gd name="connsiteY8" fmla="*/ 4471434 h 4471434"/>
              <a:gd name="connsiteX9" fmla="*/ 3255 w 4496467"/>
              <a:gd name="connsiteY9" fmla="*/ 4468255 h 4471434"/>
              <a:gd name="connsiteX10" fmla="*/ 0 w 4496467"/>
              <a:gd name="connsiteY10" fmla="*/ 82591 h 4471434"/>
              <a:gd name="connsiteX0" fmla="*/ 0 w 4496467"/>
              <a:gd name="connsiteY0" fmla="*/ 82591 h 4471434"/>
              <a:gd name="connsiteX1" fmla="*/ 399674 w 4496467"/>
              <a:gd name="connsiteY1" fmla="*/ 179 h 4471434"/>
              <a:gd name="connsiteX2" fmla="*/ 947644 w 4496467"/>
              <a:gd name="connsiteY2" fmla="*/ 112461 h 4471434"/>
              <a:gd name="connsiteX3" fmla="*/ 1185729 w 4496467"/>
              <a:gd name="connsiteY3" fmla="*/ 155595 h 4471434"/>
              <a:gd name="connsiteX4" fmla="*/ 1935162 w 4496467"/>
              <a:gd name="connsiteY4" fmla="*/ 463791 h 4471434"/>
              <a:gd name="connsiteX5" fmla="*/ 2971700 w 4496467"/>
              <a:gd name="connsiteY5" fmla="*/ 716628 h 4471434"/>
              <a:gd name="connsiteX6" fmla="*/ 3991130 w 4496467"/>
              <a:gd name="connsiteY6" fmla="*/ 2837395 h 4471434"/>
              <a:gd name="connsiteX7" fmla="*/ 4496467 w 4496467"/>
              <a:gd name="connsiteY7" fmla="*/ 3939566 h 4471434"/>
              <a:gd name="connsiteX8" fmla="*/ 3527424 w 4496467"/>
              <a:gd name="connsiteY8" fmla="*/ 4471434 h 4471434"/>
              <a:gd name="connsiteX9" fmla="*/ 3255 w 4496467"/>
              <a:gd name="connsiteY9" fmla="*/ 4468255 h 4471434"/>
              <a:gd name="connsiteX10" fmla="*/ 0 w 4496467"/>
              <a:gd name="connsiteY10" fmla="*/ 82591 h 4471434"/>
              <a:gd name="connsiteX0" fmla="*/ 0 w 4496467"/>
              <a:gd name="connsiteY0" fmla="*/ 82888 h 4471731"/>
              <a:gd name="connsiteX1" fmla="*/ 399674 w 4496467"/>
              <a:gd name="connsiteY1" fmla="*/ 476 h 4471731"/>
              <a:gd name="connsiteX2" fmla="*/ 947644 w 4496467"/>
              <a:gd name="connsiteY2" fmla="*/ 112758 h 4471731"/>
              <a:gd name="connsiteX3" fmla="*/ 1185729 w 4496467"/>
              <a:gd name="connsiteY3" fmla="*/ 155892 h 4471731"/>
              <a:gd name="connsiteX4" fmla="*/ 1935162 w 4496467"/>
              <a:gd name="connsiteY4" fmla="*/ 464088 h 4471731"/>
              <a:gd name="connsiteX5" fmla="*/ 2971700 w 4496467"/>
              <a:gd name="connsiteY5" fmla="*/ 716925 h 4471731"/>
              <a:gd name="connsiteX6" fmla="*/ 3991130 w 4496467"/>
              <a:gd name="connsiteY6" fmla="*/ 2837692 h 4471731"/>
              <a:gd name="connsiteX7" fmla="*/ 4496467 w 4496467"/>
              <a:gd name="connsiteY7" fmla="*/ 3939863 h 4471731"/>
              <a:gd name="connsiteX8" fmla="*/ 3527424 w 4496467"/>
              <a:gd name="connsiteY8" fmla="*/ 4471731 h 4471731"/>
              <a:gd name="connsiteX9" fmla="*/ 3255 w 4496467"/>
              <a:gd name="connsiteY9" fmla="*/ 4468552 h 4471731"/>
              <a:gd name="connsiteX10" fmla="*/ 0 w 4496467"/>
              <a:gd name="connsiteY10" fmla="*/ 82888 h 4471731"/>
              <a:gd name="connsiteX0" fmla="*/ 0 w 4496467"/>
              <a:gd name="connsiteY0" fmla="*/ 82888 h 4471731"/>
              <a:gd name="connsiteX1" fmla="*/ 399674 w 4496467"/>
              <a:gd name="connsiteY1" fmla="*/ 476 h 4471731"/>
              <a:gd name="connsiteX2" fmla="*/ 947644 w 4496467"/>
              <a:gd name="connsiteY2" fmla="*/ 112758 h 4471731"/>
              <a:gd name="connsiteX3" fmla="*/ 1185729 w 4496467"/>
              <a:gd name="connsiteY3" fmla="*/ 155892 h 4471731"/>
              <a:gd name="connsiteX4" fmla="*/ 1935162 w 4496467"/>
              <a:gd name="connsiteY4" fmla="*/ 464088 h 4471731"/>
              <a:gd name="connsiteX5" fmla="*/ 2971700 w 4496467"/>
              <a:gd name="connsiteY5" fmla="*/ 716925 h 4471731"/>
              <a:gd name="connsiteX6" fmla="*/ 3991130 w 4496467"/>
              <a:gd name="connsiteY6" fmla="*/ 2837692 h 4471731"/>
              <a:gd name="connsiteX7" fmla="*/ 4496467 w 4496467"/>
              <a:gd name="connsiteY7" fmla="*/ 3920558 h 4471731"/>
              <a:gd name="connsiteX8" fmla="*/ 3527424 w 4496467"/>
              <a:gd name="connsiteY8" fmla="*/ 4471731 h 4471731"/>
              <a:gd name="connsiteX9" fmla="*/ 3255 w 4496467"/>
              <a:gd name="connsiteY9" fmla="*/ 4468552 h 4471731"/>
              <a:gd name="connsiteX10" fmla="*/ 0 w 4496467"/>
              <a:gd name="connsiteY10" fmla="*/ 82888 h 44717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4496467" h="4471731">
                <a:moveTo>
                  <a:pt x="0" y="82888"/>
                </a:moveTo>
                <a:cubicBezTo>
                  <a:pt x="118517" y="29931"/>
                  <a:pt x="241733" y="-4502"/>
                  <a:pt x="399674" y="476"/>
                </a:cubicBezTo>
                <a:cubicBezTo>
                  <a:pt x="557615" y="5454"/>
                  <a:pt x="819453" y="60503"/>
                  <a:pt x="947644" y="112758"/>
                </a:cubicBezTo>
                <a:lnTo>
                  <a:pt x="1185729" y="155892"/>
                </a:lnTo>
                <a:cubicBezTo>
                  <a:pt x="1443036" y="265088"/>
                  <a:pt x="1627651" y="340583"/>
                  <a:pt x="1935162" y="464088"/>
                </a:cubicBezTo>
                <a:cubicBezTo>
                  <a:pt x="2228630" y="538516"/>
                  <a:pt x="2362863" y="579326"/>
                  <a:pt x="2971700" y="716925"/>
                </a:cubicBezTo>
                <a:cubicBezTo>
                  <a:pt x="3161953" y="1168257"/>
                  <a:pt x="3737002" y="2303753"/>
                  <a:pt x="3991130" y="2837692"/>
                </a:cubicBezTo>
                <a:cubicBezTo>
                  <a:pt x="4245258" y="3371631"/>
                  <a:pt x="4373033" y="3703949"/>
                  <a:pt x="4496467" y="3920558"/>
                </a:cubicBezTo>
                <a:lnTo>
                  <a:pt x="3527424" y="4471731"/>
                </a:lnTo>
                <a:lnTo>
                  <a:pt x="3255" y="4468552"/>
                </a:lnTo>
                <a:cubicBezTo>
                  <a:pt x="-3889" y="2759079"/>
                  <a:pt x="7144" y="1792361"/>
                  <a:pt x="0" y="82888"/>
                </a:cubicBezTo>
                <a:close/>
              </a:path>
            </a:pathLst>
          </a:custGeom>
          <a:solidFill>
            <a:schemeClr val="accent6">
              <a:lumMod val="50000"/>
              <a:alpha val="34000"/>
            </a:schemeClr>
          </a:soli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2955B917-07EC-128C-1E2D-32D4897A6A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3500000">
            <a:off x="5218941" y="1193194"/>
            <a:ext cx="702259" cy="3881445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B1007F2C-C25A-20F7-DE3F-1DD10D0DE4FB}"/>
              </a:ext>
            </a:extLst>
          </p:cNvPr>
          <p:cNvSpPr txBox="1"/>
          <p:nvPr/>
        </p:nvSpPr>
        <p:spPr>
          <a:xfrm>
            <a:off x="1176078" y="5836337"/>
            <a:ext cx="70000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Post-</a:t>
            </a:r>
            <a:r>
              <a:rPr lang="de-DE" sz="1100" dirty="0" err="1"/>
              <a:t>drill</a:t>
            </a:r>
            <a:r>
              <a:rPr lang="de-DE" sz="1100" dirty="0"/>
              <a:t> </a:t>
            </a:r>
            <a:r>
              <a:rPr lang="de-DE" sz="1100" dirty="0" err="1"/>
              <a:t>geological</a:t>
            </a:r>
            <a:r>
              <a:rPr lang="de-DE" sz="1100" dirty="0"/>
              <a:t> </a:t>
            </a:r>
            <a:r>
              <a:rPr lang="de-DE" sz="1100" dirty="0" err="1"/>
              <a:t>cross</a:t>
            </a:r>
            <a:r>
              <a:rPr lang="de-DE" sz="1100" dirty="0"/>
              <a:t> </a:t>
            </a:r>
            <a:r>
              <a:rPr lang="de-DE" sz="1100" dirty="0" err="1"/>
              <a:t>section</a:t>
            </a:r>
            <a:r>
              <a:rPr lang="de-DE" sz="1100" dirty="0"/>
              <a:t>, BASE-1A (</a:t>
            </a:r>
            <a:r>
              <a:rPr lang="de-DE" sz="1100" dirty="0" err="1"/>
              <a:t>Fairview</a:t>
            </a:r>
            <a:r>
              <a:rPr lang="de-DE" sz="1100" dirty="0"/>
              <a:t> Mine, Eureka </a:t>
            </a:r>
            <a:r>
              <a:rPr lang="de-DE" sz="1100" dirty="0" err="1"/>
              <a:t>Syncline</a:t>
            </a:r>
            <a:r>
              <a:rPr lang="de-DE" sz="1100" dirty="0"/>
              <a:t>).  The </a:t>
            </a:r>
            <a:r>
              <a:rPr lang="de-DE" sz="1100" dirty="0" err="1"/>
              <a:t>sampled</a:t>
            </a:r>
            <a:r>
              <a:rPr lang="de-DE" sz="1100" dirty="0"/>
              <a:t> </a:t>
            </a:r>
            <a:r>
              <a:rPr lang="de-DE" sz="1100" dirty="0" err="1"/>
              <a:t>interval</a:t>
            </a:r>
            <a:r>
              <a:rPr lang="de-DE" sz="1100" dirty="0"/>
              <a:t> (</a:t>
            </a:r>
            <a:r>
              <a:rPr lang="de-DE" sz="1100" dirty="0" err="1"/>
              <a:t>white</a:t>
            </a:r>
            <a:r>
              <a:rPr lang="de-DE" sz="1100" dirty="0"/>
              <a:t> </a:t>
            </a:r>
            <a:r>
              <a:rPr lang="de-DE" sz="1100" dirty="0" err="1"/>
              <a:t>arrow</a:t>
            </a:r>
            <a:r>
              <a:rPr lang="de-DE" sz="1100" dirty="0"/>
              <a:t>) </a:t>
            </a:r>
            <a:r>
              <a:rPr lang="de-DE" sz="1100" dirty="0" err="1"/>
              <a:t>stratigraphically</a:t>
            </a:r>
            <a:r>
              <a:rPr lang="de-DE" sz="1100" dirty="0"/>
              <a:t> </a:t>
            </a:r>
            <a:r>
              <a:rPr lang="de-DE" sz="1100" dirty="0" err="1"/>
              <a:t>overlies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Moodies Lava (MdL2)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about</a:t>
            </a:r>
            <a:r>
              <a:rPr lang="de-DE" sz="1100" dirty="0"/>
              <a:t> 30-50m.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4E96C77-0BB0-52E3-EB5B-1487091CCF99}"/>
              </a:ext>
            </a:extLst>
          </p:cNvPr>
          <p:cNvSpPr txBox="1"/>
          <p:nvPr/>
        </p:nvSpPr>
        <p:spPr>
          <a:xfrm>
            <a:off x="692334" y="-1322735"/>
            <a:ext cx="79632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31"/>
              </a:spcAft>
            </a:pPr>
            <a:r>
              <a:rPr lang="en-ZA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pendix D – Geological Cross Sections</a:t>
            </a:r>
            <a:endParaRPr lang="de-DE" sz="16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5" name="Freihandform 4">
            <a:extLst>
              <a:ext uri="{FF2B5EF4-FFF2-40B4-BE49-F238E27FC236}">
                <a16:creationId xmlns:a16="http://schemas.microsoft.com/office/drawing/2014/main" id="{65B601E2-AD95-DF3E-DC17-3F2A7053C6AF}"/>
              </a:ext>
            </a:extLst>
          </p:cNvPr>
          <p:cNvSpPr/>
          <p:nvPr/>
        </p:nvSpPr>
        <p:spPr>
          <a:xfrm>
            <a:off x="2302531" y="1653504"/>
            <a:ext cx="1123636" cy="3988019"/>
          </a:xfrm>
          <a:custGeom>
            <a:avLst/>
            <a:gdLst>
              <a:gd name="connsiteX0" fmla="*/ 0 w 1128713"/>
              <a:gd name="connsiteY0" fmla="*/ 0 h 4162425"/>
              <a:gd name="connsiteX1" fmla="*/ 114300 w 1128713"/>
              <a:gd name="connsiteY1" fmla="*/ 4762 h 4162425"/>
              <a:gd name="connsiteX2" fmla="*/ 1128713 w 1128713"/>
              <a:gd name="connsiteY2" fmla="*/ 4062412 h 4162425"/>
              <a:gd name="connsiteX3" fmla="*/ 1042988 w 1128713"/>
              <a:gd name="connsiteY3" fmla="*/ 4162425 h 4162425"/>
              <a:gd name="connsiteX4" fmla="*/ 0 w 1128713"/>
              <a:gd name="connsiteY4" fmla="*/ 0 h 4162425"/>
              <a:gd name="connsiteX0" fmla="*/ 0 w 1123951"/>
              <a:gd name="connsiteY0" fmla="*/ 0 h 4191000"/>
              <a:gd name="connsiteX1" fmla="*/ 109538 w 1123951"/>
              <a:gd name="connsiteY1" fmla="*/ 33337 h 4191000"/>
              <a:gd name="connsiteX2" fmla="*/ 1123951 w 1123951"/>
              <a:gd name="connsiteY2" fmla="*/ 4090987 h 4191000"/>
              <a:gd name="connsiteX3" fmla="*/ 1038226 w 1123951"/>
              <a:gd name="connsiteY3" fmla="*/ 4191000 h 4191000"/>
              <a:gd name="connsiteX4" fmla="*/ 0 w 1123951"/>
              <a:gd name="connsiteY4" fmla="*/ 0 h 4191000"/>
              <a:gd name="connsiteX0" fmla="*/ 0 w 1123951"/>
              <a:gd name="connsiteY0" fmla="*/ 0 h 4191000"/>
              <a:gd name="connsiteX1" fmla="*/ 109538 w 1123951"/>
              <a:gd name="connsiteY1" fmla="*/ 33337 h 4191000"/>
              <a:gd name="connsiteX2" fmla="*/ 1123951 w 1123951"/>
              <a:gd name="connsiteY2" fmla="*/ 4090987 h 4191000"/>
              <a:gd name="connsiteX3" fmla="*/ 1038226 w 1123951"/>
              <a:gd name="connsiteY3" fmla="*/ 4191000 h 4191000"/>
              <a:gd name="connsiteX4" fmla="*/ 0 w 1123951"/>
              <a:gd name="connsiteY4" fmla="*/ 0 h 4191000"/>
              <a:gd name="connsiteX0" fmla="*/ 0 w 1123951"/>
              <a:gd name="connsiteY0" fmla="*/ 0 h 4191000"/>
              <a:gd name="connsiteX1" fmla="*/ 109538 w 1123951"/>
              <a:gd name="connsiteY1" fmla="*/ 23812 h 4191000"/>
              <a:gd name="connsiteX2" fmla="*/ 1123951 w 1123951"/>
              <a:gd name="connsiteY2" fmla="*/ 4090987 h 4191000"/>
              <a:gd name="connsiteX3" fmla="*/ 1038226 w 1123951"/>
              <a:gd name="connsiteY3" fmla="*/ 4191000 h 4191000"/>
              <a:gd name="connsiteX4" fmla="*/ 0 w 1123951"/>
              <a:gd name="connsiteY4" fmla="*/ 0 h 4191000"/>
              <a:gd name="connsiteX0" fmla="*/ 0 w 1200151"/>
              <a:gd name="connsiteY0" fmla="*/ 0 h 4776788"/>
              <a:gd name="connsiteX1" fmla="*/ 109538 w 1200151"/>
              <a:gd name="connsiteY1" fmla="*/ 23812 h 4776788"/>
              <a:gd name="connsiteX2" fmla="*/ 1123951 w 1200151"/>
              <a:gd name="connsiteY2" fmla="*/ 4090987 h 4776788"/>
              <a:gd name="connsiteX3" fmla="*/ 1200151 w 1200151"/>
              <a:gd name="connsiteY3" fmla="*/ 4776788 h 4776788"/>
              <a:gd name="connsiteX4" fmla="*/ 0 w 1200151"/>
              <a:gd name="connsiteY4" fmla="*/ 0 h 4776788"/>
              <a:gd name="connsiteX0" fmla="*/ 0 w 1257301"/>
              <a:gd name="connsiteY0" fmla="*/ 0 h 4776788"/>
              <a:gd name="connsiteX1" fmla="*/ 109538 w 1257301"/>
              <a:gd name="connsiteY1" fmla="*/ 23812 h 4776788"/>
              <a:gd name="connsiteX2" fmla="*/ 1257301 w 1257301"/>
              <a:gd name="connsiteY2" fmla="*/ 4624387 h 4776788"/>
              <a:gd name="connsiteX3" fmla="*/ 1200151 w 1257301"/>
              <a:gd name="connsiteY3" fmla="*/ 4776788 h 4776788"/>
              <a:gd name="connsiteX4" fmla="*/ 0 w 1257301"/>
              <a:gd name="connsiteY4" fmla="*/ 0 h 4776788"/>
              <a:gd name="connsiteX0" fmla="*/ 0 w 1276351"/>
              <a:gd name="connsiteY0" fmla="*/ 0 h 4776788"/>
              <a:gd name="connsiteX1" fmla="*/ 109538 w 1276351"/>
              <a:gd name="connsiteY1" fmla="*/ 23812 h 4776788"/>
              <a:gd name="connsiteX2" fmla="*/ 1276351 w 1276351"/>
              <a:gd name="connsiteY2" fmla="*/ 4686299 h 4776788"/>
              <a:gd name="connsiteX3" fmla="*/ 1200151 w 1276351"/>
              <a:gd name="connsiteY3" fmla="*/ 4776788 h 4776788"/>
              <a:gd name="connsiteX4" fmla="*/ 0 w 1276351"/>
              <a:gd name="connsiteY4" fmla="*/ 0 h 4776788"/>
              <a:gd name="connsiteX0" fmla="*/ 0 w 1276351"/>
              <a:gd name="connsiteY0" fmla="*/ 0 h 4731544"/>
              <a:gd name="connsiteX1" fmla="*/ 109538 w 1276351"/>
              <a:gd name="connsiteY1" fmla="*/ 23812 h 4731544"/>
              <a:gd name="connsiteX2" fmla="*/ 1276351 w 1276351"/>
              <a:gd name="connsiteY2" fmla="*/ 4686299 h 4731544"/>
              <a:gd name="connsiteX3" fmla="*/ 1193007 w 1276351"/>
              <a:gd name="connsiteY3" fmla="*/ 4731544 h 4731544"/>
              <a:gd name="connsiteX4" fmla="*/ 0 w 1276351"/>
              <a:gd name="connsiteY4" fmla="*/ 0 h 4731544"/>
              <a:gd name="connsiteX0" fmla="*/ 0 w 1276351"/>
              <a:gd name="connsiteY0" fmla="*/ 0 h 4929187"/>
              <a:gd name="connsiteX1" fmla="*/ 109538 w 1276351"/>
              <a:gd name="connsiteY1" fmla="*/ 23812 h 4929187"/>
              <a:gd name="connsiteX2" fmla="*/ 1276351 w 1276351"/>
              <a:gd name="connsiteY2" fmla="*/ 4686299 h 4929187"/>
              <a:gd name="connsiteX3" fmla="*/ 1250157 w 1276351"/>
              <a:gd name="connsiteY3" fmla="*/ 4929187 h 4929187"/>
              <a:gd name="connsiteX4" fmla="*/ 0 w 1276351"/>
              <a:gd name="connsiteY4" fmla="*/ 0 h 4929187"/>
              <a:gd name="connsiteX0" fmla="*/ 0 w 1323976"/>
              <a:gd name="connsiteY0" fmla="*/ 0 h 4929187"/>
              <a:gd name="connsiteX1" fmla="*/ 109538 w 1323976"/>
              <a:gd name="connsiteY1" fmla="*/ 23812 h 4929187"/>
              <a:gd name="connsiteX2" fmla="*/ 1323976 w 1323976"/>
              <a:gd name="connsiteY2" fmla="*/ 4883943 h 4929187"/>
              <a:gd name="connsiteX3" fmla="*/ 1250157 w 1323976"/>
              <a:gd name="connsiteY3" fmla="*/ 4929187 h 4929187"/>
              <a:gd name="connsiteX4" fmla="*/ 0 w 1323976"/>
              <a:gd name="connsiteY4" fmla="*/ 0 h 4929187"/>
              <a:gd name="connsiteX0" fmla="*/ 0 w 1331119"/>
              <a:gd name="connsiteY0" fmla="*/ 0 h 5243512"/>
              <a:gd name="connsiteX1" fmla="*/ 109538 w 1331119"/>
              <a:gd name="connsiteY1" fmla="*/ 23812 h 5243512"/>
              <a:gd name="connsiteX2" fmla="*/ 1323976 w 1331119"/>
              <a:gd name="connsiteY2" fmla="*/ 4883943 h 5243512"/>
              <a:gd name="connsiteX3" fmla="*/ 1331119 w 1331119"/>
              <a:gd name="connsiteY3" fmla="*/ 5243512 h 5243512"/>
              <a:gd name="connsiteX4" fmla="*/ 0 w 1331119"/>
              <a:gd name="connsiteY4" fmla="*/ 0 h 5243512"/>
              <a:gd name="connsiteX0" fmla="*/ 0 w 1414464"/>
              <a:gd name="connsiteY0" fmla="*/ 0 h 5243512"/>
              <a:gd name="connsiteX1" fmla="*/ 109538 w 1414464"/>
              <a:gd name="connsiteY1" fmla="*/ 23812 h 5243512"/>
              <a:gd name="connsiteX2" fmla="*/ 1414464 w 1414464"/>
              <a:gd name="connsiteY2" fmla="*/ 5236368 h 5243512"/>
              <a:gd name="connsiteX3" fmla="*/ 1331119 w 1414464"/>
              <a:gd name="connsiteY3" fmla="*/ 5243512 h 5243512"/>
              <a:gd name="connsiteX4" fmla="*/ 0 w 1414464"/>
              <a:gd name="connsiteY4" fmla="*/ 0 h 5243512"/>
              <a:gd name="connsiteX0" fmla="*/ 0 w 1635311"/>
              <a:gd name="connsiteY0" fmla="*/ 0 h 5381402"/>
              <a:gd name="connsiteX1" fmla="*/ 330385 w 1635311"/>
              <a:gd name="connsiteY1" fmla="*/ 161702 h 5381402"/>
              <a:gd name="connsiteX2" fmla="*/ 1635311 w 1635311"/>
              <a:gd name="connsiteY2" fmla="*/ 5374258 h 5381402"/>
              <a:gd name="connsiteX3" fmla="*/ 1551966 w 1635311"/>
              <a:gd name="connsiteY3" fmla="*/ 5381402 h 5381402"/>
              <a:gd name="connsiteX4" fmla="*/ 0 w 1635311"/>
              <a:gd name="connsiteY4" fmla="*/ 0 h 5381402"/>
              <a:gd name="connsiteX0" fmla="*/ 0 w 1635311"/>
              <a:gd name="connsiteY0" fmla="*/ 0 h 5374258"/>
              <a:gd name="connsiteX1" fmla="*/ 330385 w 1635311"/>
              <a:gd name="connsiteY1" fmla="*/ 161702 h 5374258"/>
              <a:gd name="connsiteX2" fmla="*/ 1635311 w 1635311"/>
              <a:gd name="connsiteY2" fmla="*/ 5374258 h 5374258"/>
              <a:gd name="connsiteX3" fmla="*/ 1193089 w 1635311"/>
              <a:gd name="connsiteY3" fmla="*/ 5140095 h 5374258"/>
              <a:gd name="connsiteX4" fmla="*/ 0 w 1635311"/>
              <a:gd name="connsiteY4" fmla="*/ 0 h 5374258"/>
              <a:gd name="connsiteX0" fmla="*/ 0 w 1483478"/>
              <a:gd name="connsiteY0" fmla="*/ 0 h 5146740"/>
              <a:gd name="connsiteX1" fmla="*/ 330385 w 1483478"/>
              <a:gd name="connsiteY1" fmla="*/ 161702 h 5146740"/>
              <a:gd name="connsiteX2" fmla="*/ 1483478 w 1483478"/>
              <a:gd name="connsiteY2" fmla="*/ 5146740 h 5146740"/>
              <a:gd name="connsiteX3" fmla="*/ 1193089 w 1483478"/>
              <a:gd name="connsiteY3" fmla="*/ 5140095 h 5146740"/>
              <a:gd name="connsiteX4" fmla="*/ 0 w 1483478"/>
              <a:gd name="connsiteY4" fmla="*/ 0 h 5146740"/>
              <a:gd name="connsiteX0" fmla="*/ 0 w 1483478"/>
              <a:gd name="connsiteY0" fmla="*/ 0 h 5146740"/>
              <a:gd name="connsiteX1" fmla="*/ 330385 w 1483478"/>
              <a:gd name="connsiteY1" fmla="*/ 161702 h 5146740"/>
              <a:gd name="connsiteX2" fmla="*/ 1483478 w 1483478"/>
              <a:gd name="connsiteY2" fmla="*/ 5146740 h 5146740"/>
              <a:gd name="connsiteX3" fmla="*/ 1193088 w 1483478"/>
              <a:gd name="connsiteY3" fmla="*/ 5143542 h 5146740"/>
              <a:gd name="connsiteX4" fmla="*/ 0 w 1483478"/>
              <a:gd name="connsiteY4" fmla="*/ 0 h 5146740"/>
              <a:gd name="connsiteX0" fmla="*/ 0 w 1483478"/>
              <a:gd name="connsiteY0" fmla="*/ 0 h 5146740"/>
              <a:gd name="connsiteX1" fmla="*/ 368343 w 1483478"/>
              <a:gd name="connsiteY1" fmla="*/ 130675 h 5146740"/>
              <a:gd name="connsiteX2" fmla="*/ 1483478 w 1483478"/>
              <a:gd name="connsiteY2" fmla="*/ 5146740 h 5146740"/>
              <a:gd name="connsiteX3" fmla="*/ 1193088 w 1483478"/>
              <a:gd name="connsiteY3" fmla="*/ 5143542 h 5146740"/>
              <a:gd name="connsiteX4" fmla="*/ 0 w 1483478"/>
              <a:gd name="connsiteY4" fmla="*/ 0 h 5146740"/>
              <a:gd name="connsiteX0" fmla="*/ 0 w 1390308"/>
              <a:gd name="connsiteY0" fmla="*/ 0 h 5136398"/>
              <a:gd name="connsiteX1" fmla="*/ 275173 w 1390308"/>
              <a:gd name="connsiteY1" fmla="*/ 120333 h 5136398"/>
              <a:gd name="connsiteX2" fmla="*/ 1390308 w 1390308"/>
              <a:gd name="connsiteY2" fmla="*/ 5136398 h 5136398"/>
              <a:gd name="connsiteX3" fmla="*/ 1099918 w 1390308"/>
              <a:gd name="connsiteY3" fmla="*/ 5133200 h 5136398"/>
              <a:gd name="connsiteX4" fmla="*/ 0 w 1390308"/>
              <a:gd name="connsiteY4" fmla="*/ 0 h 5136398"/>
              <a:gd name="connsiteX0" fmla="*/ 0 w 1390308"/>
              <a:gd name="connsiteY0" fmla="*/ 0 h 5136398"/>
              <a:gd name="connsiteX1" fmla="*/ 275173 w 1390308"/>
              <a:gd name="connsiteY1" fmla="*/ 120333 h 5136398"/>
              <a:gd name="connsiteX2" fmla="*/ 1390308 w 1390308"/>
              <a:gd name="connsiteY2" fmla="*/ 5136398 h 5136398"/>
              <a:gd name="connsiteX3" fmla="*/ 1099918 w 1390308"/>
              <a:gd name="connsiteY3" fmla="*/ 5133200 h 5136398"/>
              <a:gd name="connsiteX4" fmla="*/ 0 w 1390308"/>
              <a:gd name="connsiteY4" fmla="*/ 0 h 5136398"/>
              <a:gd name="connsiteX0" fmla="*/ 0 w 1390308"/>
              <a:gd name="connsiteY0" fmla="*/ 0 h 5136398"/>
              <a:gd name="connsiteX1" fmla="*/ 275173 w 1390308"/>
              <a:gd name="connsiteY1" fmla="*/ 120333 h 5136398"/>
              <a:gd name="connsiteX2" fmla="*/ 1390308 w 1390308"/>
              <a:gd name="connsiteY2" fmla="*/ 5136398 h 5136398"/>
              <a:gd name="connsiteX3" fmla="*/ 1099918 w 1390308"/>
              <a:gd name="connsiteY3" fmla="*/ 4978074 h 5136398"/>
              <a:gd name="connsiteX4" fmla="*/ 0 w 1390308"/>
              <a:gd name="connsiteY4" fmla="*/ 0 h 5136398"/>
              <a:gd name="connsiteX0" fmla="*/ 0 w 1369603"/>
              <a:gd name="connsiteY0" fmla="*/ 0 h 4981272"/>
              <a:gd name="connsiteX1" fmla="*/ 275173 w 1369603"/>
              <a:gd name="connsiteY1" fmla="*/ 120333 h 4981272"/>
              <a:gd name="connsiteX2" fmla="*/ 1369603 w 1369603"/>
              <a:gd name="connsiteY2" fmla="*/ 4981272 h 4981272"/>
              <a:gd name="connsiteX3" fmla="*/ 1099918 w 1369603"/>
              <a:gd name="connsiteY3" fmla="*/ 4978074 h 4981272"/>
              <a:gd name="connsiteX4" fmla="*/ 0 w 1369603"/>
              <a:gd name="connsiteY4" fmla="*/ 0 h 4981272"/>
              <a:gd name="connsiteX0" fmla="*/ 0 w 1369603"/>
              <a:gd name="connsiteY0" fmla="*/ 0 h 4981272"/>
              <a:gd name="connsiteX1" fmla="*/ 275173 w 1369603"/>
              <a:gd name="connsiteY1" fmla="*/ 120333 h 4981272"/>
              <a:gd name="connsiteX2" fmla="*/ 1369603 w 1369603"/>
              <a:gd name="connsiteY2" fmla="*/ 4981272 h 4981272"/>
              <a:gd name="connsiteX3" fmla="*/ 958439 w 1369603"/>
              <a:gd name="connsiteY3" fmla="*/ 4319648 h 4981272"/>
              <a:gd name="connsiteX4" fmla="*/ 0 w 1369603"/>
              <a:gd name="connsiteY4" fmla="*/ 0 h 4981272"/>
              <a:gd name="connsiteX0" fmla="*/ 0 w 1221221"/>
              <a:gd name="connsiteY0" fmla="*/ 0 h 4329741"/>
              <a:gd name="connsiteX1" fmla="*/ 275173 w 1221221"/>
              <a:gd name="connsiteY1" fmla="*/ 120333 h 4329741"/>
              <a:gd name="connsiteX2" fmla="*/ 1221221 w 1221221"/>
              <a:gd name="connsiteY2" fmla="*/ 4329741 h 4329741"/>
              <a:gd name="connsiteX3" fmla="*/ 958439 w 1221221"/>
              <a:gd name="connsiteY3" fmla="*/ 4319648 h 4329741"/>
              <a:gd name="connsiteX4" fmla="*/ 0 w 1221221"/>
              <a:gd name="connsiteY4" fmla="*/ 0 h 4329741"/>
              <a:gd name="connsiteX0" fmla="*/ 0 w 1221221"/>
              <a:gd name="connsiteY0" fmla="*/ 0 h 4329990"/>
              <a:gd name="connsiteX1" fmla="*/ 275173 w 1221221"/>
              <a:gd name="connsiteY1" fmla="*/ 120333 h 4329990"/>
              <a:gd name="connsiteX2" fmla="*/ 1221221 w 1221221"/>
              <a:gd name="connsiteY2" fmla="*/ 4329741 h 4329990"/>
              <a:gd name="connsiteX3" fmla="*/ 965339 w 1221221"/>
              <a:gd name="connsiteY3" fmla="*/ 4329990 h 4329990"/>
              <a:gd name="connsiteX4" fmla="*/ 0 w 1221221"/>
              <a:gd name="connsiteY4" fmla="*/ 0 h 4329990"/>
              <a:gd name="connsiteX0" fmla="*/ 0 w 1221221"/>
              <a:gd name="connsiteY0" fmla="*/ 0 h 4329990"/>
              <a:gd name="connsiteX1" fmla="*/ 275173 w 1221221"/>
              <a:gd name="connsiteY1" fmla="*/ 120333 h 4329990"/>
              <a:gd name="connsiteX2" fmla="*/ 1221221 w 1221221"/>
              <a:gd name="connsiteY2" fmla="*/ 4329741 h 4329990"/>
              <a:gd name="connsiteX3" fmla="*/ 965339 w 1221221"/>
              <a:gd name="connsiteY3" fmla="*/ 4329990 h 4329990"/>
              <a:gd name="connsiteX4" fmla="*/ 0 w 1221221"/>
              <a:gd name="connsiteY4" fmla="*/ 0 h 4329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21" h="4329990">
                <a:moveTo>
                  <a:pt x="0" y="0"/>
                </a:moveTo>
                <a:cubicBezTo>
                  <a:pt x="105527" y="36662"/>
                  <a:pt x="183449" y="80222"/>
                  <a:pt x="275173" y="120333"/>
                </a:cubicBezTo>
                <a:lnTo>
                  <a:pt x="1221221" y="4329741"/>
                </a:lnTo>
                <a:lnTo>
                  <a:pt x="965339" y="4329990"/>
                </a:lnTo>
                <a:cubicBezTo>
                  <a:pt x="598700" y="2670632"/>
                  <a:pt x="366639" y="1659358"/>
                  <a:pt x="0" y="0"/>
                </a:cubicBezTo>
                <a:close/>
              </a:path>
            </a:pathLst>
          </a:custGeom>
          <a:solidFill>
            <a:srgbClr val="EDE947"/>
          </a:soli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 dirty="0"/>
          </a:p>
        </p:txBody>
      </p:sp>
      <p:cxnSp>
        <p:nvCxnSpPr>
          <p:cNvPr id="177" name="Gerader Verbinder 176">
            <a:extLst>
              <a:ext uri="{FF2B5EF4-FFF2-40B4-BE49-F238E27FC236}">
                <a16:creationId xmlns:a16="http://schemas.microsoft.com/office/drawing/2014/main" id="{16414831-F08E-F046-BC91-ECDA734791AC}"/>
              </a:ext>
            </a:extLst>
          </p:cNvPr>
          <p:cNvCxnSpPr>
            <a:cxnSpLocks/>
          </p:cNvCxnSpPr>
          <p:nvPr/>
        </p:nvCxnSpPr>
        <p:spPr>
          <a:xfrm>
            <a:off x="1252422" y="1618407"/>
            <a:ext cx="814260" cy="366552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feld 177">
            <a:extLst>
              <a:ext uri="{FF2B5EF4-FFF2-40B4-BE49-F238E27FC236}">
                <a16:creationId xmlns:a16="http://schemas.microsoft.com/office/drawing/2014/main" id="{7E2471BA-A42D-D422-004D-B25B0A3CA8A8}"/>
              </a:ext>
            </a:extLst>
          </p:cNvPr>
          <p:cNvSpPr txBox="1"/>
          <p:nvPr/>
        </p:nvSpPr>
        <p:spPr>
          <a:xfrm>
            <a:off x="7154420" y="183380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0</a:t>
            </a:r>
          </a:p>
        </p:txBody>
      </p:sp>
      <p:sp>
        <p:nvSpPr>
          <p:cNvPr id="179" name="Textfeld 178">
            <a:extLst>
              <a:ext uri="{FF2B5EF4-FFF2-40B4-BE49-F238E27FC236}">
                <a16:creationId xmlns:a16="http://schemas.microsoft.com/office/drawing/2014/main" id="{2A8E17EF-6908-CECD-DB3C-84FEC1E40F19}"/>
              </a:ext>
            </a:extLst>
          </p:cNvPr>
          <p:cNvSpPr txBox="1"/>
          <p:nvPr/>
        </p:nvSpPr>
        <p:spPr>
          <a:xfrm>
            <a:off x="6167126" y="1992515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0</a:t>
            </a:r>
          </a:p>
        </p:txBody>
      </p:sp>
      <p:sp>
        <p:nvSpPr>
          <p:cNvPr id="180" name="Textfeld 179">
            <a:extLst>
              <a:ext uri="{FF2B5EF4-FFF2-40B4-BE49-F238E27FC236}">
                <a16:creationId xmlns:a16="http://schemas.microsoft.com/office/drawing/2014/main" id="{6FC83F79-7222-5CEF-F8DF-86C4256E8ED5}"/>
              </a:ext>
            </a:extLst>
          </p:cNvPr>
          <p:cNvSpPr txBox="1"/>
          <p:nvPr/>
        </p:nvSpPr>
        <p:spPr>
          <a:xfrm>
            <a:off x="5251868" y="2018429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1</a:t>
            </a:r>
          </a:p>
        </p:txBody>
      </p:sp>
      <p:cxnSp>
        <p:nvCxnSpPr>
          <p:cNvPr id="181" name="Gerader Verbinder 180">
            <a:extLst>
              <a:ext uri="{FF2B5EF4-FFF2-40B4-BE49-F238E27FC236}">
                <a16:creationId xmlns:a16="http://schemas.microsoft.com/office/drawing/2014/main" id="{128D8721-0E47-6692-1FB8-F5DFA9AC7457}"/>
              </a:ext>
            </a:extLst>
          </p:cNvPr>
          <p:cNvCxnSpPr/>
          <p:nvPr/>
        </p:nvCxnSpPr>
        <p:spPr>
          <a:xfrm rot="4320000">
            <a:off x="4521176" y="2538853"/>
            <a:ext cx="589528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feld 181">
            <a:extLst>
              <a:ext uri="{FF2B5EF4-FFF2-40B4-BE49-F238E27FC236}">
                <a16:creationId xmlns:a16="http://schemas.microsoft.com/office/drawing/2014/main" id="{E94E2D02-B295-9975-2682-A711D9F86A1D}"/>
              </a:ext>
            </a:extLst>
          </p:cNvPr>
          <p:cNvSpPr txBox="1"/>
          <p:nvPr/>
        </p:nvSpPr>
        <p:spPr>
          <a:xfrm>
            <a:off x="4507697" y="205082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2</a:t>
            </a:r>
          </a:p>
        </p:txBody>
      </p:sp>
      <p:cxnSp>
        <p:nvCxnSpPr>
          <p:cNvPr id="183" name="Gerader Verbinder 182">
            <a:extLst>
              <a:ext uri="{FF2B5EF4-FFF2-40B4-BE49-F238E27FC236}">
                <a16:creationId xmlns:a16="http://schemas.microsoft.com/office/drawing/2014/main" id="{7F535C44-255A-821C-1C4A-F5E914218BB3}"/>
              </a:ext>
            </a:extLst>
          </p:cNvPr>
          <p:cNvCxnSpPr/>
          <p:nvPr/>
        </p:nvCxnSpPr>
        <p:spPr>
          <a:xfrm rot="4260000">
            <a:off x="4175452" y="2563433"/>
            <a:ext cx="589528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feld 183">
            <a:extLst>
              <a:ext uri="{FF2B5EF4-FFF2-40B4-BE49-F238E27FC236}">
                <a16:creationId xmlns:a16="http://schemas.microsoft.com/office/drawing/2014/main" id="{13A25852-BF85-5334-E1AB-3A10116A59BA}"/>
              </a:ext>
            </a:extLst>
          </p:cNvPr>
          <p:cNvSpPr txBox="1"/>
          <p:nvPr/>
        </p:nvSpPr>
        <p:spPr>
          <a:xfrm>
            <a:off x="4222304" y="2095879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1</a:t>
            </a:r>
          </a:p>
        </p:txBody>
      </p:sp>
      <p:cxnSp>
        <p:nvCxnSpPr>
          <p:cNvPr id="185" name="Gerader Verbinder 184">
            <a:extLst>
              <a:ext uri="{FF2B5EF4-FFF2-40B4-BE49-F238E27FC236}">
                <a16:creationId xmlns:a16="http://schemas.microsoft.com/office/drawing/2014/main" id="{3254744A-B3A0-171E-7A5F-B5C960C5836B}"/>
              </a:ext>
            </a:extLst>
          </p:cNvPr>
          <p:cNvCxnSpPr/>
          <p:nvPr/>
        </p:nvCxnSpPr>
        <p:spPr>
          <a:xfrm rot="4020000">
            <a:off x="3789113" y="2459451"/>
            <a:ext cx="5895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feld 185">
            <a:extLst>
              <a:ext uri="{FF2B5EF4-FFF2-40B4-BE49-F238E27FC236}">
                <a16:creationId xmlns:a16="http://schemas.microsoft.com/office/drawing/2014/main" id="{F27FA8CD-C8B8-DD07-E7C3-51EA2DA056A6}"/>
              </a:ext>
            </a:extLst>
          </p:cNvPr>
          <p:cNvSpPr txBox="1"/>
          <p:nvPr/>
        </p:nvSpPr>
        <p:spPr>
          <a:xfrm>
            <a:off x="3982232" y="2025611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69</a:t>
            </a:r>
          </a:p>
        </p:txBody>
      </p:sp>
      <p:cxnSp>
        <p:nvCxnSpPr>
          <p:cNvPr id="187" name="Gerader Verbinder 186">
            <a:extLst>
              <a:ext uri="{FF2B5EF4-FFF2-40B4-BE49-F238E27FC236}">
                <a16:creationId xmlns:a16="http://schemas.microsoft.com/office/drawing/2014/main" id="{33B44BFA-0451-11D6-6CB2-8B2EC0FBBAE9}"/>
              </a:ext>
            </a:extLst>
          </p:cNvPr>
          <p:cNvCxnSpPr/>
          <p:nvPr/>
        </p:nvCxnSpPr>
        <p:spPr>
          <a:xfrm rot="4500000">
            <a:off x="5153336" y="2516919"/>
            <a:ext cx="589528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feld 187">
            <a:extLst>
              <a:ext uri="{FF2B5EF4-FFF2-40B4-BE49-F238E27FC236}">
                <a16:creationId xmlns:a16="http://schemas.microsoft.com/office/drawing/2014/main" id="{A04A43B3-A978-E462-EB52-1FE203877057}"/>
              </a:ext>
            </a:extLst>
          </p:cNvPr>
          <p:cNvSpPr txBox="1"/>
          <p:nvPr/>
        </p:nvSpPr>
        <p:spPr>
          <a:xfrm>
            <a:off x="5211976" y="240777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5</a:t>
            </a:r>
          </a:p>
        </p:txBody>
      </p:sp>
      <p:sp>
        <p:nvSpPr>
          <p:cNvPr id="189" name="Textfeld 188">
            <a:extLst>
              <a:ext uri="{FF2B5EF4-FFF2-40B4-BE49-F238E27FC236}">
                <a16:creationId xmlns:a16="http://schemas.microsoft.com/office/drawing/2014/main" id="{13209558-21F7-BA90-8812-69372CFA811B}"/>
              </a:ext>
            </a:extLst>
          </p:cNvPr>
          <p:cNvSpPr txBox="1"/>
          <p:nvPr/>
        </p:nvSpPr>
        <p:spPr>
          <a:xfrm>
            <a:off x="3857570" y="1983501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69</a:t>
            </a:r>
          </a:p>
        </p:txBody>
      </p:sp>
      <p:sp>
        <p:nvSpPr>
          <p:cNvPr id="190" name="Textfeld 189">
            <a:extLst>
              <a:ext uri="{FF2B5EF4-FFF2-40B4-BE49-F238E27FC236}">
                <a16:creationId xmlns:a16="http://schemas.microsoft.com/office/drawing/2014/main" id="{03A82123-D66F-F79D-F1F2-7F8D69E5CC5F}"/>
              </a:ext>
            </a:extLst>
          </p:cNvPr>
          <p:cNvSpPr txBox="1"/>
          <p:nvPr/>
        </p:nvSpPr>
        <p:spPr>
          <a:xfrm>
            <a:off x="3804538" y="2249991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1</a:t>
            </a:r>
          </a:p>
        </p:txBody>
      </p:sp>
      <p:sp>
        <p:nvSpPr>
          <p:cNvPr id="191" name="Textfeld 190">
            <a:extLst>
              <a:ext uri="{FF2B5EF4-FFF2-40B4-BE49-F238E27FC236}">
                <a16:creationId xmlns:a16="http://schemas.microsoft.com/office/drawing/2014/main" id="{8B6ACE65-C06C-4857-D5DE-B33249EB366E}"/>
              </a:ext>
            </a:extLst>
          </p:cNvPr>
          <p:cNvSpPr txBox="1"/>
          <p:nvPr/>
        </p:nvSpPr>
        <p:spPr>
          <a:xfrm>
            <a:off x="3466717" y="191703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1</a:t>
            </a:r>
          </a:p>
        </p:txBody>
      </p:sp>
      <p:cxnSp>
        <p:nvCxnSpPr>
          <p:cNvPr id="192" name="Gerader Verbinder 191">
            <a:extLst>
              <a:ext uri="{FF2B5EF4-FFF2-40B4-BE49-F238E27FC236}">
                <a16:creationId xmlns:a16="http://schemas.microsoft.com/office/drawing/2014/main" id="{9C6A3712-8B2A-49B7-6B7E-D34F9BBF5C2D}"/>
              </a:ext>
            </a:extLst>
          </p:cNvPr>
          <p:cNvCxnSpPr/>
          <p:nvPr/>
        </p:nvCxnSpPr>
        <p:spPr>
          <a:xfrm rot="4380000">
            <a:off x="2724234" y="2203715"/>
            <a:ext cx="589528" cy="0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feld 192">
            <a:extLst>
              <a:ext uri="{FF2B5EF4-FFF2-40B4-BE49-F238E27FC236}">
                <a16:creationId xmlns:a16="http://schemas.microsoft.com/office/drawing/2014/main" id="{11FF6F4C-DB1C-C70A-3041-7FE114199CEE}"/>
              </a:ext>
            </a:extLst>
          </p:cNvPr>
          <p:cNvSpPr txBox="1"/>
          <p:nvPr/>
        </p:nvSpPr>
        <p:spPr>
          <a:xfrm>
            <a:off x="2806305" y="173133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3</a:t>
            </a:r>
          </a:p>
        </p:txBody>
      </p:sp>
      <p:sp>
        <p:nvSpPr>
          <p:cNvPr id="194" name="Textfeld 193">
            <a:extLst>
              <a:ext uri="{FF2B5EF4-FFF2-40B4-BE49-F238E27FC236}">
                <a16:creationId xmlns:a16="http://schemas.microsoft.com/office/drawing/2014/main" id="{F77EBEE0-9FD4-6579-AE86-A57D1BC8D9D1}"/>
              </a:ext>
            </a:extLst>
          </p:cNvPr>
          <p:cNvSpPr txBox="1"/>
          <p:nvPr/>
        </p:nvSpPr>
        <p:spPr>
          <a:xfrm>
            <a:off x="2486529" y="1615593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6</a:t>
            </a:r>
          </a:p>
        </p:txBody>
      </p:sp>
      <p:sp>
        <p:nvSpPr>
          <p:cNvPr id="195" name="Textfeld 194">
            <a:extLst>
              <a:ext uri="{FF2B5EF4-FFF2-40B4-BE49-F238E27FC236}">
                <a16:creationId xmlns:a16="http://schemas.microsoft.com/office/drawing/2014/main" id="{595D2093-554C-E4B7-F129-2E223699F618}"/>
              </a:ext>
            </a:extLst>
          </p:cNvPr>
          <p:cNvSpPr txBox="1"/>
          <p:nvPr/>
        </p:nvSpPr>
        <p:spPr>
          <a:xfrm>
            <a:off x="1994350" y="1433995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6</a:t>
            </a:r>
          </a:p>
        </p:txBody>
      </p:sp>
      <p:sp>
        <p:nvSpPr>
          <p:cNvPr id="196" name="Textfeld 195">
            <a:extLst>
              <a:ext uri="{FF2B5EF4-FFF2-40B4-BE49-F238E27FC236}">
                <a16:creationId xmlns:a16="http://schemas.microsoft.com/office/drawing/2014/main" id="{0FF3D36F-F2C8-D8BF-550F-823CE46EB533}"/>
              </a:ext>
            </a:extLst>
          </p:cNvPr>
          <p:cNvSpPr txBox="1"/>
          <p:nvPr/>
        </p:nvSpPr>
        <p:spPr>
          <a:xfrm>
            <a:off x="1853067" y="1390127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6</a:t>
            </a:r>
          </a:p>
        </p:txBody>
      </p:sp>
      <p:cxnSp>
        <p:nvCxnSpPr>
          <p:cNvPr id="197" name="Gerader Verbinder 196">
            <a:extLst>
              <a:ext uri="{FF2B5EF4-FFF2-40B4-BE49-F238E27FC236}">
                <a16:creationId xmlns:a16="http://schemas.microsoft.com/office/drawing/2014/main" id="{30CA1087-1028-E2EE-4975-319C22CF2FDB}"/>
              </a:ext>
            </a:extLst>
          </p:cNvPr>
          <p:cNvCxnSpPr>
            <a:cxnSpLocks/>
          </p:cNvCxnSpPr>
          <p:nvPr/>
        </p:nvCxnSpPr>
        <p:spPr>
          <a:xfrm>
            <a:off x="1582274" y="1524719"/>
            <a:ext cx="131657" cy="564191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feld 197">
            <a:extLst>
              <a:ext uri="{FF2B5EF4-FFF2-40B4-BE49-F238E27FC236}">
                <a16:creationId xmlns:a16="http://schemas.microsoft.com/office/drawing/2014/main" id="{A3E4D144-4878-ABC5-11CD-069C387300C2}"/>
              </a:ext>
            </a:extLst>
          </p:cNvPr>
          <p:cNvSpPr txBox="1"/>
          <p:nvPr/>
        </p:nvSpPr>
        <p:spPr>
          <a:xfrm>
            <a:off x="1521599" y="1328711"/>
            <a:ext cx="268023" cy="1919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47" dirty="0"/>
              <a:t>76</a:t>
            </a:r>
          </a:p>
        </p:txBody>
      </p:sp>
      <p:sp>
        <p:nvSpPr>
          <p:cNvPr id="199" name="Textfeld 198">
            <a:extLst>
              <a:ext uri="{FF2B5EF4-FFF2-40B4-BE49-F238E27FC236}">
                <a16:creationId xmlns:a16="http://schemas.microsoft.com/office/drawing/2014/main" id="{7EB1A01A-AE7F-46CE-8EA1-44D573367637}"/>
              </a:ext>
            </a:extLst>
          </p:cNvPr>
          <p:cNvSpPr txBox="1"/>
          <p:nvPr/>
        </p:nvSpPr>
        <p:spPr>
          <a:xfrm rot="15444735">
            <a:off x="2425604" y="2847531"/>
            <a:ext cx="577403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100" dirty="0"/>
              <a:t>MdQ3 </a:t>
            </a:r>
          </a:p>
        </p:txBody>
      </p:sp>
      <p:sp>
        <p:nvSpPr>
          <p:cNvPr id="200" name="Textfeld 199">
            <a:extLst>
              <a:ext uri="{FF2B5EF4-FFF2-40B4-BE49-F238E27FC236}">
                <a16:creationId xmlns:a16="http://schemas.microsoft.com/office/drawing/2014/main" id="{EE27F9BE-7503-DDA8-48E0-1CFB30B99122}"/>
              </a:ext>
            </a:extLst>
          </p:cNvPr>
          <p:cNvSpPr txBox="1"/>
          <p:nvPr/>
        </p:nvSpPr>
        <p:spPr>
          <a:xfrm rot="15051003">
            <a:off x="6257195" y="3227561"/>
            <a:ext cx="514885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S1</a:t>
            </a:r>
          </a:p>
        </p:txBody>
      </p:sp>
      <p:sp>
        <p:nvSpPr>
          <p:cNvPr id="201" name="Textfeld 200">
            <a:extLst>
              <a:ext uri="{FF2B5EF4-FFF2-40B4-BE49-F238E27FC236}">
                <a16:creationId xmlns:a16="http://schemas.microsoft.com/office/drawing/2014/main" id="{25DC5BB6-974E-4E3A-6B47-D1EF6AAC5220}"/>
              </a:ext>
            </a:extLst>
          </p:cNvPr>
          <p:cNvSpPr txBox="1"/>
          <p:nvPr/>
        </p:nvSpPr>
        <p:spPr>
          <a:xfrm rot="14848395">
            <a:off x="4515726" y="3056811"/>
            <a:ext cx="545343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Q2</a:t>
            </a:r>
          </a:p>
        </p:txBody>
      </p:sp>
      <p:sp>
        <p:nvSpPr>
          <p:cNvPr id="202" name="Textfeld 201">
            <a:extLst>
              <a:ext uri="{FF2B5EF4-FFF2-40B4-BE49-F238E27FC236}">
                <a16:creationId xmlns:a16="http://schemas.microsoft.com/office/drawing/2014/main" id="{94B4D045-5E19-91B5-E94E-C419F1C34CB8}"/>
              </a:ext>
            </a:extLst>
          </p:cNvPr>
          <p:cNvSpPr txBox="1"/>
          <p:nvPr/>
        </p:nvSpPr>
        <p:spPr>
          <a:xfrm rot="15300771">
            <a:off x="3183840" y="2930203"/>
            <a:ext cx="514885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S2</a:t>
            </a:r>
          </a:p>
        </p:txBody>
      </p:sp>
      <p:sp>
        <p:nvSpPr>
          <p:cNvPr id="203" name="Textfeld 202">
            <a:extLst>
              <a:ext uri="{FF2B5EF4-FFF2-40B4-BE49-F238E27FC236}">
                <a16:creationId xmlns:a16="http://schemas.microsoft.com/office/drawing/2014/main" id="{9D816834-7AB9-AE6C-29A1-59774036A1BE}"/>
              </a:ext>
            </a:extLst>
          </p:cNvPr>
          <p:cNvSpPr txBox="1"/>
          <p:nvPr/>
        </p:nvSpPr>
        <p:spPr>
          <a:xfrm rot="14940000">
            <a:off x="4232433" y="3056117"/>
            <a:ext cx="510076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L2</a:t>
            </a:r>
          </a:p>
        </p:txBody>
      </p:sp>
      <p:sp>
        <p:nvSpPr>
          <p:cNvPr id="204" name="Textfeld 203">
            <a:extLst>
              <a:ext uri="{FF2B5EF4-FFF2-40B4-BE49-F238E27FC236}">
                <a16:creationId xmlns:a16="http://schemas.microsoft.com/office/drawing/2014/main" id="{B1CAEBE2-707C-D625-B722-77288D300788}"/>
              </a:ext>
            </a:extLst>
          </p:cNvPr>
          <p:cNvSpPr txBox="1"/>
          <p:nvPr/>
        </p:nvSpPr>
        <p:spPr>
          <a:xfrm rot="16200000">
            <a:off x="1189474" y="4173207"/>
            <a:ext cx="511679" cy="291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93" dirty="0" err="1"/>
              <a:t>dol</a:t>
            </a:r>
            <a:r>
              <a:rPr lang="de-DE" sz="1293" dirty="0"/>
              <a:t> ?</a:t>
            </a:r>
          </a:p>
        </p:txBody>
      </p:sp>
      <p:sp>
        <p:nvSpPr>
          <p:cNvPr id="205" name="Textfeld 204">
            <a:extLst>
              <a:ext uri="{FF2B5EF4-FFF2-40B4-BE49-F238E27FC236}">
                <a16:creationId xmlns:a16="http://schemas.microsoft.com/office/drawing/2014/main" id="{5765A97D-1C2C-52F3-2578-0A5D7659156F}"/>
              </a:ext>
            </a:extLst>
          </p:cNvPr>
          <p:cNvSpPr txBox="1"/>
          <p:nvPr/>
        </p:nvSpPr>
        <p:spPr>
          <a:xfrm rot="15260095">
            <a:off x="6153505" y="1630052"/>
            <a:ext cx="68159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67" i="1" dirty="0" err="1">
                <a:solidFill>
                  <a:srgbClr val="FF0000"/>
                </a:solidFill>
              </a:rPr>
              <a:t>Sheba</a:t>
            </a:r>
            <a:r>
              <a:rPr lang="de-DE" sz="1067" i="1" dirty="0">
                <a:solidFill>
                  <a:srgbClr val="FF0000"/>
                </a:solidFill>
              </a:rPr>
              <a:t> FZ</a:t>
            </a:r>
          </a:p>
        </p:txBody>
      </p:sp>
      <p:sp>
        <p:nvSpPr>
          <p:cNvPr id="206" name="Textfeld 205">
            <a:extLst>
              <a:ext uri="{FF2B5EF4-FFF2-40B4-BE49-F238E27FC236}">
                <a16:creationId xmlns:a16="http://schemas.microsoft.com/office/drawing/2014/main" id="{C56BA271-871B-4BEF-383E-EECBC890011F}"/>
              </a:ext>
            </a:extLst>
          </p:cNvPr>
          <p:cNvSpPr txBox="1"/>
          <p:nvPr/>
        </p:nvSpPr>
        <p:spPr>
          <a:xfrm rot="15405611">
            <a:off x="1920770" y="2795215"/>
            <a:ext cx="514885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S3</a:t>
            </a:r>
          </a:p>
        </p:txBody>
      </p:sp>
      <p:sp>
        <p:nvSpPr>
          <p:cNvPr id="207" name="Gleichschenkliges Dreieck 206">
            <a:extLst>
              <a:ext uri="{FF2B5EF4-FFF2-40B4-BE49-F238E27FC236}">
                <a16:creationId xmlns:a16="http://schemas.microsoft.com/office/drawing/2014/main" id="{F4A7E3F1-D282-56D9-DAE4-EC30C7E8B02C}"/>
              </a:ext>
            </a:extLst>
          </p:cNvPr>
          <p:cNvSpPr/>
          <p:nvPr/>
        </p:nvSpPr>
        <p:spPr>
          <a:xfrm rot="14796711">
            <a:off x="7223059" y="3298205"/>
            <a:ext cx="120452" cy="20540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208" name="Gleichschenkliges Dreieck 207">
            <a:extLst>
              <a:ext uri="{FF2B5EF4-FFF2-40B4-BE49-F238E27FC236}">
                <a16:creationId xmlns:a16="http://schemas.microsoft.com/office/drawing/2014/main" id="{B6579DF5-A4AA-8568-B0BD-FA024BC8AA7F}"/>
              </a:ext>
            </a:extLst>
          </p:cNvPr>
          <p:cNvSpPr/>
          <p:nvPr/>
        </p:nvSpPr>
        <p:spPr>
          <a:xfrm rot="15356046">
            <a:off x="2087033" y="3413331"/>
            <a:ext cx="120452" cy="20540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55"/>
          </a:p>
        </p:txBody>
      </p:sp>
      <p:sp>
        <p:nvSpPr>
          <p:cNvPr id="210" name="Textfeld 209">
            <a:extLst>
              <a:ext uri="{FF2B5EF4-FFF2-40B4-BE49-F238E27FC236}">
                <a16:creationId xmlns:a16="http://schemas.microsoft.com/office/drawing/2014/main" id="{676E6C8C-D96A-CB3C-91D0-643A0A0A74F6}"/>
              </a:ext>
            </a:extLst>
          </p:cNvPr>
          <p:cNvSpPr txBox="1"/>
          <p:nvPr/>
        </p:nvSpPr>
        <p:spPr>
          <a:xfrm>
            <a:off x="6770204" y="1783688"/>
            <a:ext cx="338555" cy="229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89" dirty="0"/>
              <a:t>45°</a:t>
            </a:r>
          </a:p>
        </p:txBody>
      </p:sp>
      <p:sp>
        <p:nvSpPr>
          <p:cNvPr id="213" name="Textfeld 212">
            <a:extLst>
              <a:ext uri="{FF2B5EF4-FFF2-40B4-BE49-F238E27FC236}">
                <a16:creationId xmlns:a16="http://schemas.microsoft.com/office/drawing/2014/main" id="{9BED9157-C99C-91E9-4BE2-7117FA507D09}"/>
              </a:ext>
            </a:extLst>
          </p:cNvPr>
          <p:cNvSpPr txBox="1"/>
          <p:nvPr/>
        </p:nvSpPr>
        <p:spPr>
          <a:xfrm rot="15212194">
            <a:off x="3404928" y="1642649"/>
            <a:ext cx="537327" cy="291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93" dirty="0">
                <a:solidFill>
                  <a:srgbClr val="CC3399"/>
                </a:solidFill>
              </a:rPr>
              <a:t>MdI2</a:t>
            </a:r>
          </a:p>
        </p:txBody>
      </p:sp>
      <p:grpSp>
        <p:nvGrpSpPr>
          <p:cNvPr id="214" name="Gruppieren 213">
            <a:extLst>
              <a:ext uri="{FF2B5EF4-FFF2-40B4-BE49-F238E27FC236}">
                <a16:creationId xmlns:a16="http://schemas.microsoft.com/office/drawing/2014/main" id="{B3F842CE-EB99-F172-9F50-8FCCBB5B8272}"/>
              </a:ext>
            </a:extLst>
          </p:cNvPr>
          <p:cNvGrpSpPr/>
          <p:nvPr/>
        </p:nvGrpSpPr>
        <p:grpSpPr>
          <a:xfrm rot="240000">
            <a:off x="5973525" y="2373433"/>
            <a:ext cx="385583" cy="1268441"/>
            <a:chOff x="4651756" y="3385219"/>
            <a:chExt cx="289187" cy="951331"/>
          </a:xfrm>
        </p:grpSpPr>
        <p:cxnSp>
          <p:nvCxnSpPr>
            <p:cNvPr id="329" name="Gerader Verbinder 328">
              <a:extLst>
                <a:ext uri="{FF2B5EF4-FFF2-40B4-BE49-F238E27FC236}">
                  <a16:creationId xmlns:a16="http://schemas.microsoft.com/office/drawing/2014/main" id="{E0D7636B-3004-BF40-80A2-2AFC4C6952C3}"/>
                </a:ext>
              </a:extLst>
            </p:cNvPr>
            <p:cNvCxnSpPr>
              <a:cxnSpLocks/>
            </p:cNvCxnSpPr>
            <p:nvPr/>
          </p:nvCxnSpPr>
          <p:spPr>
            <a:xfrm>
              <a:off x="4651756" y="3385219"/>
              <a:ext cx="242410" cy="758573"/>
            </a:xfrm>
            <a:prstGeom prst="line">
              <a:avLst/>
            </a:prstGeom>
            <a:ln w="3175">
              <a:solidFill>
                <a:srgbClr val="CE081B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Gerader Verbinder 329">
              <a:extLst>
                <a:ext uri="{FF2B5EF4-FFF2-40B4-BE49-F238E27FC236}">
                  <a16:creationId xmlns:a16="http://schemas.microsoft.com/office/drawing/2014/main" id="{4458E788-D4D4-83F8-D8DD-BEDB63B36993}"/>
                </a:ext>
              </a:extLst>
            </p:cNvPr>
            <p:cNvCxnSpPr>
              <a:cxnSpLocks/>
            </p:cNvCxnSpPr>
            <p:nvPr/>
          </p:nvCxnSpPr>
          <p:spPr>
            <a:xfrm>
              <a:off x="4698533" y="3577977"/>
              <a:ext cx="242410" cy="758573"/>
            </a:xfrm>
            <a:prstGeom prst="line">
              <a:avLst/>
            </a:prstGeom>
            <a:ln w="3175">
              <a:solidFill>
                <a:srgbClr val="CE081B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Gerader Verbinder 330">
              <a:extLst>
                <a:ext uri="{FF2B5EF4-FFF2-40B4-BE49-F238E27FC236}">
                  <a16:creationId xmlns:a16="http://schemas.microsoft.com/office/drawing/2014/main" id="{4F9F0A25-F29B-9FD5-8423-FF9AF330D13E}"/>
                </a:ext>
              </a:extLst>
            </p:cNvPr>
            <p:cNvCxnSpPr>
              <a:cxnSpLocks/>
            </p:cNvCxnSpPr>
            <p:nvPr/>
          </p:nvCxnSpPr>
          <p:spPr>
            <a:xfrm>
              <a:off x="4678376" y="3425423"/>
              <a:ext cx="242410" cy="758573"/>
            </a:xfrm>
            <a:prstGeom prst="line">
              <a:avLst/>
            </a:prstGeom>
            <a:ln w="3175">
              <a:solidFill>
                <a:srgbClr val="CE081B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5" name="Textfeld 214">
            <a:extLst>
              <a:ext uri="{FF2B5EF4-FFF2-40B4-BE49-F238E27FC236}">
                <a16:creationId xmlns:a16="http://schemas.microsoft.com/office/drawing/2014/main" id="{19A56F5A-716A-779F-DA83-D11937D12793}"/>
              </a:ext>
            </a:extLst>
          </p:cNvPr>
          <p:cNvSpPr txBox="1"/>
          <p:nvPr/>
        </p:nvSpPr>
        <p:spPr>
          <a:xfrm rot="15494057">
            <a:off x="5670977" y="1826980"/>
            <a:ext cx="537327" cy="291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93" dirty="0">
                <a:solidFill>
                  <a:srgbClr val="CC3399"/>
                </a:solidFill>
              </a:rPr>
              <a:t>MdI1</a:t>
            </a:r>
          </a:p>
        </p:txBody>
      </p:sp>
      <p:grpSp>
        <p:nvGrpSpPr>
          <p:cNvPr id="216" name="Gruppieren 215">
            <a:extLst>
              <a:ext uri="{FF2B5EF4-FFF2-40B4-BE49-F238E27FC236}">
                <a16:creationId xmlns:a16="http://schemas.microsoft.com/office/drawing/2014/main" id="{0496BA7A-DC05-BA97-E890-D2514295660E}"/>
              </a:ext>
            </a:extLst>
          </p:cNvPr>
          <p:cNvGrpSpPr/>
          <p:nvPr/>
        </p:nvGrpSpPr>
        <p:grpSpPr>
          <a:xfrm>
            <a:off x="831170" y="1232464"/>
            <a:ext cx="7233185" cy="1340821"/>
            <a:chOff x="1470809" y="2497227"/>
            <a:chExt cx="5372331" cy="1536793"/>
          </a:xfrm>
        </p:grpSpPr>
        <p:grpSp>
          <p:nvGrpSpPr>
            <p:cNvPr id="311" name="Gruppieren 310">
              <a:extLst>
                <a:ext uri="{FF2B5EF4-FFF2-40B4-BE49-F238E27FC236}">
                  <a16:creationId xmlns:a16="http://schemas.microsoft.com/office/drawing/2014/main" id="{728CA05B-F15B-4FCF-952B-8B556A779A13}"/>
                </a:ext>
              </a:extLst>
            </p:cNvPr>
            <p:cNvGrpSpPr/>
            <p:nvPr/>
          </p:nvGrpSpPr>
          <p:grpSpPr>
            <a:xfrm>
              <a:off x="1720975" y="2906129"/>
              <a:ext cx="5122165" cy="903458"/>
              <a:chOff x="2643748" y="7282602"/>
              <a:chExt cx="8994617" cy="3202556"/>
            </a:xfrm>
          </p:grpSpPr>
          <p:cxnSp>
            <p:nvCxnSpPr>
              <p:cNvPr id="322" name="Gerader Verbinder 321">
                <a:extLst>
                  <a:ext uri="{FF2B5EF4-FFF2-40B4-BE49-F238E27FC236}">
                    <a16:creationId xmlns:a16="http://schemas.microsoft.com/office/drawing/2014/main" id="{DF2AF485-A7A3-FD56-F907-B8F3ED85CDCC}"/>
                  </a:ext>
                </a:extLst>
              </p:cNvPr>
              <p:cNvCxnSpPr/>
              <p:nvPr/>
            </p:nvCxnSpPr>
            <p:spPr>
              <a:xfrm>
                <a:off x="2677245" y="7913049"/>
                <a:ext cx="8961120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Gerader Verbinder 322">
                <a:extLst>
                  <a:ext uri="{FF2B5EF4-FFF2-40B4-BE49-F238E27FC236}">
                    <a16:creationId xmlns:a16="http://schemas.microsoft.com/office/drawing/2014/main" id="{479FCE5B-2C65-CFC6-1C76-50C929AE9C20}"/>
                  </a:ext>
                </a:extLst>
              </p:cNvPr>
              <p:cNvCxnSpPr/>
              <p:nvPr/>
            </p:nvCxnSpPr>
            <p:spPr>
              <a:xfrm>
                <a:off x="2677245" y="9202104"/>
                <a:ext cx="8961120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4" name="Gerader Verbinder 323">
                <a:extLst>
                  <a:ext uri="{FF2B5EF4-FFF2-40B4-BE49-F238E27FC236}">
                    <a16:creationId xmlns:a16="http://schemas.microsoft.com/office/drawing/2014/main" id="{480C71CD-049F-D8ED-8C6B-8F12990457F8}"/>
                  </a:ext>
                </a:extLst>
              </p:cNvPr>
              <p:cNvCxnSpPr/>
              <p:nvPr/>
            </p:nvCxnSpPr>
            <p:spPr>
              <a:xfrm>
                <a:off x="2677245" y="7282602"/>
                <a:ext cx="8961120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Gerader Verbinder 324">
                <a:extLst>
                  <a:ext uri="{FF2B5EF4-FFF2-40B4-BE49-F238E27FC236}">
                    <a16:creationId xmlns:a16="http://schemas.microsoft.com/office/drawing/2014/main" id="{E9034DF3-F1E7-3114-A3CF-E593EB128C1E}"/>
                  </a:ext>
                </a:extLst>
              </p:cNvPr>
              <p:cNvCxnSpPr/>
              <p:nvPr/>
            </p:nvCxnSpPr>
            <p:spPr>
              <a:xfrm>
                <a:off x="2651845" y="9848002"/>
                <a:ext cx="8961120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6" name="Gerader Verbinder 325">
                <a:extLst>
                  <a:ext uri="{FF2B5EF4-FFF2-40B4-BE49-F238E27FC236}">
                    <a16:creationId xmlns:a16="http://schemas.microsoft.com/office/drawing/2014/main" id="{106F3304-19A3-5ED0-95E0-3F9D49DAC78E}"/>
                  </a:ext>
                </a:extLst>
              </p:cNvPr>
              <p:cNvCxnSpPr/>
              <p:nvPr/>
            </p:nvCxnSpPr>
            <p:spPr>
              <a:xfrm>
                <a:off x="2660497" y="9843631"/>
                <a:ext cx="8961119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Gerader Verbinder 326">
                <a:extLst>
                  <a:ext uri="{FF2B5EF4-FFF2-40B4-BE49-F238E27FC236}">
                    <a16:creationId xmlns:a16="http://schemas.microsoft.com/office/drawing/2014/main" id="{0189402B-7CAE-E5B7-0FA6-2DEA4AF68FBC}"/>
                  </a:ext>
                </a:extLst>
              </p:cNvPr>
              <p:cNvCxnSpPr/>
              <p:nvPr/>
            </p:nvCxnSpPr>
            <p:spPr>
              <a:xfrm>
                <a:off x="2643748" y="10485158"/>
                <a:ext cx="8961119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Gerader Verbinder 327">
                <a:extLst>
                  <a:ext uri="{FF2B5EF4-FFF2-40B4-BE49-F238E27FC236}">
                    <a16:creationId xmlns:a16="http://schemas.microsoft.com/office/drawing/2014/main" id="{40B3E8F9-7776-16A2-0B6D-2A409DE70A94}"/>
                  </a:ext>
                </a:extLst>
              </p:cNvPr>
              <p:cNvCxnSpPr/>
              <p:nvPr/>
            </p:nvCxnSpPr>
            <p:spPr>
              <a:xfrm>
                <a:off x="2677217" y="8531296"/>
                <a:ext cx="8961120" cy="0"/>
              </a:xfrm>
              <a:prstGeom prst="line">
                <a:avLst/>
              </a:prstGeom>
              <a:ln w="3175"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2" name="Gruppieren 311">
              <a:extLst>
                <a:ext uri="{FF2B5EF4-FFF2-40B4-BE49-F238E27FC236}">
                  <a16:creationId xmlns:a16="http://schemas.microsoft.com/office/drawing/2014/main" id="{59FBA232-BB8E-9B63-80BC-14251A12DB25}"/>
                </a:ext>
              </a:extLst>
            </p:cNvPr>
            <p:cNvGrpSpPr/>
            <p:nvPr/>
          </p:nvGrpSpPr>
          <p:grpSpPr>
            <a:xfrm>
              <a:off x="1473217" y="2775884"/>
              <a:ext cx="262290" cy="1258136"/>
              <a:chOff x="2236190" y="5073704"/>
              <a:chExt cx="380091" cy="1821363"/>
            </a:xfrm>
          </p:grpSpPr>
          <p:sp>
            <p:nvSpPr>
              <p:cNvPr id="315" name="Textfeld 314">
                <a:extLst>
                  <a:ext uri="{FF2B5EF4-FFF2-40B4-BE49-F238E27FC236}">
                    <a16:creationId xmlns:a16="http://schemas.microsoft.com/office/drawing/2014/main" id="{6F3DA7A9-67B7-F1A7-4B8E-01855E41ACB4}"/>
                  </a:ext>
                </a:extLst>
              </p:cNvPr>
              <p:cNvSpPr txBox="1"/>
              <p:nvPr/>
            </p:nvSpPr>
            <p:spPr>
              <a:xfrm>
                <a:off x="2236190" y="6110409"/>
                <a:ext cx="354038" cy="3439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47" dirty="0">
                    <a:solidFill>
                      <a:schemeClr val="bg1">
                        <a:lumMod val="50000"/>
                      </a:schemeClr>
                    </a:solidFill>
                  </a:rPr>
                  <a:t>820</a:t>
                </a:r>
              </a:p>
            </p:txBody>
          </p:sp>
          <p:sp>
            <p:nvSpPr>
              <p:cNvPr id="316" name="Textfeld 315">
                <a:extLst>
                  <a:ext uri="{FF2B5EF4-FFF2-40B4-BE49-F238E27FC236}">
                    <a16:creationId xmlns:a16="http://schemas.microsoft.com/office/drawing/2014/main" id="{D80B3F12-89FA-C522-47BD-95D02899ED76}"/>
                  </a:ext>
                </a:extLst>
              </p:cNvPr>
              <p:cNvSpPr txBox="1"/>
              <p:nvPr/>
            </p:nvSpPr>
            <p:spPr>
              <a:xfrm>
                <a:off x="2240777" y="5846250"/>
                <a:ext cx="354038" cy="3439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47" dirty="0">
                    <a:solidFill>
                      <a:schemeClr val="bg1">
                        <a:lumMod val="50000"/>
                      </a:schemeClr>
                    </a:solidFill>
                  </a:rPr>
                  <a:t>840</a:t>
                </a:r>
              </a:p>
            </p:txBody>
          </p:sp>
          <p:sp>
            <p:nvSpPr>
              <p:cNvPr id="317" name="Textfeld 316">
                <a:extLst>
                  <a:ext uri="{FF2B5EF4-FFF2-40B4-BE49-F238E27FC236}">
                    <a16:creationId xmlns:a16="http://schemas.microsoft.com/office/drawing/2014/main" id="{3E14229B-E0F3-D332-FBBF-302D77A77F8D}"/>
                  </a:ext>
                </a:extLst>
              </p:cNvPr>
              <p:cNvSpPr txBox="1"/>
              <p:nvPr/>
            </p:nvSpPr>
            <p:spPr>
              <a:xfrm>
                <a:off x="2248664" y="5564640"/>
                <a:ext cx="354038" cy="3439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47" dirty="0">
                    <a:solidFill>
                      <a:schemeClr val="bg1">
                        <a:lumMod val="50000"/>
                      </a:schemeClr>
                    </a:solidFill>
                  </a:rPr>
                  <a:t>860</a:t>
                </a:r>
              </a:p>
            </p:txBody>
          </p:sp>
          <p:sp>
            <p:nvSpPr>
              <p:cNvPr id="318" name="Textfeld 317">
                <a:extLst>
                  <a:ext uri="{FF2B5EF4-FFF2-40B4-BE49-F238E27FC236}">
                    <a16:creationId xmlns:a16="http://schemas.microsoft.com/office/drawing/2014/main" id="{CAC4A5E1-D0AB-B188-B732-EB7CA3257949}"/>
                  </a:ext>
                </a:extLst>
              </p:cNvPr>
              <p:cNvSpPr txBox="1"/>
              <p:nvPr/>
            </p:nvSpPr>
            <p:spPr>
              <a:xfrm>
                <a:off x="2255251" y="5313714"/>
                <a:ext cx="354038" cy="3439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47" dirty="0">
                    <a:solidFill>
                      <a:schemeClr val="bg1">
                        <a:lumMod val="50000"/>
                      </a:schemeClr>
                    </a:solidFill>
                  </a:rPr>
                  <a:t>880</a:t>
                </a:r>
              </a:p>
            </p:txBody>
          </p:sp>
          <p:sp>
            <p:nvSpPr>
              <p:cNvPr id="319" name="Textfeld 318">
                <a:extLst>
                  <a:ext uri="{FF2B5EF4-FFF2-40B4-BE49-F238E27FC236}">
                    <a16:creationId xmlns:a16="http://schemas.microsoft.com/office/drawing/2014/main" id="{A0744B12-5925-F778-7913-A1E3B3551964}"/>
                  </a:ext>
                </a:extLst>
              </p:cNvPr>
              <p:cNvSpPr txBox="1"/>
              <p:nvPr/>
            </p:nvSpPr>
            <p:spPr>
              <a:xfrm>
                <a:off x="2262243" y="5073704"/>
                <a:ext cx="354038" cy="3439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747" dirty="0">
                    <a:solidFill>
                      <a:schemeClr val="bg1">
                        <a:lumMod val="50000"/>
                      </a:schemeClr>
                    </a:solidFill>
                  </a:rPr>
                  <a:t>900</a:t>
                </a:r>
              </a:p>
            </p:txBody>
          </p:sp>
          <p:sp>
            <p:nvSpPr>
              <p:cNvPr id="320" name="Textfeld 319">
                <a:extLst>
                  <a:ext uri="{FF2B5EF4-FFF2-40B4-BE49-F238E27FC236}">
                    <a16:creationId xmlns:a16="http://schemas.microsoft.com/office/drawing/2014/main" id="{C34F1A23-CC36-4AE9-8200-EEC313FAAB34}"/>
                  </a:ext>
                </a:extLst>
              </p:cNvPr>
              <p:cNvSpPr txBox="1"/>
              <p:nvPr/>
            </p:nvSpPr>
            <p:spPr>
              <a:xfrm>
                <a:off x="2300770" y="6494397"/>
                <a:ext cx="305729" cy="4006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69" dirty="0">
                    <a:solidFill>
                      <a:schemeClr val="bg1">
                        <a:lumMod val="50000"/>
                      </a:schemeClr>
                    </a:solidFill>
                  </a:rPr>
                  <a:t>m</a:t>
                </a:r>
              </a:p>
            </p:txBody>
          </p:sp>
          <p:sp>
            <p:nvSpPr>
              <p:cNvPr id="321" name="Textfeld 320">
                <a:extLst>
                  <a:ext uri="{FF2B5EF4-FFF2-40B4-BE49-F238E27FC236}">
                    <a16:creationId xmlns:a16="http://schemas.microsoft.com/office/drawing/2014/main" id="{040A1A1B-4776-833C-A7AB-E9A012748238}"/>
                  </a:ext>
                </a:extLst>
              </p:cNvPr>
              <p:cNvSpPr txBox="1"/>
              <p:nvPr/>
            </p:nvSpPr>
            <p:spPr>
              <a:xfrm>
                <a:off x="2255400" y="6382436"/>
                <a:ext cx="343686" cy="3268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80" dirty="0">
                    <a:solidFill>
                      <a:schemeClr val="bg1">
                        <a:lumMod val="50000"/>
                      </a:schemeClr>
                    </a:solidFill>
                  </a:rPr>
                  <a:t>800</a:t>
                </a:r>
              </a:p>
            </p:txBody>
          </p:sp>
        </p:grpSp>
        <p:sp>
          <p:nvSpPr>
            <p:cNvPr id="313" name="Textfeld 312">
              <a:extLst>
                <a:ext uri="{FF2B5EF4-FFF2-40B4-BE49-F238E27FC236}">
                  <a16:creationId xmlns:a16="http://schemas.microsoft.com/office/drawing/2014/main" id="{937A064D-C876-7585-9CA1-18299AAC4718}"/>
                </a:ext>
              </a:extLst>
            </p:cNvPr>
            <p:cNvSpPr txBox="1"/>
            <p:nvPr/>
          </p:nvSpPr>
          <p:spPr>
            <a:xfrm>
              <a:off x="1470809" y="2497227"/>
              <a:ext cx="497911" cy="3693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47" dirty="0" err="1">
                  <a:solidFill>
                    <a:schemeClr val="bg1">
                      <a:lumMod val="50000"/>
                    </a:schemeClr>
                  </a:solidFill>
                </a:rPr>
                <a:t>Topographic</a:t>
              </a:r>
              <a:endParaRPr lang="de-DE" sz="747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de-DE" sz="747" dirty="0">
                  <a:solidFill>
                    <a:schemeClr val="bg1">
                      <a:lumMod val="50000"/>
                    </a:schemeClr>
                  </a:solidFill>
                </a:rPr>
                <a:t>Elevation</a:t>
              </a:r>
            </a:p>
          </p:txBody>
        </p:sp>
        <p:sp>
          <p:nvSpPr>
            <p:cNvPr id="314" name="Freihandform: Form 313">
              <a:extLst>
                <a:ext uri="{FF2B5EF4-FFF2-40B4-BE49-F238E27FC236}">
                  <a16:creationId xmlns:a16="http://schemas.microsoft.com/office/drawing/2014/main" id="{573FD2E7-66A6-CDAF-9831-D12BDB222720}"/>
                </a:ext>
              </a:extLst>
            </p:cNvPr>
            <p:cNvSpPr/>
            <p:nvPr/>
          </p:nvSpPr>
          <p:spPr>
            <a:xfrm>
              <a:off x="1736200" y="2827853"/>
              <a:ext cx="4791950" cy="889143"/>
            </a:xfrm>
            <a:custGeom>
              <a:avLst/>
              <a:gdLst>
                <a:gd name="connsiteX0" fmla="*/ 0 w 5985164"/>
                <a:gd name="connsiteY0" fmla="*/ 0 h 1171940"/>
                <a:gd name="connsiteX1" fmla="*/ 477982 w 5985164"/>
                <a:gd name="connsiteY1" fmla="*/ 249382 h 1171940"/>
                <a:gd name="connsiteX2" fmla="*/ 976746 w 5985164"/>
                <a:gd name="connsiteY2" fmla="*/ 561109 h 1171940"/>
                <a:gd name="connsiteX3" fmla="*/ 1517073 w 5985164"/>
                <a:gd name="connsiteY3" fmla="*/ 789709 h 1171940"/>
                <a:gd name="connsiteX4" fmla="*/ 2369128 w 5985164"/>
                <a:gd name="connsiteY4" fmla="*/ 1080654 h 1171940"/>
                <a:gd name="connsiteX5" fmla="*/ 2660073 w 5985164"/>
                <a:gd name="connsiteY5" fmla="*/ 1143000 h 1171940"/>
                <a:gd name="connsiteX6" fmla="*/ 4447309 w 5985164"/>
                <a:gd name="connsiteY6" fmla="*/ 1059872 h 1171940"/>
                <a:gd name="connsiteX7" fmla="*/ 5985164 w 5985164"/>
                <a:gd name="connsiteY7" fmla="*/ 0 h 1171940"/>
                <a:gd name="connsiteX8" fmla="*/ 5985164 w 5985164"/>
                <a:gd name="connsiteY8" fmla="*/ 0 h 1171940"/>
                <a:gd name="connsiteX0" fmla="*/ 0 w 5985164"/>
                <a:gd name="connsiteY0" fmla="*/ 0 h 1171940"/>
                <a:gd name="connsiteX1" fmla="*/ 166255 w 5985164"/>
                <a:gd name="connsiteY1" fmla="*/ 83127 h 1171940"/>
                <a:gd name="connsiteX2" fmla="*/ 477982 w 5985164"/>
                <a:gd name="connsiteY2" fmla="*/ 249382 h 1171940"/>
                <a:gd name="connsiteX3" fmla="*/ 976746 w 5985164"/>
                <a:gd name="connsiteY3" fmla="*/ 561109 h 1171940"/>
                <a:gd name="connsiteX4" fmla="*/ 1517073 w 5985164"/>
                <a:gd name="connsiteY4" fmla="*/ 789709 h 1171940"/>
                <a:gd name="connsiteX5" fmla="*/ 2369128 w 5985164"/>
                <a:gd name="connsiteY5" fmla="*/ 1080654 h 1171940"/>
                <a:gd name="connsiteX6" fmla="*/ 2660073 w 5985164"/>
                <a:gd name="connsiteY6" fmla="*/ 1143000 h 1171940"/>
                <a:gd name="connsiteX7" fmla="*/ 4447309 w 5985164"/>
                <a:gd name="connsiteY7" fmla="*/ 1059872 h 1171940"/>
                <a:gd name="connsiteX8" fmla="*/ 5985164 w 5985164"/>
                <a:gd name="connsiteY8" fmla="*/ 0 h 1171940"/>
                <a:gd name="connsiteX9" fmla="*/ 5985164 w 5985164"/>
                <a:gd name="connsiteY9" fmla="*/ 0 h 1171940"/>
                <a:gd name="connsiteX0" fmla="*/ 0 w 6920346"/>
                <a:gd name="connsiteY0" fmla="*/ 20782 h 1171940"/>
                <a:gd name="connsiteX1" fmla="*/ 1101437 w 6920346"/>
                <a:gd name="connsiteY1" fmla="*/ 83127 h 1171940"/>
                <a:gd name="connsiteX2" fmla="*/ 1413164 w 6920346"/>
                <a:gd name="connsiteY2" fmla="*/ 249382 h 1171940"/>
                <a:gd name="connsiteX3" fmla="*/ 1911928 w 6920346"/>
                <a:gd name="connsiteY3" fmla="*/ 561109 h 1171940"/>
                <a:gd name="connsiteX4" fmla="*/ 2452255 w 6920346"/>
                <a:gd name="connsiteY4" fmla="*/ 789709 h 1171940"/>
                <a:gd name="connsiteX5" fmla="*/ 3304310 w 6920346"/>
                <a:gd name="connsiteY5" fmla="*/ 1080654 h 1171940"/>
                <a:gd name="connsiteX6" fmla="*/ 3595255 w 6920346"/>
                <a:gd name="connsiteY6" fmla="*/ 1143000 h 1171940"/>
                <a:gd name="connsiteX7" fmla="*/ 5382491 w 6920346"/>
                <a:gd name="connsiteY7" fmla="*/ 1059872 h 1171940"/>
                <a:gd name="connsiteX8" fmla="*/ 6920346 w 6920346"/>
                <a:gd name="connsiteY8" fmla="*/ 0 h 1171940"/>
                <a:gd name="connsiteX9" fmla="*/ 6920346 w 6920346"/>
                <a:gd name="connsiteY9" fmla="*/ 0 h 1171940"/>
                <a:gd name="connsiteX0" fmla="*/ 0 w 6920346"/>
                <a:gd name="connsiteY0" fmla="*/ 20782 h 1171940"/>
                <a:gd name="connsiteX1" fmla="*/ 477982 w 6920346"/>
                <a:gd name="connsiteY1" fmla="*/ 62345 h 1171940"/>
                <a:gd name="connsiteX2" fmla="*/ 1101437 w 6920346"/>
                <a:gd name="connsiteY2" fmla="*/ 83127 h 1171940"/>
                <a:gd name="connsiteX3" fmla="*/ 1413164 w 6920346"/>
                <a:gd name="connsiteY3" fmla="*/ 249382 h 1171940"/>
                <a:gd name="connsiteX4" fmla="*/ 1911928 w 6920346"/>
                <a:gd name="connsiteY4" fmla="*/ 561109 h 1171940"/>
                <a:gd name="connsiteX5" fmla="*/ 2452255 w 6920346"/>
                <a:gd name="connsiteY5" fmla="*/ 789709 h 1171940"/>
                <a:gd name="connsiteX6" fmla="*/ 3304310 w 6920346"/>
                <a:gd name="connsiteY6" fmla="*/ 1080654 h 1171940"/>
                <a:gd name="connsiteX7" fmla="*/ 3595255 w 6920346"/>
                <a:gd name="connsiteY7" fmla="*/ 1143000 h 1171940"/>
                <a:gd name="connsiteX8" fmla="*/ 5382491 w 6920346"/>
                <a:gd name="connsiteY8" fmla="*/ 1059872 h 1171940"/>
                <a:gd name="connsiteX9" fmla="*/ 6920346 w 6920346"/>
                <a:gd name="connsiteY9" fmla="*/ 0 h 1171940"/>
                <a:gd name="connsiteX10" fmla="*/ 6920346 w 6920346"/>
                <a:gd name="connsiteY10" fmla="*/ 0 h 1171940"/>
                <a:gd name="connsiteX0" fmla="*/ 0 w 6920346"/>
                <a:gd name="connsiteY0" fmla="*/ 145950 h 1297108"/>
                <a:gd name="connsiteX1" fmla="*/ 436419 w 6920346"/>
                <a:gd name="connsiteY1" fmla="*/ 477 h 1297108"/>
                <a:gd name="connsiteX2" fmla="*/ 1101437 w 6920346"/>
                <a:gd name="connsiteY2" fmla="*/ 208295 h 1297108"/>
                <a:gd name="connsiteX3" fmla="*/ 1413164 w 6920346"/>
                <a:gd name="connsiteY3" fmla="*/ 374550 h 1297108"/>
                <a:gd name="connsiteX4" fmla="*/ 1911928 w 6920346"/>
                <a:gd name="connsiteY4" fmla="*/ 686277 h 1297108"/>
                <a:gd name="connsiteX5" fmla="*/ 2452255 w 6920346"/>
                <a:gd name="connsiteY5" fmla="*/ 914877 h 1297108"/>
                <a:gd name="connsiteX6" fmla="*/ 3304310 w 6920346"/>
                <a:gd name="connsiteY6" fmla="*/ 1205822 h 1297108"/>
                <a:gd name="connsiteX7" fmla="*/ 3595255 w 6920346"/>
                <a:gd name="connsiteY7" fmla="*/ 1268168 h 1297108"/>
                <a:gd name="connsiteX8" fmla="*/ 5382491 w 6920346"/>
                <a:gd name="connsiteY8" fmla="*/ 1185040 h 1297108"/>
                <a:gd name="connsiteX9" fmla="*/ 6920346 w 6920346"/>
                <a:gd name="connsiteY9" fmla="*/ 125168 h 1297108"/>
                <a:gd name="connsiteX10" fmla="*/ 6920346 w 6920346"/>
                <a:gd name="connsiteY10" fmla="*/ 125168 h 1297108"/>
                <a:gd name="connsiteX0" fmla="*/ 0 w 6920346"/>
                <a:gd name="connsiteY0" fmla="*/ 145950 h 1299337"/>
                <a:gd name="connsiteX1" fmla="*/ 436419 w 6920346"/>
                <a:gd name="connsiteY1" fmla="*/ 477 h 1299337"/>
                <a:gd name="connsiteX2" fmla="*/ 1101437 w 6920346"/>
                <a:gd name="connsiteY2" fmla="*/ 208295 h 1299337"/>
                <a:gd name="connsiteX3" fmla="*/ 1413164 w 6920346"/>
                <a:gd name="connsiteY3" fmla="*/ 374550 h 1299337"/>
                <a:gd name="connsiteX4" fmla="*/ 1911928 w 6920346"/>
                <a:gd name="connsiteY4" fmla="*/ 686277 h 1299337"/>
                <a:gd name="connsiteX5" fmla="*/ 2452255 w 6920346"/>
                <a:gd name="connsiteY5" fmla="*/ 914877 h 1299337"/>
                <a:gd name="connsiteX6" fmla="*/ 3190010 w 6920346"/>
                <a:gd name="connsiteY6" fmla="*/ 1167722 h 1299337"/>
                <a:gd name="connsiteX7" fmla="*/ 3595255 w 6920346"/>
                <a:gd name="connsiteY7" fmla="*/ 1268168 h 1299337"/>
                <a:gd name="connsiteX8" fmla="*/ 5382491 w 6920346"/>
                <a:gd name="connsiteY8" fmla="*/ 1185040 h 1299337"/>
                <a:gd name="connsiteX9" fmla="*/ 6920346 w 6920346"/>
                <a:gd name="connsiteY9" fmla="*/ 125168 h 1299337"/>
                <a:gd name="connsiteX10" fmla="*/ 6920346 w 6920346"/>
                <a:gd name="connsiteY10" fmla="*/ 125168 h 1299337"/>
                <a:gd name="connsiteX0" fmla="*/ 0 w 6920346"/>
                <a:gd name="connsiteY0" fmla="*/ 145950 h 1309929"/>
                <a:gd name="connsiteX1" fmla="*/ 436419 w 6920346"/>
                <a:gd name="connsiteY1" fmla="*/ 477 h 1309929"/>
                <a:gd name="connsiteX2" fmla="*/ 1101437 w 6920346"/>
                <a:gd name="connsiteY2" fmla="*/ 208295 h 1309929"/>
                <a:gd name="connsiteX3" fmla="*/ 1413164 w 6920346"/>
                <a:gd name="connsiteY3" fmla="*/ 374550 h 1309929"/>
                <a:gd name="connsiteX4" fmla="*/ 1911928 w 6920346"/>
                <a:gd name="connsiteY4" fmla="*/ 686277 h 1309929"/>
                <a:gd name="connsiteX5" fmla="*/ 2452255 w 6920346"/>
                <a:gd name="connsiteY5" fmla="*/ 914877 h 1309929"/>
                <a:gd name="connsiteX6" fmla="*/ 3190010 w 6920346"/>
                <a:gd name="connsiteY6" fmla="*/ 1167722 h 1309929"/>
                <a:gd name="connsiteX7" fmla="*/ 3557155 w 6920346"/>
                <a:gd name="connsiteY7" fmla="*/ 1287218 h 1309929"/>
                <a:gd name="connsiteX8" fmla="*/ 5382491 w 6920346"/>
                <a:gd name="connsiteY8" fmla="*/ 1185040 h 1309929"/>
                <a:gd name="connsiteX9" fmla="*/ 6920346 w 6920346"/>
                <a:gd name="connsiteY9" fmla="*/ 125168 h 1309929"/>
                <a:gd name="connsiteX10" fmla="*/ 6920346 w 6920346"/>
                <a:gd name="connsiteY10" fmla="*/ 125168 h 1309929"/>
                <a:gd name="connsiteX0" fmla="*/ 0 w 6920346"/>
                <a:gd name="connsiteY0" fmla="*/ 145950 h 1309929"/>
                <a:gd name="connsiteX1" fmla="*/ 436419 w 6920346"/>
                <a:gd name="connsiteY1" fmla="*/ 477 h 1309929"/>
                <a:gd name="connsiteX2" fmla="*/ 1101437 w 6920346"/>
                <a:gd name="connsiteY2" fmla="*/ 208295 h 1309929"/>
                <a:gd name="connsiteX3" fmla="*/ 1413164 w 6920346"/>
                <a:gd name="connsiteY3" fmla="*/ 374550 h 1309929"/>
                <a:gd name="connsiteX4" fmla="*/ 1911928 w 6920346"/>
                <a:gd name="connsiteY4" fmla="*/ 686277 h 1309929"/>
                <a:gd name="connsiteX5" fmla="*/ 2452255 w 6920346"/>
                <a:gd name="connsiteY5" fmla="*/ 914877 h 1309929"/>
                <a:gd name="connsiteX6" fmla="*/ 3190010 w 6920346"/>
                <a:gd name="connsiteY6" fmla="*/ 1167722 h 1309929"/>
                <a:gd name="connsiteX7" fmla="*/ 3557155 w 6920346"/>
                <a:gd name="connsiteY7" fmla="*/ 1287218 h 1309929"/>
                <a:gd name="connsiteX8" fmla="*/ 5382491 w 6920346"/>
                <a:gd name="connsiteY8" fmla="*/ 1185040 h 1309929"/>
                <a:gd name="connsiteX9" fmla="*/ 6920346 w 6920346"/>
                <a:gd name="connsiteY9" fmla="*/ 125168 h 1309929"/>
                <a:gd name="connsiteX10" fmla="*/ 6920346 w 6920346"/>
                <a:gd name="connsiteY10" fmla="*/ 125168 h 1309929"/>
                <a:gd name="connsiteX0" fmla="*/ 0 w 6920346"/>
                <a:gd name="connsiteY0" fmla="*/ 145950 h 1289502"/>
                <a:gd name="connsiteX1" fmla="*/ 436419 w 6920346"/>
                <a:gd name="connsiteY1" fmla="*/ 477 h 1289502"/>
                <a:gd name="connsiteX2" fmla="*/ 1101437 w 6920346"/>
                <a:gd name="connsiteY2" fmla="*/ 208295 h 1289502"/>
                <a:gd name="connsiteX3" fmla="*/ 1413164 w 6920346"/>
                <a:gd name="connsiteY3" fmla="*/ 374550 h 1289502"/>
                <a:gd name="connsiteX4" fmla="*/ 1911928 w 6920346"/>
                <a:gd name="connsiteY4" fmla="*/ 686277 h 1289502"/>
                <a:gd name="connsiteX5" fmla="*/ 2452255 w 6920346"/>
                <a:gd name="connsiteY5" fmla="*/ 914877 h 1289502"/>
                <a:gd name="connsiteX6" fmla="*/ 3190010 w 6920346"/>
                <a:gd name="connsiteY6" fmla="*/ 1167722 h 1289502"/>
                <a:gd name="connsiteX7" fmla="*/ 3557155 w 6920346"/>
                <a:gd name="connsiteY7" fmla="*/ 1287218 h 1289502"/>
                <a:gd name="connsiteX8" fmla="*/ 5382491 w 6920346"/>
                <a:gd name="connsiteY8" fmla="*/ 1185040 h 1289502"/>
                <a:gd name="connsiteX9" fmla="*/ 6920346 w 6920346"/>
                <a:gd name="connsiteY9" fmla="*/ 125168 h 1289502"/>
                <a:gd name="connsiteX10" fmla="*/ 6920346 w 6920346"/>
                <a:gd name="connsiteY10" fmla="*/ 125168 h 1289502"/>
                <a:gd name="connsiteX0" fmla="*/ 0 w 6920346"/>
                <a:gd name="connsiteY0" fmla="*/ 145950 h 1289502"/>
                <a:gd name="connsiteX1" fmla="*/ 436419 w 6920346"/>
                <a:gd name="connsiteY1" fmla="*/ 477 h 1289502"/>
                <a:gd name="connsiteX2" fmla="*/ 1101437 w 6920346"/>
                <a:gd name="connsiteY2" fmla="*/ 208295 h 1289502"/>
                <a:gd name="connsiteX3" fmla="*/ 1413164 w 6920346"/>
                <a:gd name="connsiteY3" fmla="*/ 374550 h 1289502"/>
                <a:gd name="connsiteX4" fmla="*/ 1911928 w 6920346"/>
                <a:gd name="connsiteY4" fmla="*/ 686277 h 1289502"/>
                <a:gd name="connsiteX5" fmla="*/ 2452255 w 6920346"/>
                <a:gd name="connsiteY5" fmla="*/ 914877 h 1289502"/>
                <a:gd name="connsiteX6" fmla="*/ 3190010 w 6920346"/>
                <a:gd name="connsiteY6" fmla="*/ 1167722 h 1289502"/>
                <a:gd name="connsiteX7" fmla="*/ 3557155 w 6920346"/>
                <a:gd name="connsiteY7" fmla="*/ 1287218 h 1289502"/>
                <a:gd name="connsiteX8" fmla="*/ 5382491 w 6920346"/>
                <a:gd name="connsiteY8" fmla="*/ 1185040 h 1289502"/>
                <a:gd name="connsiteX9" fmla="*/ 6920346 w 6920346"/>
                <a:gd name="connsiteY9" fmla="*/ 125168 h 1289502"/>
                <a:gd name="connsiteX10" fmla="*/ 6920346 w 6920346"/>
                <a:gd name="connsiteY10" fmla="*/ 125168 h 1289502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10" fmla="*/ 6920346 w 6920346"/>
                <a:gd name="connsiteY10" fmla="*/ 125168 h 1287218"/>
                <a:gd name="connsiteX0" fmla="*/ 0 w 7031821"/>
                <a:gd name="connsiteY0" fmla="*/ 145950 h 1287218"/>
                <a:gd name="connsiteX1" fmla="*/ 436419 w 7031821"/>
                <a:gd name="connsiteY1" fmla="*/ 477 h 1287218"/>
                <a:gd name="connsiteX2" fmla="*/ 1101437 w 7031821"/>
                <a:gd name="connsiteY2" fmla="*/ 208295 h 1287218"/>
                <a:gd name="connsiteX3" fmla="*/ 1413164 w 7031821"/>
                <a:gd name="connsiteY3" fmla="*/ 374550 h 1287218"/>
                <a:gd name="connsiteX4" fmla="*/ 1911928 w 7031821"/>
                <a:gd name="connsiteY4" fmla="*/ 686277 h 1287218"/>
                <a:gd name="connsiteX5" fmla="*/ 2452255 w 7031821"/>
                <a:gd name="connsiteY5" fmla="*/ 914877 h 1287218"/>
                <a:gd name="connsiteX6" fmla="*/ 3190010 w 7031821"/>
                <a:gd name="connsiteY6" fmla="*/ 1167722 h 1287218"/>
                <a:gd name="connsiteX7" fmla="*/ 3557155 w 7031821"/>
                <a:gd name="connsiteY7" fmla="*/ 1287218 h 1287218"/>
                <a:gd name="connsiteX8" fmla="*/ 5382491 w 7031821"/>
                <a:gd name="connsiteY8" fmla="*/ 1185040 h 1287218"/>
                <a:gd name="connsiteX9" fmla="*/ 6920346 w 7031821"/>
                <a:gd name="connsiteY9" fmla="*/ 125168 h 1287218"/>
                <a:gd name="connsiteX10" fmla="*/ 6910821 w 7031821"/>
                <a:gd name="connsiteY10" fmla="*/ 106118 h 1287218"/>
                <a:gd name="connsiteX0" fmla="*/ 0 w 7005275"/>
                <a:gd name="connsiteY0" fmla="*/ 145950 h 1287218"/>
                <a:gd name="connsiteX1" fmla="*/ 436419 w 7005275"/>
                <a:gd name="connsiteY1" fmla="*/ 477 h 1287218"/>
                <a:gd name="connsiteX2" fmla="*/ 1101437 w 7005275"/>
                <a:gd name="connsiteY2" fmla="*/ 208295 h 1287218"/>
                <a:gd name="connsiteX3" fmla="*/ 1413164 w 7005275"/>
                <a:gd name="connsiteY3" fmla="*/ 374550 h 1287218"/>
                <a:gd name="connsiteX4" fmla="*/ 1911928 w 7005275"/>
                <a:gd name="connsiteY4" fmla="*/ 686277 h 1287218"/>
                <a:gd name="connsiteX5" fmla="*/ 2452255 w 7005275"/>
                <a:gd name="connsiteY5" fmla="*/ 914877 h 1287218"/>
                <a:gd name="connsiteX6" fmla="*/ 3190010 w 7005275"/>
                <a:gd name="connsiteY6" fmla="*/ 1167722 h 1287218"/>
                <a:gd name="connsiteX7" fmla="*/ 3557155 w 7005275"/>
                <a:gd name="connsiteY7" fmla="*/ 1287218 h 1287218"/>
                <a:gd name="connsiteX8" fmla="*/ 5382491 w 7005275"/>
                <a:gd name="connsiteY8" fmla="*/ 1185040 h 1287218"/>
                <a:gd name="connsiteX9" fmla="*/ 6920346 w 7005275"/>
                <a:gd name="connsiteY9" fmla="*/ 125168 h 1287218"/>
                <a:gd name="connsiteX10" fmla="*/ 6815571 w 7005275"/>
                <a:gd name="connsiteY10" fmla="*/ 2013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125168 h 1287218"/>
                <a:gd name="connsiteX0" fmla="*/ 0 w 6920346"/>
                <a:gd name="connsiteY0" fmla="*/ 145950 h 1287218"/>
                <a:gd name="connsiteX1" fmla="*/ 436419 w 6920346"/>
                <a:gd name="connsiteY1" fmla="*/ 477 h 1287218"/>
                <a:gd name="connsiteX2" fmla="*/ 1101437 w 6920346"/>
                <a:gd name="connsiteY2" fmla="*/ 208295 h 1287218"/>
                <a:gd name="connsiteX3" fmla="*/ 1413164 w 6920346"/>
                <a:gd name="connsiteY3" fmla="*/ 374550 h 1287218"/>
                <a:gd name="connsiteX4" fmla="*/ 1911928 w 6920346"/>
                <a:gd name="connsiteY4" fmla="*/ 686277 h 1287218"/>
                <a:gd name="connsiteX5" fmla="*/ 2452255 w 6920346"/>
                <a:gd name="connsiteY5" fmla="*/ 914877 h 1287218"/>
                <a:gd name="connsiteX6" fmla="*/ 3190010 w 6920346"/>
                <a:gd name="connsiteY6" fmla="*/ 1167722 h 1287218"/>
                <a:gd name="connsiteX7" fmla="*/ 3557155 w 6920346"/>
                <a:gd name="connsiteY7" fmla="*/ 1287218 h 1287218"/>
                <a:gd name="connsiteX8" fmla="*/ 5382491 w 6920346"/>
                <a:gd name="connsiteY8" fmla="*/ 1185040 h 1287218"/>
                <a:gd name="connsiteX9" fmla="*/ 6920346 w 6920346"/>
                <a:gd name="connsiteY9" fmla="*/ 374550 h 1287218"/>
                <a:gd name="connsiteX0" fmla="*/ 0 w 6944159"/>
                <a:gd name="connsiteY0" fmla="*/ 150636 h 1287141"/>
                <a:gd name="connsiteX1" fmla="*/ 460232 w 6944159"/>
                <a:gd name="connsiteY1" fmla="*/ 400 h 1287141"/>
                <a:gd name="connsiteX2" fmla="*/ 1125250 w 6944159"/>
                <a:gd name="connsiteY2" fmla="*/ 208218 h 1287141"/>
                <a:gd name="connsiteX3" fmla="*/ 1436977 w 6944159"/>
                <a:gd name="connsiteY3" fmla="*/ 374473 h 1287141"/>
                <a:gd name="connsiteX4" fmla="*/ 1935741 w 6944159"/>
                <a:gd name="connsiteY4" fmla="*/ 686200 h 1287141"/>
                <a:gd name="connsiteX5" fmla="*/ 2476068 w 6944159"/>
                <a:gd name="connsiteY5" fmla="*/ 914800 h 1287141"/>
                <a:gd name="connsiteX6" fmla="*/ 3213823 w 6944159"/>
                <a:gd name="connsiteY6" fmla="*/ 1167645 h 1287141"/>
                <a:gd name="connsiteX7" fmla="*/ 3580968 w 6944159"/>
                <a:gd name="connsiteY7" fmla="*/ 1287141 h 1287141"/>
                <a:gd name="connsiteX8" fmla="*/ 5406304 w 6944159"/>
                <a:gd name="connsiteY8" fmla="*/ 1184963 h 1287141"/>
                <a:gd name="connsiteX9" fmla="*/ 6944159 w 6944159"/>
                <a:gd name="connsiteY9" fmla="*/ 374473 h 1287141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944159 w 6944159"/>
                <a:gd name="connsiteY9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525060 w 6944159"/>
                <a:gd name="connsiteY9" fmla="*/ 616075 h 1287182"/>
                <a:gd name="connsiteX10" fmla="*/ 6944159 w 6944159"/>
                <a:gd name="connsiteY10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525060 w 6944159"/>
                <a:gd name="connsiteY9" fmla="*/ 616075 h 1287182"/>
                <a:gd name="connsiteX10" fmla="*/ 6944159 w 6944159"/>
                <a:gd name="connsiteY10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365516 w 6944159"/>
                <a:gd name="connsiteY9" fmla="*/ 71132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427428 w 6944159"/>
                <a:gd name="connsiteY9" fmla="*/ 65417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427428 w 6944159"/>
                <a:gd name="connsiteY9" fmla="*/ 65417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427428 w 6944159"/>
                <a:gd name="connsiteY9" fmla="*/ 65417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427428 w 6944159"/>
                <a:gd name="connsiteY9" fmla="*/ 65417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  <a:gd name="connsiteX0" fmla="*/ 0 w 6944159"/>
                <a:gd name="connsiteY0" fmla="*/ 150677 h 1287182"/>
                <a:gd name="connsiteX1" fmla="*/ 460232 w 6944159"/>
                <a:gd name="connsiteY1" fmla="*/ 441 h 1287182"/>
                <a:gd name="connsiteX2" fmla="*/ 1125250 w 6944159"/>
                <a:gd name="connsiteY2" fmla="*/ 208259 h 1287182"/>
                <a:gd name="connsiteX3" fmla="*/ 1436977 w 6944159"/>
                <a:gd name="connsiteY3" fmla="*/ 374514 h 1287182"/>
                <a:gd name="connsiteX4" fmla="*/ 1935741 w 6944159"/>
                <a:gd name="connsiteY4" fmla="*/ 686241 h 1287182"/>
                <a:gd name="connsiteX5" fmla="*/ 2476068 w 6944159"/>
                <a:gd name="connsiteY5" fmla="*/ 914841 h 1287182"/>
                <a:gd name="connsiteX6" fmla="*/ 3213823 w 6944159"/>
                <a:gd name="connsiteY6" fmla="*/ 1167686 h 1287182"/>
                <a:gd name="connsiteX7" fmla="*/ 3580968 w 6944159"/>
                <a:gd name="connsiteY7" fmla="*/ 1287182 h 1287182"/>
                <a:gd name="connsiteX8" fmla="*/ 5406304 w 6944159"/>
                <a:gd name="connsiteY8" fmla="*/ 1185004 h 1287182"/>
                <a:gd name="connsiteX9" fmla="*/ 6427428 w 6944159"/>
                <a:gd name="connsiteY9" fmla="*/ 654175 h 1287182"/>
                <a:gd name="connsiteX10" fmla="*/ 6525060 w 6944159"/>
                <a:gd name="connsiteY10" fmla="*/ 616075 h 1287182"/>
                <a:gd name="connsiteX11" fmla="*/ 6944159 w 6944159"/>
                <a:gd name="connsiteY11" fmla="*/ 374514 h 12871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6944159" h="1287182">
                  <a:moveTo>
                    <a:pt x="0" y="150677"/>
                  </a:moveTo>
                  <a:cubicBezTo>
                    <a:pt x="79664" y="140935"/>
                    <a:pt x="272691" y="-9156"/>
                    <a:pt x="460232" y="441"/>
                  </a:cubicBezTo>
                  <a:cubicBezTo>
                    <a:pt x="647773" y="10038"/>
                    <a:pt x="969386" y="177086"/>
                    <a:pt x="1125250" y="208259"/>
                  </a:cubicBezTo>
                  <a:cubicBezTo>
                    <a:pt x="1281114" y="239432"/>
                    <a:pt x="1301895" y="294850"/>
                    <a:pt x="1436977" y="374514"/>
                  </a:cubicBezTo>
                  <a:cubicBezTo>
                    <a:pt x="1572059" y="454178"/>
                    <a:pt x="1762559" y="596187"/>
                    <a:pt x="1935741" y="686241"/>
                  </a:cubicBezTo>
                  <a:cubicBezTo>
                    <a:pt x="2108923" y="776295"/>
                    <a:pt x="2263054" y="834600"/>
                    <a:pt x="2476068" y="914841"/>
                  </a:cubicBezTo>
                  <a:cubicBezTo>
                    <a:pt x="2689082" y="995082"/>
                    <a:pt x="3029673" y="1105629"/>
                    <a:pt x="3213823" y="1167686"/>
                  </a:cubicBezTo>
                  <a:cubicBezTo>
                    <a:pt x="3302723" y="1201168"/>
                    <a:pt x="3272705" y="1227146"/>
                    <a:pt x="3580968" y="1287182"/>
                  </a:cubicBezTo>
                  <a:cubicBezTo>
                    <a:pt x="3784456" y="1109093"/>
                    <a:pt x="4740997" y="1207229"/>
                    <a:pt x="5406304" y="1185004"/>
                  </a:cubicBezTo>
                  <a:cubicBezTo>
                    <a:pt x="5870395" y="1089028"/>
                    <a:pt x="6310025" y="770428"/>
                    <a:pt x="6427428" y="654175"/>
                  </a:cubicBezTo>
                  <a:cubicBezTo>
                    <a:pt x="6528162" y="649841"/>
                    <a:pt x="6492912" y="665066"/>
                    <a:pt x="6525060" y="616075"/>
                  </a:cubicBezTo>
                  <a:cubicBezTo>
                    <a:pt x="6781369" y="480993"/>
                    <a:pt x="6874309" y="414774"/>
                    <a:pt x="6944159" y="374514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55"/>
            </a:p>
          </p:txBody>
        </p:sp>
      </p:grpSp>
      <p:grpSp>
        <p:nvGrpSpPr>
          <p:cNvPr id="217" name="Gruppieren 216">
            <a:extLst>
              <a:ext uri="{FF2B5EF4-FFF2-40B4-BE49-F238E27FC236}">
                <a16:creationId xmlns:a16="http://schemas.microsoft.com/office/drawing/2014/main" id="{F306D0AA-8EA6-8E29-D34E-9A94044BDD6A}"/>
              </a:ext>
            </a:extLst>
          </p:cNvPr>
          <p:cNvGrpSpPr/>
          <p:nvPr/>
        </p:nvGrpSpPr>
        <p:grpSpPr>
          <a:xfrm>
            <a:off x="7747865" y="1789843"/>
            <a:ext cx="472607" cy="3748872"/>
            <a:chOff x="7779406" y="3057185"/>
            <a:chExt cx="354455" cy="2811654"/>
          </a:xfrm>
        </p:grpSpPr>
        <p:cxnSp>
          <p:nvCxnSpPr>
            <p:cNvPr id="284" name="Gerader Verbinder 283">
              <a:extLst>
                <a:ext uri="{FF2B5EF4-FFF2-40B4-BE49-F238E27FC236}">
                  <a16:creationId xmlns:a16="http://schemas.microsoft.com/office/drawing/2014/main" id="{4D810762-3387-7BD4-05AC-6D949EBA1871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373050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Gerader Verbinder 284">
              <a:extLst>
                <a:ext uri="{FF2B5EF4-FFF2-40B4-BE49-F238E27FC236}">
                  <a16:creationId xmlns:a16="http://schemas.microsoft.com/office/drawing/2014/main" id="{0B16EDDE-D573-44FD-E8E2-A3F0ACEBA311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432239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Gerader Verbinder 285">
              <a:extLst>
                <a:ext uri="{FF2B5EF4-FFF2-40B4-BE49-F238E27FC236}">
                  <a16:creationId xmlns:a16="http://schemas.microsoft.com/office/drawing/2014/main" id="{60B5F79C-55F3-7DBC-C6B2-2527A96B65F8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491428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Gerader Verbinder 286">
              <a:extLst>
                <a:ext uri="{FF2B5EF4-FFF2-40B4-BE49-F238E27FC236}">
                  <a16:creationId xmlns:a16="http://schemas.microsoft.com/office/drawing/2014/main" id="{98694424-702E-E94E-105C-C5FA69275AEF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344102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Gerader Verbinder 287">
              <a:extLst>
                <a:ext uri="{FF2B5EF4-FFF2-40B4-BE49-F238E27FC236}">
                  <a16:creationId xmlns:a16="http://schemas.microsoft.com/office/drawing/2014/main" id="{88440D12-F634-D747-6A90-98D7F18E0D17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4032091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Gerader Verbinder 288">
              <a:extLst>
                <a:ext uri="{FF2B5EF4-FFF2-40B4-BE49-F238E27FC236}">
                  <a16:creationId xmlns:a16="http://schemas.microsoft.com/office/drawing/2014/main" id="{42D8ED9B-C59D-F524-D4AA-B53FF31562C2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4618972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Gerader Verbinder 289">
              <a:extLst>
                <a:ext uri="{FF2B5EF4-FFF2-40B4-BE49-F238E27FC236}">
                  <a16:creationId xmlns:a16="http://schemas.microsoft.com/office/drawing/2014/main" id="{03957AD0-EA79-0741-CF52-71E1B32FAA3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707406" y="3210963"/>
              <a:ext cx="14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Gerader Verbinder 290">
              <a:extLst>
                <a:ext uri="{FF2B5EF4-FFF2-40B4-BE49-F238E27FC236}">
                  <a16:creationId xmlns:a16="http://schemas.microsoft.com/office/drawing/2014/main" id="{70591105-BBB3-2B1E-0C37-73F657A9608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707406" y="4393718"/>
              <a:ext cx="14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Gerader Verbinder 291">
              <a:extLst>
                <a:ext uri="{FF2B5EF4-FFF2-40B4-BE49-F238E27FC236}">
                  <a16:creationId xmlns:a16="http://schemas.microsoft.com/office/drawing/2014/main" id="{E9FADF6C-D69C-9A98-DC8A-92EC84D2D87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707406" y="3802509"/>
              <a:ext cx="14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Gerader Verbinder 292">
              <a:extLst>
                <a:ext uri="{FF2B5EF4-FFF2-40B4-BE49-F238E27FC236}">
                  <a16:creationId xmlns:a16="http://schemas.microsoft.com/office/drawing/2014/main" id="{88BAA5FD-C36E-2240-DC46-E40022821530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491428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Gerader Verbinder 293">
              <a:extLst>
                <a:ext uri="{FF2B5EF4-FFF2-40B4-BE49-F238E27FC236}">
                  <a16:creationId xmlns:a16="http://schemas.microsoft.com/office/drawing/2014/main" id="{58F66E0D-6764-2337-4084-8955C48C76FE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5209603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Gerader Verbinder 294">
              <a:extLst>
                <a:ext uri="{FF2B5EF4-FFF2-40B4-BE49-F238E27FC236}">
                  <a16:creationId xmlns:a16="http://schemas.microsoft.com/office/drawing/2014/main" id="{66286DCF-5D2C-8197-5B85-7B2E908E023B}"/>
                </a:ext>
              </a:extLst>
            </p:cNvPr>
            <p:cNvCxnSpPr>
              <a:cxnSpLocks/>
            </p:cNvCxnSpPr>
            <p:nvPr/>
          </p:nvCxnSpPr>
          <p:spPr>
            <a:xfrm rot="16200000" flipH="1" flipV="1">
              <a:off x="6447406" y="4472138"/>
              <a:ext cx="266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Gerader Verbinder 295">
              <a:extLst>
                <a:ext uri="{FF2B5EF4-FFF2-40B4-BE49-F238E27FC236}">
                  <a16:creationId xmlns:a16="http://schemas.microsoft.com/office/drawing/2014/main" id="{BE1A0AA1-6E77-DA58-41A2-5A480B9EA078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5504920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7" name="Textfeld 296">
              <a:extLst>
                <a:ext uri="{FF2B5EF4-FFF2-40B4-BE49-F238E27FC236}">
                  <a16:creationId xmlns:a16="http://schemas.microsoft.com/office/drawing/2014/main" id="{ADF25B30-AAAB-EEA1-93D0-77CD4CF3B446}"/>
                </a:ext>
              </a:extLst>
            </p:cNvPr>
            <p:cNvSpPr txBox="1"/>
            <p:nvPr/>
          </p:nvSpPr>
          <p:spPr>
            <a:xfrm>
              <a:off x="7886356" y="3640630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100</a:t>
              </a:r>
            </a:p>
          </p:txBody>
        </p:sp>
        <p:sp>
          <p:nvSpPr>
            <p:cNvPr id="298" name="Textfeld 297">
              <a:extLst>
                <a:ext uri="{FF2B5EF4-FFF2-40B4-BE49-F238E27FC236}">
                  <a16:creationId xmlns:a16="http://schemas.microsoft.com/office/drawing/2014/main" id="{11937DC9-00F4-10AB-25CD-7F4191B96EA3}"/>
                </a:ext>
              </a:extLst>
            </p:cNvPr>
            <p:cNvSpPr txBox="1"/>
            <p:nvPr/>
          </p:nvSpPr>
          <p:spPr>
            <a:xfrm>
              <a:off x="7886356" y="4230309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200</a:t>
              </a:r>
            </a:p>
          </p:txBody>
        </p:sp>
        <p:sp>
          <p:nvSpPr>
            <p:cNvPr id="299" name="Textfeld 298">
              <a:extLst>
                <a:ext uri="{FF2B5EF4-FFF2-40B4-BE49-F238E27FC236}">
                  <a16:creationId xmlns:a16="http://schemas.microsoft.com/office/drawing/2014/main" id="{6B638CF7-0BE4-2859-33F7-137C4448ECD8}"/>
                </a:ext>
              </a:extLst>
            </p:cNvPr>
            <p:cNvSpPr txBox="1"/>
            <p:nvPr/>
          </p:nvSpPr>
          <p:spPr>
            <a:xfrm>
              <a:off x="7886356" y="4824360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300</a:t>
              </a:r>
            </a:p>
          </p:txBody>
        </p:sp>
        <p:sp>
          <p:nvSpPr>
            <p:cNvPr id="300" name="Textfeld 299">
              <a:extLst>
                <a:ext uri="{FF2B5EF4-FFF2-40B4-BE49-F238E27FC236}">
                  <a16:creationId xmlns:a16="http://schemas.microsoft.com/office/drawing/2014/main" id="{B959945C-346B-0D98-EC84-1CB2BBA9BF44}"/>
                </a:ext>
              </a:extLst>
            </p:cNvPr>
            <p:cNvSpPr txBox="1"/>
            <p:nvPr/>
          </p:nvSpPr>
          <p:spPr>
            <a:xfrm>
              <a:off x="7886757" y="3350997"/>
              <a:ext cx="210635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50</a:t>
              </a:r>
            </a:p>
          </p:txBody>
        </p:sp>
        <p:sp>
          <p:nvSpPr>
            <p:cNvPr id="301" name="Textfeld 300">
              <a:extLst>
                <a:ext uri="{FF2B5EF4-FFF2-40B4-BE49-F238E27FC236}">
                  <a16:creationId xmlns:a16="http://schemas.microsoft.com/office/drawing/2014/main" id="{E801ED3F-A611-573E-801A-0F208EF00DEE}"/>
                </a:ext>
              </a:extLst>
            </p:cNvPr>
            <p:cNvSpPr txBox="1"/>
            <p:nvPr/>
          </p:nvSpPr>
          <p:spPr>
            <a:xfrm>
              <a:off x="7886356" y="3940589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150</a:t>
              </a:r>
            </a:p>
          </p:txBody>
        </p:sp>
        <p:sp>
          <p:nvSpPr>
            <p:cNvPr id="302" name="Textfeld 301">
              <a:extLst>
                <a:ext uri="{FF2B5EF4-FFF2-40B4-BE49-F238E27FC236}">
                  <a16:creationId xmlns:a16="http://schemas.microsoft.com/office/drawing/2014/main" id="{E5D1E15A-2EC6-5494-2707-21A3E6D5B357}"/>
                </a:ext>
              </a:extLst>
            </p:cNvPr>
            <p:cNvSpPr txBox="1"/>
            <p:nvPr/>
          </p:nvSpPr>
          <p:spPr>
            <a:xfrm>
              <a:off x="7886356" y="4528873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250</a:t>
              </a:r>
            </a:p>
          </p:txBody>
        </p:sp>
        <p:sp>
          <p:nvSpPr>
            <p:cNvPr id="303" name="Textfeld 302">
              <a:extLst>
                <a:ext uri="{FF2B5EF4-FFF2-40B4-BE49-F238E27FC236}">
                  <a16:creationId xmlns:a16="http://schemas.microsoft.com/office/drawing/2014/main" id="{BE7894B9-6623-B0CB-C909-CAC00994000D}"/>
                </a:ext>
              </a:extLst>
            </p:cNvPr>
            <p:cNvSpPr txBox="1"/>
            <p:nvPr/>
          </p:nvSpPr>
          <p:spPr>
            <a:xfrm>
              <a:off x="7886356" y="5119848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350</a:t>
              </a:r>
            </a:p>
          </p:txBody>
        </p:sp>
        <p:sp>
          <p:nvSpPr>
            <p:cNvPr id="304" name="Textfeld 303">
              <a:extLst>
                <a:ext uri="{FF2B5EF4-FFF2-40B4-BE49-F238E27FC236}">
                  <a16:creationId xmlns:a16="http://schemas.microsoft.com/office/drawing/2014/main" id="{FDA9CBA2-BC4F-93E6-3907-419B31134477}"/>
                </a:ext>
              </a:extLst>
            </p:cNvPr>
            <p:cNvSpPr txBox="1"/>
            <p:nvPr/>
          </p:nvSpPr>
          <p:spPr>
            <a:xfrm>
              <a:off x="7886356" y="5415387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400</a:t>
              </a:r>
            </a:p>
          </p:txBody>
        </p:sp>
        <p:cxnSp>
          <p:nvCxnSpPr>
            <p:cNvPr id="305" name="Gerader Verbinder 304">
              <a:extLst>
                <a:ext uri="{FF2B5EF4-FFF2-40B4-BE49-F238E27FC236}">
                  <a16:creationId xmlns:a16="http://schemas.microsoft.com/office/drawing/2014/main" id="{3EDACBA9-0477-DD76-0D0F-7A7D042794FE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314045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6" name="Textfeld 305">
              <a:extLst>
                <a:ext uri="{FF2B5EF4-FFF2-40B4-BE49-F238E27FC236}">
                  <a16:creationId xmlns:a16="http://schemas.microsoft.com/office/drawing/2014/main" id="{FE7720EF-3FD9-7C12-F898-B42AD13DC428}"/>
                </a:ext>
              </a:extLst>
            </p:cNvPr>
            <p:cNvSpPr txBox="1"/>
            <p:nvPr/>
          </p:nvSpPr>
          <p:spPr>
            <a:xfrm>
              <a:off x="7887159" y="3057185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0 m</a:t>
              </a:r>
            </a:p>
          </p:txBody>
        </p:sp>
        <p:cxnSp>
          <p:nvCxnSpPr>
            <p:cNvPr id="307" name="Gerader Verbinder 306">
              <a:extLst>
                <a:ext uri="{FF2B5EF4-FFF2-40B4-BE49-F238E27FC236}">
                  <a16:creationId xmlns:a16="http://schemas.microsoft.com/office/drawing/2014/main" id="{D2E20F52-8C97-4066-BC44-A212552B3DCE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520898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Gerader Verbinder 307">
              <a:extLst>
                <a:ext uri="{FF2B5EF4-FFF2-40B4-BE49-F238E27FC236}">
                  <a16:creationId xmlns:a16="http://schemas.microsoft.com/office/drawing/2014/main" id="{3D275710-0006-CFA0-C487-9C544511C9DA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580472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9" name="Textfeld 308">
              <a:extLst>
                <a:ext uri="{FF2B5EF4-FFF2-40B4-BE49-F238E27FC236}">
                  <a16:creationId xmlns:a16="http://schemas.microsoft.com/office/drawing/2014/main" id="{1507ADB6-2CBA-40C4-6CE5-2204B7CA54B3}"/>
                </a:ext>
              </a:extLst>
            </p:cNvPr>
            <p:cNvSpPr txBox="1"/>
            <p:nvPr/>
          </p:nvSpPr>
          <p:spPr>
            <a:xfrm>
              <a:off x="7886356" y="5714998"/>
              <a:ext cx="246702" cy="15384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733" dirty="0"/>
                <a:t>450</a:t>
              </a:r>
            </a:p>
          </p:txBody>
        </p:sp>
        <p:cxnSp>
          <p:nvCxnSpPr>
            <p:cNvPr id="310" name="Gerader Verbinder 309">
              <a:extLst>
                <a:ext uri="{FF2B5EF4-FFF2-40B4-BE49-F238E27FC236}">
                  <a16:creationId xmlns:a16="http://schemas.microsoft.com/office/drawing/2014/main" id="{B8879446-D03D-DB27-B53B-D46B209D8A06}"/>
                </a:ext>
              </a:extLst>
            </p:cNvPr>
            <p:cNvCxnSpPr>
              <a:cxnSpLocks/>
            </p:cNvCxnSpPr>
            <p:nvPr/>
          </p:nvCxnSpPr>
          <p:spPr>
            <a:xfrm>
              <a:off x="7779406" y="5804294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8" name="Gruppieren 217">
            <a:extLst>
              <a:ext uri="{FF2B5EF4-FFF2-40B4-BE49-F238E27FC236}">
                <a16:creationId xmlns:a16="http://schemas.microsoft.com/office/drawing/2014/main" id="{92D62126-B054-36F2-5B43-F2C13ADE4E77}"/>
              </a:ext>
            </a:extLst>
          </p:cNvPr>
          <p:cNvGrpSpPr/>
          <p:nvPr/>
        </p:nvGrpSpPr>
        <p:grpSpPr>
          <a:xfrm>
            <a:off x="3912476" y="1504211"/>
            <a:ext cx="3369940" cy="3603816"/>
            <a:chOff x="3729237" y="2843482"/>
            <a:chExt cx="2527455" cy="2702862"/>
          </a:xfrm>
        </p:grpSpPr>
        <p:cxnSp>
          <p:nvCxnSpPr>
            <p:cNvPr id="245" name="Gerader Verbinder 244">
              <a:extLst>
                <a:ext uri="{FF2B5EF4-FFF2-40B4-BE49-F238E27FC236}">
                  <a16:creationId xmlns:a16="http://schemas.microsoft.com/office/drawing/2014/main" id="{6AD80741-B04C-DECF-BC7A-129E7824F10B}"/>
                </a:ext>
              </a:extLst>
            </p:cNvPr>
            <p:cNvCxnSpPr/>
            <p:nvPr/>
          </p:nvCxnSpPr>
          <p:spPr>
            <a:xfrm rot="2700000">
              <a:off x="5482669" y="3489604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Gerader Verbinder 245">
              <a:extLst>
                <a:ext uri="{FF2B5EF4-FFF2-40B4-BE49-F238E27FC236}">
                  <a16:creationId xmlns:a16="http://schemas.microsoft.com/office/drawing/2014/main" id="{F0B4569A-818F-05B7-8767-DDDB7CF6185B}"/>
                </a:ext>
              </a:extLst>
            </p:cNvPr>
            <p:cNvCxnSpPr/>
            <p:nvPr/>
          </p:nvCxnSpPr>
          <p:spPr>
            <a:xfrm rot="2700000">
              <a:off x="5064141" y="3908134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Gerader Verbinder 246">
              <a:extLst>
                <a:ext uri="{FF2B5EF4-FFF2-40B4-BE49-F238E27FC236}">
                  <a16:creationId xmlns:a16="http://schemas.microsoft.com/office/drawing/2014/main" id="{F16DC63A-D297-3967-EBF3-3BD0EB51D6A8}"/>
                </a:ext>
              </a:extLst>
            </p:cNvPr>
            <p:cNvCxnSpPr/>
            <p:nvPr/>
          </p:nvCxnSpPr>
          <p:spPr>
            <a:xfrm rot="2700000">
              <a:off x="4645612" y="4326663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Gerader Verbinder 247">
              <a:extLst>
                <a:ext uri="{FF2B5EF4-FFF2-40B4-BE49-F238E27FC236}">
                  <a16:creationId xmlns:a16="http://schemas.microsoft.com/office/drawing/2014/main" id="{A90AEC43-B239-CCBB-6172-B30AC0730AC7}"/>
                </a:ext>
              </a:extLst>
            </p:cNvPr>
            <p:cNvCxnSpPr/>
            <p:nvPr/>
          </p:nvCxnSpPr>
          <p:spPr>
            <a:xfrm rot="2700000">
              <a:off x="5687362" y="3284912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Gerader Verbinder 248">
              <a:extLst>
                <a:ext uri="{FF2B5EF4-FFF2-40B4-BE49-F238E27FC236}">
                  <a16:creationId xmlns:a16="http://schemas.microsoft.com/office/drawing/2014/main" id="{1DEDEA04-4E4A-EFA4-238D-77016DB48435}"/>
                </a:ext>
              </a:extLst>
            </p:cNvPr>
            <p:cNvCxnSpPr/>
            <p:nvPr/>
          </p:nvCxnSpPr>
          <p:spPr>
            <a:xfrm rot="2700000">
              <a:off x="5269418" y="3702855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Gerader Verbinder 249">
              <a:extLst>
                <a:ext uri="{FF2B5EF4-FFF2-40B4-BE49-F238E27FC236}">
                  <a16:creationId xmlns:a16="http://schemas.microsoft.com/office/drawing/2014/main" id="{B6E9315B-E8B5-A407-F9EE-2D3AA4637603}"/>
                </a:ext>
              </a:extLst>
            </p:cNvPr>
            <p:cNvCxnSpPr/>
            <p:nvPr/>
          </p:nvCxnSpPr>
          <p:spPr>
            <a:xfrm rot="2700000">
              <a:off x="4842025" y="4105437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Gerader Verbinder 250">
              <a:extLst>
                <a:ext uri="{FF2B5EF4-FFF2-40B4-BE49-F238E27FC236}">
                  <a16:creationId xmlns:a16="http://schemas.microsoft.com/office/drawing/2014/main" id="{2ADD12F8-6A6F-9063-D5C6-7D0D6D7BC330}"/>
                </a:ext>
              </a:extLst>
            </p:cNvPr>
            <p:cNvCxnSpPr/>
            <p:nvPr/>
          </p:nvCxnSpPr>
          <p:spPr>
            <a:xfrm rot="8100000">
              <a:off x="5668887" y="3359301"/>
              <a:ext cx="58780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Gerader Verbinder 251">
              <a:extLst>
                <a:ext uri="{FF2B5EF4-FFF2-40B4-BE49-F238E27FC236}">
                  <a16:creationId xmlns:a16="http://schemas.microsoft.com/office/drawing/2014/main" id="{663F9BE1-B83A-9517-9CB3-681554D91CA5}"/>
                </a:ext>
              </a:extLst>
            </p:cNvPr>
            <p:cNvCxnSpPr/>
            <p:nvPr/>
          </p:nvCxnSpPr>
          <p:spPr>
            <a:xfrm rot="8100000">
              <a:off x="4832553" y="4195635"/>
              <a:ext cx="58780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Gerader Verbinder 252">
              <a:extLst>
                <a:ext uri="{FF2B5EF4-FFF2-40B4-BE49-F238E27FC236}">
                  <a16:creationId xmlns:a16="http://schemas.microsoft.com/office/drawing/2014/main" id="{343B889C-7329-93EF-3B6E-BB118A92C41D}"/>
                </a:ext>
              </a:extLst>
            </p:cNvPr>
            <p:cNvCxnSpPr/>
            <p:nvPr/>
          </p:nvCxnSpPr>
          <p:spPr>
            <a:xfrm rot="8100000">
              <a:off x="5250601" y="3777587"/>
              <a:ext cx="58780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Gerader Verbinder 253">
              <a:extLst>
                <a:ext uri="{FF2B5EF4-FFF2-40B4-BE49-F238E27FC236}">
                  <a16:creationId xmlns:a16="http://schemas.microsoft.com/office/drawing/2014/main" id="{A1BED285-6C69-9AB5-4E45-BB6D89E40D4E}"/>
                </a:ext>
              </a:extLst>
            </p:cNvPr>
            <p:cNvCxnSpPr/>
            <p:nvPr/>
          </p:nvCxnSpPr>
          <p:spPr>
            <a:xfrm rot="2700000">
              <a:off x="4645611" y="4326663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Gerader Verbinder 254">
              <a:extLst>
                <a:ext uri="{FF2B5EF4-FFF2-40B4-BE49-F238E27FC236}">
                  <a16:creationId xmlns:a16="http://schemas.microsoft.com/office/drawing/2014/main" id="{C0CB734C-0356-5141-8958-EFADF9C3123F}"/>
                </a:ext>
              </a:extLst>
            </p:cNvPr>
            <p:cNvCxnSpPr/>
            <p:nvPr/>
          </p:nvCxnSpPr>
          <p:spPr>
            <a:xfrm rot="2700000">
              <a:off x="4449198" y="4547888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Gerader Verbinder 255">
              <a:extLst>
                <a:ext uri="{FF2B5EF4-FFF2-40B4-BE49-F238E27FC236}">
                  <a16:creationId xmlns:a16="http://schemas.microsoft.com/office/drawing/2014/main" id="{C796FD15-411C-4602-0593-B440C638A2DF}"/>
                </a:ext>
              </a:extLst>
            </p:cNvPr>
            <p:cNvCxnSpPr>
              <a:cxnSpLocks/>
            </p:cNvCxnSpPr>
            <p:nvPr/>
          </p:nvCxnSpPr>
          <p:spPr>
            <a:xfrm rot="18900000" flipH="1" flipV="1">
              <a:off x="4153869" y="4717751"/>
              <a:ext cx="891650" cy="2896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Gerader Verbinder 256">
              <a:extLst>
                <a:ext uri="{FF2B5EF4-FFF2-40B4-BE49-F238E27FC236}">
                  <a16:creationId xmlns:a16="http://schemas.microsoft.com/office/drawing/2014/main" id="{E139D576-F0FC-125F-FC99-1D70BCF55C08}"/>
                </a:ext>
              </a:extLst>
            </p:cNvPr>
            <p:cNvCxnSpPr/>
            <p:nvPr/>
          </p:nvCxnSpPr>
          <p:spPr>
            <a:xfrm rot="2700000">
              <a:off x="4252784" y="4769114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Textfeld 257">
              <a:extLst>
                <a:ext uri="{FF2B5EF4-FFF2-40B4-BE49-F238E27FC236}">
                  <a16:creationId xmlns:a16="http://schemas.microsoft.com/office/drawing/2014/main" id="{A4605DF4-C272-62C7-70BC-AA7019574053}"/>
                </a:ext>
              </a:extLst>
            </p:cNvPr>
            <p:cNvSpPr txBox="1"/>
            <p:nvPr/>
          </p:nvSpPr>
          <p:spPr>
            <a:xfrm rot="13555909">
              <a:off x="5481365" y="3421476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100</a:t>
              </a:r>
            </a:p>
          </p:txBody>
        </p:sp>
        <p:sp>
          <p:nvSpPr>
            <p:cNvPr id="259" name="Textfeld 258">
              <a:extLst>
                <a:ext uri="{FF2B5EF4-FFF2-40B4-BE49-F238E27FC236}">
                  <a16:creationId xmlns:a16="http://schemas.microsoft.com/office/drawing/2014/main" id="{712EE03C-45E5-AE04-C1D4-58199432826C}"/>
                </a:ext>
              </a:extLst>
            </p:cNvPr>
            <p:cNvSpPr txBox="1"/>
            <p:nvPr/>
          </p:nvSpPr>
          <p:spPr>
            <a:xfrm rot="13555909">
              <a:off x="5008774" y="3797865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200</a:t>
              </a:r>
            </a:p>
          </p:txBody>
        </p:sp>
        <p:sp>
          <p:nvSpPr>
            <p:cNvPr id="261" name="Textfeld 260">
              <a:extLst>
                <a:ext uri="{FF2B5EF4-FFF2-40B4-BE49-F238E27FC236}">
                  <a16:creationId xmlns:a16="http://schemas.microsoft.com/office/drawing/2014/main" id="{B92D770E-6686-7C43-FC3A-0D3C0E776B2B}"/>
                </a:ext>
              </a:extLst>
            </p:cNvPr>
            <p:cNvSpPr txBox="1"/>
            <p:nvPr/>
          </p:nvSpPr>
          <p:spPr>
            <a:xfrm rot="13346789">
              <a:off x="5656140" y="3180229"/>
              <a:ext cx="201017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50</a:t>
              </a:r>
            </a:p>
          </p:txBody>
        </p:sp>
        <p:sp>
          <p:nvSpPr>
            <p:cNvPr id="262" name="Textfeld 261">
              <a:extLst>
                <a:ext uri="{FF2B5EF4-FFF2-40B4-BE49-F238E27FC236}">
                  <a16:creationId xmlns:a16="http://schemas.microsoft.com/office/drawing/2014/main" id="{5F45C47A-C097-14C7-805B-BB0F06B8DE89}"/>
                </a:ext>
              </a:extLst>
            </p:cNvPr>
            <p:cNvSpPr txBox="1"/>
            <p:nvPr/>
          </p:nvSpPr>
          <p:spPr>
            <a:xfrm rot="13555909">
              <a:off x="5201042" y="3596904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150</a:t>
              </a:r>
            </a:p>
          </p:txBody>
        </p:sp>
        <p:cxnSp>
          <p:nvCxnSpPr>
            <p:cNvPr id="266" name="Gerader Verbinder 265">
              <a:extLst>
                <a:ext uri="{FF2B5EF4-FFF2-40B4-BE49-F238E27FC236}">
                  <a16:creationId xmlns:a16="http://schemas.microsoft.com/office/drawing/2014/main" id="{004C4193-023C-2B24-09ED-427AC6B48BEA}"/>
                </a:ext>
              </a:extLst>
            </p:cNvPr>
            <p:cNvCxnSpPr/>
            <p:nvPr/>
          </p:nvCxnSpPr>
          <p:spPr>
            <a:xfrm rot="2700000">
              <a:off x="5903146" y="3075623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7" name="Textfeld 266">
              <a:extLst>
                <a:ext uri="{FF2B5EF4-FFF2-40B4-BE49-F238E27FC236}">
                  <a16:creationId xmlns:a16="http://schemas.microsoft.com/office/drawing/2014/main" id="{521C1CEB-3EA4-8F65-9B85-E992B7DE8F0F}"/>
                </a:ext>
              </a:extLst>
            </p:cNvPr>
            <p:cNvSpPr txBox="1"/>
            <p:nvPr/>
          </p:nvSpPr>
          <p:spPr>
            <a:xfrm rot="13684023">
              <a:off x="5894067" y="2888254"/>
              <a:ext cx="233477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0 m</a:t>
              </a:r>
            </a:p>
          </p:txBody>
        </p:sp>
        <p:cxnSp>
          <p:nvCxnSpPr>
            <p:cNvPr id="270" name="Gerader Verbinder 269">
              <a:extLst>
                <a:ext uri="{FF2B5EF4-FFF2-40B4-BE49-F238E27FC236}">
                  <a16:creationId xmlns:a16="http://schemas.microsoft.com/office/drawing/2014/main" id="{287BE98E-0F43-4885-54E0-16BB49D4A67F}"/>
                </a:ext>
              </a:extLst>
            </p:cNvPr>
            <p:cNvCxnSpPr/>
            <p:nvPr/>
          </p:nvCxnSpPr>
          <p:spPr>
            <a:xfrm rot="2700000">
              <a:off x="4066478" y="5006801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feld 270">
              <a:extLst>
                <a:ext uri="{FF2B5EF4-FFF2-40B4-BE49-F238E27FC236}">
                  <a16:creationId xmlns:a16="http://schemas.microsoft.com/office/drawing/2014/main" id="{B030CD29-B8F3-1B1F-4FF8-125B86F0AE1F}"/>
                </a:ext>
              </a:extLst>
            </p:cNvPr>
            <p:cNvSpPr txBox="1"/>
            <p:nvPr/>
          </p:nvSpPr>
          <p:spPr>
            <a:xfrm rot="13510063">
              <a:off x="3575821" y="5154497"/>
              <a:ext cx="545263" cy="2384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733" dirty="0" err="1"/>
                <a:t>Measured</a:t>
              </a:r>
              <a:r>
                <a:rPr lang="de-DE" sz="733" dirty="0"/>
                <a:t> </a:t>
              </a:r>
              <a:r>
                <a:rPr lang="de-DE" sz="733" dirty="0" err="1"/>
                <a:t>depth</a:t>
              </a:r>
              <a:r>
                <a:rPr lang="de-DE" sz="733" dirty="0"/>
                <a:t>(m)</a:t>
              </a:r>
            </a:p>
          </p:txBody>
        </p:sp>
        <p:cxnSp>
          <p:nvCxnSpPr>
            <p:cNvPr id="273" name="Gerader Verbinder 272">
              <a:extLst>
                <a:ext uri="{FF2B5EF4-FFF2-40B4-BE49-F238E27FC236}">
                  <a16:creationId xmlns:a16="http://schemas.microsoft.com/office/drawing/2014/main" id="{FC652EC5-09D1-1C7F-5EFE-A834CD03A331}"/>
                </a:ext>
              </a:extLst>
            </p:cNvPr>
            <p:cNvCxnSpPr/>
            <p:nvPr/>
          </p:nvCxnSpPr>
          <p:spPr>
            <a:xfrm rot="2700000">
              <a:off x="3799701" y="5167099"/>
              <a:ext cx="378983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Gerader Verbinder 273">
              <a:extLst>
                <a:ext uri="{FF2B5EF4-FFF2-40B4-BE49-F238E27FC236}">
                  <a16:creationId xmlns:a16="http://schemas.microsoft.com/office/drawing/2014/main" id="{4C71E387-19C7-049F-4267-A795155785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57600" y="5033667"/>
              <a:ext cx="225349" cy="217095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6" name="Textfeld 275">
              <a:extLst>
                <a:ext uri="{FF2B5EF4-FFF2-40B4-BE49-F238E27FC236}">
                  <a16:creationId xmlns:a16="http://schemas.microsoft.com/office/drawing/2014/main" id="{C179A52A-A589-85AB-9763-9033AC5ECD1C}"/>
                </a:ext>
              </a:extLst>
            </p:cNvPr>
            <p:cNvSpPr txBox="1"/>
            <p:nvPr/>
          </p:nvSpPr>
          <p:spPr>
            <a:xfrm rot="14433803">
              <a:off x="4902160" y="4385304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chemeClr val="accent6">
                      <a:lumMod val="75000"/>
                    </a:schemeClr>
                  </a:solidFill>
                </a:rPr>
                <a:t>289</a:t>
              </a:r>
            </a:p>
          </p:txBody>
        </p:sp>
        <p:sp>
          <p:nvSpPr>
            <p:cNvPr id="277" name="Textfeld 276">
              <a:extLst>
                <a:ext uri="{FF2B5EF4-FFF2-40B4-BE49-F238E27FC236}">
                  <a16:creationId xmlns:a16="http://schemas.microsoft.com/office/drawing/2014/main" id="{F727280A-D3AF-53D1-E58A-4799E881B0A6}"/>
                </a:ext>
              </a:extLst>
            </p:cNvPr>
            <p:cNvSpPr txBox="1"/>
            <p:nvPr/>
          </p:nvSpPr>
          <p:spPr>
            <a:xfrm rot="14438336">
              <a:off x="4987812" y="4352364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chemeClr val="accent6">
                      <a:lumMod val="75000"/>
                    </a:schemeClr>
                  </a:solidFill>
                </a:rPr>
                <a:t>282</a:t>
              </a:r>
            </a:p>
          </p:txBody>
        </p:sp>
        <p:sp>
          <p:nvSpPr>
            <p:cNvPr id="278" name="Textfeld 277">
              <a:extLst>
                <a:ext uri="{FF2B5EF4-FFF2-40B4-BE49-F238E27FC236}">
                  <a16:creationId xmlns:a16="http://schemas.microsoft.com/office/drawing/2014/main" id="{189D31E2-3FC9-8E93-BE67-7A497B2662FC}"/>
                </a:ext>
              </a:extLst>
            </p:cNvPr>
            <p:cNvSpPr txBox="1"/>
            <p:nvPr/>
          </p:nvSpPr>
          <p:spPr>
            <a:xfrm rot="15209654">
              <a:off x="5428918" y="4440663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rgbClr val="FF0000"/>
                  </a:solidFill>
                </a:rPr>
                <a:t>179</a:t>
              </a:r>
            </a:p>
          </p:txBody>
        </p:sp>
        <p:sp>
          <p:nvSpPr>
            <p:cNvPr id="279" name="Textfeld 278">
              <a:extLst>
                <a:ext uri="{FF2B5EF4-FFF2-40B4-BE49-F238E27FC236}">
                  <a16:creationId xmlns:a16="http://schemas.microsoft.com/office/drawing/2014/main" id="{011B1545-A97B-95FD-1FA8-FE3209FF2ADE}"/>
                </a:ext>
              </a:extLst>
            </p:cNvPr>
            <p:cNvSpPr txBox="1"/>
            <p:nvPr/>
          </p:nvSpPr>
          <p:spPr>
            <a:xfrm rot="15170163">
              <a:off x="5425940" y="4279512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rgbClr val="FF0000"/>
                  </a:solidFill>
                </a:rPr>
                <a:t>176</a:t>
              </a:r>
            </a:p>
          </p:txBody>
        </p:sp>
        <p:sp>
          <p:nvSpPr>
            <p:cNvPr id="280" name="Textfeld 279">
              <a:extLst>
                <a:ext uri="{FF2B5EF4-FFF2-40B4-BE49-F238E27FC236}">
                  <a16:creationId xmlns:a16="http://schemas.microsoft.com/office/drawing/2014/main" id="{6D120CAB-6667-8E45-0EAD-A44D65D894AE}"/>
                </a:ext>
              </a:extLst>
            </p:cNvPr>
            <p:cNvSpPr txBox="1"/>
            <p:nvPr/>
          </p:nvSpPr>
          <p:spPr>
            <a:xfrm rot="13479229">
              <a:off x="4366700" y="4665031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388</a:t>
              </a:r>
            </a:p>
          </p:txBody>
        </p:sp>
        <p:sp>
          <p:nvSpPr>
            <p:cNvPr id="281" name="Textfeld 280">
              <a:extLst>
                <a:ext uri="{FF2B5EF4-FFF2-40B4-BE49-F238E27FC236}">
                  <a16:creationId xmlns:a16="http://schemas.microsoft.com/office/drawing/2014/main" id="{D634A19D-F80A-F92A-357D-5834CA7EC7DD}"/>
                </a:ext>
              </a:extLst>
            </p:cNvPr>
            <p:cNvSpPr txBox="1"/>
            <p:nvPr/>
          </p:nvSpPr>
          <p:spPr>
            <a:xfrm rot="13479229">
              <a:off x="4414031" y="4805421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403</a:t>
              </a:r>
            </a:p>
          </p:txBody>
        </p:sp>
        <p:sp>
          <p:nvSpPr>
            <p:cNvPr id="282" name="Textfeld 281">
              <a:extLst>
                <a:ext uri="{FF2B5EF4-FFF2-40B4-BE49-F238E27FC236}">
                  <a16:creationId xmlns:a16="http://schemas.microsoft.com/office/drawing/2014/main" id="{5F96E8B5-0629-AD23-0F8A-29C39DD087A6}"/>
                </a:ext>
              </a:extLst>
            </p:cNvPr>
            <p:cNvSpPr txBox="1"/>
            <p:nvPr/>
          </p:nvSpPr>
          <p:spPr>
            <a:xfrm rot="14370290">
              <a:off x="4359375" y="4863247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rgbClr val="FF0000"/>
                  </a:solidFill>
                </a:rPr>
                <a:t>406</a:t>
              </a:r>
            </a:p>
          </p:txBody>
        </p:sp>
        <p:sp>
          <p:nvSpPr>
            <p:cNvPr id="283" name="Textfeld 282">
              <a:extLst>
                <a:ext uri="{FF2B5EF4-FFF2-40B4-BE49-F238E27FC236}">
                  <a16:creationId xmlns:a16="http://schemas.microsoft.com/office/drawing/2014/main" id="{8CD7B5CA-6CA0-4BCF-79F5-490A239456F4}"/>
                </a:ext>
              </a:extLst>
            </p:cNvPr>
            <p:cNvSpPr txBox="1"/>
            <p:nvPr/>
          </p:nvSpPr>
          <p:spPr>
            <a:xfrm rot="14262419">
              <a:off x="4243239" y="4966386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>
                  <a:solidFill>
                    <a:srgbClr val="FF0000"/>
                  </a:solidFill>
                </a:rPr>
                <a:t>424</a:t>
              </a:r>
            </a:p>
          </p:txBody>
        </p:sp>
        <p:sp>
          <p:nvSpPr>
            <p:cNvPr id="263" name="Textfeld 262">
              <a:extLst>
                <a:ext uri="{FF2B5EF4-FFF2-40B4-BE49-F238E27FC236}">
                  <a16:creationId xmlns:a16="http://schemas.microsoft.com/office/drawing/2014/main" id="{1780F4A2-FA17-A830-DFD0-E4DD87B2ECF0}"/>
                </a:ext>
              </a:extLst>
            </p:cNvPr>
            <p:cNvSpPr txBox="1"/>
            <p:nvPr/>
          </p:nvSpPr>
          <p:spPr>
            <a:xfrm rot="13555909">
              <a:off x="4736795" y="3858308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250</a:t>
              </a:r>
            </a:p>
          </p:txBody>
        </p:sp>
        <p:sp>
          <p:nvSpPr>
            <p:cNvPr id="260" name="Textfeld 259">
              <a:extLst>
                <a:ext uri="{FF2B5EF4-FFF2-40B4-BE49-F238E27FC236}">
                  <a16:creationId xmlns:a16="http://schemas.microsoft.com/office/drawing/2014/main" id="{BECA328A-6A83-FDD4-DF32-93AF9EF0A416}"/>
                </a:ext>
              </a:extLst>
            </p:cNvPr>
            <p:cNvSpPr txBox="1"/>
            <p:nvPr/>
          </p:nvSpPr>
          <p:spPr>
            <a:xfrm rot="13555909">
              <a:off x="4541492" y="4081050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300</a:t>
              </a:r>
            </a:p>
          </p:txBody>
        </p:sp>
        <p:sp>
          <p:nvSpPr>
            <p:cNvPr id="264" name="Textfeld 263">
              <a:extLst>
                <a:ext uri="{FF2B5EF4-FFF2-40B4-BE49-F238E27FC236}">
                  <a16:creationId xmlns:a16="http://schemas.microsoft.com/office/drawing/2014/main" id="{C26E3940-F581-91A6-81F0-6FC16921190B}"/>
                </a:ext>
              </a:extLst>
            </p:cNvPr>
            <p:cNvSpPr txBox="1"/>
            <p:nvPr/>
          </p:nvSpPr>
          <p:spPr>
            <a:xfrm rot="13555909">
              <a:off x="4347807" y="4300617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350</a:t>
              </a:r>
            </a:p>
          </p:txBody>
        </p:sp>
        <p:sp>
          <p:nvSpPr>
            <p:cNvPr id="265" name="Textfeld 264">
              <a:extLst>
                <a:ext uri="{FF2B5EF4-FFF2-40B4-BE49-F238E27FC236}">
                  <a16:creationId xmlns:a16="http://schemas.microsoft.com/office/drawing/2014/main" id="{C6A1C0D7-B5BF-45F8-D232-F9F67742C282}"/>
                </a:ext>
              </a:extLst>
            </p:cNvPr>
            <p:cNvSpPr txBox="1"/>
            <p:nvPr/>
          </p:nvSpPr>
          <p:spPr>
            <a:xfrm rot="13555909">
              <a:off x="4157424" y="4525273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400</a:t>
              </a:r>
            </a:p>
          </p:txBody>
        </p:sp>
        <p:sp>
          <p:nvSpPr>
            <p:cNvPr id="272" name="Textfeld 271">
              <a:extLst>
                <a:ext uri="{FF2B5EF4-FFF2-40B4-BE49-F238E27FC236}">
                  <a16:creationId xmlns:a16="http://schemas.microsoft.com/office/drawing/2014/main" id="{23CD4EAE-319E-A59E-02DB-5896D2D2B325}"/>
                </a:ext>
              </a:extLst>
            </p:cNvPr>
            <p:cNvSpPr txBox="1"/>
            <p:nvPr/>
          </p:nvSpPr>
          <p:spPr>
            <a:xfrm rot="13555909">
              <a:off x="3911861" y="4710182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450</a:t>
              </a:r>
            </a:p>
          </p:txBody>
        </p:sp>
        <p:sp>
          <p:nvSpPr>
            <p:cNvPr id="275" name="Textfeld 274">
              <a:extLst>
                <a:ext uri="{FF2B5EF4-FFF2-40B4-BE49-F238E27FC236}">
                  <a16:creationId xmlns:a16="http://schemas.microsoft.com/office/drawing/2014/main" id="{7A30844A-D8BE-6BEB-E34A-FB7166953A39}"/>
                </a:ext>
              </a:extLst>
            </p:cNvPr>
            <p:cNvSpPr txBox="1"/>
            <p:nvPr/>
          </p:nvSpPr>
          <p:spPr>
            <a:xfrm rot="13555909">
              <a:off x="3688262" y="4908792"/>
              <a:ext cx="232275" cy="143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47" dirty="0"/>
                <a:t>500</a:t>
              </a:r>
            </a:p>
          </p:txBody>
        </p:sp>
      </p:grpSp>
      <p:cxnSp>
        <p:nvCxnSpPr>
          <p:cNvPr id="219" name="Gerader Verbinder 218">
            <a:extLst>
              <a:ext uri="{FF2B5EF4-FFF2-40B4-BE49-F238E27FC236}">
                <a16:creationId xmlns:a16="http://schemas.microsoft.com/office/drawing/2014/main" id="{570EFEB6-A728-E82F-989D-58C34369E7BE}"/>
              </a:ext>
            </a:extLst>
          </p:cNvPr>
          <p:cNvCxnSpPr/>
          <p:nvPr/>
        </p:nvCxnSpPr>
        <p:spPr>
          <a:xfrm rot="2700000">
            <a:off x="4294140" y="4323315"/>
            <a:ext cx="505311" cy="0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Gerader Verbinder 219">
            <a:extLst>
              <a:ext uri="{FF2B5EF4-FFF2-40B4-BE49-F238E27FC236}">
                <a16:creationId xmlns:a16="http://schemas.microsoft.com/office/drawing/2014/main" id="{4ABE548D-28F1-76C8-EBD9-1363473F2A29}"/>
              </a:ext>
            </a:extLst>
          </p:cNvPr>
          <p:cNvCxnSpPr>
            <a:cxnSpLocks/>
          </p:cNvCxnSpPr>
          <p:nvPr/>
        </p:nvCxnSpPr>
        <p:spPr>
          <a:xfrm rot="4260000">
            <a:off x="3580272" y="2256048"/>
            <a:ext cx="2924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r Verbinder 220">
            <a:extLst>
              <a:ext uri="{FF2B5EF4-FFF2-40B4-BE49-F238E27FC236}">
                <a16:creationId xmlns:a16="http://schemas.microsoft.com/office/drawing/2014/main" id="{62C9ABAC-FEBC-98BD-A718-58D979F4D543}"/>
              </a:ext>
            </a:extLst>
          </p:cNvPr>
          <p:cNvCxnSpPr>
            <a:cxnSpLocks/>
          </p:cNvCxnSpPr>
          <p:nvPr/>
        </p:nvCxnSpPr>
        <p:spPr>
          <a:xfrm rot="4500000">
            <a:off x="5112642" y="2369201"/>
            <a:ext cx="2924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Freihandform: Form 221">
            <a:extLst>
              <a:ext uri="{FF2B5EF4-FFF2-40B4-BE49-F238E27FC236}">
                <a16:creationId xmlns:a16="http://schemas.microsoft.com/office/drawing/2014/main" id="{228E9F28-78E2-25A1-13D8-3EB9A46DC452}"/>
              </a:ext>
            </a:extLst>
          </p:cNvPr>
          <p:cNvSpPr/>
          <p:nvPr/>
        </p:nvSpPr>
        <p:spPr>
          <a:xfrm>
            <a:off x="6288452" y="1509268"/>
            <a:ext cx="201228" cy="660463"/>
          </a:xfrm>
          <a:custGeom>
            <a:avLst/>
            <a:gdLst>
              <a:gd name="connsiteX0" fmla="*/ 0 w 332745"/>
              <a:gd name="connsiteY0" fmla="*/ 0 h 2175029"/>
              <a:gd name="connsiteX1" fmla="*/ 62143 w 332745"/>
              <a:gd name="connsiteY1" fmla="*/ 248575 h 2175029"/>
              <a:gd name="connsiteX2" fmla="*/ 133165 w 332745"/>
              <a:gd name="connsiteY2" fmla="*/ 381740 h 2175029"/>
              <a:gd name="connsiteX3" fmla="*/ 177553 w 332745"/>
              <a:gd name="connsiteY3" fmla="*/ 612560 h 2175029"/>
              <a:gd name="connsiteX4" fmla="*/ 230819 w 332745"/>
              <a:gd name="connsiteY4" fmla="*/ 1074198 h 2175029"/>
              <a:gd name="connsiteX5" fmla="*/ 284085 w 332745"/>
              <a:gd name="connsiteY5" fmla="*/ 1358284 h 2175029"/>
              <a:gd name="connsiteX6" fmla="*/ 328474 w 332745"/>
              <a:gd name="connsiteY6" fmla="*/ 1686758 h 2175029"/>
              <a:gd name="connsiteX7" fmla="*/ 328474 w 332745"/>
              <a:gd name="connsiteY7" fmla="*/ 2175029 h 2175029"/>
              <a:gd name="connsiteX0" fmla="*/ 0 w 412644"/>
              <a:gd name="connsiteY0" fmla="*/ 0 h 2530136"/>
              <a:gd name="connsiteX1" fmla="*/ 142042 w 412644"/>
              <a:gd name="connsiteY1" fmla="*/ 603682 h 2530136"/>
              <a:gd name="connsiteX2" fmla="*/ 213064 w 412644"/>
              <a:gd name="connsiteY2" fmla="*/ 736847 h 2530136"/>
              <a:gd name="connsiteX3" fmla="*/ 257452 w 412644"/>
              <a:gd name="connsiteY3" fmla="*/ 967667 h 2530136"/>
              <a:gd name="connsiteX4" fmla="*/ 310718 w 412644"/>
              <a:gd name="connsiteY4" fmla="*/ 1429305 h 2530136"/>
              <a:gd name="connsiteX5" fmla="*/ 363984 w 412644"/>
              <a:gd name="connsiteY5" fmla="*/ 1713391 h 2530136"/>
              <a:gd name="connsiteX6" fmla="*/ 408373 w 412644"/>
              <a:gd name="connsiteY6" fmla="*/ 2041865 h 2530136"/>
              <a:gd name="connsiteX7" fmla="*/ 408373 w 412644"/>
              <a:gd name="connsiteY7" fmla="*/ 2530136 h 2530136"/>
              <a:gd name="connsiteX0" fmla="*/ 0 w 412644"/>
              <a:gd name="connsiteY0" fmla="*/ 0 h 2530136"/>
              <a:gd name="connsiteX1" fmla="*/ 53265 w 412644"/>
              <a:gd name="connsiteY1" fmla="*/ 372863 h 2530136"/>
              <a:gd name="connsiteX2" fmla="*/ 213064 w 412644"/>
              <a:gd name="connsiteY2" fmla="*/ 736847 h 2530136"/>
              <a:gd name="connsiteX3" fmla="*/ 257452 w 412644"/>
              <a:gd name="connsiteY3" fmla="*/ 967667 h 2530136"/>
              <a:gd name="connsiteX4" fmla="*/ 310718 w 412644"/>
              <a:gd name="connsiteY4" fmla="*/ 1429305 h 2530136"/>
              <a:gd name="connsiteX5" fmla="*/ 363984 w 412644"/>
              <a:gd name="connsiteY5" fmla="*/ 1713391 h 2530136"/>
              <a:gd name="connsiteX6" fmla="*/ 408373 w 412644"/>
              <a:gd name="connsiteY6" fmla="*/ 2041865 h 2530136"/>
              <a:gd name="connsiteX7" fmla="*/ 408373 w 412644"/>
              <a:gd name="connsiteY7" fmla="*/ 2530136 h 2530136"/>
              <a:gd name="connsiteX0" fmla="*/ 0 w 359379"/>
              <a:gd name="connsiteY0" fmla="*/ 0 h 2157273"/>
              <a:gd name="connsiteX1" fmla="*/ 159799 w 359379"/>
              <a:gd name="connsiteY1" fmla="*/ 363984 h 2157273"/>
              <a:gd name="connsiteX2" fmla="*/ 204187 w 359379"/>
              <a:gd name="connsiteY2" fmla="*/ 594804 h 2157273"/>
              <a:gd name="connsiteX3" fmla="*/ 257453 w 359379"/>
              <a:gd name="connsiteY3" fmla="*/ 1056442 h 2157273"/>
              <a:gd name="connsiteX4" fmla="*/ 310719 w 359379"/>
              <a:gd name="connsiteY4" fmla="*/ 1340528 h 2157273"/>
              <a:gd name="connsiteX5" fmla="*/ 355108 w 359379"/>
              <a:gd name="connsiteY5" fmla="*/ 1669002 h 2157273"/>
              <a:gd name="connsiteX6" fmla="*/ 355108 w 359379"/>
              <a:gd name="connsiteY6" fmla="*/ 2157273 h 2157273"/>
              <a:gd name="connsiteX0" fmla="*/ 0 w 199580"/>
              <a:gd name="connsiteY0" fmla="*/ 0 h 1793289"/>
              <a:gd name="connsiteX1" fmla="*/ 44388 w 199580"/>
              <a:gd name="connsiteY1" fmla="*/ 230820 h 1793289"/>
              <a:gd name="connsiteX2" fmla="*/ 97654 w 199580"/>
              <a:gd name="connsiteY2" fmla="*/ 692458 h 1793289"/>
              <a:gd name="connsiteX3" fmla="*/ 150920 w 199580"/>
              <a:gd name="connsiteY3" fmla="*/ 976544 h 1793289"/>
              <a:gd name="connsiteX4" fmla="*/ 195309 w 199580"/>
              <a:gd name="connsiteY4" fmla="*/ 1305018 h 1793289"/>
              <a:gd name="connsiteX5" fmla="*/ 195309 w 199580"/>
              <a:gd name="connsiteY5" fmla="*/ 1793289 h 1793289"/>
              <a:gd name="connsiteX0" fmla="*/ 0 w 155192"/>
              <a:gd name="connsiteY0" fmla="*/ 1 h 1562470"/>
              <a:gd name="connsiteX1" fmla="*/ 53266 w 155192"/>
              <a:gd name="connsiteY1" fmla="*/ 461639 h 1562470"/>
              <a:gd name="connsiteX2" fmla="*/ 106532 w 155192"/>
              <a:gd name="connsiteY2" fmla="*/ 745725 h 1562470"/>
              <a:gd name="connsiteX3" fmla="*/ 150921 w 155192"/>
              <a:gd name="connsiteY3" fmla="*/ 1074199 h 1562470"/>
              <a:gd name="connsiteX4" fmla="*/ 150921 w 155192"/>
              <a:gd name="connsiteY4" fmla="*/ 1562470 h 1562470"/>
              <a:gd name="connsiteX0" fmla="*/ 0 w 150921"/>
              <a:gd name="connsiteY0" fmla="*/ 1 h 1562470"/>
              <a:gd name="connsiteX1" fmla="*/ 53266 w 150921"/>
              <a:gd name="connsiteY1" fmla="*/ 461639 h 1562470"/>
              <a:gd name="connsiteX2" fmla="*/ 106532 w 150921"/>
              <a:gd name="connsiteY2" fmla="*/ 745725 h 1562470"/>
              <a:gd name="connsiteX3" fmla="*/ 150921 w 150921"/>
              <a:gd name="connsiteY3" fmla="*/ 1562470 h 1562470"/>
              <a:gd name="connsiteX0" fmla="*/ 0 w 150921"/>
              <a:gd name="connsiteY0" fmla="*/ 1 h 1562470"/>
              <a:gd name="connsiteX1" fmla="*/ 106532 w 150921"/>
              <a:gd name="connsiteY1" fmla="*/ 745725 h 1562470"/>
              <a:gd name="connsiteX2" fmla="*/ 150921 w 150921"/>
              <a:gd name="connsiteY2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50921" h="1562470">
                <a:moveTo>
                  <a:pt x="0" y="1"/>
                </a:moveTo>
                <a:cubicBezTo>
                  <a:pt x="28876" y="550869"/>
                  <a:pt x="105376" y="928977"/>
                  <a:pt x="150921" y="1562470"/>
                </a:cubicBezTo>
              </a:path>
            </a:pathLst>
          </a:cu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2400"/>
          </a:p>
        </p:txBody>
      </p:sp>
      <p:sp>
        <p:nvSpPr>
          <p:cNvPr id="224" name="Freihandform: Form 223">
            <a:extLst>
              <a:ext uri="{FF2B5EF4-FFF2-40B4-BE49-F238E27FC236}">
                <a16:creationId xmlns:a16="http://schemas.microsoft.com/office/drawing/2014/main" id="{2F10E54A-9038-EF22-DBD9-DE51DAF2942D}"/>
              </a:ext>
            </a:extLst>
          </p:cNvPr>
          <p:cNvSpPr/>
          <p:nvPr/>
        </p:nvSpPr>
        <p:spPr>
          <a:xfrm>
            <a:off x="6595591" y="1428447"/>
            <a:ext cx="123616" cy="660463"/>
          </a:xfrm>
          <a:custGeom>
            <a:avLst/>
            <a:gdLst>
              <a:gd name="connsiteX0" fmla="*/ 0 w 332745"/>
              <a:gd name="connsiteY0" fmla="*/ 0 h 2175029"/>
              <a:gd name="connsiteX1" fmla="*/ 62143 w 332745"/>
              <a:gd name="connsiteY1" fmla="*/ 248575 h 2175029"/>
              <a:gd name="connsiteX2" fmla="*/ 133165 w 332745"/>
              <a:gd name="connsiteY2" fmla="*/ 381740 h 2175029"/>
              <a:gd name="connsiteX3" fmla="*/ 177553 w 332745"/>
              <a:gd name="connsiteY3" fmla="*/ 612560 h 2175029"/>
              <a:gd name="connsiteX4" fmla="*/ 230819 w 332745"/>
              <a:gd name="connsiteY4" fmla="*/ 1074198 h 2175029"/>
              <a:gd name="connsiteX5" fmla="*/ 284085 w 332745"/>
              <a:gd name="connsiteY5" fmla="*/ 1358284 h 2175029"/>
              <a:gd name="connsiteX6" fmla="*/ 328474 w 332745"/>
              <a:gd name="connsiteY6" fmla="*/ 1686758 h 2175029"/>
              <a:gd name="connsiteX7" fmla="*/ 328474 w 332745"/>
              <a:gd name="connsiteY7" fmla="*/ 2175029 h 2175029"/>
              <a:gd name="connsiteX0" fmla="*/ 0 w 412644"/>
              <a:gd name="connsiteY0" fmla="*/ 0 h 2530136"/>
              <a:gd name="connsiteX1" fmla="*/ 142042 w 412644"/>
              <a:gd name="connsiteY1" fmla="*/ 603682 h 2530136"/>
              <a:gd name="connsiteX2" fmla="*/ 213064 w 412644"/>
              <a:gd name="connsiteY2" fmla="*/ 736847 h 2530136"/>
              <a:gd name="connsiteX3" fmla="*/ 257452 w 412644"/>
              <a:gd name="connsiteY3" fmla="*/ 967667 h 2530136"/>
              <a:gd name="connsiteX4" fmla="*/ 310718 w 412644"/>
              <a:gd name="connsiteY4" fmla="*/ 1429305 h 2530136"/>
              <a:gd name="connsiteX5" fmla="*/ 363984 w 412644"/>
              <a:gd name="connsiteY5" fmla="*/ 1713391 h 2530136"/>
              <a:gd name="connsiteX6" fmla="*/ 408373 w 412644"/>
              <a:gd name="connsiteY6" fmla="*/ 2041865 h 2530136"/>
              <a:gd name="connsiteX7" fmla="*/ 408373 w 412644"/>
              <a:gd name="connsiteY7" fmla="*/ 2530136 h 2530136"/>
              <a:gd name="connsiteX0" fmla="*/ 0 w 412644"/>
              <a:gd name="connsiteY0" fmla="*/ 0 h 2530136"/>
              <a:gd name="connsiteX1" fmla="*/ 53265 w 412644"/>
              <a:gd name="connsiteY1" fmla="*/ 372863 h 2530136"/>
              <a:gd name="connsiteX2" fmla="*/ 213064 w 412644"/>
              <a:gd name="connsiteY2" fmla="*/ 736847 h 2530136"/>
              <a:gd name="connsiteX3" fmla="*/ 257452 w 412644"/>
              <a:gd name="connsiteY3" fmla="*/ 967667 h 2530136"/>
              <a:gd name="connsiteX4" fmla="*/ 310718 w 412644"/>
              <a:gd name="connsiteY4" fmla="*/ 1429305 h 2530136"/>
              <a:gd name="connsiteX5" fmla="*/ 363984 w 412644"/>
              <a:gd name="connsiteY5" fmla="*/ 1713391 h 2530136"/>
              <a:gd name="connsiteX6" fmla="*/ 408373 w 412644"/>
              <a:gd name="connsiteY6" fmla="*/ 2041865 h 2530136"/>
              <a:gd name="connsiteX7" fmla="*/ 408373 w 412644"/>
              <a:gd name="connsiteY7" fmla="*/ 2530136 h 2530136"/>
              <a:gd name="connsiteX0" fmla="*/ 0 w 359379"/>
              <a:gd name="connsiteY0" fmla="*/ 0 h 2157273"/>
              <a:gd name="connsiteX1" fmla="*/ 159799 w 359379"/>
              <a:gd name="connsiteY1" fmla="*/ 363984 h 2157273"/>
              <a:gd name="connsiteX2" fmla="*/ 204187 w 359379"/>
              <a:gd name="connsiteY2" fmla="*/ 594804 h 2157273"/>
              <a:gd name="connsiteX3" fmla="*/ 257453 w 359379"/>
              <a:gd name="connsiteY3" fmla="*/ 1056442 h 2157273"/>
              <a:gd name="connsiteX4" fmla="*/ 310719 w 359379"/>
              <a:gd name="connsiteY4" fmla="*/ 1340528 h 2157273"/>
              <a:gd name="connsiteX5" fmla="*/ 355108 w 359379"/>
              <a:gd name="connsiteY5" fmla="*/ 1669002 h 2157273"/>
              <a:gd name="connsiteX6" fmla="*/ 355108 w 359379"/>
              <a:gd name="connsiteY6" fmla="*/ 2157273 h 2157273"/>
              <a:gd name="connsiteX0" fmla="*/ 0 w 199580"/>
              <a:gd name="connsiteY0" fmla="*/ 0 h 1793289"/>
              <a:gd name="connsiteX1" fmla="*/ 44388 w 199580"/>
              <a:gd name="connsiteY1" fmla="*/ 230820 h 1793289"/>
              <a:gd name="connsiteX2" fmla="*/ 97654 w 199580"/>
              <a:gd name="connsiteY2" fmla="*/ 692458 h 1793289"/>
              <a:gd name="connsiteX3" fmla="*/ 150920 w 199580"/>
              <a:gd name="connsiteY3" fmla="*/ 976544 h 1793289"/>
              <a:gd name="connsiteX4" fmla="*/ 195309 w 199580"/>
              <a:gd name="connsiteY4" fmla="*/ 1305018 h 1793289"/>
              <a:gd name="connsiteX5" fmla="*/ 195309 w 199580"/>
              <a:gd name="connsiteY5" fmla="*/ 1793289 h 1793289"/>
              <a:gd name="connsiteX0" fmla="*/ 0 w 155192"/>
              <a:gd name="connsiteY0" fmla="*/ 1 h 1562470"/>
              <a:gd name="connsiteX1" fmla="*/ 53266 w 155192"/>
              <a:gd name="connsiteY1" fmla="*/ 461639 h 1562470"/>
              <a:gd name="connsiteX2" fmla="*/ 106532 w 155192"/>
              <a:gd name="connsiteY2" fmla="*/ 745725 h 1562470"/>
              <a:gd name="connsiteX3" fmla="*/ 150921 w 155192"/>
              <a:gd name="connsiteY3" fmla="*/ 1074199 h 1562470"/>
              <a:gd name="connsiteX4" fmla="*/ 150921 w 155192"/>
              <a:gd name="connsiteY4" fmla="*/ 1562470 h 1562470"/>
              <a:gd name="connsiteX0" fmla="*/ 0 w 150921"/>
              <a:gd name="connsiteY0" fmla="*/ 1 h 1562470"/>
              <a:gd name="connsiteX1" fmla="*/ 53266 w 150921"/>
              <a:gd name="connsiteY1" fmla="*/ 461639 h 1562470"/>
              <a:gd name="connsiteX2" fmla="*/ 106532 w 150921"/>
              <a:gd name="connsiteY2" fmla="*/ 745725 h 1562470"/>
              <a:gd name="connsiteX3" fmla="*/ 150921 w 150921"/>
              <a:gd name="connsiteY3" fmla="*/ 1562470 h 1562470"/>
              <a:gd name="connsiteX0" fmla="*/ 0 w 150921"/>
              <a:gd name="connsiteY0" fmla="*/ 1 h 1562470"/>
              <a:gd name="connsiteX1" fmla="*/ 106532 w 150921"/>
              <a:gd name="connsiteY1" fmla="*/ 745725 h 1562470"/>
              <a:gd name="connsiteX2" fmla="*/ 150921 w 150921"/>
              <a:gd name="connsiteY2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  <a:gd name="connsiteX0" fmla="*/ 0 w 150921"/>
              <a:gd name="connsiteY0" fmla="*/ 1 h 1562470"/>
              <a:gd name="connsiteX1" fmla="*/ 150921 w 150921"/>
              <a:gd name="connsiteY1" fmla="*/ 1562470 h 15624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50921" h="1562470">
                <a:moveTo>
                  <a:pt x="0" y="1"/>
                </a:moveTo>
                <a:cubicBezTo>
                  <a:pt x="28876" y="550869"/>
                  <a:pt x="105376" y="928977"/>
                  <a:pt x="150921" y="1562470"/>
                </a:cubicBezTo>
              </a:path>
            </a:pathLst>
          </a:cu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2400"/>
          </a:p>
        </p:txBody>
      </p:sp>
      <p:sp>
        <p:nvSpPr>
          <p:cNvPr id="225" name="Textfeld 224">
            <a:extLst>
              <a:ext uri="{FF2B5EF4-FFF2-40B4-BE49-F238E27FC236}">
                <a16:creationId xmlns:a16="http://schemas.microsoft.com/office/drawing/2014/main" id="{0B65F6F7-E34F-D8AB-E861-82BEAF2F9089}"/>
              </a:ext>
            </a:extLst>
          </p:cNvPr>
          <p:cNvSpPr txBox="1"/>
          <p:nvPr/>
        </p:nvSpPr>
        <p:spPr>
          <a:xfrm rot="15051003">
            <a:off x="6634303" y="2646539"/>
            <a:ext cx="134844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100" dirty="0" err="1">
                <a:solidFill>
                  <a:schemeClr val="bg1"/>
                </a:solidFill>
              </a:rPr>
              <a:t>Onv</a:t>
            </a:r>
            <a:r>
              <a:rPr lang="de-DE" sz="1100" dirty="0">
                <a:solidFill>
                  <a:schemeClr val="bg1"/>
                </a:solidFill>
              </a:rPr>
              <a:t>. Group</a:t>
            </a:r>
          </a:p>
          <a:p>
            <a:pPr algn="ctr"/>
            <a:r>
              <a:rPr lang="de-DE" sz="1100" dirty="0">
                <a:solidFill>
                  <a:schemeClr val="bg1"/>
                </a:solidFill>
              </a:rPr>
              <a:t> </a:t>
            </a:r>
            <a:r>
              <a:rPr lang="de-DE" sz="1100" dirty="0" err="1">
                <a:solidFill>
                  <a:schemeClr val="bg1"/>
                </a:solidFill>
              </a:rPr>
              <a:t>ultramafic</a:t>
            </a:r>
            <a:r>
              <a:rPr lang="de-DE" sz="1100" dirty="0">
                <a:solidFill>
                  <a:schemeClr val="bg1"/>
                </a:solidFill>
              </a:rPr>
              <a:t> </a:t>
            </a:r>
            <a:r>
              <a:rPr lang="de-DE" sz="1100" dirty="0" err="1">
                <a:solidFill>
                  <a:schemeClr val="bg1"/>
                </a:solidFill>
              </a:rPr>
              <a:t>volcanics</a:t>
            </a:r>
            <a:endParaRPr lang="de-DE" sz="1100" dirty="0">
              <a:solidFill>
                <a:schemeClr val="bg1"/>
              </a:solidFill>
            </a:endParaRPr>
          </a:p>
        </p:txBody>
      </p:sp>
      <p:grpSp>
        <p:nvGrpSpPr>
          <p:cNvPr id="226" name="Gruppieren 225">
            <a:extLst>
              <a:ext uri="{FF2B5EF4-FFF2-40B4-BE49-F238E27FC236}">
                <a16:creationId xmlns:a16="http://schemas.microsoft.com/office/drawing/2014/main" id="{AB21844B-9938-259E-4602-F9BC0E9648F2}"/>
              </a:ext>
            </a:extLst>
          </p:cNvPr>
          <p:cNvGrpSpPr/>
          <p:nvPr/>
        </p:nvGrpSpPr>
        <p:grpSpPr>
          <a:xfrm>
            <a:off x="5293468" y="3393876"/>
            <a:ext cx="306355" cy="512695"/>
            <a:chOff x="3509820" y="601810"/>
            <a:chExt cx="229766" cy="384521"/>
          </a:xfrm>
        </p:grpSpPr>
        <p:cxnSp>
          <p:nvCxnSpPr>
            <p:cNvPr id="240" name="Gerader Verbinder 239">
              <a:extLst>
                <a:ext uri="{FF2B5EF4-FFF2-40B4-BE49-F238E27FC236}">
                  <a16:creationId xmlns:a16="http://schemas.microsoft.com/office/drawing/2014/main" id="{12513DFC-50DA-6351-F22D-AA51EEFA7DF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85904" y="601810"/>
              <a:ext cx="153682" cy="29098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Gerader Verbinder 240">
              <a:extLst>
                <a:ext uri="{FF2B5EF4-FFF2-40B4-BE49-F238E27FC236}">
                  <a16:creationId xmlns:a16="http://schemas.microsoft.com/office/drawing/2014/main" id="{E655D958-BD25-EDF7-99BC-18AB05830C9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66883" y="625194"/>
              <a:ext cx="153682" cy="29098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Gerader Verbinder 241">
              <a:extLst>
                <a:ext uri="{FF2B5EF4-FFF2-40B4-BE49-F238E27FC236}">
                  <a16:creationId xmlns:a16="http://schemas.microsoft.com/office/drawing/2014/main" id="{8D1DF530-BF82-E8B6-4DCC-3713CA66F56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47862" y="648578"/>
              <a:ext cx="153682" cy="29098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Gerader Verbinder 242">
              <a:extLst>
                <a:ext uri="{FF2B5EF4-FFF2-40B4-BE49-F238E27FC236}">
                  <a16:creationId xmlns:a16="http://schemas.microsoft.com/office/drawing/2014/main" id="{DA906241-4F9B-3FDF-DE20-F9123C9B2BA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28841" y="671962"/>
              <a:ext cx="153682" cy="29098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Gerader Verbinder 243">
              <a:extLst>
                <a:ext uri="{FF2B5EF4-FFF2-40B4-BE49-F238E27FC236}">
                  <a16:creationId xmlns:a16="http://schemas.microsoft.com/office/drawing/2014/main" id="{4283B88A-6026-DAA3-1971-4E12FFA424B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09820" y="695346"/>
              <a:ext cx="153682" cy="29098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27" name="Gerader Verbinder 226">
            <a:extLst>
              <a:ext uri="{FF2B5EF4-FFF2-40B4-BE49-F238E27FC236}">
                <a16:creationId xmlns:a16="http://schemas.microsoft.com/office/drawing/2014/main" id="{13573288-68F5-193A-5974-D20CAE658B1A}"/>
              </a:ext>
            </a:extLst>
          </p:cNvPr>
          <p:cNvCxnSpPr>
            <a:cxnSpLocks/>
          </p:cNvCxnSpPr>
          <p:nvPr/>
        </p:nvCxnSpPr>
        <p:spPr>
          <a:xfrm>
            <a:off x="6274144" y="2838419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Gerader Verbinder 227">
            <a:extLst>
              <a:ext uri="{FF2B5EF4-FFF2-40B4-BE49-F238E27FC236}">
                <a16:creationId xmlns:a16="http://schemas.microsoft.com/office/drawing/2014/main" id="{F01A0B1B-B4A0-ADD1-91B5-514FCAB9E875}"/>
              </a:ext>
            </a:extLst>
          </p:cNvPr>
          <p:cNvCxnSpPr>
            <a:cxnSpLocks/>
          </p:cNvCxnSpPr>
          <p:nvPr/>
        </p:nvCxnSpPr>
        <p:spPr>
          <a:xfrm>
            <a:off x="6274144" y="2838419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9" name="Gruppieren 228">
            <a:extLst>
              <a:ext uri="{FF2B5EF4-FFF2-40B4-BE49-F238E27FC236}">
                <a16:creationId xmlns:a16="http://schemas.microsoft.com/office/drawing/2014/main" id="{B0C7781E-CF0C-FD4B-7E3C-90D37751166D}"/>
              </a:ext>
            </a:extLst>
          </p:cNvPr>
          <p:cNvGrpSpPr/>
          <p:nvPr/>
        </p:nvGrpSpPr>
        <p:grpSpPr>
          <a:xfrm>
            <a:off x="7219860" y="1922103"/>
            <a:ext cx="385920" cy="598241"/>
            <a:chOff x="5482127" y="3799897"/>
            <a:chExt cx="289440" cy="448681"/>
          </a:xfrm>
        </p:grpSpPr>
        <p:sp>
          <p:nvSpPr>
            <p:cNvPr id="238" name="Textfeld 237">
              <a:extLst>
                <a:ext uri="{FF2B5EF4-FFF2-40B4-BE49-F238E27FC236}">
                  <a16:creationId xmlns:a16="http://schemas.microsoft.com/office/drawing/2014/main" id="{6FCA1BA1-37ED-31F1-41E5-BC951EE6FC2B}"/>
                </a:ext>
              </a:extLst>
            </p:cNvPr>
            <p:cNvSpPr txBox="1"/>
            <p:nvPr/>
          </p:nvSpPr>
          <p:spPr>
            <a:xfrm rot="13550607">
              <a:off x="5451022" y="3928033"/>
              <a:ext cx="448681" cy="1924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67" dirty="0">
                  <a:solidFill>
                    <a:srgbClr val="FF0000"/>
                  </a:solidFill>
                </a:rPr>
                <a:t>May 19</a:t>
              </a:r>
            </a:p>
          </p:txBody>
        </p:sp>
        <p:cxnSp>
          <p:nvCxnSpPr>
            <p:cNvPr id="239" name="Gerader Verbinder 238">
              <a:extLst>
                <a:ext uri="{FF2B5EF4-FFF2-40B4-BE49-F238E27FC236}">
                  <a16:creationId xmlns:a16="http://schemas.microsoft.com/office/drawing/2014/main" id="{EE58E56C-61E2-F958-68F7-CC3C8A194431}"/>
                </a:ext>
              </a:extLst>
            </p:cNvPr>
            <p:cNvCxnSpPr>
              <a:cxnSpLocks/>
            </p:cNvCxnSpPr>
            <p:nvPr/>
          </p:nvCxnSpPr>
          <p:spPr>
            <a:xfrm>
              <a:off x="5482127" y="3837785"/>
              <a:ext cx="68216" cy="6211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0" name="Freihandform: Form 229">
            <a:extLst>
              <a:ext uri="{FF2B5EF4-FFF2-40B4-BE49-F238E27FC236}">
                <a16:creationId xmlns:a16="http://schemas.microsoft.com/office/drawing/2014/main" id="{EB2CC27D-18CD-72E5-2758-F98C39717083}"/>
              </a:ext>
            </a:extLst>
          </p:cNvPr>
          <p:cNvSpPr/>
          <p:nvPr/>
        </p:nvSpPr>
        <p:spPr>
          <a:xfrm>
            <a:off x="5499904" y="3236380"/>
            <a:ext cx="255383" cy="521147"/>
          </a:xfrm>
          <a:custGeom>
            <a:avLst/>
            <a:gdLst>
              <a:gd name="connsiteX0" fmla="*/ 5691 w 165484"/>
              <a:gd name="connsiteY0" fmla="*/ 5948 h 401260"/>
              <a:gd name="connsiteX1" fmla="*/ 98559 w 165484"/>
              <a:gd name="connsiteY1" fmla="*/ 263123 h 401260"/>
              <a:gd name="connsiteX2" fmla="*/ 165234 w 165484"/>
              <a:gd name="connsiteY2" fmla="*/ 401235 h 401260"/>
              <a:gd name="connsiteX3" fmla="*/ 74747 w 165484"/>
              <a:gd name="connsiteY3" fmla="*/ 253598 h 401260"/>
              <a:gd name="connsiteX4" fmla="*/ 19978 w 165484"/>
              <a:gd name="connsiteY4" fmla="*/ 98817 h 401260"/>
              <a:gd name="connsiteX5" fmla="*/ 5691 w 165484"/>
              <a:gd name="connsiteY5" fmla="*/ 5948 h 401260"/>
              <a:gd name="connsiteX0" fmla="*/ 2606 w 191002"/>
              <a:gd name="connsiteY0" fmla="*/ 6123 h 391909"/>
              <a:gd name="connsiteX1" fmla="*/ 124049 w 191002"/>
              <a:gd name="connsiteY1" fmla="*/ 253773 h 391909"/>
              <a:gd name="connsiteX2" fmla="*/ 190724 w 191002"/>
              <a:gd name="connsiteY2" fmla="*/ 391885 h 391909"/>
              <a:gd name="connsiteX3" fmla="*/ 100237 w 191002"/>
              <a:gd name="connsiteY3" fmla="*/ 244248 h 391909"/>
              <a:gd name="connsiteX4" fmla="*/ 45468 w 191002"/>
              <a:gd name="connsiteY4" fmla="*/ 89467 h 391909"/>
              <a:gd name="connsiteX5" fmla="*/ 2606 w 191002"/>
              <a:gd name="connsiteY5" fmla="*/ 6123 h 391909"/>
              <a:gd name="connsiteX0" fmla="*/ 3141 w 191537"/>
              <a:gd name="connsiteY0" fmla="*/ 5074 h 390860"/>
              <a:gd name="connsiteX1" fmla="*/ 124584 w 191537"/>
              <a:gd name="connsiteY1" fmla="*/ 252724 h 390860"/>
              <a:gd name="connsiteX2" fmla="*/ 191259 w 191537"/>
              <a:gd name="connsiteY2" fmla="*/ 390836 h 390860"/>
              <a:gd name="connsiteX3" fmla="*/ 100772 w 191537"/>
              <a:gd name="connsiteY3" fmla="*/ 243199 h 390860"/>
              <a:gd name="connsiteX4" fmla="*/ 41241 w 191537"/>
              <a:gd name="connsiteY4" fmla="*/ 97943 h 390860"/>
              <a:gd name="connsiteX5" fmla="*/ 3141 w 191537"/>
              <a:gd name="connsiteY5" fmla="*/ 5074 h 390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91537" h="390860">
                <a:moveTo>
                  <a:pt x="3141" y="5074"/>
                </a:moveTo>
                <a:cubicBezTo>
                  <a:pt x="17031" y="30871"/>
                  <a:pt x="93231" y="188430"/>
                  <a:pt x="124584" y="252724"/>
                </a:cubicBezTo>
                <a:cubicBezTo>
                  <a:pt x="155937" y="317018"/>
                  <a:pt x="195228" y="392423"/>
                  <a:pt x="191259" y="390836"/>
                </a:cubicBezTo>
                <a:cubicBezTo>
                  <a:pt x="187290" y="389249"/>
                  <a:pt x="124981" y="293602"/>
                  <a:pt x="100772" y="243199"/>
                </a:cubicBezTo>
                <a:cubicBezTo>
                  <a:pt x="76563" y="192796"/>
                  <a:pt x="57513" y="137631"/>
                  <a:pt x="41241" y="97943"/>
                </a:cubicBezTo>
                <a:cubicBezTo>
                  <a:pt x="24969" y="58256"/>
                  <a:pt x="-10749" y="-20723"/>
                  <a:pt x="3141" y="5074"/>
                </a:cubicBezTo>
                <a:close/>
              </a:path>
            </a:pathLst>
          </a:custGeom>
          <a:solidFill>
            <a:schemeClr val="accent6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2400"/>
          </a:p>
        </p:txBody>
      </p:sp>
      <p:cxnSp>
        <p:nvCxnSpPr>
          <p:cNvPr id="231" name="Gerade Verbindung mit Pfeil 230">
            <a:extLst>
              <a:ext uri="{FF2B5EF4-FFF2-40B4-BE49-F238E27FC236}">
                <a16:creationId xmlns:a16="http://schemas.microsoft.com/office/drawing/2014/main" id="{72307AB3-A704-7865-C08E-20000A71B192}"/>
              </a:ext>
            </a:extLst>
          </p:cNvPr>
          <p:cNvCxnSpPr>
            <a:cxnSpLocks/>
          </p:cNvCxnSpPr>
          <p:nvPr/>
        </p:nvCxnSpPr>
        <p:spPr>
          <a:xfrm flipV="1">
            <a:off x="5280842" y="4512761"/>
            <a:ext cx="397285" cy="225547"/>
          </a:xfrm>
          <a:prstGeom prst="straightConnector1">
            <a:avLst/>
          </a:prstGeom>
          <a:ln w="3175">
            <a:solidFill>
              <a:schemeClr val="tx1"/>
            </a:solidFill>
            <a:prstDash val="dash"/>
            <a:headEnd type="arrow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Textfeld 231">
            <a:extLst>
              <a:ext uri="{FF2B5EF4-FFF2-40B4-BE49-F238E27FC236}">
                <a16:creationId xmlns:a16="http://schemas.microsoft.com/office/drawing/2014/main" id="{687730BB-3DD9-3D4F-BD31-ECB1020C9EFB}"/>
              </a:ext>
            </a:extLst>
          </p:cNvPr>
          <p:cNvSpPr txBox="1"/>
          <p:nvPr/>
        </p:nvSpPr>
        <p:spPr>
          <a:xfrm rot="19757890">
            <a:off x="5270844" y="4676939"/>
            <a:ext cx="565843" cy="29149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47" i="1" dirty="0"/>
              <a:t>Ca. 50 m</a:t>
            </a:r>
            <a:endParaRPr lang="de-DE" sz="647" dirty="0"/>
          </a:p>
          <a:p>
            <a:pPr algn="ctr"/>
            <a:endParaRPr lang="de-DE" sz="647" i="1" dirty="0"/>
          </a:p>
        </p:txBody>
      </p:sp>
      <p:sp>
        <p:nvSpPr>
          <p:cNvPr id="234" name="Textfeld 233">
            <a:extLst>
              <a:ext uri="{FF2B5EF4-FFF2-40B4-BE49-F238E27FC236}">
                <a16:creationId xmlns:a16="http://schemas.microsoft.com/office/drawing/2014/main" id="{57692C84-A446-B2E3-06E5-32CA1297B6B6}"/>
              </a:ext>
            </a:extLst>
          </p:cNvPr>
          <p:cNvSpPr txBox="1"/>
          <p:nvPr/>
        </p:nvSpPr>
        <p:spPr>
          <a:xfrm>
            <a:off x="2169537" y="3215247"/>
            <a:ext cx="476412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67" dirty="0" err="1"/>
              <a:t>older</a:t>
            </a:r>
            <a:endParaRPr lang="de-DE" sz="1067" dirty="0"/>
          </a:p>
        </p:txBody>
      </p:sp>
      <p:sp>
        <p:nvSpPr>
          <p:cNvPr id="235" name="Textfeld 234">
            <a:extLst>
              <a:ext uri="{FF2B5EF4-FFF2-40B4-BE49-F238E27FC236}">
                <a16:creationId xmlns:a16="http://schemas.microsoft.com/office/drawing/2014/main" id="{C4825A77-5BCF-9988-D2A6-239C6416C525}"/>
              </a:ext>
            </a:extLst>
          </p:cNvPr>
          <p:cNvSpPr txBox="1"/>
          <p:nvPr/>
        </p:nvSpPr>
        <p:spPr>
          <a:xfrm>
            <a:off x="1424566" y="3480316"/>
            <a:ext cx="643125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67" dirty="0" err="1"/>
              <a:t>younger</a:t>
            </a:r>
            <a:endParaRPr lang="de-DE" sz="1067" dirty="0"/>
          </a:p>
        </p:txBody>
      </p:sp>
      <p:cxnSp>
        <p:nvCxnSpPr>
          <p:cNvPr id="236" name="Gerader Verbinder 235">
            <a:extLst>
              <a:ext uri="{FF2B5EF4-FFF2-40B4-BE49-F238E27FC236}">
                <a16:creationId xmlns:a16="http://schemas.microsoft.com/office/drawing/2014/main" id="{2DF70828-D894-513A-91A3-112405E583A4}"/>
              </a:ext>
            </a:extLst>
          </p:cNvPr>
          <p:cNvCxnSpPr>
            <a:cxnSpLocks/>
          </p:cNvCxnSpPr>
          <p:nvPr/>
        </p:nvCxnSpPr>
        <p:spPr>
          <a:xfrm>
            <a:off x="2064054" y="1621757"/>
            <a:ext cx="126947" cy="563768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Gerader Verbinder 236">
            <a:extLst>
              <a:ext uri="{FF2B5EF4-FFF2-40B4-BE49-F238E27FC236}">
                <a16:creationId xmlns:a16="http://schemas.microsoft.com/office/drawing/2014/main" id="{0D6305B9-B1F3-6747-D442-8B51306870B6}"/>
              </a:ext>
            </a:extLst>
          </p:cNvPr>
          <p:cNvCxnSpPr>
            <a:cxnSpLocks/>
          </p:cNvCxnSpPr>
          <p:nvPr/>
        </p:nvCxnSpPr>
        <p:spPr>
          <a:xfrm>
            <a:off x="2635703" y="1786068"/>
            <a:ext cx="111409" cy="560471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47CDE39A-DA09-DFAF-0E7E-B5C3FA88FE55}"/>
              </a:ext>
            </a:extLst>
          </p:cNvPr>
          <p:cNvSpPr txBox="1"/>
          <p:nvPr/>
        </p:nvSpPr>
        <p:spPr>
          <a:xfrm rot="14940000">
            <a:off x="3913460" y="3018337"/>
            <a:ext cx="486031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MdI2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5EDE98C0-47BC-B9EF-AE13-E5298FCB97D1}"/>
              </a:ext>
            </a:extLst>
          </p:cNvPr>
          <p:cNvSpPr txBox="1"/>
          <p:nvPr/>
        </p:nvSpPr>
        <p:spPr>
          <a:xfrm>
            <a:off x="1166648" y="956441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W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B87234A0-ED27-F19D-F5E5-33AC42EBB347}"/>
              </a:ext>
            </a:extLst>
          </p:cNvPr>
          <p:cNvSpPr txBox="1"/>
          <p:nvPr/>
        </p:nvSpPr>
        <p:spPr>
          <a:xfrm>
            <a:off x="7673838" y="104243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E</a:t>
            </a:r>
          </a:p>
        </p:txBody>
      </p:sp>
      <p:sp>
        <p:nvSpPr>
          <p:cNvPr id="5" name="Freihandform: Form 4">
            <a:extLst>
              <a:ext uri="{FF2B5EF4-FFF2-40B4-BE49-F238E27FC236}">
                <a16:creationId xmlns:a16="http://schemas.microsoft.com/office/drawing/2014/main" id="{23782D88-B989-0514-882D-290681B202C0}"/>
              </a:ext>
            </a:extLst>
          </p:cNvPr>
          <p:cNvSpPr/>
          <p:nvPr/>
        </p:nvSpPr>
        <p:spPr>
          <a:xfrm rot="14395002">
            <a:off x="4275780" y="4647232"/>
            <a:ext cx="289823" cy="516048"/>
          </a:xfrm>
          <a:custGeom>
            <a:avLst/>
            <a:gdLst>
              <a:gd name="connsiteX0" fmla="*/ 0 w 176213"/>
              <a:gd name="connsiteY0" fmla="*/ 0 h 233363"/>
              <a:gd name="connsiteX1" fmla="*/ 166688 w 176213"/>
              <a:gd name="connsiteY1" fmla="*/ 233363 h 233363"/>
              <a:gd name="connsiteX2" fmla="*/ 166688 w 176213"/>
              <a:gd name="connsiteY2" fmla="*/ 233363 h 233363"/>
              <a:gd name="connsiteX3" fmla="*/ 176213 w 176213"/>
              <a:gd name="connsiteY3" fmla="*/ 233363 h 233363"/>
              <a:gd name="connsiteX0" fmla="*/ 0 w 166688"/>
              <a:gd name="connsiteY0" fmla="*/ 0 h 233363"/>
              <a:gd name="connsiteX1" fmla="*/ 166688 w 166688"/>
              <a:gd name="connsiteY1" fmla="*/ 233363 h 233363"/>
              <a:gd name="connsiteX2" fmla="*/ 166688 w 166688"/>
              <a:gd name="connsiteY2" fmla="*/ 233363 h 233363"/>
              <a:gd name="connsiteX0" fmla="*/ 0 w 166688"/>
              <a:gd name="connsiteY0" fmla="*/ 0 h 233363"/>
              <a:gd name="connsiteX1" fmla="*/ 166688 w 166688"/>
              <a:gd name="connsiteY1" fmla="*/ 233363 h 233363"/>
              <a:gd name="connsiteX2" fmla="*/ 166688 w 166688"/>
              <a:gd name="connsiteY2" fmla="*/ 233363 h 233363"/>
              <a:gd name="connsiteX0" fmla="*/ 0 w 166688"/>
              <a:gd name="connsiteY0" fmla="*/ 0 h 233363"/>
              <a:gd name="connsiteX1" fmla="*/ 166688 w 166688"/>
              <a:gd name="connsiteY1" fmla="*/ 233363 h 233363"/>
              <a:gd name="connsiteX2" fmla="*/ 166688 w 166688"/>
              <a:gd name="connsiteY2" fmla="*/ 233363 h 2333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66688" h="233363">
                <a:moveTo>
                  <a:pt x="0" y="0"/>
                </a:moveTo>
                <a:cubicBezTo>
                  <a:pt x="12700" y="111125"/>
                  <a:pt x="44450" y="160337"/>
                  <a:pt x="166688" y="233363"/>
                </a:cubicBezTo>
                <a:lnTo>
                  <a:pt x="166688" y="233363"/>
                </a:lnTo>
              </a:path>
            </a:pathLst>
          </a:custGeom>
          <a:noFill/>
          <a:ln w="381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3FF416A-4C88-A38B-F13B-C67B35AF31C7}"/>
              </a:ext>
            </a:extLst>
          </p:cNvPr>
          <p:cNvSpPr txBox="1"/>
          <p:nvPr/>
        </p:nvSpPr>
        <p:spPr>
          <a:xfrm>
            <a:off x="3339230" y="5053592"/>
            <a:ext cx="14756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i="1" dirty="0" err="1"/>
              <a:t>Sampled</a:t>
            </a:r>
            <a:r>
              <a:rPr lang="de-DE" sz="1400" i="1" dirty="0"/>
              <a:t> </a:t>
            </a:r>
            <a:r>
              <a:rPr lang="de-DE" sz="1400" i="1" dirty="0" err="1"/>
              <a:t>interval</a:t>
            </a:r>
            <a:r>
              <a:rPr lang="de-DE" sz="1400" i="1" dirty="0"/>
              <a:t> 454.8 – 484.5 m</a:t>
            </a:r>
          </a:p>
        </p:txBody>
      </p:sp>
    </p:spTree>
    <p:extLst>
      <p:ext uri="{BB962C8B-B14F-4D97-AF65-F5344CB8AC3E}">
        <p14:creationId xmlns:p14="http://schemas.microsoft.com/office/powerpoint/2010/main" val="1291604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F359E04083A72D49A567FF0E9DD00540" ma:contentTypeVersion="5" ma:contentTypeDescription="Ein neues Dokument erstellen." ma:contentTypeScope="" ma:versionID="9f7f81e7a686515098d274573a583016">
  <xsd:schema xmlns:xsd="http://www.w3.org/2001/XMLSchema" xmlns:xs="http://www.w3.org/2001/XMLSchema" xmlns:p="http://schemas.microsoft.com/office/2006/metadata/properties" xmlns:ns3="9ca870b1-9e8b-4fdf-8cc1-bdc0d0426960" targetNamespace="http://schemas.microsoft.com/office/2006/metadata/properties" ma:root="true" ma:fieldsID="b393ee8723cf3067fcfc86b586fe3856" ns3:_="">
    <xsd:import namespace="9ca870b1-9e8b-4fdf-8cc1-bdc0d042696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ca870b1-9e8b-4fdf-8cc1-bdc0d042696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9ca870b1-9e8b-4fdf-8cc1-bdc0d0426960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295AB6B-6D57-49F1-A6E0-B1973117283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ca870b1-9e8b-4fdf-8cc1-bdc0d042696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717F90A-0551-44AF-9CF4-C19A17E92AFF}">
  <ds:schemaRefs>
    <ds:schemaRef ds:uri="http://purl.org/dc/elements/1.1/"/>
    <ds:schemaRef ds:uri="http://purl.org/dc/terms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schemas.microsoft.com/office/infopath/2007/PartnerControls"/>
    <ds:schemaRef ds:uri="9ca870b1-9e8b-4fdf-8cc1-bdc0d0426960"/>
  </ds:schemaRefs>
</ds:datastoreItem>
</file>

<file path=customXml/itemProps3.xml><?xml version="1.0" encoding="utf-8"?>
<ds:datastoreItem xmlns:ds="http://schemas.openxmlformats.org/officeDocument/2006/customXml" ds:itemID="{84C2FEEB-6A8E-46B7-B112-BFEBD7AB070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49</Words>
  <Application>Microsoft Office PowerPoint</Application>
  <PresentationFormat>On-screen Show (4:3)</PresentationFormat>
  <Paragraphs>2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oph.heubeck</dc:creator>
  <cp:lastModifiedBy>Abu Baidya</cp:lastModifiedBy>
  <cp:revision>53</cp:revision>
  <dcterms:created xsi:type="dcterms:W3CDTF">2020-07-27T09:42:27Z</dcterms:created>
  <dcterms:modified xsi:type="dcterms:W3CDTF">2024-12-28T08:4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359E04083A72D49A567FF0E9DD00540</vt:lpwstr>
  </property>
</Properties>
</file>